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5" r:id="rId2"/>
    <p:sldId id="266" r:id="rId3"/>
  </p:sldIdLst>
  <p:sldSz cx="9144000" cy="6858000" type="screen4x3"/>
  <p:notesSz cx="7099300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980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Sheet1!$D$62,Sheet1!$E$62,Sheet1!$F$62,Sheet1!$G$62,Sheet1!$H$62,Sheet1!$I$62,Sheet1!$J$62)</c:f>
                <c:numCache>
                  <c:formatCode>General</c:formatCode>
                  <c:ptCount val="7"/>
                  <c:pt idx="0">
                    <c:v>0.10572661875720998</c:v>
                  </c:pt>
                  <c:pt idx="1">
                    <c:v>0.12652578670119471</c:v>
                  </c:pt>
                  <c:pt idx="2">
                    <c:v>8.23103389710097E-2</c:v>
                  </c:pt>
                  <c:pt idx="4">
                    <c:v>0.10166853859259017</c:v>
                  </c:pt>
                  <c:pt idx="5">
                    <c:v>9.2704045753315548E-2</c:v>
                  </c:pt>
                  <c:pt idx="6">
                    <c:v>5.788582257798845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D$60:$J$60</c:f>
              <c:strCache>
                <c:ptCount val="7"/>
                <c:pt idx="0">
                  <c:v>① WT TDP-43</c:v>
                </c:pt>
                <c:pt idx="1">
                  <c:v>④ A315T TDP-43</c:v>
                </c:pt>
                <c:pt idx="2">
                  <c:v>⑤ A382T TDP-43</c:v>
                </c:pt>
                <c:pt idx="4">
                  <c:v>⑥ WT FUS</c:v>
                </c:pt>
                <c:pt idx="5">
                  <c:v>⑦ R514S FUS</c:v>
                </c:pt>
                <c:pt idx="6">
                  <c:v>⑧ P525L FUS</c:v>
                </c:pt>
              </c:strCache>
            </c:strRef>
          </c:cat>
          <c:val>
            <c:numRef>
              <c:f>Sheet1!$D$61:$J$61</c:f>
              <c:numCache>
                <c:formatCode>General</c:formatCode>
                <c:ptCount val="7"/>
                <c:pt idx="0">
                  <c:v>0.93828571428571461</c:v>
                </c:pt>
                <c:pt idx="1">
                  <c:v>0.93378571428571477</c:v>
                </c:pt>
                <c:pt idx="2">
                  <c:v>0.97961904761904806</c:v>
                </c:pt>
                <c:pt idx="4">
                  <c:v>0.96880952380952423</c:v>
                </c:pt>
                <c:pt idx="5">
                  <c:v>0.95759523809523861</c:v>
                </c:pt>
                <c:pt idx="6">
                  <c:v>0.9837777777777775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1"/>
        <c:axId val="133853296"/>
        <c:axId val="134196832"/>
      </c:barChart>
      <c:catAx>
        <c:axId val="133853296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134196832"/>
        <c:crosses val="autoZero"/>
        <c:auto val="1"/>
        <c:lblAlgn val="ctr"/>
        <c:lblOffset val="100"/>
        <c:noMultiLvlLbl val="0"/>
      </c:catAx>
      <c:valAx>
        <c:axId val="134196832"/>
        <c:scaling>
          <c:orientation val="minMax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3853296"/>
        <c:crosses val="autoZero"/>
        <c:crossBetween val="between"/>
        <c:majorUnit val="0.2"/>
      </c:valAx>
    </c:plotArea>
    <c:plotVisOnly val="1"/>
    <c:dispBlanksAs val="gap"/>
    <c:showDLblsOverMax val="0"/>
  </c:chart>
  <c:txPr>
    <a:bodyPr/>
    <a:lstStyle/>
    <a:p>
      <a:pPr>
        <a:defRPr sz="1600"/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0A545302-2B77-4B27-879C-E2938CE1C4BE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92188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00FF5A2A-FAA2-4263-826D-44E0F45096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0581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054C7-AAFF-4554-8D79-91919F796AE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79400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054C7-AAFF-4554-8D79-91919F796AE6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73926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065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1279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6499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850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630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3412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6261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2229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4960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7319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4268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9116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png"/><Relationship Id="rId18" Type="http://schemas.openxmlformats.org/officeDocument/2006/relationships/image" Target="../media/image15.png"/><Relationship Id="rId3" Type="http://schemas.openxmlformats.org/officeDocument/2006/relationships/image" Target="../media/image1.png"/><Relationship Id="rId21" Type="http://schemas.openxmlformats.org/officeDocument/2006/relationships/image" Target="../media/image18.png"/><Relationship Id="rId7" Type="http://schemas.openxmlformats.org/officeDocument/2006/relationships/image" Target="../media/image5.png"/><Relationship Id="rId12" Type="http://schemas.openxmlformats.org/officeDocument/2006/relationships/chart" Target="../charts/chart1.xml"/><Relationship Id="rId17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png"/><Relationship Id="rId20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2.png"/><Relationship Id="rId10" Type="http://schemas.openxmlformats.org/officeDocument/2006/relationships/image" Target="../media/image8.png"/><Relationship Id="rId19" Type="http://schemas.openxmlformats.org/officeDocument/2006/relationships/image" Target="../media/image16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11" Type="http://schemas.openxmlformats.org/officeDocument/2006/relationships/image" Target="../media/image27.png"/><Relationship Id="rId5" Type="http://schemas.openxmlformats.org/officeDocument/2006/relationships/image" Target="../media/image21.png"/><Relationship Id="rId10" Type="http://schemas.openxmlformats.org/officeDocument/2006/relationships/image" Target="../media/image26.png"/><Relationship Id="rId4" Type="http://schemas.openxmlformats.org/officeDocument/2006/relationships/image" Target="../media/image20.png"/><Relationship Id="rId9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61" name="Picture 1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1194" y="620688"/>
            <a:ext cx="1551940" cy="15557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1" name="正方形/長方形 180"/>
          <p:cNvSpPr/>
          <p:nvPr/>
        </p:nvSpPr>
        <p:spPr>
          <a:xfrm>
            <a:off x="4778541" y="401271"/>
            <a:ext cx="368352" cy="584890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 pitchFamily="34" charset="0"/>
              <a:cs typeface="Helvetica" pitchFamily="34" charset="0"/>
            </a:endParaRPr>
          </a:p>
        </p:txBody>
      </p:sp>
      <p:pic>
        <p:nvPicPr>
          <p:cNvPr id="2073" name="Picture 2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1194" y="3645024"/>
            <a:ext cx="1420936" cy="13790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0" name="Picture 1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73314" y="621305"/>
            <a:ext cx="1627078" cy="15557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テキスト ボックス 1"/>
          <p:cNvSpPr txBox="1"/>
          <p:nvPr/>
        </p:nvSpPr>
        <p:spPr>
          <a:xfrm>
            <a:off x="7431" y="0"/>
            <a:ext cx="28098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S1.</a:t>
            </a:r>
            <a:endParaRPr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-66623" y="339672"/>
            <a:ext cx="2777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3" name="正方形/長方形 22"/>
          <p:cNvSpPr/>
          <p:nvPr/>
        </p:nvSpPr>
        <p:spPr>
          <a:xfrm flipH="1">
            <a:off x="1639118" y="790717"/>
            <a:ext cx="45719" cy="277438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3" name="正方形/長方形 62"/>
          <p:cNvSpPr/>
          <p:nvPr/>
        </p:nvSpPr>
        <p:spPr>
          <a:xfrm flipH="1">
            <a:off x="224236" y="2060090"/>
            <a:ext cx="4278281" cy="920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8" name="正方形/長方形 77"/>
          <p:cNvSpPr/>
          <p:nvPr/>
        </p:nvSpPr>
        <p:spPr>
          <a:xfrm flipH="1">
            <a:off x="2982685" y="777337"/>
            <a:ext cx="45719" cy="277438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236" y="632939"/>
            <a:ext cx="1679357" cy="15549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5633" y="605232"/>
            <a:ext cx="1679357" cy="15549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87411" y="617156"/>
            <a:ext cx="1679357" cy="15549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4670" y="2155154"/>
            <a:ext cx="1552996" cy="14911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96010" y="2147634"/>
            <a:ext cx="1552996" cy="14911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4600" y="2132857"/>
            <a:ext cx="1552996" cy="14911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5" name="正方形/長方形 94"/>
          <p:cNvSpPr/>
          <p:nvPr/>
        </p:nvSpPr>
        <p:spPr>
          <a:xfrm flipH="1">
            <a:off x="184747" y="431413"/>
            <a:ext cx="243446" cy="321486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 rot="16200000">
            <a:off x="-477009" y="2576649"/>
            <a:ext cx="13812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solidFill>
                  <a:srgbClr val="00B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E</a:t>
            </a:r>
            <a:r>
              <a:rPr kumimoji="1" lang="en-US" altLang="ja-JP" sz="1400" b="1" dirty="0" smtClean="0">
                <a:solidFill>
                  <a:srgbClr val="00B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dogenous</a:t>
            </a:r>
          </a:p>
          <a:p>
            <a:r>
              <a:rPr kumimoji="1" lang="en-US" altLang="ja-JP" sz="1400" b="1" dirty="0" smtClean="0">
                <a:solidFill>
                  <a:srgbClr val="00B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US/TLS</a:t>
            </a:r>
            <a:endParaRPr kumimoji="1" lang="ja-JP" altLang="en-US" sz="1400" b="1" dirty="0">
              <a:solidFill>
                <a:srgbClr val="00B05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 rot="16200000">
            <a:off x="-497638" y="1030756"/>
            <a:ext cx="142250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solidFill>
                  <a:srgbClr val="00B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E</a:t>
            </a:r>
            <a:r>
              <a:rPr kumimoji="1" lang="en-US" altLang="ja-JP" sz="1400" b="1" dirty="0" smtClean="0">
                <a:solidFill>
                  <a:srgbClr val="00B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dogenous</a:t>
            </a:r>
          </a:p>
          <a:p>
            <a:r>
              <a:rPr kumimoji="1" lang="en-US" altLang="ja-JP" sz="1400" b="1" dirty="0" smtClean="0">
                <a:solidFill>
                  <a:srgbClr val="00B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TDP-43</a:t>
            </a:r>
            <a:endParaRPr kumimoji="1" lang="ja-JP" altLang="en-US" sz="1400" b="1" dirty="0">
              <a:solidFill>
                <a:srgbClr val="00B05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96" name="正方形/長方形 95"/>
          <p:cNvSpPr/>
          <p:nvPr/>
        </p:nvSpPr>
        <p:spPr>
          <a:xfrm>
            <a:off x="1773391" y="526552"/>
            <a:ext cx="122619" cy="311972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334806" y="649872"/>
            <a:ext cx="1078775" cy="307777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2</a:t>
            </a:r>
            <a:endParaRPr kumimoji="1" lang="ja-JP" altLang="en-US" sz="1400" b="1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995936" y="602216"/>
            <a:ext cx="9381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ge</a:t>
            </a:r>
            <a:endParaRPr kumimoji="1" lang="ja-JP" altLang="en-US" sz="1400" b="1" dirty="0">
              <a:solidFill>
                <a:schemeClr val="bg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99" name="正方形/長方形 98"/>
          <p:cNvSpPr/>
          <p:nvPr/>
        </p:nvSpPr>
        <p:spPr>
          <a:xfrm flipH="1">
            <a:off x="3268101" y="482940"/>
            <a:ext cx="86498" cy="33099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01" name="正方形/長方形 100"/>
          <p:cNvSpPr/>
          <p:nvPr/>
        </p:nvSpPr>
        <p:spPr>
          <a:xfrm flipH="1">
            <a:off x="4721008" y="186634"/>
            <a:ext cx="189737" cy="35010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02" name="テキスト ボックス 101"/>
          <p:cNvSpPr txBox="1"/>
          <p:nvPr/>
        </p:nvSpPr>
        <p:spPr>
          <a:xfrm>
            <a:off x="2334806" y="2223047"/>
            <a:ext cx="1078775" cy="307777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2</a:t>
            </a:r>
            <a:endParaRPr kumimoji="1" lang="ja-JP" altLang="en-US" sz="1400" b="1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3995936" y="2185119"/>
            <a:ext cx="9381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ge</a:t>
            </a:r>
            <a:endParaRPr kumimoji="1" lang="ja-JP" altLang="en-US" sz="1400" b="1" dirty="0">
              <a:solidFill>
                <a:schemeClr val="bg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 rot="16200000">
            <a:off x="2726588" y="6029359"/>
            <a:ext cx="90222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WT</a:t>
            </a:r>
            <a:r>
              <a:rPr kumimoji="1" lang="en-US" altLang="ja-JP" sz="12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</a:p>
          <a:p>
            <a:r>
              <a:rPr kumimoji="1" lang="en-US" altLang="ja-JP" sz="12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US/TLS</a:t>
            </a:r>
            <a:endParaRPr kumimoji="1" lang="ja-JP" altLang="en-US" sz="12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 rot="16200000">
            <a:off x="775547" y="6045382"/>
            <a:ext cx="79391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WT</a:t>
            </a:r>
            <a:r>
              <a:rPr kumimoji="1" lang="en-US" altLang="ja-JP" sz="12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</a:p>
          <a:p>
            <a:r>
              <a:rPr kumimoji="1" lang="en-US" altLang="ja-JP" sz="12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TDP-43</a:t>
            </a:r>
            <a:endParaRPr kumimoji="1" lang="ja-JP" altLang="en-US" sz="12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 rot="16200000">
            <a:off x="3774735" y="6070625"/>
            <a:ext cx="840741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525L</a:t>
            </a:r>
          </a:p>
          <a:p>
            <a:r>
              <a:rPr lang="en-US" altLang="ja-JP" sz="12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US/TLS</a:t>
            </a:r>
            <a:endParaRPr kumimoji="1" lang="ja-JP" altLang="en-US" sz="12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 rot="16200000">
            <a:off x="3222420" y="6090165"/>
            <a:ext cx="840741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R514S</a:t>
            </a:r>
          </a:p>
          <a:p>
            <a:r>
              <a:rPr lang="en-US" altLang="ja-JP" sz="12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US/TLS</a:t>
            </a:r>
            <a:endParaRPr kumimoji="1" lang="ja-JP" altLang="en-US" sz="12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 rot="16200000">
            <a:off x="1769542" y="5998616"/>
            <a:ext cx="840741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382T</a:t>
            </a:r>
          </a:p>
          <a:p>
            <a:r>
              <a:rPr kumimoji="1" lang="en-US" altLang="ja-JP" sz="12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TDP-43</a:t>
            </a:r>
            <a:endParaRPr kumimoji="1" lang="ja-JP" altLang="en-US" sz="12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 rot="16200000">
            <a:off x="1217227" y="6018156"/>
            <a:ext cx="840741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315T</a:t>
            </a:r>
          </a:p>
          <a:p>
            <a:r>
              <a:rPr kumimoji="1" lang="en-US" altLang="ja-JP" sz="12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TDP-43</a:t>
            </a:r>
            <a:endParaRPr kumimoji="1" lang="ja-JP" altLang="en-US" sz="12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aphicFrame>
        <p:nvGraphicFramePr>
          <p:cNvPr id="70" name="グラフ 69"/>
          <p:cNvGraphicFramePr>
            <a:graphicFrameLocks/>
          </p:cNvGraphicFramePr>
          <p:nvPr>
            <p:extLst/>
          </p:nvPr>
        </p:nvGraphicFramePr>
        <p:xfrm>
          <a:off x="391795" y="3683165"/>
          <a:ext cx="4178159" cy="24316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71" name="角丸四角形 70"/>
          <p:cNvSpPr/>
          <p:nvPr/>
        </p:nvSpPr>
        <p:spPr>
          <a:xfrm>
            <a:off x="455181" y="3792854"/>
            <a:ext cx="442365" cy="225316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439148" y="4094099"/>
            <a:ext cx="39734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100</a:t>
            </a:r>
            <a:endParaRPr kumimoji="1" lang="ja-JP" altLang="en-US" sz="8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465498" y="4441506"/>
            <a:ext cx="36122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8</a:t>
            </a:r>
            <a:r>
              <a:rPr kumimoji="1" lang="en-US" altLang="ja-JP" sz="8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0</a:t>
            </a:r>
            <a:endParaRPr kumimoji="1" lang="ja-JP" altLang="en-US" sz="8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465498" y="4801546"/>
            <a:ext cx="41589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6</a:t>
            </a:r>
            <a:r>
              <a:rPr kumimoji="1" lang="en-US" altLang="ja-JP" sz="8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0</a:t>
            </a:r>
            <a:endParaRPr kumimoji="1" lang="ja-JP" altLang="en-US" sz="8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465498" y="5137836"/>
            <a:ext cx="43204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4</a:t>
            </a:r>
            <a:r>
              <a:rPr kumimoji="1" lang="en-US" altLang="ja-JP" sz="8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0</a:t>
            </a:r>
            <a:endParaRPr kumimoji="1" lang="ja-JP" altLang="en-US" sz="8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458058" y="5449038"/>
            <a:ext cx="43948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</a:t>
            </a:r>
            <a:r>
              <a:rPr kumimoji="1" lang="en-US" altLang="ja-JP" sz="8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0</a:t>
            </a:r>
            <a:endParaRPr kumimoji="1" lang="ja-JP" altLang="en-US" sz="8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572210" y="5809660"/>
            <a:ext cx="23597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0</a:t>
            </a:r>
            <a:endParaRPr kumimoji="1" lang="ja-JP" altLang="en-US" sz="8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-75741" y="3648838"/>
            <a:ext cx="2777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 rot="16200000">
            <a:off x="4362510" y="899193"/>
            <a:ext cx="115881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315T</a:t>
            </a:r>
            <a:r>
              <a:rPr kumimoji="1" lang="en-US" altLang="ja-JP" sz="14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TDP-43</a:t>
            </a:r>
            <a:endParaRPr kumimoji="1" lang="ja-JP" altLang="en-US" sz="1400" b="1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 rot="16200000">
            <a:off x="4362510" y="2393048"/>
            <a:ext cx="115881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382T</a:t>
            </a:r>
            <a:r>
              <a:rPr kumimoji="1" lang="en-US" altLang="ja-JP" sz="14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TDP-43</a:t>
            </a:r>
            <a:endParaRPr kumimoji="1" lang="ja-JP" altLang="en-US" sz="1400" b="1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5" name="正方形/長方形 64"/>
          <p:cNvSpPr/>
          <p:nvPr/>
        </p:nvSpPr>
        <p:spPr>
          <a:xfrm flipH="1">
            <a:off x="4902230" y="2207484"/>
            <a:ext cx="4235613" cy="720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107" name="直線コネクタ 106"/>
          <p:cNvCxnSpPr/>
          <p:nvPr/>
        </p:nvCxnSpPr>
        <p:spPr>
          <a:xfrm>
            <a:off x="3942829" y="2003620"/>
            <a:ext cx="629171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線コネクタ 109"/>
          <p:cNvCxnSpPr/>
          <p:nvPr/>
        </p:nvCxnSpPr>
        <p:spPr>
          <a:xfrm>
            <a:off x="3936628" y="3431208"/>
            <a:ext cx="629171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フリーフォーム 9"/>
          <p:cNvSpPr/>
          <p:nvPr/>
        </p:nvSpPr>
        <p:spPr>
          <a:xfrm>
            <a:off x="3632200" y="920672"/>
            <a:ext cx="594397" cy="816053"/>
          </a:xfrm>
          <a:custGeom>
            <a:avLst/>
            <a:gdLst>
              <a:gd name="connsiteX0" fmla="*/ 212725 w 594397"/>
              <a:gd name="connsiteY0" fmla="*/ 78 h 816053"/>
              <a:gd name="connsiteX1" fmla="*/ 168275 w 594397"/>
              <a:gd name="connsiteY1" fmla="*/ 15953 h 816053"/>
              <a:gd name="connsiteX2" fmla="*/ 155575 w 594397"/>
              <a:gd name="connsiteY2" fmla="*/ 22303 h 816053"/>
              <a:gd name="connsiteX3" fmla="*/ 133350 w 594397"/>
              <a:gd name="connsiteY3" fmla="*/ 28653 h 816053"/>
              <a:gd name="connsiteX4" fmla="*/ 123825 w 594397"/>
              <a:gd name="connsiteY4" fmla="*/ 31828 h 816053"/>
              <a:gd name="connsiteX5" fmla="*/ 104775 w 594397"/>
              <a:gd name="connsiteY5" fmla="*/ 44528 h 816053"/>
              <a:gd name="connsiteX6" fmla="*/ 95250 w 594397"/>
              <a:gd name="connsiteY6" fmla="*/ 50878 h 816053"/>
              <a:gd name="connsiteX7" fmla="*/ 88900 w 594397"/>
              <a:gd name="connsiteY7" fmla="*/ 60403 h 816053"/>
              <a:gd name="connsiteX8" fmla="*/ 69850 w 594397"/>
              <a:gd name="connsiteY8" fmla="*/ 73103 h 816053"/>
              <a:gd name="connsiteX9" fmla="*/ 44450 w 594397"/>
              <a:gd name="connsiteY9" fmla="*/ 111203 h 816053"/>
              <a:gd name="connsiteX10" fmla="*/ 38100 w 594397"/>
              <a:gd name="connsiteY10" fmla="*/ 130253 h 816053"/>
              <a:gd name="connsiteX11" fmla="*/ 31750 w 594397"/>
              <a:gd name="connsiteY11" fmla="*/ 149303 h 816053"/>
              <a:gd name="connsiteX12" fmla="*/ 28575 w 594397"/>
              <a:gd name="connsiteY12" fmla="*/ 158828 h 816053"/>
              <a:gd name="connsiteX13" fmla="*/ 22225 w 594397"/>
              <a:gd name="connsiteY13" fmla="*/ 168353 h 816053"/>
              <a:gd name="connsiteX14" fmla="*/ 19050 w 594397"/>
              <a:gd name="connsiteY14" fmla="*/ 187403 h 816053"/>
              <a:gd name="connsiteX15" fmla="*/ 9525 w 594397"/>
              <a:gd name="connsiteY15" fmla="*/ 225503 h 816053"/>
              <a:gd name="connsiteX16" fmla="*/ 6350 w 594397"/>
              <a:gd name="connsiteY16" fmla="*/ 235028 h 816053"/>
              <a:gd name="connsiteX17" fmla="*/ 0 w 594397"/>
              <a:gd name="connsiteY17" fmla="*/ 260428 h 816053"/>
              <a:gd name="connsiteX18" fmla="*/ 3175 w 594397"/>
              <a:gd name="connsiteY18" fmla="*/ 400128 h 816053"/>
              <a:gd name="connsiteX19" fmla="*/ 6350 w 594397"/>
              <a:gd name="connsiteY19" fmla="*/ 409653 h 816053"/>
              <a:gd name="connsiteX20" fmla="*/ 9525 w 594397"/>
              <a:gd name="connsiteY20" fmla="*/ 422353 h 816053"/>
              <a:gd name="connsiteX21" fmla="*/ 15875 w 594397"/>
              <a:gd name="connsiteY21" fmla="*/ 441403 h 816053"/>
              <a:gd name="connsiteX22" fmla="*/ 22225 w 594397"/>
              <a:gd name="connsiteY22" fmla="*/ 460453 h 816053"/>
              <a:gd name="connsiteX23" fmla="*/ 25400 w 594397"/>
              <a:gd name="connsiteY23" fmla="*/ 469978 h 816053"/>
              <a:gd name="connsiteX24" fmla="*/ 38100 w 594397"/>
              <a:gd name="connsiteY24" fmla="*/ 489028 h 816053"/>
              <a:gd name="connsiteX25" fmla="*/ 44450 w 594397"/>
              <a:gd name="connsiteY25" fmla="*/ 508078 h 816053"/>
              <a:gd name="connsiteX26" fmla="*/ 57150 w 594397"/>
              <a:gd name="connsiteY26" fmla="*/ 527128 h 816053"/>
              <a:gd name="connsiteX27" fmla="*/ 60325 w 594397"/>
              <a:gd name="connsiteY27" fmla="*/ 536653 h 816053"/>
              <a:gd name="connsiteX28" fmla="*/ 66675 w 594397"/>
              <a:gd name="connsiteY28" fmla="*/ 546178 h 816053"/>
              <a:gd name="connsiteX29" fmla="*/ 69850 w 594397"/>
              <a:gd name="connsiteY29" fmla="*/ 555703 h 816053"/>
              <a:gd name="connsiteX30" fmla="*/ 79375 w 594397"/>
              <a:gd name="connsiteY30" fmla="*/ 565228 h 816053"/>
              <a:gd name="connsiteX31" fmla="*/ 92075 w 594397"/>
              <a:gd name="connsiteY31" fmla="*/ 584278 h 816053"/>
              <a:gd name="connsiteX32" fmla="*/ 95250 w 594397"/>
              <a:gd name="connsiteY32" fmla="*/ 593803 h 816053"/>
              <a:gd name="connsiteX33" fmla="*/ 107950 w 594397"/>
              <a:gd name="connsiteY33" fmla="*/ 612853 h 816053"/>
              <a:gd name="connsiteX34" fmla="*/ 133350 w 594397"/>
              <a:gd name="connsiteY34" fmla="*/ 650953 h 816053"/>
              <a:gd name="connsiteX35" fmla="*/ 152400 w 594397"/>
              <a:gd name="connsiteY35" fmla="*/ 679528 h 816053"/>
              <a:gd name="connsiteX36" fmla="*/ 171450 w 594397"/>
              <a:gd name="connsiteY36" fmla="*/ 692228 h 816053"/>
              <a:gd name="connsiteX37" fmla="*/ 187325 w 594397"/>
              <a:gd name="connsiteY37" fmla="*/ 704928 h 816053"/>
              <a:gd name="connsiteX38" fmla="*/ 203200 w 594397"/>
              <a:gd name="connsiteY38" fmla="*/ 717628 h 816053"/>
              <a:gd name="connsiteX39" fmla="*/ 209550 w 594397"/>
              <a:gd name="connsiteY39" fmla="*/ 727153 h 816053"/>
              <a:gd name="connsiteX40" fmla="*/ 228600 w 594397"/>
              <a:gd name="connsiteY40" fmla="*/ 739853 h 816053"/>
              <a:gd name="connsiteX41" fmla="*/ 250825 w 594397"/>
              <a:gd name="connsiteY41" fmla="*/ 765253 h 816053"/>
              <a:gd name="connsiteX42" fmla="*/ 257175 w 594397"/>
              <a:gd name="connsiteY42" fmla="*/ 774778 h 816053"/>
              <a:gd name="connsiteX43" fmla="*/ 276225 w 594397"/>
              <a:gd name="connsiteY43" fmla="*/ 784303 h 816053"/>
              <a:gd name="connsiteX44" fmla="*/ 282575 w 594397"/>
              <a:gd name="connsiteY44" fmla="*/ 793828 h 816053"/>
              <a:gd name="connsiteX45" fmla="*/ 311150 w 594397"/>
              <a:gd name="connsiteY45" fmla="*/ 806528 h 816053"/>
              <a:gd name="connsiteX46" fmla="*/ 320675 w 594397"/>
              <a:gd name="connsiteY46" fmla="*/ 809703 h 816053"/>
              <a:gd name="connsiteX47" fmla="*/ 358775 w 594397"/>
              <a:gd name="connsiteY47" fmla="*/ 816053 h 816053"/>
              <a:gd name="connsiteX48" fmla="*/ 415925 w 594397"/>
              <a:gd name="connsiteY48" fmla="*/ 812878 h 816053"/>
              <a:gd name="connsiteX49" fmla="*/ 434975 w 594397"/>
              <a:gd name="connsiteY49" fmla="*/ 806528 h 816053"/>
              <a:gd name="connsiteX50" fmla="*/ 457200 w 594397"/>
              <a:gd name="connsiteY50" fmla="*/ 803353 h 816053"/>
              <a:gd name="connsiteX51" fmla="*/ 476250 w 594397"/>
              <a:gd name="connsiteY51" fmla="*/ 797003 h 816053"/>
              <a:gd name="connsiteX52" fmla="*/ 495300 w 594397"/>
              <a:gd name="connsiteY52" fmla="*/ 784303 h 816053"/>
              <a:gd name="connsiteX53" fmla="*/ 504825 w 594397"/>
              <a:gd name="connsiteY53" fmla="*/ 774778 h 816053"/>
              <a:gd name="connsiteX54" fmla="*/ 523875 w 594397"/>
              <a:gd name="connsiteY54" fmla="*/ 762078 h 816053"/>
              <a:gd name="connsiteX55" fmla="*/ 533400 w 594397"/>
              <a:gd name="connsiteY55" fmla="*/ 755728 h 816053"/>
              <a:gd name="connsiteX56" fmla="*/ 542925 w 594397"/>
              <a:gd name="connsiteY56" fmla="*/ 746203 h 816053"/>
              <a:gd name="connsiteX57" fmla="*/ 555625 w 594397"/>
              <a:gd name="connsiteY57" fmla="*/ 727153 h 816053"/>
              <a:gd name="connsiteX58" fmla="*/ 558800 w 594397"/>
              <a:gd name="connsiteY58" fmla="*/ 717628 h 816053"/>
              <a:gd name="connsiteX59" fmla="*/ 565150 w 594397"/>
              <a:gd name="connsiteY59" fmla="*/ 708103 h 816053"/>
              <a:gd name="connsiteX60" fmla="*/ 568325 w 594397"/>
              <a:gd name="connsiteY60" fmla="*/ 698578 h 816053"/>
              <a:gd name="connsiteX61" fmla="*/ 574675 w 594397"/>
              <a:gd name="connsiteY61" fmla="*/ 689053 h 816053"/>
              <a:gd name="connsiteX62" fmla="*/ 581025 w 594397"/>
              <a:gd name="connsiteY62" fmla="*/ 670003 h 816053"/>
              <a:gd name="connsiteX63" fmla="*/ 584200 w 594397"/>
              <a:gd name="connsiteY63" fmla="*/ 628728 h 816053"/>
              <a:gd name="connsiteX64" fmla="*/ 590550 w 594397"/>
              <a:gd name="connsiteY64" fmla="*/ 584278 h 816053"/>
              <a:gd name="connsiteX65" fmla="*/ 590550 w 594397"/>
              <a:gd name="connsiteY65" fmla="*/ 390603 h 816053"/>
              <a:gd name="connsiteX66" fmla="*/ 584200 w 594397"/>
              <a:gd name="connsiteY66" fmla="*/ 371553 h 816053"/>
              <a:gd name="connsiteX67" fmla="*/ 577850 w 594397"/>
              <a:gd name="connsiteY67" fmla="*/ 352503 h 816053"/>
              <a:gd name="connsiteX68" fmla="*/ 571500 w 594397"/>
              <a:gd name="connsiteY68" fmla="*/ 342978 h 816053"/>
              <a:gd name="connsiteX69" fmla="*/ 565150 w 594397"/>
              <a:gd name="connsiteY69" fmla="*/ 320753 h 816053"/>
              <a:gd name="connsiteX70" fmla="*/ 558800 w 594397"/>
              <a:gd name="connsiteY70" fmla="*/ 301703 h 816053"/>
              <a:gd name="connsiteX71" fmla="*/ 552450 w 594397"/>
              <a:gd name="connsiteY71" fmla="*/ 292178 h 816053"/>
              <a:gd name="connsiteX72" fmla="*/ 542925 w 594397"/>
              <a:gd name="connsiteY72" fmla="*/ 263603 h 816053"/>
              <a:gd name="connsiteX73" fmla="*/ 530225 w 594397"/>
              <a:gd name="connsiteY73" fmla="*/ 244553 h 816053"/>
              <a:gd name="connsiteX74" fmla="*/ 527050 w 594397"/>
              <a:gd name="connsiteY74" fmla="*/ 235028 h 816053"/>
              <a:gd name="connsiteX75" fmla="*/ 504825 w 594397"/>
              <a:gd name="connsiteY75" fmla="*/ 206453 h 816053"/>
              <a:gd name="connsiteX76" fmla="*/ 495300 w 594397"/>
              <a:gd name="connsiteY76" fmla="*/ 187403 h 816053"/>
              <a:gd name="connsiteX77" fmla="*/ 485775 w 594397"/>
              <a:gd name="connsiteY77" fmla="*/ 181053 h 816053"/>
              <a:gd name="connsiteX78" fmla="*/ 473075 w 594397"/>
              <a:gd name="connsiteY78" fmla="*/ 162003 h 816053"/>
              <a:gd name="connsiteX79" fmla="*/ 460375 w 594397"/>
              <a:gd name="connsiteY79" fmla="*/ 142953 h 816053"/>
              <a:gd name="connsiteX80" fmla="*/ 450850 w 594397"/>
              <a:gd name="connsiteY80" fmla="*/ 133428 h 816053"/>
              <a:gd name="connsiteX81" fmla="*/ 438150 w 594397"/>
              <a:gd name="connsiteY81" fmla="*/ 114378 h 816053"/>
              <a:gd name="connsiteX82" fmla="*/ 428625 w 594397"/>
              <a:gd name="connsiteY82" fmla="*/ 108028 h 816053"/>
              <a:gd name="connsiteX83" fmla="*/ 419100 w 594397"/>
              <a:gd name="connsiteY83" fmla="*/ 98503 h 816053"/>
              <a:gd name="connsiteX84" fmla="*/ 409575 w 594397"/>
              <a:gd name="connsiteY84" fmla="*/ 92153 h 816053"/>
              <a:gd name="connsiteX85" fmla="*/ 400050 w 594397"/>
              <a:gd name="connsiteY85" fmla="*/ 82628 h 816053"/>
              <a:gd name="connsiteX86" fmla="*/ 381000 w 594397"/>
              <a:gd name="connsiteY86" fmla="*/ 69928 h 816053"/>
              <a:gd name="connsiteX87" fmla="*/ 365125 w 594397"/>
              <a:gd name="connsiteY87" fmla="*/ 50878 h 816053"/>
              <a:gd name="connsiteX88" fmla="*/ 336550 w 594397"/>
              <a:gd name="connsiteY88" fmla="*/ 31828 h 816053"/>
              <a:gd name="connsiteX89" fmla="*/ 317500 w 594397"/>
              <a:gd name="connsiteY89" fmla="*/ 25478 h 816053"/>
              <a:gd name="connsiteX90" fmla="*/ 279400 w 594397"/>
              <a:gd name="connsiteY90" fmla="*/ 12778 h 816053"/>
              <a:gd name="connsiteX91" fmla="*/ 231775 w 594397"/>
              <a:gd name="connsiteY91" fmla="*/ 9603 h 816053"/>
              <a:gd name="connsiteX92" fmla="*/ 212725 w 594397"/>
              <a:gd name="connsiteY92" fmla="*/ 78 h 8160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</a:cxnLst>
            <a:rect l="l" t="t" r="r" b="b"/>
            <a:pathLst>
              <a:path w="594397" h="816053">
                <a:moveTo>
                  <a:pt x="212725" y="78"/>
                </a:moveTo>
                <a:cubicBezTo>
                  <a:pt x="202142" y="1136"/>
                  <a:pt x="183393" y="9234"/>
                  <a:pt x="168275" y="15953"/>
                </a:cubicBezTo>
                <a:cubicBezTo>
                  <a:pt x="163950" y="17875"/>
                  <a:pt x="159925" y="20439"/>
                  <a:pt x="155575" y="22303"/>
                </a:cubicBezTo>
                <a:cubicBezTo>
                  <a:pt x="147962" y="25566"/>
                  <a:pt x="141406" y="26351"/>
                  <a:pt x="133350" y="28653"/>
                </a:cubicBezTo>
                <a:cubicBezTo>
                  <a:pt x="130132" y="29572"/>
                  <a:pt x="127000" y="30770"/>
                  <a:pt x="123825" y="31828"/>
                </a:cubicBezTo>
                <a:lnTo>
                  <a:pt x="104775" y="44528"/>
                </a:lnTo>
                <a:lnTo>
                  <a:pt x="95250" y="50878"/>
                </a:lnTo>
                <a:cubicBezTo>
                  <a:pt x="93133" y="54053"/>
                  <a:pt x="91772" y="57890"/>
                  <a:pt x="88900" y="60403"/>
                </a:cubicBezTo>
                <a:cubicBezTo>
                  <a:pt x="83157" y="65429"/>
                  <a:pt x="69850" y="73103"/>
                  <a:pt x="69850" y="73103"/>
                </a:cubicBezTo>
                <a:lnTo>
                  <a:pt x="44450" y="111203"/>
                </a:lnTo>
                <a:cubicBezTo>
                  <a:pt x="40737" y="116772"/>
                  <a:pt x="40217" y="123903"/>
                  <a:pt x="38100" y="130253"/>
                </a:cubicBezTo>
                <a:lnTo>
                  <a:pt x="31750" y="149303"/>
                </a:lnTo>
                <a:cubicBezTo>
                  <a:pt x="30692" y="152478"/>
                  <a:pt x="30431" y="156043"/>
                  <a:pt x="28575" y="158828"/>
                </a:cubicBezTo>
                <a:lnTo>
                  <a:pt x="22225" y="168353"/>
                </a:lnTo>
                <a:cubicBezTo>
                  <a:pt x="21167" y="174703"/>
                  <a:pt x="20399" y="181108"/>
                  <a:pt x="19050" y="187403"/>
                </a:cubicBezTo>
                <a:lnTo>
                  <a:pt x="9525" y="225503"/>
                </a:lnTo>
                <a:cubicBezTo>
                  <a:pt x="8713" y="228750"/>
                  <a:pt x="7231" y="231799"/>
                  <a:pt x="6350" y="235028"/>
                </a:cubicBezTo>
                <a:cubicBezTo>
                  <a:pt x="4054" y="243448"/>
                  <a:pt x="0" y="260428"/>
                  <a:pt x="0" y="260428"/>
                </a:cubicBezTo>
                <a:cubicBezTo>
                  <a:pt x="1058" y="306995"/>
                  <a:pt x="1195" y="353591"/>
                  <a:pt x="3175" y="400128"/>
                </a:cubicBezTo>
                <a:cubicBezTo>
                  <a:pt x="3317" y="403472"/>
                  <a:pt x="5431" y="406435"/>
                  <a:pt x="6350" y="409653"/>
                </a:cubicBezTo>
                <a:cubicBezTo>
                  <a:pt x="7549" y="413849"/>
                  <a:pt x="8271" y="418173"/>
                  <a:pt x="9525" y="422353"/>
                </a:cubicBezTo>
                <a:cubicBezTo>
                  <a:pt x="11448" y="428764"/>
                  <a:pt x="13758" y="435053"/>
                  <a:pt x="15875" y="441403"/>
                </a:cubicBezTo>
                <a:lnTo>
                  <a:pt x="22225" y="460453"/>
                </a:lnTo>
                <a:cubicBezTo>
                  <a:pt x="23283" y="463628"/>
                  <a:pt x="23544" y="467193"/>
                  <a:pt x="25400" y="469978"/>
                </a:cubicBezTo>
                <a:lnTo>
                  <a:pt x="38100" y="489028"/>
                </a:lnTo>
                <a:cubicBezTo>
                  <a:pt x="41813" y="494597"/>
                  <a:pt x="40737" y="502509"/>
                  <a:pt x="44450" y="508078"/>
                </a:cubicBezTo>
                <a:cubicBezTo>
                  <a:pt x="48683" y="514428"/>
                  <a:pt x="54737" y="519888"/>
                  <a:pt x="57150" y="527128"/>
                </a:cubicBezTo>
                <a:cubicBezTo>
                  <a:pt x="58208" y="530303"/>
                  <a:pt x="58828" y="533660"/>
                  <a:pt x="60325" y="536653"/>
                </a:cubicBezTo>
                <a:cubicBezTo>
                  <a:pt x="62032" y="540066"/>
                  <a:pt x="64968" y="542765"/>
                  <a:pt x="66675" y="546178"/>
                </a:cubicBezTo>
                <a:cubicBezTo>
                  <a:pt x="68172" y="549171"/>
                  <a:pt x="67994" y="552918"/>
                  <a:pt x="69850" y="555703"/>
                </a:cubicBezTo>
                <a:cubicBezTo>
                  <a:pt x="72341" y="559439"/>
                  <a:pt x="76618" y="561684"/>
                  <a:pt x="79375" y="565228"/>
                </a:cubicBezTo>
                <a:cubicBezTo>
                  <a:pt x="84060" y="571252"/>
                  <a:pt x="87842" y="577928"/>
                  <a:pt x="92075" y="584278"/>
                </a:cubicBezTo>
                <a:cubicBezTo>
                  <a:pt x="93931" y="587063"/>
                  <a:pt x="93625" y="590877"/>
                  <a:pt x="95250" y="593803"/>
                </a:cubicBezTo>
                <a:cubicBezTo>
                  <a:pt x="98956" y="600474"/>
                  <a:pt x="103717" y="606503"/>
                  <a:pt x="107950" y="612853"/>
                </a:cubicBezTo>
                <a:lnTo>
                  <a:pt x="133350" y="650953"/>
                </a:lnTo>
                <a:lnTo>
                  <a:pt x="152400" y="679528"/>
                </a:lnTo>
                <a:cubicBezTo>
                  <a:pt x="156633" y="685878"/>
                  <a:pt x="171450" y="692228"/>
                  <a:pt x="171450" y="692228"/>
                </a:cubicBezTo>
                <a:cubicBezTo>
                  <a:pt x="189648" y="719525"/>
                  <a:pt x="165417" y="687401"/>
                  <a:pt x="187325" y="704928"/>
                </a:cubicBezTo>
                <a:cubicBezTo>
                  <a:pt x="207841" y="721341"/>
                  <a:pt x="179259" y="709648"/>
                  <a:pt x="203200" y="717628"/>
                </a:cubicBezTo>
                <a:cubicBezTo>
                  <a:pt x="205317" y="720803"/>
                  <a:pt x="206678" y="724640"/>
                  <a:pt x="209550" y="727153"/>
                </a:cubicBezTo>
                <a:cubicBezTo>
                  <a:pt x="215293" y="732179"/>
                  <a:pt x="228600" y="739853"/>
                  <a:pt x="228600" y="739853"/>
                </a:cubicBezTo>
                <a:cubicBezTo>
                  <a:pt x="243417" y="762078"/>
                  <a:pt x="234950" y="754670"/>
                  <a:pt x="250825" y="765253"/>
                </a:cubicBezTo>
                <a:cubicBezTo>
                  <a:pt x="252942" y="768428"/>
                  <a:pt x="254477" y="772080"/>
                  <a:pt x="257175" y="774778"/>
                </a:cubicBezTo>
                <a:cubicBezTo>
                  <a:pt x="263330" y="780933"/>
                  <a:pt x="268478" y="781721"/>
                  <a:pt x="276225" y="784303"/>
                </a:cubicBezTo>
                <a:cubicBezTo>
                  <a:pt x="278342" y="787478"/>
                  <a:pt x="279877" y="791130"/>
                  <a:pt x="282575" y="793828"/>
                </a:cubicBezTo>
                <a:cubicBezTo>
                  <a:pt x="290122" y="801375"/>
                  <a:pt x="301719" y="803384"/>
                  <a:pt x="311150" y="806528"/>
                </a:cubicBezTo>
                <a:lnTo>
                  <a:pt x="320675" y="809703"/>
                </a:lnTo>
                <a:cubicBezTo>
                  <a:pt x="327639" y="812024"/>
                  <a:pt x="353741" y="815334"/>
                  <a:pt x="358775" y="816053"/>
                </a:cubicBezTo>
                <a:cubicBezTo>
                  <a:pt x="377825" y="814995"/>
                  <a:pt x="396993" y="815245"/>
                  <a:pt x="415925" y="812878"/>
                </a:cubicBezTo>
                <a:cubicBezTo>
                  <a:pt x="422567" y="812048"/>
                  <a:pt x="428625" y="808645"/>
                  <a:pt x="434975" y="806528"/>
                </a:cubicBezTo>
                <a:cubicBezTo>
                  <a:pt x="442075" y="804161"/>
                  <a:pt x="449792" y="804411"/>
                  <a:pt x="457200" y="803353"/>
                </a:cubicBezTo>
                <a:cubicBezTo>
                  <a:pt x="463550" y="801236"/>
                  <a:pt x="471517" y="801736"/>
                  <a:pt x="476250" y="797003"/>
                </a:cubicBezTo>
                <a:cubicBezTo>
                  <a:pt x="488142" y="785111"/>
                  <a:pt x="481515" y="788898"/>
                  <a:pt x="495300" y="784303"/>
                </a:cubicBezTo>
                <a:cubicBezTo>
                  <a:pt x="498475" y="781128"/>
                  <a:pt x="501281" y="777535"/>
                  <a:pt x="504825" y="774778"/>
                </a:cubicBezTo>
                <a:cubicBezTo>
                  <a:pt x="510849" y="770093"/>
                  <a:pt x="517525" y="766311"/>
                  <a:pt x="523875" y="762078"/>
                </a:cubicBezTo>
                <a:cubicBezTo>
                  <a:pt x="527050" y="759961"/>
                  <a:pt x="530702" y="758426"/>
                  <a:pt x="533400" y="755728"/>
                </a:cubicBezTo>
                <a:lnTo>
                  <a:pt x="542925" y="746203"/>
                </a:lnTo>
                <a:cubicBezTo>
                  <a:pt x="550474" y="723555"/>
                  <a:pt x="539770" y="750936"/>
                  <a:pt x="555625" y="727153"/>
                </a:cubicBezTo>
                <a:cubicBezTo>
                  <a:pt x="557481" y="724368"/>
                  <a:pt x="557303" y="720621"/>
                  <a:pt x="558800" y="717628"/>
                </a:cubicBezTo>
                <a:cubicBezTo>
                  <a:pt x="560507" y="714215"/>
                  <a:pt x="563443" y="711516"/>
                  <a:pt x="565150" y="708103"/>
                </a:cubicBezTo>
                <a:cubicBezTo>
                  <a:pt x="566647" y="705110"/>
                  <a:pt x="566828" y="701571"/>
                  <a:pt x="568325" y="698578"/>
                </a:cubicBezTo>
                <a:cubicBezTo>
                  <a:pt x="570032" y="695165"/>
                  <a:pt x="573125" y="692540"/>
                  <a:pt x="574675" y="689053"/>
                </a:cubicBezTo>
                <a:cubicBezTo>
                  <a:pt x="577393" y="682936"/>
                  <a:pt x="581025" y="670003"/>
                  <a:pt x="581025" y="670003"/>
                </a:cubicBezTo>
                <a:cubicBezTo>
                  <a:pt x="582083" y="656245"/>
                  <a:pt x="582676" y="642443"/>
                  <a:pt x="584200" y="628728"/>
                </a:cubicBezTo>
                <a:cubicBezTo>
                  <a:pt x="585853" y="613852"/>
                  <a:pt x="590550" y="584278"/>
                  <a:pt x="590550" y="584278"/>
                </a:cubicBezTo>
                <a:cubicBezTo>
                  <a:pt x="594408" y="503254"/>
                  <a:pt x="596814" y="486653"/>
                  <a:pt x="590550" y="390603"/>
                </a:cubicBezTo>
                <a:cubicBezTo>
                  <a:pt x="590114" y="383924"/>
                  <a:pt x="586317" y="377903"/>
                  <a:pt x="584200" y="371553"/>
                </a:cubicBezTo>
                <a:lnTo>
                  <a:pt x="577850" y="352503"/>
                </a:lnTo>
                <a:cubicBezTo>
                  <a:pt x="576643" y="348883"/>
                  <a:pt x="573207" y="346391"/>
                  <a:pt x="571500" y="342978"/>
                </a:cubicBezTo>
                <a:cubicBezTo>
                  <a:pt x="568832" y="337643"/>
                  <a:pt x="566676" y="325839"/>
                  <a:pt x="565150" y="320753"/>
                </a:cubicBezTo>
                <a:cubicBezTo>
                  <a:pt x="563227" y="314342"/>
                  <a:pt x="560917" y="308053"/>
                  <a:pt x="558800" y="301703"/>
                </a:cubicBezTo>
                <a:cubicBezTo>
                  <a:pt x="557593" y="298083"/>
                  <a:pt x="554000" y="295665"/>
                  <a:pt x="552450" y="292178"/>
                </a:cubicBezTo>
                <a:lnTo>
                  <a:pt x="542925" y="263603"/>
                </a:lnTo>
                <a:cubicBezTo>
                  <a:pt x="540512" y="256363"/>
                  <a:pt x="534458" y="250903"/>
                  <a:pt x="530225" y="244553"/>
                </a:cubicBezTo>
                <a:cubicBezTo>
                  <a:pt x="528369" y="241768"/>
                  <a:pt x="528675" y="237954"/>
                  <a:pt x="527050" y="235028"/>
                </a:cubicBezTo>
                <a:cubicBezTo>
                  <a:pt x="517556" y="217938"/>
                  <a:pt x="516395" y="218023"/>
                  <a:pt x="504825" y="206453"/>
                </a:cubicBezTo>
                <a:cubicBezTo>
                  <a:pt x="502243" y="198706"/>
                  <a:pt x="501455" y="193558"/>
                  <a:pt x="495300" y="187403"/>
                </a:cubicBezTo>
                <a:cubicBezTo>
                  <a:pt x="492602" y="184705"/>
                  <a:pt x="488950" y="183170"/>
                  <a:pt x="485775" y="181053"/>
                </a:cubicBezTo>
                <a:cubicBezTo>
                  <a:pt x="479703" y="162837"/>
                  <a:pt x="486948" y="179840"/>
                  <a:pt x="473075" y="162003"/>
                </a:cubicBezTo>
                <a:cubicBezTo>
                  <a:pt x="468390" y="155979"/>
                  <a:pt x="464608" y="149303"/>
                  <a:pt x="460375" y="142953"/>
                </a:cubicBezTo>
                <a:cubicBezTo>
                  <a:pt x="457884" y="139217"/>
                  <a:pt x="453607" y="136972"/>
                  <a:pt x="450850" y="133428"/>
                </a:cubicBezTo>
                <a:cubicBezTo>
                  <a:pt x="446165" y="127404"/>
                  <a:pt x="442383" y="120728"/>
                  <a:pt x="438150" y="114378"/>
                </a:cubicBezTo>
                <a:cubicBezTo>
                  <a:pt x="436033" y="111203"/>
                  <a:pt x="431556" y="110471"/>
                  <a:pt x="428625" y="108028"/>
                </a:cubicBezTo>
                <a:cubicBezTo>
                  <a:pt x="425176" y="105153"/>
                  <a:pt x="422549" y="101378"/>
                  <a:pt x="419100" y="98503"/>
                </a:cubicBezTo>
                <a:cubicBezTo>
                  <a:pt x="416169" y="96060"/>
                  <a:pt x="412506" y="94596"/>
                  <a:pt x="409575" y="92153"/>
                </a:cubicBezTo>
                <a:cubicBezTo>
                  <a:pt x="406126" y="89278"/>
                  <a:pt x="403594" y="85385"/>
                  <a:pt x="400050" y="82628"/>
                </a:cubicBezTo>
                <a:cubicBezTo>
                  <a:pt x="394026" y="77943"/>
                  <a:pt x="381000" y="69928"/>
                  <a:pt x="381000" y="69928"/>
                </a:cubicBezTo>
                <a:cubicBezTo>
                  <a:pt x="375356" y="61461"/>
                  <a:pt x="373587" y="57460"/>
                  <a:pt x="365125" y="50878"/>
                </a:cubicBezTo>
                <a:lnTo>
                  <a:pt x="336550" y="31828"/>
                </a:lnTo>
                <a:cubicBezTo>
                  <a:pt x="330981" y="28115"/>
                  <a:pt x="323850" y="27595"/>
                  <a:pt x="317500" y="25478"/>
                </a:cubicBezTo>
                <a:lnTo>
                  <a:pt x="279400" y="12778"/>
                </a:lnTo>
                <a:cubicBezTo>
                  <a:pt x="264306" y="7747"/>
                  <a:pt x="247679" y="10057"/>
                  <a:pt x="231775" y="9603"/>
                </a:cubicBezTo>
                <a:cubicBezTo>
                  <a:pt x="210617" y="8998"/>
                  <a:pt x="223308" y="-980"/>
                  <a:pt x="212725" y="78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11" name="フリーフォーム 110"/>
          <p:cNvSpPr/>
          <p:nvPr/>
        </p:nvSpPr>
        <p:spPr>
          <a:xfrm>
            <a:off x="2051720" y="921420"/>
            <a:ext cx="594397" cy="816053"/>
          </a:xfrm>
          <a:custGeom>
            <a:avLst/>
            <a:gdLst>
              <a:gd name="connsiteX0" fmla="*/ 212725 w 594397"/>
              <a:gd name="connsiteY0" fmla="*/ 78 h 816053"/>
              <a:gd name="connsiteX1" fmla="*/ 168275 w 594397"/>
              <a:gd name="connsiteY1" fmla="*/ 15953 h 816053"/>
              <a:gd name="connsiteX2" fmla="*/ 155575 w 594397"/>
              <a:gd name="connsiteY2" fmla="*/ 22303 h 816053"/>
              <a:gd name="connsiteX3" fmla="*/ 133350 w 594397"/>
              <a:gd name="connsiteY3" fmla="*/ 28653 h 816053"/>
              <a:gd name="connsiteX4" fmla="*/ 123825 w 594397"/>
              <a:gd name="connsiteY4" fmla="*/ 31828 h 816053"/>
              <a:gd name="connsiteX5" fmla="*/ 104775 w 594397"/>
              <a:gd name="connsiteY5" fmla="*/ 44528 h 816053"/>
              <a:gd name="connsiteX6" fmla="*/ 95250 w 594397"/>
              <a:gd name="connsiteY6" fmla="*/ 50878 h 816053"/>
              <a:gd name="connsiteX7" fmla="*/ 88900 w 594397"/>
              <a:gd name="connsiteY7" fmla="*/ 60403 h 816053"/>
              <a:gd name="connsiteX8" fmla="*/ 69850 w 594397"/>
              <a:gd name="connsiteY8" fmla="*/ 73103 h 816053"/>
              <a:gd name="connsiteX9" fmla="*/ 44450 w 594397"/>
              <a:gd name="connsiteY9" fmla="*/ 111203 h 816053"/>
              <a:gd name="connsiteX10" fmla="*/ 38100 w 594397"/>
              <a:gd name="connsiteY10" fmla="*/ 130253 h 816053"/>
              <a:gd name="connsiteX11" fmla="*/ 31750 w 594397"/>
              <a:gd name="connsiteY11" fmla="*/ 149303 h 816053"/>
              <a:gd name="connsiteX12" fmla="*/ 28575 w 594397"/>
              <a:gd name="connsiteY12" fmla="*/ 158828 h 816053"/>
              <a:gd name="connsiteX13" fmla="*/ 22225 w 594397"/>
              <a:gd name="connsiteY13" fmla="*/ 168353 h 816053"/>
              <a:gd name="connsiteX14" fmla="*/ 19050 w 594397"/>
              <a:gd name="connsiteY14" fmla="*/ 187403 h 816053"/>
              <a:gd name="connsiteX15" fmla="*/ 9525 w 594397"/>
              <a:gd name="connsiteY15" fmla="*/ 225503 h 816053"/>
              <a:gd name="connsiteX16" fmla="*/ 6350 w 594397"/>
              <a:gd name="connsiteY16" fmla="*/ 235028 h 816053"/>
              <a:gd name="connsiteX17" fmla="*/ 0 w 594397"/>
              <a:gd name="connsiteY17" fmla="*/ 260428 h 816053"/>
              <a:gd name="connsiteX18" fmla="*/ 3175 w 594397"/>
              <a:gd name="connsiteY18" fmla="*/ 400128 h 816053"/>
              <a:gd name="connsiteX19" fmla="*/ 6350 w 594397"/>
              <a:gd name="connsiteY19" fmla="*/ 409653 h 816053"/>
              <a:gd name="connsiteX20" fmla="*/ 9525 w 594397"/>
              <a:gd name="connsiteY20" fmla="*/ 422353 h 816053"/>
              <a:gd name="connsiteX21" fmla="*/ 15875 w 594397"/>
              <a:gd name="connsiteY21" fmla="*/ 441403 h 816053"/>
              <a:gd name="connsiteX22" fmla="*/ 22225 w 594397"/>
              <a:gd name="connsiteY22" fmla="*/ 460453 h 816053"/>
              <a:gd name="connsiteX23" fmla="*/ 25400 w 594397"/>
              <a:gd name="connsiteY23" fmla="*/ 469978 h 816053"/>
              <a:gd name="connsiteX24" fmla="*/ 38100 w 594397"/>
              <a:gd name="connsiteY24" fmla="*/ 489028 h 816053"/>
              <a:gd name="connsiteX25" fmla="*/ 44450 w 594397"/>
              <a:gd name="connsiteY25" fmla="*/ 508078 h 816053"/>
              <a:gd name="connsiteX26" fmla="*/ 57150 w 594397"/>
              <a:gd name="connsiteY26" fmla="*/ 527128 h 816053"/>
              <a:gd name="connsiteX27" fmla="*/ 60325 w 594397"/>
              <a:gd name="connsiteY27" fmla="*/ 536653 h 816053"/>
              <a:gd name="connsiteX28" fmla="*/ 66675 w 594397"/>
              <a:gd name="connsiteY28" fmla="*/ 546178 h 816053"/>
              <a:gd name="connsiteX29" fmla="*/ 69850 w 594397"/>
              <a:gd name="connsiteY29" fmla="*/ 555703 h 816053"/>
              <a:gd name="connsiteX30" fmla="*/ 79375 w 594397"/>
              <a:gd name="connsiteY30" fmla="*/ 565228 h 816053"/>
              <a:gd name="connsiteX31" fmla="*/ 92075 w 594397"/>
              <a:gd name="connsiteY31" fmla="*/ 584278 h 816053"/>
              <a:gd name="connsiteX32" fmla="*/ 95250 w 594397"/>
              <a:gd name="connsiteY32" fmla="*/ 593803 h 816053"/>
              <a:gd name="connsiteX33" fmla="*/ 107950 w 594397"/>
              <a:gd name="connsiteY33" fmla="*/ 612853 h 816053"/>
              <a:gd name="connsiteX34" fmla="*/ 133350 w 594397"/>
              <a:gd name="connsiteY34" fmla="*/ 650953 h 816053"/>
              <a:gd name="connsiteX35" fmla="*/ 152400 w 594397"/>
              <a:gd name="connsiteY35" fmla="*/ 679528 h 816053"/>
              <a:gd name="connsiteX36" fmla="*/ 171450 w 594397"/>
              <a:gd name="connsiteY36" fmla="*/ 692228 h 816053"/>
              <a:gd name="connsiteX37" fmla="*/ 187325 w 594397"/>
              <a:gd name="connsiteY37" fmla="*/ 704928 h 816053"/>
              <a:gd name="connsiteX38" fmla="*/ 203200 w 594397"/>
              <a:gd name="connsiteY38" fmla="*/ 717628 h 816053"/>
              <a:gd name="connsiteX39" fmla="*/ 209550 w 594397"/>
              <a:gd name="connsiteY39" fmla="*/ 727153 h 816053"/>
              <a:gd name="connsiteX40" fmla="*/ 228600 w 594397"/>
              <a:gd name="connsiteY40" fmla="*/ 739853 h 816053"/>
              <a:gd name="connsiteX41" fmla="*/ 250825 w 594397"/>
              <a:gd name="connsiteY41" fmla="*/ 765253 h 816053"/>
              <a:gd name="connsiteX42" fmla="*/ 257175 w 594397"/>
              <a:gd name="connsiteY42" fmla="*/ 774778 h 816053"/>
              <a:gd name="connsiteX43" fmla="*/ 276225 w 594397"/>
              <a:gd name="connsiteY43" fmla="*/ 784303 h 816053"/>
              <a:gd name="connsiteX44" fmla="*/ 282575 w 594397"/>
              <a:gd name="connsiteY44" fmla="*/ 793828 h 816053"/>
              <a:gd name="connsiteX45" fmla="*/ 311150 w 594397"/>
              <a:gd name="connsiteY45" fmla="*/ 806528 h 816053"/>
              <a:gd name="connsiteX46" fmla="*/ 320675 w 594397"/>
              <a:gd name="connsiteY46" fmla="*/ 809703 h 816053"/>
              <a:gd name="connsiteX47" fmla="*/ 358775 w 594397"/>
              <a:gd name="connsiteY47" fmla="*/ 816053 h 816053"/>
              <a:gd name="connsiteX48" fmla="*/ 415925 w 594397"/>
              <a:gd name="connsiteY48" fmla="*/ 812878 h 816053"/>
              <a:gd name="connsiteX49" fmla="*/ 434975 w 594397"/>
              <a:gd name="connsiteY49" fmla="*/ 806528 h 816053"/>
              <a:gd name="connsiteX50" fmla="*/ 457200 w 594397"/>
              <a:gd name="connsiteY50" fmla="*/ 803353 h 816053"/>
              <a:gd name="connsiteX51" fmla="*/ 476250 w 594397"/>
              <a:gd name="connsiteY51" fmla="*/ 797003 h 816053"/>
              <a:gd name="connsiteX52" fmla="*/ 495300 w 594397"/>
              <a:gd name="connsiteY52" fmla="*/ 784303 h 816053"/>
              <a:gd name="connsiteX53" fmla="*/ 504825 w 594397"/>
              <a:gd name="connsiteY53" fmla="*/ 774778 h 816053"/>
              <a:gd name="connsiteX54" fmla="*/ 523875 w 594397"/>
              <a:gd name="connsiteY54" fmla="*/ 762078 h 816053"/>
              <a:gd name="connsiteX55" fmla="*/ 533400 w 594397"/>
              <a:gd name="connsiteY55" fmla="*/ 755728 h 816053"/>
              <a:gd name="connsiteX56" fmla="*/ 542925 w 594397"/>
              <a:gd name="connsiteY56" fmla="*/ 746203 h 816053"/>
              <a:gd name="connsiteX57" fmla="*/ 555625 w 594397"/>
              <a:gd name="connsiteY57" fmla="*/ 727153 h 816053"/>
              <a:gd name="connsiteX58" fmla="*/ 558800 w 594397"/>
              <a:gd name="connsiteY58" fmla="*/ 717628 h 816053"/>
              <a:gd name="connsiteX59" fmla="*/ 565150 w 594397"/>
              <a:gd name="connsiteY59" fmla="*/ 708103 h 816053"/>
              <a:gd name="connsiteX60" fmla="*/ 568325 w 594397"/>
              <a:gd name="connsiteY60" fmla="*/ 698578 h 816053"/>
              <a:gd name="connsiteX61" fmla="*/ 574675 w 594397"/>
              <a:gd name="connsiteY61" fmla="*/ 689053 h 816053"/>
              <a:gd name="connsiteX62" fmla="*/ 581025 w 594397"/>
              <a:gd name="connsiteY62" fmla="*/ 670003 h 816053"/>
              <a:gd name="connsiteX63" fmla="*/ 584200 w 594397"/>
              <a:gd name="connsiteY63" fmla="*/ 628728 h 816053"/>
              <a:gd name="connsiteX64" fmla="*/ 590550 w 594397"/>
              <a:gd name="connsiteY64" fmla="*/ 584278 h 816053"/>
              <a:gd name="connsiteX65" fmla="*/ 590550 w 594397"/>
              <a:gd name="connsiteY65" fmla="*/ 390603 h 816053"/>
              <a:gd name="connsiteX66" fmla="*/ 584200 w 594397"/>
              <a:gd name="connsiteY66" fmla="*/ 371553 h 816053"/>
              <a:gd name="connsiteX67" fmla="*/ 577850 w 594397"/>
              <a:gd name="connsiteY67" fmla="*/ 352503 h 816053"/>
              <a:gd name="connsiteX68" fmla="*/ 571500 w 594397"/>
              <a:gd name="connsiteY68" fmla="*/ 342978 h 816053"/>
              <a:gd name="connsiteX69" fmla="*/ 565150 w 594397"/>
              <a:gd name="connsiteY69" fmla="*/ 320753 h 816053"/>
              <a:gd name="connsiteX70" fmla="*/ 558800 w 594397"/>
              <a:gd name="connsiteY70" fmla="*/ 301703 h 816053"/>
              <a:gd name="connsiteX71" fmla="*/ 552450 w 594397"/>
              <a:gd name="connsiteY71" fmla="*/ 292178 h 816053"/>
              <a:gd name="connsiteX72" fmla="*/ 542925 w 594397"/>
              <a:gd name="connsiteY72" fmla="*/ 263603 h 816053"/>
              <a:gd name="connsiteX73" fmla="*/ 530225 w 594397"/>
              <a:gd name="connsiteY73" fmla="*/ 244553 h 816053"/>
              <a:gd name="connsiteX74" fmla="*/ 527050 w 594397"/>
              <a:gd name="connsiteY74" fmla="*/ 235028 h 816053"/>
              <a:gd name="connsiteX75" fmla="*/ 504825 w 594397"/>
              <a:gd name="connsiteY75" fmla="*/ 206453 h 816053"/>
              <a:gd name="connsiteX76" fmla="*/ 495300 w 594397"/>
              <a:gd name="connsiteY76" fmla="*/ 187403 h 816053"/>
              <a:gd name="connsiteX77" fmla="*/ 485775 w 594397"/>
              <a:gd name="connsiteY77" fmla="*/ 181053 h 816053"/>
              <a:gd name="connsiteX78" fmla="*/ 473075 w 594397"/>
              <a:gd name="connsiteY78" fmla="*/ 162003 h 816053"/>
              <a:gd name="connsiteX79" fmla="*/ 460375 w 594397"/>
              <a:gd name="connsiteY79" fmla="*/ 142953 h 816053"/>
              <a:gd name="connsiteX80" fmla="*/ 450850 w 594397"/>
              <a:gd name="connsiteY80" fmla="*/ 133428 h 816053"/>
              <a:gd name="connsiteX81" fmla="*/ 438150 w 594397"/>
              <a:gd name="connsiteY81" fmla="*/ 114378 h 816053"/>
              <a:gd name="connsiteX82" fmla="*/ 428625 w 594397"/>
              <a:gd name="connsiteY82" fmla="*/ 108028 h 816053"/>
              <a:gd name="connsiteX83" fmla="*/ 419100 w 594397"/>
              <a:gd name="connsiteY83" fmla="*/ 98503 h 816053"/>
              <a:gd name="connsiteX84" fmla="*/ 409575 w 594397"/>
              <a:gd name="connsiteY84" fmla="*/ 92153 h 816053"/>
              <a:gd name="connsiteX85" fmla="*/ 400050 w 594397"/>
              <a:gd name="connsiteY85" fmla="*/ 82628 h 816053"/>
              <a:gd name="connsiteX86" fmla="*/ 381000 w 594397"/>
              <a:gd name="connsiteY86" fmla="*/ 69928 h 816053"/>
              <a:gd name="connsiteX87" fmla="*/ 365125 w 594397"/>
              <a:gd name="connsiteY87" fmla="*/ 50878 h 816053"/>
              <a:gd name="connsiteX88" fmla="*/ 336550 w 594397"/>
              <a:gd name="connsiteY88" fmla="*/ 31828 h 816053"/>
              <a:gd name="connsiteX89" fmla="*/ 317500 w 594397"/>
              <a:gd name="connsiteY89" fmla="*/ 25478 h 816053"/>
              <a:gd name="connsiteX90" fmla="*/ 279400 w 594397"/>
              <a:gd name="connsiteY90" fmla="*/ 12778 h 816053"/>
              <a:gd name="connsiteX91" fmla="*/ 231775 w 594397"/>
              <a:gd name="connsiteY91" fmla="*/ 9603 h 816053"/>
              <a:gd name="connsiteX92" fmla="*/ 212725 w 594397"/>
              <a:gd name="connsiteY92" fmla="*/ 78 h 8160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</a:cxnLst>
            <a:rect l="l" t="t" r="r" b="b"/>
            <a:pathLst>
              <a:path w="594397" h="816053">
                <a:moveTo>
                  <a:pt x="212725" y="78"/>
                </a:moveTo>
                <a:cubicBezTo>
                  <a:pt x="202142" y="1136"/>
                  <a:pt x="183393" y="9234"/>
                  <a:pt x="168275" y="15953"/>
                </a:cubicBezTo>
                <a:cubicBezTo>
                  <a:pt x="163950" y="17875"/>
                  <a:pt x="159925" y="20439"/>
                  <a:pt x="155575" y="22303"/>
                </a:cubicBezTo>
                <a:cubicBezTo>
                  <a:pt x="147962" y="25566"/>
                  <a:pt x="141406" y="26351"/>
                  <a:pt x="133350" y="28653"/>
                </a:cubicBezTo>
                <a:cubicBezTo>
                  <a:pt x="130132" y="29572"/>
                  <a:pt x="127000" y="30770"/>
                  <a:pt x="123825" y="31828"/>
                </a:cubicBezTo>
                <a:lnTo>
                  <a:pt x="104775" y="44528"/>
                </a:lnTo>
                <a:lnTo>
                  <a:pt x="95250" y="50878"/>
                </a:lnTo>
                <a:cubicBezTo>
                  <a:pt x="93133" y="54053"/>
                  <a:pt x="91772" y="57890"/>
                  <a:pt x="88900" y="60403"/>
                </a:cubicBezTo>
                <a:cubicBezTo>
                  <a:pt x="83157" y="65429"/>
                  <a:pt x="69850" y="73103"/>
                  <a:pt x="69850" y="73103"/>
                </a:cubicBezTo>
                <a:lnTo>
                  <a:pt x="44450" y="111203"/>
                </a:lnTo>
                <a:cubicBezTo>
                  <a:pt x="40737" y="116772"/>
                  <a:pt x="40217" y="123903"/>
                  <a:pt x="38100" y="130253"/>
                </a:cubicBezTo>
                <a:lnTo>
                  <a:pt x="31750" y="149303"/>
                </a:lnTo>
                <a:cubicBezTo>
                  <a:pt x="30692" y="152478"/>
                  <a:pt x="30431" y="156043"/>
                  <a:pt x="28575" y="158828"/>
                </a:cubicBezTo>
                <a:lnTo>
                  <a:pt x="22225" y="168353"/>
                </a:lnTo>
                <a:cubicBezTo>
                  <a:pt x="21167" y="174703"/>
                  <a:pt x="20399" y="181108"/>
                  <a:pt x="19050" y="187403"/>
                </a:cubicBezTo>
                <a:lnTo>
                  <a:pt x="9525" y="225503"/>
                </a:lnTo>
                <a:cubicBezTo>
                  <a:pt x="8713" y="228750"/>
                  <a:pt x="7231" y="231799"/>
                  <a:pt x="6350" y="235028"/>
                </a:cubicBezTo>
                <a:cubicBezTo>
                  <a:pt x="4054" y="243448"/>
                  <a:pt x="0" y="260428"/>
                  <a:pt x="0" y="260428"/>
                </a:cubicBezTo>
                <a:cubicBezTo>
                  <a:pt x="1058" y="306995"/>
                  <a:pt x="1195" y="353591"/>
                  <a:pt x="3175" y="400128"/>
                </a:cubicBezTo>
                <a:cubicBezTo>
                  <a:pt x="3317" y="403472"/>
                  <a:pt x="5431" y="406435"/>
                  <a:pt x="6350" y="409653"/>
                </a:cubicBezTo>
                <a:cubicBezTo>
                  <a:pt x="7549" y="413849"/>
                  <a:pt x="8271" y="418173"/>
                  <a:pt x="9525" y="422353"/>
                </a:cubicBezTo>
                <a:cubicBezTo>
                  <a:pt x="11448" y="428764"/>
                  <a:pt x="13758" y="435053"/>
                  <a:pt x="15875" y="441403"/>
                </a:cubicBezTo>
                <a:lnTo>
                  <a:pt x="22225" y="460453"/>
                </a:lnTo>
                <a:cubicBezTo>
                  <a:pt x="23283" y="463628"/>
                  <a:pt x="23544" y="467193"/>
                  <a:pt x="25400" y="469978"/>
                </a:cubicBezTo>
                <a:lnTo>
                  <a:pt x="38100" y="489028"/>
                </a:lnTo>
                <a:cubicBezTo>
                  <a:pt x="41813" y="494597"/>
                  <a:pt x="40737" y="502509"/>
                  <a:pt x="44450" y="508078"/>
                </a:cubicBezTo>
                <a:cubicBezTo>
                  <a:pt x="48683" y="514428"/>
                  <a:pt x="54737" y="519888"/>
                  <a:pt x="57150" y="527128"/>
                </a:cubicBezTo>
                <a:cubicBezTo>
                  <a:pt x="58208" y="530303"/>
                  <a:pt x="58828" y="533660"/>
                  <a:pt x="60325" y="536653"/>
                </a:cubicBezTo>
                <a:cubicBezTo>
                  <a:pt x="62032" y="540066"/>
                  <a:pt x="64968" y="542765"/>
                  <a:pt x="66675" y="546178"/>
                </a:cubicBezTo>
                <a:cubicBezTo>
                  <a:pt x="68172" y="549171"/>
                  <a:pt x="67994" y="552918"/>
                  <a:pt x="69850" y="555703"/>
                </a:cubicBezTo>
                <a:cubicBezTo>
                  <a:pt x="72341" y="559439"/>
                  <a:pt x="76618" y="561684"/>
                  <a:pt x="79375" y="565228"/>
                </a:cubicBezTo>
                <a:cubicBezTo>
                  <a:pt x="84060" y="571252"/>
                  <a:pt x="87842" y="577928"/>
                  <a:pt x="92075" y="584278"/>
                </a:cubicBezTo>
                <a:cubicBezTo>
                  <a:pt x="93931" y="587063"/>
                  <a:pt x="93625" y="590877"/>
                  <a:pt x="95250" y="593803"/>
                </a:cubicBezTo>
                <a:cubicBezTo>
                  <a:pt x="98956" y="600474"/>
                  <a:pt x="103717" y="606503"/>
                  <a:pt x="107950" y="612853"/>
                </a:cubicBezTo>
                <a:lnTo>
                  <a:pt x="133350" y="650953"/>
                </a:lnTo>
                <a:lnTo>
                  <a:pt x="152400" y="679528"/>
                </a:lnTo>
                <a:cubicBezTo>
                  <a:pt x="156633" y="685878"/>
                  <a:pt x="171450" y="692228"/>
                  <a:pt x="171450" y="692228"/>
                </a:cubicBezTo>
                <a:cubicBezTo>
                  <a:pt x="189648" y="719525"/>
                  <a:pt x="165417" y="687401"/>
                  <a:pt x="187325" y="704928"/>
                </a:cubicBezTo>
                <a:cubicBezTo>
                  <a:pt x="207841" y="721341"/>
                  <a:pt x="179259" y="709648"/>
                  <a:pt x="203200" y="717628"/>
                </a:cubicBezTo>
                <a:cubicBezTo>
                  <a:pt x="205317" y="720803"/>
                  <a:pt x="206678" y="724640"/>
                  <a:pt x="209550" y="727153"/>
                </a:cubicBezTo>
                <a:cubicBezTo>
                  <a:pt x="215293" y="732179"/>
                  <a:pt x="228600" y="739853"/>
                  <a:pt x="228600" y="739853"/>
                </a:cubicBezTo>
                <a:cubicBezTo>
                  <a:pt x="243417" y="762078"/>
                  <a:pt x="234950" y="754670"/>
                  <a:pt x="250825" y="765253"/>
                </a:cubicBezTo>
                <a:cubicBezTo>
                  <a:pt x="252942" y="768428"/>
                  <a:pt x="254477" y="772080"/>
                  <a:pt x="257175" y="774778"/>
                </a:cubicBezTo>
                <a:cubicBezTo>
                  <a:pt x="263330" y="780933"/>
                  <a:pt x="268478" y="781721"/>
                  <a:pt x="276225" y="784303"/>
                </a:cubicBezTo>
                <a:cubicBezTo>
                  <a:pt x="278342" y="787478"/>
                  <a:pt x="279877" y="791130"/>
                  <a:pt x="282575" y="793828"/>
                </a:cubicBezTo>
                <a:cubicBezTo>
                  <a:pt x="290122" y="801375"/>
                  <a:pt x="301719" y="803384"/>
                  <a:pt x="311150" y="806528"/>
                </a:cubicBezTo>
                <a:lnTo>
                  <a:pt x="320675" y="809703"/>
                </a:lnTo>
                <a:cubicBezTo>
                  <a:pt x="327639" y="812024"/>
                  <a:pt x="353741" y="815334"/>
                  <a:pt x="358775" y="816053"/>
                </a:cubicBezTo>
                <a:cubicBezTo>
                  <a:pt x="377825" y="814995"/>
                  <a:pt x="396993" y="815245"/>
                  <a:pt x="415925" y="812878"/>
                </a:cubicBezTo>
                <a:cubicBezTo>
                  <a:pt x="422567" y="812048"/>
                  <a:pt x="428625" y="808645"/>
                  <a:pt x="434975" y="806528"/>
                </a:cubicBezTo>
                <a:cubicBezTo>
                  <a:pt x="442075" y="804161"/>
                  <a:pt x="449792" y="804411"/>
                  <a:pt x="457200" y="803353"/>
                </a:cubicBezTo>
                <a:cubicBezTo>
                  <a:pt x="463550" y="801236"/>
                  <a:pt x="471517" y="801736"/>
                  <a:pt x="476250" y="797003"/>
                </a:cubicBezTo>
                <a:cubicBezTo>
                  <a:pt x="488142" y="785111"/>
                  <a:pt x="481515" y="788898"/>
                  <a:pt x="495300" y="784303"/>
                </a:cubicBezTo>
                <a:cubicBezTo>
                  <a:pt x="498475" y="781128"/>
                  <a:pt x="501281" y="777535"/>
                  <a:pt x="504825" y="774778"/>
                </a:cubicBezTo>
                <a:cubicBezTo>
                  <a:pt x="510849" y="770093"/>
                  <a:pt x="517525" y="766311"/>
                  <a:pt x="523875" y="762078"/>
                </a:cubicBezTo>
                <a:cubicBezTo>
                  <a:pt x="527050" y="759961"/>
                  <a:pt x="530702" y="758426"/>
                  <a:pt x="533400" y="755728"/>
                </a:cubicBezTo>
                <a:lnTo>
                  <a:pt x="542925" y="746203"/>
                </a:lnTo>
                <a:cubicBezTo>
                  <a:pt x="550474" y="723555"/>
                  <a:pt x="539770" y="750936"/>
                  <a:pt x="555625" y="727153"/>
                </a:cubicBezTo>
                <a:cubicBezTo>
                  <a:pt x="557481" y="724368"/>
                  <a:pt x="557303" y="720621"/>
                  <a:pt x="558800" y="717628"/>
                </a:cubicBezTo>
                <a:cubicBezTo>
                  <a:pt x="560507" y="714215"/>
                  <a:pt x="563443" y="711516"/>
                  <a:pt x="565150" y="708103"/>
                </a:cubicBezTo>
                <a:cubicBezTo>
                  <a:pt x="566647" y="705110"/>
                  <a:pt x="566828" y="701571"/>
                  <a:pt x="568325" y="698578"/>
                </a:cubicBezTo>
                <a:cubicBezTo>
                  <a:pt x="570032" y="695165"/>
                  <a:pt x="573125" y="692540"/>
                  <a:pt x="574675" y="689053"/>
                </a:cubicBezTo>
                <a:cubicBezTo>
                  <a:pt x="577393" y="682936"/>
                  <a:pt x="581025" y="670003"/>
                  <a:pt x="581025" y="670003"/>
                </a:cubicBezTo>
                <a:cubicBezTo>
                  <a:pt x="582083" y="656245"/>
                  <a:pt x="582676" y="642443"/>
                  <a:pt x="584200" y="628728"/>
                </a:cubicBezTo>
                <a:cubicBezTo>
                  <a:pt x="585853" y="613852"/>
                  <a:pt x="590550" y="584278"/>
                  <a:pt x="590550" y="584278"/>
                </a:cubicBezTo>
                <a:cubicBezTo>
                  <a:pt x="594408" y="503254"/>
                  <a:pt x="596814" y="486653"/>
                  <a:pt x="590550" y="390603"/>
                </a:cubicBezTo>
                <a:cubicBezTo>
                  <a:pt x="590114" y="383924"/>
                  <a:pt x="586317" y="377903"/>
                  <a:pt x="584200" y="371553"/>
                </a:cubicBezTo>
                <a:lnTo>
                  <a:pt x="577850" y="352503"/>
                </a:lnTo>
                <a:cubicBezTo>
                  <a:pt x="576643" y="348883"/>
                  <a:pt x="573207" y="346391"/>
                  <a:pt x="571500" y="342978"/>
                </a:cubicBezTo>
                <a:cubicBezTo>
                  <a:pt x="568832" y="337643"/>
                  <a:pt x="566676" y="325839"/>
                  <a:pt x="565150" y="320753"/>
                </a:cubicBezTo>
                <a:cubicBezTo>
                  <a:pt x="563227" y="314342"/>
                  <a:pt x="560917" y="308053"/>
                  <a:pt x="558800" y="301703"/>
                </a:cubicBezTo>
                <a:cubicBezTo>
                  <a:pt x="557593" y="298083"/>
                  <a:pt x="554000" y="295665"/>
                  <a:pt x="552450" y="292178"/>
                </a:cubicBezTo>
                <a:lnTo>
                  <a:pt x="542925" y="263603"/>
                </a:lnTo>
                <a:cubicBezTo>
                  <a:pt x="540512" y="256363"/>
                  <a:pt x="534458" y="250903"/>
                  <a:pt x="530225" y="244553"/>
                </a:cubicBezTo>
                <a:cubicBezTo>
                  <a:pt x="528369" y="241768"/>
                  <a:pt x="528675" y="237954"/>
                  <a:pt x="527050" y="235028"/>
                </a:cubicBezTo>
                <a:cubicBezTo>
                  <a:pt x="517556" y="217938"/>
                  <a:pt x="516395" y="218023"/>
                  <a:pt x="504825" y="206453"/>
                </a:cubicBezTo>
                <a:cubicBezTo>
                  <a:pt x="502243" y="198706"/>
                  <a:pt x="501455" y="193558"/>
                  <a:pt x="495300" y="187403"/>
                </a:cubicBezTo>
                <a:cubicBezTo>
                  <a:pt x="492602" y="184705"/>
                  <a:pt x="488950" y="183170"/>
                  <a:pt x="485775" y="181053"/>
                </a:cubicBezTo>
                <a:cubicBezTo>
                  <a:pt x="479703" y="162837"/>
                  <a:pt x="486948" y="179840"/>
                  <a:pt x="473075" y="162003"/>
                </a:cubicBezTo>
                <a:cubicBezTo>
                  <a:pt x="468390" y="155979"/>
                  <a:pt x="464608" y="149303"/>
                  <a:pt x="460375" y="142953"/>
                </a:cubicBezTo>
                <a:cubicBezTo>
                  <a:pt x="457884" y="139217"/>
                  <a:pt x="453607" y="136972"/>
                  <a:pt x="450850" y="133428"/>
                </a:cubicBezTo>
                <a:cubicBezTo>
                  <a:pt x="446165" y="127404"/>
                  <a:pt x="442383" y="120728"/>
                  <a:pt x="438150" y="114378"/>
                </a:cubicBezTo>
                <a:cubicBezTo>
                  <a:pt x="436033" y="111203"/>
                  <a:pt x="431556" y="110471"/>
                  <a:pt x="428625" y="108028"/>
                </a:cubicBezTo>
                <a:cubicBezTo>
                  <a:pt x="425176" y="105153"/>
                  <a:pt x="422549" y="101378"/>
                  <a:pt x="419100" y="98503"/>
                </a:cubicBezTo>
                <a:cubicBezTo>
                  <a:pt x="416169" y="96060"/>
                  <a:pt x="412506" y="94596"/>
                  <a:pt x="409575" y="92153"/>
                </a:cubicBezTo>
                <a:cubicBezTo>
                  <a:pt x="406126" y="89278"/>
                  <a:pt x="403594" y="85385"/>
                  <a:pt x="400050" y="82628"/>
                </a:cubicBezTo>
                <a:cubicBezTo>
                  <a:pt x="394026" y="77943"/>
                  <a:pt x="381000" y="69928"/>
                  <a:pt x="381000" y="69928"/>
                </a:cubicBezTo>
                <a:cubicBezTo>
                  <a:pt x="375356" y="61461"/>
                  <a:pt x="373587" y="57460"/>
                  <a:pt x="365125" y="50878"/>
                </a:cubicBezTo>
                <a:lnTo>
                  <a:pt x="336550" y="31828"/>
                </a:lnTo>
                <a:cubicBezTo>
                  <a:pt x="330981" y="28115"/>
                  <a:pt x="323850" y="27595"/>
                  <a:pt x="317500" y="25478"/>
                </a:cubicBezTo>
                <a:lnTo>
                  <a:pt x="279400" y="12778"/>
                </a:lnTo>
                <a:cubicBezTo>
                  <a:pt x="264306" y="7747"/>
                  <a:pt x="247679" y="10057"/>
                  <a:pt x="231775" y="9603"/>
                </a:cubicBezTo>
                <a:cubicBezTo>
                  <a:pt x="210617" y="8998"/>
                  <a:pt x="223308" y="-980"/>
                  <a:pt x="212725" y="78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12" name="フリーフォーム 111"/>
          <p:cNvSpPr/>
          <p:nvPr/>
        </p:nvSpPr>
        <p:spPr>
          <a:xfrm>
            <a:off x="665235" y="921420"/>
            <a:ext cx="594397" cy="816053"/>
          </a:xfrm>
          <a:custGeom>
            <a:avLst/>
            <a:gdLst>
              <a:gd name="connsiteX0" fmla="*/ 212725 w 594397"/>
              <a:gd name="connsiteY0" fmla="*/ 78 h 816053"/>
              <a:gd name="connsiteX1" fmla="*/ 168275 w 594397"/>
              <a:gd name="connsiteY1" fmla="*/ 15953 h 816053"/>
              <a:gd name="connsiteX2" fmla="*/ 155575 w 594397"/>
              <a:gd name="connsiteY2" fmla="*/ 22303 h 816053"/>
              <a:gd name="connsiteX3" fmla="*/ 133350 w 594397"/>
              <a:gd name="connsiteY3" fmla="*/ 28653 h 816053"/>
              <a:gd name="connsiteX4" fmla="*/ 123825 w 594397"/>
              <a:gd name="connsiteY4" fmla="*/ 31828 h 816053"/>
              <a:gd name="connsiteX5" fmla="*/ 104775 w 594397"/>
              <a:gd name="connsiteY5" fmla="*/ 44528 h 816053"/>
              <a:gd name="connsiteX6" fmla="*/ 95250 w 594397"/>
              <a:gd name="connsiteY6" fmla="*/ 50878 h 816053"/>
              <a:gd name="connsiteX7" fmla="*/ 88900 w 594397"/>
              <a:gd name="connsiteY7" fmla="*/ 60403 h 816053"/>
              <a:gd name="connsiteX8" fmla="*/ 69850 w 594397"/>
              <a:gd name="connsiteY8" fmla="*/ 73103 h 816053"/>
              <a:gd name="connsiteX9" fmla="*/ 44450 w 594397"/>
              <a:gd name="connsiteY9" fmla="*/ 111203 h 816053"/>
              <a:gd name="connsiteX10" fmla="*/ 38100 w 594397"/>
              <a:gd name="connsiteY10" fmla="*/ 130253 h 816053"/>
              <a:gd name="connsiteX11" fmla="*/ 31750 w 594397"/>
              <a:gd name="connsiteY11" fmla="*/ 149303 h 816053"/>
              <a:gd name="connsiteX12" fmla="*/ 28575 w 594397"/>
              <a:gd name="connsiteY12" fmla="*/ 158828 h 816053"/>
              <a:gd name="connsiteX13" fmla="*/ 22225 w 594397"/>
              <a:gd name="connsiteY13" fmla="*/ 168353 h 816053"/>
              <a:gd name="connsiteX14" fmla="*/ 19050 w 594397"/>
              <a:gd name="connsiteY14" fmla="*/ 187403 h 816053"/>
              <a:gd name="connsiteX15" fmla="*/ 9525 w 594397"/>
              <a:gd name="connsiteY15" fmla="*/ 225503 h 816053"/>
              <a:gd name="connsiteX16" fmla="*/ 6350 w 594397"/>
              <a:gd name="connsiteY16" fmla="*/ 235028 h 816053"/>
              <a:gd name="connsiteX17" fmla="*/ 0 w 594397"/>
              <a:gd name="connsiteY17" fmla="*/ 260428 h 816053"/>
              <a:gd name="connsiteX18" fmla="*/ 3175 w 594397"/>
              <a:gd name="connsiteY18" fmla="*/ 400128 h 816053"/>
              <a:gd name="connsiteX19" fmla="*/ 6350 w 594397"/>
              <a:gd name="connsiteY19" fmla="*/ 409653 h 816053"/>
              <a:gd name="connsiteX20" fmla="*/ 9525 w 594397"/>
              <a:gd name="connsiteY20" fmla="*/ 422353 h 816053"/>
              <a:gd name="connsiteX21" fmla="*/ 15875 w 594397"/>
              <a:gd name="connsiteY21" fmla="*/ 441403 h 816053"/>
              <a:gd name="connsiteX22" fmla="*/ 22225 w 594397"/>
              <a:gd name="connsiteY22" fmla="*/ 460453 h 816053"/>
              <a:gd name="connsiteX23" fmla="*/ 25400 w 594397"/>
              <a:gd name="connsiteY23" fmla="*/ 469978 h 816053"/>
              <a:gd name="connsiteX24" fmla="*/ 38100 w 594397"/>
              <a:gd name="connsiteY24" fmla="*/ 489028 h 816053"/>
              <a:gd name="connsiteX25" fmla="*/ 44450 w 594397"/>
              <a:gd name="connsiteY25" fmla="*/ 508078 h 816053"/>
              <a:gd name="connsiteX26" fmla="*/ 57150 w 594397"/>
              <a:gd name="connsiteY26" fmla="*/ 527128 h 816053"/>
              <a:gd name="connsiteX27" fmla="*/ 60325 w 594397"/>
              <a:gd name="connsiteY27" fmla="*/ 536653 h 816053"/>
              <a:gd name="connsiteX28" fmla="*/ 66675 w 594397"/>
              <a:gd name="connsiteY28" fmla="*/ 546178 h 816053"/>
              <a:gd name="connsiteX29" fmla="*/ 69850 w 594397"/>
              <a:gd name="connsiteY29" fmla="*/ 555703 h 816053"/>
              <a:gd name="connsiteX30" fmla="*/ 79375 w 594397"/>
              <a:gd name="connsiteY30" fmla="*/ 565228 h 816053"/>
              <a:gd name="connsiteX31" fmla="*/ 92075 w 594397"/>
              <a:gd name="connsiteY31" fmla="*/ 584278 h 816053"/>
              <a:gd name="connsiteX32" fmla="*/ 95250 w 594397"/>
              <a:gd name="connsiteY32" fmla="*/ 593803 h 816053"/>
              <a:gd name="connsiteX33" fmla="*/ 107950 w 594397"/>
              <a:gd name="connsiteY33" fmla="*/ 612853 h 816053"/>
              <a:gd name="connsiteX34" fmla="*/ 133350 w 594397"/>
              <a:gd name="connsiteY34" fmla="*/ 650953 h 816053"/>
              <a:gd name="connsiteX35" fmla="*/ 152400 w 594397"/>
              <a:gd name="connsiteY35" fmla="*/ 679528 h 816053"/>
              <a:gd name="connsiteX36" fmla="*/ 171450 w 594397"/>
              <a:gd name="connsiteY36" fmla="*/ 692228 h 816053"/>
              <a:gd name="connsiteX37" fmla="*/ 187325 w 594397"/>
              <a:gd name="connsiteY37" fmla="*/ 704928 h 816053"/>
              <a:gd name="connsiteX38" fmla="*/ 203200 w 594397"/>
              <a:gd name="connsiteY38" fmla="*/ 717628 h 816053"/>
              <a:gd name="connsiteX39" fmla="*/ 209550 w 594397"/>
              <a:gd name="connsiteY39" fmla="*/ 727153 h 816053"/>
              <a:gd name="connsiteX40" fmla="*/ 228600 w 594397"/>
              <a:gd name="connsiteY40" fmla="*/ 739853 h 816053"/>
              <a:gd name="connsiteX41" fmla="*/ 250825 w 594397"/>
              <a:gd name="connsiteY41" fmla="*/ 765253 h 816053"/>
              <a:gd name="connsiteX42" fmla="*/ 257175 w 594397"/>
              <a:gd name="connsiteY42" fmla="*/ 774778 h 816053"/>
              <a:gd name="connsiteX43" fmla="*/ 276225 w 594397"/>
              <a:gd name="connsiteY43" fmla="*/ 784303 h 816053"/>
              <a:gd name="connsiteX44" fmla="*/ 282575 w 594397"/>
              <a:gd name="connsiteY44" fmla="*/ 793828 h 816053"/>
              <a:gd name="connsiteX45" fmla="*/ 311150 w 594397"/>
              <a:gd name="connsiteY45" fmla="*/ 806528 h 816053"/>
              <a:gd name="connsiteX46" fmla="*/ 320675 w 594397"/>
              <a:gd name="connsiteY46" fmla="*/ 809703 h 816053"/>
              <a:gd name="connsiteX47" fmla="*/ 358775 w 594397"/>
              <a:gd name="connsiteY47" fmla="*/ 816053 h 816053"/>
              <a:gd name="connsiteX48" fmla="*/ 415925 w 594397"/>
              <a:gd name="connsiteY48" fmla="*/ 812878 h 816053"/>
              <a:gd name="connsiteX49" fmla="*/ 434975 w 594397"/>
              <a:gd name="connsiteY49" fmla="*/ 806528 h 816053"/>
              <a:gd name="connsiteX50" fmla="*/ 457200 w 594397"/>
              <a:gd name="connsiteY50" fmla="*/ 803353 h 816053"/>
              <a:gd name="connsiteX51" fmla="*/ 476250 w 594397"/>
              <a:gd name="connsiteY51" fmla="*/ 797003 h 816053"/>
              <a:gd name="connsiteX52" fmla="*/ 495300 w 594397"/>
              <a:gd name="connsiteY52" fmla="*/ 784303 h 816053"/>
              <a:gd name="connsiteX53" fmla="*/ 504825 w 594397"/>
              <a:gd name="connsiteY53" fmla="*/ 774778 h 816053"/>
              <a:gd name="connsiteX54" fmla="*/ 523875 w 594397"/>
              <a:gd name="connsiteY54" fmla="*/ 762078 h 816053"/>
              <a:gd name="connsiteX55" fmla="*/ 533400 w 594397"/>
              <a:gd name="connsiteY55" fmla="*/ 755728 h 816053"/>
              <a:gd name="connsiteX56" fmla="*/ 542925 w 594397"/>
              <a:gd name="connsiteY56" fmla="*/ 746203 h 816053"/>
              <a:gd name="connsiteX57" fmla="*/ 555625 w 594397"/>
              <a:gd name="connsiteY57" fmla="*/ 727153 h 816053"/>
              <a:gd name="connsiteX58" fmla="*/ 558800 w 594397"/>
              <a:gd name="connsiteY58" fmla="*/ 717628 h 816053"/>
              <a:gd name="connsiteX59" fmla="*/ 565150 w 594397"/>
              <a:gd name="connsiteY59" fmla="*/ 708103 h 816053"/>
              <a:gd name="connsiteX60" fmla="*/ 568325 w 594397"/>
              <a:gd name="connsiteY60" fmla="*/ 698578 h 816053"/>
              <a:gd name="connsiteX61" fmla="*/ 574675 w 594397"/>
              <a:gd name="connsiteY61" fmla="*/ 689053 h 816053"/>
              <a:gd name="connsiteX62" fmla="*/ 581025 w 594397"/>
              <a:gd name="connsiteY62" fmla="*/ 670003 h 816053"/>
              <a:gd name="connsiteX63" fmla="*/ 584200 w 594397"/>
              <a:gd name="connsiteY63" fmla="*/ 628728 h 816053"/>
              <a:gd name="connsiteX64" fmla="*/ 590550 w 594397"/>
              <a:gd name="connsiteY64" fmla="*/ 584278 h 816053"/>
              <a:gd name="connsiteX65" fmla="*/ 590550 w 594397"/>
              <a:gd name="connsiteY65" fmla="*/ 390603 h 816053"/>
              <a:gd name="connsiteX66" fmla="*/ 584200 w 594397"/>
              <a:gd name="connsiteY66" fmla="*/ 371553 h 816053"/>
              <a:gd name="connsiteX67" fmla="*/ 577850 w 594397"/>
              <a:gd name="connsiteY67" fmla="*/ 352503 h 816053"/>
              <a:gd name="connsiteX68" fmla="*/ 571500 w 594397"/>
              <a:gd name="connsiteY68" fmla="*/ 342978 h 816053"/>
              <a:gd name="connsiteX69" fmla="*/ 565150 w 594397"/>
              <a:gd name="connsiteY69" fmla="*/ 320753 h 816053"/>
              <a:gd name="connsiteX70" fmla="*/ 558800 w 594397"/>
              <a:gd name="connsiteY70" fmla="*/ 301703 h 816053"/>
              <a:gd name="connsiteX71" fmla="*/ 552450 w 594397"/>
              <a:gd name="connsiteY71" fmla="*/ 292178 h 816053"/>
              <a:gd name="connsiteX72" fmla="*/ 542925 w 594397"/>
              <a:gd name="connsiteY72" fmla="*/ 263603 h 816053"/>
              <a:gd name="connsiteX73" fmla="*/ 530225 w 594397"/>
              <a:gd name="connsiteY73" fmla="*/ 244553 h 816053"/>
              <a:gd name="connsiteX74" fmla="*/ 527050 w 594397"/>
              <a:gd name="connsiteY74" fmla="*/ 235028 h 816053"/>
              <a:gd name="connsiteX75" fmla="*/ 504825 w 594397"/>
              <a:gd name="connsiteY75" fmla="*/ 206453 h 816053"/>
              <a:gd name="connsiteX76" fmla="*/ 495300 w 594397"/>
              <a:gd name="connsiteY76" fmla="*/ 187403 h 816053"/>
              <a:gd name="connsiteX77" fmla="*/ 485775 w 594397"/>
              <a:gd name="connsiteY77" fmla="*/ 181053 h 816053"/>
              <a:gd name="connsiteX78" fmla="*/ 473075 w 594397"/>
              <a:gd name="connsiteY78" fmla="*/ 162003 h 816053"/>
              <a:gd name="connsiteX79" fmla="*/ 460375 w 594397"/>
              <a:gd name="connsiteY79" fmla="*/ 142953 h 816053"/>
              <a:gd name="connsiteX80" fmla="*/ 450850 w 594397"/>
              <a:gd name="connsiteY80" fmla="*/ 133428 h 816053"/>
              <a:gd name="connsiteX81" fmla="*/ 438150 w 594397"/>
              <a:gd name="connsiteY81" fmla="*/ 114378 h 816053"/>
              <a:gd name="connsiteX82" fmla="*/ 428625 w 594397"/>
              <a:gd name="connsiteY82" fmla="*/ 108028 h 816053"/>
              <a:gd name="connsiteX83" fmla="*/ 419100 w 594397"/>
              <a:gd name="connsiteY83" fmla="*/ 98503 h 816053"/>
              <a:gd name="connsiteX84" fmla="*/ 409575 w 594397"/>
              <a:gd name="connsiteY84" fmla="*/ 92153 h 816053"/>
              <a:gd name="connsiteX85" fmla="*/ 400050 w 594397"/>
              <a:gd name="connsiteY85" fmla="*/ 82628 h 816053"/>
              <a:gd name="connsiteX86" fmla="*/ 381000 w 594397"/>
              <a:gd name="connsiteY86" fmla="*/ 69928 h 816053"/>
              <a:gd name="connsiteX87" fmla="*/ 365125 w 594397"/>
              <a:gd name="connsiteY87" fmla="*/ 50878 h 816053"/>
              <a:gd name="connsiteX88" fmla="*/ 336550 w 594397"/>
              <a:gd name="connsiteY88" fmla="*/ 31828 h 816053"/>
              <a:gd name="connsiteX89" fmla="*/ 317500 w 594397"/>
              <a:gd name="connsiteY89" fmla="*/ 25478 h 816053"/>
              <a:gd name="connsiteX90" fmla="*/ 279400 w 594397"/>
              <a:gd name="connsiteY90" fmla="*/ 12778 h 816053"/>
              <a:gd name="connsiteX91" fmla="*/ 231775 w 594397"/>
              <a:gd name="connsiteY91" fmla="*/ 9603 h 816053"/>
              <a:gd name="connsiteX92" fmla="*/ 212725 w 594397"/>
              <a:gd name="connsiteY92" fmla="*/ 78 h 8160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</a:cxnLst>
            <a:rect l="l" t="t" r="r" b="b"/>
            <a:pathLst>
              <a:path w="594397" h="816053">
                <a:moveTo>
                  <a:pt x="212725" y="78"/>
                </a:moveTo>
                <a:cubicBezTo>
                  <a:pt x="202142" y="1136"/>
                  <a:pt x="183393" y="9234"/>
                  <a:pt x="168275" y="15953"/>
                </a:cubicBezTo>
                <a:cubicBezTo>
                  <a:pt x="163950" y="17875"/>
                  <a:pt x="159925" y="20439"/>
                  <a:pt x="155575" y="22303"/>
                </a:cubicBezTo>
                <a:cubicBezTo>
                  <a:pt x="147962" y="25566"/>
                  <a:pt x="141406" y="26351"/>
                  <a:pt x="133350" y="28653"/>
                </a:cubicBezTo>
                <a:cubicBezTo>
                  <a:pt x="130132" y="29572"/>
                  <a:pt x="127000" y="30770"/>
                  <a:pt x="123825" y="31828"/>
                </a:cubicBezTo>
                <a:lnTo>
                  <a:pt x="104775" y="44528"/>
                </a:lnTo>
                <a:lnTo>
                  <a:pt x="95250" y="50878"/>
                </a:lnTo>
                <a:cubicBezTo>
                  <a:pt x="93133" y="54053"/>
                  <a:pt x="91772" y="57890"/>
                  <a:pt x="88900" y="60403"/>
                </a:cubicBezTo>
                <a:cubicBezTo>
                  <a:pt x="83157" y="65429"/>
                  <a:pt x="69850" y="73103"/>
                  <a:pt x="69850" y="73103"/>
                </a:cubicBezTo>
                <a:lnTo>
                  <a:pt x="44450" y="111203"/>
                </a:lnTo>
                <a:cubicBezTo>
                  <a:pt x="40737" y="116772"/>
                  <a:pt x="40217" y="123903"/>
                  <a:pt x="38100" y="130253"/>
                </a:cubicBezTo>
                <a:lnTo>
                  <a:pt x="31750" y="149303"/>
                </a:lnTo>
                <a:cubicBezTo>
                  <a:pt x="30692" y="152478"/>
                  <a:pt x="30431" y="156043"/>
                  <a:pt x="28575" y="158828"/>
                </a:cubicBezTo>
                <a:lnTo>
                  <a:pt x="22225" y="168353"/>
                </a:lnTo>
                <a:cubicBezTo>
                  <a:pt x="21167" y="174703"/>
                  <a:pt x="20399" y="181108"/>
                  <a:pt x="19050" y="187403"/>
                </a:cubicBezTo>
                <a:lnTo>
                  <a:pt x="9525" y="225503"/>
                </a:lnTo>
                <a:cubicBezTo>
                  <a:pt x="8713" y="228750"/>
                  <a:pt x="7231" y="231799"/>
                  <a:pt x="6350" y="235028"/>
                </a:cubicBezTo>
                <a:cubicBezTo>
                  <a:pt x="4054" y="243448"/>
                  <a:pt x="0" y="260428"/>
                  <a:pt x="0" y="260428"/>
                </a:cubicBezTo>
                <a:cubicBezTo>
                  <a:pt x="1058" y="306995"/>
                  <a:pt x="1195" y="353591"/>
                  <a:pt x="3175" y="400128"/>
                </a:cubicBezTo>
                <a:cubicBezTo>
                  <a:pt x="3317" y="403472"/>
                  <a:pt x="5431" y="406435"/>
                  <a:pt x="6350" y="409653"/>
                </a:cubicBezTo>
                <a:cubicBezTo>
                  <a:pt x="7549" y="413849"/>
                  <a:pt x="8271" y="418173"/>
                  <a:pt x="9525" y="422353"/>
                </a:cubicBezTo>
                <a:cubicBezTo>
                  <a:pt x="11448" y="428764"/>
                  <a:pt x="13758" y="435053"/>
                  <a:pt x="15875" y="441403"/>
                </a:cubicBezTo>
                <a:lnTo>
                  <a:pt x="22225" y="460453"/>
                </a:lnTo>
                <a:cubicBezTo>
                  <a:pt x="23283" y="463628"/>
                  <a:pt x="23544" y="467193"/>
                  <a:pt x="25400" y="469978"/>
                </a:cubicBezTo>
                <a:lnTo>
                  <a:pt x="38100" y="489028"/>
                </a:lnTo>
                <a:cubicBezTo>
                  <a:pt x="41813" y="494597"/>
                  <a:pt x="40737" y="502509"/>
                  <a:pt x="44450" y="508078"/>
                </a:cubicBezTo>
                <a:cubicBezTo>
                  <a:pt x="48683" y="514428"/>
                  <a:pt x="54737" y="519888"/>
                  <a:pt x="57150" y="527128"/>
                </a:cubicBezTo>
                <a:cubicBezTo>
                  <a:pt x="58208" y="530303"/>
                  <a:pt x="58828" y="533660"/>
                  <a:pt x="60325" y="536653"/>
                </a:cubicBezTo>
                <a:cubicBezTo>
                  <a:pt x="62032" y="540066"/>
                  <a:pt x="64968" y="542765"/>
                  <a:pt x="66675" y="546178"/>
                </a:cubicBezTo>
                <a:cubicBezTo>
                  <a:pt x="68172" y="549171"/>
                  <a:pt x="67994" y="552918"/>
                  <a:pt x="69850" y="555703"/>
                </a:cubicBezTo>
                <a:cubicBezTo>
                  <a:pt x="72341" y="559439"/>
                  <a:pt x="76618" y="561684"/>
                  <a:pt x="79375" y="565228"/>
                </a:cubicBezTo>
                <a:cubicBezTo>
                  <a:pt x="84060" y="571252"/>
                  <a:pt x="87842" y="577928"/>
                  <a:pt x="92075" y="584278"/>
                </a:cubicBezTo>
                <a:cubicBezTo>
                  <a:pt x="93931" y="587063"/>
                  <a:pt x="93625" y="590877"/>
                  <a:pt x="95250" y="593803"/>
                </a:cubicBezTo>
                <a:cubicBezTo>
                  <a:pt x="98956" y="600474"/>
                  <a:pt x="103717" y="606503"/>
                  <a:pt x="107950" y="612853"/>
                </a:cubicBezTo>
                <a:lnTo>
                  <a:pt x="133350" y="650953"/>
                </a:lnTo>
                <a:lnTo>
                  <a:pt x="152400" y="679528"/>
                </a:lnTo>
                <a:cubicBezTo>
                  <a:pt x="156633" y="685878"/>
                  <a:pt x="171450" y="692228"/>
                  <a:pt x="171450" y="692228"/>
                </a:cubicBezTo>
                <a:cubicBezTo>
                  <a:pt x="189648" y="719525"/>
                  <a:pt x="165417" y="687401"/>
                  <a:pt x="187325" y="704928"/>
                </a:cubicBezTo>
                <a:cubicBezTo>
                  <a:pt x="207841" y="721341"/>
                  <a:pt x="179259" y="709648"/>
                  <a:pt x="203200" y="717628"/>
                </a:cubicBezTo>
                <a:cubicBezTo>
                  <a:pt x="205317" y="720803"/>
                  <a:pt x="206678" y="724640"/>
                  <a:pt x="209550" y="727153"/>
                </a:cubicBezTo>
                <a:cubicBezTo>
                  <a:pt x="215293" y="732179"/>
                  <a:pt x="228600" y="739853"/>
                  <a:pt x="228600" y="739853"/>
                </a:cubicBezTo>
                <a:cubicBezTo>
                  <a:pt x="243417" y="762078"/>
                  <a:pt x="234950" y="754670"/>
                  <a:pt x="250825" y="765253"/>
                </a:cubicBezTo>
                <a:cubicBezTo>
                  <a:pt x="252942" y="768428"/>
                  <a:pt x="254477" y="772080"/>
                  <a:pt x="257175" y="774778"/>
                </a:cubicBezTo>
                <a:cubicBezTo>
                  <a:pt x="263330" y="780933"/>
                  <a:pt x="268478" y="781721"/>
                  <a:pt x="276225" y="784303"/>
                </a:cubicBezTo>
                <a:cubicBezTo>
                  <a:pt x="278342" y="787478"/>
                  <a:pt x="279877" y="791130"/>
                  <a:pt x="282575" y="793828"/>
                </a:cubicBezTo>
                <a:cubicBezTo>
                  <a:pt x="290122" y="801375"/>
                  <a:pt x="301719" y="803384"/>
                  <a:pt x="311150" y="806528"/>
                </a:cubicBezTo>
                <a:lnTo>
                  <a:pt x="320675" y="809703"/>
                </a:lnTo>
                <a:cubicBezTo>
                  <a:pt x="327639" y="812024"/>
                  <a:pt x="353741" y="815334"/>
                  <a:pt x="358775" y="816053"/>
                </a:cubicBezTo>
                <a:cubicBezTo>
                  <a:pt x="377825" y="814995"/>
                  <a:pt x="396993" y="815245"/>
                  <a:pt x="415925" y="812878"/>
                </a:cubicBezTo>
                <a:cubicBezTo>
                  <a:pt x="422567" y="812048"/>
                  <a:pt x="428625" y="808645"/>
                  <a:pt x="434975" y="806528"/>
                </a:cubicBezTo>
                <a:cubicBezTo>
                  <a:pt x="442075" y="804161"/>
                  <a:pt x="449792" y="804411"/>
                  <a:pt x="457200" y="803353"/>
                </a:cubicBezTo>
                <a:cubicBezTo>
                  <a:pt x="463550" y="801236"/>
                  <a:pt x="471517" y="801736"/>
                  <a:pt x="476250" y="797003"/>
                </a:cubicBezTo>
                <a:cubicBezTo>
                  <a:pt x="488142" y="785111"/>
                  <a:pt x="481515" y="788898"/>
                  <a:pt x="495300" y="784303"/>
                </a:cubicBezTo>
                <a:cubicBezTo>
                  <a:pt x="498475" y="781128"/>
                  <a:pt x="501281" y="777535"/>
                  <a:pt x="504825" y="774778"/>
                </a:cubicBezTo>
                <a:cubicBezTo>
                  <a:pt x="510849" y="770093"/>
                  <a:pt x="517525" y="766311"/>
                  <a:pt x="523875" y="762078"/>
                </a:cubicBezTo>
                <a:cubicBezTo>
                  <a:pt x="527050" y="759961"/>
                  <a:pt x="530702" y="758426"/>
                  <a:pt x="533400" y="755728"/>
                </a:cubicBezTo>
                <a:lnTo>
                  <a:pt x="542925" y="746203"/>
                </a:lnTo>
                <a:cubicBezTo>
                  <a:pt x="550474" y="723555"/>
                  <a:pt x="539770" y="750936"/>
                  <a:pt x="555625" y="727153"/>
                </a:cubicBezTo>
                <a:cubicBezTo>
                  <a:pt x="557481" y="724368"/>
                  <a:pt x="557303" y="720621"/>
                  <a:pt x="558800" y="717628"/>
                </a:cubicBezTo>
                <a:cubicBezTo>
                  <a:pt x="560507" y="714215"/>
                  <a:pt x="563443" y="711516"/>
                  <a:pt x="565150" y="708103"/>
                </a:cubicBezTo>
                <a:cubicBezTo>
                  <a:pt x="566647" y="705110"/>
                  <a:pt x="566828" y="701571"/>
                  <a:pt x="568325" y="698578"/>
                </a:cubicBezTo>
                <a:cubicBezTo>
                  <a:pt x="570032" y="695165"/>
                  <a:pt x="573125" y="692540"/>
                  <a:pt x="574675" y="689053"/>
                </a:cubicBezTo>
                <a:cubicBezTo>
                  <a:pt x="577393" y="682936"/>
                  <a:pt x="581025" y="670003"/>
                  <a:pt x="581025" y="670003"/>
                </a:cubicBezTo>
                <a:cubicBezTo>
                  <a:pt x="582083" y="656245"/>
                  <a:pt x="582676" y="642443"/>
                  <a:pt x="584200" y="628728"/>
                </a:cubicBezTo>
                <a:cubicBezTo>
                  <a:pt x="585853" y="613852"/>
                  <a:pt x="590550" y="584278"/>
                  <a:pt x="590550" y="584278"/>
                </a:cubicBezTo>
                <a:cubicBezTo>
                  <a:pt x="594408" y="503254"/>
                  <a:pt x="596814" y="486653"/>
                  <a:pt x="590550" y="390603"/>
                </a:cubicBezTo>
                <a:cubicBezTo>
                  <a:pt x="590114" y="383924"/>
                  <a:pt x="586317" y="377903"/>
                  <a:pt x="584200" y="371553"/>
                </a:cubicBezTo>
                <a:lnTo>
                  <a:pt x="577850" y="352503"/>
                </a:lnTo>
                <a:cubicBezTo>
                  <a:pt x="576643" y="348883"/>
                  <a:pt x="573207" y="346391"/>
                  <a:pt x="571500" y="342978"/>
                </a:cubicBezTo>
                <a:cubicBezTo>
                  <a:pt x="568832" y="337643"/>
                  <a:pt x="566676" y="325839"/>
                  <a:pt x="565150" y="320753"/>
                </a:cubicBezTo>
                <a:cubicBezTo>
                  <a:pt x="563227" y="314342"/>
                  <a:pt x="560917" y="308053"/>
                  <a:pt x="558800" y="301703"/>
                </a:cubicBezTo>
                <a:cubicBezTo>
                  <a:pt x="557593" y="298083"/>
                  <a:pt x="554000" y="295665"/>
                  <a:pt x="552450" y="292178"/>
                </a:cubicBezTo>
                <a:lnTo>
                  <a:pt x="542925" y="263603"/>
                </a:lnTo>
                <a:cubicBezTo>
                  <a:pt x="540512" y="256363"/>
                  <a:pt x="534458" y="250903"/>
                  <a:pt x="530225" y="244553"/>
                </a:cubicBezTo>
                <a:cubicBezTo>
                  <a:pt x="528369" y="241768"/>
                  <a:pt x="528675" y="237954"/>
                  <a:pt x="527050" y="235028"/>
                </a:cubicBezTo>
                <a:cubicBezTo>
                  <a:pt x="517556" y="217938"/>
                  <a:pt x="516395" y="218023"/>
                  <a:pt x="504825" y="206453"/>
                </a:cubicBezTo>
                <a:cubicBezTo>
                  <a:pt x="502243" y="198706"/>
                  <a:pt x="501455" y="193558"/>
                  <a:pt x="495300" y="187403"/>
                </a:cubicBezTo>
                <a:cubicBezTo>
                  <a:pt x="492602" y="184705"/>
                  <a:pt x="488950" y="183170"/>
                  <a:pt x="485775" y="181053"/>
                </a:cubicBezTo>
                <a:cubicBezTo>
                  <a:pt x="479703" y="162837"/>
                  <a:pt x="486948" y="179840"/>
                  <a:pt x="473075" y="162003"/>
                </a:cubicBezTo>
                <a:cubicBezTo>
                  <a:pt x="468390" y="155979"/>
                  <a:pt x="464608" y="149303"/>
                  <a:pt x="460375" y="142953"/>
                </a:cubicBezTo>
                <a:cubicBezTo>
                  <a:pt x="457884" y="139217"/>
                  <a:pt x="453607" y="136972"/>
                  <a:pt x="450850" y="133428"/>
                </a:cubicBezTo>
                <a:cubicBezTo>
                  <a:pt x="446165" y="127404"/>
                  <a:pt x="442383" y="120728"/>
                  <a:pt x="438150" y="114378"/>
                </a:cubicBezTo>
                <a:cubicBezTo>
                  <a:pt x="436033" y="111203"/>
                  <a:pt x="431556" y="110471"/>
                  <a:pt x="428625" y="108028"/>
                </a:cubicBezTo>
                <a:cubicBezTo>
                  <a:pt x="425176" y="105153"/>
                  <a:pt x="422549" y="101378"/>
                  <a:pt x="419100" y="98503"/>
                </a:cubicBezTo>
                <a:cubicBezTo>
                  <a:pt x="416169" y="96060"/>
                  <a:pt x="412506" y="94596"/>
                  <a:pt x="409575" y="92153"/>
                </a:cubicBezTo>
                <a:cubicBezTo>
                  <a:pt x="406126" y="89278"/>
                  <a:pt x="403594" y="85385"/>
                  <a:pt x="400050" y="82628"/>
                </a:cubicBezTo>
                <a:cubicBezTo>
                  <a:pt x="394026" y="77943"/>
                  <a:pt x="381000" y="69928"/>
                  <a:pt x="381000" y="69928"/>
                </a:cubicBezTo>
                <a:cubicBezTo>
                  <a:pt x="375356" y="61461"/>
                  <a:pt x="373587" y="57460"/>
                  <a:pt x="365125" y="50878"/>
                </a:cubicBezTo>
                <a:lnTo>
                  <a:pt x="336550" y="31828"/>
                </a:lnTo>
                <a:cubicBezTo>
                  <a:pt x="330981" y="28115"/>
                  <a:pt x="323850" y="27595"/>
                  <a:pt x="317500" y="25478"/>
                </a:cubicBezTo>
                <a:lnTo>
                  <a:pt x="279400" y="12778"/>
                </a:lnTo>
                <a:cubicBezTo>
                  <a:pt x="264306" y="7747"/>
                  <a:pt x="247679" y="10057"/>
                  <a:pt x="231775" y="9603"/>
                </a:cubicBezTo>
                <a:cubicBezTo>
                  <a:pt x="210617" y="8998"/>
                  <a:pt x="223308" y="-980"/>
                  <a:pt x="212725" y="78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2" name="フリーフォーム 11"/>
          <p:cNvSpPr/>
          <p:nvPr/>
        </p:nvSpPr>
        <p:spPr>
          <a:xfrm>
            <a:off x="3540125" y="2571750"/>
            <a:ext cx="914400" cy="571500"/>
          </a:xfrm>
          <a:custGeom>
            <a:avLst/>
            <a:gdLst>
              <a:gd name="connsiteX0" fmla="*/ 638175 w 914400"/>
              <a:gd name="connsiteY0" fmla="*/ 0 h 571500"/>
              <a:gd name="connsiteX1" fmla="*/ 590550 w 914400"/>
              <a:gd name="connsiteY1" fmla="*/ 6350 h 571500"/>
              <a:gd name="connsiteX2" fmla="*/ 581025 w 914400"/>
              <a:gd name="connsiteY2" fmla="*/ 12700 h 571500"/>
              <a:gd name="connsiteX3" fmla="*/ 561975 w 914400"/>
              <a:gd name="connsiteY3" fmla="*/ 19050 h 571500"/>
              <a:gd name="connsiteX4" fmla="*/ 552450 w 914400"/>
              <a:gd name="connsiteY4" fmla="*/ 22225 h 571500"/>
              <a:gd name="connsiteX5" fmla="*/ 542925 w 914400"/>
              <a:gd name="connsiteY5" fmla="*/ 25400 h 571500"/>
              <a:gd name="connsiteX6" fmla="*/ 533400 w 914400"/>
              <a:gd name="connsiteY6" fmla="*/ 28575 h 571500"/>
              <a:gd name="connsiteX7" fmla="*/ 520700 w 914400"/>
              <a:gd name="connsiteY7" fmla="*/ 31750 h 571500"/>
              <a:gd name="connsiteX8" fmla="*/ 511175 w 914400"/>
              <a:gd name="connsiteY8" fmla="*/ 34925 h 571500"/>
              <a:gd name="connsiteX9" fmla="*/ 495300 w 914400"/>
              <a:gd name="connsiteY9" fmla="*/ 38100 h 571500"/>
              <a:gd name="connsiteX10" fmla="*/ 482600 w 914400"/>
              <a:gd name="connsiteY10" fmla="*/ 41275 h 571500"/>
              <a:gd name="connsiteX11" fmla="*/ 428625 w 914400"/>
              <a:gd name="connsiteY11" fmla="*/ 47625 h 571500"/>
              <a:gd name="connsiteX12" fmla="*/ 400050 w 914400"/>
              <a:gd name="connsiteY12" fmla="*/ 63500 h 571500"/>
              <a:gd name="connsiteX13" fmla="*/ 371475 w 914400"/>
              <a:gd name="connsiteY13" fmla="*/ 69850 h 571500"/>
              <a:gd name="connsiteX14" fmla="*/ 358775 w 914400"/>
              <a:gd name="connsiteY14" fmla="*/ 73025 h 571500"/>
              <a:gd name="connsiteX15" fmla="*/ 339725 w 914400"/>
              <a:gd name="connsiteY15" fmla="*/ 79375 h 571500"/>
              <a:gd name="connsiteX16" fmla="*/ 311150 w 914400"/>
              <a:gd name="connsiteY16" fmla="*/ 92075 h 571500"/>
              <a:gd name="connsiteX17" fmla="*/ 301625 w 914400"/>
              <a:gd name="connsiteY17" fmla="*/ 95250 h 571500"/>
              <a:gd name="connsiteX18" fmla="*/ 244475 w 914400"/>
              <a:gd name="connsiteY18" fmla="*/ 133350 h 571500"/>
              <a:gd name="connsiteX19" fmla="*/ 225425 w 914400"/>
              <a:gd name="connsiteY19" fmla="*/ 139700 h 571500"/>
              <a:gd name="connsiteX20" fmla="*/ 215900 w 914400"/>
              <a:gd name="connsiteY20" fmla="*/ 142875 h 571500"/>
              <a:gd name="connsiteX21" fmla="*/ 206375 w 914400"/>
              <a:gd name="connsiteY21" fmla="*/ 149225 h 571500"/>
              <a:gd name="connsiteX22" fmla="*/ 187325 w 914400"/>
              <a:gd name="connsiteY22" fmla="*/ 155575 h 571500"/>
              <a:gd name="connsiteX23" fmla="*/ 168275 w 914400"/>
              <a:gd name="connsiteY23" fmla="*/ 168275 h 571500"/>
              <a:gd name="connsiteX24" fmla="*/ 158750 w 914400"/>
              <a:gd name="connsiteY24" fmla="*/ 174625 h 571500"/>
              <a:gd name="connsiteX25" fmla="*/ 149225 w 914400"/>
              <a:gd name="connsiteY25" fmla="*/ 177800 h 571500"/>
              <a:gd name="connsiteX26" fmla="*/ 120650 w 914400"/>
              <a:gd name="connsiteY26" fmla="*/ 190500 h 571500"/>
              <a:gd name="connsiteX27" fmla="*/ 111125 w 914400"/>
              <a:gd name="connsiteY27" fmla="*/ 193675 h 571500"/>
              <a:gd name="connsiteX28" fmla="*/ 101600 w 914400"/>
              <a:gd name="connsiteY28" fmla="*/ 200025 h 571500"/>
              <a:gd name="connsiteX29" fmla="*/ 82550 w 914400"/>
              <a:gd name="connsiteY29" fmla="*/ 209550 h 571500"/>
              <a:gd name="connsiteX30" fmla="*/ 76200 w 914400"/>
              <a:gd name="connsiteY30" fmla="*/ 219075 h 571500"/>
              <a:gd name="connsiteX31" fmla="*/ 66675 w 914400"/>
              <a:gd name="connsiteY31" fmla="*/ 222250 h 571500"/>
              <a:gd name="connsiteX32" fmla="*/ 57150 w 914400"/>
              <a:gd name="connsiteY32" fmla="*/ 228600 h 571500"/>
              <a:gd name="connsiteX33" fmla="*/ 50800 w 914400"/>
              <a:gd name="connsiteY33" fmla="*/ 238125 h 571500"/>
              <a:gd name="connsiteX34" fmla="*/ 41275 w 914400"/>
              <a:gd name="connsiteY34" fmla="*/ 241300 h 571500"/>
              <a:gd name="connsiteX35" fmla="*/ 31750 w 914400"/>
              <a:gd name="connsiteY35" fmla="*/ 247650 h 571500"/>
              <a:gd name="connsiteX36" fmla="*/ 25400 w 914400"/>
              <a:gd name="connsiteY36" fmla="*/ 257175 h 571500"/>
              <a:gd name="connsiteX37" fmla="*/ 15875 w 914400"/>
              <a:gd name="connsiteY37" fmla="*/ 263525 h 571500"/>
              <a:gd name="connsiteX38" fmla="*/ 9525 w 914400"/>
              <a:gd name="connsiteY38" fmla="*/ 282575 h 571500"/>
              <a:gd name="connsiteX39" fmla="*/ 0 w 914400"/>
              <a:gd name="connsiteY39" fmla="*/ 301625 h 571500"/>
              <a:gd name="connsiteX40" fmla="*/ 3175 w 914400"/>
              <a:gd name="connsiteY40" fmla="*/ 393700 h 571500"/>
              <a:gd name="connsiteX41" fmla="*/ 12700 w 914400"/>
              <a:gd name="connsiteY41" fmla="*/ 412750 h 571500"/>
              <a:gd name="connsiteX42" fmla="*/ 22225 w 914400"/>
              <a:gd name="connsiteY42" fmla="*/ 422275 h 571500"/>
              <a:gd name="connsiteX43" fmla="*/ 41275 w 914400"/>
              <a:gd name="connsiteY43" fmla="*/ 450850 h 571500"/>
              <a:gd name="connsiteX44" fmla="*/ 47625 w 914400"/>
              <a:gd name="connsiteY44" fmla="*/ 460375 h 571500"/>
              <a:gd name="connsiteX45" fmla="*/ 57150 w 914400"/>
              <a:gd name="connsiteY45" fmla="*/ 479425 h 571500"/>
              <a:gd name="connsiteX46" fmla="*/ 66675 w 914400"/>
              <a:gd name="connsiteY46" fmla="*/ 485775 h 571500"/>
              <a:gd name="connsiteX47" fmla="*/ 73025 w 914400"/>
              <a:gd name="connsiteY47" fmla="*/ 495300 h 571500"/>
              <a:gd name="connsiteX48" fmla="*/ 92075 w 914400"/>
              <a:gd name="connsiteY48" fmla="*/ 508000 h 571500"/>
              <a:gd name="connsiteX49" fmla="*/ 98425 w 914400"/>
              <a:gd name="connsiteY49" fmla="*/ 517525 h 571500"/>
              <a:gd name="connsiteX50" fmla="*/ 117475 w 914400"/>
              <a:gd name="connsiteY50" fmla="*/ 527050 h 571500"/>
              <a:gd name="connsiteX51" fmla="*/ 142875 w 914400"/>
              <a:gd name="connsiteY51" fmla="*/ 549275 h 571500"/>
              <a:gd name="connsiteX52" fmla="*/ 161925 w 914400"/>
              <a:gd name="connsiteY52" fmla="*/ 555625 h 571500"/>
              <a:gd name="connsiteX53" fmla="*/ 171450 w 914400"/>
              <a:gd name="connsiteY53" fmla="*/ 561975 h 571500"/>
              <a:gd name="connsiteX54" fmla="*/ 206375 w 914400"/>
              <a:gd name="connsiteY54" fmla="*/ 571500 h 571500"/>
              <a:gd name="connsiteX55" fmla="*/ 488950 w 914400"/>
              <a:gd name="connsiteY55" fmla="*/ 568325 h 571500"/>
              <a:gd name="connsiteX56" fmla="*/ 501650 w 914400"/>
              <a:gd name="connsiteY56" fmla="*/ 565150 h 571500"/>
              <a:gd name="connsiteX57" fmla="*/ 530225 w 914400"/>
              <a:gd name="connsiteY57" fmla="*/ 558800 h 571500"/>
              <a:gd name="connsiteX58" fmla="*/ 549275 w 914400"/>
              <a:gd name="connsiteY58" fmla="*/ 552450 h 571500"/>
              <a:gd name="connsiteX59" fmla="*/ 577850 w 914400"/>
              <a:gd name="connsiteY59" fmla="*/ 533400 h 571500"/>
              <a:gd name="connsiteX60" fmla="*/ 596900 w 914400"/>
              <a:gd name="connsiteY60" fmla="*/ 527050 h 571500"/>
              <a:gd name="connsiteX61" fmla="*/ 606425 w 914400"/>
              <a:gd name="connsiteY61" fmla="*/ 520700 h 571500"/>
              <a:gd name="connsiteX62" fmla="*/ 625475 w 914400"/>
              <a:gd name="connsiteY62" fmla="*/ 514350 h 571500"/>
              <a:gd name="connsiteX63" fmla="*/ 635000 w 914400"/>
              <a:gd name="connsiteY63" fmla="*/ 508000 h 571500"/>
              <a:gd name="connsiteX64" fmla="*/ 644525 w 914400"/>
              <a:gd name="connsiteY64" fmla="*/ 504825 h 571500"/>
              <a:gd name="connsiteX65" fmla="*/ 673100 w 914400"/>
              <a:gd name="connsiteY65" fmla="*/ 488950 h 571500"/>
              <a:gd name="connsiteX66" fmla="*/ 701675 w 914400"/>
              <a:gd name="connsiteY66" fmla="*/ 469900 h 571500"/>
              <a:gd name="connsiteX67" fmla="*/ 711200 w 914400"/>
              <a:gd name="connsiteY67" fmla="*/ 466725 h 571500"/>
              <a:gd name="connsiteX68" fmla="*/ 720725 w 914400"/>
              <a:gd name="connsiteY68" fmla="*/ 460375 h 571500"/>
              <a:gd name="connsiteX69" fmla="*/ 730250 w 914400"/>
              <a:gd name="connsiteY69" fmla="*/ 457200 h 571500"/>
              <a:gd name="connsiteX70" fmla="*/ 758825 w 914400"/>
              <a:gd name="connsiteY70" fmla="*/ 441325 h 571500"/>
              <a:gd name="connsiteX71" fmla="*/ 777875 w 914400"/>
              <a:gd name="connsiteY71" fmla="*/ 431800 h 571500"/>
              <a:gd name="connsiteX72" fmla="*/ 796925 w 914400"/>
              <a:gd name="connsiteY72" fmla="*/ 422275 h 571500"/>
              <a:gd name="connsiteX73" fmla="*/ 809625 w 914400"/>
              <a:gd name="connsiteY73" fmla="*/ 406400 h 571500"/>
              <a:gd name="connsiteX74" fmla="*/ 822325 w 914400"/>
              <a:gd name="connsiteY74" fmla="*/ 387350 h 571500"/>
              <a:gd name="connsiteX75" fmla="*/ 828675 w 914400"/>
              <a:gd name="connsiteY75" fmla="*/ 377825 h 571500"/>
              <a:gd name="connsiteX76" fmla="*/ 838200 w 914400"/>
              <a:gd name="connsiteY76" fmla="*/ 349250 h 571500"/>
              <a:gd name="connsiteX77" fmla="*/ 857250 w 914400"/>
              <a:gd name="connsiteY77" fmla="*/ 320675 h 571500"/>
              <a:gd name="connsiteX78" fmla="*/ 863600 w 914400"/>
              <a:gd name="connsiteY78" fmla="*/ 301625 h 571500"/>
              <a:gd name="connsiteX79" fmla="*/ 869950 w 914400"/>
              <a:gd name="connsiteY79" fmla="*/ 292100 h 571500"/>
              <a:gd name="connsiteX80" fmla="*/ 873125 w 914400"/>
              <a:gd name="connsiteY80" fmla="*/ 282575 h 571500"/>
              <a:gd name="connsiteX81" fmla="*/ 885825 w 914400"/>
              <a:gd name="connsiteY81" fmla="*/ 263525 h 571500"/>
              <a:gd name="connsiteX82" fmla="*/ 892175 w 914400"/>
              <a:gd name="connsiteY82" fmla="*/ 254000 h 571500"/>
              <a:gd name="connsiteX83" fmla="*/ 898525 w 914400"/>
              <a:gd name="connsiteY83" fmla="*/ 234950 h 571500"/>
              <a:gd name="connsiteX84" fmla="*/ 904875 w 914400"/>
              <a:gd name="connsiteY84" fmla="*/ 225425 h 571500"/>
              <a:gd name="connsiteX85" fmla="*/ 911225 w 914400"/>
              <a:gd name="connsiteY85" fmla="*/ 206375 h 571500"/>
              <a:gd name="connsiteX86" fmla="*/ 914400 w 914400"/>
              <a:gd name="connsiteY86" fmla="*/ 196850 h 571500"/>
              <a:gd name="connsiteX87" fmla="*/ 911225 w 914400"/>
              <a:gd name="connsiteY87" fmla="*/ 158750 h 571500"/>
              <a:gd name="connsiteX88" fmla="*/ 898525 w 914400"/>
              <a:gd name="connsiteY88" fmla="*/ 130175 h 571500"/>
              <a:gd name="connsiteX89" fmla="*/ 892175 w 914400"/>
              <a:gd name="connsiteY89" fmla="*/ 111125 h 571500"/>
              <a:gd name="connsiteX90" fmla="*/ 889000 w 914400"/>
              <a:gd name="connsiteY90" fmla="*/ 101600 h 571500"/>
              <a:gd name="connsiteX91" fmla="*/ 876300 w 914400"/>
              <a:gd name="connsiteY91" fmla="*/ 82550 h 571500"/>
              <a:gd name="connsiteX92" fmla="*/ 873125 w 914400"/>
              <a:gd name="connsiteY92" fmla="*/ 73025 h 571500"/>
              <a:gd name="connsiteX93" fmla="*/ 857250 w 914400"/>
              <a:gd name="connsiteY93" fmla="*/ 57150 h 571500"/>
              <a:gd name="connsiteX94" fmla="*/ 854075 w 914400"/>
              <a:gd name="connsiteY94" fmla="*/ 47625 h 571500"/>
              <a:gd name="connsiteX95" fmla="*/ 844550 w 914400"/>
              <a:gd name="connsiteY95" fmla="*/ 44450 h 571500"/>
              <a:gd name="connsiteX96" fmla="*/ 835025 w 914400"/>
              <a:gd name="connsiteY96" fmla="*/ 38100 h 571500"/>
              <a:gd name="connsiteX97" fmla="*/ 812800 w 914400"/>
              <a:gd name="connsiteY97" fmla="*/ 22225 h 571500"/>
              <a:gd name="connsiteX98" fmla="*/ 784225 w 914400"/>
              <a:gd name="connsiteY98" fmla="*/ 12700 h 571500"/>
              <a:gd name="connsiteX99" fmla="*/ 771525 w 914400"/>
              <a:gd name="connsiteY99" fmla="*/ 9525 h 571500"/>
              <a:gd name="connsiteX100" fmla="*/ 698500 w 914400"/>
              <a:gd name="connsiteY100" fmla="*/ 6350 h 571500"/>
              <a:gd name="connsiteX101" fmla="*/ 622300 w 914400"/>
              <a:gd name="connsiteY101" fmla="*/ 6350 h 571500"/>
              <a:gd name="connsiteX102" fmla="*/ 638175 w 914400"/>
              <a:gd name="connsiteY102" fmla="*/ 0 h 571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</a:cxnLst>
            <a:rect l="l" t="t" r="r" b="b"/>
            <a:pathLst>
              <a:path w="914400" h="571500">
                <a:moveTo>
                  <a:pt x="638175" y="0"/>
                </a:moveTo>
                <a:cubicBezTo>
                  <a:pt x="632883" y="0"/>
                  <a:pt x="597676" y="3975"/>
                  <a:pt x="590550" y="6350"/>
                </a:cubicBezTo>
                <a:cubicBezTo>
                  <a:pt x="586930" y="7557"/>
                  <a:pt x="584512" y="11150"/>
                  <a:pt x="581025" y="12700"/>
                </a:cubicBezTo>
                <a:cubicBezTo>
                  <a:pt x="574908" y="15418"/>
                  <a:pt x="568325" y="16933"/>
                  <a:pt x="561975" y="19050"/>
                </a:cubicBezTo>
                <a:lnTo>
                  <a:pt x="552450" y="22225"/>
                </a:lnTo>
                <a:lnTo>
                  <a:pt x="542925" y="25400"/>
                </a:lnTo>
                <a:cubicBezTo>
                  <a:pt x="539750" y="26458"/>
                  <a:pt x="536647" y="27763"/>
                  <a:pt x="533400" y="28575"/>
                </a:cubicBezTo>
                <a:cubicBezTo>
                  <a:pt x="529167" y="29633"/>
                  <a:pt x="524896" y="30551"/>
                  <a:pt x="520700" y="31750"/>
                </a:cubicBezTo>
                <a:cubicBezTo>
                  <a:pt x="517482" y="32669"/>
                  <a:pt x="514422" y="34113"/>
                  <a:pt x="511175" y="34925"/>
                </a:cubicBezTo>
                <a:cubicBezTo>
                  <a:pt x="505940" y="36234"/>
                  <a:pt x="500568" y="36929"/>
                  <a:pt x="495300" y="38100"/>
                </a:cubicBezTo>
                <a:cubicBezTo>
                  <a:pt x="491040" y="39047"/>
                  <a:pt x="486893" y="40494"/>
                  <a:pt x="482600" y="41275"/>
                </a:cubicBezTo>
                <a:cubicBezTo>
                  <a:pt x="465443" y="44394"/>
                  <a:pt x="445654" y="45922"/>
                  <a:pt x="428625" y="47625"/>
                </a:cubicBezTo>
                <a:cubicBezTo>
                  <a:pt x="411860" y="53213"/>
                  <a:pt x="421885" y="48944"/>
                  <a:pt x="400050" y="63500"/>
                </a:cubicBezTo>
                <a:cubicBezTo>
                  <a:pt x="394754" y="67031"/>
                  <a:pt x="373945" y="69356"/>
                  <a:pt x="371475" y="69850"/>
                </a:cubicBezTo>
                <a:cubicBezTo>
                  <a:pt x="367196" y="70706"/>
                  <a:pt x="362955" y="71771"/>
                  <a:pt x="358775" y="73025"/>
                </a:cubicBezTo>
                <a:cubicBezTo>
                  <a:pt x="352364" y="74948"/>
                  <a:pt x="339725" y="79375"/>
                  <a:pt x="339725" y="79375"/>
                </a:cubicBezTo>
                <a:cubicBezTo>
                  <a:pt x="324631" y="89438"/>
                  <a:pt x="333820" y="84518"/>
                  <a:pt x="311150" y="92075"/>
                </a:cubicBezTo>
                <a:lnTo>
                  <a:pt x="301625" y="95250"/>
                </a:lnTo>
                <a:lnTo>
                  <a:pt x="244475" y="133350"/>
                </a:lnTo>
                <a:cubicBezTo>
                  <a:pt x="238906" y="137063"/>
                  <a:pt x="231775" y="137583"/>
                  <a:pt x="225425" y="139700"/>
                </a:cubicBezTo>
                <a:lnTo>
                  <a:pt x="215900" y="142875"/>
                </a:lnTo>
                <a:cubicBezTo>
                  <a:pt x="212725" y="144992"/>
                  <a:pt x="209862" y="147675"/>
                  <a:pt x="206375" y="149225"/>
                </a:cubicBezTo>
                <a:cubicBezTo>
                  <a:pt x="200258" y="151943"/>
                  <a:pt x="187325" y="155575"/>
                  <a:pt x="187325" y="155575"/>
                </a:cubicBezTo>
                <a:lnTo>
                  <a:pt x="168275" y="168275"/>
                </a:lnTo>
                <a:cubicBezTo>
                  <a:pt x="165100" y="170392"/>
                  <a:pt x="162370" y="173418"/>
                  <a:pt x="158750" y="174625"/>
                </a:cubicBezTo>
                <a:lnTo>
                  <a:pt x="149225" y="177800"/>
                </a:lnTo>
                <a:cubicBezTo>
                  <a:pt x="134131" y="187863"/>
                  <a:pt x="143320" y="182943"/>
                  <a:pt x="120650" y="190500"/>
                </a:cubicBezTo>
                <a:lnTo>
                  <a:pt x="111125" y="193675"/>
                </a:lnTo>
                <a:cubicBezTo>
                  <a:pt x="107950" y="195792"/>
                  <a:pt x="105013" y="198318"/>
                  <a:pt x="101600" y="200025"/>
                </a:cubicBezTo>
                <a:cubicBezTo>
                  <a:pt x="75310" y="213170"/>
                  <a:pt x="109847" y="191352"/>
                  <a:pt x="82550" y="209550"/>
                </a:cubicBezTo>
                <a:cubicBezTo>
                  <a:pt x="80433" y="212725"/>
                  <a:pt x="79180" y="216691"/>
                  <a:pt x="76200" y="219075"/>
                </a:cubicBezTo>
                <a:cubicBezTo>
                  <a:pt x="73587" y="221166"/>
                  <a:pt x="69668" y="220753"/>
                  <a:pt x="66675" y="222250"/>
                </a:cubicBezTo>
                <a:cubicBezTo>
                  <a:pt x="63262" y="223957"/>
                  <a:pt x="60325" y="226483"/>
                  <a:pt x="57150" y="228600"/>
                </a:cubicBezTo>
                <a:cubicBezTo>
                  <a:pt x="55033" y="231775"/>
                  <a:pt x="53780" y="235741"/>
                  <a:pt x="50800" y="238125"/>
                </a:cubicBezTo>
                <a:cubicBezTo>
                  <a:pt x="48187" y="240216"/>
                  <a:pt x="44268" y="239803"/>
                  <a:pt x="41275" y="241300"/>
                </a:cubicBezTo>
                <a:cubicBezTo>
                  <a:pt x="37862" y="243007"/>
                  <a:pt x="34925" y="245533"/>
                  <a:pt x="31750" y="247650"/>
                </a:cubicBezTo>
                <a:cubicBezTo>
                  <a:pt x="29633" y="250825"/>
                  <a:pt x="28098" y="254477"/>
                  <a:pt x="25400" y="257175"/>
                </a:cubicBezTo>
                <a:cubicBezTo>
                  <a:pt x="22702" y="259873"/>
                  <a:pt x="17897" y="260289"/>
                  <a:pt x="15875" y="263525"/>
                </a:cubicBezTo>
                <a:cubicBezTo>
                  <a:pt x="12327" y="269201"/>
                  <a:pt x="13238" y="277006"/>
                  <a:pt x="9525" y="282575"/>
                </a:cubicBezTo>
                <a:cubicBezTo>
                  <a:pt x="1319" y="294885"/>
                  <a:pt x="4382" y="288480"/>
                  <a:pt x="0" y="301625"/>
                </a:cubicBezTo>
                <a:cubicBezTo>
                  <a:pt x="1058" y="332317"/>
                  <a:pt x="1259" y="363050"/>
                  <a:pt x="3175" y="393700"/>
                </a:cubicBezTo>
                <a:cubicBezTo>
                  <a:pt x="3562" y="399892"/>
                  <a:pt x="9048" y="408368"/>
                  <a:pt x="12700" y="412750"/>
                </a:cubicBezTo>
                <a:cubicBezTo>
                  <a:pt x="15575" y="416199"/>
                  <a:pt x="19468" y="418731"/>
                  <a:pt x="22225" y="422275"/>
                </a:cubicBezTo>
                <a:lnTo>
                  <a:pt x="41275" y="450850"/>
                </a:lnTo>
                <a:cubicBezTo>
                  <a:pt x="43392" y="454025"/>
                  <a:pt x="46418" y="456755"/>
                  <a:pt x="47625" y="460375"/>
                </a:cubicBezTo>
                <a:cubicBezTo>
                  <a:pt x="50207" y="468122"/>
                  <a:pt x="50995" y="473270"/>
                  <a:pt x="57150" y="479425"/>
                </a:cubicBezTo>
                <a:cubicBezTo>
                  <a:pt x="59848" y="482123"/>
                  <a:pt x="63500" y="483658"/>
                  <a:pt x="66675" y="485775"/>
                </a:cubicBezTo>
                <a:cubicBezTo>
                  <a:pt x="68792" y="488950"/>
                  <a:pt x="70153" y="492787"/>
                  <a:pt x="73025" y="495300"/>
                </a:cubicBezTo>
                <a:cubicBezTo>
                  <a:pt x="78768" y="500326"/>
                  <a:pt x="92075" y="508000"/>
                  <a:pt x="92075" y="508000"/>
                </a:cubicBezTo>
                <a:cubicBezTo>
                  <a:pt x="94192" y="511175"/>
                  <a:pt x="95727" y="514827"/>
                  <a:pt x="98425" y="517525"/>
                </a:cubicBezTo>
                <a:cubicBezTo>
                  <a:pt x="104580" y="523680"/>
                  <a:pt x="109728" y="524468"/>
                  <a:pt x="117475" y="527050"/>
                </a:cubicBezTo>
                <a:cubicBezTo>
                  <a:pt x="128058" y="542925"/>
                  <a:pt x="120650" y="534458"/>
                  <a:pt x="142875" y="549275"/>
                </a:cubicBezTo>
                <a:cubicBezTo>
                  <a:pt x="148444" y="552988"/>
                  <a:pt x="161925" y="555625"/>
                  <a:pt x="161925" y="555625"/>
                </a:cubicBezTo>
                <a:cubicBezTo>
                  <a:pt x="165100" y="557742"/>
                  <a:pt x="167963" y="560425"/>
                  <a:pt x="171450" y="561975"/>
                </a:cubicBezTo>
                <a:cubicBezTo>
                  <a:pt x="184633" y="567834"/>
                  <a:pt x="192794" y="568784"/>
                  <a:pt x="206375" y="571500"/>
                </a:cubicBezTo>
                <a:lnTo>
                  <a:pt x="488950" y="568325"/>
                </a:lnTo>
                <a:cubicBezTo>
                  <a:pt x="493313" y="568231"/>
                  <a:pt x="497390" y="566097"/>
                  <a:pt x="501650" y="565150"/>
                </a:cubicBezTo>
                <a:cubicBezTo>
                  <a:pt x="513303" y="562560"/>
                  <a:pt x="519163" y="562118"/>
                  <a:pt x="530225" y="558800"/>
                </a:cubicBezTo>
                <a:cubicBezTo>
                  <a:pt x="536636" y="556877"/>
                  <a:pt x="549275" y="552450"/>
                  <a:pt x="549275" y="552450"/>
                </a:cubicBezTo>
                <a:lnTo>
                  <a:pt x="577850" y="533400"/>
                </a:lnTo>
                <a:cubicBezTo>
                  <a:pt x="583419" y="529687"/>
                  <a:pt x="596900" y="527050"/>
                  <a:pt x="596900" y="527050"/>
                </a:cubicBezTo>
                <a:cubicBezTo>
                  <a:pt x="600075" y="524933"/>
                  <a:pt x="602938" y="522250"/>
                  <a:pt x="606425" y="520700"/>
                </a:cubicBezTo>
                <a:cubicBezTo>
                  <a:pt x="612542" y="517982"/>
                  <a:pt x="625475" y="514350"/>
                  <a:pt x="625475" y="514350"/>
                </a:cubicBezTo>
                <a:cubicBezTo>
                  <a:pt x="628650" y="512233"/>
                  <a:pt x="631587" y="509707"/>
                  <a:pt x="635000" y="508000"/>
                </a:cubicBezTo>
                <a:cubicBezTo>
                  <a:pt x="637993" y="506503"/>
                  <a:pt x="641599" y="506450"/>
                  <a:pt x="644525" y="504825"/>
                </a:cubicBezTo>
                <a:cubicBezTo>
                  <a:pt x="677277" y="486629"/>
                  <a:pt x="651547" y="496134"/>
                  <a:pt x="673100" y="488950"/>
                </a:cubicBezTo>
                <a:lnTo>
                  <a:pt x="701675" y="469900"/>
                </a:lnTo>
                <a:cubicBezTo>
                  <a:pt x="704460" y="468044"/>
                  <a:pt x="708025" y="467783"/>
                  <a:pt x="711200" y="466725"/>
                </a:cubicBezTo>
                <a:cubicBezTo>
                  <a:pt x="714375" y="464608"/>
                  <a:pt x="717312" y="462082"/>
                  <a:pt x="720725" y="460375"/>
                </a:cubicBezTo>
                <a:cubicBezTo>
                  <a:pt x="723718" y="458878"/>
                  <a:pt x="727324" y="458825"/>
                  <a:pt x="730250" y="457200"/>
                </a:cubicBezTo>
                <a:cubicBezTo>
                  <a:pt x="763002" y="439004"/>
                  <a:pt x="737272" y="448509"/>
                  <a:pt x="758825" y="441325"/>
                </a:cubicBezTo>
                <a:cubicBezTo>
                  <a:pt x="786122" y="423127"/>
                  <a:pt x="751585" y="444945"/>
                  <a:pt x="777875" y="431800"/>
                </a:cubicBezTo>
                <a:cubicBezTo>
                  <a:pt x="802494" y="419490"/>
                  <a:pt x="772984" y="430255"/>
                  <a:pt x="796925" y="422275"/>
                </a:cubicBezTo>
                <a:cubicBezTo>
                  <a:pt x="814524" y="410542"/>
                  <a:pt x="800604" y="422638"/>
                  <a:pt x="809625" y="406400"/>
                </a:cubicBezTo>
                <a:cubicBezTo>
                  <a:pt x="813331" y="399729"/>
                  <a:pt x="818092" y="393700"/>
                  <a:pt x="822325" y="387350"/>
                </a:cubicBezTo>
                <a:cubicBezTo>
                  <a:pt x="824442" y="384175"/>
                  <a:pt x="827468" y="381445"/>
                  <a:pt x="828675" y="377825"/>
                </a:cubicBezTo>
                <a:lnTo>
                  <a:pt x="838200" y="349250"/>
                </a:lnTo>
                <a:lnTo>
                  <a:pt x="857250" y="320675"/>
                </a:lnTo>
                <a:cubicBezTo>
                  <a:pt x="860963" y="315106"/>
                  <a:pt x="861483" y="307975"/>
                  <a:pt x="863600" y="301625"/>
                </a:cubicBezTo>
                <a:cubicBezTo>
                  <a:pt x="864807" y="298005"/>
                  <a:pt x="868243" y="295513"/>
                  <a:pt x="869950" y="292100"/>
                </a:cubicBezTo>
                <a:cubicBezTo>
                  <a:pt x="871447" y="289107"/>
                  <a:pt x="871500" y="285501"/>
                  <a:pt x="873125" y="282575"/>
                </a:cubicBezTo>
                <a:cubicBezTo>
                  <a:pt x="876831" y="275904"/>
                  <a:pt x="881592" y="269875"/>
                  <a:pt x="885825" y="263525"/>
                </a:cubicBezTo>
                <a:cubicBezTo>
                  <a:pt x="887942" y="260350"/>
                  <a:pt x="890968" y="257620"/>
                  <a:pt x="892175" y="254000"/>
                </a:cubicBezTo>
                <a:cubicBezTo>
                  <a:pt x="894292" y="247650"/>
                  <a:pt x="894812" y="240519"/>
                  <a:pt x="898525" y="234950"/>
                </a:cubicBezTo>
                <a:cubicBezTo>
                  <a:pt x="900642" y="231775"/>
                  <a:pt x="903325" y="228912"/>
                  <a:pt x="904875" y="225425"/>
                </a:cubicBezTo>
                <a:cubicBezTo>
                  <a:pt x="907593" y="219308"/>
                  <a:pt x="909108" y="212725"/>
                  <a:pt x="911225" y="206375"/>
                </a:cubicBezTo>
                <a:lnTo>
                  <a:pt x="914400" y="196850"/>
                </a:lnTo>
                <a:cubicBezTo>
                  <a:pt x="913342" y="184150"/>
                  <a:pt x="913320" y="171321"/>
                  <a:pt x="911225" y="158750"/>
                </a:cubicBezTo>
                <a:cubicBezTo>
                  <a:pt x="906183" y="128500"/>
                  <a:pt x="907154" y="149590"/>
                  <a:pt x="898525" y="130175"/>
                </a:cubicBezTo>
                <a:cubicBezTo>
                  <a:pt x="895807" y="124058"/>
                  <a:pt x="894292" y="117475"/>
                  <a:pt x="892175" y="111125"/>
                </a:cubicBezTo>
                <a:cubicBezTo>
                  <a:pt x="891117" y="107950"/>
                  <a:pt x="890856" y="104385"/>
                  <a:pt x="889000" y="101600"/>
                </a:cubicBezTo>
                <a:lnTo>
                  <a:pt x="876300" y="82550"/>
                </a:lnTo>
                <a:cubicBezTo>
                  <a:pt x="874444" y="79765"/>
                  <a:pt x="874622" y="76018"/>
                  <a:pt x="873125" y="73025"/>
                </a:cubicBezTo>
                <a:cubicBezTo>
                  <a:pt x="867833" y="62442"/>
                  <a:pt x="866775" y="63500"/>
                  <a:pt x="857250" y="57150"/>
                </a:cubicBezTo>
                <a:cubicBezTo>
                  <a:pt x="856192" y="53975"/>
                  <a:pt x="856442" y="49992"/>
                  <a:pt x="854075" y="47625"/>
                </a:cubicBezTo>
                <a:cubicBezTo>
                  <a:pt x="851708" y="45258"/>
                  <a:pt x="847543" y="45947"/>
                  <a:pt x="844550" y="44450"/>
                </a:cubicBezTo>
                <a:cubicBezTo>
                  <a:pt x="841137" y="42743"/>
                  <a:pt x="838200" y="40217"/>
                  <a:pt x="835025" y="38100"/>
                </a:cubicBezTo>
                <a:cubicBezTo>
                  <a:pt x="829733" y="22225"/>
                  <a:pt x="835025" y="29633"/>
                  <a:pt x="812800" y="22225"/>
                </a:cubicBezTo>
                <a:lnTo>
                  <a:pt x="784225" y="12700"/>
                </a:lnTo>
                <a:cubicBezTo>
                  <a:pt x="780085" y="11320"/>
                  <a:pt x="775877" y="9847"/>
                  <a:pt x="771525" y="9525"/>
                </a:cubicBezTo>
                <a:cubicBezTo>
                  <a:pt x="747227" y="7725"/>
                  <a:pt x="722842" y="7408"/>
                  <a:pt x="698500" y="6350"/>
                </a:cubicBezTo>
                <a:cubicBezTo>
                  <a:pt x="663880" y="580"/>
                  <a:pt x="676245" y="1212"/>
                  <a:pt x="622300" y="6350"/>
                </a:cubicBezTo>
                <a:cubicBezTo>
                  <a:pt x="618968" y="6667"/>
                  <a:pt x="643467" y="0"/>
                  <a:pt x="638175" y="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13" name="フリーフォーム 112"/>
          <p:cNvSpPr/>
          <p:nvPr/>
        </p:nvSpPr>
        <p:spPr>
          <a:xfrm>
            <a:off x="2077120" y="2572643"/>
            <a:ext cx="914400" cy="571500"/>
          </a:xfrm>
          <a:custGeom>
            <a:avLst/>
            <a:gdLst>
              <a:gd name="connsiteX0" fmla="*/ 638175 w 914400"/>
              <a:gd name="connsiteY0" fmla="*/ 0 h 571500"/>
              <a:gd name="connsiteX1" fmla="*/ 590550 w 914400"/>
              <a:gd name="connsiteY1" fmla="*/ 6350 h 571500"/>
              <a:gd name="connsiteX2" fmla="*/ 581025 w 914400"/>
              <a:gd name="connsiteY2" fmla="*/ 12700 h 571500"/>
              <a:gd name="connsiteX3" fmla="*/ 561975 w 914400"/>
              <a:gd name="connsiteY3" fmla="*/ 19050 h 571500"/>
              <a:gd name="connsiteX4" fmla="*/ 552450 w 914400"/>
              <a:gd name="connsiteY4" fmla="*/ 22225 h 571500"/>
              <a:gd name="connsiteX5" fmla="*/ 542925 w 914400"/>
              <a:gd name="connsiteY5" fmla="*/ 25400 h 571500"/>
              <a:gd name="connsiteX6" fmla="*/ 533400 w 914400"/>
              <a:gd name="connsiteY6" fmla="*/ 28575 h 571500"/>
              <a:gd name="connsiteX7" fmla="*/ 520700 w 914400"/>
              <a:gd name="connsiteY7" fmla="*/ 31750 h 571500"/>
              <a:gd name="connsiteX8" fmla="*/ 511175 w 914400"/>
              <a:gd name="connsiteY8" fmla="*/ 34925 h 571500"/>
              <a:gd name="connsiteX9" fmla="*/ 495300 w 914400"/>
              <a:gd name="connsiteY9" fmla="*/ 38100 h 571500"/>
              <a:gd name="connsiteX10" fmla="*/ 482600 w 914400"/>
              <a:gd name="connsiteY10" fmla="*/ 41275 h 571500"/>
              <a:gd name="connsiteX11" fmla="*/ 428625 w 914400"/>
              <a:gd name="connsiteY11" fmla="*/ 47625 h 571500"/>
              <a:gd name="connsiteX12" fmla="*/ 400050 w 914400"/>
              <a:gd name="connsiteY12" fmla="*/ 63500 h 571500"/>
              <a:gd name="connsiteX13" fmla="*/ 371475 w 914400"/>
              <a:gd name="connsiteY13" fmla="*/ 69850 h 571500"/>
              <a:gd name="connsiteX14" fmla="*/ 358775 w 914400"/>
              <a:gd name="connsiteY14" fmla="*/ 73025 h 571500"/>
              <a:gd name="connsiteX15" fmla="*/ 339725 w 914400"/>
              <a:gd name="connsiteY15" fmla="*/ 79375 h 571500"/>
              <a:gd name="connsiteX16" fmla="*/ 311150 w 914400"/>
              <a:gd name="connsiteY16" fmla="*/ 92075 h 571500"/>
              <a:gd name="connsiteX17" fmla="*/ 301625 w 914400"/>
              <a:gd name="connsiteY17" fmla="*/ 95250 h 571500"/>
              <a:gd name="connsiteX18" fmla="*/ 244475 w 914400"/>
              <a:gd name="connsiteY18" fmla="*/ 133350 h 571500"/>
              <a:gd name="connsiteX19" fmla="*/ 225425 w 914400"/>
              <a:gd name="connsiteY19" fmla="*/ 139700 h 571500"/>
              <a:gd name="connsiteX20" fmla="*/ 215900 w 914400"/>
              <a:gd name="connsiteY20" fmla="*/ 142875 h 571500"/>
              <a:gd name="connsiteX21" fmla="*/ 206375 w 914400"/>
              <a:gd name="connsiteY21" fmla="*/ 149225 h 571500"/>
              <a:gd name="connsiteX22" fmla="*/ 187325 w 914400"/>
              <a:gd name="connsiteY22" fmla="*/ 155575 h 571500"/>
              <a:gd name="connsiteX23" fmla="*/ 168275 w 914400"/>
              <a:gd name="connsiteY23" fmla="*/ 168275 h 571500"/>
              <a:gd name="connsiteX24" fmla="*/ 158750 w 914400"/>
              <a:gd name="connsiteY24" fmla="*/ 174625 h 571500"/>
              <a:gd name="connsiteX25" fmla="*/ 149225 w 914400"/>
              <a:gd name="connsiteY25" fmla="*/ 177800 h 571500"/>
              <a:gd name="connsiteX26" fmla="*/ 120650 w 914400"/>
              <a:gd name="connsiteY26" fmla="*/ 190500 h 571500"/>
              <a:gd name="connsiteX27" fmla="*/ 111125 w 914400"/>
              <a:gd name="connsiteY27" fmla="*/ 193675 h 571500"/>
              <a:gd name="connsiteX28" fmla="*/ 101600 w 914400"/>
              <a:gd name="connsiteY28" fmla="*/ 200025 h 571500"/>
              <a:gd name="connsiteX29" fmla="*/ 82550 w 914400"/>
              <a:gd name="connsiteY29" fmla="*/ 209550 h 571500"/>
              <a:gd name="connsiteX30" fmla="*/ 76200 w 914400"/>
              <a:gd name="connsiteY30" fmla="*/ 219075 h 571500"/>
              <a:gd name="connsiteX31" fmla="*/ 66675 w 914400"/>
              <a:gd name="connsiteY31" fmla="*/ 222250 h 571500"/>
              <a:gd name="connsiteX32" fmla="*/ 57150 w 914400"/>
              <a:gd name="connsiteY32" fmla="*/ 228600 h 571500"/>
              <a:gd name="connsiteX33" fmla="*/ 50800 w 914400"/>
              <a:gd name="connsiteY33" fmla="*/ 238125 h 571500"/>
              <a:gd name="connsiteX34" fmla="*/ 41275 w 914400"/>
              <a:gd name="connsiteY34" fmla="*/ 241300 h 571500"/>
              <a:gd name="connsiteX35" fmla="*/ 31750 w 914400"/>
              <a:gd name="connsiteY35" fmla="*/ 247650 h 571500"/>
              <a:gd name="connsiteX36" fmla="*/ 25400 w 914400"/>
              <a:gd name="connsiteY36" fmla="*/ 257175 h 571500"/>
              <a:gd name="connsiteX37" fmla="*/ 15875 w 914400"/>
              <a:gd name="connsiteY37" fmla="*/ 263525 h 571500"/>
              <a:gd name="connsiteX38" fmla="*/ 9525 w 914400"/>
              <a:gd name="connsiteY38" fmla="*/ 282575 h 571500"/>
              <a:gd name="connsiteX39" fmla="*/ 0 w 914400"/>
              <a:gd name="connsiteY39" fmla="*/ 301625 h 571500"/>
              <a:gd name="connsiteX40" fmla="*/ 3175 w 914400"/>
              <a:gd name="connsiteY40" fmla="*/ 393700 h 571500"/>
              <a:gd name="connsiteX41" fmla="*/ 12700 w 914400"/>
              <a:gd name="connsiteY41" fmla="*/ 412750 h 571500"/>
              <a:gd name="connsiteX42" fmla="*/ 22225 w 914400"/>
              <a:gd name="connsiteY42" fmla="*/ 422275 h 571500"/>
              <a:gd name="connsiteX43" fmla="*/ 41275 w 914400"/>
              <a:gd name="connsiteY43" fmla="*/ 450850 h 571500"/>
              <a:gd name="connsiteX44" fmla="*/ 47625 w 914400"/>
              <a:gd name="connsiteY44" fmla="*/ 460375 h 571500"/>
              <a:gd name="connsiteX45" fmla="*/ 57150 w 914400"/>
              <a:gd name="connsiteY45" fmla="*/ 479425 h 571500"/>
              <a:gd name="connsiteX46" fmla="*/ 66675 w 914400"/>
              <a:gd name="connsiteY46" fmla="*/ 485775 h 571500"/>
              <a:gd name="connsiteX47" fmla="*/ 73025 w 914400"/>
              <a:gd name="connsiteY47" fmla="*/ 495300 h 571500"/>
              <a:gd name="connsiteX48" fmla="*/ 92075 w 914400"/>
              <a:gd name="connsiteY48" fmla="*/ 508000 h 571500"/>
              <a:gd name="connsiteX49" fmla="*/ 98425 w 914400"/>
              <a:gd name="connsiteY49" fmla="*/ 517525 h 571500"/>
              <a:gd name="connsiteX50" fmla="*/ 117475 w 914400"/>
              <a:gd name="connsiteY50" fmla="*/ 527050 h 571500"/>
              <a:gd name="connsiteX51" fmla="*/ 142875 w 914400"/>
              <a:gd name="connsiteY51" fmla="*/ 549275 h 571500"/>
              <a:gd name="connsiteX52" fmla="*/ 161925 w 914400"/>
              <a:gd name="connsiteY52" fmla="*/ 555625 h 571500"/>
              <a:gd name="connsiteX53" fmla="*/ 171450 w 914400"/>
              <a:gd name="connsiteY53" fmla="*/ 561975 h 571500"/>
              <a:gd name="connsiteX54" fmla="*/ 206375 w 914400"/>
              <a:gd name="connsiteY54" fmla="*/ 571500 h 571500"/>
              <a:gd name="connsiteX55" fmla="*/ 488950 w 914400"/>
              <a:gd name="connsiteY55" fmla="*/ 568325 h 571500"/>
              <a:gd name="connsiteX56" fmla="*/ 501650 w 914400"/>
              <a:gd name="connsiteY56" fmla="*/ 565150 h 571500"/>
              <a:gd name="connsiteX57" fmla="*/ 530225 w 914400"/>
              <a:gd name="connsiteY57" fmla="*/ 558800 h 571500"/>
              <a:gd name="connsiteX58" fmla="*/ 549275 w 914400"/>
              <a:gd name="connsiteY58" fmla="*/ 552450 h 571500"/>
              <a:gd name="connsiteX59" fmla="*/ 577850 w 914400"/>
              <a:gd name="connsiteY59" fmla="*/ 533400 h 571500"/>
              <a:gd name="connsiteX60" fmla="*/ 596900 w 914400"/>
              <a:gd name="connsiteY60" fmla="*/ 527050 h 571500"/>
              <a:gd name="connsiteX61" fmla="*/ 606425 w 914400"/>
              <a:gd name="connsiteY61" fmla="*/ 520700 h 571500"/>
              <a:gd name="connsiteX62" fmla="*/ 625475 w 914400"/>
              <a:gd name="connsiteY62" fmla="*/ 514350 h 571500"/>
              <a:gd name="connsiteX63" fmla="*/ 635000 w 914400"/>
              <a:gd name="connsiteY63" fmla="*/ 508000 h 571500"/>
              <a:gd name="connsiteX64" fmla="*/ 644525 w 914400"/>
              <a:gd name="connsiteY64" fmla="*/ 504825 h 571500"/>
              <a:gd name="connsiteX65" fmla="*/ 673100 w 914400"/>
              <a:gd name="connsiteY65" fmla="*/ 488950 h 571500"/>
              <a:gd name="connsiteX66" fmla="*/ 701675 w 914400"/>
              <a:gd name="connsiteY66" fmla="*/ 469900 h 571500"/>
              <a:gd name="connsiteX67" fmla="*/ 711200 w 914400"/>
              <a:gd name="connsiteY67" fmla="*/ 466725 h 571500"/>
              <a:gd name="connsiteX68" fmla="*/ 720725 w 914400"/>
              <a:gd name="connsiteY68" fmla="*/ 460375 h 571500"/>
              <a:gd name="connsiteX69" fmla="*/ 730250 w 914400"/>
              <a:gd name="connsiteY69" fmla="*/ 457200 h 571500"/>
              <a:gd name="connsiteX70" fmla="*/ 758825 w 914400"/>
              <a:gd name="connsiteY70" fmla="*/ 441325 h 571500"/>
              <a:gd name="connsiteX71" fmla="*/ 777875 w 914400"/>
              <a:gd name="connsiteY71" fmla="*/ 431800 h 571500"/>
              <a:gd name="connsiteX72" fmla="*/ 796925 w 914400"/>
              <a:gd name="connsiteY72" fmla="*/ 422275 h 571500"/>
              <a:gd name="connsiteX73" fmla="*/ 809625 w 914400"/>
              <a:gd name="connsiteY73" fmla="*/ 406400 h 571500"/>
              <a:gd name="connsiteX74" fmla="*/ 822325 w 914400"/>
              <a:gd name="connsiteY74" fmla="*/ 387350 h 571500"/>
              <a:gd name="connsiteX75" fmla="*/ 828675 w 914400"/>
              <a:gd name="connsiteY75" fmla="*/ 377825 h 571500"/>
              <a:gd name="connsiteX76" fmla="*/ 838200 w 914400"/>
              <a:gd name="connsiteY76" fmla="*/ 349250 h 571500"/>
              <a:gd name="connsiteX77" fmla="*/ 857250 w 914400"/>
              <a:gd name="connsiteY77" fmla="*/ 320675 h 571500"/>
              <a:gd name="connsiteX78" fmla="*/ 863600 w 914400"/>
              <a:gd name="connsiteY78" fmla="*/ 301625 h 571500"/>
              <a:gd name="connsiteX79" fmla="*/ 869950 w 914400"/>
              <a:gd name="connsiteY79" fmla="*/ 292100 h 571500"/>
              <a:gd name="connsiteX80" fmla="*/ 873125 w 914400"/>
              <a:gd name="connsiteY80" fmla="*/ 282575 h 571500"/>
              <a:gd name="connsiteX81" fmla="*/ 885825 w 914400"/>
              <a:gd name="connsiteY81" fmla="*/ 263525 h 571500"/>
              <a:gd name="connsiteX82" fmla="*/ 892175 w 914400"/>
              <a:gd name="connsiteY82" fmla="*/ 254000 h 571500"/>
              <a:gd name="connsiteX83" fmla="*/ 898525 w 914400"/>
              <a:gd name="connsiteY83" fmla="*/ 234950 h 571500"/>
              <a:gd name="connsiteX84" fmla="*/ 904875 w 914400"/>
              <a:gd name="connsiteY84" fmla="*/ 225425 h 571500"/>
              <a:gd name="connsiteX85" fmla="*/ 911225 w 914400"/>
              <a:gd name="connsiteY85" fmla="*/ 206375 h 571500"/>
              <a:gd name="connsiteX86" fmla="*/ 914400 w 914400"/>
              <a:gd name="connsiteY86" fmla="*/ 196850 h 571500"/>
              <a:gd name="connsiteX87" fmla="*/ 911225 w 914400"/>
              <a:gd name="connsiteY87" fmla="*/ 158750 h 571500"/>
              <a:gd name="connsiteX88" fmla="*/ 898525 w 914400"/>
              <a:gd name="connsiteY88" fmla="*/ 130175 h 571500"/>
              <a:gd name="connsiteX89" fmla="*/ 892175 w 914400"/>
              <a:gd name="connsiteY89" fmla="*/ 111125 h 571500"/>
              <a:gd name="connsiteX90" fmla="*/ 889000 w 914400"/>
              <a:gd name="connsiteY90" fmla="*/ 101600 h 571500"/>
              <a:gd name="connsiteX91" fmla="*/ 876300 w 914400"/>
              <a:gd name="connsiteY91" fmla="*/ 82550 h 571500"/>
              <a:gd name="connsiteX92" fmla="*/ 873125 w 914400"/>
              <a:gd name="connsiteY92" fmla="*/ 73025 h 571500"/>
              <a:gd name="connsiteX93" fmla="*/ 857250 w 914400"/>
              <a:gd name="connsiteY93" fmla="*/ 57150 h 571500"/>
              <a:gd name="connsiteX94" fmla="*/ 854075 w 914400"/>
              <a:gd name="connsiteY94" fmla="*/ 47625 h 571500"/>
              <a:gd name="connsiteX95" fmla="*/ 844550 w 914400"/>
              <a:gd name="connsiteY95" fmla="*/ 44450 h 571500"/>
              <a:gd name="connsiteX96" fmla="*/ 835025 w 914400"/>
              <a:gd name="connsiteY96" fmla="*/ 38100 h 571500"/>
              <a:gd name="connsiteX97" fmla="*/ 812800 w 914400"/>
              <a:gd name="connsiteY97" fmla="*/ 22225 h 571500"/>
              <a:gd name="connsiteX98" fmla="*/ 784225 w 914400"/>
              <a:gd name="connsiteY98" fmla="*/ 12700 h 571500"/>
              <a:gd name="connsiteX99" fmla="*/ 771525 w 914400"/>
              <a:gd name="connsiteY99" fmla="*/ 9525 h 571500"/>
              <a:gd name="connsiteX100" fmla="*/ 698500 w 914400"/>
              <a:gd name="connsiteY100" fmla="*/ 6350 h 571500"/>
              <a:gd name="connsiteX101" fmla="*/ 622300 w 914400"/>
              <a:gd name="connsiteY101" fmla="*/ 6350 h 571500"/>
              <a:gd name="connsiteX102" fmla="*/ 638175 w 914400"/>
              <a:gd name="connsiteY102" fmla="*/ 0 h 571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</a:cxnLst>
            <a:rect l="l" t="t" r="r" b="b"/>
            <a:pathLst>
              <a:path w="914400" h="571500">
                <a:moveTo>
                  <a:pt x="638175" y="0"/>
                </a:moveTo>
                <a:cubicBezTo>
                  <a:pt x="632883" y="0"/>
                  <a:pt x="597676" y="3975"/>
                  <a:pt x="590550" y="6350"/>
                </a:cubicBezTo>
                <a:cubicBezTo>
                  <a:pt x="586930" y="7557"/>
                  <a:pt x="584512" y="11150"/>
                  <a:pt x="581025" y="12700"/>
                </a:cubicBezTo>
                <a:cubicBezTo>
                  <a:pt x="574908" y="15418"/>
                  <a:pt x="568325" y="16933"/>
                  <a:pt x="561975" y="19050"/>
                </a:cubicBezTo>
                <a:lnTo>
                  <a:pt x="552450" y="22225"/>
                </a:lnTo>
                <a:lnTo>
                  <a:pt x="542925" y="25400"/>
                </a:lnTo>
                <a:cubicBezTo>
                  <a:pt x="539750" y="26458"/>
                  <a:pt x="536647" y="27763"/>
                  <a:pt x="533400" y="28575"/>
                </a:cubicBezTo>
                <a:cubicBezTo>
                  <a:pt x="529167" y="29633"/>
                  <a:pt x="524896" y="30551"/>
                  <a:pt x="520700" y="31750"/>
                </a:cubicBezTo>
                <a:cubicBezTo>
                  <a:pt x="517482" y="32669"/>
                  <a:pt x="514422" y="34113"/>
                  <a:pt x="511175" y="34925"/>
                </a:cubicBezTo>
                <a:cubicBezTo>
                  <a:pt x="505940" y="36234"/>
                  <a:pt x="500568" y="36929"/>
                  <a:pt x="495300" y="38100"/>
                </a:cubicBezTo>
                <a:cubicBezTo>
                  <a:pt x="491040" y="39047"/>
                  <a:pt x="486893" y="40494"/>
                  <a:pt x="482600" y="41275"/>
                </a:cubicBezTo>
                <a:cubicBezTo>
                  <a:pt x="465443" y="44394"/>
                  <a:pt x="445654" y="45922"/>
                  <a:pt x="428625" y="47625"/>
                </a:cubicBezTo>
                <a:cubicBezTo>
                  <a:pt x="411860" y="53213"/>
                  <a:pt x="421885" y="48944"/>
                  <a:pt x="400050" y="63500"/>
                </a:cubicBezTo>
                <a:cubicBezTo>
                  <a:pt x="394754" y="67031"/>
                  <a:pt x="373945" y="69356"/>
                  <a:pt x="371475" y="69850"/>
                </a:cubicBezTo>
                <a:cubicBezTo>
                  <a:pt x="367196" y="70706"/>
                  <a:pt x="362955" y="71771"/>
                  <a:pt x="358775" y="73025"/>
                </a:cubicBezTo>
                <a:cubicBezTo>
                  <a:pt x="352364" y="74948"/>
                  <a:pt x="339725" y="79375"/>
                  <a:pt x="339725" y="79375"/>
                </a:cubicBezTo>
                <a:cubicBezTo>
                  <a:pt x="324631" y="89438"/>
                  <a:pt x="333820" y="84518"/>
                  <a:pt x="311150" y="92075"/>
                </a:cubicBezTo>
                <a:lnTo>
                  <a:pt x="301625" y="95250"/>
                </a:lnTo>
                <a:lnTo>
                  <a:pt x="244475" y="133350"/>
                </a:lnTo>
                <a:cubicBezTo>
                  <a:pt x="238906" y="137063"/>
                  <a:pt x="231775" y="137583"/>
                  <a:pt x="225425" y="139700"/>
                </a:cubicBezTo>
                <a:lnTo>
                  <a:pt x="215900" y="142875"/>
                </a:lnTo>
                <a:cubicBezTo>
                  <a:pt x="212725" y="144992"/>
                  <a:pt x="209862" y="147675"/>
                  <a:pt x="206375" y="149225"/>
                </a:cubicBezTo>
                <a:cubicBezTo>
                  <a:pt x="200258" y="151943"/>
                  <a:pt x="187325" y="155575"/>
                  <a:pt x="187325" y="155575"/>
                </a:cubicBezTo>
                <a:lnTo>
                  <a:pt x="168275" y="168275"/>
                </a:lnTo>
                <a:cubicBezTo>
                  <a:pt x="165100" y="170392"/>
                  <a:pt x="162370" y="173418"/>
                  <a:pt x="158750" y="174625"/>
                </a:cubicBezTo>
                <a:lnTo>
                  <a:pt x="149225" y="177800"/>
                </a:lnTo>
                <a:cubicBezTo>
                  <a:pt x="134131" y="187863"/>
                  <a:pt x="143320" y="182943"/>
                  <a:pt x="120650" y="190500"/>
                </a:cubicBezTo>
                <a:lnTo>
                  <a:pt x="111125" y="193675"/>
                </a:lnTo>
                <a:cubicBezTo>
                  <a:pt x="107950" y="195792"/>
                  <a:pt x="105013" y="198318"/>
                  <a:pt x="101600" y="200025"/>
                </a:cubicBezTo>
                <a:cubicBezTo>
                  <a:pt x="75310" y="213170"/>
                  <a:pt x="109847" y="191352"/>
                  <a:pt x="82550" y="209550"/>
                </a:cubicBezTo>
                <a:cubicBezTo>
                  <a:pt x="80433" y="212725"/>
                  <a:pt x="79180" y="216691"/>
                  <a:pt x="76200" y="219075"/>
                </a:cubicBezTo>
                <a:cubicBezTo>
                  <a:pt x="73587" y="221166"/>
                  <a:pt x="69668" y="220753"/>
                  <a:pt x="66675" y="222250"/>
                </a:cubicBezTo>
                <a:cubicBezTo>
                  <a:pt x="63262" y="223957"/>
                  <a:pt x="60325" y="226483"/>
                  <a:pt x="57150" y="228600"/>
                </a:cubicBezTo>
                <a:cubicBezTo>
                  <a:pt x="55033" y="231775"/>
                  <a:pt x="53780" y="235741"/>
                  <a:pt x="50800" y="238125"/>
                </a:cubicBezTo>
                <a:cubicBezTo>
                  <a:pt x="48187" y="240216"/>
                  <a:pt x="44268" y="239803"/>
                  <a:pt x="41275" y="241300"/>
                </a:cubicBezTo>
                <a:cubicBezTo>
                  <a:pt x="37862" y="243007"/>
                  <a:pt x="34925" y="245533"/>
                  <a:pt x="31750" y="247650"/>
                </a:cubicBezTo>
                <a:cubicBezTo>
                  <a:pt x="29633" y="250825"/>
                  <a:pt x="28098" y="254477"/>
                  <a:pt x="25400" y="257175"/>
                </a:cubicBezTo>
                <a:cubicBezTo>
                  <a:pt x="22702" y="259873"/>
                  <a:pt x="17897" y="260289"/>
                  <a:pt x="15875" y="263525"/>
                </a:cubicBezTo>
                <a:cubicBezTo>
                  <a:pt x="12327" y="269201"/>
                  <a:pt x="13238" y="277006"/>
                  <a:pt x="9525" y="282575"/>
                </a:cubicBezTo>
                <a:cubicBezTo>
                  <a:pt x="1319" y="294885"/>
                  <a:pt x="4382" y="288480"/>
                  <a:pt x="0" y="301625"/>
                </a:cubicBezTo>
                <a:cubicBezTo>
                  <a:pt x="1058" y="332317"/>
                  <a:pt x="1259" y="363050"/>
                  <a:pt x="3175" y="393700"/>
                </a:cubicBezTo>
                <a:cubicBezTo>
                  <a:pt x="3562" y="399892"/>
                  <a:pt x="9048" y="408368"/>
                  <a:pt x="12700" y="412750"/>
                </a:cubicBezTo>
                <a:cubicBezTo>
                  <a:pt x="15575" y="416199"/>
                  <a:pt x="19468" y="418731"/>
                  <a:pt x="22225" y="422275"/>
                </a:cubicBezTo>
                <a:lnTo>
                  <a:pt x="41275" y="450850"/>
                </a:lnTo>
                <a:cubicBezTo>
                  <a:pt x="43392" y="454025"/>
                  <a:pt x="46418" y="456755"/>
                  <a:pt x="47625" y="460375"/>
                </a:cubicBezTo>
                <a:cubicBezTo>
                  <a:pt x="50207" y="468122"/>
                  <a:pt x="50995" y="473270"/>
                  <a:pt x="57150" y="479425"/>
                </a:cubicBezTo>
                <a:cubicBezTo>
                  <a:pt x="59848" y="482123"/>
                  <a:pt x="63500" y="483658"/>
                  <a:pt x="66675" y="485775"/>
                </a:cubicBezTo>
                <a:cubicBezTo>
                  <a:pt x="68792" y="488950"/>
                  <a:pt x="70153" y="492787"/>
                  <a:pt x="73025" y="495300"/>
                </a:cubicBezTo>
                <a:cubicBezTo>
                  <a:pt x="78768" y="500326"/>
                  <a:pt x="92075" y="508000"/>
                  <a:pt x="92075" y="508000"/>
                </a:cubicBezTo>
                <a:cubicBezTo>
                  <a:pt x="94192" y="511175"/>
                  <a:pt x="95727" y="514827"/>
                  <a:pt x="98425" y="517525"/>
                </a:cubicBezTo>
                <a:cubicBezTo>
                  <a:pt x="104580" y="523680"/>
                  <a:pt x="109728" y="524468"/>
                  <a:pt x="117475" y="527050"/>
                </a:cubicBezTo>
                <a:cubicBezTo>
                  <a:pt x="128058" y="542925"/>
                  <a:pt x="120650" y="534458"/>
                  <a:pt x="142875" y="549275"/>
                </a:cubicBezTo>
                <a:cubicBezTo>
                  <a:pt x="148444" y="552988"/>
                  <a:pt x="161925" y="555625"/>
                  <a:pt x="161925" y="555625"/>
                </a:cubicBezTo>
                <a:cubicBezTo>
                  <a:pt x="165100" y="557742"/>
                  <a:pt x="167963" y="560425"/>
                  <a:pt x="171450" y="561975"/>
                </a:cubicBezTo>
                <a:cubicBezTo>
                  <a:pt x="184633" y="567834"/>
                  <a:pt x="192794" y="568784"/>
                  <a:pt x="206375" y="571500"/>
                </a:cubicBezTo>
                <a:lnTo>
                  <a:pt x="488950" y="568325"/>
                </a:lnTo>
                <a:cubicBezTo>
                  <a:pt x="493313" y="568231"/>
                  <a:pt x="497390" y="566097"/>
                  <a:pt x="501650" y="565150"/>
                </a:cubicBezTo>
                <a:cubicBezTo>
                  <a:pt x="513303" y="562560"/>
                  <a:pt x="519163" y="562118"/>
                  <a:pt x="530225" y="558800"/>
                </a:cubicBezTo>
                <a:cubicBezTo>
                  <a:pt x="536636" y="556877"/>
                  <a:pt x="549275" y="552450"/>
                  <a:pt x="549275" y="552450"/>
                </a:cubicBezTo>
                <a:lnTo>
                  <a:pt x="577850" y="533400"/>
                </a:lnTo>
                <a:cubicBezTo>
                  <a:pt x="583419" y="529687"/>
                  <a:pt x="596900" y="527050"/>
                  <a:pt x="596900" y="527050"/>
                </a:cubicBezTo>
                <a:cubicBezTo>
                  <a:pt x="600075" y="524933"/>
                  <a:pt x="602938" y="522250"/>
                  <a:pt x="606425" y="520700"/>
                </a:cubicBezTo>
                <a:cubicBezTo>
                  <a:pt x="612542" y="517982"/>
                  <a:pt x="625475" y="514350"/>
                  <a:pt x="625475" y="514350"/>
                </a:cubicBezTo>
                <a:cubicBezTo>
                  <a:pt x="628650" y="512233"/>
                  <a:pt x="631587" y="509707"/>
                  <a:pt x="635000" y="508000"/>
                </a:cubicBezTo>
                <a:cubicBezTo>
                  <a:pt x="637993" y="506503"/>
                  <a:pt x="641599" y="506450"/>
                  <a:pt x="644525" y="504825"/>
                </a:cubicBezTo>
                <a:cubicBezTo>
                  <a:pt x="677277" y="486629"/>
                  <a:pt x="651547" y="496134"/>
                  <a:pt x="673100" y="488950"/>
                </a:cubicBezTo>
                <a:lnTo>
                  <a:pt x="701675" y="469900"/>
                </a:lnTo>
                <a:cubicBezTo>
                  <a:pt x="704460" y="468044"/>
                  <a:pt x="708025" y="467783"/>
                  <a:pt x="711200" y="466725"/>
                </a:cubicBezTo>
                <a:cubicBezTo>
                  <a:pt x="714375" y="464608"/>
                  <a:pt x="717312" y="462082"/>
                  <a:pt x="720725" y="460375"/>
                </a:cubicBezTo>
                <a:cubicBezTo>
                  <a:pt x="723718" y="458878"/>
                  <a:pt x="727324" y="458825"/>
                  <a:pt x="730250" y="457200"/>
                </a:cubicBezTo>
                <a:cubicBezTo>
                  <a:pt x="763002" y="439004"/>
                  <a:pt x="737272" y="448509"/>
                  <a:pt x="758825" y="441325"/>
                </a:cubicBezTo>
                <a:cubicBezTo>
                  <a:pt x="786122" y="423127"/>
                  <a:pt x="751585" y="444945"/>
                  <a:pt x="777875" y="431800"/>
                </a:cubicBezTo>
                <a:cubicBezTo>
                  <a:pt x="802494" y="419490"/>
                  <a:pt x="772984" y="430255"/>
                  <a:pt x="796925" y="422275"/>
                </a:cubicBezTo>
                <a:cubicBezTo>
                  <a:pt x="814524" y="410542"/>
                  <a:pt x="800604" y="422638"/>
                  <a:pt x="809625" y="406400"/>
                </a:cubicBezTo>
                <a:cubicBezTo>
                  <a:pt x="813331" y="399729"/>
                  <a:pt x="818092" y="393700"/>
                  <a:pt x="822325" y="387350"/>
                </a:cubicBezTo>
                <a:cubicBezTo>
                  <a:pt x="824442" y="384175"/>
                  <a:pt x="827468" y="381445"/>
                  <a:pt x="828675" y="377825"/>
                </a:cubicBezTo>
                <a:lnTo>
                  <a:pt x="838200" y="349250"/>
                </a:lnTo>
                <a:lnTo>
                  <a:pt x="857250" y="320675"/>
                </a:lnTo>
                <a:cubicBezTo>
                  <a:pt x="860963" y="315106"/>
                  <a:pt x="861483" y="307975"/>
                  <a:pt x="863600" y="301625"/>
                </a:cubicBezTo>
                <a:cubicBezTo>
                  <a:pt x="864807" y="298005"/>
                  <a:pt x="868243" y="295513"/>
                  <a:pt x="869950" y="292100"/>
                </a:cubicBezTo>
                <a:cubicBezTo>
                  <a:pt x="871447" y="289107"/>
                  <a:pt x="871500" y="285501"/>
                  <a:pt x="873125" y="282575"/>
                </a:cubicBezTo>
                <a:cubicBezTo>
                  <a:pt x="876831" y="275904"/>
                  <a:pt x="881592" y="269875"/>
                  <a:pt x="885825" y="263525"/>
                </a:cubicBezTo>
                <a:cubicBezTo>
                  <a:pt x="887942" y="260350"/>
                  <a:pt x="890968" y="257620"/>
                  <a:pt x="892175" y="254000"/>
                </a:cubicBezTo>
                <a:cubicBezTo>
                  <a:pt x="894292" y="247650"/>
                  <a:pt x="894812" y="240519"/>
                  <a:pt x="898525" y="234950"/>
                </a:cubicBezTo>
                <a:cubicBezTo>
                  <a:pt x="900642" y="231775"/>
                  <a:pt x="903325" y="228912"/>
                  <a:pt x="904875" y="225425"/>
                </a:cubicBezTo>
                <a:cubicBezTo>
                  <a:pt x="907593" y="219308"/>
                  <a:pt x="909108" y="212725"/>
                  <a:pt x="911225" y="206375"/>
                </a:cubicBezTo>
                <a:lnTo>
                  <a:pt x="914400" y="196850"/>
                </a:lnTo>
                <a:cubicBezTo>
                  <a:pt x="913342" y="184150"/>
                  <a:pt x="913320" y="171321"/>
                  <a:pt x="911225" y="158750"/>
                </a:cubicBezTo>
                <a:cubicBezTo>
                  <a:pt x="906183" y="128500"/>
                  <a:pt x="907154" y="149590"/>
                  <a:pt x="898525" y="130175"/>
                </a:cubicBezTo>
                <a:cubicBezTo>
                  <a:pt x="895807" y="124058"/>
                  <a:pt x="894292" y="117475"/>
                  <a:pt x="892175" y="111125"/>
                </a:cubicBezTo>
                <a:cubicBezTo>
                  <a:pt x="891117" y="107950"/>
                  <a:pt x="890856" y="104385"/>
                  <a:pt x="889000" y="101600"/>
                </a:cubicBezTo>
                <a:lnTo>
                  <a:pt x="876300" y="82550"/>
                </a:lnTo>
                <a:cubicBezTo>
                  <a:pt x="874444" y="79765"/>
                  <a:pt x="874622" y="76018"/>
                  <a:pt x="873125" y="73025"/>
                </a:cubicBezTo>
                <a:cubicBezTo>
                  <a:pt x="867833" y="62442"/>
                  <a:pt x="866775" y="63500"/>
                  <a:pt x="857250" y="57150"/>
                </a:cubicBezTo>
                <a:cubicBezTo>
                  <a:pt x="856192" y="53975"/>
                  <a:pt x="856442" y="49992"/>
                  <a:pt x="854075" y="47625"/>
                </a:cubicBezTo>
                <a:cubicBezTo>
                  <a:pt x="851708" y="45258"/>
                  <a:pt x="847543" y="45947"/>
                  <a:pt x="844550" y="44450"/>
                </a:cubicBezTo>
                <a:cubicBezTo>
                  <a:pt x="841137" y="42743"/>
                  <a:pt x="838200" y="40217"/>
                  <a:pt x="835025" y="38100"/>
                </a:cubicBezTo>
                <a:cubicBezTo>
                  <a:pt x="829733" y="22225"/>
                  <a:pt x="835025" y="29633"/>
                  <a:pt x="812800" y="22225"/>
                </a:cubicBezTo>
                <a:lnTo>
                  <a:pt x="784225" y="12700"/>
                </a:lnTo>
                <a:cubicBezTo>
                  <a:pt x="780085" y="11320"/>
                  <a:pt x="775877" y="9847"/>
                  <a:pt x="771525" y="9525"/>
                </a:cubicBezTo>
                <a:cubicBezTo>
                  <a:pt x="747227" y="7725"/>
                  <a:pt x="722842" y="7408"/>
                  <a:pt x="698500" y="6350"/>
                </a:cubicBezTo>
                <a:cubicBezTo>
                  <a:pt x="663880" y="580"/>
                  <a:pt x="676245" y="1212"/>
                  <a:pt x="622300" y="6350"/>
                </a:cubicBezTo>
                <a:cubicBezTo>
                  <a:pt x="618968" y="6667"/>
                  <a:pt x="643467" y="0"/>
                  <a:pt x="638175" y="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14" name="フリーフォーム 113"/>
          <p:cNvSpPr/>
          <p:nvPr/>
        </p:nvSpPr>
        <p:spPr>
          <a:xfrm>
            <a:off x="605210" y="2590304"/>
            <a:ext cx="914400" cy="571500"/>
          </a:xfrm>
          <a:custGeom>
            <a:avLst/>
            <a:gdLst>
              <a:gd name="connsiteX0" fmla="*/ 638175 w 914400"/>
              <a:gd name="connsiteY0" fmla="*/ 0 h 571500"/>
              <a:gd name="connsiteX1" fmla="*/ 590550 w 914400"/>
              <a:gd name="connsiteY1" fmla="*/ 6350 h 571500"/>
              <a:gd name="connsiteX2" fmla="*/ 581025 w 914400"/>
              <a:gd name="connsiteY2" fmla="*/ 12700 h 571500"/>
              <a:gd name="connsiteX3" fmla="*/ 561975 w 914400"/>
              <a:gd name="connsiteY3" fmla="*/ 19050 h 571500"/>
              <a:gd name="connsiteX4" fmla="*/ 552450 w 914400"/>
              <a:gd name="connsiteY4" fmla="*/ 22225 h 571500"/>
              <a:gd name="connsiteX5" fmla="*/ 542925 w 914400"/>
              <a:gd name="connsiteY5" fmla="*/ 25400 h 571500"/>
              <a:gd name="connsiteX6" fmla="*/ 533400 w 914400"/>
              <a:gd name="connsiteY6" fmla="*/ 28575 h 571500"/>
              <a:gd name="connsiteX7" fmla="*/ 520700 w 914400"/>
              <a:gd name="connsiteY7" fmla="*/ 31750 h 571500"/>
              <a:gd name="connsiteX8" fmla="*/ 511175 w 914400"/>
              <a:gd name="connsiteY8" fmla="*/ 34925 h 571500"/>
              <a:gd name="connsiteX9" fmla="*/ 495300 w 914400"/>
              <a:gd name="connsiteY9" fmla="*/ 38100 h 571500"/>
              <a:gd name="connsiteX10" fmla="*/ 482600 w 914400"/>
              <a:gd name="connsiteY10" fmla="*/ 41275 h 571500"/>
              <a:gd name="connsiteX11" fmla="*/ 428625 w 914400"/>
              <a:gd name="connsiteY11" fmla="*/ 47625 h 571500"/>
              <a:gd name="connsiteX12" fmla="*/ 400050 w 914400"/>
              <a:gd name="connsiteY12" fmla="*/ 63500 h 571500"/>
              <a:gd name="connsiteX13" fmla="*/ 371475 w 914400"/>
              <a:gd name="connsiteY13" fmla="*/ 69850 h 571500"/>
              <a:gd name="connsiteX14" fmla="*/ 358775 w 914400"/>
              <a:gd name="connsiteY14" fmla="*/ 73025 h 571500"/>
              <a:gd name="connsiteX15" fmla="*/ 339725 w 914400"/>
              <a:gd name="connsiteY15" fmla="*/ 79375 h 571500"/>
              <a:gd name="connsiteX16" fmla="*/ 311150 w 914400"/>
              <a:gd name="connsiteY16" fmla="*/ 92075 h 571500"/>
              <a:gd name="connsiteX17" fmla="*/ 301625 w 914400"/>
              <a:gd name="connsiteY17" fmla="*/ 95250 h 571500"/>
              <a:gd name="connsiteX18" fmla="*/ 244475 w 914400"/>
              <a:gd name="connsiteY18" fmla="*/ 133350 h 571500"/>
              <a:gd name="connsiteX19" fmla="*/ 225425 w 914400"/>
              <a:gd name="connsiteY19" fmla="*/ 139700 h 571500"/>
              <a:gd name="connsiteX20" fmla="*/ 215900 w 914400"/>
              <a:gd name="connsiteY20" fmla="*/ 142875 h 571500"/>
              <a:gd name="connsiteX21" fmla="*/ 206375 w 914400"/>
              <a:gd name="connsiteY21" fmla="*/ 149225 h 571500"/>
              <a:gd name="connsiteX22" fmla="*/ 187325 w 914400"/>
              <a:gd name="connsiteY22" fmla="*/ 155575 h 571500"/>
              <a:gd name="connsiteX23" fmla="*/ 168275 w 914400"/>
              <a:gd name="connsiteY23" fmla="*/ 168275 h 571500"/>
              <a:gd name="connsiteX24" fmla="*/ 158750 w 914400"/>
              <a:gd name="connsiteY24" fmla="*/ 174625 h 571500"/>
              <a:gd name="connsiteX25" fmla="*/ 149225 w 914400"/>
              <a:gd name="connsiteY25" fmla="*/ 177800 h 571500"/>
              <a:gd name="connsiteX26" fmla="*/ 120650 w 914400"/>
              <a:gd name="connsiteY26" fmla="*/ 190500 h 571500"/>
              <a:gd name="connsiteX27" fmla="*/ 111125 w 914400"/>
              <a:gd name="connsiteY27" fmla="*/ 193675 h 571500"/>
              <a:gd name="connsiteX28" fmla="*/ 101600 w 914400"/>
              <a:gd name="connsiteY28" fmla="*/ 200025 h 571500"/>
              <a:gd name="connsiteX29" fmla="*/ 82550 w 914400"/>
              <a:gd name="connsiteY29" fmla="*/ 209550 h 571500"/>
              <a:gd name="connsiteX30" fmla="*/ 76200 w 914400"/>
              <a:gd name="connsiteY30" fmla="*/ 219075 h 571500"/>
              <a:gd name="connsiteX31" fmla="*/ 66675 w 914400"/>
              <a:gd name="connsiteY31" fmla="*/ 222250 h 571500"/>
              <a:gd name="connsiteX32" fmla="*/ 57150 w 914400"/>
              <a:gd name="connsiteY32" fmla="*/ 228600 h 571500"/>
              <a:gd name="connsiteX33" fmla="*/ 50800 w 914400"/>
              <a:gd name="connsiteY33" fmla="*/ 238125 h 571500"/>
              <a:gd name="connsiteX34" fmla="*/ 41275 w 914400"/>
              <a:gd name="connsiteY34" fmla="*/ 241300 h 571500"/>
              <a:gd name="connsiteX35" fmla="*/ 31750 w 914400"/>
              <a:gd name="connsiteY35" fmla="*/ 247650 h 571500"/>
              <a:gd name="connsiteX36" fmla="*/ 25400 w 914400"/>
              <a:gd name="connsiteY36" fmla="*/ 257175 h 571500"/>
              <a:gd name="connsiteX37" fmla="*/ 15875 w 914400"/>
              <a:gd name="connsiteY37" fmla="*/ 263525 h 571500"/>
              <a:gd name="connsiteX38" fmla="*/ 9525 w 914400"/>
              <a:gd name="connsiteY38" fmla="*/ 282575 h 571500"/>
              <a:gd name="connsiteX39" fmla="*/ 0 w 914400"/>
              <a:gd name="connsiteY39" fmla="*/ 301625 h 571500"/>
              <a:gd name="connsiteX40" fmla="*/ 3175 w 914400"/>
              <a:gd name="connsiteY40" fmla="*/ 393700 h 571500"/>
              <a:gd name="connsiteX41" fmla="*/ 12700 w 914400"/>
              <a:gd name="connsiteY41" fmla="*/ 412750 h 571500"/>
              <a:gd name="connsiteX42" fmla="*/ 22225 w 914400"/>
              <a:gd name="connsiteY42" fmla="*/ 422275 h 571500"/>
              <a:gd name="connsiteX43" fmla="*/ 41275 w 914400"/>
              <a:gd name="connsiteY43" fmla="*/ 450850 h 571500"/>
              <a:gd name="connsiteX44" fmla="*/ 47625 w 914400"/>
              <a:gd name="connsiteY44" fmla="*/ 460375 h 571500"/>
              <a:gd name="connsiteX45" fmla="*/ 57150 w 914400"/>
              <a:gd name="connsiteY45" fmla="*/ 479425 h 571500"/>
              <a:gd name="connsiteX46" fmla="*/ 66675 w 914400"/>
              <a:gd name="connsiteY46" fmla="*/ 485775 h 571500"/>
              <a:gd name="connsiteX47" fmla="*/ 73025 w 914400"/>
              <a:gd name="connsiteY47" fmla="*/ 495300 h 571500"/>
              <a:gd name="connsiteX48" fmla="*/ 92075 w 914400"/>
              <a:gd name="connsiteY48" fmla="*/ 508000 h 571500"/>
              <a:gd name="connsiteX49" fmla="*/ 98425 w 914400"/>
              <a:gd name="connsiteY49" fmla="*/ 517525 h 571500"/>
              <a:gd name="connsiteX50" fmla="*/ 117475 w 914400"/>
              <a:gd name="connsiteY50" fmla="*/ 527050 h 571500"/>
              <a:gd name="connsiteX51" fmla="*/ 142875 w 914400"/>
              <a:gd name="connsiteY51" fmla="*/ 549275 h 571500"/>
              <a:gd name="connsiteX52" fmla="*/ 161925 w 914400"/>
              <a:gd name="connsiteY52" fmla="*/ 555625 h 571500"/>
              <a:gd name="connsiteX53" fmla="*/ 171450 w 914400"/>
              <a:gd name="connsiteY53" fmla="*/ 561975 h 571500"/>
              <a:gd name="connsiteX54" fmla="*/ 206375 w 914400"/>
              <a:gd name="connsiteY54" fmla="*/ 571500 h 571500"/>
              <a:gd name="connsiteX55" fmla="*/ 488950 w 914400"/>
              <a:gd name="connsiteY55" fmla="*/ 568325 h 571500"/>
              <a:gd name="connsiteX56" fmla="*/ 501650 w 914400"/>
              <a:gd name="connsiteY56" fmla="*/ 565150 h 571500"/>
              <a:gd name="connsiteX57" fmla="*/ 530225 w 914400"/>
              <a:gd name="connsiteY57" fmla="*/ 558800 h 571500"/>
              <a:gd name="connsiteX58" fmla="*/ 549275 w 914400"/>
              <a:gd name="connsiteY58" fmla="*/ 552450 h 571500"/>
              <a:gd name="connsiteX59" fmla="*/ 577850 w 914400"/>
              <a:gd name="connsiteY59" fmla="*/ 533400 h 571500"/>
              <a:gd name="connsiteX60" fmla="*/ 596900 w 914400"/>
              <a:gd name="connsiteY60" fmla="*/ 527050 h 571500"/>
              <a:gd name="connsiteX61" fmla="*/ 606425 w 914400"/>
              <a:gd name="connsiteY61" fmla="*/ 520700 h 571500"/>
              <a:gd name="connsiteX62" fmla="*/ 625475 w 914400"/>
              <a:gd name="connsiteY62" fmla="*/ 514350 h 571500"/>
              <a:gd name="connsiteX63" fmla="*/ 635000 w 914400"/>
              <a:gd name="connsiteY63" fmla="*/ 508000 h 571500"/>
              <a:gd name="connsiteX64" fmla="*/ 644525 w 914400"/>
              <a:gd name="connsiteY64" fmla="*/ 504825 h 571500"/>
              <a:gd name="connsiteX65" fmla="*/ 673100 w 914400"/>
              <a:gd name="connsiteY65" fmla="*/ 488950 h 571500"/>
              <a:gd name="connsiteX66" fmla="*/ 701675 w 914400"/>
              <a:gd name="connsiteY66" fmla="*/ 469900 h 571500"/>
              <a:gd name="connsiteX67" fmla="*/ 711200 w 914400"/>
              <a:gd name="connsiteY67" fmla="*/ 466725 h 571500"/>
              <a:gd name="connsiteX68" fmla="*/ 720725 w 914400"/>
              <a:gd name="connsiteY68" fmla="*/ 460375 h 571500"/>
              <a:gd name="connsiteX69" fmla="*/ 730250 w 914400"/>
              <a:gd name="connsiteY69" fmla="*/ 457200 h 571500"/>
              <a:gd name="connsiteX70" fmla="*/ 758825 w 914400"/>
              <a:gd name="connsiteY70" fmla="*/ 441325 h 571500"/>
              <a:gd name="connsiteX71" fmla="*/ 777875 w 914400"/>
              <a:gd name="connsiteY71" fmla="*/ 431800 h 571500"/>
              <a:gd name="connsiteX72" fmla="*/ 796925 w 914400"/>
              <a:gd name="connsiteY72" fmla="*/ 422275 h 571500"/>
              <a:gd name="connsiteX73" fmla="*/ 809625 w 914400"/>
              <a:gd name="connsiteY73" fmla="*/ 406400 h 571500"/>
              <a:gd name="connsiteX74" fmla="*/ 822325 w 914400"/>
              <a:gd name="connsiteY74" fmla="*/ 387350 h 571500"/>
              <a:gd name="connsiteX75" fmla="*/ 828675 w 914400"/>
              <a:gd name="connsiteY75" fmla="*/ 377825 h 571500"/>
              <a:gd name="connsiteX76" fmla="*/ 838200 w 914400"/>
              <a:gd name="connsiteY76" fmla="*/ 349250 h 571500"/>
              <a:gd name="connsiteX77" fmla="*/ 857250 w 914400"/>
              <a:gd name="connsiteY77" fmla="*/ 320675 h 571500"/>
              <a:gd name="connsiteX78" fmla="*/ 863600 w 914400"/>
              <a:gd name="connsiteY78" fmla="*/ 301625 h 571500"/>
              <a:gd name="connsiteX79" fmla="*/ 869950 w 914400"/>
              <a:gd name="connsiteY79" fmla="*/ 292100 h 571500"/>
              <a:gd name="connsiteX80" fmla="*/ 873125 w 914400"/>
              <a:gd name="connsiteY80" fmla="*/ 282575 h 571500"/>
              <a:gd name="connsiteX81" fmla="*/ 885825 w 914400"/>
              <a:gd name="connsiteY81" fmla="*/ 263525 h 571500"/>
              <a:gd name="connsiteX82" fmla="*/ 892175 w 914400"/>
              <a:gd name="connsiteY82" fmla="*/ 254000 h 571500"/>
              <a:gd name="connsiteX83" fmla="*/ 898525 w 914400"/>
              <a:gd name="connsiteY83" fmla="*/ 234950 h 571500"/>
              <a:gd name="connsiteX84" fmla="*/ 904875 w 914400"/>
              <a:gd name="connsiteY84" fmla="*/ 225425 h 571500"/>
              <a:gd name="connsiteX85" fmla="*/ 911225 w 914400"/>
              <a:gd name="connsiteY85" fmla="*/ 206375 h 571500"/>
              <a:gd name="connsiteX86" fmla="*/ 914400 w 914400"/>
              <a:gd name="connsiteY86" fmla="*/ 196850 h 571500"/>
              <a:gd name="connsiteX87" fmla="*/ 911225 w 914400"/>
              <a:gd name="connsiteY87" fmla="*/ 158750 h 571500"/>
              <a:gd name="connsiteX88" fmla="*/ 898525 w 914400"/>
              <a:gd name="connsiteY88" fmla="*/ 130175 h 571500"/>
              <a:gd name="connsiteX89" fmla="*/ 892175 w 914400"/>
              <a:gd name="connsiteY89" fmla="*/ 111125 h 571500"/>
              <a:gd name="connsiteX90" fmla="*/ 889000 w 914400"/>
              <a:gd name="connsiteY90" fmla="*/ 101600 h 571500"/>
              <a:gd name="connsiteX91" fmla="*/ 876300 w 914400"/>
              <a:gd name="connsiteY91" fmla="*/ 82550 h 571500"/>
              <a:gd name="connsiteX92" fmla="*/ 873125 w 914400"/>
              <a:gd name="connsiteY92" fmla="*/ 73025 h 571500"/>
              <a:gd name="connsiteX93" fmla="*/ 857250 w 914400"/>
              <a:gd name="connsiteY93" fmla="*/ 57150 h 571500"/>
              <a:gd name="connsiteX94" fmla="*/ 854075 w 914400"/>
              <a:gd name="connsiteY94" fmla="*/ 47625 h 571500"/>
              <a:gd name="connsiteX95" fmla="*/ 844550 w 914400"/>
              <a:gd name="connsiteY95" fmla="*/ 44450 h 571500"/>
              <a:gd name="connsiteX96" fmla="*/ 835025 w 914400"/>
              <a:gd name="connsiteY96" fmla="*/ 38100 h 571500"/>
              <a:gd name="connsiteX97" fmla="*/ 812800 w 914400"/>
              <a:gd name="connsiteY97" fmla="*/ 22225 h 571500"/>
              <a:gd name="connsiteX98" fmla="*/ 784225 w 914400"/>
              <a:gd name="connsiteY98" fmla="*/ 12700 h 571500"/>
              <a:gd name="connsiteX99" fmla="*/ 771525 w 914400"/>
              <a:gd name="connsiteY99" fmla="*/ 9525 h 571500"/>
              <a:gd name="connsiteX100" fmla="*/ 698500 w 914400"/>
              <a:gd name="connsiteY100" fmla="*/ 6350 h 571500"/>
              <a:gd name="connsiteX101" fmla="*/ 622300 w 914400"/>
              <a:gd name="connsiteY101" fmla="*/ 6350 h 571500"/>
              <a:gd name="connsiteX102" fmla="*/ 638175 w 914400"/>
              <a:gd name="connsiteY102" fmla="*/ 0 h 571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</a:cxnLst>
            <a:rect l="l" t="t" r="r" b="b"/>
            <a:pathLst>
              <a:path w="914400" h="571500">
                <a:moveTo>
                  <a:pt x="638175" y="0"/>
                </a:moveTo>
                <a:cubicBezTo>
                  <a:pt x="632883" y="0"/>
                  <a:pt x="597676" y="3975"/>
                  <a:pt x="590550" y="6350"/>
                </a:cubicBezTo>
                <a:cubicBezTo>
                  <a:pt x="586930" y="7557"/>
                  <a:pt x="584512" y="11150"/>
                  <a:pt x="581025" y="12700"/>
                </a:cubicBezTo>
                <a:cubicBezTo>
                  <a:pt x="574908" y="15418"/>
                  <a:pt x="568325" y="16933"/>
                  <a:pt x="561975" y="19050"/>
                </a:cubicBezTo>
                <a:lnTo>
                  <a:pt x="552450" y="22225"/>
                </a:lnTo>
                <a:lnTo>
                  <a:pt x="542925" y="25400"/>
                </a:lnTo>
                <a:cubicBezTo>
                  <a:pt x="539750" y="26458"/>
                  <a:pt x="536647" y="27763"/>
                  <a:pt x="533400" y="28575"/>
                </a:cubicBezTo>
                <a:cubicBezTo>
                  <a:pt x="529167" y="29633"/>
                  <a:pt x="524896" y="30551"/>
                  <a:pt x="520700" y="31750"/>
                </a:cubicBezTo>
                <a:cubicBezTo>
                  <a:pt x="517482" y="32669"/>
                  <a:pt x="514422" y="34113"/>
                  <a:pt x="511175" y="34925"/>
                </a:cubicBezTo>
                <a:cubicBezTo>
                  <a:pt x="505940" y="36234"/>
                  <a:pt x="500568" y="36929"/>
                  <a:pt x="495300" y="38100"/>
                </a:cubicBezTo>
                <a:cubicBezTo>
                  <a:pt x="491040" y="39047"/>
                  <a:pt x="486893" y="40494"/>
                  <a:pt x="482600" y="41275"/>
                </a:cubicBezTo>
                <a:cubicBezTo>
                  <a:pt x="465443" y="44394"/>
                  <a:pt x="445654" y="45922"/>
                  <a:pt x="428625" y="47625"/>
                </a:cubicBezTo>
                <a:cubicBezTo>
                  <a:pt x="411860" y="53213"/>
                  <a:pt x="421885" y="48944"/>
                  <a:pt x="400050" y="63500"/>
                </a:cubicBezTo>
                <a:cubicBezTo>
                  <a:pt x="394754" y="67031"/>
                  <a:pt x="373945" y="69356"/>
                  <a:pt x="371475" y="69850"/>
                </a:cubicBezTo>
                <a:cubicBezTo>
                  <a:pt x="367196" y="70706"/>
                  <a:pt x="362955" y="71771"/>
                  <a:pt x="358775" y="73025"/>
                </a:cubicBezTo>
                <a:cubicBezTo>
                  <a:pt x="352364" y="74948"/>
                  <a:pt x="339725" y="79375"/>
                  <a:pt x="339725" y="79375"/>
                </a:cubicBezTo>
                <a:cubicBezTo>
                  <a:pt x="324631" y="89438"/>
                  <a:pt x="333820" y="84518"/>
                  <a:pt x="311150" y="92075"/>
                </a:cubicBezTo>
                <a:lnTo>
                  <a:pt x="301625" y="95250"/>
                </a:lnTo>
                <a:lnTo>
                  <a:pt x="244475" y="133350"/>
                </a:lnTo>
                <a:cubicBezTo>
                  <a:pt x="238906" y="137063"/>
                  <a:pt x="231775" y="137583"/>
                  <a:pt x="225425" y="139700"/>
                </a:cubicBezTo>
                <a:lnTo>
                  <a:pt x="215900" y="142875"/>
                </a:lnTo>
                <a:cubicBezTo>
                  <a:pt x="212725" y="144992"/>
                  <a:pt x="209862" y="147675"/>
                  <a:pt x="206375" y="149225"/>
                </a:cubicBezTo>
                <a:cubicBezTo>
                  <a:pt x="200258" y="151943"/>
                  <a:pt x="187325" y="155575"/>
                  <a:pt x="187325" y="155575"/>
                </a:cubicBezTo>
                <a:lnTo>
                  <a:pt x="168275" y="168275"/>
                </a:lnTo>
                <a:cubicBezTo>
                  <a:pt x="165100" y="170392"/>
                  <a:pt x="162370" y="173418"/>
                  <a:pt x="158750" y="174625"/>
                </a:cubicBezTo>
                <a:lnTo>
                  <a:pt x="149225" y="177800"/>
                </a:lnTo>
                <a:cubicBezTo>
                  <a:pt x="134131" y="187863"/>
                  <a:pt x="143320" y="182943"/>
                  <a:pt x="120650" y="190500"/>
                </a:cubicBezTo>
                <a:lnTo>
                  <a:pt x="111125" y="193675"/>
                </a:lnTo>
                <a:cubicBezTo>
                  <a:pt x="107950" y="195792"/>
                  <a:pt x="105013" y="198318"/>
                  <a:pt x="101600" y="200025"/>
                </a:cubicBezTo>
                <a:cubicBezTo>
                  <a:pt x="75310" y="213170"/>
                  <a:pt x="109847" y="191352"/>
                  <a:pt x="82550" y="209550"/>
                </a:cubicBezTo>
                <a:cubicBezTo>
                  <a:pt x="80433" y="212725"/>
                  <a:pt x="79180" y="216691"/>
                  <a:pt x="76200" y="219075"/>
                </a:cubicBezTo>
                <a:cubicBezTo>
                  <a:pt x="73587" y="221166"/>
                  <a:pt x="69668" y="220753"/>
                  <a:pt x="66675" y="222250"/>
                </a:cubicBezTo>
                <a:cubicBezTo>
                  <a:pt x="63262" y="223957"/>
                  <a:pt x="60325" y="226483"/>
                  <a:pt x="57150" y="228600"/>
                </a:cubicBezTo>
                <a:cubicBezTo>
                  <a:pt x="55033" y="231775"/>
                  <a:pt x="53780" y="235741"/>
                  <a:pt x="50800" y="238125"/>
                </a:cubicBezTo>
                <a:cubicBezTo>
                  <a:pt x="48187" y="240216"/>
                  <a:pt x="44268" y="239803"/>
                  <a:pt x="41275" y="241300"/>
                </a:cubicBezTo>
                <a:cubicBezTo>
                  <a:pt x="37862" y="243007"/>
                  <a:pt x="34925" y="245533"/>
                  <a:pt x="31750" y="247650"/>
                </a:cubicBezTo>
                <a:cubicBezTo>
                  <a:pt x="29633" y="250825"/>
                  <a:pt x="28098" y="254477"/>
                  <a:pt x="25400" y="257175"/>
                </a:cubicBezTo>
                <a:cubicBezTo>
                  <a:pt x="22702" y="259873"/>
                  <a:pt x="17897" y="260289"/>
                  <a:pt x="15875" y="263525"/>
                </a:cubicBezTo>
                <a:cubicBezTo>
                  <a:pt x="12327" y="269201"/>
                  <a:pt x="13238" y="277006"/>
                  <a:pt x="9525" y="282575"/>
                </a:cubicBezTo>
                <a:cubicBezTo>
                  <a:pt x="1319" y="294885"/>
                  <a:pt x="4382" y="288480"/>
                  <a:pt x="0" y="301625"/>
                </a:cubicBezTo>
                <a:cubicBezTo>
                  <a:pt x="1058" y="332317"/>
                  <a:pt x="1259" y="363050"/>
                  <a:pt x="3175" y="393700"/>
                </a:cubicBezTo>
                <a:cubicBezTo>
                  <a:pt x="3562" y="399892"/>
                  <a:pt x="9048" y="408368"/>
                  <a:pt x="12700" y="412750"/>
                </a:cubicBezTo>
                <a:cubicBezTo>
                  <a:pt x="15575" y="416199"/>
                  <a:pt x="19468" y="418731"/>
                  <a:pt x="22225" y="422275"/>
                </a:cubicBezTo>
                <a:lnTo>
                  <a:pt x="41275" y="450850"/>
                </a:lnTo>
                <a:cubicBezTo>
                  <a:pt x="43392" y="454025"/>
                  <a:pt x="46418" y="456755"/>
                  <a:pt x="47625" y="460375"/>
                </a:cubicBezTo>
                <a:cubicBezTo>
                  <a:pt x="50207" y="468122"/>
                  <a:pt x="50995" y="473270"/>
                  <a:pt x="57150" y="479425"/>
                </a:cubicBezTo>
                <a:cubicBezTo>
                  <a:pt x="59848" y="482123"/>
                  <a:pt x="63500" y="483658"/>
                  <a:pt x="66675" y="485775"/>
                </a:cubicBezTo>
                <a:cubicBezTo>
                  <a:pt x="68792" y="488950"/>
                  <a:pt x="70153" y="492787"/>
                  <a:pt x="73025" y="495300"/>
                </a:cubicBezTo>
                <a:cubicBezTo>
                  <a:pt x="78768" y="500326"/>
                  <a:pt x="92075" y="508000"/>
                  <a:pt x="92075" y="508000"/>
                </a:cubicBezTo>
                <a:cubicBezTo>
                  <a:pt x="94192" y="511175"/>
                  <a:pt x="95727" y="514827"/>
                  <a:pt x="98425" y="517525"/>
                </a:cubicBezTo>
                <a:cubicBezTo>
                  <a:pt x="104580" y="523680"/>
                  <a:pt x="109728" y="524468"/>
                  <a:pt x="117475" y="527050"/>
                </a:cubicBezTo>
                <a:cubicBezTo>
                  <a:pt x="128058" y="542925"/>
                  <a:pt x="120650" y="534458"/>
                  <a:pt x="142875" y="549275"/>
                </a:cubicBezTo>
                <a:cubicBezTo>
                  <a:pt x="148444" y="552988"/>
                  <a:pt x="161925" y="555625"/>
                  <a:pt x="161925" y="555625"/>
                </a:cubicBezTo>
                <a:cubicBezTo>
                  <a:pt x="165100" y="557742"/>
                  <a:pt x="167963" y="560425"/>
                  <a:pt x="171450" y="561975"/>
                </a:cubicBezTo>
                <a:cubicBezTo>
                  <a:pt x="184633" y="567834"/>
                  <a:pt x="192794" y="568784"/>
                  <a:pt x="206375" y="571500"/>
                </a:cubicBezTo>
                <a:lnTo>
                  <a:pt x="488950" y="568325"/>
                </a:lnTo>
                <a:cubicBezTo>
                  <a:pt x="493313" y="568231"/>
                  <a:pt x="497390" y="566097"/>
                  <a:pt x="501650" y="565150"/>
                </a:cubicBezTo>
                <a:cubicBezTo>
                  <a:pt x="513303" y="562560"/>
                  <a:pt x="519163" y="562118"/>
                  <a:pt x="530225" y="558800"/>
                </a:cubicBezTo>
                <a:cubicBezTo>
                  <a:pt x="536636" y="556877"/>
                  <a:pt x="549275" y="552450"/>
                  <a:pt x="549275" y="552450"/>
                </a:cubicBezTo>
                <a:lnTo>
                  <a:pt x="577850" y="533400"/>
                </a:lnTo>
                <a:cubicBezTo>
                  <a:pt x="583419" y="529687"/>
                  <a:pt x="596900" y="527050"/>
                  <a:pt x="596900" y="527050"/>
                </a:cubicBezTo>
                <a:cubicBezTo>
                  <a:pt x="600075" y="524933"/>
                  <a:pt x="602938" y="522250"/>
                  <a:pt x="606425" y="520700"/>
                </a:cubicBezTo>
                <a:cubicBezTo>
                  <a:pt x="612542" y="517982"/>
                  <a:pt x="625475" y="514350"/>
                  <a:pt x="625475" y="514350"/>
                </a:cubicBezTo>
                <a:cubicBezTo>
                  <a:pt x="628650" y="512233"/>
                  <a:pt x="631587" y="509707"/>
                  <a:pt x="635000" y="508000"/>
                </a:cubicBezTo>
                <a:cubicBezTo>
                  <a:pt x="637993" y="506503"/>
                  <a:pt x="641599" y="506450"/>
                  <a:pt x="644525" y="504825"/>
                </a:cubicBezTo>
                <a:cubicBezTo>
                  <a:pt x="677277" y="486629"/>
                  <a:pt x="651547" y="496134"/>
                  <a:pt x="673100" y="488950"/>
                </a:cubicBezTo>
                <a:lnTo>
                  <a:pt x="701675" y="469900"/>
                </a:lnTo>
                <a:cubicBezTo>
                  <a:pt x="704460" y="468044"/>
                  <a:pt x="708025" y="467783"/>
                  <a:pt x="711200" y="466725"/>
                </a:cubicBezTo>
                <a:cubicBezTo>
                  <a:pt x="714375" y="464608"/>
                  <a:pt x="717312" y="462082"/>
                  <a:pt x="720725" y="460375"/>
                </a:cubicBezTo>
                <a:cubicBezTo>
                  <a:pt x="723718" y="458878"/>
                  <a:pt x="727324" y="458825"/>
                  <a:pt x="730250" y="457200"/>
                </a:cubicBezTo>
                <a:cubicBezTo>
                  <a:pt x="763002" y="439004"/>
                  <a:pt x="737272" y="448509"/>
                  <a:pt x="758825" y="441325"/>
                </a:cubicBezTo>
                <a:cubicBezTo>
                  <a:pt x="786122" y="423127"/>
                  <a:pt x="751585" y="444945"/>
                  <a:pt x="777875" y="431800"/>
                </a:cubicBezTo>
                <a:cubicBezTo>
                  <a:pt x="802494" y="419490"/>
                  <a:pt x="772984" y="430255"/>
                  <a:pt x="796925" y="422275"/>
                </a:cubicBezTo>
                <a:cubicBezTo>
                  <a:pt x="814524" y="410542"/>
                  <a:pt x="800604" y="422638"/>
                  <a:pt x="809625" y="406400"/>
                </a:cubicBezTo>
                <a:cubicBezTo>
                  <a:pt x="813331" y="399729"/>
                  <a:pt x="818092" y="393700"/>
                  <a:pt x="822325" y="387350"/>
                </a:cubicBezTo>
                <a:cubicBezTo>
                  <a:pt x="824442" y="384175"/>
                  <a:pt x="827468" y="381445"/>
                  <a:pt x="828675" y="377825"/>
                </a:cubicBezTo>
                <a:lnTo>
                  <a:pt x="838200" y="349250"/>
                </a:lnTo>
                <a:lnTo>
                  <a:pt x="857250" y="320675"/>
                </a:lnTo>
                <a:cubicBezTo>
                  <a:pt x="860963" y="315106"/>
                  <a:pt x="861483" y="307975"/>
                  <a:pt x="863600" y="301625"/>
                </a:cubicBezTo>
                <a:cubicBezTo>
                  <a:pt x="864807" y="298005"/>
                  <a:pt x="868243" y="295513"/>
                  <a:pt x="869950" y="292100"/>
                </a:cubicBezTo>
                <a:cubicBezTo>
                  <a:pt x="871447" y="289107"/>
                  <a:pt x="871500" y="285501"/>
                  <a:pt x="873125" y="282575"/>
                </a:cubicBezTo>
                <a:cubicBezTo>
                  <a:pt x="876831" y="275904"/>
                  <a:pt x="881592" y="269875"/>
                  <a:pt x="885825" y="263525"/>
                </a:cubicBezTo>
                <a:cubicBezTo>
                  <a:pt x="887942" y="260350"/>
                  <a:pt x="890968" y="257620"/>
                  <a:pt x="892175" y="254000"/>
                </a:cubicBezTo>
                <a:cubicBezTo>
                  <a:pt x="894292" y="247650"/>
                  <a:pt x="894812" y="240519"/>
                  <a:pt x="898525" y="234950"/>
                </a:cubicBezTo>
                <a:cubicBezTo>
                  <a:pt x="900642" y="231775"/>
                  <a:pt x="903325" y="228912"/>
                  <a:pt x="904875" y="225425"/>
                </a:cubicBezTo>
                <a:cubicBezTo>
                  <a:pt x="907593" y="219308"/>
                  <a:pt x="909108" y="212725"/>
                  <a:pt x="911225" y="206375"/>
                </a:cubicBezTo>
                <a:lnTo>
                  <a:pt x="914400" y="196850"/>
                </a:lnTo>
                <a:cubicBezTo>
                  <a:pt x="913342" y="184150"/>
                  <a:pt x="913320" y="171321"/>
                  <a:pt x="911225" y="158750"/>
                </a:cubicBezTo>
                <a:cubicBezTo>
                  <a:pt x="906183" y="128500"/>
                  <a:pt x="907154" y="149590"/>
                  <a:pt x="898525" y="130175"/>
                </a:cubicBezTo>
                <a:cubicBezTo>
                  <a:pt x="895807" y="124058"/>
                  <a:pt x="894292" y="117475"/>
                  <a:pt x="892175" y="111125"/>
                </a:cubicBezTo>
                <a:cubicBezTo>
                  <a:pt x="891117" y="107950"/>
                  <a:pt x="890856" y="104385"/>
                  <a:pt x="889000" y="101600"/>
                </a:cubicBezTo>
                <a:lnTo>
                  <a:pt x="876300" y="82550"/>
                </a:lnTo>
                <a:cubicBezTo>
                  <a:pt x="874444" y="79765"/>
                  <a:pt x="874622" y="76018"/>
                  <a:pt x="873125" y="73025"/>
                </a:cubicBezTo>
                <a:cubicBezTo>
                  <a:pt x="867833" y="62442"/>
                  <a:pt x="866775" y="63500"/>
                  <a:pt x="857250" y="57150"/>
                </a:cubicBezTo>
                <a:cubicBezTo>
                  <a:pt x="856192" y="53975"/>
                  <a:pt x="856442" y="49992"/>
                  <a:pt x="854075" y="47625"/>
                </a:cubicBezTo>
                <a:cubicBezTo>
                  <a:pt x="851708" y="45258"/>
                  <a:pt x="847543" y="45947"/>
                  <a:pt x="844550" y="44450"/>
                </a:cubicBezTo>
                <a:cubicBezTo>
                  <a:pt x="841137" y="42743"/>
                  <a:pt x="838200" y="40217"/>
                  <a:pt x="835025" y="38100"/>
                </a:cubicBezTo>
                <a:cubicBezTo>
                  <a:pt x="829733" y="22225"/>
                  <a:pt x="835025" y="29633"/>
                  <a:pt x="812800" y="22225"/>
                </a:cubicBezTo>
                <a:lnTo>
                  <a:pt x="784225" y="12700"/>
                </a:lnTo>
                <a:cubicBezTo>
                  <a:pt x="780085" y="11320"/>
                  <a:pt x="775877" y="9847"/>
                  <a:pt x="771525" y="9525"/>
                </a:cubicBezTo>
                <a:cubicBezTo>
                  <a:pt x="747227" y="7725"/>
                  <a:pt x="722842" y="7408"/>
                  <a:pt x="698500" y="6350"/>
                </a:cubicBezTo>
                <a:cubicBezTo>
                  <a:pt x="663880" y="580"/>
                  <a:pt x="676245" y="1212"/>
                  <a:pt x="622300" y="6350"/>
                </a:cubicBezTo>
                <a:cubicBezTo>
                  <a:pt x="618968" y="6667"/>
                  <a:pt x="643467" y="0"/>
                  <a:pt x="638175" y="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pic>
        <p:nvPicPr>
          <p:cNvPr id="2059" name="Picture 11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41466" y="616534"/>
            <a:ext cx="1627078" cy="15557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6" name="Picture 18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84368" y="2181637"/>
            <a:ext cx="1437804" cy="13885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9" name="Picture 21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1193" y="2185481"/>
            <a:ext cx="1433503" cy="13885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70" name="Picture 22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99584" y="3645024"/>
            <a:ext cx="1420936" cy="13790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74" name="Picture 26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84367" y="4883428"/>
            <a:ext cx="1419621" cy="13425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77" name="Picture 29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1194" y="4885035"/>
            <a:ext cx="1392317" cy="13425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9" name="テキスト ボックス 38"/>
          <p:cNvSpPr txBox="1"/>
          <p:nvPr/>
        </p:nvSpPr>
        <p:spPr>
          <a:xfrm>
            <a:off x="6785043" y="642783"/>
            <a:ext cx="1015206" cy="307777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2</a:t>
            </a:r>
            <a:endParaRPr kumimoji="1" lang="ja-JP" altLang="en-US" sz="1400" b="1" dirty="0">
              <a:solidFill>
                <a:srgbClr val="92D05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pic>
        <p:nvPicPr>
          <p:cNvPr id="2067" name="Picture 19"/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16216" y="2187102"/>
            <a:ext cx="1437804" cy="13885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71" name="Picture 23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16216" y="3645024"/>
            <a:ext cx="1420936" cy="13790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75" name="Picture 27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16215" y="4889696"/>
            <a:ext cx="1419621" cy="13425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4" name="正方形/長方形 23"/>
          <p:cNvSpPr/>
          <p:nvPr/>
        </p:nvSpPr>
        <p:spPr>
          <a:xfrm flipH="1">
            <a:off x="6398489" y="530742"/>
            <a:ext cx="45719" cy="550521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0" name="正方形/長方形 99"/>
          <p:cNvSpPr/>
          <p:nvPr/>
        </p:nvSpPr>
        <p:spPr>
          <a:xfrm flipH="1">
            <a:off x="350505" y="2128821"/>
            <a:ext cx="8859345" cy="760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30" name="正方形/長方形 129"/>
          <p:cNvSpPr/>
          <p:nvPr/>
        </p:nvSpPr>
        <p:spPr>
          <a:xfrm>
            <a:off x="6382898" y="616108"/>
            <a:ext cx="122619" cy="583722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1" name="正方形/長方形 130"/>
          <p:cNvSpPr/>
          <p:nvPr/>
        </p:nvSpPr>
        <p:spPr>
          <a:xfrm>
            <a:off x="7761749" y="620688"/>
            <a:ext cx="122619" cy="58326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2" name="正方形/長方形 131"/>
          <p:cNvSpPr/>
          <p:nvPr/>
        </p:nvSpPr>
        <p:spPr>
          <a:xfrm>
            <a:off x="9081776" y="604432"/>
            <a:ext cx="674800" cy="584890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4" name="正方形/長方形 133"/>
          <p:cNvSpPr/>
          <p:nvPr/>
        </p:nvSpPr>
        <p:spPr>
          <a:xfrm flipH="1">
            <a:off x="467544" y="3592864"/>
            <a:ext cx="8859345" cy="760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35" name="正方形/長方形 134"/>
          <p:cNvSpPr/>
          <p:nvPr/>
        </p:nvSpPr>
        <p:spPr>
          <a:xfrm flipH="1">
            <a:off x="4794759" y="4870797"/>
            <a:ext cx="4495482" cy="760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v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97" name="正方形/長方形 96"/>
          <p:cNvSpPr/>
          <p:nvPr/>
        </p:nvSpPr>
        <p:spPr>
          <a:xfrm flipH="1" flipV="1">
            <a:off x="350505" y="517322"/>
            <a:ext cx="8976382" cy="14450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36" name="正方形/長方形 135"/>
          <p:cNvSpPr/>
          <p:nvPr/>
        </p:nvSpPr>
        <p:spPr>
          <a:xfrm flipH="1">
            <a:off x="424670" y="3568981"/>
            <a:ext cx="8902218" cy="798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6789990" y="2224320"/>
            <a:ext cx="1015206" cy="307777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2</a:t>
            </a:r>
            <a:endParaRPr kumimoji="1" lang="ja-JP" altLang="en-US" sz="1400" b="1" dirty="0">
              <a:solidFill>
                <a:srgbClr val="92D05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38" name="テキスト ボックス 137"/>
          <p:cNvSpPr txBox="1"/>
          <p:nvPr/>
        </p:nvSpPr>
        <p:spPr>
          <a:xfrm>
            <a:off x="6822331" y="3631079"/>
            <a:ext cx="1015206" cy="307777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2</a:t>
            </a:r>
            <a:endParaRPr kumimoji="1" lang="ja-JP" altLang="en-US" sz="1400" b="1" dirty="0">
              <a:solidFill>
                <a:srgbClr val="92D05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39" name="テキスト ボックス 138"/>
          <p:cNvSpPr txBox="1"/>
          <p:nvPr/>
        </p:nvSpPr>
        <p:spPr>
          <a:xfrm>
            <a:off x="6794623" y="4941168"/>
            <a:ext cx="1015206" cy="307777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2</a:t>
            </a:r>
            <a:endParaRPr kumimoji="1" lang="ja-JP" altLang="en-US" sz="1400" b="1" dirty="0">
              <a:solidFill>
                <a:srgbClr val="92D05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8417299" y="591318"/>
            <a:ext cx="9381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ge</a:t>
            </a:r>
            <a:endParaRPr kumimoji="1" lang="ja-JP" altLang="en-US" sz="1400" b="1" dirty="0">
              <a:solidFill>
                <a:schemeClr val="bg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40" name="テキスト ボックス 139"/>
          <p:cNvSpPr txBox="1"/>
          <p:nvPr/>
        </p:nvSpPr>
        <p:spPr>
          <a:xfrm>
            <a:off x="8421932" y="2165869"/>
            <a:ext cx="9381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ge</a:t>
            </a:r>
            <a:endParaRPr kumimoji="1" lang="ja-JP" altLang="en-US" sz="1400" b="1" dirty="0">
              <a:solidFill>
                <a:schemeClr val="bg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41" name="テキスト ボックス 140"/>
          <p:cNvSpPr txBox="1"/>
          <p:nvPr/>
        </p:nvSpPr>
        <p:spPr>
          <a:xfrm>
            <a:off x="8419886" y="3625279"/>
            <a:ext cx="9381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ge</a:t>
            </a:r>
            <a:endParaRPr kumimoji="1" lang="ja-JP" altLang="en-US" sz="1400" b="1" dirty="0">
              <a:solidFill>
                <a:schemeClr val="bg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42" name="テキスト ボックス 141"/>
          <p:cNvSpPr txBox="1"/>
          <p:nvPr/>
        </p:nvSpPr>
        <p:spPr>
          <a:xfrm>
            <a:off x="8417299" y="4902173"/>
            <a:ext cx="9381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ge</a:t>
            </a:r>
            <a:endParaRPr kumimoji="1" lang="ja-JP" altLang="en-US" sz="1400" b="1" dirty="0">
              <a:solidFill>
                <a:schemeClr val="bg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146" name="直線コネクタ 145"/>
          <p:cNvCxnSpPr/>
          <p:nvPr/>
        </p:nvCxnSpPr>
        <p:spPr>
          <a:xfrm>
            <a:off x="8532440" y="3490466"/>
            <a:ext cx="45536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直線コネクタ 148"/>
          <p:cNvCxnSpPr/>
          <p:nvPr/>
        </p:nvCxnSpPr>
        <p:spPr>
          <a:xfrm>
            <a:off x="8590823" y="4797152"/>
            <a:ext cx="42996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直線コネクタ 158"/>
          <p:cNvCxnSpPr/>
          <p:nvPr/>
        </p:nvCxnSpPr>
        <p:spPr>
          <a:xfrm>
            <a:off x="8678658" y="6148237"/>
            <a:ext cx="34212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正方形/長方形 161"/>
          <p:cNvSpPr/>
          <p:nvPr/>
        </p:nvSpPr>
        <p:spPr>
          <a:xfrm flipH="1">
            <a:off x="4932040" y="6237910"/>
            <a:ext cx="4495482" cy="760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v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3" name="フリーフォーム 32"/>
          <p:cNvSpPr/>
          <p:nvPr/>
        </p:nvSpPr>
        <p:spPr>
          <a:xfrm>
            <a:off x="8048625" y="961449"/>
            <a:ext cx="881183" cy="781626"/>
          </a:xfrm>
          <a:custGeom>
            <a:avLst/>
            <a:gdLst>
              <a:gd name="connsiteX0" fmla="*/ 307975 w 881183"/>
              <a:gd name="connsiteY0" fmla="*/ 576 h 781626"/>
              <a:gd name="connsiteX1" fmla="*/ 273050 w 881183"/>
              <a:gd name="connsiteY1" fmla="*/ 3751 h 781626"/>
              <a:gd name="connsiteX2" fmla="*/ 231775 w 881183"/>
              <a:gd name="connsiteY2" fmla="*/ 6926 h 781626"/>
              <a:gd name="connsiteX3" fmla="*/ 222250 w 881183"/>
              <a:gd name="connsiteY3" fmla="*/ 10101 h 781626"/>
              <a:gd name="connsiteX4" fmla="*/ 200025 w 881183"/>
              <a:gd name="connsiteY4" fmla="*/ 16451 h 781626"/>
              <a:gd name="connsiteX5" fmla="*/ 171450 w 881183"/>
              <a:gd name="connsiteY5" fmla="*/ 29151 h 781626"/>
              <a:gd name="connsiteX6" fmla="*/ 161925 w 881183"/>
              <a:gd name="connsiteY6" fmla="*/ 32326 h 781626"/>
              <a:gd name="connsiteX7" fmla="*/ 133350 w 881183"/>
              <a:gd name="connsiteY7" fmla="*/ 51376 h 781626"/>
              <a:gd name="connsiteX8" fmla="*/ 123825 w 881183"/>
              <a:gd name="connsiteY8" fmla="*/ 54551 h 781626"/>
              <a:gd name="connsiteX9" fmla="*/ 101600 w 881183"/>
              <a:gd name="connsiteY9" fmla="*/ 70426 h 781626"/>
              <a:gd name="connsiteX10" fmla="*/ 79375 w 881183"/>
              <a:gd name="connsiteY10" fmla="*/ 89476 h 781626"/>
              <a:gd name="connsiteX11" fmla="*/ 60325 w 881183"/>
              <a:gd name="connsiteY11" fmla="*/ 102176 h 781626"/>
              <a:gd name="connsiteX12" fmla="*/ 47625 w 881183"/>
              <a:gd name="connsiteY12" fmla="*/ 121226 h 781626"/>
              <a:gd name="connsiteX13" fmla="*/ 38100 w 881183"/>
              <a:gd name="connsiteY13" fmla="*/ 149801 h 781626"/>
              <a:gd name="connsiteX14" fmla="*/ 25400 w 881183"/>
              <a:gd name="connsiteY14" fmla="*/ 168851 h 781626"/>
              <a:gd name="connsiteX15" fmla="*/ 19050 w 881183"/>
              <a:gd name="connsiteY15" fmla="*/ 187901 h 781626"/>
              <a:gd name="connsiteX16" fmla="*/ 15875 w 881183"/>
              <a:gd name="connsiteY16" fmla="*/ 200601 h 781626"/>
              <a:gd name="connsiteX17" fmla="*/ 9525 w 881183"/>
              <a:gd name="connsiteY17" fmla="*/ 210126 h 781626"/>
              <a:gd name="connsiteX18" fmla="*/ 6350 w 881183"/>
              <a:gd name="connsiteY18" fmla="*/ 222826 h 781626"/>
              <a:gd name="connsiteX19" fmla="*/ 0 w 881183"/>
              <a:gd name="connsiteY19" fmla="*/ 279976 h 781626"/>
              <a:gd name="connsiteX20" fmla="*/ 9525 w 881183"/>
              <a:gd name="connsiteY20" fmla="*/ 337126 h 781626"/>
              <a:gd name="connsiteX21" fmla="*/ 22225 w 881183"/>
              <a:gd name="connsiteY21" fmla="*/ 356176 h 781626"/>
              <a:gd name="connsiteX22" fmla="*/ 25400 w 881183"/>
              <a:gd name="connsiteY22" fmla="*/ 365701 h 781626"/>
              <a:gd name="connsiteX23" fmla="*/ 38100 w 881183"/>
              <a:gd name="connsiteY23" fmla="*/ 384751 h 781626"/>
              <a:gd name="connsiteX24" fmla="*/ 44450 w 881183"/>
              <a:gd name="connsiteY24" fmla="*/ 403801 h 781626"/>
              <a:gd name="connsiteX25" fmla="*/ 47625 w 881183"/>
              <a:gd name="connsiteY25" fmla="*/ 413326 h 781626"/>
              <a:gd name="connsiteX26" fmla="*/ 57150 w 881183"/>
              <a:gd name="connsiteY26" fmla="*/ 432376 h 781626"/>
              <a:gd name="connsiteX27" fmla="*/ 69850 w 881183"/>
              <a:gd name="connsiteY27" fmla="*/ 457776 h 781626"/>
              <a:gd name="connsiteX28" fmla="*/ 82550 w 881183"/>
              <a:gd name="connsiteY28" fmla="*/ 476826 h 781626"/>
              <a:gd name="connsiteX29" fmla="*/ 95250 w 881183"/>
              <a:gd name="connsiteY29" fmla="*/ 495876 h 781626"/>
              <a:gd name="connsiteX30" fmla="*/ 98425 w 881183"/>
              <a:gd name="connsiteY30" fmla="*/ 505401 h 781626"/>
              <a:gd name="connsiteX31" fmla="*/ 117475 w 881183"/>
              <a:gd name="connsiteY31" fmla="*/ 533976 h 781626"/>
              <a:gd name="connsiteX32" fmla="*/ 120650 w 881183"/>
              <a:gd name="connsiteY32" fmla="*/ 543501 h 781626"/>
              <a:gd name="connsiteX33" fmla="*/ 133350 w 881183"/>
              <a:gd name="connsiteY33" fmla="*/ 562551 h 781626"/>
              <a:gd name="connsiteX34" fmla="*/ 136525 w 881183"/>
              <a:gd name="connsiteY34" fmla="*/ 572076 h 781626"/>
              <a:gd name="connsiteX35" fmla="*/ 155575 w 881183"/>
              <a:gd name="connsiteY35" fmla="*/ 600651 h 781626"/>
              <a:gd name="connsiteX36" fmla="*/ 161925 w 881183"/>
              <a:gd name="connsiteY36" fmla="*/ 610176 h 781626"/>
              <a:gd name="connsiteX37" fmla="*/ 168275 w 881183"/>
              <a:gd name="connsiteY37" fmla="*/ 619701 h 781626"/>
              <a:gd name="connsiteX38" fmla="*/ 187325 w 881183"/>
              <a:gd name="connsiteY38" fmla="*/ 638751 h 781626"/>
              <a:gd name="connsiteX39" fmla="*/ 206375 w 881183"/>
              <a:gd name="connsiteY39" fmla="*/ 651451 h 781626"/>
              <a:gd name="connsiteX40" fmla="*/ 225425 w 881183"/>
              <a:gd name="connsiteY40" fmla="*/ 664151 h 781626"/>
              <a:gd name="connsiteX41" fmla="*/ 234950 w 881183"/>
              <a:gd name="connsiteY41" fmla="*/ 673676 h 781626"/>
              <a:gd name="connsiteX42" fmla="*/ 254000 w 881183"/>
              <a:gd name="connsiteY42" fmla="*/ 683201 h 781626"/>
              <a:gd name="connsiteX43" fmla="*/ 273050 w 881183"/>
              <a:gd name="connsiteY43" fmla="*/ 692726 h 781626"/>
              <a:gd name="connsiteX44" fmla="*/ 282575 w 881183"/>
              <a:gd name="connsiteY44" fmla="*/ 699076 h 781626"/>
              <a:gd name="connsiteX45" fmla="*/ 311150 w 881183"/>
              <a:gd name="connsiteY45" fmla="*/ 708601 h 781626"/>
              <a:gd name="connsiteX46" fmla="*/ 323850 w 881183"/>
              <a:gd name="connsiteY46" fmla="*/ 711776 h 781626"/>
              <a:gd name="connsiteX47" fmla="*/ 342900 w 881183"/>
              <a:gd name="connsiteY47" fmla="*/ 718126 h 781626"/>
              <a:gd name="connsiteX48" fmla="*/ 381000 w 881183"/>
              <a:gd name="connsiteY48" fmla="*/ 730826 h 781626"/>
              <a:gd name="connsiteX49" fmla="*/ 390525 w 881183"/>
              <a:gd name="connsiteY49" fmla="*/ 734001 h 781626"/>
              <a:gd name="connsiteX50" fmla="*/ 400050 w 881183"/>
              <a:gd name="connsiteY50" fmla="*/ 737176 h 781626"/>
              <a:gd name="connsiteX51" fmla="*/ 412750 w 881183"/>
              <a:gd name="connsiteY51" fmla="*/ 740351 h 781626"/>
              <a:gd name="connsiteX52" fmla="*/ 422275 w 881183"/>
              <a:gd name="connsiteY52" fmla="*/ 746701 h 781626"/>
              <a:gd name="connsiteX53" fmla="*/ 457200 w 881183"/>
              <a:gd name="connsiteY53" fmla="*/ 756226 h 781626"/>
              <a:gd name="connsiteX54" fmla="*/ 482600 w 881183"/>
              <a:gd name="connsiteY54" fmla="*/ 762576 h 781626"/>
              <a:gd name="connsiteX55" fmla="*/ 495300 w 881183"/>
              <a:gd name="connsiteY55" fmla="*/ 765751 h 781626"/>
              <a:gd name="connsiteX56" fmla="*/ 546100 w 881183"/>
              <a:gd name="connsiteY56" fmla="*/ 772101 h 781626"/>
              <a:gd name="connsiteX57" fmla="*/ 555625 w 881183"/>
              <a:gd name="connsiteY57" fmla="*/ 775276 h 781626"/>
              <a:gd name="connsiteX58" fmla="*/ 606425 w 881183"/>
              <a:gd name="connsiteY58" fmla="*/ 781626 h 781626"/>
              <a:gd name="connsiteX59" fmla="*/ 673100 w 881183"/>
              <a:gd name="connsiteY59" fmla="*/ 772101 h 781626"/>
              <a:gd name="connsiteX60" fmla="*/ 692150 w 881183"/>
              <a:gd name="connsiteY60" fmla="*/ 765751 h 781626"/>
              <a:gd name="connsiteX61" fmla="*/ 701675 w 881183"/>
              <a:gd name="connsiteY61" fmla="*/ 762576 h 781626"/>
              <a:gd name="connsiteX62" fmla="*/ 720725 w 881183"/>
              <a:gd name="connsiteY62" fmla="*/ 753051 h 781626"/>
              <a:gd name="connsiteX63" fmla="*/ 739775 w 881183"/>
              <a:gd name="connsiteY63" fmla="*/ 743526 h 781626"/>
              <a:gd name="connsiteX64" fmla="*/ 749300 w 881183"/>
              <a:gd name="connsiteY64" fmla="*/ 737176 h 781626"/>
              <a:gd name="connsiteX65" fmla="*/ 768350 w 881183"/>
              <a:gd name="connsiteY65" fmla="*/ 730826 h 781626"/>
              <a:gd name="connsiteX66" fmla="*/ 787400 w 881183"/>
              <a:gd name="connsiteY66" fmla="*/ 721301 h 781626"/>
              <a:gd name="connsiteX67" fmla="*/ 796925 w 881183"/>
              <a:gd name="connsiteY67" fmla="*/ 714951 h 781626"/>
              <a:gd name="connsiteX68" fmla="*/ 809625 w 881183"/>
              <a:gd name="connsiteY68" fmla="*/ 711776 h 781626"/>
              <a:gd name="connsiteX69" fmla="*/ 828675 w 881183"/>
              <a:gd name="connsiteY69" fmla="*/ 705426 h 781626"/>
              <a:gd name="connsiteX70" fmla="*/ 835025 w 881183"/>
              <a:gd name="connsiteY70" fmla="*/ 695901 h 781626"/>
              <a:gd name="connsiteX71" fmla="*/ 844550 w 881183"/>
              <a:gd name="connsiteY71" fmla="*/ 692726 h 781626"/>
              <a:gd name="connsiteX72" fmla="*/ 847725 w 881183"/>
              <a:gd name="connsiteY72" fmla="*/ 683201 h 781626"/>
              <a:gd name="connsiteX73" fmla="*/ 857250 w 881183"/>
              <a:gd name="connsiteY73" fmla="*/ 664151 h 781626"/>
              <a:gd name="connsiteX74" fmla="*/ 863600 w 881183"/>
              <a:gd name="connsiteY74" fmla="*/ 622876 h 781626"/>
              <a:gd name="connsiteX75" fmla="*/ 866775 w 881183"/>
              <a:gd name="connsiteY75" fmla="*/ 607001 h 781626"/>
              <a:gd name="connsiteX76" fmla="*/ 873125 w 881183"/>
              <a:gd name="connsiteY76" fmla="*/ 587951 h 781626"/>
              <a:gd name="connsiteX77" fmla="*/ 876300 w 881183"/>
              <a:gd name="connsiteY77" fmla="*/ 578426 h 781626"/>
              <a:gd name="connsiteX78" fmla="*/ 876300 w 881183"/>
              <a:gd name="connsiteY78" fmla="*/ 419676 h 781626"/>
              <a:gd name="connsiteX79" fmla="*/ 866775 w 881183"/>
              <a:gd name="connsiteY79" fmla="*/ 387926 h 781626"/>
              <a:gd name="connsiteX80" fmla="*/ 863600 w 881183"/>
              <a:gd name="connsiteY80" fmla="*/ 378401 h 781626"/>
              <a:gd name="connsiteX81" fmla="*/ 860425 w 881183"/>
              <a:gd name="connsiteY81" fmla="*/ 368876 h 781626"/>
              <a:gd name="connsiteX82" fmla="*/ 847725 w 881183"/>
              <a:gd name="connsiteY82" fmla="*/ 349826 h 781626"/>
              <a:gd name="connsiteX83" fmla="*/ 828675 w 881183"/>
              <a:gd name="connsiteY83" fmla="*/ 337126 h 781626"/>
              <a:gd name="connsiteX84" fmla="*/ 809625 w 881183"/>
              <a:gd name="connsiteY84" fmla="*/ 324426 h 781626"/>
              <a:gd name="connsiteX85" fmla="*/ 800100 w 881183"/>
              <a:gd name="connsiteY85" fmla="*/ 318076 h 781626"/>
              <a:gd name="connsiteX86" fmla="*/ 781050 w 881183"/>
              <a:gd name="connsiteY86" fmla="*/ 311726 h 781626"/>
              <a:gd name="connsiteX87" fmla="*/ 752475 w 881183"/>
              <a:gd name="connsiteY87" fmla="*/ 299026 h 781626"/>
              <a:gd name="connsiteX88" fmla="*/ 742950 w 881183"/>
              <a:gd name="connsiteY88" fmla="*/ 295851 h 781626"/>
              <a:gd name="connsiteX89" fmla="*/ 733425 w 881183"/>
              <a:gd name="connsiteY89" fmla="*/ 292676 h 781626"/>
              <a:gd name="connsiteX90" fmla="*/ 720725 w 881183"/>
              <a:gd name="connsiteY90" fmla="*/ 289501 h 781626"/>
              <a:gd name="connsiteX91" fmla="*/ 701675 w 881183"/>
              <a:gd name="connsiteY91" fmla="*/ 283151 h 781626"/>
              <a:gd name="connsiteX92" fmla="*/ 692150 w 881183"/>
              <a:gd name="connsiteY92" fmla="*/ 276801 h 781626"/>
              <a:gd name="connsiteX93" fmla="*/ 673100 w 881183"/>
              <a:gd name="connsiteY93" fmla="*/ 267276 h 781626"/>
              <a:gd name="connsiteX94" fmla="*/ 666750 w 881183"/>
              <a:gd name="connsiteY94" fmla="*/ 257751 h 781626"/>
              <a:gd name="connsiteX95" fmla="*/ 654050 w 881183"/>
              <a:gd name="connsiteY95" fmla="*/ 254576 h 781626"/>
              <a:gd name="connsiteX96" fmla="*/ 644525 w 881183"/>
              <a:gd name="connsiteY96" fmla="*/ 251401 h 781626"/>
              <a:gd name="connsiteX97" fmla="*/ 635000 w 881183"/>
              <a:gd name="connsiteY97" fmla="*/ 245051 h 781626"/>
              <a:gd name="connsiteX98" fmla="*/ 628650 w 881183"/>
              <a:gd name="connsiteY98" fmla="*/ 235526 h 781626"/>
              <a:gd name="connsiteX99" fmla="*/ 609600 w 881183"/>
              <a:gd name="connsiteY99" fmla="*/ 229176 h 781626"/>
              <a:gd name="connsiteX100" fmla="*/ 593725 w 881183"/>
              <a:gd name="connsiteY100" fmla="*/ 213301 h 781626"/>
              <a:gd name="connsiteX101" fmla="*/ 574675 w 881183"/>
              <a:gd name="connsiteY101" fmla="*/ 206951 h 781626"/>
              <a:gd name="connsiteX102" fmla="*/ 555625 w 881183"/>
              <a:gd name="connsiteY102" fmla="*/ 191076 h 781626"/>
              <a:gd name="connsiteX103" fmla="*/ 546100 w 881183"/>
              <a:gd name="connsiteY103" fmla="*/ 187901 h 781626"/>
              <a:gd name="connsiteX104" fmla="*/ 527050 w 881183"/>
              <a:gd name="connsiteY104" fmla="*/ 168851 h 781626"/>
              <a:gd name="connsiteX105" fmla="*/ 511175 w 881183"/>
              <a:gd name="connsiteY105" fmla="*/ 140276 h 781626"/>
              <a:gd name="connsiteX106" fmla="*/ 501650 w 881183"/>
              <a:gd name="connsiteY106" fmla="*/ 133926 h 781626"/>
              <a:gd name="connsiteX107" fmla="*/ 492125 w 881183"/>
              <a:gd name="connsiteY107" fmla="*/ 124401 h 781626"/>
              <a:gd name="connsiteX108" fmla="*/ 463550 w 881183"/>
              <a:gd name="connsiteY108" fmla="*/ 105351 h 781626"/>
              <a:gd name="connsiteX109" fmla="*/ 454025 w 881183"/>
              <a:gd name="connsiteY109" fmla="*/ 99001 h 781626"/>
              <a:gd name="connsiteX110" fmla="*/ 438150 w 881183"/>
              <a:gd name="connsiteY110" fmla="*/ 86301 h 781626"/>
              <a:gd name="connsiteX111" fmla="*/ 422275 w 881183"/>
              <a:gd name="connsiteY111" fmla="*/ 73601 h 781626"/>
              <a:gd name="connsiteX112" fmla="*/ 403225 w 881183"/>
              <a:gd name="connsiteY112" fmla="*/ 57726 h 781626"/>
              <a:gd name="connsiteX113" fmla="*/ 393700 w 881183"/>
              <a:gd name="connsiteY113" fmla="*/ 54551 h 781626"/>
              <a:gd name="connsiteX114" fmla="*/ 374650 w 881183"/>
              <a:gd name="connsiteY114" fmla="*/ 41851 h 781626"/>
              <a:gd name="connsiteX115" fmla="*/ 355600 w 881183"/>
              <a:gd name="connsiteY115" fmla="*/ 29151 h 781626"/>
              <a:gd name="connsiteX116" fmla="*/ 336550 w 881183"/>
              <a:gd name="connsiteY116" fmla="*/ 16451 h 781626"/>
              <a:gd name="connsiteX117" fmla="*/ 307975 w 881183"/>
              <a:gd name="connsiteY117" fmla="*/ 576 h 78162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</a:cxnLst>
            <a:rect l="l" t="t" r="r" b="b"/>
            <a:pathLst>
              <a:path w="881183" h="781626">
                <a:moveTo>
                  <a:pt x="307975" y="576"/>
                </a:moveTo>
                <a:cubicBezTo>
                  <a:pt x="297392" y="-1541"/>
                  <a:pt x="284699" y="2780"/>
                  <a:pt x="273050" y="3751"/>
                </a:cubicBezTo>
                <a:cubicBezTo>
                  <a:pt x="259299" y="4897"/>
                  <a:pt x="245467" y="5214"/>
                  <a:pt x="231775" y="6926"/>
                </a:cubicBezTo>
                <a:cubicBezTo>
                  <a:pt x="228454" y="7341"/>
                  <a:pt x="225468" y="9182"/>
                  <a:pt x="222250" y="10101"/>
                </a:cubicBezTo>
                <a:cubicBezTo>
                  <a:pt x="194343" y="18074"/>
                  <a:pt x="222863" y="8838"/>
                  <a:pt x="200025" y="16451"/>
                </a:cubicBezTo>
                <a:cubicBezTo>
                  <a:pt x="184931" y="26514"/>
                  <a:pt x="194120" y="21594"/>
                  <a:pt x="171450" y="29151"/>
                </a:cubicBezTo>
                <a:lnTo>
                  <a:pt x="161925" y="32326"/>
                </a:lnTo>
                <a:lnTo>
                  <a:pt x="133350" y="51376"/>
                </a:lnTo>
                <a:cubicBezTo>
                  <a:pt x="130565" y="53232"/>
                  <a:pt x="127000" y="53493"/>
                  <a:pt x="123825" y="54551"/>
                </a:cubicBezTo>
                <a:cubicBezTo>
                  <a:pt x="105667" y="72709"/>
                  <a:pt x="123888" y="56496"/>
                  <a:pt x="101600" y="70426"/>
                </a:cubicBezTo>
                <a:cubicBezTo>
                  <a:pt x="75896" y="86491"/>
                  <a:pt x="100628" y="72946"/>
                  <a:pt x="79375" y="89476"/>
                </a:cubicBezTo>
                <a:cubicBezTo>
                  <a:pt x="73351" y="94161"/>
                  <a:pt x="60325" y="102176"/>
                  <a:pt x="60325" y="102176"/>
                </a:cubicBezTo>
                <a:cubicBezTo>
                  <a:pt x="49821" y="133688"/>
                  <a:pt x="67444" y="85551"/>
                  <a:pt x="47625" y="121226"/>
                </a:cubicBezTo>
                <a:lnTo>
                  <a:pt x="38100" y="149801"/>
                </a:lnTo>
                <a:cubicBezTo>
                  <a:pt x="35687" y="157041"/>
                  <a:pt x="27813" y="161611"/>
                  <a:pt x="25400" y="168851"/>
                </a:cubicBezTo>
                <a:lnTo>
                  <a:pt x="19050" y="187901"/>
                </a:lnTo>
                <a:cubicBezTo>
                  <a:pt x="17670" y="192041"/>
                  <a:pt x="17594" y="196590"/>
                  <a:pt x="15875" y="200601"/>
                </a:cubicBezTo>
                <a:cubicBezTo>
                  <a:pt x="14372" y="204108"/>
                  <a:pt x="11642" y="206951"/>
                  <a:pt x="9525" y="210126"/>
                </a:cubicBezTo>
                <a:cubicBezTo>
                  <a:pt x="8467" y="214359"/>
                  <a:pt x="7067" y="218522"/>
                  <a:pt x="6350" y="222826"/>
                </a:cubicBezTo>
                <a:cubicBezTo>
                  <a:pt x="4103" y="236309"/>
                  <a:pt x="1223" y="267747"/>
                  <a:pt x="0" y="279976"/>
                </a:cubicBezTo>
                <a:cubicBezTo>
                  <a:pt x="3731" y="324746"/>
                  <a:pt x="-855" y="305986"/>
                  <a:pt x="9525" y="337126"/>
                </a:cubicBezTo>
                <a:cubicBezTo>
                  <a:pt x="11938" y="344366"/>
                  <a:pt x="19812" y="348936"/>
                  <a:pt x="22225" y="356176"/>
                </a:cubicBezTo>
                <a:cubicBezTo>
                  <a:pt x="23283" y="359351"/>
                  <a:pt x="23775" y="362775"/>
                  <a:pt x="25400" y="365701"/>
                </a:cubicBezTo>
                <a:cubicBezTo>
                  <a:pt x="29106" y="372372"/>
                  <a:pt x="35687" y="377511"/>
                  <a:pt x="38100" y="384751"/>
                </a:cubicBezTo>
                <a:lnTo>
                  <a:pt x="44450" y="403801"/>
                </a:lnTo>
                <a:cubicBezTo>
                  <a:pt x="45508" y="406976"/>
                  <a:pt x="45769" y="410541"/>
                  <a:pt x="47625" y="413326"/>
                </a:cubicBezTo>
                <a:cubicBezTo>
                  <a:pt x="61541" y="434200"/>
                  <a:pt x="47761" y="411719"/>
                  <a:pt x="57150" y="432376"/>
                </a:cubicBezTo>
                <a:cubicBezTo>
                  <a:pt x="61067" y="440994"/>
                  <a:pt x="65617" y="449309"/>
                  <a:pt x="69850" y="457776"/>
                </a:cubicBezTo>
                <a:cubicBezTo>
                  <a:pt x="73263" y="464602"/>
                  <a:pt x="78317" y="470476"/>
                  <a:pt x="82550" y="476826"/>
                </a:cubicBezTo>
                <a:lnTo>
                  <a:pt x="95250" y="495876"/>
                </a:lnTo>
                <a:cubicBezTo>
                  <a:pt x="97106" y="498661"/>
                  <a:pt x="96800" y="502475"/>
                  <a:pt x="98425" y="505401"/>
                </a:cubicBezTo>
                <a:lnTo>
                  <a:pt x="117475" y="533976"/>
                </a:lnTo>
                <a:cubicBezTo>
                  <a:pt x="119331" y="536761"/>
                  <a:pt x="119025" y="540575"/>
                  <a:pt x="120650" y="543501"/>
                </a:cubicBezTo>
                <a:cubicBezTo>
                  <a:pt x="124356" y="550172"/>
                  <a:pt x="130937" y="555311"/>
                  <a:pt x="133350" y="562551"/>
                </a:cubicBezTo>
                <a:cubicBezTo>
                  <a:pt x="134408" y="565726"/>
                  <a:pt x="134900" y="569150"/>
                  <a:pt x="136525" y="572076"/>
                </a:cubicBezTo>
                <a:lnTo>
                  <a:pt x="155575" y="600651"/>
                </a:lnTo>
                <a:lnTo>
                  <a:pt x="161925" y="610176"/>
                </a:lnTo>
                <a:cubicBezTo>
                  <a:pt x="164042" y="613351"/>
                  <a:pt x="165577" y="617003"/>
                  <a:pt x="168275" y="619701"/>
                </a:cubicBezTo>
                <a:cubicBezTo>
                  <a:pt x="174625" y="626051"/>
                  <a:pt x="179853" y="633770"/>
                  <a:pt x="187325" y="638751"/>
                </a:cubicBezTo>
                <a:lnTo>
                  <a:pt x="206375" y="651451"/>
                </a:lnTo>
                <a:cubicBezTo>
                  <a:pt x="220110" y="672054"/>
                  <a:pt x="203345" y="651534"/>
                  <a:pt x="225425" y="664151"/>
                </a:cubicBezTo>
                <a:cubicBezTo>
                  <a:pt x="229324" y="666379"/>
                  <a:pt x="231501" y="670801"/>
                  <a:pt x="234950" y="673676"/>
                </a:cubicBezTo>
                <a:cubicBezTo>
                  <a:pt x="243156" y="680515"/>
                  <a:pt x="244454" y="680019"/>
                  <a:pt x="254000" y="683201"/>
                </a:cubicBezTo>
                <a:cubicBezTo>
                  <a:pt x="281297" y="701399"/>
                  <a:pt x="246760" y="679581"/>
                  <a:pt x="273050" y="692726"/>
                </a:cubicBezTo>
                <a:cubicBezTo>
                  <a:pt x="276463" y="694433"/>
                  <a:pt x="279088" y="697526"/>
                  <a:pt x="282575" y="699076"/>
                </a:cubicBezTo>
                <a:lnTo>
                  <a:pt x="311150" y="708601"/>
                </a:lnTo>
                <a:cubicBezTo>
                  <a:pt x="315290" y="709981"/>
                  <a:pt x="319670" y="710522"/>
                  <a:pt x="323850" y="711776"/>
                </a:cubicBezTo>
                <a:cubicBezTo>
                  <a:pt x="330261" y="713699"/>
                  <a:pt x="336550" y="716009"/>
                  <a:pt x="342900" y="718126"/>
                </a:cubicBezTo>
                <a:lnTo>
                  <a:pt x="381000" y="730826"/>
                </a:lnTo>
                <a:lnTo>
                  <a:pt x="390525" y="734001"/>
                </a:lnTo>
                <a:cubicBezTo>
                  <a:pt x="393700" y="735059"/>
                  <a:pt x="396803" y="736364"/>
                  <a:pt x="400050" y="737176"/>
                </a:cubicBezTo>
                <a:lnTo>
                  <a:pt x="412750" y="740351"/>
                </a:lnTo>
                <a:cubicBezTo>
                  <a:pt x="415925" y="742468"/>
                  <a:pt x="418788" y="745151"/>
                  <a:pt x="422275" y="746701"/>
                </a:cubicBezTo>
                <a:cubicBezTo>
                  <a:pt x="437884" y="753638"/>
                  <a:pt x="441663" y="752641"/>
                  <a:pt x="457200" y="756226"/>
                </a:cubicBezTo>
                <a:cubicBezTo>
                  <a:pt x="465704" y="758188"/>
                  <a:pt x="474133" y="760459"/>
                  <a:pt x="482600" y="762576"/>
                </a:cubicBezTo>
                <a:cubicBezTo>
                  <a:pt x="486833" y="763634"/>
                  <a:pt x="490970" y="765210"/>
                  <a:pt x="495300" y="765751"/>
                </a:cubicBezTo>
                <a:lnTo>
                  <a:pt x="546100" y="772101"/>
                </a:lnTo>
                <a:cubicBezTo>
                  <a:pt x="549275" y="773159"/>
                  <a:pt x="552378" y="774464"/>
                  <a:pt x="555625" y="775276"/>
                </a:cubicBezTo>
                <a:cubicBezTo>
                  <a:pt x="574371" y="779962"/>
                  <a:pt x="584737" y="779654"/>
                  <a:pt x="606425" y="781626"/>
                </a:cubicBezTo>
                <a:cubicBezTo>
                  <a:pt x="660729" y="778006"/>
                  <a:pt x="638956" y="783482"/>
                  <a:pt x="673100" y="772101"/>
                </a:cubicBezTo>
                <a:lnTo>
                  <a:pt x="692150" y="765751"/>
                </a:lnTo>
                <a:lnTo>
                  <a:pt x="701675" y="762576"/>
                </a:lnTo>
                <a:cubicBezTo>
                  <a:pt x="728972" y="744378"/>
                  <a:pt x="694435" y="766196"/>
                  <a:pt x="720725" y="753051"/>
                </a:cubicBezTo>
                <a:cubicBezTo>
                  <a:pt x="745344" y="740741"/>
                  <a:pt x="715834" y="751506"/>
                  <a:pt x="739775" y="743526"/>
                </a:cubicBezTo>
                <a:cubicBezTo>
                  <a:pt x="742950" y="741409"/>
                  <a:pt x="745813" y="738726"/>
                  <a:pt x="749300" y="737176"/>
                </a:cubicBezTo>
                <a:cubicBezTo>
                  <a:pt x="755417" y="734458"/>
                  <a:pt x="768350" y="730826"/>
                  <a:pt x="768350" y="730826"/>
                </a:cubicBezTo>
                <a:cubicBezTo>
                  <a:pt x="795647" y="712628"/>
                  <a:pt x="761110" y="734446"/>
                  <a:pt x="787400" y="721301"/>
                </a:cubicBezTo>
                <a:cubicBezTo>
                  <a:pt x="790813" y="719594"/>
                  <a:pt x="793418" y="716454"/>
                  <a:pt x="796925" y="714951"/>
                </a:cubicBezTo>
                <a:cubicBezTo>
                  <a:pt x="800936" y="713232"/>
                  <a:pt x="805445" y="713030"/>
                  <a:pt x="809625" y="711776"/>
                </a:cubicBezTo>
                <a:cubicBezTo>
                  <a:pt x="816036" y="709853"/>
                  <a:pt x="828675" y="705426"/>
                  <a:pt x="828675" y="705426"/>
                </a:cubicBezTo>
                <a:cubicBezTo>
                  <a:pt x="830792" y="702251"/>
                  <a:pt x="832045" y="698285"/>
                  <a:pt x="835025" y="695901"/>
                </a:cubicBezTo>
                <a:cubicBezTo>
                  <a:pt x="837638" y="693810"/>
                  <a:pt x="842183" y="695093"/>
                  <a:pt x="844550" y="692726"/>
                </a:cubicBezTo>
                <a:cubicBezTo>
                  <a:pt x="846917" y="690359"/>
                  <a:pt x="846228" y="686194"/>
                  <a:pt x="847725" y="683201"/>
                </a:cubicBezTo>
                <a:cubicBezTo>
                  <a:pt x="860035" y="658582"/>
                  <a:pt x="849270" y="688092"/>
                  <a:pt x="857250" y="664151"/>
                </a:cubicBezTo>
                <a:cubicBezTo>
                  <a:pt x="859628" y="647502"/>
                  <a:pt x="860663" y="639029"/>
                  <a:pt x="863600" y="622876"/>
                </a:cubicBezTo>
                <a:cubicBezTo>
                  <a:pt x="864565" y="617567"/>
                  <a:pt x="865355" y="612207"/>
                  <a:pt x="866775" y="607001"/>
                </a:cubicBezTo>
                <a:cubicBezTo>
                  <a:pt x="868536" y="600543"/>
                  <a:pt x="871008" y="594301"/>
                  <a:pt x="873125" y="587951"/>
                </a:cubicBezTo>
                <a:lnTo>
                  <a:pt x="876300" y="578426"/>
                </a:lnTo>
                <a:cubicBezTo>
                  <a:pt x="883826" y="510690"/>
                  <a:pt x="881711" y="541414"/>
                  <a:pt x="876300" y="419676"/>
                </a:cubicBezTo>
                <a:cubicBezTo>
                  <a:pt x="876054" y="414139"/>
                  <a:pt x="867522" y="390167"/>
                  <a:pt x="866775" y="387926"/>
                </a:cubicBezTo>
                <a:lnTo>
                  <a:pt x="863600" y="378401"/>
                </a:lnTo>
                <a:cubicBezTo>
                  <a:pt x="862542" y="375226"/>
                  <a:pt x="862281" y="371661"/>
                  <a:pt x="860425" y="368876"/>
                </a:cubicBezTo>
                <a:lnTo>
                  <a:pt x="847725" y="349826"/>
                </a:lnTo>
                <a:cubicBezTo>
                  <a:pt x="843492" y="343476"/>
                  <a:pt x="835025" y="341359"/>
                  <a:pt x="828675" y="337126"/>
                </a:cubicBezTo>
                <a:lnTo>
                  <a:pt x="809625" y="324426"/>
                </a:lnTo>
                <a:lnTo>
                  <a:pt x="800100" y="318076"/>
                </a:lnTo>
                <a:cubicBezTo>
                  <a:pt x="794531" y="314363"/>
                  <a:pt x="781050" y="311726"/>
                  <a:pt x="781050" y="311726"/>
                </a:cubicBezTo>
                <a:cubicBezTo>
                  <a:pt x="765956" y="301663"/>
                  <a:pt x="775145" y="306583"/>
                  <a:pt x="752475" y="299026"/>
                </a:cubicBezTo>
                <a:lnTo>
                  <a:pt x="742950" y="295851"/>
                </a:lnTo>
                <a:cubicBezTo>
                  <a:pt x="739775" y="294793"/>
                  <a:pt x="736672" y="293488"/>
                  <a:pt x="733425" y="292676"/>
                </a:cubicBezTo>
                <a:cubicBezTo>
                  <a:pt x="729192" y="291618"/>
                  <a:pt x="724905" y="290755"/>
                  <a:pt x="720725" y="289501"/>
                </a:cubicBezTo>
                <a:cubicBezTo>
                  <a:pt x="714314" y="287578"/>
                  <a:pt x="701675" y="283151"/>
                  <a:pt x="701675" y="283151"/>
                </a:cubicBezTo>
                <a:cubicBezTo>
                  <a:pt x="698500" y="281034"/>
                  <a:pt x="695563" y="278508"/>
                  <a:pt x="692150" y="276801"/>
                </a:cubicBezTo>
                <a:cubicBezTo>
                  <a:pt x="665860" y="263656"/>
                  <a:pt x="700397" y="285474"/>
                  <a:pt x="673100" y="267276"/>
                </a:cubicBezTo>
                <a:cubicBezTo>
                  <a:pt x="670983" y="264101"/>
                  <a:pt x="669925" y="259868"/>
                  <a:pt x="666750" y="257751"/>
                </a:cubicBezTo>
                <a:cubicBezTo>
                  <a:pt x="663119" y="255330"/>
                  <a:pt x="658246" y="255775"/>
                  <a:pt x="654050" y="254576"/>
                </a:cubicBezTo>
                <a:cubicBezTo>
                  <a:pt x="650832" y="253657"/>
                  <a:pt x="647700" y="252459"/>
                  <a:pt x="644525" y="251401"/>
                </a:cubicBezTo>
                <a:cubicBezTo>
                  <a:pt x="641350" y="249284"/>
                  <a:pt x="637698" y="247749"/>
                  <a:pt x="635000" y="245051"/>
                </a:cubicBezTo>
                <a:cubicBezTo>
                  <a:pt x="632302" y="242353"/>
                  <a:pt x="631886" y="237548"/>
                  <a:pt x="628650" y="235526"/>
                </a:cubicBezTo>
                <a:cubicBezTo>
                  <a:pt x="622974" y="231978"/>
                  <a:pt x="609600" y="229176"/>
                  <a:pt x="609600" y="229176"/>
                </a:cubicBezTo>
                <a:cubicBezTo>
                  <a:pt x="603807" y="220487"/>
                  <a:pt x="603751" y="217757"/>
                  <a:pt x="593725" y="213301"/>
                </a:cubicBezTo>
                <a:cubicBezTo>
                  <a:pt x="587608" y="210583"/>
                  <a:pt x="574675" y="206951"/>
                  <a:pt x="574675" y="206951"/>
                </a:cubicBezTo>
                <a:cubicBezTo>
                  <a:pt x="567653" y="199929"/>
                  <a:pt x="564466" y="195496"/>
                  <a:pt x="555625" y="191076"/>
                </a:cubicBezTo>
                <a:cubicBezTo>
                  <a:pt x="552632" y="189579"/>
                  <a:pt x="549275" y="188959"/>
                  <a:pt x="546100" y="187901"/>
                </a:cubicBezTo>
                <a:cubicBezTo>
                  <a:pt x="539750" y="181551"/>
                  <a:pt x="529890" y="177370"/>
                  <a:pt x="527050" y="168851"/>
                </a:cubicBezTo>
                <a:cubicBezTo>
                  <a:pt x="523741" y="158925"/>
                  <a:pt x="520533" y="146514"/>
                  <a:pt x="511175" y="140276"/>
                </a:cubicBezTo>
                <a:cubicBezTo>
                  <a:pt x="508000" y="138159"/>
                  <a:pt x="504581" y="136369"/>
                  <a:pt x="501650" y="133926"/>
                </a:cubicBezTo>
                <a:cubicBezTo>
                  <a:pt x="498201" y="131051"/>
                  <a:pt x="495669" y="127158"/>
                  <a:pt x="492125" y="124401"/>
                </a:cubicBezTo>
                <a:lnTo>
                  <a:pt x="463550" y="105351"/>
                </a:lnTo>
                <a:lnTo>
                  <a:pt x="454025" y="99001"/>
                </a:lnTo>
                <a:cubicBezTo>
                  <a:pt x="435827" y="71704"/>
                  <a:pt x="460058" y="103828"/>
                  <a:pt x="438150" y="86301"/>
                </a:cubicBezTo>
                <a:cubicBezTo>
                  <a:pt x="417634" y="69888"/>
                  <a:pt x="446216" y="81581"/>
                  <a:pt x="422275" y="73601"/>
                </a:cubicBezTo>
                <a:cubicBezTo>
                  <a:pt x="415253" y="66579"/>
                  <a:pt x="412066" y="62146"/>
                  <a:pt x="403225" y="57726"/>
                </a:cubicBezTo>
                <a:cubicBezTo>
                  <a:pt x="400232" y="56229"/>
                  <a:pt x="396875" y="55609"/>
                  <a:pt x="393700" y="54551"/>
                </a:cubicBezTo>
                <a:cubicBezTo>
                  <a:pt x="387350" y="50318"/>
                  <a:pt x="380046" y="47247"/>
                  <a:pt x="374650" y="41851"/>
                </a:cubicBezTo>
                <a:cubicBezTo>
                  <a:pt x="362758" y="29959"/>
                  <a:pt x="369385" y="33746"/>
                  <a:pt x="355600" y="29151"/>
                </a:cubicBezTo>
                <a:cubicBezTo>
                  <a:pt x="349250" y="24918"/>
                  <a:pt x="343790" y="18864"/>
                  <a:pt x="336550" y="16451"/>
                </a:cubicBezTo>
                <a:cubicBezTo>
                  <a:pt x="305452" y="6085"/>
                  <a:pt x="318558" y="2693"/>
                  <a:pt x="307975" y="576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64" name="フリーフォーム 163"/>
          <p:cNvSpPr/>
          <p:nvPr/>
        </p:nvSpPr>
        <p:spPr>
          <a:xfrm>
            <a:off x="6686578" y="972140"/>
            <a:ext cx="881183" cy="781626"/>
          </a:xfrm>
          <a:custGeom>
            <a:avLst/>
            <a:gdLst>
              <a:gd name="connsiteX0" fmla="*/ 307975 w 881183"/>
              <a:gd name="connsiteY0" fmla="*/ 576 h 781626"/>
              <a:gd name="connsiteX1" fmla="*/ 273050 w 881183"/>
              <a:gd name="connsiteY1" fmla="*/ 3751 h 781626"/>
              <a:gd name="connsiteX2" fmla="*/ 231775 w 881183"/>
              <a:gd name="connsiteY2" fmla="*/ 6926 h 781626"/>
              <a:gd name="connsiteX3" fmla="*/ 222250 w 881183"/>
              <a:gd name="connsiteY3" fmla="*/ 10101 h 781626"/>
              <a:gd name="connsiteX4" fmla="*/ 200025 w 881183"/>
              <a:gd name="connsiteY4" fmla="*/ 16451 h 781626"/>
              <a:gd name="connsiteX5" fmla="*/ 171450 w 881183"/>
              <a:gd name="connsiteY5" fmla="*/ 29151 h 781626"/>
              <a:gd name="connsiteX6" fmla="*/ 161925 w 881183"/>
              <a:gd name="connsiteY6" fmla="*/ 32326 h 781626"/>
              <a:gd name="connsiteX7" fmla="*/ 133350 w 881183"/>
              <a:gd name="connsiteY7" fmla="*/ 51376 h 781626"/>
              <a:gd name="connsiteX8" fmla="*/ 123825 w 881183"/>
              <a:gd name="connsiteY8" fmla="*/ 54551 h 781626"/>
              <a:gd name="connsiteX9" fmla="*/ 101600 w 881183"/>
              <a:gd name="connsiteY9" fmla="*/ 70426 h 781626"/>
              <a:gd name="connsiteX10" fmla="*/ 79375 w 881183"/>
              <a:gd name="connsiteY10" fmla="*/ 89476 h 781626"/>
              <a:gd name="connsiteX11" fmla="*/ 60325 w 881183"/>
              <a:gd name="connsiteY11" fmla="*/ 102176 h 781626"/>
              <a:gd name="connsiteX12" fmla="*/ 47625 w 881183"/>
              <a:gd name="connsiteY12" fmla="*/ 121226 h 781626"/>
              <a:gd name="connsiteX13" fmla="*/ 38100 w 881183"/>
              <a:gd name="connsiteY13" fmla="*/ 149801 h 781626"/>
              <a:gd name="connsiteX14" fmla="*/ 25400 w 881183"/>
              <a:gd name="connsiteY14" fmla="*/ 168851 h 781626"/>
              <a:gd name="connsiteX15" fmla="*/ 19050 w 881183"/>
              <a:gd name="connsiteY15" fmla="*/ 187901 h 781626"/>
              <a:gd name="connsiteX16" fmla="*/ 15875 w 881183"/>
              <a:gd name="connsiteY16" fmla="*/ 200601 h 781626"/>
              <a:gd name="connsiteX17" fmla="*/ 9525 w 881183"/>
              <a:gd name="connsiteY17" fmla="*/ 210126 h 781626"/>
              <a:gd name="connsiteX18" fmla="*/ 6350 w 881183"/>
              <a:gd name="connsiteY18" fmla="*/ 222826 h 781626"/>
              <a:gd name="connsiteX19" fmla="*/ 0 w 881183"/>
              <a:gd name="connsiteY19" fmla="*/ 279976 h 781626"/>
              <a:gd name="connsiteX20" fmla="*/ 9525 w 881183"/>
              <a:gd name="connsiteY20" fmla="*/ 337126 h 781626"/>
              <a:gd name="connsiteX21" fmla="*/ 22225 w 881183"/>
              <a:gd name="connsiteY21" fmla="*/ 356176 h 781626"/>
              <a:gd name="connsiteX22" fmla="*/ 25400 w 881183"/>
              <a:gd name="connsiteY22" fmla="*/ 365701 h 781626"/>
              <a:gd name="connsiteX23" fmla="*/ 38100 w 881183"/>
              <a:gd name="connsiteY23" fmla="*/ 384751 h 781626"/>
              <a:gd name="connsiteX24" fmla="*/ 44450 w 881183"/>
              <a:gd name="connsiteY24" fmla="*/ 403801 h 781626"/>
              <a:gd name="connsiteX25" fmla="*/ 47625 w 881183"/>
              <a:gd name="connsiteY25" fmla="*/ 413326 h 781626"/>
              <a:gd name="connsiteX26" fmla="*/ 57150 w 881183"/>
              <a:gd name="connsiteY26" fmla="*/ 432376 h 781626"/>
              <a:gd name="connsiteX27" fmla="*/ 69850 w 881183"/>
              <a:gd name="connsiteY27" fmla="*/ 457776 h 781626"/>
              <a:gd name="connsiteX28" fmla="*/ 82550 w 881183"/>
              <a:gd name="connsiteY28" fmla="*/ 476826 h 781626"/>
              <a:gd name="connsiteX29" fmla="*/ 95250 w 881183"/>
              <a:gd name="connsiteY29" fmla="*/ 495876 h 781626"/>
              <a:gd name="connsiteX30" fmla="*/ 98425 w 881183"/>
              <a:gd name="connsiteY30" fmla="*/ 505401 h 781626"/>
              <a:gd name="connsiteX31" fmla="*/ 117475 w 881183"/>
              <a:gd name="connsiteY31" fmla="*/ 533976 h 781626"/>
              <a:gd name="connsiteX32" fmla="*/ 120650 w 881183"/>
              <a:gd name="connsiteY32" fmla="*/ 543501 h 781626"/>
              <a:gd name="connsiteX33" fmla="*/ 133350 w 881183"/>
              <a:gd name="connsiteY33" fmla="*/ 562551 h 781626"/>
              <a:gd name="connsiteX34" fmla="*/ 136525 w 881183"/>
              <a:gd name="connsiteY34" fmla="*/ 572076 h 781626"/>
              <a:gd name="connsiteX35" fmla="*/ 155575 w 881183"/>
              <a:gd name="connsiteY35" fmla="*/ 600651 h 781626"/>
              <a:gd name="connsiteX36" fmla="*/ 161925 w 881183"/>
              <a:gd name="connsiteY36" fmla="*/ 610176 h 781626"/>
              <a:gd name="connsiteX37" fmla="*/ 168275 w 881183"/>
              <a:gd name="connsiteY37" fmla="*/ 619701 h 781626"/>
              <a:gd name="connsiteX38" fmla="*/ 187325 w 881183"/>
              <a:gd name="connsiteY38" fmla="*/ 638751 h 781626"/>
              <a:gd name="connsiteX39" fmla="*/ 206375 w 881183"/>
              <a:gd name="connsiteY39" fmla="*/ 651451 h 781626"/>
              <a:gd name="connsiteX40" fmla="*/ 225425 w 881183"/>
              <a:gd name="connsiteY40" fmla="*/ 664151 h 781626"/>
              <a:gd name="connsiteX41" fmla="*/ 234950 w 881183"/>
              <a:gd name="connsiteY41" fmla="*/ 673676 h 781626"/>
              <a:gd name="connsiteX42" fmla="*/ 254000 w 881183"/>
              <a:gd name="connsiteY42" fmla="*/ 683201 h 781626"/>
              <a:gd name="connsiteX43" fmla="*/ 273050 w 881183"/>
              <a:gd name="connsiteY43" fmla="*/ 692726 h 781626"/>
              <a:gd name="connsiteX44" fmla="*/ 282575 w 881183"/>
              <a:gd name="connsiteY44" fmla="*/ 699076 h 781626"/>
              <a:gd name="connsiteX45" fmla="*/ 311150 w 881183"/>
              <a:gd name="connsiteY45" fmla="*/ 708601 h 781626"/>
              <a:gd name="connsiteX46" fmla="*/ 323850 w 881183"/>
              <a:gd name="connsiteY46" fmla="*/ 711776 h 781626"/>
              <a:gd name="connsiteX47" fmla="*/ 342900 w 881183"/>
              <a:gd name="connsiteY47" fmla="*/ 718126 h 781626"/>
              <a:gd name="connsiteX48" fmla="*/ 381000 w 881183"/>
              <a:gd name="connsiteY48" fmla="*/ 730826 h 781626"/>
              <a:gd name="connsiteX49" fmla="*/ 390525 w 881183"/>
              <a:gd name="connsiteY49" fmla="*/ 734001 h 781626"/>
              <a:gd name="connsiteX50" fmla="*/ 400050 w 881183"/>
              <a:gd name="connsiteY50" fmla="*/ 737176 h 781626"/>
              <a:gd name="connsiteX51" fmla="*/ 412750 w 881183"/>
              <a:gd name="connsiteY51" fmla="*/ 740351 h 781626"/>
              <a:gd name="connsiteX52" fmla="*/ 422275 w 881183"/>
              <a:gd name="connsiteY52" fmla="*/ 746701 h 781626"/>
              <a:gd name="connsiteX53" fmla="*/ 457200 w 881183"/>
              <a:gd name="connsiteY53" fmla="*/ 756226 h 781626"/>
              <a:gd name="connsiteX54" fmla="*/ 482600 w 881183"/>
              <a:gd name="connsiteY54" fmla="*/ 762576 h 781626"/>
              <a:gd name="connsiteX55" fmla="*/ 495300 w 881183"/>
              <a:gd name="connsiteY55" fmla="*/ 765751 h 781626"/>
              <a:gd name="connsiteX56" fmla="*/ 546100 w 881183"/>
              <a:gd name="connsiteY56" fmla="*/ 772101 h 781626"/>
              <a:gd name="connsiteX57" fmla="*/ 555625 w 881183"/>
              <a:gd name="connsiteY57" fmla="*/ 775276 h 781626"/>
              <a:gd name="connsiteX58" fmla="*/ 606425 w 881183"/>
              <a:gd name="connsiteY58" fmla="*/ 781626 h 781626"/>
              <a:gd name="connsiteX59" fmla="*/ 673100 w 881183"/>
              <a:gd name="connsiteY59" fmla="*/ 772101 h 781626"/>
              <a:gd name="connsiteX60" fmla="*/ 692150 w 881183"/>
              <a:gd name="connsiteY60" fmla="*/ 765751 h 781626"/>
              <a:gd name="connsiteX61" fmla="*/ 701675 w 881183"/>
              <a:gd name="connsiteY61" fmla="*/ 762576 h 781626"/>
              <a:gd name="connsiteX62" fmla="*/ 720725 w 881183"/>
              <a:gd name="connsiteY62" fmla="*/ 753051 h 781626"/>
              <a:gd name="connsiteX63" fmla="*/ 739775 w 881183"/>
              <a:gd name="connsiteY63" fmla="*/ 743526 h 781626"/>
              <a:gd name="connsiteX64" fmla="*/ 749300 w 881183"/>
              <a:gd name="connsiteY64" fmla="*/ 737176 h 781626"/>
              <a:gd name="connsiteX65" fmla="*/ 768350 w 881183"/>
              <a:gd name="connsiteY65" fmla="*/ 730826 h 781626"/>
              <a:gd name="connsiteX66" fmla="*/ 787400 w 881183"/>
              <a:gd name="connsiteY66" fmla="*/ 721301 h 781626"/>
              <a:gd name="connsiteX67" fmla="*/ 796925 w 881183"/>
              <a:gd name="connsiteY67" fmla="*/ 714951 h 781626"/>
              <a:gd name="connsiteX68" fmla="*/ 809625 w 881183"/>
              <a:gd name="connsiteY68" fmla="*/ 711776 h 781626"/>
              <a:gd name="connsiteX69" fmla="*/ 828675 w 881183"/>
              <a:gd name="connsiteY69" fmla="*/ 705426 h 781626"/>
              <a:gd name="connsiteX70" fmla="*/ 835025 w 881183"/>
              <a:gd name="connsiteY70" fmla="*/ 695901 h 781626"/>
              <a:gd name="connsiteX71" fmla="*/ 844550 w 881183"/>
              <a:gd name="connsiteY71" fmla="*/ 692726 h 781626"/>
              <a:gd name="connsiteX72" fmla="*/ 847725 w 881183"/>
              <a:gd name="connsiteY72" fmla="*/ 683201 h 781626"/>
              <a:gd name="connsiteX73" fmla="*/ 857250 w 881183"/>
              <a:gd name="connsiteY73" fmla="*/ 664151 h 781626"/>
              <a:gd name="connsiteX74" fmla="*/ 863600 w 881183"/>
              <a:gd name="connsiteY74" fmla="*/ 622876 h 781626"/>
              <a:gd name="connsiteX75" fmla="*/ 866775 w 881183"/>
              <a:gd name="connsiteY75" fmla="*/ 607001 h 781626"/>
              <a:gd name="connsiteX76" fmla="*/ 873125 w 881183"/>
              <a:gd name="connsiteY76" fmla="*/ 587951 h 781626"/>
              <a:gd name="connsiteX77" fmla="*/ 876300 w 881183"/>
              <a:gd name="connsiteY77" fmla="*/ 578426 h 781626"/>
              <a:gd name="connsiteX78" fmla="*/ 876300 w 881183"/>
              <a:gd name="connsiteY78" fmla="*/ 419676 h 781626"/>
              <a:gd name="connsiteX79" fmla="*/ 866775 w 881183"/>
              <a:gd name="connsiteY79" fmla="*/ 387926 h 781626"/>
              <a:gd name="connsiteX80" fmla="*/ 863600 w 881183"/>
              <a:gd name="connsiteY80" fmla="*/ 378401 h 781626"/>
              <a:gd name="connsiteX81" fmla="*/ 860425 w 881183"/>
              <a:gd name="connsiteY81" fmla="*/ 368876 h 781626"/>
              <a:gd name="connsiteX82" fmla="*/ 847725 w 881183"/>
              <a:gd name="connsiteY82" fmla="*/ 349826 h 781626"/>
              <a:gd name="connsiteX83" fmla="*/ 828675 w 881183"/>
              <a:gd name="connsiteY83" fmla="*/ 337126 h 781626"/>
              <a:gd name="connsiteX84" fmla="*/ 809625 w 881183"/>
              <a:gd name="connsiteY84" fmla="*/ 324426 h 781626"/>
              <a:gd name="connsiteX85" fmla="*/ 800100 w 881183"/>
              <a:gd name="connsiteY85" fmla="*/ 318076 h 781626"/>
              <a:gd name="connsiteX86" fmla="*/ 781050 w 881183"/>
              <a:gd name="connsiteY86" fmla="*/ 311726 h 781626"/>
              <a:gd name="connsiteX87" fmla="*/ 752475 w 881183"/>
              <a:gd name="connsiteY87" fmla="*/ 299026 h 781626"/>
              <a:gd name="connsiteX88" fmla="*/ 742950 w 881183"/>
              <a:gd name="connsiteY88" fmla="*/ 295851 h 781626"/>
              <a:gd name="connsiteX89" fmla="*/ 733425 w 881183"/>
              <a:gd name="connsiteY89" fmla="*/ 292676 h 781626"/>
              <a:gd name="connsiteX90" fmla="*/ 720725 w 881183"/>
              <a:gd name="connsiteY90" fmla="*/ 289501 h 781626"/>
              <a:gd name="connsiteX91" fmla="*/ 701675 w 881183"/>
              <a:gd name="connsiteY91" fmla="*/ 283151 h 781626"/>
              <a:gd name="connsiteX92" fmla="*/ 692150 w 881183"/>
              <a:gd name="connsiteY92" fmla="*/ 276801 h 781626"/>
              <a:gd name="connsiteX93" fmla="*/ 673100 w 881183"/>
              <a:gd name="connsiteY93" fmla="*/ 267276 h 781626"/>
              <a:gd name="connsiteX94" fmla="*/ 666750 w 881183"/>
              <a:gd name="connsiteY94" fmla="*/ 257751 h 781626"/>
              <a:gd name="connsiteX95" fmla="*/ 654050 w 881183"/>
              <a:gd name="connsiteY95" fmla="*/ 254576 h 781626"/>
              <a:gd name="connsiteX96" fmla="*/ 644525 w 881183"/>
              <a:gd name="connsiteY96" fmla="*/ 251401 h 781626"/>
              <a:gd name="connsiteX97" fmla="*/ 635000 w 881183"/>
              <a:gd name="connsiteY97" fmla="*/ 245051 h 781626"/>
              <a:gd name="connsiteX98" fmla="*/ 628650 w 881183"/>
              <a:gd name="connsiteY98" fmla="*/ 235526 h 781626"/>
              <a:gd name="connsiteX99" fmla="*/ 609600 w 881183"/>
              <a:gd name="connsiteY99" fmla="*/ 229176 h 781626"/>
              <a:gd name="connsiteX100" fmla="*/ 593725 w 881183"/>
              <a:gd name="connsiteY100" fmla="*/ 213301 h 781626"/>
              <a:gd name="connsiteX101" fmla="*/ 574675 w 881183"/>
              <a:gd name="connsiteY101" fmla="*/ 206951 h 781626"/>
              <a:gd name="connsiteX102" fmla="*/ 555625 w 881183"/>
              <a:gd name="connsiteY102" fmla="*/ 191076 h 781626"/>
              <a:gd name="connsiteX103" fmla="*/ 546100 w 881183"/>
              <a:gd name="connsiteY103" fmla="*/ 187901 h 781626"/>
              <a:gd name="connsiteX104" fmla="*/ 527050 w 881183"/>
              <a:gd name="connsiteY104" fmla="*/ 168851 h 781626"/>
              <a:gd name="connsiteX105" fmla="*/ 511175 w 881183"/>
              <a:gd name="connsiteY105" fmla="*/ 140276 h 781626"/>
              <a:gd name="connsiteX106" fmla="*/ 501650 w 881183"/>
              <a:gd name="connsiteY106" fmla="*/ 133926 h 781626"/>
              <a:gd name="connsiteX107" fmla="*/ 492125 w 881183"/>
              <a:gd name="connsiteY107" fmla="*/ 124401 h 781626"/>
              <a:gd name="connsiteX108" fmla="*/ 463550 w 881183"/>
              <a:gd name="connsiteY108" fmla="*/ 105351 h 781626"/>
              <a:gd name="connsiteX109" fmla="*/ 454025 w 881183"/>
              <a:gd name="connsiteY109" fmla="*/ 99001 h 781626"/>
              <a:gd name="connsiteX110" fmla="*/ 438150 w 881183"/>
              <a:gd name="connsiteY110" fmla="*/ 86301 h 781626"/>
              <a:gd name="connsiteX111" fmla="*/ 422275 w 881183"/>
              <a:gd name="connsiteY111" fmla="*/ 73601 h 781626"/>
              <a:gd name="connsiteX112" fmla="*/ 403225 w 881183"/>
              <a:gd name="connsiteY112" fmla="*/ 57726 h 781626"/>
              <a:gd name="connsiteX113" fmla="*/ 393700 w 881183"/>
              <a:gd name="connsiteY113" fmla="*/ 54551 h 781626"/>
              <a:gd name="connsiteX114" fmla="*/ 374650 w 881183"/>
              <a:gd name="connsiteY114" fmla="*/ 41851 h 781626"/>
              <a:gd name="connsiteX115" fmla="*/ 355600 w 881183"/>
              <a:gd name="connsiteY115" fmla="*/ 29151 h 781626"/>
              <a:gd name="connsiteX116" fmla="*/ 336550 w 881183"/>
              <a:gd name="connsiteY116" fmla="*/ 16451 h 781626"/>
              <a:gd name="connsiteX117" fmla="*/ 307975 w 881183"/>
              <a:gd name="connsiteY117" fmla="*/ 576 h 78162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</a:cxnLst>
            <a:rect l="l" t="t" r="r" b="b"/>
            <a:pathLst>
              <a:path w="881183" h="781626">
                <a:moveTo>
                  <a:pt x="307975" y="576"/>
                </a:moveTo>
                <a:cubicBezTo>
                  <a:pt x="297392" y="-1541"/>
                  <a:pt x="284699" y="2780"/>
                  <a:pt x="273050" y="3751"/>
                </a:cubicBezTo>
                <a:cubicBezTo>
                  <a:pt x="259299" y="4897"/>
                  <a:pt x="245467" y="5214"/>
                  <a:pt x="231775" y="6926"/>
                </a:cubicBezTo>
                <a:cubicBezTo>
                  <a:pt x="228454" y="7341"/>
                  <a:pt x="225468" y="9182"/>
                  <a:pt x="222250" y="10101"/>
                </a:cubicBezTo>
                <a:cubicBezTo>
                  <a:pt x="194343" y="18074"/>
                  <a:pt x="222863" y="8838"/>
                  <a:pt x="200025" y="16451"/>
                </a:cubicBezTo>
                <a:cubicBezTo>
                  <a:pt x="184931" y="26514"/>
                  <a:pt x="194120" y="21594"/>
                  <a:pt x="171450" y="29151"/>
                </a:cubicBezTo>
                <a:lnTo>
                  <a:pt x="161925" y="32326"/>
                </a:lnTo>
                <a:lnTo>
                  <a:pt x="133350" y="51376"/>
                </a:lnTo>
                <a:cubicBezTo>
                  <a:pt x="130565" y="53232"/>
                  <a:pt x="127000" y="53493"/>
                  <a:pt x="123825" y="54551"/>
                </a:cubicBezTo>
                <a:cubicBezTo>
                  <a:pt x="105667" y="72709"/>
                  <a:pt x="123888" y="56496"/>
                  <a:pt x="101600" y="70426"/>
                </a:cubicBezTo>
                <a:cubicBezTo>
                  <a:pt x="75896" y="86491"/>
                  <a:pt x="100628" y="72946"/>
                  <a:pt x="79375" y="89476"/>
                </a:cubicBezTo>
                <a:cubicBezTo>
                  <a:pt x="73351" y="94161"/>
                  <a:pt x="60325" y="102176"/>
                  <a:pt x="60325" y="102176"/>
                </a:cubicBezTo>
                <a:cubicBezTo>
                  <a:pt x="49821" y="133688"/>
                  <a:pt x="67444" y="85551"/>
                  <a:pt x="47625" y="121226"/>
                </a:cubicBezTo>
                <a:lnTo>
                  <a:pt x="38100" y="149801"/>
                </a:lnTo>
                <a:cubicBezTo>
                  <a:pt x="35687" y="157041"/>
                  <a:pt x="27813" y="161611"/>
                  <a:pt x="25400" y="168851"/>
                </a:cubicBezTo>
                <a:lnTo>
                  <a:pt x="19050" y="187901"/>
                </a:lnTo>
                <a:cubicBezTo>
                  <a:pt x="17670" y="192041"/>
                  <a:pt x="17594" y="196590"/>
                  <a:pt x="15875" y="200601"/>
                </a:cubicBezTo>
                <a:cubicBezTo>
                  <a:pt x="14372" y="204108"/>
                  <a:pt x="11642" y="206951"/>
                  <a:pt x="9525" y="210126"/>
                </a:cubicBezTo>
                <a:cubicBezTo>
                  <a:pt x="8467" y="214359"/>
                  <a:pt x="7067" y="218522"/>
                  <a:pt x="6350" y="222826"/>
                </a:cubicBezTo>
                <a:cubicBezTo>
                  <a:pt x="4103" y="236309"/>
                  <a:pt x="1223" y="267747"/>
                  <a:pt x="0" y="279976"/>
                </a:cubicBezTo>
                <a:cubicBezTo>
                  <a:pt x="3731" y="324746"/>
                  <a:pt x="-855" y="305986"/>
                  <a:pt x="9525" y="337126"/>
                </a:cubicBezTo>
                <a:cubicBezTo>
                  <a:pt x="11938" y="344366"/>
                  <a:pt x="19812" y="348936"/>
                  <a:pt x="22225" y="356176"/>
                </a:cubicBezTo>
                <a:cubicBezTo>
                  <a:pt x="23283" y="359351"/>
                  <a:pt x="23775" y="362775"/>
                  <a:pt x="25400" y="365701"/>
                </a:cubicBezTo>
                <a:cubicBezTo>
                  <a:pt x="29106" y="372372"/>
                  <a:pt x="35687" y="377511"/>
                  <a:pt x="38100" y="384751"/>
                </a:cubicBezTo>
                <a:lnTo>
                  <a:pt x="44450" y="403801"/>
                </a:lnTo>
                <a:cubicBezTo>
                  <a:pt x="45508" y="406976"/>
                  <a:pt x="45769" y="410541"/>
                  <a:pt x="47625" y="413326"/>
                </a:cubicBezTo>
                <a:cubicBezTo>
                  <a:pt x="61541" y="434200"/>
                  <a:pt x="47761" y="411719"/>
                  <a:pt x="57150" y="432376"/>
                </a:cubicBezTo>
                <a:cubicBezTo>
                  <a:pt x="61067" y="440994"/>
                  <a:pt x="65617" y="449309"/>
                  <a:pt x="69850" y="457776"/>
                </a:cubicBezTo>
                <a:cubicBezTo>
                  <a:pt x="73263" y="464602"/>
                  <a:pt x="78317" y="470476"/>
                  <a:pt x="82550" y="476826"/>
                </a:cubicBezTo>
                <a:lnTo>
                  <a:pt x="95250" y="495876"/>
                </a:lnTo>
                <a:cubicBezTo>
                  <a:pt x="97106" y="498661"/>
                  <a:pt x="96800" y="502475"/>
                  <a:pt x="98425" y="505401"/>
                </a:cubicBezTo>
                <a:lnTo>
                  <a:pt x="117475" y="533976"/>
                </a:lnTo>
                <a:cubicBezTo>
                  <a:pt x="119331" y="536761"/>
                  <a:pt x="119025" y="540575"/>
                  <a:pt x="120650" y="543501"/>
                </a:cubicBezTo>
                <a:cubicBezTo>
                  <a:pt x="124356" y="550172"/>
                  <a:pt x="130937" y="555311"/>
                  <a:pt x="133350" y="562551"/>
                </a:cubicBezTo>
                <a:cubicBezTo>
                  <a:pt x="134408" y="565726"/>
                  <a:pt x="134900" y="569150"/>
                  <a:pt x="136525" y="572076"/>
                </a:cubicBezTo>
                <a:lnTo>
                  <a:pt x="155575" y="600651"/>
                </a:lnTo>
                <a:lnTo>
                  <a:pt x="161925" y="610176"/>
                </a:lnTo>
                <a:cubicBezTo>
                  <a:pt x="164042" y="613351"/>
                  <a:pt x="165577" y="617003"/>
                  <a:pt x="168275" y="619701"/>
                </a:cubicBezTo>
                <a:cubicBezTo>
                  <a:pt x="174625" y="626051"/>
                  <a:pt x="179853" y="633770"/>
                  <a:pt x="187325" y="638751"/>
                </a:cubicBezTo>
                <a:lnTo>
                  <a:pt x="206375" y="651451"/>
                </a:lnTo>
                <a:cubicBezTo>
                  <a:pt x="220110" y="672054"/>
                  <a:pt x="203345" y="651534"/>
                  <a:pt x="225425" y="664151"/>
                </a:cubicBezTo>
                <a:cubicBezTo>
                  <a:pt x="229324" y="666379"/>
                  <a:pt x="231501" y="670801"/>
                  <a:pt x="234950" y="673676"/>
                </a:cubicBezTo>
                <a:cubicBezTo>
                  <a:pt x="243156" y="680515"/>
                  <a:pt x="244454" y="680019"/>
                  <a:pt x="254000" y="683201"/>
                </a:cubicBezTo>
                <a:cubicBezTo>
                  <a:pt x="281297" y="701399"/>
                  <a:pt x="246760" y="679581"/>
                  <a:pt x="273050" y="692726"/>
                </a:cubicBezTo>
                <a:cubicBezTo>
                  <a:pt x="276463" y="694433"/>
                  <a:pt x="279088" y="697526"/>
                  <a:pt x="282575" y="699076"/>
                </a:cubicBezTo>
                <a:lnTo>
                  <a:pt x="311150" y="708601"/>
                </a:lnTo>
                <a:cubicBezTo>
                  <a:pt x="315290" y="709981"/>
                  <a:pt x="319670" y="710522"/>
                  <a:pt x="323850" y="711776"/>
                </a:cubicBezTo>
                <a:cubicBezTo>
                  <a:pt x="330261" y="713699"/>
                  <a:pt x="336550" y="716009"/>
                  <a:pt x="342900" y="718126"/>
                </a:cubicBezTo>
                <a:lnTo>
                  <a:pt x="381000" y="730826"/>
                </a:lnTo>
                <a:lnTo>
                  <a:pt x="390525" y="734001"/>
                </a:lnTo>
                <a:cubicBezTo>
                  <a:pt x="393700" y="735059"/>
                  <a:pt x="396803" y="736364"/>
                  <a:pt x="400050" y="737176"/>
                </a:cubicBezTo>
                <a:lnTo>
                  <a:pt x="412750" y="740351"/>
                </a:lnTo>
                <a:cubicBezTo>
                  <a:pt x="415925" y="742468"/>
                  <a:pt x="418788" y="745151"/>
                  <a:pt x="422275" y="746701"/>
                </a:cubicBezTo>
                <a:cubicBezTo>
                  <a:pt x="437884" y="753638"/>
                  <a:pt x="441663" y="752641"/>
                  <a:pt x="457200" y="756226"/>
                </a:cubicBezTo>
                <a:cubicBezTo>
                  <a:pt x="465704" y="758188"/>
                  <a:pt x="474133" y="760459"/>
                  <a:pt x="482600" y="762576"/>
                </a:cubicBezTo>
                <a:cubicBezTo>
                  <a:pt x="486833" y="763634"/>
                  <a:pt x="490970" y="765210"/>
                  <a:pt x="495300" y="765751"/>
                </a:cubicBezTo>
                <a:lnTo>
                  <a:pt x="546100" y="772101"/>
                </a:lnTo>
                <a:cubicBezTo>
                  <a:pt x="549275" y="773159"/>
                  <a:pt x="552378" y="774464"/>
                  <a:pt x="555625" y="775276"/>
                </a:cubicBezTo>
                <a:cubicBezTo>
                  <a:pt x="574371" y="779962"/>
                  <a:pt x="584737" y="779654"/>
                  <a:pt x="606425" y="781626"/>
                </a:cubicBezTo>
                <a:cubicBezTo>
                  <a:pt x="660729" y="778006"/>
                  <a:pt x="638956" y="783482"/>
                  <a:pt x="673100" y="772101"/>
                </a:cubicBezTo>
                <a:lnTo>
                  <a:pt x="692150" y="765751"/>
                </a:lnTo>
                <a:lnTo>
                  <a:pt x="701675" y="762576"/>
                </a:lnTo>
                <a:cubicBezTo>
                  <a:pt x="728972" y="744378"/>
                  <a:pt x="694435" y="766196"/>
                  <a:pt x="720725" y="753051"/>
                </a:cubicBezTo>
                <a:cubicBezTo>
                  <a:pt x="745344" y="740741"/>
                  <a:pt x="715834" y="751506"/>
                  <a:pt x="739775" y="743526"/>
                </a:cubicBezTo>
                <a:cubicBezTo>
                  <a:pt x="742950" y="741409"/>
                  <a:pt x="745813" y="738726"/>
                  <a:pt x="749300" y="737176"/>
                </a:cubicBezTo>
                <a:cubicBezTo>
                  <a:pt x="755417" y="734458"/>
                  <a:pt x="768350" y="730826"/>
                  <a:pt x="768350" y="730826"/>
                </a:cubicBezTo>
                <a:cubicBezTo>
                  <a:pt x="795647" y="712628"/>
                  <a:pt x="761110" y="734446"/>
                  <a:pt x="787400" y="721301"/>
                </a:cubicBezTo>
                <a:cubicBezTo>
                  <a:pt x="790813" y="719594"/>
                  <a:pt x="793418" y="716454"/>
                  <a:pt x="796925" y="714951"/>
                </a:cubicBezTo>
                <a:cubicBezTo>
                  <a:pt x="800936" y="713232"/>
                  <a:pt x="805445" y="713030"/>
                  <a:pt x="809625" y="711776"/>
                </a:cubicBezTo>
                <a:cubicBezTo>
                  <a:pt x="816036" y="709853"/>
                  <a:pt x="828675" y="705426"/>
                  <a:pt x="828675" y="705426"/>
                </a:cubicBezTo>
                <a:cubicBezTo>
                  <a:pt x="830792" y="702251"/>
                  <a:pt x="832045" y="698285"/>
                  <a:pt x="835025" y="695901"/>
                </a:cubicBezTo>
                <a:cubicBezTo>
                  <a:pt x="837638" y="693810"/>
                  <a:pt x="842183" y="695093"/>
                  <a:pt x="844550" y="692726"/>
                </a:cubicBezTo>
                <a:cubicBezTo>
                  <a:pt x="846917" y="690359"/>
                  <a:pt x="846228" y="686194"/>
                  <a:pt x="847725" y="683201"/>
                </a:cubicBezTo>
                <a:cubicBezTo>
                  <a:pt x="860035" y="658582"/>
                  <a:pt x="849270" y="688092"/>
                  <a:pt x="857250" y="664151"/>
                </a:cubicBezTo>
                <a:cubicBezTo>
                  <a:pt x="859628" y="647502"/>
                  <a:pt x="860663" y="639029"/>
                  <a:pt x="863600" y="622876"/>
                </a:cubicBezTo>
                <a:cubicBezTo>
                  <a:pt x="864565" y="617567"/>
                  <a:pt x="865355" y="612207"/>
                  <a:pt x="866775" y="607001"/>
                </a:cubicBezTo>
                <a:cubicBezTo>
                  <a:pt x="868536" y="600543"/>
                  <a:pt x="871008" y="594301"/>
                  <a:pt x="873125" y="587951"/>
                </a:cubicBezTo>
                <a:lnTo>
                  <a:pt x="876300" y="578426"/>
                </a:lnTo>
                <a:cubicBezTo>
                  <a:pt x="883826" y="510690"/>
                  <a:pt x="881711" y="541414"/>
                  <a:pt x="876300" y="419676"/>
                </a:cubicBezTo>
                <a:cubicBezTo>
                  <a:pt x="876054" y="414139"/>
                  <a:pt x="867522" y="390167"/>
                  <a:pt x="866775" y="387926"/>
                </a:cubicBezTo>
                <a:lnTo>
                  <a:pt x="863600" y="378401"/>
                </a:lnTo>
                <a:cubicBezTo>
                  <a:pt x="862542" y="375226"/>
                  <a:pt x="862281" y="371661"/>
                  <a:pt x="860425" y="368876"/>
                </a:cubicBezTo>
                <a:lnTo>
                  <a:pt x="847725" y="349826"/>
                </a:lnTo>
                <a:cubicBezTo>
                  <a:pt x="843492" y="343476"/>
                  <a:pt x="835025" y="341359"/>
                  <a:pt x="828675" y="337126"/>
                </a:cubicBezTo>
                <a:lnTo>
                  <a:pt x="809625" y="324426"/>
                </a:lnTo>
                <a:lnTo>
                  <a:pt x="800100" y="318076"/>
                </a:lnTo>
                <a:cubicBezTo>
                  <a:pt x="794531" y="314363"/>
                  <a:pt x="781050" y="311726"/>
                  <a:pt x="781050" y="311726"/>
                </a:cubicBezTo>
                <a:cubicBezTo>
                  <a:pt x="765956" y="301663"/>
                  <a:pt x="775145" y="306583"/>
                  <a:pt x="752475" y="299026"/>
                </a:cubicBezTo>
                <a:lnTo>
                  <a:pt x="742950" y="295851"/>
                </a:lnTo>
                <a:cubicBezTo>
                  <a:pt x="739775" y="294793"/>
                  <a:pt x="736672" y="293488"/>
                  <a:pt x="733425" y="292676"/>
                </a:cubicBezTo>
                <a:cubicBezTo>
                  <a:pt x="729192" y="291618"/>
                  <a:pt x="724905" y="290755"/>
                  <a:pt x="720725" y="289501"/>
                </a:cubicBezTo>
                <a:cubicBezTo>
                  <a:pt x="714314" y="287578"/>
                  <a:pt x="701675" y="283151"/>
                  <a:pt x="701675" y="283151"/>
                </a:cubicBezTo>
                <a:cubicBezTo>
                  <a:pt x="698500" y="281034"/>
                  <a:pt x="695563" y="278508"/>
                  <a:pt x="692150" y="276801"/>
                </a:cubicBezTo>
                <a:cubicBezTo>
                  <a:pt x="665860" y="263656"/>
                  <a:pt x="700397" y="285474"/>
                  <a:pt x="673100" y="267276"/>
                </a:cubicBezTo>
                <a:cubicBezTo>
                  <a:pt x="670983" y="264101"/>
                  <a:pt x="669925" y="259868"/>
                  <a:pt x="666750" y="257751"/>
                </a:cubicBezTo>
                <a:cubicBezTo>
                  <a:pt x="663119" y="255330"/>
                  <a:pt x="658246" y="255775"/>
                  <a:pt x="654050" y="254576"/>
                </a:cubicBezTo>
                <a:cubicBezTo>
                  <a:pt x="650832" y="253657"/>
                  <a:pt x="647700" y="252459"/>
                  <a:pt x="644525" y="251401"/>
                </a:cubicBezTo>
                <a:cubicBezTo>
                  <a:pt x="641350" y="249284"/>
                  <a:pt x="637698" y="247749"/>
                  <a:pt x="635000" y="245051"/>
                </a:cubicBezTo>
                <a:cubicBezTo>
                  <a:pt x="632302" y="242353"/>
                  <a:pt x="631886" y="237548"/>
                  <a:pt x="628650" y="235526"/>
                </a:cubicBezTo>
                <a:cubicBezTo>
                  <a:pt x="622974" y="231978"/>
                  <a:pt x="609600" y="229176"/>
                  <a:pt x="609600" y="229176"/>
                </a:cubicBezTo>
                <a:cubicBezTo>
                  <a:pt x="603807" y="220487"/>
                  <a:pt x="603751" y="217757"/>
                  <a:pt x="593725" y="213301"/>
                </a:cubicBezTo>
                <a:cubicBezTo>
                  <a:pt x="587608" y="210583"/>
                  <a:pt x="574675" y="206951"/>
                  <a:pt x="574675" y="206951"/>
                </a:cubicBezTo>
                <a:cubicBezTo>
                  <a:pt x="567653" y="199929"/>
                  <a:pt x="564466" y="195496"/>
                  <a:pt x="555625" y="191076"/>
                </a:cubicBezTo>
                <a:cubicBezTo>
                  <a:pt x="552632" y="189579"/>
                  <a:pt x="549275" y="188959"/>
                  <a:pt x="546100" y="187901"/>
                </a:cubicBezTo>
                <a:cubicBezTo>
                  <a:pt x="539750" y="181551"/>
                  <a:pt x="529890" y="177370"/>
                  <a:pt x="527050" y="168851"/>
                </a:cubicBezTo>
                <a:cubicBezTo>
                  <a:pt x="523741" y="158925"/>
                  <a:pt x="520533" y="146514"/>
                  <a:pt x="511175" y="140276"/>
                </a:cubicBezTo>
                <a:cubicBezTo>
                  <a:pt x="508000" y="138159"/>
                  <a:pt x="504581" y="136369"/>
                  <a:pt x="501650" y="133926"/>
                </a:cubicBezTo>
                <a:cubicBezTo>
                  <a:pt x="498201" y="131051"/>
                  <a:pt x="495669" y="127158"/>
                  <a:pt x="492125" y="124401"/>
                </a:cubicBezTo>
                <a:lnTo>
                  <a:pt x="463550" y="105351"/>
                </a:lnTo>
                <a:lnTo>
                  <a:pt x="454025" y="99001"/>
                </a:lnTo>
                <a:cubicBezTo>
                  <a:pt x="435827" y="71704"/>
                  <a:pt x="460058" y="103828"/>
                  <a:pt x="438150" y="86301"/>
                </a:cubicBezTo>
                <a:cubicBezTo>
                  <a:pt x="417634" y="69888"/>
                  <a:pt x="446216" y="81581"/>
                  <a:pt x="422275" y="73601"/>
                </a:cubicBezTo>
                <a:cubicBezTo>
                  <a:pt x="415253" y="66579"/>
                  <a:pt x="412066" y="62146"/>
                  <a:pt x="403225" y="57726"/>
                </a:cubicBezTo>
                <a:cubicBezTo>
                  <a:pt x="400232" y="56229"/>
                  <a:pt x="396875" y="55609"/>
                  <a:pt x="393700" y="54551"/>
                </a:cubicBezTo>
                <a:cubicBezTo>
                  <a:pt x="387350" y="50318"/>
                  <a:pt x="380046" y="47247"/>
                  <a:pt x="374650" y="41851"/>
                </a:cubicBezTo>
                <a:cubicBezTo>
                  <a:pt x="362758" y="29959"/>
                  <a:pt x="369385" y="33746"/>
                  <a:pt x="355600" y="29151"/>
                </a:cubicBezTo>
                <a:cubicBezTo>
                  <a:pt x="349250" y="24918"/>
                  <a:pt x="343790" y="18864"/>
                  <a:pt x="336550" y="16451"/>
                </a:cubicBezTo>
                <a:cubicBezTo>
                  <a:pt x="305452" y="6085"/>
                  <a:pt x="318558" y="2693"/>
                  <a:pt x="307975" y="576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65" name="フリーフォーム 164"/>
          <p:cNvSpPr/>
          <p:nvPr/>
        </p:nvSpPr>
        <p:spPr>
          <a:xfrm>
            <a:off x="5292080" y="961678"/>
            <a:ext cx="881183" cy="781626"/>
          </a:xfrm>
          <a:custGeom>
            <a:avLst/>
            <a:gdLst>
              <a:gd name="connsiteX0" fmla="*/ 307975 w 881183"/>
              <a:gd name="connsiteY0" fmla="*/ 576 h 781626"/>
              <a:gd name="connsiteX1" fmla="*/ 273050 w 881183"/>
              <a:gd name="connsiteY1" fmla="*/ 3751 h 781626"/>
              <a:gd name="connsiteX2" fmla="*/ 231775 w 881183"/>
              <a:gd name="connsiteY2" fmla="*/ 6926 h 781626"/>
              <a:gd name="connsiteX3" fmla="*/ 222250 w 881183"/>
              <a:gd name="connsiteY3" fmla="*/ 10101 h 781626"/>
              <a:gd name="connsiteX4" fmla="*/ 200025 w 881183"/>
              <a:gd name="connsiteY4" fmla="*/ 16451 h 781626"/>
              <a:gd name="connsiteX5" fmla="*/ 171450 w 881183"/>
              <a:gd name="connsiteY5" fmla="*/ 29151 h 781626"/>
              <a:gd name="connsiteX6" fmla="*/ 161925 w 881183"/>
              <a:gd name="connsiteY6" fmla="*/ 32326 h 781626"/>
              <a:gd name="connsiteX7" fmla="*/ 133350 w 881183"/>
              <a:gd name="connsiteY7" fmla="*/ 51376 h 781626"/>
              <a:gd name="connsiteX8" fmla="*/ 123825 w 881183"/>
              <a:gd name="connsiteY8" fmla="*/ 54551 h 781626"/>
              <a:gd name="connsiteX9" fmla="*/ 101600 w 881183"/>
              <a:gd name="connsiteY9" fmla="*/ 70426 h 781626"/>
              <a:gd name="connsiteX10" fmla="*/ 79375 w 881183"/>
              <a:gd name="connsiteY10" fmla="*/ 89476 h 781626"/>
              <a:gd name="connsiteX11" fmla="*/ 60325 w 881183"/>
              <a:gd name="connsiteY11" fmla="*/ 102176 h 781626"/>
              <a:gd name="connsiteX12" fmla="*/ 47625 w 881183"/>
              <a:gd name="connsiteY12" fmla="*/ 121226 h 781626"/>
              <a:gd name="connsiteX13" fmla="*/ 38100 w 881183"/>
              <a:gd name="connsiteY13" fmla="*/ 149801 h 781626"/>
              <a:gd name="connsiteX14" fmla="*/ 25400 w 881183"/>
              <a:gd name="connsiteY14" fmla="*/ 168851 h 781626"/>
              <a:gd name="connsiteX15" fmla="*/ 19050 w 881183"/>
              <a:gd name="connsiteY15" fmla="*/ 187901 h 781626"/>
              <a:gd name="connsiteX16" fmla="*/ 15875 w 881183"/>
              <a:gd name="connsiteY16" fmla="*/ 200601 h 781626"/>
              <a:gd name="connsiteX17" fmla="*/ 9525 w 881183"/>
              <a:gd name="connsiteY17" fmla="*/ 210126 h 781626"/>
              <a:gd name="connsiteX18" fmla="*/ 6350 w 881183"/>
              <a:gd name="connsiteY18" fmla="*/ 222826 h 781626"/>
              <a:gd name="connsiteX19" fmla="*/ 0 w 881183"/>
              <a:gd name="connsiteY19" fmla="*/ 279976 h 781626"/>
              <a:gd name="connsiteX20" fmla="*/ 9525 w 881183"/>
              <a:gd name="connsiteY20" fmla="*/ 337126 h 781626"/>
              <a:gd name="connsiteX21" fmla="*/ 22225 w 881183"/>
              <a:gd name="connsiteY21" fmla="*/ 356176 h 781626"/>
              <a:gd name="connsiteX22" fmla="*/ 25400 w 881183"/>
              <a:gd name="connsiteY22" fmla="*/ 365701 h 781626"/>
              <a:gd name="connsiteX23" fmla="*/ 38100 w 881183"/>
              <a:gd name="connsiteY23" fmla="*/ 384751 h 781626"/>
              <a:gd name="connsiteX24" fmla="*/ 44450 w 881183"/>
              <a:gd name="connsiteY24" fmla="*/ 403801 h 781626"/>
              <a:gd name="connsiteX25" fmla="*/ 47625 w 881183"/>
              <a:gd name="connsiteY25" fmla="*/ 413326 h 781626"/>
              <a:gd name="connsiteX26" fmla="*/ 57150 w 881183"/>
              <a:gd name="connsiteY26" fmla="*/ 432376 h 781626"/>
              <a:gd name="connsiteX27" fmla="*/ 69850 w 881183"/>
              <a:gd name="connsiteY27" fmla="*/ 457776 h 781626"/>
              <a:gd name="connsiteX28" fmla="*/ 82550 w 881183"/>
              <a:gd name="connsiteY28" fmla="*/ 476826 h 781626"/>
              <a:gd name="connsiteX29" fmla="*/ 95250 w 881183"/>
              <a:gd name="connsiteY29" fmla="*/ 495876 h 781626"/>
              <a:gd name="connsiteX30" fmla="*/ 98425 w 881183"/>
              <a:gd name="connsiteY30" fmla="*/ 505401 h 781626"/>
              <a:gd name="connsiteX31" fmla="*/ 117475 w 881183"/>
              <a:gd name="connsiteY31" fmla="*/ 533976 h 781626"/>
              <a:gd name="connsiteX32" fmla="*/ 120650 w 881183"/>
              <a:gd name="connsiteY32" fmla="*/ 543501 h 781626"/>
              <a:gd name="connsiteX33" fmla="*/ 133350 w 881183"/>
              <a:gd name="connsiteY33" fmla="*/ 562551 h 781626"/>
              <a:gd name="connsiteX34" fmla="*/ 136525 w 881183"/>
              <a:gd name="connsiteY34" fmla="*/ 572076 h 781626"/>
              <a:gd name="connsiteX35" fmla="*/ 155575 w 881183"/>
              <a:gd name="connsiteY35" fmla="*/ 600651 h 781626"/>
              <a:gd name="connsiteX36" fmla="*/ 161925 w 881183"/>
              <a:gd name="connsiteY36" fmla="*/ 610176 h 781626"/>
              <a:gd name="connsiteX37" fmla="*/ 168275 w 881183"/>
              <a:gd name="connsiteY37" fmla="*/ 619701 h 781626"/>
              <a:gd name="connsiteX38" fmla="*/ 187325 w 881183"/>
              <a:gd name="connsiteY38" fmla="*/ 638751 h 781626"/>
              <a:gd name="connsiteX39" fmla="*/ 206375 w 881183"/>
              <a:gd name="connsiteY39" fmla="*/ 651451 h 781626"/>
              <a:gd name="connsiteX40" fmla="*/ 225425 w 881183"/>
              <a:gd name="connsiteY40" fmla="*/ 664151 h 781626"/>
              <a:gd name="connsiteX41" fmla="*/ 234950 w 881183"/>
              <a:gd name="connsiteY41" fmla="*/ 673676 h 781626"/>
              <a:gd name="connsiteX42" fmla="*/ 254000 w 881183"/>
              <a:gd name="connsiteY42" fmla="*/ 683201 h 781626"/>
              <a:gd name="connsiteX43" fmla="*/ 273050 w 881183"/>
              <a:gd name="connsiteY43" fmla="*/ 692726 h 781626"/>
              <a:gd name="connsiteX44" fmla="*/ 282575 w 881183"/>
              <a:gd name="connsiteY44" fmla="*/ 699076 h 781626"/>
              <a:gd name="connsiteX45" fmla="*/ 311150 w 881183"/>
              <a:gd name="connsiteY45" fmla="*/ 708601 h 781626"/>
              <a:gd name="connsiteX46" fmla="*/ 323850 w 881183"/>
              <a:gd name="connsiteY46" fmla="*/ 711776 h 781626"/>
              <a:gd name="connsiteX47" fmla="*/ 342900 w 881183"/>
              <a:gd name="connsiteY47" fmla="*/ 718126 h 781626"/>
              <a:gd name="connsiteX48" fmla="*/ 381000 w 881183"/>
              <a:gd name="connsiteY48" fmla="*/ 730826 h 781626"/>
              <a:gd name="connsiteX49" fmla="*/ 390525 w 881183"/>
              <a:gd name="connsiteY49" fmla="*/ 734001 h 781626"/>
              <a:gd name="connsiteX50" fmla="*/ 400050 w 881183"/>
              <a:gd name="connsiteY50" fmla="*/ 737176 h 781626"/>
              <a:gd name="connsiteX51" fmla="*/ 412750 w 881183"/>
              <a:gd name="connsiteY51" fmla="*/ 740351 h 781626"/>
              <a:gd name="connsiteX52" fmla="*/ 422275 w 881183"/>
              <a:gd name="connsiteY52" fmla="*/ 746701 h 781626"/>
              <a:gd name="connsiteX53" fmla="*/ 457200 w 881183"/>
              <a:gd name="connsiteY53" fmla="*/ 756226 h 781626"/>
              <a:gd name="connsiteX54" fmla="*/ 482600 w 881183"/>
              <a:gd name="connsiteY54" fmla="*/ 762576 h 781626"/>
              <a:gd name="connsiteX55" fmla="*/ 495300 w 881183"/>
              <a:gd name="connsiteY55" fmla="*/ 765751 h 781626"/>
              <a:gd name="connsiteX56" fmla="*/ 546100 w 881183"/>
              <a:gd name="connsiteY56" fmla="*/ 772101 h 781626"/>
              <a:gd name="connsiteX57" fmla="*/ 555625 w 881183"/>
              <a:gd name="connsiteY57" fmla="*/ 775276 h 781626"/>
              <a:gd name="connsiteX58" fmla="*/ 606425 w 881183"/>
              <a:gd name="connsiteY58" fmla="*/ 781626 h 781626"/>
              <a:gd name="connsiteX59" fmla="*/ 673100 w 881183"/>
              <a:gd name="connsiteY59" fmla="*/ 772101 h 781626"/>
              <a:gd name="connsiteX60" fmla="*/ 692150 w 881183"/>
              <a:gd name="connsiteY60" fmla="*/ 765751 h 781626"/>
              <a:gd name="connsiteX61" fmla="*/ 701675 w 881183"/>
              <a:gd name="connsiteY61" fmla="*/ 762576 h 781626"/>
              <a:gd name="connsiteX62" fmla="*/ 720725 w 881183"/>
              <a:gd name="connsiteY62" fmla="*/ 753051 h 781626"/>
              <a:gd name="connsiteX63" fmla="*/ 739775 w 881183"/>
              <a:gd name="connsiteY63" fmla="*/ 743526 h 781626"/>
              <a:gd name="connsiteX64" fmla="*/ 749300 w 881183"/>
              <a:gd name="connsiteY64" fmla="*/ 737176 h 781626"/>
              <a:gd name="connsiteX65" fmla="*/ 768350 w 881183"/>
              <a:gd name="connsiteY65" fmla="*/ 730826 h 781626"/>
              <a:gd name="connsiteX66" fmla="*/ 787400 w 881183"/>
              <a:gd name="connsiteY66" fmla="*/ 721301 h 781626"/>
              <a:gd name="connsiteX67" fmla="*/ 796925 w 881183"/>
              <a:gd name="connsiteY67" fmla="*/ 714951 h 781626"/>
              <a:gd name="connsiteX68" fmla="*/ 809625 w 881183"/>
              <a:gd name="connsiteY68" fmla="*/ 711776 h 781626"/>
              <a:gd name="connsiteX69" fmla="*/ 828675 w 881183"/>
              <a:gd name="connsiteY69" fmla="*/ 705426 h 781626"/>
              <a:gd name="connsiteX70" fmla="*/ 835025 w 881183"/>
              <a:gd name="connsiteY70" fmla="*/ 695901 h 781626"/>
              <a:gd name="connsiteX71" fmla="*/ 844550 w 881183"/>
              <a:gd name="connsiteY71" fmla="*/ 692726 h 781626"/>
              <a:gd name="connsiteX72" fmla="*/ 847725 w 881183"/>
              <a:gd name="connsiteY72" fmla="*/ 683201 h 781626"/>
              <a:gd name="connsiteX73" fmla="*/ 857250 w 881183"/>
              <a:gd name="connsiteY73" fmla="*/ 664151 h 781626"/>
              <a:gd name="connsiteX74" fmla="*/ 863600 w 881183"/>
              <a:gd name="connsiteY74" fmla="*/ 622876 h 781626"/>
              <a:gd name="connsiteX75" fmla="*/ 866775 w 881183"/>
              <a:gd name="connsiteY75" fmla="*/ 607001 h 781626"/>
              <a:gd name="connsiteX76" fmla="*/ 873125 w 881183"/>
              <a:gd name="connsiteY76" fmla="*/ 587951 h 781626"/>
              <a:gd name="connsiteX77" fmla="*/ 876300 w 881183"/>
              <a:gd name="connsiteY77" fmla="*/ 578426 h 781626"/>
              <a:gd name="connsiteX78" fmla="*/ 876300 w 881183"/>
              <a:gd name="connsiteY78" fmla="*/ 419676 h 781626"/>
              <a:gd name="connsiteX79" fmla="*/ 866775 w 881183"/>
              <a:gd name="connsiteY79" fmla="*/ 387926 h 781626"/>
              <a:gd name="connsiteX80" fmla="*/ 863600 w 881183"/>
              <a:gd name="connsiteY80" fmla="*/ 378401 h 781626"/>
              <a:gd name="connsiteX81" fmla="*/ 860425 w 881183"/>
              <a:gd name="connsiteY81" fmla="*/ 368876 h 781626"/>
              <a:gd name="connsiteX82" fmla="*/ 847725 w 881183"/>
              <a:gd name="connsiteY82" fmla="*/ 349826 h 781626"/>
              <a:gd name="connsiteX83" fmla="*/ 828675 w 881183"/>
              <a:gd name="connsiteY83" fmla="*/ 337126 h 781626"/>
              <a:gd name="connsiteX84" fmla="*/ 809625 w 881183"/>
              <a:gd name="connsiteY84" fmla="*/ 324426 h 781626"/>
              <a:gd name="connsiteX85" fmla="*/ 800100 w 881183"/>
              <a:gd name="connsiteY85" fmla="*/ 318076 h 781626"/>
              <a:gd name="connsiteX86" fmla="*/ 781050 w 881183"/>
              <a:gd name="connsiteY86" fmla="*/ 311726 h 781626"/>
              <a:gd name="connsiteX87" fmla="*/ 752475 w 881183"/>
              <a:gd name="connsiteY87" fmla="*/ 299026 h 781626"/>
              <a:gd name="connsiteX88" fmla="*/ 742950 w 881183"/>
              <a:gd name="connsiteY88" fmla="*/ 295851 h 781626"/>
              <a:gd name="connsiteX89" fmla="*/ 733425 w 881183"/>
              <a:gd name="connsiteY89" fmla="*/ 292676 h 781626"/>
              <a:gd name="connsiteX90" fmla="*/ 720725 w 881183"/>
              <a:gd name="connsiteY90" fmla="*/ 289501 h 781626"/>
              <a:gd name="connsiteX91" fmla="*/ 701675 w 881183"/>
              <a:gd name="connsiteY91" fmla="*/ 283151 h 781626"/>
              <a:gd name="connsiteX92" fmla="*/ 692150 w 881183"/>
              <a:gd name="connsiteY92" fmla="*/ 276801 h 781626"/>
              <a:gd name="connsiteX93" fmla="*/ 673100 w 881183"/>
              <a:gd name="connsiteY93" fmla="*/ 267276 h 781626"/>
              <a:gd name="connsiteX94" fmla="*/ 666750 w 881183"/>
              <a:gd name="connsiteY94" fmla="*/ 257751 h 781626"/>
              <a:gd name="connsiteX95" fmla="*/ 654050 w 881183"/>
              <a:gd name="connsiteY95" fmla="*/ 254576 h 781626"/>
              <a:gd name="connsiteX96" fmla="*/ 644525 w 881183"/>
              <a:gd name="connsiteY96" fmla="*/ 251401 h 781626"/>
              <a:gd name="connsiteX97" fmla="*/ 635000 w 881183"/>
              <a:gd name="connsiteY97" fmla="*/ 245051 h 781626"/>
              <a:gd name="connsiteX98" fmla="*/ 628650 w 881183"/>
              <a:gd name="connsiteY98" fmla="*/ 235526 h 781626"/>
              <a:gd name="connsiteX99" fmla="*/ 609600 w 881183"/>
              <a:gd name="connsiteY99" fmla="*/ 229176 h 781626"/>
              <a:gd name="connsiteX100" fmla="*/ 593725 w 881183"/>
              <a:gd name="connsiteY100" fmla="*/ 213301 h 781626"/>
              <a:gd name="connsiteX101" fmla="*/ 574675 w 881183"/>
              <a:gd name="connsiteY101" fmla="*/ 206951 h 781626"/>
              <a:gd name="connsiteX102" fmla="*/ 555625 w 881183"/>
              <a:gd name="connsiteY102" fmla="*/ 191076 h 781626"/>
              <a:gd name="connsiteX103" fmla="*/ 546100 w 881183"/>
              <a:gd name="connsiteY103" fmla="*/ 187901 h 781626"/>
              <a:gd name="connsiteX104" fmla="*/ 527050 w 881183"/>
              <a:gd name="connsiteY104" fmla="*/ 168851 h 781626"/>
              <a:gd name="connsiteX105" fmla="*/ 511175 w 881183"/>
              <a:gd name="connsiteY105" fmla="*/ 140276 h 781626"/>
              <a:gd name="connsiteX106" fmla="*/ 501650 w 881183"/>
              <a:gd name="connsiteY106" fmla="*/ 133926 h 781626"/>
              <a:gd name="connsiteX107" fmla="*/ 492125 w 881183"/>
              <a:gd name="connsiteY107" fmla="*/ 124401 h 781626"/>
              <a:gd name="connsiteX108" fmla="*/ 463550 w 881183"/>
              <a:gd name="connsiteY108" fmla="*/ 105351 h 781626"/>
              <a:gd name="connsiteX109" fmla="*/ 454025 w 881183"/>
              <a:gd name="connsiteY109" fmla="*/ 99001 h 781626"/>
              <a:gd name="connsiteX110" fmla="*/ 438150 w 881183"/>
              <a:gd name="connsiteY110" fmla="*/ 86301 h 781626"/>
              <a:gd name="connsiteX111" fmla="*/ 422275 w 881183"/>
              <a:gd name="connsiteY111" fmla="*/ 73601 h 781626"/>
              <a:gd name="connsiteX112" fmla="*/ 403225 w 881183"/>
              <a:gd name="connsiteY112" fmla="*/ 57726 h 781626"/>
              <a:gd name="connsiteX113" fmla="*/ 393700 w 881183"/>
              <a:gd name="connsiteY113" fmla="*/ 54551 h 781626"/>
              <a:gd name="connsiteX114" fmla="*/ 374650 w 881183"/>
              <a:gd name="connsiteY114" fmla="*/ 41851 h 781626"/>
              <a:gd name="connsiteX115" fmla="*/ 355600 w 881183"/>
              <a:gd name="connsiteY115" fmla="*/ 29151 h 781626"/>
              <a:gd name="connsiteX116" fmla="*/ 336550 w 881183"/>
              <a:gd name="connsiteY116" fmla="*/ 16451 h 781626"/>
              <a:gd name="connsiteX117" fmla="*/ 307975 w 881183"/>
              <a:gd name="connsiteY117" fmla="*/ 576 h 78162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</a:cxnLst>
            <a:rect l="l" t="t" r="r" b="b"/>
            <a:pathLst>
              <a:path w="881183" h="781626">
                <a:moveTo>
                  <a:pt x="307975" y="576"/>
                </a:moveTo>
                <a:cubicBezTo>
                  <a:pt x="297392" y="-1541"/>
                  <a:pt x="284699" y="2780"/>
                  <a:pt x="273050" y="3751"/>
                </a:cubicBezTo>
                <a:cubicBezTo>
                  <a:pt x="259299" y="4897"/>
                  <a:pt x="245467" y="5214"/>
                  <a:pt x="231775" y="6926"/>
                </a:cubicBezTo>
                <a:cubicBezTo>
                  <a:pt x="228454" y="7341"/>
                  <a:pt x="225468" y="9182"/>
                  <a:pt x="222250" y="10101"/>
                </a:cubicBezTo>
                <a:cubicBezTo>
                  <a:pt x="194343" y="18074"/>
                  <a:pt x="222863" y="8838"/>
                  <a:pt x="200025" y="16451"/>
                </a:cubicBezTo>
                <a:cubicBezTo>
                  <a:pt x="184931" y="26514"/>
                  <a:pt x="194120" y="21594"/>
                  <a:pt x="171450" y="29151"/>
                </a:cubicBezTo>
                <a:lnTo>
                  <a:pt x="161925" y="32326"/>
                </a:lnTo>
                <a:lnTo>
                  <a:pt x="133350" y="51376"/>
                </a:lnTo>
                <a:cubicBezTo>
                  <a:pt x="130565" y="53232"/>
                  <a:pt x="127000" y="53493"/>
                  <a:pt x="123825" y="54551"/>
                </a:cubicBezTo>
                <a:cubicBezTo>
                  <a:pt x="105667" y="72709"/>
                  <a:pt x="123888" y="56496"/>
                  <a:pt x="101600" y="70426"/>
                </a:cubicBezTo>
                <a:cubicBezTo>
                  <a:pt x="75896" y="86491"/>
                  <a:pt x="100628" y="72946"/>
                  <a:pt x="79375" y="89476"/>
                </a:cubicBezTo>
                <a:cubicBezTo>
                  <a:pt x="73351" y="94161"/>
                  <a:pt x="60325" y="102176"/>
                  <a:pt x="60325" y="102176"/>
                </a:cubicBezTo>
                <a:cubicBezTo>
                  <a:pt x="49821" y="133688"/>
                  <a:pt x="67444" y="85551"/>
                  <a:pt x="47625" y="121226"/>
                </a:cubicBezTo>
                <a:lnTo>
                  <a:pt x="38100" y="149801"/>
                </a:lnTo>
                <a:cubicBezTo>
                  <a:pt x="35687" y="157041"/>
                  <a:pt x="27813" y="161611"/>
                  <a:pt x="25400" y="168851"/>
                </a:cubicBezTo>
                <a:lnTo>
                  <a:pt x="19050" y="187901"/>
                </a:lnTo>
                <a:cubicBezTo>
                  <a:pt x="17670" y="192041"/>
                  <a:pt x="17594" y="196590"/>
                  <a:pt x="15875" y="200601"/>
                </a:cubicBezTo>
                <a:cubicBezTo>
                  <a:pt x="14372" y="204108"/>
                  <a:pt x="11642" y="206951"/>
                  <a:pt x="9525" y="210126"/>
                </a:cubicBezTo>
                <a:cubicBezTo>
                  <a:pt x="8467" y="214359"/>
                  <a:pt x="7067" y="218522"/>
                  <a:pt x="6350" y="222826"/>
                </a:cubicBezTo>
                <a:cubicBezTo>
                  <a:pt x="4103" y="236309"/>
                  <a:pt x="1223" y="267747"/>
                  <a:pt x="0" y="279976"/>
                </a:cubicBezTo>
                <a:cubicBezTo>
                  <a:pt x="3731" y="324746"/>
                  <a:pt x="-855" y="305986"/>
                  <a:pt x="9525" y="337126"/>
                </a:cubicBezTo>
                <a:cubicBezTo>
                  <a:pt x="11938" y="344366"/>
                  <a:pt x="19812" y="348936"/>
                  <a:pt x="22225" y="356176"/>
                </a:cubicBezTo>
                <a:cubicBezTo>
                  <a:pt x="23283" y="359351"/>
                  <a:pt x="23775" y="362775"/>
                  <a:pt x="25400" y="365701"/>
                </a:cubicBezTo>
                <a:cubicBezTo>
                  <a:pt x="29106" y="372372"/>
                  <a:pt x="35687" y="377511"/>
                  <a:pt x="38100" y="384751"/>
                </a:cubicBezTo>
                <a:lnTo>
                  <a:pt x="44450" y="403801"/>
                </a:lnTo>
                <a:cubicBezTo>
                  <a:pt x="45508" y="406976"/>
                  <a:pt x="45769" y="410541"/>
                  <a:pt x="47625" y="413326"/>
                </a:cubicBezTo>
                <a:cubicBezTo>
                  <a:pt x="61541" y="434200"/>
                  <a:pt x="47761" y="411719"/>
                  <a:pt x="57150" y="432376"/>
                </a:cubicBezTo>
                <a:cubicBezTo>
                  <a:pt x="61067" y="440994"/>
                  <a:pt x="65617" y="449309"/>
                  <a:pt x="69850" y="457776"/>
                </a:cubicBezTo>
                <a:cubicBezTo>
                  <a:pt x="73263" y="464602"/>
                  <a:pt x="78317" y="470476"/>
                  <a:pt x="82550" y="476826"/>
                </a:cubicBezTo>
                <a:lnTo>
                  <a:pt x="95250" y="495876"/>
                </a:lnTo>
                <a:cubicBezTo>
                  <a:pt x="97106" y="498661"/>
                  <a:pt x="96800" y="502475"/>
                  <a:pt x="98425" y="505401"/>
                </a:cubicBezTo>
                <a:lnTo>
                  <a:pt x="117475" y="533976"/>
                </a:lnTo>
                <a:cubicBezTo>
                  <a:pt x="119331" y="536761"/>
                  <a:pt x="119025" y="540575"/>
                  <a:pt x="120650" y="543501"/>
                </a:cubicBezTo>
                <a:cubicBezTo>
                  <a:pt x="124356" y="550172"/>
                  <a:pt x="130937" y="555311"/>
                  <a:pt x="133350" y="562551"/>
                </a:cubicBezTo>
                <a:cubicBezTo>
                  <a:pt x="134408" y="565726"/>
                  <a:pt x="134900" y="569150"/>
                  <a:pt x="136525" y="572076"/>
                </a:cubicBezTo>
                <a:lnTo>
                  <a:pt x="155575" y="600651"/>
                </a:lnTo>
                <a:lnTo>
                  <a:pt x="161925" y="610176"/>
                </a:lnTo>
                <a:cubicBezTo>
                  <a:pt x="164042" y="613351"/>
                  <a:pt x="165577" y="617003"/>
                  <a:pt x="168275" y="619701"/>
                </a:cubicBezTo>
                <a:cubicBezTo>
                  <a:pt x="174625" y="626051"/>
                  <a:pt x="179853" y="633770"/>
                  <a:pt x="187325" y="638751"/>
                </a:cubicBezTo>
                <a:lnTo>
                  <a:pt x="206375" y="651451"/>
                </a:lnTo>
                <a:cubicBezTo>
                  <a:pt x="220110" y="672054"/>
                  <a:pt x="203345" y="651534"/>
                  <a:pt x="225425" y="664151"/>
                </a:cubicBezTo>
                <a:cubicBezTo>
                  <a:pt x="229324" y="666379"/>
                  <a:pt x="231501" y="670801"/>
                  <a:pt x="234950" y="673676"/>
                </a:cubicBezTo>
                <a:cubicBezTo>
                  <a:pt x="243156" y="680515"/>
                  <a:pt x="244454" y="680019"/>
                  <a:pt x="254000" y="683201"/>
                </a:cubicBezTo>
                <a:cubicBezTo>
                  <a:pt x="281297" y="701399"/>
                  <a:pt x="246760" y="679581"/>
                  <a:pt x="273050" y="692726"/>
                </a:cubicBezTo>
                <a:cubicBezTo>
                  <a:pt x="276463" y="694433"/>
                  <a:pt x="279088" y="697526"/>
                  <a:pt x="282575" y="699076"/>
                </a:cubicBezTo>
                <a:lnTo>
                  <a:pt x="311150" y="708601"/>
                </a:lnTo>
                <a:cubicBezTo>
                  <a:pt x="315290" y="709981"/>
                  <a:pt x="319670" y="710522"/>
                  <a:pt x="323850" y="711776"/>
                </a:cubicBezTo>
                <a:cubicBezTo>
                  <a:pt x="330261" y="713699"/>
                  <a:pt x="336550" y="716009"/>
                  <a:pt x="342900" y="718126"/>
                </a:cubicBezTo>
                <a:lnTo>
                  <a:pt x="381000" y="730826"/>
                </a:lnTo>
                <a:lnTo>
                  <a:pt x="390525" y="734001"/>
                </a:lnTo>
                <a:cubicBezTo>
                  <a:pt x="393700" y="735059"/>
                  <a:pt x="396803" y="736364"/>
                  <a:pt x="400050" y="737176"/>
                </a:cubicBezTo>
                <a:lnTo>
                  <a:pt x="412750" y="740351"/>
                </a:lnTo>
                <a:cubicBezTo>
                  <a:pt x="415925" y="742468"/>
                  <a:pt x="418788" y="745151"/>
                  <a:pt x="422275" y="746701"/>
                </a:cubicBezTo>
                <a:cubicBezTo>
                  <a:pt x="437884" y="753638"/>
                  <a:pt x="441663" y="752641"/>
                  <a:pt x="457200" y="756226"/>
                </a:cubicBezTo>
                <a:cubicBezTo>
                  <a:pt x="465704" y="758188"/>
                  <a:pt x="474133" y="760459"/>
                  <a:pt x="482600" y="762576"/>
                </a:cubicBezTo>
                <a:cubicBezTo>
                  <a:pt x="486833" y="763634"/>
                  <a:pt x="490970" y="765210"/>
                  <a:pt x="495300" y="765751"/>
                </a:cubicBezTo>
                <a:lnTo>
                  <a:pt x="546100" y="772101"/>
                </a:lnTo>
                <a:cubicBezTo>
                  <a:pt x="549275" y="773159"/>
                  <a:pt x="552378" y="774464"/>
                  <a:pt x="555625" y="775276"/>
                </a:cubicBezTo>
                <a:cubicBezTo>
                  <a:pt x="574371" y="779962"/>
                  <a:pt x="584737" y="779654"/>
                  <a:pt x="606425" y="781626"/>
                </a:cubicBezTo>
                <a:cubicBezTo>
                  <a:pt x="660729" y="778006"/>
                  <a:pt x="638956" y="783482"/>
                  <a:pt x="673100" y="772101"/>
                </a:cubicBezTo>
                <a:lnTo>
                  <a:pt x="692150" y="765751"/>
                </a:lnTo>
                <a:lnTo>
                  <a:pt x="701675" y="762576"/>
                </a:lnTo>
                <a:cubicBezTo>
                  <a:pt x="728972" y="744378"/>
                  <a:pt x="694435" y="766196"/>
                  <a:pt x="720725" y="753051"/>
                </a:cubicBezTo>
                <a:cubicBezTo>
                  <a:pt x="745344" y="740741"/>
                  <a:pt x="715834" y="751506"/>
                  <a:pt x="739775" y="743526"/>
                </a:cubicBezTo>
                <a:cubicBezTo>
                  <a:pt x="742950" y="741409"/>
                  <a:pt x="745813" y="738726"/>
                  <a:pt x="749300" y="737176"/>
                </a:cubicBezTo>
                <a:cubicBezTo>
                  <a:pt x="755417" y="734458"/>
                  <a:pt x="768350" y="730826"/>
                  <a:pt x="768350" y="730826"/>
                </a:cubicBezTo>
                <a:cubicBezTo>
                  <a:pt x="795647" y="712628"/>
                  <a:pt x="761110" y="734446"/>
                  <a:pt x="787400" y="721301"/>
                </a:cubicBezTo>
                <a:cubicBezTo>
                  <a:pt x="790813" y="719594"/>
                  <a:pt x="793418" y="716454"/>
                  <a:pt x="796925" y="714951"/>
                </a:cubicBezTo>
                <a:cubicBezTo>
                  <a:pt x="800936" y="713232"/>
                  <a:pt x="805445" y="713030"/>
                  <a:pt x="809625" y="711776"/>
                </a:cubicBezTo>
                <a:cubicBezTo>
                  <a:pt x="816036" y="709853"/>
                  <a:pt x="828675" y="705426"/>
                  <a:pt x="828675" y="705426"/>
                </a:cubicBezTo>
                <a:cubicBezTo>
                  <a:pt x="830792" y="702251"/>
                  <a:pt x="832045" y="698285"/>
                  <a:pt x="835025" y="695901"/>
                </a:cubicBezTo>
                <a:cubicBezTo>
                  <a:pt x="837638" y="693810"/>
                  <a:pt x="842183" y="695093"/>
                  <a:pt x="844550" y="692726"/>
                </a:cubicBezTo>
                <a:cubicBezTo>
                  <a:pt x="846917" y="690359"/>
                  <a:pt x="846228" y="686194"/>
                  <a:pt x="847725" y="683201"/>
                </a:cubicBezTo>
                <a:cubicBezTo>
                  <a:pt x="860035" y="658582"/>
                  <a:pt x="849270" y="688092"/>
                  <a:pt x="857250" y="664151"/>
                </a:cubicBezTo>
                <a:cubicBezTo>
                  <a:pt x="859628" y="647502"/>
                  <a:pt x="860663" y="639029"/>
                  <a:pt x="863600" y="622876"/>
                </a:cubicBezTo>
                <a:cubicBezTo>
                  <a:pt x="864565" y="617567"/>
                  <a:pt x="865355" y="612207"/>
                  <a:pt x="866775" y="607001"/>
                </a:cubicBezTo>
                <a:cubicBezTo>
                  <a:pt x="868536" y="600543"/>
                  <a:pt x="871008" y="594301"/>
                  <a:pt x="873125" y="587951"/>
                </a:cubicBezTo>
                <a:lnTo>
                  <a:pt x="876300" y="578426"/>
                </a:lnTo>
                <a:cubicBezTo>
                  <a:pt x="883826" y="510690"/>
                  <a:pt x="881711" y="541414"/>
                  <a:pt x="876300" y="419676"/>
                </a:cubicBezTo>
                <a:cubicBezTo>
                  <a:pt x="876054" y="414139"/>
                  <a:pt x="867522" y="390167"/>
                  <a:pt x="866775" y="387926"/>
                </a:cubicBezTo>
                <a:lnTo>
                  <a:pt x="863600" y="378401"/>
                </a:lnTo>
                <a:cubicBezTo>
                  <a:pt x="862542" y="375226"/>
                  <a:pt x="862281" y="371661"/>
                  <a:pt x="860425" y="368876"/>
                </a:cubicBezTo>
                <a:lnTo>
                  <a:pt x="847725" y="349826"/>
                </a:lnTo>
                <a:cubicBezTo>
                  <a:pt x="843492" y="343476"/>
                  <a:pt x="835025" y="341359"/>
                  <a:pt x="828675" y="337126"/>
                </a:cubicBezTo>
                <a:lnTo>
                  <a:pt x="809625" y="324426"/>
                </a:lnTo>
                <a:lnTo>
                  <a:pt x="800100" y="318076"/>
                </a:lnTo>
                <a:cubicBezTo>
                  <a:pt x="794531" y="314363"/>
                  <a:pt x="781050" y="311726"/>
                  <a:pt x="781050" y="311726"/>
                </a:cubicBezTo>
                <a:cubicBezTo>
                  <a:pt x="765956" y="301663"/>
                  <a:pt x="775145" y="306583"/>
                  <a:pt x="752475" y="299026"/>
                </a:cubicBezTo>
                <a:lnTo>
                  <a:pt x="742950" y="295851"/>
                </a:lnTo>
                <a:cubicBezTo>
                  <a:pt x="739775" y="294793"/>
                  <a:pt x="736672" y="293488"/>
                  <a:pt x="733425" y="292676"/>
                </a:cubicBezTo>
                <a:cubicBezTo>
                  <a:pt x="729192" y="291618"/>
                  <a:pt x="724905" y="290755"/>
                  <a:pt x="720725" y="289501"/>
                </a:cubicBezTo>
                <a:cubicBezTo>
                  <a:pt x="714314" y="287578"/>
                  <a:pt x="701675" y="283151"/>
                  <a:pt x="701675" y="283151"/>
                </a:cubicBezTo>
                <a:cubicBezTo>
                  <a:pt x="698500" y="281034"/>
                  <a:pt x="695563" y="278508"/>
                  <a:pt x="692150" y="276801"/>
                </a:cubicBezTo>
                <a:cubicBezTo>
                  <a:pt x="665860" y="263656"/>
                  <a:pt x="700397" y="285474"/>
                  <a:pt x="673100" y="267276"/>
                </a:cubicBezTo>
                <a:cubicBezTo>
                  <a:pt x="670983" y="264101"/>
                  <a:pt x="669925" y="259868"/>
                  <a:pt x="666750" y="257751"/>
                </a:cubicBezTo>
                <a:cubicBezTo>
                  <a:pt x="663119" y="255330"/>
                  <a:pt x="658246" y="255775"/>
                  <a:pt x="654050" y="254576"/>
                </a:cubicBezTo>
                <a:cubicBezTo>
                  <a:pt x="650832" y="253657"/>
                  <a:pt x="647700" y="252459"/>
                  <a:pt x="644525" y="251401"/>
                </a:cubicBezTo>
                <a:cubicBezTo>
                  <a:pt x="641350" y="249284"/>
                  <a:pt x="637698" y="247749"/>
                  <a:pt x="635000" y="245051"/>
                </a:cubicBezTo>
                <a:cubicBezTo>
                  <a:pt x="632302" y="242353"/>
                  <a:pt x="631886" y="237548"/>
                  <a:pt x="628650" y="235526"/>
                </a:cubicBezTo>
                <a:cubicBezTo>
                  <a:pt x="622974" y="231978"/>
                  <a:pt x="609600" y="229176"/>
                  <a:pt x="609600" y="229176"/>
                </a:cubicBezTo>
                <a:cubicBezTo>
                  <a:pt x="603807" y="220487"/>
                  <a:pt x="603751" y="217757"/>
                  <a:pt x="593725" y="213301"/>
                </a:cubicBezTo>
                <a:cubicBezTo>
                  <a:pt x="587608" y="210583"/>
                  <a:pt x="574675" y="206951"/>
                  <a:pt x="574675" y="206951"/>
                </a:cubicBezTo>
                <a:cubicBezTo>
                  <a:pt x="567653" y="199929"/>
                  <a:pt x="564466" y="195496"/>
                  <a:pt x="555625" y="191076"/>
                </a:cubicBezTo>
                <a:cubicBezTo>
                  <a:pt x="552632" y="189579"/>
                  <a:pt x="549275" y="188959"/>
                  <a:pt x="546100" y="187901"/>
                </a:cubicBezTo>
                <a:cubicBezTo>
                  <a:pt x="539750" y="181551"/>
                  <a:pt x="529890" y="177370"/>
                  <a:pt x="527050" y="168851"/>
                </a:cubicBezTo>
                <a:cubicBezTo>
                  <a:pt x="523741" y="158925"/>
                  <a:pt x="520533" y="146514"/>
                  <a:pt x="511175" y="140276"/>
                </a:cubicBezTo>
                <a:cubicBezTo>
                  <a:pt x="508000" y="138159"/>
                  <a:pt x="504581" y="136369"/>
                  <a:pt x="501650" y="133926"/>
                </a:cubicBezTo>
                <a:cubicBezTo>
                  <a:pt x="498201" y="131051"/>
                  <a:pt x="495669" y="127158"/>
                  <a:pt x="492125" y="124401"/>
                </a:cubicBezTo>
                <a:lnTo>
                  <a:pt x="463550" y="105351"/>
                </a:lnTo>
                <a:lnTo>
                  <a:pt x="454025" y="99001"/>
                </a:lnTo>
                <a:cubicBezTo>
                  <a:pt x="435827" y="71704"/>
                  <a:pt x="460058" y="103828"/>
                  <a:pt x="438150" y="86301"/>
                </a:cubicBezTo>
                <a:cubicBezTo>
                  <a:pt x="417634" y="69888"/>
                  <a:pt x="446216" y="81581"/>
                  <a:pt x="422275" y="73601"/>
                </a:cubicBezTo>
                <a:cubicBezTo>
                  <a:pt x="415253" y="66579"/>
                  <a:pt x="412066" y="62146"/>
                  <a:pt x="403225" y="57726"/>
                </a:cubicBezTo>
                <a:cubicBezTo>
                  <a:pt x="400232" y="56229"/>
                  <a:pt x="396875" y="55609"/>
                  <a:pt x="393700" y="54551"/>
                </a:cubicBezTo>
                <a:cubicBezTo>
                  <a:pt x="387350" y="50318"/>
                  <a:pt x="380046" y="47247"/>
                  <a:pt x="374650" y="41851"/>
                </a:cubicBezTo>
                <a:cubicBezTo>
                  <a:pt x="362758" y="29959"/>
                  <a:pt x="369385" y="33746"/>
                  <a:pt x="355600" y="29151"/>
                </a:cubicBezTo>
                <a:cubicBezTo>
                  <a:pt x="349250" y="24918"/>
                  <a:pt x="343790" y="18864"/>
                  <a:pt x="336550" y="16451"/>
                </a:cubicBezTo>
                <a:cubicBezTo>
                  <a:pt x="305452" y="6085"/>
                  <a:pt x="318558" y="2693"/>
                  <a:pt x="307975" y="576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4" name="フリーフォーム 33"/>
          <p:cNvSpPr/>
          <p:nvPr/>
        </p:nvSpPr>
        <p:spPr>
          <a:xfrm>
            <a:off x="8118475" y="2585324"/>
            <a:ext cx="723900" cy="535701"/>
          </a:xfrm>
          <a:custGeom>
            <a:avLst/>
            <a:gdLst>
              <a:gd name="connsiteX0" fmla="*/ 517525 w 723900"/>
              <a:gd name="connsiteY0" fmla="*/ 2301 h 535701"/>
              <a:gd name="connsiteX1" fmla="*/ 431800 w 723900"/>
              <a:gd name="connsiteY1" fmla="*/ 2301 h 535701"/>
              <a:gd name="connsiteX2" fmla="*/ 422275 w 723900"/>
              <a:gd name="connsiteY2" fmla="*/ 5476 h 535701"/>
              <a:gd name="connsiteX3" fmla="*/ 400050 w 723900"/>
              <a:gd name="connsiteY3" fmla="*/ 11826 h 535701"/>
              <a:gd name="connsiteX4" fmla="*/ 381000 w 723900"/>
              <a:gd name="connsiteY4" fmla="*/ 21351 h 535701"/>
              <a:gd name="connsiteX5" fmla="*/ 361950 w 723900"/>
              <a:gd name="connsiteY5" fmla="*/ 30876 h 535701"/>
              <a:gd name="connsiteX6" fmla="*/ 333375 w 723900"/>
              <a:gd name="connsiteY6" fmla="*/ 46751 h 535701"/>
              <a:gd name="connsiteX7" fmla="*/ 304800 w 723900"/>
              <a:gd name="connsiteY7" fmla="*/ 65801 h 535701"/>
              <a:gd name="connsiteX8" fmla="*/ 295275 w 723900"/>
              <a:gd name="connsiteY8" fmla="*/ 72151 h 535701"/>
              <a:gd name="connsiteX9" fmla="*/ 285750 w 723900"/>
              <a:gd name="connsiteY9" fmla="*/ 81676 h 535701"/>
              <a:gd name="connsiteX10" fmla="*/ 266700 w 723900"/>
              <a:gd name="connsiteY10" fmla="*/ 88026 h 535701"/>
              <a:gd name="connsiteX11" fmla="*/ 238125 w 723900"/>
              <a:gd name="connsiteY11" fmla="*/ 107076 h 535701"/>
              <a:gd name="connsiteX12" fmla="*/ 219075 w 723900"/>
              <a:gd name="connsiteY12" fmla="*/ 113426 h 535701"/>
              <a:gd name="connsiteX13" fmla="*/ 200025 w 723900"/>
              <a:gd name="connsiteY13" fmla="*/ 129301 h 535701"/>
              <a:gd name="connsiteX14" fmla="*/ 180975 w 723900"/>
              <a:gd name="connsiteY14" fmla="*/ 135651 h 535701"/>
              <a:gd name="connsiteX15" fmla="*/ 161925 w 723900"/>
              <a:gd name="connsiteY15" fmla="*/ 145176 h 535701"/>
              <a:gd name="connsiteX16" fmla="*/ 152400 w 723900"/>
              <a:gd name="connsiteY16" fmla="*/ 151526 h 535701"/>
              <a:gd name="connsiteX17" fmla="*/ 133350 w 723900"/>
              <a:gd name="connsiteY17" fmla="*/ 157876 h 535701"/>
              <a:gd name="connsiteX18" fmla="*/ 114300 w 723900"/>
              <a:gd name="connsiteY18" fmla="*/ 173751 h 535701"/>
              <a:gd name="connsiteX19" fmla="*/ 104775 w 723900"/>
              <a:gd name="connsiteY19" fmla="*/ 176926 h 535701"/>
              <a:gd name="connsiteX20" fmla="*/ 85725 w 723900"/>
              <a:gd name="connsiteY20" fmla="*/ 189626 h 535701"/>
              <a:gd name="connsiteX21" fmla="*/ 66675 w 723900"/>
              <a:gd name="connsiteY21" fmla="*/ 202326 h 535701"/>
              <a:gd name="connsiteX22" fmla="*/ 50800 w 723900"/>
              <a:gd name="connsiteY22" fmla="*/ 215026 h 535701"/>
              <a:gd name="connsiteX23" fmla="*/ 41275 w 723900"/>
              <a:gd name="connsiteY23" fmla="*/ 234076 h 535701"/>
              <a:gd name="connsiteX24" fmla="*/ 25400 w 723900"/>
              <a:gd name="connsiteY24" fmla="*/ 253126 h 535701"/>
              <a:gd name="connsiteX25" fmla="*/ 19050 w 723900"/>
              <a:gd name="connsiteY25" fmla="*/ 272176 h 535701"/>
              <a:gd name="connsiteX26" fmla="*/ 6350 w 723900"/>
              <a:gd name="connsiteY26" fmla="*/ 300751 h 535701"/>
              <a:gd name="connsiteX27" fmla="*/ 3175 w 723900"/>
              <a:gd name="connsiteY27" fmla="*/ 310276 h 535701"/>
              <a:gd name="connsiteX28" fmla="*/ 0 w 723900"/>
              <a:gd name="connsiteY28" fmla="*/ 319801 h 535701"/>
              <a:gd name="connsiteX29" fmla="*/ 3175 w 723900"/>
              <a:gd name="connsiteY29" fmla="*/ 405526 h 535701"/>
              <a:gd name="connsiteX30" fmla="*/ 9525 w 723900"/>
              <a:gd name="connsiteY30" fmla="*/ 424576 h 535701"/>
              <a:gd name="connsiteX31" fmla="*/ 15875 w 723900"/>
              <a:gd name="connsiteY31" fmla="*/ 434101 h 535701"/>
              <a:gd name="connsiteX32" fmla="*/ 31750 w 723900"/>
              <a:gd name="connsiteY32" fmla="*/ 462676 h 535701"/>
              <a:gd name="connsiteX33" fmla="*/ 41275 w 723900"/>
              <a:gd name="connsiteY33" fmla="*/ 465851 h 535701"/>
              <a:gd name="connsiteX34" fmla="*/ 47625 w 723900"/>
              <a:gd name="connsiteY34" fmla="*/ 475376 h 535701"/>
              <a:gd name="connsiteX35" fmla="*/ 57150 w 723900"/>
              <a:gd name="connsiteY35" fmla="*/ 478551 h 535701"/>
              <a:gd name="connsiteX36" fmla="*/ 82550 w 723900"/>
              <a:gd name="connsiteY36" fmla="*/ 488076 h 535701"/>
              <a:gd name="connsiteX37" fmla="*/ 101600 w 723900"/>
              <a:gd name="connsiteY37" fmla="*/ 494426 h 535701"/>
              <a:gd name="connsiteX38" fmla="*/ 139700 w 723900"/>
              <a:gd name="connsiteY38" fmla="*/ 507126 h 535701"/>
              <a:gd name="connsiteX39" fmla="*/ 158750 w 723900"/>
              <a:gd name="connsiteY39" fmla="*/ 510301 h 535701"/>
              <a:gd name="connsiteX40" fmla="*/ 171450 w 723900"/>
              <a:gd name="connsiteY40" fmla="*/ 513476 h 535701"/>
              <a:gd name="connsiteX41" fmla="*/ 180975 w 723900"/>
              <a:gd name="connsiteY41" fmla="*/ 519826 h 535701"/>
              <a:gd name="connsiteX42" fmla="*/ 200025 w 723900"/>
              <a:gd name="connsiteY42" fmla="*/ 526176 h 535701"/>
              <a:gd name="connsiteX43" fmla="*/ 260350 w 723900"/>
              <a:gd name="connsiteY43" fmla="*/ 532526 h 535701"/>
              <a:gd name="connsiteX44" fmla="*/ 298450 w 723900"/>
              <a:gd name="connsiteY44" fmla="*/ 535701 h 535701"/>
              <a:gd name="connsiteX45" fmla="*/ 381000 w 723900"/>
              <a:gd name="connsiteY45" fmla="*/ 532526 h 535701"/>
              <a:gd name="connsiteX46" fmla="*/ 415925 w 723900"/>
              <a:gd name="connsiteY46" fmla="*/ 529351 h 535701"/>
              <a:gd name="connsiteX47" fmla="*/ 434975 w 723900"/>
              <a:gd name="connsiteY47" fmla="*/ 523001 h 535701"/>
              <a:gd name="connsiteX48" fmla="*/ 444500 w 723900"/>
              <a:gd name="connsiteY48" fmla="*/ 513476 h 535701"/>
              <a:gd name="connsiteX49" fmla="*/ 454025 w 723900"/>
              <a:gd name="connsiteY49" fmla="*/ 510301 h 535701"/>
              <a:gd name="connsiteX50" fmla="*/ 473075 w 723900"/>
              <a:gd name="connsiteY50" fmla="*/ 497601 h 535701"/>
              <a:gd name="connsiteX51" fmla="*/ 492125 w 723900"/>
              <a:gd name="connsiteY51" fmla="*/ 484901 h 535701"/>
              <a:gd name="connsiteX52" fmla="*/ 501650 w 723900"/>
              <a:gd name="connsiteY52" fmla="*/ 478551 h 535701"/>
              <a:gd name="connsiteX53" fmla="*/ 508000 w 723900"/>
              <a:gd name="connsiteY53" fmla="*/ 469026 h 535701"/>
              <a:gd name="connsiteX54" fmla="*/ 517525 w 723900"/>
              <a:gd name="connsiteY54" fmla="*/ 465851 h 535701"/>
              <a:gd name="connsiteX55" fmla="*/ 527050 w 723900"/>
              <a:gd name="connsiteY55" fmla="*/ 459501 h 535701"/>
              <a:gd name="connsiteX56" fmla="*/ 536575 w 723900"/>
              <a:gd name="connsiteY56" fmla="*/ 449976 h 535701"/>
              <a:gd name="connsiteX57" fmla="*/ 546100 w 723900"/>
              <a:gd name="connsiteY57" fmla="*/ 446801 h 535701"/>
              <a:gd name="connsiteX58" fmla="*/ 574675 w 723900"/>
              <a:gd name="connsiteY58" fmla="*/ 424576 h 535701"/>
              <a:gd name="connsiteX59" fmla="*/ 603250 w 723900"/>
              <a:gd name="connsiteY59" fmla="*/ 405526 h 535701"/>
              <a:gd name="connsiteX60" fmla="*/ 612775 w 723900"/>
              <a:gd name="connsiteY60" fmla="*/ 402351 h 535701"/>
              <a:gd name="connsiteX61" fmla="*/ 619125 w 723900"/>
              <a:gd name="connsiteY61" fmla="*/ 392826 h 535701"/>
              <a:gd name="connsiteX62" fmla="*/ 628650 w 723900"/>
              <a:gd name="connsiteY62" fmla="*/ 389651 h 535701"/>
              <a:gd name="connsiteX63" fmla="*/ 638175 w 723900"/>
              <a:gd name="connsiteY63" fmla="*/ 380126 h 535701"/>
              <a:gd name="connsiteX64" fmla="*/ 647700 w 723900"/>
              <a:gd name="connsiteY64" fmla="*/ 361076 h 535701"/>
              <a:gd name="connsiteX65" fmla="*/ 657225 w 723900"/>
              <a:gd name="connsiteY65" fmla="*/ 354726 h 535701"/>
              <a:gd name="connsiteX66" fmla="*/ 663575 w 723900"/>
              <a:gd name="connsiteY66" fmla="*/ 335676 h 535701"/>
              <a:gd name="connsiteX67" fmla="*/ 673100 w 723900"/>
              <a:gd name="connsiteY67" fmla="*/ 326151 h 535701"/>
              <a:gd name="connsiteX68" fmla="*/ 685800 w 723900"/>
              <a:gd name="connsiteY68" fmla="*/ 307101 h 535701"/>
              <a:gd name="connsiteX69" fmla="*/ 688975 w 723900"/>
              <a:gd name="connsiteY69" fmla="*/ 297576 h 535701"/>
              <a:gd name="connsiteX70" fmla="*/ 701675 w 723900"/>
              <a:gd name="connsiteY70" fmla="*/ 278526 h 535701"/>
              <a:gd name="connsiteX71" fmla="*/ 708025 w 723900"/>
              <a:gd name="connsiteY71" fmla="*/ 259476 h 535701"/>
              <a:gd name="connsiteX72" fmla="*/ 717550 w 723900"/>
              <a:gd name="connsiteY72" fmla="*/ 240426 h 535701"/>
              <a:gd name="connsiteX73" fmla="*/ 723900 w 723900"/>
              <a:gd name="connsiteY73" fmla="*/ 183276 h 535701"/>
              <a:gd name="connsiteX74" fmla="*/ 720725 w 723900"/>
              <a:gd name="connsiteY74" fmla="*/ 113426 h 535701"/>
              <a:gd name="connsiteX75" fmla="*/ 711200 w 723900"/>
              <a:gd name="connsiteY75" fmla="*/ 94376 h 535701"/>
              <a:gd name="connsiteX76" fmla="*/ 701675 w 723900"/>
              <a:gd name="connsiteY76" fmla="*/ 88026 h 535701"/>
              <a:gd name="connsiteX77" fmla="*/ 692150 w 723900"/>
              <a:gd name="connsiteY77" fmla="*/ 78501 h 535701"/>
              <a:gd name="connsiteX78" fmla="*/ 673100 w 723900"/>
              <a:gd name="connsiteY78" fmla="*/ 68976 h 535701"/>
              <a:gd name="connsiteX79" fmla="*/ 654050 w 723900"/>
              <a:gd name="connsiteY79" fmla="*/ 56276 h 535701"/>
              <a:gd name="connsiteX80" fmla="*/ 644525 w 723900"/>
              <a:gd name="connsiteY80" fmla="*/ 49926 h 535701"/>
              <a:gd name="connsiteX81" fmla="*/ 635000 w 723900"/>
              <a:gd name="connsiteY81" fmla="*/ 46751 h 535701"/>
              <a:gd name="connsiteX82" fmla="*/ 625475 w 723900"/>
              <a:gd name="connsiteY82" fmla="*/ 40401 h 535701"/>
              <a:gd name="connsiteX83" fmla="*/ 612775 w 723900"/>
              <a:gd name="connsiteY83" fmla="*/ 27701 h 535701"/>
              <a:gd name="connsiteX84" fmla="*/ 584200 w 723900"/>
              <a:gd name="connsiteY84" fmla="*/ 8651 h 535701"/>
              <a:gd name="connsiteX85" fmla="*/ 574675 w 723900"/>
              <a:gd name="connsiteY85" fmla="*/ 5476 h 535701"/>
              <a:gd name="connsiteX86" fmla="*/ 561975 w 723900"/>
              <a:gd name="connsiteY86" fmla="*/ 2301 h 535701"/>
              <a:gd name="connsiteX87" fmla="*/ 517525 w 723900"/>
              <a:gd name="connsiteY87" fmla="*/ 2301 h 53570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</a:cxnLst>
            <a:rect l="l" t="t" r="r" b="b"/>
            <a:pathLst>
              <a:path w="723900" h="535701">
                <a:moveTo>
                  <a:pt x="517525" y="2301"/>
                </a:moveTo>
                <a:cubicBezTo>
                  <a:pt x="495829" y="2301"/>
                  <a:pt x="491361" y="-2878"/>
                  <a:pt x="431800" y="2301"/>
                </a:cubicBezTo>
                <a:cubicBezTo>
                  <a:pt x="428466" y="2591"/>
                  <a:pt x="425493" y="4557"/>
                  <a:pt x="422275" y="5476"/>
                </a:cubicBezTo>
                <a:cubicBezTo>
                  <a:pt x="394368" y="13449"/>
                  <a:pt x="422888" y="4213"/>
                  <a:pt x="400050" y="11826"/>
                </a:cubicBezTo>
                <a:cubicBezTo>
                  <a:pt x="372753" y="30024"/>
                  <a:pt x="407290" y="8206"/>
                  <a:pt x="381000" y="21351"/>
                </a:cubicBezTo>
                <a:cubicBezTo>
                  <a:pt x="356381" y="33661"/>
                  <a:pt x="385891" y="22896"/>
                  <a:pt x="361950" y="30876"/>
                </a:cubicBezTo>
                <a:cubicBezTo>
                  <a:pt x="340115" y="45432"/>
                  <a:pt x="350140" y="41163"/>
                  <a:pt x="333375" y="46751"/>
                </a:cubicBezTo>
                <a:lnTo>
                  <a:pt x="304800" y="65801"/>
                </a:lnTo>
                <a:cubicBezTo>
                  <a:pt x="301625" y="67918"/>
                  <a:pt x="297973" y="69453"/>
                  <a:pt x="295275" y="72151"/>
                </a:cubicBezTo>
                <a:cubicBezTo>
                  <a:pt x="292100" y="75326"/>
                  <a:pt x="289675" y="79495"/>
                  <a:pt x="285750" y="81676"/>
                </a:cubicBezTo>
                <a:cubicBezTo>
                  <a:pt x="279899" y="84927"/>
                  <a:pt x="266700" y="88026"/>
                  <a:pt x="266700" y="88026"/>
                </a:cubicBezTo>
                <a:lnTo>
                  <a:pt x="238125" y="107076"/>
                </a:lnTo>
                <a:cubicBezTo>
                  <a:pt x="232556" y="110789"/>
                  <a:pt x="219075" y="113426"/>
                  <a:pt x="219075" y="113426"/>
                </a:cubicBezTo>
                <a:cubicBezTo>
                  <a:pt x="213093" y="119408"/>
                  <a:pt x="207982" y="125765"/>
                  <a:pt x="200025" y="129301"/>
                </a:cubicBezTo>
                <a:cubicBezTo>
                  <a:pt x="193908" y="132019"/>
                  <a:pt x="180975" y="135651"/>
                  <a:pt x="180975" y="135651"/>
                </a:cubicBezTo>
                <a:cubicBezTo>
                  <a:pt x="153678" y="153849"/>
                  <a:pt x="188215" y="132031"/>
                  <a:pt x="161925" y="145176"/>
                </a:cubicBezTo>
                <a:cubicBezTo>
                  <a:pt x="158512" y="146883"/>
                  <a:pt x="155887" y="149976"/>
                  <a:pt x="152400" y="151526"/>
                </a:cubicBezTo>
                <a:cubicBezTo>
                  <a:pt x="146283" y="154244"/>
                  <a:pt x="133350" y="157876"/>
                  <a:pt x="133350" y="157876"/>
                </a:cubicBezTo>
                <a:cubicBezTo>
                  <a:pt x="126328" y="164898"/>
                  <a:pt x="123141" y="169331"/>
                  <a:pt x="114300" y="173751"/>
                </a:cubicBezTo>
                <a:cubicBezTo>
                  <a:pt x="111307" y="175248"/>
                  <a:pt x="107950" y="175868"/>
                  <a:pt x="104775" y="176926"/>
                </a:cubicBezTo>
                <a:lnTo>
                  <a:pt x="85725" y="189626"/>
                </a:lnTo>
                <a:cubicBezTo>
                  <a:pt x="61942" y="205481"/>
                  <a:pt x="89323" y="194777"/>
                  <a:pt x="66675" y="202326"/>
                </a:cubicBezTo>
                <a:cubicBezTo>
                  <a:pt x="48477" y="229623"/>
                  <a:pt x="72708" y="197499"/>
                  <a:pt x="50800" y="215026"/>
                </a:cubicBezTo>
                <a:cubicBezTo>
                  <a:pt x="40095" y="223590"/>
                  <a:pt x="47848" y="224216"/>
                  <a:pt x="41275" y="234076"/>
                </a:cubicBezTo>
                <a:cubicBezTo>
                  <a:pt x="31306" y="249030"/>
                  <a:pt x="32325" y="237544"/>
                  <a:pt x="25400" y="253126"/>
                </a:cubicBezTo>
                <a:cubicBezTo>
                  <a:pt x="22682" y="259243"/>
                  <a:pt x="22763" y="266607"/>
                  <a:pt x="19050" y="272176"/>
                </a:cubicBezTo>
                <a:cubicBezTo>
                  <a:pt x="8987" y="287270"/>
                  <a:pt x="13907" y="278081"/>
                  <a:pt x="6350" y="300751"/>
                </a:cubicBezTo>
                <a:lnTo>
                  <a:pt x="3175" y="310276"/>
                </a:lnTo>
                <a:lnTo>
                  <a:pt x="0" y="319801"/>
                </a:lnTo>
                <a:cubicBezTo>
                  <a:pt x="1058" y="348376"/>
                  <a:pt x="586" y="377049"/>
                  <a:pt x="3175" y="405526"/>
                </a:cubicBezTo>
                <a:cubicBezTo>
                  <a:pt x="3781" y="412192"/>
                  <a:pt x="5812" y="419007"/>
                  <a:pt x="9525" y="424576"/>
                </a:cubicBezTo>
                <a:cubicBezTo>
                  <a:pt x="11642" y="427751"/>
                  <a:pt x="14168" y="430688"/>
                  <a:pt x="15875" y="434101"/>
                </a:cubicBezTo>
                <a:cubicBezTo>
                  <a:pt x="20348" y="443047"/>
                  <a:pt x="19737" y="458672"/>
                  <a:pt x="31750" y="462676"/>
                </a:cubicBezTo>
                <a:lnTo>
                  <a:pt x="41275" y="465851"/>
                </a:lnTo>
                <a:cubicBezTo>
                  <a:pt x="43392" y="469026"/>
                  <a:pt x="44645" y="472992"/>
                  <a:pt x="47625" y="475376"/>
                </a:cubicBezTo>
                <a:cubicBezTo>
                  <a:pt x="50238" y="477467"/>
                  <a:pt x="54157" y="477054"/>
                  <a:pt x="57150" y="478551"/>
                </a:cubicBezTo>
                <a:cubicBezTo>
                  <a:pt x="85882" y="492917"/>
                  <a:pt x="42121" y="477050"/>
                  <a:pt x="82550" y="488076"/>
                </a:cubicBezTo>
                <a:cubicBezTo>
                  <a:pt x="89008" y="489837"/>
                  <a:pt x="95250" y="492309"/>
                  <a:pt x="101600" y="494426"/>
                </a:cubicBezTo>
                <a:lnTo>
                  <a:pt x="139700" y="507126"/>
                </a:lnTo>
                <a:cubicBezTo>
                  <a:pt x="145807" y="509162"/>
                  <a:pt x="152437" y="509038"/>
                  <a:pt x="158750" y="510301"/>
                </a:cubicBezTo>
                <a:cubicBezTo>
                  <a:pt x="163029" y="511157"/>
                  <a:pt x="167217" y="512418"/>
                  <a:pt x="171450" y="513476"/>
                </a:cubicBezTo>
                <a:cubicBezTo>
                  <a:pt x="174625" y="515593"/>
                  <a:pt x="177488" y="518276"/>
                  <a:pt x="180975" y="519826"/>
                </a:cubicBezTo>
                <a:cubicBezTo>
                  <a:pt x="187092" y="522544"/>
                  <a:pt x="193675" y="524059"/>
                  <a:pt x="200025" y="526176"/>
                </a:cubicBezTo>
                <a:cubicBezTo>
                  <a:pt x="226010" y="534838"/>
                  <a:pt x="204364" y="528527"/>
                  <a:pt x="260350" y="532526"/>
                </a:cubicBezTo>
                <a:cubicBezTo>
                  <a:pt x="273062" y="533434"/>
                  <a:pt x="285750" y="534643"/>
                  <a:pt x="298450" y="535701"/>
                </a:cubicBezTo>
                <a:lnTo>
                  <a:pt x="381000" y="532526"/>
                </a:lnTo>
                <a:cubicBezTo>
                  <a:pt x="392673" y="531895"/>
                  <a:pt x="404413" y="531382"/>
                  <a:pt x="415925" y="529351"/>
                </a:cubicBezTo>
                <a:cubicBezTo>
                  <a:pt x="422517" y="528188"/>
                  <a:pt x="434975" y="523001"/>
                  <a:pt x="434975" y="523001"/>
                </a:cubicBezTo>
                <a:cubicBezTo>
                  <a:pt x="438150" y="519826"/>
                  <a:pt x="440764" y="515967"/>
                  <a:pt x="444500" y="513476"/>
                </a:cubicBezTo>
                <a:cubicBezTo>
                  <a:pt x="447285" y="511620"/>
                  <a:pt x="451099" y="511926"/>
                  <a:pt x="454025" y="510301"/>
                </a:cubicBezTo>
                <a:cubicBezTo>
                  <a:pt x="460696" y="506595"/>
                  <a:pt x="467679" y="502997"/>
                  <a:pt x="473075" y="497601"/>
                </a:cubicBezTo>
                <a:cubicBezTo>
                  <a:pt x="484967" y="485709"/>
                  <a:pt x="478340" y="489496"/>
                  <a:pt x="492125" y="484901"/>
                </a:cubicBezTo>
                <a:cubicBezTo>
                  <a:pt x="495300" y="482784"/>
                  <a:pt x="498952" y="481249"/>
                  <a:pt x="501650" y="478551"/>
                </a:cubicBezTo>
                <a:cubicBezTo>
                  <a:pt x="504348" y="475853"/>
                  <a:pt x="505020" y="471410"/>
                  <a:pt x="508000" y="469026"/>
                </a:cubicBezTo>
                <a:cubicBezTo>
                  <a:pt x="510613" y="466935"/>
                  <a:pt x="514350" y="466909"/>
                  <a:pt x="517525" y="465851"/>
                </a:cubicBezTo>
                <a:cubicBezTo>
                  <a:pt x="520700" y="463734"/>
                  <a:pt x="524119" y="461944"/>
                  <a:pt x="527050" y="459501"/>
                </a:cubicBezTo>
                <a:cubicBezTo>
                  <a:pt x="530499" y="456626"/>
                  <a:pt x="532839" y="452467"/>
                  <a:pt x="536575" y="449976"/>
                </a:cubicBezTo>
                <a:cubicBezTo>
                  <a:pt x="539360" y="448120"/>
                  <a:pt x="542925" y="447859"/>
                  <a:pt x="546100" y="446801"/>
                </a:cubicBezTo>
                <a:cubicBezTo>
                  <a:pt x="567517" y="425384"/>
                  <a:pt x="556631" y="430591"/>
                  <a:pt x="574675" y="424576"/>
                </a:cubicBezTo>
                <a:lnTo>
                  <a:pt x="603250" y="405526"/>
                </a:lnTo>
                <a:cubicBezTo>
                  <a:pt x="606035" y="403670"/>
                  <a:pt x="609600" y="403409"/>
                  <a:pt x="612775" y="402351"/>
                </a:cubicBezTo>
                <a:cubicBezTo>
                  <a:pt x="614892" y="399176"/>
                  <a:pt x="616145" y="395210"/>
                  <a:pt x="619125" y="392826"/>
                </a:cubicBezTo>
                <a:cubicBezTo>
                  <a:pt x="621738" y="390735"/>
                  <a:pt x="625865" y="391507"/>
                  <a:pt x="628650" y="389651"/>
                </a:cubicBezTo>
                <a:cubicBezTo>
                  <a:pt x="632386" y="387160"/>
                  <a:pt x="635000" y="383301"/>
                  <a:pt x="638175" y="380126"/>
                </a:cubicBezTo>
                <a:cubicBezTo>
                  <a:pt x="640757" y="372379"/>
                  <a:pt x="641545" y="367231"/>
                  <a:pt x="647700" y="361076"/>
                </a:cubicBezTo>
                <a:cubicBezTo>
                  <a:pt x="650398" y="358378"/>
                  <a:pt x="654050" y="356843"/>
                  <a:pt x="657225" y="354726"/>
                </a:cubicBezTo>
                <a:lnTo>
                  <a:pt x="663575" y="335676"/>
                </a:lnTo>
                <a:cubicBezTo>
                  <a:pt x="664995" y="331416"/>
                  <a:pt x="670343" y="329695"/>
                  <a:pt x="673100" y="326151"/>
                </a:cubicBezTo>
                <a:cubicBezTo>
                  <a:pt x="677785" y="320127"/>
                  <a:pt x="683387" y="314341"/>
                  <a:pt x="685800" y="307101"/>
                </a:cubicBezTo>
                <a:cubicBezTo>
                  <a:pt x="686858" y="303926"/>
                  <a:pt x="687350" y="300502"/>
                  <a:pt x="688975" y="297576"/>
                </a:cubicBezTo>
                <a:cubicBezTo>
                  <a:pt x="692681" y="290905"/>
                  <a:pt x="699262" y="285766"/>
                  <a:pt x="701675" y="278526"/>
                </a:cubicBezTo>
                <a:cubicBezTo>
                  <a:pt x="703792" y="272176"/>
                  <a:pt x="704312" y="265045"/>
                  <a:pt x="708025" y="259476"/>
                </a:cubicBezTo>
                <a:cubicBezTo>
                  <a:pt x="716231" y="247166"/>
                  <a:pt x="713168" y="253571"/>
                  <a:pt x="717550" y="240426"/>
                </a:cubicBezTo>
                <a:cubicBezTo>
                  <a:pt x="718816" y="230297"/>
                  <a:pt x="723900" y="191324"/>
                  <a:pt x="723900" y="183276"/>
                </a:cubicBezTo>
                <a:cubicBezTo>
                  <a:pt x="723900" y="159969"/>
                  <a:pt x="722584" y="136659"/>
                  <a:pt x="720725" y="113426"/>
                </a:cubicBezTo>
                <a:cubicBezTo>
                  <a:pt x="720276" y="107812"/>
                  <a:pt x="714923" y="98099"/>
                  <a:pt x="711200" y="94376"/>
                </a:cubicBezTo>
                <a:cubicBezTo>
                  <a:pt x="708502" y="91678"/>
                  <a:pt x="704606" y="90469"/>
                  <a:pt x="701675" y="88026"/>
                </a:cubicBezTo>
                <a:cubicBezTo>
                  <a:pt x="698226" y="85151"/>
                  <a:pt x="695599" y="81376"/>
                  <a:pt x="692150" y="78501"/>
                </a:cubicBezTo>
                <a:cubicBezTo>
                  <a:pt x="683944" y="71662"/>
                  <a:pt x="682646" y="72158"/>
                  <a:pt x="673100" y="68976"/>
                </a:cubicBezTo>
                <a:lnTo>
                  <a:pt x="654050" y="56276"/>
                </a:lnTo>
                <a:cubicBezTo>
                  <a:pt x="650875" y="54159"/>
                  <a:pt x="648145" y="51133"/>
                  <a:pt x="644525" y="49926"/>
                </a:cubicBezTo>
                <a:lnTo>
                  <a:pt x="635000" y="46751"/>
                </a:lnTo>
                <a:cubicBezTo>
                  <a:pt x="631825" y="44634"/>
                  <a:pt x="627859" y="43381"/>
                  <a:pt x="625475" y="40401"/>
                </a:cubicBezTo>
                <a:cubicBezTo>
                  <a:pt x="613160" y="25007"/>
                  <a:pt x="633557" y="34628"/>
                  <a:pt x="612775" y="27701"/>
                </a:cubicBezTo>
                <a:lnTo>
                  <a:pt x="584200" y="8651"/>
                </a:lnTo>
                <a:cubicBezTo>
                  <a:pt x="581415" y="6795"/>
                  <a:pt x="577893" y="6395"/>
                  <a:pt x="574675" y="5476"/>
                </a:cubicBezTo>
                <a:cubicBezTo>
                  <a:pt x="570479" y="4277"/>
                  <a:pt x="566337" y="2433"/>
                  <a:pt x="561975" y="2301"/>
                </a:cubicBezTo>
                <a:cubicBezTo>
                  <a:pt x="531297" y="1371"/>
                  <a:pt x="539221" y="2301"/>
                  <a:pt x="517525" y="2301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67" name="フリーフォーム 166"/>
          <p:cNvSpPr/>
          <p:nvPr/>
        </p:nvSpPr>
        <p:spPr>
          <a:xfrm>
            <a:off x="6754465" y="2596654"/>
            <a:ext cx="723900" cy="535701"/>
          </a:xfrm>
          <a:custGeom>
            <a:avLst/>
            <a:gdLst>
              <a:gd name="connsiteX0" fmla="*/ 517525 w 723900"/>
              <a:gd name="connsiteY0" fmla="*/ 2301 h 535701"/>
              <a:gd name="connsiteX1" fmla="*/ 431800 w 723900"/>
              <a:gd name="connsiteY1" fmla="*/ 2301 h 535701"/>
              <a:gd name="connsiteX2" fmla="*/ 422275 w 723900"/>
              <a:gd name="connsiteY2" fmla="*/ 5476 h 535701"/>
              <a:gd name="connsiteX3" fmla="*/ 400050 w 723900"/>
              <a:gd name="connsiteY3" fmla="*/ 11826 h 535701"/>
              <a:gd name="connsiteX4" fmla="*/ 381000 w 723900"/>
              <a:gd name="connsiteY4" fmla="*/ 21351 h 535701"/>
              <a:gd name="connsiteX5" fmla="*/ 361950 w 723900"/>
              <a:gd name="connsiteY5" fmla="*/ 30876 h 535701"/>
              <a:gd name="connsiteX6" fmla="*/ 333375 w 723900"/>
              <a:gd name="connsiteY6" fmla="*/ 46751 h 535701"/>
              <a:gd name="connsiteX7" fmla="*/ 304800 w 723900"/>
              <a:gd name="connsiteY7" fmla="*/ 65801 h 535701"/>
              <a:gd name="connsiteX8" fmla="*/ 295275 w 723900"/>
              <a:gd name="connsiteY8" fmla="*/ 72151 h 535701"/>
              <a:gd name="connsiteX9" fmla="*/ 285750 w 723900"/>
              <a:gd name="connsiteY9" fmla="*/ 81676 h 535701"/>
              <a:gd name="connsiteX10" fmla="*/ 266700 w 723900"/>
              <a:gd name="connsiteY10" fmla="*/ 88026 h 535701"/>
              <a:gd name="connsiteX11" fmla="*/ 238125 w 723900"/>
              <a:gd name="connsiteY11" fmla="*/ 107076 h 535701"/>
              <a:gd name="connsiteX12" fmla="*/ 219075 w 723900"/>
              <a:gd name="connsiteY12" fmla="*/ 113426 h 535701"/>
              <a:gd name="connsiteX13" fmla="*/ 200025 w 723900"/>
              <a:gd name="connsiteY13" fmla="*/ 129301 h 535701"/>
              <a:gd name="connsiteX14" fmla="*/ 180975 w 723900"/>
              <a:gd name="connsiteY14" fmla="*/ 135651 h 535701"/>
              <a:gd name="connsiteX15" fmla="*/ 161925 w 723900"/>
              <a:gd name="connsiteY15" fmla="*/ 145176 h 535701"/>
              <a:gd name="connsiteX16" fmla="*/ 152400 w 723900"/>
              <a:gd name="connsiteY16" fmla="*/ 151526 h 535701"/>
              <a:gd name="connsiteX17" fmla="*/ 133350 w 723900"/>
              <a:gd name="connsiteY17" fmla="*/ 157876 h 535701"/>
              <a:gd name="connsiteX18" fmla="*/ 114300 w 723900"/>
              <a:gd name="connsiteY18" fmla="*/ 173751 h 535701"/>
              <a:gd name="connsiteX19" fmla="*/ 104775 w 723900"/>
              <a:gd name="connsiteY19" fmla="*/ 176926 h 535701"/>
              <a:gd name="connsiteX20" fmla="*/ 85725 w 723900"/>
              <a:gd name="connsiteY20" fmla="*/ 189626 h 535701"/>
              <a:gd name="connsiteX21" fmla="*/ 66675 w 723900"/>
              <a:gd name="connsiteY21" fmla="*/ 202326 h 535701"/>
              <a:gd name="connsiteX22" fmla="*/ 50800 w 723900"/>
              <a:gd name="connsiteY22" fmla="*/ 215026 h 535701"/>
              <a:gd name="connsiteX23" fmla="*/ 41275 w 723900"/>
              <a:gd name="connsiteY23" fmla="*/ 234076 h 535701"/>
              <a:gd name="connsiteX24" fmla="*/ 25400 w 723900"/>
              <a:gd name="connsiteY24" fmla="*/ 253126 h 535701"/>
              <a:gd name="connsiteX25" fmla="*/ 19050 w 723900"/>
              <a:gd name="connsiteY25" fmla="*/ 272176 h 535701"/>
              <a:gd name="connsiteX26" fmla="*/ 6350 w 723900"/>
              <a:gd name="connsiteY26" fmla="*/ 300751 h 535701"/>
              <a:gd name="connsiteX27" fmla="*/ 3175 w 723900"/>
              <a:gd name="connsiteY27" fmla="*/ 310276 h 535701"/>
              <a:gd name="connsiteX28" fmla="*/ 0 w 723900"/>
              <a:gd name="connsiteY28" fmla="*/ 319801 h 535701"/>
              <a:gd name="connsiteX29" fmla="*/ 3175 w 723900"/>
              <a:gd name="connsiteY29" fmla="*/ 405526 h 535701"/>
              <a:gd name="connsiteX30" fmla="*/ 9525 w 723900"/>
              <a:gd name="connsiteY30" fmla="*/ 424576 h 535701"/>
              <a:gd name="connsiteX31" fmla="*/ 15875 w 723900"/>
              <a:gd name="connsiteY31" fmla="*/ 434101 h 535701"/>
              <a:gd name="connsiteX32" fmla="*/ 31750 w 723900"/>
              <a:gd name="connsiteY32" fmla="*/ 462676 h 535701"/>
              <a:gd name="connsiteX33" fmla="*/ 41275 w 723900"/>
              <a:gd name="connsiteY33" fmla="*/ 465851 h 535701"/>
              <a:gd name="connsiteX34" fmla="*/ 47625 w 723900"/>
              <a:gd name="connsiteY34" fmla="*/ 475376 h 535701"/>
              <a:gd name="connsiteX35" fmla="*/ 57150 w 723900"/>
              <a:gd name="connsiteY35" fmla="*/ 478551 h 535701"/>
              <a:gd name="connsiteX36" fmla="*/ 82550 w 723900"/>
              <a:gd name="connsiteY36" fmla="*/ 488076 h 535701"/>
              <a:gd name="connsiteX37" fmla="*/ 101600 w 723900"/>
              <a:gd name="connsiteY37" fmla="*/ 494426 h 535701"/>
              <a:gd name="connsiteX38" fmla="*/ 139700 w 723900"/>
              <a:gd name="connsiteY38" fmla="*/ 507126 h 535701"/>
              <a:gd name="connsiteX39" fmla="*/ 158750 w 723900"/>
              <a:gd name="connsiteY39" fmla="*/ 510301 h 535701"/>
              <a:gd name="connsiteX40" fmla="*/ 171450 w 723900"/>
              <a:gd name="connsiteY40" fmla="*/ 513476 h 535701"/>
              <a:gd name="connsiteX41" fmla="*/ 180975 w 723900"/>
              <a:gd name="connsiteY41" fmla="*/ 519826 h 535701"/>
              <a:gd name="connsiteX42" fmla="*/ 200025 w 723900"/>
              <a:gd name="connsiteY42" fmla="*/ 526176 h 535701"/>
              <a:gd name="connsiteX43" fmla="*/ 260350 w 723900"/>
              <a:gd name="connsiteY43" fmla="*/ 532526 h 535701"/>
              <a:gd name="connsiteX44" fmla="*/ 298450 w 723900"/>
              <a:gd name="connsiteY44" fmla="*/ 535701 h 535701"/>
              <a:gd name="connsiteX45" fmla="*/ 381000 w 723900"/>
              <a:gd name="connsiteY45" fmla="*/ 532526 h 535701"/>
              <a:gd name="connsiteX46" fmla="*/ 415925 w 723900"/>
              <a:gd name="connsiteY46" fmla="*/ 529351 h 535701"/>
              <a:gd name="connsiteX47" fmla="*/ 434975 w 723900"/>
              <a:gd name="connsiteY47" fmla="*/ 523001 h 535701"/>
              <a:gd name="connsiteX48" fmla="*/ 444500 w 723900"/>
              <a:gd name="connsiteY48" fmla="*/ 513476 h 535701"/>
              <a:gd name="connsiteX49" fmla="*/ 454025 w 723900"/>
              <a:gd name="connsiteY49" fmla="*/ 510301 h 535701"/>
              <a:gd name="connsiteX50" fmla="*/ 473075 w 723900"/>
              <a:gd name="connsiteY50" fmla="*/ 497601 h 535701"/>
              <a:gd name="connsiteX51" fmla="*/ 492125 w 723900"/>
              <a:gd name="connsiteY51" fmla="*/ 484901 h 535701"/>
              <a:gd name="connsiteX52" fmla="*/ 501650 w 723900"/>
              <a:gd name="connsiteY52" fmla="*/ 478551 h 535701"/>
              <a:gd name="connsiteX53" fmla="*/ 508000 w 723900"/>
              <a:gd name="connsiteY53" fmla="*/ 469026 h 535701"/>
              <a:gd name="connsiteX54" fmla="*/ 517525 w 723900"/>
              <a:gd name="connsiteY54" fmla="*/ 465851 h 535701"/>
              <a:gd name="connsiteX55" fmla="*/ 527050 w 723900"/>
              <a:gd name="connsiteY55" fmla="*/ 459501 h 535701"/>
              <a:gd name="connsiteX56" fmla="*/ 536575 w 723900"/>
              <a:gd name="connsiteY56" fmla="*/ 449976 h 535701"/>
              <a:gd name="connsiteX57" fmla="*/ 546100 w 723900"/>
              <a:gd name="connsiteY57" fmla="*/ 446801 h 535701"/>
              <a:gd name="connsiteX58" fmla="*/ 574675 w 723900"/>
              <a:gd name="connsiteY58" fmla="*/ 424576 h 535701"/>
              <a:gd name="connsiteX59" fmla="*/ 603250 w 723900"/>
              <a:gd name="connsiteY59" fmla="*/ 405526 h 535701"/>
              <a:gd name="connsiteX60" fmla="*/ 612775 w 723900"/>
              <a:gd name="connsiteY60" fmla="*/ 402351 h 535701"/>
              <a:gd name="connsiteX61" fmla="*/ 619125 w 723900"/>
              <a:gd name="connsiteY61" fmla="*/ 392826 h 535701"/>
              <a:gd name="connsiteX62" fmla="*/ 628650 w 723900"/>
              <a:gd name="connsiteY62" fmla="*/ 389651 h 535701"/>
              <a:gd name="connsiteX63" fmla="*/ 638175 w 723900"/>
              <a:gd name="connsiteY63" fmla="*/ 380126 h 535701"/>
              <a:gd name="connsiteX64" fmla="*/ 647700 w 723900"/>
              <a:gd name="connsiteY64" fmla="*/ 361076 h 535701"/>
              <a:gd name="connsiteX65" fmla="*/ 657225 w 723900"/>
              <a:gd name="connsiteY65" fmla="*/ 354726 h 535701"/>
              <a:gd name="connsiteX66" fmla="*/ 663575 w 723900"/>
              <a:gd name="connsiteY66" fmla="*/ 335676 h 535701"/>
              <a:gd name="connsiteX67" fmla="*/ 673100 w 723900"/>
              <a:gd name="connsiteY67" fmla="*/ 326151 h 535701"/>
              <a:gd name="connsiteX68" fmla="*/ 685800 w 723900"/>
              <a:gd name="connsiteY68" fmla="*/ 307101 h 535701"/>
              <a:gd name="connsiteX69" fmla="*/ 688975 w 723900"/>
              <a:gd name="connsiteY69" fmla="*/ 297576 h 535701"/>
              <a:gd name="connsiteX70" fmla="*/ 701675 w 723900"/>
              <a:gd name="connsiteY70" fmla="*/ 278526 h 535701"/>
              <a:gd name="connsiteX71" fmla="*/ 708025 w 723900"/>
              <a:gd name="connsiteY71" fmla="*/ 259476 h 535701"/>
              <a:gd name="connsiteX72" fmla="*/ 717550 w 723900"/>
              <a:gd name="connsiteY72" fmla="*/ 240426 h 535701"/>
              <a:gd name="connsiteX73" fmla="*/ 723900 w 723900"/>
              <a:gd name="connsiteY73" fmla="*/ 183276 h 535701"/>
              <a:gd name="connsiteX74" fmla="*/ 720725 w 723900"/>
              <a:gd name="connsiteY74" fmla="*/ 113426 h 535701"/>
              <a:gd name="connsiteX75" fmla="*/ 711200 w 723900"/>
              <a:gd name="connsiteY75" fmla="*/ 94376 h 535701"/>
              <a:gd name="connsiteX76" fmla="*/ 701675 w 723900"/>
              <a:gd name="connsiteY76" fmla="*/ 88026 h 535701"/>
              <a:gd name="connsiteX77" fmla="*/ 692150 w 723900"/>
              <a:gd name="connsiteY77" fmla="*/ 78501 h 535701"/>
              <a:gd name="connsiteX78" fmla="*/ 673100 w 723900"/>
              <a:gd name="connsiteY78" fmla="*/ 68976 h 535701"/>
              <a:gd name="connsiteX79" fmla="*/ 654050 w 723900"/>
              <a:gd name="connsiteY79" fmla="*/ 56276 h 535701"/>
              <a:gd name="connsiteX80" fmla="*/ 644525 w 723900"/>
              <a:gd name="connsiteY80" fmla="*/ 49926 h 535701"/>
              <a:gd name="connsiteX81" fmla="*/ 635000 w 723900"/>
              <a:gd name="connsiteY81" fmla="*/ 46751 h 535701"/>
              <a:gd name="connsiteX82" fmla="*/ 625475 w 723900"/>
              <a:gd name="connsiteY82" fmla="*/ 40401 h 535701"/>
              <a:gd name="connsiteX83" fmla="*/ 612775 w 723900"/>
              <a:gd name="connsiteY83" fmla="*/ 27701 h 535701"/>
              <a:gd name="connsiteX84" fmla="*/ 584200 w 723900"/>
              <a:gd name="connsiteY84" fmla="*/ 8651 h 535701"/>
              <a:gd name="connsiteX85" fmla="*/ 574675 w 723900"/>
              <a:gd name="connsiteY85" fmla="*/ 5476 h 535701"/>
              <a:gd name="connsiteX86" fmla="*/ 561975 w 723900"/>
              <a:gd name="connsiteY86" fmla="*/ 2301 h 535701"/>
              <a:gd name="connsiteX87" fmla="*/ 517525 w 723900"/>
              <a:gd name="connsiteY87" fmla="*/ 2301 h 53570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</a:cxnLst>
            <a:rect l="l" t="t" r="r" b="b"/>
            <a:pathLst>
              <a:path w="723900" h="535701">
                <a:moveTo>
                  <a:pt x="517525" y="2301"/>
                </a:moveTo>
                <a:cubicBezTo>
                  <a:pt x="495829" y="2301"/>
                  <a:pt x="491361" y="-2878"/>
                  <a:pt x="431800" y="2301"/>
                </a:cubicBezTo>
                <a:cubicBezTo>
                  <a:pt x="428466" y="2591"/>
                  <a:pt x="425493" y="4557"/>
                  <a:pt x="422275" y="5476"/>
                </a:cubicBezTo>
                <a:cubicBezTo>
                  <a:pt x="394368" y="13449"/>
                  <a:pt x="422888" y="4213"/>
                  <a:pt x="400050" y="11826"/>
                </a:cubicBezTo>
                <a:cubicBezTo>
                  <a:pt x="372753" y="30024"/>
                  <a:pt x="407290" y="8206"/>
                  <a:pt x="381000" y="21351"/>
                </a:cubicBezTo>
                <a:cubicBezTo>
                  <a:pt x="356381" y="33661"/>
                  <a:pt x="385891" y="22896"/>
                  <a:pt x="361950" y="30876"/>
                </a:cubicBezTo>
                <a:cubicBezTo>
                  <a:pt x="340115" y="45432"/>
                  <a:pt x="350140" y="41163"/>
                  <a:pt x="333375" y="46751"/>
                </a:cubicBezTo>
                <a:lnTo>
                  <a:pt x="304800" y="65801"/>
                </a:lnTo>
                <a:cubicBezTo>
                  <a:pt x="301625" y="67918"/>
                  <a:pt x="297973" y="69453"/>
                  <a:pt x="295275" y="72151"/>
                </a:cubicBezTo>
                <a:cubicBezTo>
                  <a:pt x="292100" y="75326"/>
                  <a:pt x="289675" y="79495"/>
                  <a:pt x="285750" y="81676"/>
                </a:cubicBezTo>
                <a:cubicBezTo>
                  <a:pt x="279899" y="84927"/>
                  <a:pt x="266700" y="88026"/>
                  <a:pt x="266700" y="88026"/>
                </a:cubicBezTo>
                <a:lnTo>
                  <a:pt x="238125" y="107076"/>
                </a:lnTo>
                <a:cubicBezTo>
                  <a:pt x="232556" y="110789"/>
                  <a:pt x="219075" y="113426"/>
                  <a:pt x="219075" y="113426"/>
                </a:cubicBezTo>
                <a:cubicBezTo>
                  <a:pt x="213093" y="119408"/>
                  <a:pt x="207982" y="125765"/>
                  <a:pt x="200025" y="129301"/>
                </a:cubicBezTo>
                <a:cubicBezTo>
                  <a:pt x="193908" y="132019"/>
                  <a:pt x="180975" y="135651"/>
                  <a:pt x="180975" y="135651"/>
                </a:cubicBezTo>
                <a:cubicBezTo>
                  <a:pt x="153678" y="153849"/>
                  <a:pt x="188215" y="132031"/>
                  <a:pt x="161925" y="145176"/>
                </a:cubicBezTo>
                <a:cubicBezTo>
                  <a:pt x="158512" y="146883"/>
                  <a:pt x="155887" y="149976"/>
                  <a:pt x="152400" y="151526"/>
                </a:cubicBezTo>
                <a:cubicBezTo>
                  <a:pt x="146283" y="154244"/>
                  <a:pt x="133350" y="157876"/>
                  <a:pt x="133350" y="157876"/>
                </a:cubicBezTo>
                <a:cubicBezTo>
                  <a:pt x="126328" y="164898"/>
                  <a:pt x="123141" y="169331"/>
                  <a:pt x="114300" y="173751"/>
                </a:cubicBezTo>
                <a:cubicBezTo>
                  <a:pt x="111307" y="175248"/>
                  <a:pt x="107950" y="175868"/>
                  <a:pt x="104775" y="176926"/>
                </a:cubicBezTo>
                <a:lnTo>
                  <a:pt x="85725" y="189626"/>
                </a:lnTo>
                <a:cubicBezTo>
                  <a:pt x="61942" y="205481"/>
                  <a:pt x="89323" y="194777"/>
                  <a:pt x="66675" y="202326"/>
                </a:cubicBezTo>
                <a:cubicBezTo>
                  <a:pt x="48477" y="229623"/>
                  <a:pt x="72708" y="197499"/>
                  <a:pt x="50800" y="215026"/>
                </a:cubicBezTo>
                <a:cubicBezTo>
                  <a:pt x="40095" y="223590"/>
                  <a:pt x="47848" y="224216"/>
                  <a:pt x="41275" y="234076"/>
                </a:cubicBezTo>
                <a:cubicBezTo>
                  <a:pt x="31306" y="249030"/>
                  <a:pt x="32325" y="237544"/>
                  <a:pt x="25400" y="253126"/>
                </a:cubicBezTo>
                <a:cubicBezTo>
                  <a:pt x="22682" y="259243"/>
                  <a:pt x="22763" y="266607"/>
                  <a:pt x="19050" y="272176"/>
                </a:cubicBezTo>
                <a:cubicBezTo>
                  <a:pt x="8987" y="287270"/>
                  <a:pt x="13907" y="278081"/>
                  <a:pt x="6350" y="300751"/>
                </a:cubicBezTo>
                <a:lnTo>
                  <a:pt x="3175" y="310276"/>
                </a:lnTo>
                <a:lnTo>
                  <a:pt x="0" y="319801"/>
                </a:lnTo>
                <a:cubicBezTo>
                  <a:pt x="1058" y="348376"/>
                  <a:pt x="586" y="377049"/>
                  <a:pt x="3175" y="405526"/>
                </a:cubicBezTo>
                <a:cubicBezTo>
                  <a:pt x="3781" y="412192"/>
                  <a:pt x="5812" y="419007"/>
                  <a:pt x="9525" y="424576"/>
                </a:cubicBezTo>
                <a:cubicBezTo>
                  <a:pt x="11642" y="427751"/>
                  <a:pt x="14168" y="430688"/>
                  <a:pt x="15875" y="434101"/>
                </a:cubicBezTo>
                <a:cubicBezTo>
                  <a:pt x="20348" y="443047"/>
                  <a:pt x="19737" y="458672"/>
                  <a:pt x="31750" y="462676"/>
                </a:cubicBezTo>
                <a:lnTo>
                  <a:pt x="41275" y="465851"/>
                </a:lnTo>
                <a:cubicBezTo>
                  <a:pt x="43392" y="469026"/>
                  <a:pt x="44645" y="472992"/>
                  <a:pt x="47625" y="475376"/>
                </a:cubicBezTo>
                <a:cubicBezTo>
                  <a:pt x="50238" y="477467"/>
                  <a:pt x="54157" y="477054"/>
                  <a:pt x="57150" y="478551"/>
                </a:cubicBezTo>
                <a:cubicBezTo>
                  <a:pt x="85882" y="492917"/>
                  <a:pt x="42121" y="477050"/>
                  <a:pt x="82550" y="488076"/>
                </a:cubicBezTo>
                <a:cubicBezTo>
                  <a:pt x="89008" y="489837"/>
                  <a:pt x="95250" y="492309"/>
                  <a:pt x="101600" y="494426"/>
                </a:cubicBezTo>
                <a:lnTo>
                  <a:pt x="139700" y="507126"/>
                </a:lnTo>
                <a:cubicBezTo>
                  <a:pt x="145807" y="509162"/>
                  <a:pt x="152437" y="509038"/>
                  <a:pt x="158750" y="510301"/>
                </a:cubicBezTo>
                <a:cubicBezTo>
                  <a:pt x="163029" y="511157"/>
                  <a:pt x="167217" y="512418"/>
                  <a:pt x="171450" y="513476"/>
                </a:cubicBezTo>
                <a:cubicBezTo>
                  <a:pt x="174625" y="515593"/>
                  <a:pt x="177488" y="518276"/>
                  <a:pt x="180975" y="519826"/>
                </a:cubicBezTo>
                <a:cubicBezTo>
                  <a:pt x="187092" y="522544"/>
                  <a:pt x="193675" y="524059"/>
                  <a:pt x="200025" y="526176"/>
                </a:cubicBezTo>
                <a:cubicBezTo>
                  <a:pt x="226010" y="534838"/>
                  <a:pt x="204364" y="528527"/>
                  <a:pt x="260350" y="532526"/>
                </a:cubicBezTo>
                <a:cubicBezTo>
                  <a:pt x="273062" y="533434"/>
                  <a:pt x="285750" y="534643"/>
                  <a:pt x="298450" y="535701"/>
                </a:cubicBezTo>
                <a:lnTo>
                  <a:pt x="381000" y="532526"/>
                </a:lnTo>
                <a:cubicBezTo>
                  <a:pt x="392673" y="531895"/>
                  <a:pt x="404413" y="531382"/>
                  <a:pt x="415925" y="529351"/>
                </a:cubicBezTo>
                <a:cubicBezTo>
                  <a:pt x="422517" y="528188"/>
                  <a:pt x="434975" y="523001"/>
                  <a:pt x="434975" y="523001"/>
                </a:cubicBezTo>
                <a:cubicBezTo>
                  <a:pt x="438150" y="519826"/>
                  <a:pt x="440764" y="515967"/>
                  <a:pt x="444500" y="513476"/>
                </a:cubicBezTo>
                <a:cubicBezTo>
                  <a:pt x="447285" y="511620"/>
                  <a:pt x="451099" y="511926"/>
                  <a:pt x="454025" y="510301"/>
                </a:cubicBezTo>
                <a:cubicBezTo>
                  <a:pt x="460696" y="506595"/>
                  <a:pt x="467679" y="502997"/>
                  <a:pt x="473075" y="497601"/>
                </a:cubicBezTo>
                <a:cubicBezTo>
                  <a:pt x="484967" y="485709"/>
                  <a:pt x="478340" y="489496"/>
                  <a:pt x="492125" y="484901"/>
                </a:cubicBezTo>
                <a:cubicBezTo>
                  <a:pt x="495300" y="482784"/>
                  <a:pt x="498952" y="481249"/>
                  <a:pt x="501650" y="478551"/>
                </a:cubicBezTo>
                <a:cubicBezTo>
                  <a:pt x="504348" y="475853"/>
                  <a:pt x="505020" y="471410"/>
                  <a:pt x="508000" y="469026"/>
                </a:cubicBezTo>
                <a:cubicBezTo>
                  <a:pt x="510613" y="466935"/>
                  <a:pt x="514350" y="466909"/>
                  <a:pt x="517525" y="465851"/>
                </a:cubicBezTo>
                <a:cubicBezTo>
                  <a:pt x="520700" y="463734"/>
                  <a:pt x="524119" y="461944"/>
                  <a:pt x="527050" y="459501"/>
                </a:cubicBezTo>
                <a:cubicBezTo>
                  <a:pt x="530499" y="456626"/>
                  <a:pt x="532839" y="452467"/>
                  <a:pt x="536575" y="449976"/>
                </a:cubicBezTo>
                <a:cubicBezTo>
                  <a:pt x="539360" y="448120"/>
                  <a:pt x="542925" y="447859"/>
                  <a:pt x="546100" y="446801"/>
                </a:cubicBezTo>
                <a:cubicBezTo>
                  <a:pt x="567517" y="425384"/>
                  <a:pt x="556631" y="430591"/>
                  <a:pt x="574675" y="424576"/>
                </a:cubicBezTo>
                <a:lnTo>
                  <a:pt x="603250" y="405526"/>
                </a:lnTo>
                <a:cubicBezTo>
                  <a:pt x="606035" y="403670"/>
                  <a:pt x="609600" y="403409"/>
                  <a:pt x="612775" y="402351"/>
                </a:cubicBezTo>
                <a:cubicBezTo>
                  <a:pt x="614892" y="399176"/>
                  <a:pt x="616145" y="395210"/>
                  <a:pt x="619125" y="392826"/>
                </a:cubicBezTo>
                <a:cubicBezTo>
                  <a:pt x="621738" y="390735"/>
                  <a:pt x="625865" y="391507"/>
                  <a:pt x="628650" y="389651"/>
                </a:cubicBezTo>
                <a:cubicBezTo>
                  <a:pt x="632386" y="387160"/>
                  <a:pt x="635000" y="383301"/>
                  <a:pt x="638175" y="380126"/>
                </a:cubicBezTo>
                <a:cubicBezTo>
                  <a:pt x="640757" y="372379"/>
                  <a:pt x="641545" y="367231"/>
                  <a:pt x="647700" y="361076"/>
                </a:cubicBezTo>
                <a:cubicBezTo>
                  <a:pt x="650398" y="358378"/>
                  <a:pt x="654050" y="356843"/>
                  <a:pt x="657225" y="354726"/>
                </a:cubicBezTo>
                <a:lnTo>
                  <a:pt x="663575" y="335676"/>
                </a:lnTo>
                <a:cubicBezTo>
                  <a:pt x="664995" y="331416"/>
                  <a:pt x="670343" y="329695"/>
                  <a:pt x="673100" y="326151"/>
                </a:cubicBezTo>
                <a:cubicBezTo>
                  <a:pt x="677785" y="320127"/>
                  <a:pt x="683387" y="314341"/>
                  <a:pt x="685800" y="307101"/>
                </a:cubicBezTo>
                <a:cubicBezTo>
                  <a:pt x="686858" y="303926"/>
                  <a:pt x="687350" y="300502"/>
                  <a:pt x="688975" y="297576"/>
                </a:cubicBezTo>
                <a:cubicBezTo>
                  <a:pt x="692681" y="290905"/>
                  <a:pt x="699262" y="285766"/>
                  <a:pt x="701675" y="278526"/>
                </a:cubicBezTo>
                <a:cubicBezTo>
                  <a:pt x="703792" y="272176"/>
                  <a:pt x="704312" y="265045"/>
                  <a:pt x="708025" y="259476"/>
                </a:cubicBezTo>
                <a:cubicBezTo>
                  <a:pt x="716231" y="247166"/>
                  <a:pt x="713168" y="253571"/>
                  <a:pt x="717550" y="240426"/>
                </a:cubicBezTo>
                <a:cubicBezTo>
                  <a:pt x="718816" y="230297"/>
                  <a:pt x="723900" y="191324"/>
                  <a:pt x="723900" y="183276"/>
                </a:cubicBezTo>
                <a:cubicBezTo>
                  <a:pt x="723900" y="159969"/>
                  <a:pt x="722584" y="136659"/>
                  <a:pt x="720725" y="113426"/>
                </a:cubicBezTo>
                <a:cubicBezTo>
                  <a:pt x="720276" y="107812"/>
                  <a:pt x="714923" y="98099"/>
                  <a:pt x="711200" y="94376"/>
                </a:cubicBezTo>
                <a:cubicBezTo>
                  <a:pt x="708502" y="91678"/>
                  <a:pt x="704606" y="90469"/>
                  <a:pt x="701675" y="88026"/>
                </a:cubicBezTo>
                <a:cubicBezTo>
                  <a:pt x="698226" y="85151"/>
                  <a:pt x="695599" y="81376"/>
                  <a:pt x="692150" y="78501"/>
                </a:cubicBezTo>
                <a:cubicBezTo>
                  <a:pt x="683944" y="71662"/>
                  <a:pt x="682646" y="72158"/>
                  <a:pt x="673100" y="68976"/>
                </a:cubicBezTo>
                <a:lnTo>
                  <a:pt x="654050" y="56276"/>
                </a:lnTo>
                <a:cubicBezTo>
                  <a:pt x="650875" y="54159"/>
                  <a:pt x="648145" y="51133"/>
                  <a:pt x="644525" y="49926"/>
                </a:cubicBezTo>
                <a:lnTo>
                  <a:pt x="635000" y="46751"/>
                </a:lnTo>
                <a:cubicBezTo>
                  <a:pt x="631825" y="44634"/>
                  <a:pt x="627859" y="43381"/>
                  <a:pt x="625475" y="40401"/>
                </a:cubicBezTo>
                <a:cubicBezTo>
                  <a:pt x="613160" y="25007"/>
                  <a:pt x="633557" y="34628"/>
                  <a:pt x="612775" y="27701"/>
                </a:cubicBezTo>
                <a:lnTo>
                  <a:pt x="584200" y="8651"/>
                </a:lnTo>
                <a:cubicBezTo>
                  <a:pt x="581415" y="6795"/>
                  <a:pt x="577893" y="6395"/>
                  <a:pt x="574675" y="5476"/>
                </a:cubicBezTo>
                <a:cubicBezTo>
                  <a:pt x="570479" y="4277"/>
                  <a:pt x="566337" y="2433"/>
                  <a:pt x="561975" y="2301"/>
                </a:cubicBezTo>
                <a:cubicBezTo>
                  <a:pt x="531297" y="1371"/>
                  <a:pt x="539221" y="2301"/>
                  <a:pt x="517525" y="2301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68" name="フリーフォーム 167"/>
          <p:cNvSpPr/>
          <p:nvPr/>
        </p:nvSpPr>
        <p:spPr>
          <a:xfrm>
            <a:off x="5382493" y="2583042"/>
            <a:ext cx="723900" cy="535701"/>
          </a:xfrm>
          <a:custGeom>
            <a:avLst/>
            <a:gdLst>
              <a:gd name="connsiteX0" fmla="*/ 517525 w 723900"/>
              <a:gd name="connsiteY0" fmla="*/ 2301 h 535701"/>
              <a:gd name="connsiteX1" fmla="*/ 431800 w 723900"/>
              <a:gd name="connsiteY1" fmla="*/ 2301 h 535701"/>
              <a:gd name="connsiteX2" fmla="*/ 422275 w 723900"/>
              <a:gd name="connsiteY2" fmla="*/ 5476 h 535701"/>
              <a:gd name="connsiteX3" fmla="*/ 400050 w 723900"/>
              <a:gd name="connsiteY3" fmla="*/ 11826 h 535701"/>
              <a:gd name="connsiteX4" fmla="*/ 381000 w 723900"/>
              <a:gd name="connsiteY4" fmla="*/ 21351 h 535701"/>
              <a:gd name="connsiteX5" fmla="*/ 361950 w 723900"/>
              <a:gd name="connsiteY5" fmla="*/ 30876 h 535701"/>
              <a:gd name="connsiteX6" fmla="*/ 333375 w 723900"/>
              <a:gd name="connsiteY6" fmla="*/ 46751 h 535701"/>
              <a:gd name="connsiteX7" fmla="*/ 304800 w 723900"/>
              <a:gd name="connsiteY7" fmla="*/ 65801 h 535701"/>
              <a:gd name="connsiteX8" fmla="*/ 295275 w 723900"/>
              <a:gd name="connsiteY8" fmla="*/ 72151 h 535701"/>
              <a:gd name="connsiteX9" fmla="*/ 285750 w 723900"/>
              <a:gd name="connsiteY9" fmla="*/ 81676 h 535701"/>
              <a:gd name="connsiteX10" fmla="*/ 266700 w 723900"/>
              <a:gd name="connsiteY10" fmla="*/ 88026 h 535701"/>
              <a:gd name="connsiteX11" fmla="*/ 238125 w 723900"/>
              <a:gd name="connsiteY11" fmla="*/ 107076 h 535701"/>
              <a:gd name="connsiteX12" fmla="*/ 219075 w 723900"/>
              <a:gd name="connsiteY12" fmla="*/ 113426 h 535701"/>
              <a:gd name="connsiteX13" fmla="*/ 200025 w 723900"/>
              <a:gd name="connsiteY13" fmla="*/ 129301 h 535701"/>
              <a:gd name="connsiteX14" fmla="*/ 180975 w 723900"/>
              <a:gd name="connsiteY14" fmla="*/ 135651 h 535701"/>
              <a:gd name="connsiteX15" fmla="*/ 161925 w 723900"/>
              <a:gd name="connsiteY15" fmla="*/ 145176 h 535701"/>
              <a:gd name="connsiteX16" fmla="*/ 152400 w 723900"/>
              <a:gd name="connsiteY16" fmla="*/ 151526 h 535701"/>
              <a:gd name="connsiteX17" fmla="*/ 133350 w 723900"/>
              <a:gd name="connsiteY17" fmla="*/ 157876 h 535701"/>
              <a:gd name="connsiteX18" fmla="*/ 114300 w 723900"/>
              <a:gd name="connsiteY18" fmla="*/ 173751 h 535701"/>
              <a:gd name="connsiteX19" fmla="*/ 104775 w 723900"/>
              <a:gd name="connsiteY19" fmla="*/ 176926 h 535701"/>
              <a:gd name="connsiteX20" fmla="*/ 85725 w 723900"/>
              <a:gd name="connsiteY20" fmla="*/ 189626 h 535701"/>
              <a:gd name="connsiteX21" fmla="*/ 66675 w 723900"/>
              <a:gd name="connsiteY21" fmla="*/ 202326 h 535701"/>
              <a:gd name="connsiteX22" fmla="*/ 50800 w 723900"/>
              <a:gd name="connsiteY22" fmla="*/ 215026 h 535701"/>
              <a:gd name="connsiteX23" fmla="*/ 41275 w 723900"/>
              <a:gd name="connsiteY23" fmla="*/ 234076 h 535701"/>
              <a:gd name="connsiteX24" fmla="*/ 25400 w 723900"/>
              <a:gd name="connsiteY24" fmla="*/ 253126 h 535701"/>
              <a:gd name="connsiteX25" fmla="*/ 19050 w 723900"/>
              <a:gd name="connsiteY25" fmla="*/ 272176 h 535701"/>
              <a:gd name="connsiteX26" fmla="*/ 6350 w 723900"/>
              <a:gd name="connsiteY26" fmla="*/ 300751 h 535701"/>
              <a:gd name="connsiteX27" fmla="*/ 3175 w 723900"/>
              <a:gd name="connsiteY27" fmla="*/ 310276 h 535701"/>
              <a:gd name="connsiteX28" fmla="*/ 0 w 723900"/>
              <a:gd name="connsiteY28" fmla="*/ 319801 h 535701"/>
              <a:gd name="connsiteX29" fmla="*/ 3175 w 723900"/>
              <a:gd name="connsiteY29" fmla="*/ 405526 h 535701"/>
              <a:gd name="connsiteX30" fmla="*/ 9525 w 723900"/>
              <a:gd name="connsiteY30" fmla="*/ 424576 h 535701"/>
              <a:gd name="connsiteX31" fmla="*/ 15875 w 723900"/>
              <a:gd name="connsiteY31" fmla="*/ 434101 h 535701"/>
              <a:gd name="connsiteX32" fmla="*/ 31750 w 723900"/>
              <a:gd name="connsiteY32" fmla="*/ 462676 h 535701"/>
              <a:gd name="connsiteX33" fmla="*/ 41275 w 723900"/>
              <a:gd name="connsiteY33" fmla="*/ 465851 h 535701"/>
              <a:gd name="connsiteX34" fmla="*/ 47625 w 723900"/>
              <a:gd name="connsiteY34" fmla="*/ 475376 h 535701"/>
              <a:gd name="connsiteX35" fmla="*/ 57150 w 723900"/>
              <a:gd name="connsiteY35" fmla="*/ 478551 h 535701"/>
              <a:gd name="connsiteX36" fmla="*/ 82550 w 723900"/>
              <a:gd name="connsiteY36" fmla="*/ 488076 h 535701"/>
              <a:gd name="connsiteX37" fmla="*/ 101600 w 723900"/>
              <a:gd name="connsiteY37" fmla="*/ 494426 h 535701"/>
              <a:gd name="connsiteX38" fmla="*/ 139700 w 723900"/>
              <a:gd name="connsiteY38" fmla="*/ 507126 h 535701"/>
              <a:gd name="connsiteX39" fmla="*/ 158750 w 723900"/>
              <a:gd name="connsiteY39" fmla="*/ 510301 h 535701"/>
              <a:gd name="connsiteX40" fmla="*/ 171450 w 723900"/>
              <a:gd name="connsiteY40" fmla="*/ 513476 h 535701"/>
              <a:gd name="connsiteX41" fmla="*/ 180975 w 723900"/>
              <a:gd name="connsiteY41" fmla="*/ 519826 h 535701"/>
              <a:gd name="connsiteX42" fmla="*/ 200025 w 723900"/>
              <a:gd name="connsiteY42" fmla="*/ 526176 h 535701"/>
              <a:gd name="connsiteX43" fmla="*/ 260350 w 723900"/>
              <a:gd name="connsiteY43" fmla="*/ 532526 h 535701"/>
              <a:gd name="connsiteX44" fmla="*/ 298450 w 723900"/>
              <a:gd name="connsiteY44" fmla="*/ 535701 h 535701"/>
              <a:gd name="connsiteX45" fmla="*/ 381000 w 723900"/>
              <a:gd name="connsiteY45" fmla="*/ 532526 h 535701"/>
              <a:gd name="connsiteX46" fmla="*/ 415925 w 723900"/>
              <a:gd name="connsiteY46" fmla="*/ 529351 h 535701"/>
              <a:gd name="connsiteX47" fmla="*/ 434975 w 723900"/>
              <a:gd name="connsiteY47" fmla="*/ 523001 h 535701"/>
              <a:gd name="connsiteX48" fmla="*/ 444500 w 723900"/>
              <a:gd name="connsiteY48" fmla="*/ 513476 h 535701"/>
              <a:gd name="connsiteX49" fmla="*/ 454025 w 723900"/>
              <a:gd name="connsiteY49" fmla="*/ 510301 h 535701"/>
              <a:gd name="connsiteX50" fmla="*/ 473075 w 723900"/>
              <a:gd name="connsiteY50" fmla="*/ 497601 h 535701"/>
              <a:gd name="connsiteX51" fmla="*/ 492125 w 723900"/>
              <a:gd name="connsiteY51" fmla="*/ 484901 h 535701"/>
              <a:gd name="connsiteX52" fmla="*/ 501650 w 723900"/>
              <a:gd name="connsiteY52" fmla="*/ 478551 h 535701"/>
              <a:gd name="connsiteX53" fmla="*/ 508000 w 723900"/>
              <a:gd name="connsiteY53" fmla="*/ 469026 h 535701"/>
              <a:gd name="connsiteX54" fmla="*/ 517525 w 723900"/>
              <a:gd name="connsiteY54" fmla="*/ 465851 h 535701"/>
              <a:gd name="connsiteX55" fmla="*/ 527050 w 723900"/>
              <a:gd name="connsiteY55" fmla="*/ 459501 h 535701"/>
              <a:gd name="connsiteX56" fmla="*/ 536575 w 723900"/>
              <a:gd name="connsiteY56" fmla="*/ 449976 h 535701"/>
              <a:gd name="connsiteX57" fmla="*/ 546100 w 723900"/>
              <a:gd name="connsiteY57" fmla="*/ 446801 h 535701"/>
              <a:gd name="connsiteX58" fmla="*/ 574675 w 723900"/>
              <a:gd name="connsiteY58" fmla="*/ 424576 h 535701"/>
              <a:gd name="connsiteX59" fmla="*/ 603250 w 723900"/>
              <a:gd name="connsiteY59" fmla="*/ 405526 h 535701"/>
              <a:gd name="connsiteX60" fmla="*/ 612775 w 723900"/>
              <a:gd name="connsiteY60" fmla="*/ 402351 h 535701"/>
              <a:gd name="connsiteX61" fmla="*/ 619125 w 723900"/>
              <a:gd name="connsiteY61" fmla="*/ 392826 h 535701"/>
              <a:gd name="connsiteX62" fmla="*/ 628650 w 723900"/>
              <a:gd name="connsiteY62" fmla="*/ 389651 h 535701"/>
              <a:gd name="connsiteX63" fmla="*/ 638175 w 723900"/>
              <a:gd name="connsiteY63" fmla="*/ 380126 h 535701"/>
              <a:gd name="connsiteX64" fmla="*/ 647700 w 723900"/>
              <a:gd name="connsiteY64" fmla="*/ 361076 h 535701"/>
              <a:gd name="connsiteX65" fmla="*/ 657225 w 723900"/>
              <a:gd name="connsiteY65" fmla="*/ 354726 h 535701"/>
              <a:gd name="connsiteX66" fmla="*/ 663575 w 723900"/>
              <a:gd name="connsiteY66" fmla="*/ 335676 h 535701"/>
              <a:gd name="connsiteX67" fmla="*/ 673100 w 723900"/>
              <a:gd name="connsiteY67" fmla="*/ 326151 h 535701"/>
              <a:gd name="connsiteX68" fmla="*/ 685800 w 723900"/>
              <a:gd name="connsiteY68" fmla="*/ 307101 h 535701"/>
              <a:gd name="connsiteX69" fmla="*/ 688975 w 723900"/>
              <a:gd name="connsiteY69" fmla="*/ 297576 h 535701"/>
              <a:gd name="connsiteX70" fmla="*/ 701675 w 723900"/>
              <a:gd name="connsiteY70" fmla="*/ 278526 h 535701"/>
              <a:gd name="connsiteX71" fmla="*/ 708025 w 723900"/>
              <a:gd name="connsiteY71" fmla="*/ 259476 h 535701"/>
              <a:gd name="connsiteX72" fmla="*/ 717550 w 723900"/>
              <a:gd name="connsiteY72" fmla="*/ 240426 h 535701"/>
              <a:gd name="connsiteX73" fmla="*/ 723900 w 723900"/>
              <a:gd name="connsiteY73" fmla="*/ 183276 h 535701"/>
              <a:gd name="connsiteX74" fmla="*/ 720725 w 723900"/>
              <a:gd name="connsiteY74" fmla="*/ 113426 h 535701"/>
              <a:gd name="connsiteX75" fmla="*/ 711200 w 723900"/>
              <a:gd name="connsiteY75" fmla="*/ 94376 h 535701"/>
              <a:gd name="connsiteX76" fmla="*/ 701675 w 723900"/>
              <a:gd name="connsiteY76" fmla="*/ 88026 h 535701"/>
              <a:gd name="connsiteX77" fmla="*/ 692150 w 723900"/>
              <a:gd name="connsiteY77" fmla="*/ 78501 h 535701"/>
              <a:gd name="connsiteX78" fmla="*/ 673100 w 723900"/>
              <a:gd name="connsiteY78" fmla="*/ 68976 h 535701"/>
              <a:gd name="connsiteX79" fmla="*/ 654050 w 723900"/>
              <a:gd name="connsiteY79" fmla="*/ 56276 h 535701"/>
              <a:gd name="connsiteX80" fmla="*/ 644525 w 723900"/>
              <a:gd name="connsiteY80" fmla="*/ 49926 h 535701"/>
              <a:gd name="connsiteX81" fmla="*/ 635000 w 723900"/>
              <a:gd name="connsiteY81" fmla="*/ 46751 h 535701"/>
              <a:gd name="connsiteX82" fmla="*/ 625475 w 723900"/>
              <a:gd name="connsiteY82" fmla="*/ 40401 h 535701"/>
              <a:gd name="connsiteX83" fmla="*/ 612775 w 723900"/>
              <a:gd name="connsiteY83" fmla="*/ 27701 h 535701"/>
              <a:gd name="connsiteX84" fmla="*/ 584200 w 723900"/>
              <a:gd name="connsiteY84" fmla="*/ 8651 h 535701"/>
              <a:gd name="connsiteX85" fmla="*/ 574675 w 723900"/>
              <a:gd name="connsiteY85" fmla="*/ 5476 h 535701"/>
              <a:gd name="connsiteX86" fmla="*/ 561975 w 723900"/>
              <a:gd name="connsiteY86" fmla="*/ 2301 h 535701"/>
              <a:gd name="connsiteX87" fmla="*/ 517525 w 723900"/>
              <a:gd name="connsiteY87" fmla="*/ 2301 h 53570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</a:cxnLst>
            <a:rect l="l" t="t" r="r" b="b"/>
            <a:pathLst>
              <a:path w="723900" h="535701">
                <a:moveTo>
                  <a:pt x="517525" y="2301"/>
                </a:moveTo>
                <a:cubicBezTo>
                  <a:pt x="495829" y="2301"/>
                  <a:pt x="491361" y="-2878"/>
                  <a:pt x="431800" y="2301"/>
                </a:cubicBezTo>
                <a:cubicBezTo>
                  <a:pt x="428466" y="2591"/>
                  <a:pt x="425493" y="4557"/>
                  <a:pt x="422275" y="5476"/>
                </a:cubicBezTo>
                <a:cubicBezTo>
                  <a:pt x="394368" y="13449"/>
                  <a:pt x="422888" y="4213"/>
                  <a:pt x="400050" y="11826"/>
                </a:cubicBezTo>
                <a:cubicBezTo>
                  <a:pt x="372753" y="30024"/>
                  <a:pt x="407290" y="8206"/>
                  <a:pt x="381000" y="21351"/>
                </a:cubicBezTo>
                <a:cubicBezTo>
                  <a:pt x="356381" y="33661"/>
                  <a:pt x="385891" y="22896"/>
                  <a:pt x="361950" y="30876"/>
                </a:cubicBezTo>
                <a:cubicBezTo>
                  <a:pt x="340115" y="45432"/>
                  <a:pt x="350140" y="41163"/>
                  <a:pt x="333375" y="46751"/>
                </a:cubicBezTo>
                <a:lnTo>
                  <a:pt x="304800" y="65801"/>
                </a:lnTo>
                <a:cubicBezTo>
                  <a:pt x="301625" y="67918"/>
                  <a:pt x="297973" y="69453"/>
                  <a:pt x="295275" y="72151"/>
                </a:cubicBezTo>
                <a:cubicBezTo>
                  <a:pt x="292100" y="75326"/>
                  <a:pt x="289675" y="79495"/>
                  <a:pt x="285750" y="81676"/>
                </a:cubicBezTo>
                <a:cubicBezTo>
                  <a:pt x="279899" y="84927"/>
                  <a:pt x="266700" y="88026"/>
                  <a:pt x="266700" y="88026"/>
                </a:cubicBezTo>
                <a:lnTo>
                  <a:pt x="238125" y="107076"/>
                </a:lnTo>
                <a:cubicBezTo>
                  <a:pt x="232556" y="110789"/>
                  <a:pt x="219075" y="113426"/>
                  <a:pt x="219075" y="113426"/>
                </a:cubicBezTo>
                <a:cubicBezTo>
                  <a:pt x="213093" y="119408"/>
                  <a:pt x="207982" y="125765"/>
                  <a:pt x="200025" y="129301"/>
                </a:cubicBezTo>
                <a:cubicBezTo>
                  <a:pt x="193908" y="132019"/>
                  <a:pt x="180975" y="135651"/>
                  <a:pt x="180975" y="135651"/>
                </a:cubicBezTo>
                <a:cubicBezTo>
                  <a:pt x="153678" y="153849"/>
                  <a:pt x="188215" y="132031"/>
                  <a:pt x="161925" y="145176"/>
                </a:cubicBezTo>
                <a:cubicBezTo>
                  <a:pt x="158512" y="146883"/>
                  <a:pt x="155887" y="149976"/>
                  <a:pt x="152400" y="151526"/>
                </a:cubicBezTo>
                <a:cubicBezTo>
                  <a:pt x="146283" y="154244"/>
                  <a:pt x="133350" y="157876"/>
                  <a:pt x="133350" y="157876"/>
                </a:cubicBezTo>
                <a:cubicBezTo>
                  <a:pt x="126328" y="164898"/>
                  <a:pt x="123141" y="169331"/>
                  <a:pt x="114300" y="173751"/>
                </a:cubicBezTo>
                <a:cubicBezTo>
                  <a:pt x="111307" y="175248"/>
                  <a:pt x="107950" y="175868"/>
                  <a:pt x="104775" y="176926"/>
                </a:cubicBezTo>
                <a:lnTo>
                  <a:pt x="85725" y="189626"/>
                </a:lnTo>
                <a:cubicBezTo>
                  <a:pt x="61942" y="205481"/>
                  <a:pt x="89323" y="194777"/>
                  <a:pt x="66675" y="202326"/>
                </a:cubicBezTo>
                <a:cubicBezTo>
                  <a:pt x="48477" y="229623"/>
                  <a:pt x="72708" y="197499"/>
                  <a:pt x="50800" y="215026"/>
                </a:cubicBezTo>
                <a:cubicBezTo>
                  <a:pt x="40095" y="223590"/>
                  <a:pt x="47848" y="224216"/>
                  <a:pt x="41275" y="234076"/>
                </a:cubicBezTo>
                <a:cubicBezTo>
                  <a:pt x="31306" y="249030"/>
                  <a:pt x="32325" y="237544"/>
                  <a:pt x="25400" y="253126"/>
                </a:cubicBezTo>
                <a:cubicBezTo>
                  <a:pt x="22682" y="259243"/>
                  <a:pt x="22763" y="266607"/>
                  <a:pt x="19050" y="272176"/>
                </a:cubicBezTo>
                <a:cubicBezTo>
                  <a:pt x="8987" y="287270"/>
                  <a:pt x="13907" y="278081"/>
                  <a:pt x="6350" y="300751"/>
                </a:cubicBezTo>
                <a:lnTo>
                  <a:pt x="3175" y="310276"/>
                </a:lnTo>
                <a:lnTo>
                  <a:pt x="0" y="319801"/>
                </a:lnTo>
                <a:cubicBezTo>
                  <a:pt x="1058" y="348376"/>
                  <a:pt x="586" y="377049"/>
                  <a:pt x="3175" y="405526"/>
                </a:cubicBezTo>
                <a:cubicBezTo>
                  <a:pt x="3781" y="412192"/>
                  <a:pt x="5812" y="419007"/>
                  <a:pt x="9525" y="424576"/>
                </a:cubicBezTo>
                <a:cubicBezTo>
                  <a:pt x="11642" y="427751"/>
                  <a:pt x="14168" y="430688"/>
                  <a:pt x="15875" y="434101"/>
                </a:cubicBezTo>
                <a:cubicBezTo>
                  <a:pt x="20348" y="443047"/>
                  <a:pt x="19737" y="458672"/>
                  <a:pt x="31750" y="462676"/>
                </a:cubicBezTo>
                <a:lnTo>
                  <a:pt x="41275" y="465851"/>
                </a:lnTo>
                <a:cubicBezTo>
                  <a:pt x="43392" y="469026"/>
                  <a:pt x="44645" y="472992"/>
                  <a:pt x="47625" y="475376"/>
                </a:cubicBezTo>
                <a:cubicBezTo>
                  <a:pt x="50238" y="477467"/>
                  <a:pt x="54157" y="477054"/>
                  <a:pt x="57150" y="478551"/>
                </a:cubicBezTo>
                <a:cubicBezTo>
                  <a:pt x="85882" y="492917"/>
                  <a:pt x="42121" y="477050"/>
                  <a:pt x="82550" y="488076"/>
                </a:cubicBezTo>
                <a:cubicBezTo>
                  <a:pt x="89008" y="489837"/>
                  <a:pt x="95250" y="492309"/>
                  <a:pt x="101600" y="494426"/>
                </a:cubicBezTo>
                <a:lnTo>
                  <a:pt x="139700" y="507126"/>
                </a:lnTo>
                <a:cubicBezTo>
                  <a:pt x="145807" y="509162"/>
                  <a:pt x="152437" y="509038"/>
                  <a:pt x="158750" y="510301"/>
                </a:cubicBezTo>
                <a:cubicBezTo>
                  <a:pt x="163029" y="511157"/>
                  <a:pt x="167217" y="512418"/>
                  <a:pt x="171450" y="513476"/>
                </a:cubicBezTo>
                <a:cubicBezTo>
                  <a:pt x="174625" y="515593"/>
                  <a:pt x="177488" y="518276"/>
                  <a:pt x="180975" y="519826"/>
                </a:cubicBezTo>
                <a:cubicBezTo>
                  <a:pt x="187092" y="522544"/>
                  <a:pt x="193675" y="524059"/>
                  <a:pt x="200025" y="526176"/>
                </a:cubicBezTo>
                <a:cubicBezTo>
                  <a:pt x="226010" y="534838"/>
                  <a:pt x="204364" y="528527"/>
                  <a:pt x="260350" y="532526"/>
                </a:cubicBezTo>
                <a:cubicBezTo>
                  <a:pt x="273062" y="533434"/>
                  <a:pt x="285750" y="534643"/>
                  <a:pt x="298450" y="535701"/>
                </a:cubicBezTo>
                <a:lnTo>
                  <a:pt x="381000" y="532526"/>
                </a:lnTo>
                <a:cubicBezTo>
                  <a:pt x="392673" y="531895"/>
                  <a:pt x="404413" y="531382"/>
                  <a:pt x="415925" y="529351"/>
                </a:cubicBezTo>
                <a:cubicBezTo>
                  <a:pt x="422517" y="528188"/>
                  <a:pt x="434975" y="523001"/>
                  <a:pt x="434975" y="523001"/>
                </a:cubicBezTo>
                <a:cubicBezTo>
                  <a:pt x="438150" y="519826"/>
                  <a:pt x="440764" y="515967"/>
                  <a:pt x="444500" y="513476"/>
                </a:cubicBezTo>
                <a:cubicBezTo>
                  <a:pt x="447285" y="511620"/>
                  <a:pt x="451099" y="511926"/>
                  <a:pt x="454025" y="510301"/>
                </a:cubicBezTo>
                <a:cubicBezTo>
                  <a:pt x="460696" y="506595"/>
                  <a:pt x="467679" y="502997"/>
                  <a:pt x="473075" y="497601"/>
                </a:cubicBezTo>
                <a:cubicBezTo>
                  <a:pt x="484967" y="485709"/>
                  <a:pt x="478340" y="489496"/>
                  <a:pt x="492125" y="484901"/>
                </a:cubicBezTo>
                <a:cubicBezTo>
                  <a:pt x="495300" y="482784"/>
                  <a:pt x="498952" y="481249"/>
                  <a:pt x="501650" y="478551"/>
                </a:cubicBezTo>
                <a:cubicBezTo>
                  <a:pt x="504348" y="475853"/>
                  <a:pt x="505020" y="471410"/>
                  <a:pt x="508000" y="469026"/>
                </a:cubicBezTo>
                <a:cubicBezTo>
                  <a:pt x="510613" y="466935"/>
                  <a:pt x="514350" y="466909"/>
                  <a:pt x="517525" y="465851"/>
                </a:cubicBezTo>
                <a:cubicBezTo>
                  <a:pt x="520700" y="463734"/>
                  <a:pt x="524119" y="461944"/>
                  <a:pt x="527050" y="459501"/>
                </a:cubicBezTo>
                <a:cubicBezTo>
                  <a:pt x="530499" y="456626"/>
                  <a:pt x="532839" y="452467"/>
                  <a:pt x="536575" y="449976"/>
                </a:cubicBezTo>
                <a:cubicBezTo>
                  <a:pt x="539360" y="448120"/>
                  <a:pt x="542925" y="447859"/>
                  <a:pt x="546100" y="446801"/>
                </a:cubicBezTo>
                <a:cubicBezTo>
                  <a:pt x="567517" y="425384"/>
                  <a:pt x="556631" y="430591"/>
                  <a:pt x="574675" y="424576"/>
                </a:cubicBezTo>
                <a:lnTo>
                  <a:pt x="603250" y="405526"/>
                </a:lnTo>
                <a:cubicBezTo>
                  <a:pt x="606035" y="403670"/>
                  <a:pt x="609600" y="403409"/>
                  <a:pt x="612775" y="402351"/>
                </a:cubicBezTo>
                <a:cubicBezTo>
                  <a:pt x="614892" y="399176"/>
                  <a:pt x="616145" y="395210"/>
                  <a:pt x="619125" y="392826"/>
                </a:cubicBezTo>
                <a:cubicBezTo>
                  <a:pt x="621738" y="390735"/>
                  <a:pt x="625865" y="391507"/>
                  <a:pt x="628650" y="389651"/>
                </a:cubicBezTo>
                <a:cubicBezTo>
                  <a:pt x="632386" y="387160"/>
                  <a:pt x="635000" y="383301"/>
                  <a:pt x="638175" y="380126"/>
                </a:cubicBezTo>
                <a:cubicBezTo>
                  <a:pt x="640757" y="372379"/>
                  <a:pt x="641545" y="367231"/>
                  <a:pt x="647700" y="361076"/>
                </a:cubicBezTo>
                <a:cubicBezTo>
                  <a:pt x="650398" y="358378"/>
                  <a:pt x="654050" y="356843"/>
                  <a:pt x="657225" y="354726"/>
                </a:cubicBezTo>
                <a:lnTo>
                  <a:pt x="663575" y="335676"/>
                </a:lnTo>
                <a:cubicBezTo>
                  <a:pt x="664995" y="331416"/>
                  <a:pt x="670343" y="329695"/>
                  <a:pt x="673100" y="326151"/>
                </a:cubicBezTo>
                <a:cubicBezTo>
                  <a:pt x="677785" y="320127"/>
                  <a:pt x="683387" y="314341"/>
                  <a:pt x="685800" y="307101"/>
                </a:cubicBezTo>
                <a:cubicBezTo>
                  <a:pt x="686858" y="303926"/>
                  <a:pt x="687350" y="300502"/>
                  <a:pt x="688975" y="297576"/>
                </a:cubicBezTo>
                <a:cubicBezTo>
                  <a:pt x="692681" y="290905"/>
                  <a:pt x="699262" y="285766"/>
                  <a:pt x="701675" y="278526"/>
                </a:cubicBezTo>
                <a:cubicBezTo>
                  <a:pt x="703792" y="272176"/>
                  <a:pt x="704312" y="265045"/>
                  <a:pt x="708025" y="259476"/>
                </a:cubicBezTo>
                <a:cubicBezTo>
                  <a:pt x="716231" y="247166"/>
                  <a:pt x="713168" y="253571"/>
                  <a:pt x="717550" y="240426"/>
                </a:cubicBezTo>
                <a:cubicBezTo>
                  <a:pt x="718816" y="230297"/>
                  <a:pt x="723900" y="191324"/>
                  <a:pt x="723900" y="183276"/>
                </a:cubicBezTo>
                <a:cubicBezTo>
                  <a:pt x="723900" y="159969"/>
                  <a:pt x="722584" y="136659"/>
                  <a:pt x="720725" y="113426"/>
                </a:cubicBezTo>
                <a:cubicBezTo>
                  <a:pt x="720276" y="107812"/>
                  <a:pt x="714923" y="98099"/>
                  <a:pt x="711200" y="94376"/>
                </a:cubicBezTo>
                <a:cubicBezTo>
                  <a:pt x="708502" y="91678"/>
                  <a:pt x="704606" y="90469"/>
                  <a:pt x="701675" y="88026"/>
                </a:cubicBezTo>
                <a:cubicBezTo>
                  <a:pt x="698226" y="85151"/>
                  <a:pt x="695599" y="81376"/>
                  <a:pt x="692150" y="78501"/>
                </a:cubicBezTo>
                <a:cubicBezTo>
                  <a:pt x="683944" y="71662"/>
                  <a:pt x="682646" y="72158"/>
                  <a:pt x="673100" y="68976"/>
                </a:cubicBezTo>
                <a:lnTo>
                  <a:pt x="654050" y="56276"/>
                </a:lnTo>
                <a:cubicBezTo>
                  <a:pt x="650875" y="54159"/>
                  <a:pt x="648145" y="51133"/>
                  <a:pt x="644525" y="49926"/>
                </a:cubicBezTo>
                <a:lnTo>
                  <a:pt x="635000" y="46751"/>
                </a:lnTo>
                <a:cubicBezTo>
                  <a:pt x="631825" y="44634"/>
                  <a:pt x="627859" y="43381"/>
                  <a:pt x="625475" y="40401"/>
                </a:cubicBezTo>
                <a:cubicBezTo>
                  <a:pt x="613160" y="25007"/>
                  <a:pt x="633557" y="34628"/>
                  <a:pt x="612775" y="27701"/>
                </a:cubicBezTo>
                <a:lnTo>
                  <a:pt x="584200" y="8651"/>
                </a:lnTo>
                <a:cubicBezTo>
                  <a:pt x="581415" y="6795"/>
                  <a:pt x="577893" y="6395"/>
                  <a:pt x="574675" y="5476"/>
                </a:cubicBezTo>
                <a:cubicBezTo>
                  <a:pt x="570479" y="4277"/>
                  <a:pt x="566337" y="2433"/>
                  <a:pt x="561975" y="2301"/>
                </a:cubicBezTo>
                <a:cubicBezTo>
                  <a:pt x="531297" y="1371"/>
                  <a:pt x="539221" y="2301"/>
                  <a:pt x="517525" y="2301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5" name="フリーフォーム 34"/>
          <p:cNvSpPr/>
          <p:nvPr/>
        </p:nvSpPr>
        <p:spPr>
          <a:xfrm>
            <a:off x="8248650" y="3867150"/>
            <a:ext cx="520814" cy="895350"/>
          </a:xfrm>
          <a:custGeom>
            <a:avLst/>
            <a:gdLst>
              <a:gd name="connsiteX0" fmla="*/ 307975 w 520814"/>
              <a:gd name="connsiteY0" fmla="*/ 0 h 895350"/>
              <a:gd name="connsiteX1" fmla="*/ 260350 w 520814"/>
              <a:gd name="connsiteY1" fmla="*/ 3175 h 895350"/>
              <a:gd name="connsiteX2" fmla="*/ 231775 w 520814"/>
              <a:gd name="connsiteY2" fmla="*/ 9525 h 895350"/>
              <a:gd name="connsiteX3" fmla="*/ 200025 w 520814"/>
              <a:gd name="connsiteY3" fmla="*/ 15875 h 895350"/>
              <a:gd name="connsiteX4" fmla="*/ 180975 w 520814"/>
              <a:gd name="connsiteY4" fmla="*/ 22225 h 895350"/>
              <a:gd name="connsiteX5" fmla="*/ 142875 w 520814"/>
              <a:gd name="connsiteY5" fmla="*/ 47625 h 895350"/>
              <a:gd name="connsiteX6" fmla="*/ 133350 w 520814"/>
              <a:gd name="connsiteY6" fmla="*/ 57150 h 895350"/>
              <a:gd name="connsiteX7" fmla="*/ 120650 w 520814"/>
              <a:gd name="connsiteY7" fmla="*/ 73025 h 895350"/>
              <a:gd name="connsiteX8" fmla="*/ 98425 w 520814"/>
              <a:gd name="connsiteY8" fmla="*/ 98425 h 895350"/>
              <a:gd name="connsiteX9" fmla="*/ 92075 w 520814"/>
              <a:gd name="connsiteY9" fmla="*/ 107950 h 895350"/>
              <a:gd name="connsiteX10" fmla="*/ 88900 w 520814"/>
              <a:gd name="connsiteY10" fmla="*/ 117475 h 895350"/>
              <a:gd name="connsiteX11" fmla="*/ 79375 w 520814"/>
              <a:gd name="connsiteY11" fmla="*/ 120650 h 895350"/>
              <a:gd name="connsiteX12" fmla="*/ 73025 w 520814"/>
              <a:gd name="connsiteY12" fmla="*/ 139700 h 895350"/>
              <a:gd name="connsiteX13" fmla="*/ 66675 w 520814"/>
              <a:gd name="connsiteY13" fmla="*/ 149225 h 895350"/>
              <a:gd name="connsiteX14" fmla="*/ 63500 w 520814"/>
              <a:gd name="connsiteY14" fmla="*/ 158750 h 895350"/>
              <a:gd name="connsiteX15" fmla="*/ 53975 w 520814"/>
              <a:gd name="connsiteY15" fmla="*/ 168275 h 895350"/>
              <a:gd name="connsiteX16" fmla="*/ 38100 w 520814"/>
              <a:gd name="connsiteY16" fmla="*/ 196850 h 895350"/>
              <a:gd name="connsiteX17" fmla="*/ 34925 w 520814"/>
              <a:gd name="connsiteY17" fmla="*/ 206375 h 895350"/>
              <a:gd name="connsiteX18" fmla="*/ 28575 w 520814"/>
              <a:gd name="connsiteY18" fmla="*/ 215900 h 895350"/>
              <a:gd name="connsiteX19" fmla="*/ 22225 w 520814"/>
              <a:gd name="connsiteY19" fmla="*/ 234950 h 895350"/>
              <a:gd name="connsiteX20" fmla="*/ 15875 w 520814"/>
              <a:gd name="connsiteY20" fmla="*/ 260350 h 895350"/>
              <a:gd name="connsiteX21" fmla="*/ 9525 w 520814"/>
              <a:gd name="connsiteY21" fmla="*/ 482600 h 895350"/>
              <a:gd name="connsiteX22" fmla="*/ 6350 w 520814"/>
              <a:gd name="connsiteY22" fmla="*/ 508000 h 895350"/>
              <a:gd name="connsiteX23" fmla="*/ 0 w 520814"/>
              <a:gd name="connsiteY23" fmla="*/ 533400 h 895350"/>
              <a:gd name="connsiteX24" fmla="*/ 3175 w 520814"/>
              <a:gd name="connsiteY24" fmla="*/ 666750 h 895350"/>
              <a:gd name="connsiteX25" fmla="*/ 9525 w 520814"/>
              <a:gd name="connsiteY25" fmla="*/ 685800 h 895350"/>
              <a:gd name="connsiteX26" fmla="*/ 12700 w 520814"/>
              <a:gd name="connsiteY26" fmla="*/ 695325 h 895350"/>
              <a:gd name="connsiteX27" fmla="*/ 19050 w 520814"/>
              <a:gd name="connsiteY27" fmla="*/ 714375 h 895350"/>
              <a:gd name="connsiteX28" fmla="*/ 22225 w 520814"/>
              <a:gd name="connsiteY28" fmla="*/ 723900 h 895350"/>
              <a:gd name="connsiteX29" fmla="*/ 28575 w 520814"/>
              <a:gd name="connsiteY29" fmla="*/ 733425 h 895350"/>
              <a:gd name="connsiteX30" fmla="*/ 31750 w 520814"/>
              <a:gd name="connsiteY30" fmla="*/ 742950 h 895350"/>
              <a:gd name="connsiteX31" fmla="*/ 44450 w 520814"/>
              <a:gd name="connsiteY31" fmla="*/ 762000 h 895350"/>
              <a:gd name="connsiteX32" fmla="*/ 60325 w 520814"/>
              <a:gd name="connsiteY32" fmla="*/ 790575 h 895350"/>
              <a:gd name="connsiteX33" fmla="*/ 92075 w 520814"/>
              <a:gd name="connsiteY33" fmla="*/ 838200 h 895350"/>
              <a:gd name="connsiteX34" fmla="*/ 111125 w 520814"/>
              <a:gd name="connsiteY34" fmla="*/ 857250 h 895350"/>
              <a:gd name="connsiteX35" fmla="*/ 142875 w 520814"/>
              <a:gd name="connsiteY35" fmla="*/ 876300 h 895350"/>
              <a:gd name="connsiteX36" fmla="*/ 161925 w 520814"/>
              <a:gd name="connsiteY36" fmla="*/ 882650 h 895350"/>
              <a:gd name="connsiteX37" fmla="*/ 171450 w 520814"/>
              <a:gd name="connsiteY37" fmla="*/ 889000 h 895350"/>
              <a:gd name="connsiteX38" fmla="*/ 206375 w 520814"/>
              <a:gd name="connsiteY38" fmla="*/ 895350 h 895350"/>
              <a:gd name="connsiteX39" fmla="*/ 301625 w 520814"/>
              <a:gd name="connsiteY39" fmla="*/ 892175 h 895350"/>
              <a:gd name="connsiteX40" fmla="*/ 320675 w 520814"/>
              <a:gd name="connsiteY40" fmla="*/ 882650 h 895350"/>
              <a:gd name="connsiteX41" fmla="*/ 330200 w 520814"/>
              <a:gd name="connsiteY41" fmla="*/ 879475 h 895350"/>
              <a:gd name="connsiteX42" fmla="*/ 336550 w 520814"/>
              <a:gd name="connsiteY42" fmla="*/ 869950 h 895350"/>
              <a:gd name="connsiteX43" fmla="*/ 346075 w 520814"/>
              <a:gd name="connsiteY43" fmla="*/ 866775 h 895350"/>
              <a:gd name="connsiteX44" fmla="*/ 355600 w 520814"/>
              <a:gd name="connsiteY44" fmla="*/ 860425 h 895350"/>
              <a:gd name="connsiteX45" fmla="*/ 377825 w 520814"/>
              <a:gd name="connsiteY45" fmla="*/ 831850 h 895350"/>
              <a:gd name="connsiteX46" fmla="*/ 393700 w 520814"/>
              <a:gd name="connsiteY46" fmla="*/ 803275 h 895350"/>
              <a:gd name="connsiteX47" fmla="*/ 400050 w 520814"/>
              <a:gd name="connsiteY47" fmla="*/ 793750 h 895350"/>
              <a:gd name="connsiteX48" fmla="*/ 415925 w 520814"/>
              <a:gd name="connsiteY48" fmla="*/ 765175 h 895350"/>
              <a:gd name="connsiteX49" fmla="*/ 422275 w 520814"/>
              <a:gd name="connsiteY49" fmla="*/ 755650 h 895350"/>
              <a:gd name="connsiteX50" fmla="*/ 441325 w 520814"/>
              <a:gd name="connsiteY50" fmla="*/ 717550 h 895350"/>
              <a:gd name="connsiteX51" fmla="*/ 447675 w 520814"/>
              <a:gd name="connsiteY51" fmla="*/ 698500 h 895350"/>
              <a:gd name="connsiteX52" fmla="*/ 460375 w 520814"/>
              <a:gd name="connsiteY52" fmla="*/ 660400 h 895350"/>
              <a:gd name="connsiteX53" fmla="*/ 466725 w 520814"/>
              <a:gd name="connsiteY53" fmla="*/ 650875 h 895350"/>
              <a:gd name="connsiteX54" fmla="*/ 476250 w 520814"/>
              <a:gd name="connsiteY54" fmla="*/ 619125 h 895350"/>
              <a:gd name="connsiteX55" fmla="*/ 482600 w 520814"/>
              <a:gd name="connsiteY55" fmla="*/ 600075 h 895350"/>
              <a:gd name="connsiteX56" fmla="*/ 488950 w 520814"/>
              <a:gd name="connsiteY56" fmla="*/ 581025 h 895350"/>
              <a:gd name="connsiteX57" fmla="*/ 492125 w 520814"/>
              <a:gd name="connsiteY57" fmla="*/ 571500 h 895350"/>
              <a:gd name="connsiteX58" fmla="*/ 495300 w 520814"/>
              <a:gd name="connsiteY58" fmla="*/ 558800 h 895350"/>
              <a:gd name="connsiteX59" fmla="*/ 504825 w 520814"/>
              <a:gd name="connsiteY59" fmla="*/ 530225 h 895350"/>
              <a:gd name="connsiteX60" fmla="*/ 511175 w 520814"/>
              <a:gd name="connsiteY60" fmla="*/ 501650 h 895350"/>
              <a:gd name="connsiteX61" fmla="*/ 517525 w 520814"/>
              <a:gd name="connsiteY61" fmla="*/ 384175 h 895350"/>
              <a:gd name="connsiteX62" fmla="*/ 511175 w 520814"/>
              <a:gd name="connsiteY62" fmla="*/ 241300 h 895350"/>
              <a:gd name="connsiteX63" fmla="*/ 501650 w 520814"/>
              <a:gd name="connsiteY63" fmla="*/ 180975 h 895350"/>
              <a:gd name="connsiteX64" fmla="*/ 495300 w 520814"/>
              <a:gd name="connsiteY64" fmla="*/ 161925 h 895350"/>
              <a:gd name="connsiteX65" fmla="*/ 488950 w 520814"/>
              <a:gd name="connsiteY65" fmla="*/ 142875 h 895350"/>
              <a:gd name="connsiteX66" fmla="*/ 485775 w 520814"/>
              <a:gd name="connsiteY66" fmla="*/ 133350 h 895350"/>
              <a:gd name="connsiteX67" fmla="*/ 482600 w 520814"/>
              <a:gd name="connsiteY67" fmla="*/ 123825 h 895350"/>
              <a:gd name="connsiteX68" fmla="*/ 476250 w 520814"/>
              <a:gd name="connsiteY68" fmla="*/ 114300 h 895350"/>
              <a:gd name="connsiteX69" fmla="*/ 463550 w 520814"/>
              <a:gd name="connsiteY69" fmla="*/ 85725 h 895350"/>
              <a:gd name="connsiteX70" fmla="*/ 454025 w 520814"/>
              <a:gd name="connsiteY70" fmla="*/ 76200 h 895350"/>
              <a:gd name="connsiteX71" fmla="*/ 441325 w 520814"/>
              <a:gd name="connsiteY71" fmla="*/ 60325 h 895350"/>
              <a:gd name="connsiteX72" fmla="*/ 412750 w 520814"/>
              <a:gd name="connsiteY72" fmla="*/ 38100 h 895350"/>
              <a:gd name="connsiteX73" fmla="*/ 393700 w 520814"/>
              <a:gd name="connsiteY73" fmla="*/ 25400 h 895350"/>
              <a:gd name="connsiteX74" fmla="*/ 365125 w 520814"/>
              <a:gd name="connsiteY74" fmla="*/ 15875 h 895350"/>
              <a:gd name="connsiteX75" fmla="*/ 355600 w 520814"/>
              <a:gd name="connsiteY75" fmla="*/ 12700 h 895350"/>
              <a:gd name="connsiteX76" fmla="*/ 311150 w 520814"/>
              <a:gd name="connsiteY76" fmla="*/ 3175 h 895350"/>
              <a:gd name="connsiteX77" fmla="*/ 307975 w 520814"/>
              <a:gd name="connsiteY77" fmla="*/ 0 h 8953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</a:cxnLst>
            <a:rect l="l" t="t" r="r" b="b"/>
            <a:pathLst>
              <a:path w="520814" h="895350">
                <a:moveTo>
                  <a:pt x="307975" y="0"/>
                </a:moveTo>
                <a:cubicBezTo>
                  <a:pt x="299508" y="0"/>
                  <a:pt x="276189" y="1667"/>
                  <a:pt x="260350" y="3175"/>
                </a:cubicBezTo>
                <a:cubicBezTo>
                  <a:pt x="238863" y="5221"/>
                  <a:pt x="246958" y="5187"/>
                  <a:pt x="231775" y="9525"/>
                </a:cubicBezTo>
                <a:cubicBezTo>
                  <a:pt x="218513" y="13314"/>
                  <a:pt x="214994" y="13380"/>
                  <a:pt x="200025" y="15875"/>
                </a:cubicBezTo>
                <a:cubicBezTo>
                  <a:pt x="193675" y="17992"/>
                  <a:pt x="186544" y="18512"/>
                  <a:pt x="180975" y="22225"/>
                </a:cubicBezTo>
                <a:lnTo>
                  <a:pt x="142875" y="47625"/>
                </a:lnTo>
                <a:cubicBezTo>
                  <a:pt x="139139" y="50116"/>
                  <a:pt x="136525" y="53975"/>
                  <a:pt x="133350" y="57150"/>
                </a:cubicBezTo>
                <a:cubicBezTo>
                  <a:pt x="126200" y="78600"/>
                  <a:pt x="136116" y="55350"/>
                  <a:pt x="120650" y="73025"/>
                </a:cubicBezTo>
                <a:cubicBezTo>
                  <a:pt x="94721" y="102658"/>
                  <a:pt x="119856" y="84137"/>
                  <a:pt x="98425" y="98425"/>
                </a:cubicBezTo>
                <a:cubicBezTo>
                  <a:pt x="96308" y="101600"/>
                  <a:pt x="93782" y="104537"/>
                  <a:pt x="92075" y="107950"/>
                </a:cubicBezTo>
                <a:cubicBezTo>
                  <a:pt x="90578" y="110943"/>
                  <a:pt x="91267" y="115108"/>
                  <a:pt x="88900" y="117475"/>
                </a:cubicBezTo>
                <a:cubicBezTo>
                  <a:pt x="86533" y="119842"/>
                  <a:pt x="82550" y="119592"/>
                  <a:pt x="79375" y="120650"/>
                </a:cubicBezTo>
                <a:cubicBezTo>
                  <a:pt x="77258" y="127000"/>
                  <a:pt x="76738" y="134131"/>
                  <a:pt x="73025" y="139700"/>
                </a:cubicBezTo>
                <a:cubicBezTo>
                  <a:pt x="70908" y="142875"/>
                  <a:pt x="68382" y="145812"/>
                  <a:pt x="66675" y="149225"/>
                </a:cubicBezTo>
                <a:cubicBezTo>
                  <a:pt x="65178" y="152218"/>
                  <a:pt x="65356" y="155965"/>
                  <a:pt x="63500" y="158750"/>
                </a:cubicBezTo>
                <a:cubicBezTo>
                  <a:pt x="61009" y="162486"/>
                  <a:pt x="57150" y="165100"/>
                  <a:pt x="53975" y="168275"/>
                </a:cubicBezTo>
                <a:cubicBezTo>
                  <a:pt x="48387" y="185040"/>
                  <a:pt x="52656" y="175015"/>
                  <a:pt x="38100" y="196850"/>
                </a:cubicBezTo>
                <a:cubicBezTo>
                  <a:pt x="36244" y="199635"/>
                  <a:pt x="36422" y="203382"/>
                  <a:pt x="34925" y="206375"/>
                </a:cubicBezTo>
                <a:cubicBezTo>
                  <a:pt x="33218" y="209788"/>
                  <a:pt x="30125" y="212413"/>
                  <a:pt x="28575" y="215900"/>
                </a:cubicBezTo>
                <a:cubicBezTo>
                  <a:pt x="25857" y="222017"/>
                  <a:pt x="24342" y="228600"/>
                  <a:pt x="22225" y="234950"/>
                </a:cubicBezTo>
                <a:cubicBezTo>
                  <a:pt x="17343" y="249595"/>
                  <a:pt x="19706" y="241193"/>
                  <a:pt x="15875" y="260350"/>
                </a:cubicBezTo>
                <a:cubicBezTo>
                  <a:pt x="7546" y="393607"/>
                  <a:pt x="18364" y="208586"/>
                  <a:pt x="9525" y="482600"/>
                </a:cubicBezTo>
                <a:cubicBezTo>
                  <a:pt x="9250" y="491128"/>
                  <a:pt x="7922" y="499614"/>
                  <a:pt x="6350" y="508000"/>
                </a:cubicBezTo>
                <a:cubicBezTo>
                  <a:pt x="4742" y="516578"/>
                  <a:pt x="0" y="533400"/>
                  <a:pt x="0" y="533400"/>
                </a:cubicBezTo>
                <a:cubicBezTo>
                  <a:pt x="1058" y="577850"/>
                  <a:pt x="401" y="622374"/>
                  <a:pt x="3175" y="666750"/>
                </a:cubicBezTo>
                <a:cubicBezTo>
                  <a:pt x="3593" y="673430"/>
                  <a:pt x="7408" y="679450"/>
                  <a:pt x="9525" y="685800"/>
                </a:cubicBezTo>
                <a:lnTo>
                  <a:pt x="12700" y="695325"/>
                </a:lnTo>
                <a:lnTo>
                  <a:pt x="19050" y="714375"/>
                </a:lnTo>
                <a:cubicBezTo>
                  <a:pt x="20108" y="717550"/>
                  <a:pt x="20369" y="721115"/>
                  <a:pt x="22225" y="723900"/>
                </a:cubicBezTo>
                <a:cubicBezTo>
                  <a:pt x="24342" y="727075"/>
                  <a:pt x="26868" y="730012"/>
                  <a:pt x="28575" y="733425"/>
                </a:cubicBezTo>
                <a:cubicBezTo>
                  <a:pt x="30072" y="736418"/>
                  <a:pt x="30125" y="740024"/>
                  <a:pt x="31750" y="742950"/>
                </a:cubicBezTo>
                <a:cubicBezTo>
                  <a:pt x="35456" y="749621"/>
                  <a:pt x="42037" y="754760"/>
                  <a:pt x="44450" y="762000"/>
                </a:cubicBezTo>
                <a:cubicBezTo>
                  <a:pt x="50038" y="778765"/>
                  <a:pt x="45769" y="768740"/>
                  <a:pt x="60325" y="790575"/>
                </a:cubicBezTo>
                <a:lnTo>
                  <a:pt x="92075" y="838200"/>
                </a:lnTo>
                <a:cubicBezTo>
                  <a:pt x="97056" y="845672"/>
                  <a:pt x="104775" y="850900"/>
                  <a:pt x="111125" y="857250"/>
                </a:cubicBezTo>
                <a:cubicBezTo>
                  <a:pt x="116094" y="862219"/>
                  <a:pt x="134524" y="872959"/>
                  <a:pt x="142875" y="876300"/>
                </a:cubicBezTo>
                <a:cubicBezTo>
                  <a:pt x="149090" y="878786"/>
                  <a:pt x="161925" y="882650"/>
                  <a:pt x="161925" y="882650"/>
                </a:cubicBezTo>
                <a:cubicBezTo>
                  <a:pt x="165100" y="884767"/>
                  <a:pt x="168037" y="887293"/>
                  <a:pt x="171450" y="889000"/>
                </a:cubicBezTo>
                <a:cubicBezTo>
                  <a:pt x="181239" y="893894"/>
                  <a:pt x="197619" y="894256"/>
                  <a:pt x="206375" y="895350"/>
                </a:cubicBezTo>
                <a:cubicBezTo>
                  <a:pt x="238125" y="894292"/>
                  <a:pt x="269916" y="894097"/>
                  <a:pt x="301625" y="892175"/>
                </a:cubicBezTo>
                <a:cubicBezTo>
                  <a:pt x="310706" y="891625"/>
                  <a:pt x="312999" y="886488"/>
                  <a:pt x="320675" y="882650"/>
                </a:cubicBezTo>
                <a:cubicBezTo>
                  <a:pt x="323668" y="881153"/>
                  <a:pt x="327025" y="880533"/>
                  <a:pt x="330200" y="879475"/>
                </a:cubicBezTo>
                <a:cubicBezTo>
                  <a:pt x="332317" y="876300"/>
                  <a:pt x="333570" y="872334"/>
                  <a:pt x="336550" y="869950"/>
                </a:cubicBezTo>
                <a:cubicBezTo>
                  <a:pt x="339163" y="867859"/>
                  <a:pt x="343082" y="868272"/>
                  <a:pt x="346075" y="866775"/>
                </a:cubicBezTo>
                <a:cubicBezTo>
                  <a:pt x="349488" y="865068"/>
                  <a:pt x="352425" y="862542"/>
                  <a:pt x="355600" y="860425"/>
                </a:cubicBezTo>
                <a:cubicBezTo>
                  <a:pt x="370791" y="837639"/>
                  <a:pt x="362904" y="846771"/>
                  <a:pt x="377825" y="831850"/>
                </a:cubicBezTo>
                <a:cubicBezTo>
                  <a:pt x="383413" y="815085"/>
                  <a:pt x="379144" y="825110"/>
                  <a:pt x="393700" y="803275"/>
                </a:cubicBezTo>
                <a:cubicBezTo>
                  <a:pt x="395817" y="800100"/>
                  <a:pt x="398843" y="797370"/>
                  <a:pt x="400050" y="793750"/>
                </a:cubicBezTo>
                <a:cubicBezTo>
                  <a:pt x="405638" y="776985"/>
                  <a:pt x="401369" y="787010"/>
                  <a:pt x="415925" y="765175"/>
                </a:cubicBezTo>
                <a:cubicBezTo>
                  <a:pt x="418042" y="762000"/>
                  <a:pt x="421068" y="759270"/>
                  <a:pt x="422275" y="755650"/>
                </a:cubicBezTo>
                <a:cubicBezTo>
                  <a:pt x="431038" y="729360"/>
                  <a:pt x="424912" y="742169"/>
                  <a:pt x="441325" y="717550"/>
                </a:cubicBezTo>
                <a:cubicBezTo>
                  <a:pt x="445038" y="711981"/>
                  <a:pt x="445558" y="704850"/>
                  <a:pt x="447675" y="698500"/>
                </a:cubicBezTo>
                <a:lnTo>
                  <a:pt x="460375" y="660400"/>
                </a:lnTo>
                <a:cubicBezTo>
                  <a:pt x="461582" y="656780"/>
                  <a:pt x="465175" y="654362"/>
                  <a:pt x="466725" y="650875"/>
                </a:cubicBezTo>
                <a:cubicBezTo>
                  <a:pt x="473633" y="635332"/>
                  <a:pt x="471987" y="633333"/>
                  <a:pt x="476250" y="619125"/>
                </a:cubicBezTo>
                <a:cubicBezTo>
                  <a:pt x="478173" y="612714"/>
                  <a:pt x="480483" y="606425"/>
                  <a:pt x="482600" y="600075"/>
                </a:cubicBezTo>
                <a:lnTo>
                  <a:pt x="488950" y="581025"/>
                </a:lnTo>
                <a:cubicBezTo>
                  <a:pt x="490008" y="577850"/>
                  <a:pt x="491313" y="574747"/>
                  <a:pt x="492125" y="571500"/>
                </a:cubicBezTo>
                <a:cubicBezTo>
                  <a:pt x="493183" y="567267"/>
                  <a:pt x="494046" y="562980"/>
                  <a:pt x="495300" y="558800"/>
                </a:cubicBezTo>
                <a:cubicBezTo>
                  <a:pt x="498185" y="549183"/>
                  <a:pt x="501650" y="539750"/>
                  <a:pt x="504825" y="530225"/>
                </a:cubicBezTo>
                <a:cubicBezTo>
                  <a:pt x="507067" y="523499"/>
                  <a:pt x="509917" y="507941"/>
                  <a:pt x="511175" y="501650"/>
                </a:cubicBezTo>
                <a:cubicBezTo>
                  <a:pt x="513757" y="465504"/>
                  <a:pt x="517525" y="418557"/>
                  <a:pt x="517525" y="384175"/>
                </a:cubicBezTo>
                <a:cubicBezTo>
                  <a:pt x="517525" y="257243"/>
                  <a:pt x="528165" y="292271"/>
                  <a:pt x="511175" y="241300"/>
                </a:cubicBezTo>
                <a:cubicBezTo>
                  <a:pt x="510841" y="238959"/>
                  <a:pt x="505316" y="194418"/>
                  <a:pt x="501650" y="180975"/>
                </a:cubicBezTo>
                <a:cubicBezTo>
                  <a:pt x="499889" y="174517"/>
                  <a:pt x="497417" y="168275"/>
                  <a:pt x="495300" y="161925"/>
                </a:cubicBezTo>
                <a:lnTo>
                  <a:pt x="488950" y="142875"/>
                </a:lnTo>
                <a:lnTo>
                  <a:pt x="485775" y="133350"/>
                </a:lnTo>
                <a:cubicBezTo>
                  <a:pt x="484717" y="130175"/>
                  <a:pt x="484456" y="126610"/>
                  <a:pt x="482600" y="123825"/>
                </a:cubicBezTo>
                <a:cubicBezTo>
                  <a:pt x="480483" y="120650"/>
                  <a:pt x="477800" y="117787"/>
                  <a:pt x="476250" y="114300"/>
                </a:cubicBezTo>
                <a:cubicBezTo>
                  <a:pt x="468339" y="96500"/>
                  <a:pt x="473815" y="98043"/>
                  <a:pt x="463550" y="85725"/>
                </a:cubicBezTo>
                <a:cubicBezTo>
                  <a:pt x="460675" y="82276"/>
                  <a:pt x="457200" y="79375"/>
                  <a:pt x="454025" y="76200"/>
                </a:cubicBezTo>
                <a:cubicBezTo>
                  <a:pt x="448507" y="59646"/>
                  <a:pt x="454930" y="72419"/>
                  <a:pt x="441325" y="60325"/>
                </a:cubicBezTo>
                <a:cubicBezTo>
                  <a:pt x="415625" y="37481"/>
                  <a:pt x="432391" y="44647"/>
                  <a:pt x="412750" y="38100"/>
                </a:cubicBezTo>
                <a:cubicBezTo>
                  <a:pt x="406400" y="33867"/>
                  <a:pt x="400940" y="27813"/>
                  <a:pt x="393700" y="25400"/>
                </a:cubicBezTo>
                <a:lnTo>
                  <a:pt x="365125" y="15875"/>
                </a:lnTo>
                <a:cubicBezTo>
                  <a:pt x="361950" y="14817"/>
                  <a:pt x="358847" y="13512"/>
                  <a:pt x="355600" y="12700"/>
                </a:cubicBezTo>
                <a:cubicBezTo>
                  <a:pt x="332429" y="6907"/>
                  <a:pt x="347179" y="10381"/>
                  <a:pt x="311150" y="3175"/>
                </a:cubicBezTo>
                <a:cubicBezTo>
                  <a:pt x="303886" y="1722"/>
                  <a:pt x="316442" y="0"/>
                  <a:pt x="307975" y="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70" name="フリーフォーム 169"/>
          <p:cNvSpPr/>
          <p:nvPr/>
        </p:nvSpPr>
        <p:spPr>
          <a:xfrm>
            <a:off x="6859498" y="3867398"/>
            <a:ext cx="520814" cy="895350"/>
          </a:xfrm>
          <a:custGeom>
            <a:avLst/>
            <a:gdLst>
              <a:gd name="connsiteX0" fmla="*/ 307975 w 520814"/>
              <a:gd name="connsiteY0" fmla="*/ 0 h 895350"/>
              <a:gd name="connsiteX1" fmla="*/ 260350 w 520814"/>
              <a:gd name="connsiteY1" fmla="*/ 3175 h 895350"/>
              <a:gd name="connsiteX2" fmla="*/ 231775 w 520814"/>
              <a:gd name="connsiteY2" fmla="*/ 9525 h 895350"/>
              <a:gd name="connsiteX3" fmla="*/ 200025 w 520814"/>
              <a:gd name="connsiteY3" fmla="*/ 15875 h 895350"/>
              <a:gd name="connsiteX4" fmla="*/ 180975 w 520814"/>
              <a:gd name="connsiteY4" fmla="*/ 22225 h 895350"/>
              <a:gd name="connsiteX5" fmla="*/ 142875 w 520814"/>
              <a:gd name="connsiteY5" fmla="*/ 47625 h 895350"/>
              <a:gd name="connsiteX6" fmla="*/ 133350 w 520814"/>
              <a:gd name="connsiteY6" fmla="*/ 57150 h 895350"/>
              <a:gd name="connsiteX7" fmla="*/ 120650 w 520814"/>
              <a:gd name="connsiteY7" fmla="*/ 73025 h 895350"/>
              <a:gd name="connsiteX8" fmla="*/ 98425 w 520814"/>
              <a:gd name="connsiteY8" fmla="*/ 98425 h 895350"/>
              <a:gd name="connsiteX9" fmla="*/ 92075 w 520814"/>
              <a:gd name="connsiteY9" fmla="*/ 107950 h 895350"/>
              <a:gd name="connsiteX10" fmla="*/ 88900 w 520814"/>
              <a:gd name="connsiteY10" fmla="*/ 117475 h 895350"/>
              <a:gd name="connsiteX11" fmla="*/ 79375 w 520814"/>
              <a:gd name="connsiteY11" fmla="*/ 120650 h 895350"/>
              <a:gd name="connsiteX12" fmla="*/ 73025 w 520814"/>
              <a:gd name="connsiteY12" fmla="*/ 139700 h 895350"/>
              <a:gd name="connsiteX13" fmla="*/ 66675 w 520814"/>
              <a:gd name="connsiteY13" fmla="*/ 149225 h 895350"/>
              <a:gd name="connsiteX14" fmla="*/ 63500 w 520814"/>
              <a:gd name="connsiteY14" fmla="*/ 158750 h 895350"/>
              <a:gd name="connsiteX15" fmla="*/ 53975 w 520814"/>
              <a:gd name="connsiteY15" fmla="*/ 168275 h 895350"/>
              <a:gd name="connsiteX16" fmla="*/ 38100 w 520814"/>
              <a:gd name="connsiteY16" fmla="*/ 196850 h 895350"/>
              <a:gd name="connsiteX17" fmla="*/ 34925 w 520814"/>
              <a:gd name="connsiteY17" fmla="*/ 206375 h 895350"/>
              <a:gd name="connsiteX18" fmla="*/ 28575 w 520814"/>
              <a:gd name="connsiteY18" fmla="*/ 215900 h 895350"/>
              <a:gd name="connsiteX19" fmla="*/ 22225 w 520814"/>
              <a:gd name="connsiteY19" fmla="*/ 234950 h 895350"/>
              <a:gd name="connsiteX20" fmla="*/ 15875 w 520814"/>
              <a:gd name="connsiteY20" fmla="*/ 260350 h 895350"/>
              <a:gd name="connsiteX21" fmla="*/ 9525 w 520814"/>
              <a:gd name="connsiteY21" fmla="*/ 482600 h 895350"/>
              <a:gd name="connsiteX22" fmla="*/ 6350 w 520814"/>
              <a:gd name="connsiteY22" fmla="*/ 508000 h 895350"/>
              <a:gd name="connsiteX23" fmla="*/ 0 w 520814"/>
              <a:gd name="connsiteY23" fmla="*/ 533400 h 895350"/>
              <a:gd name="connsiteX24" fmla="*/ 3175 w 520814"/>
              <a:gd name="connsiteY24" fmla="*/ 666750 h 895350"/>
              <a:gd name="connsiteX25" fmla="*/ 9525 w 520814"/>
              <a:gd name="connsiteY25" fmla="*/ 685800 h 895350"/>
              <a:gd name="connsiteX26" fmla="*/ 12700 w 520814"/>
              <a:gd name="connsiteY26" fmla="*/ 695325 h 895350"/>
              <a:gd name="connsiteX27" fmla="*/ 19050 w 520814"/>
              <a:gd name="connsiteY27" fmla="*/ 714375 h 895350"/>
              <a:gd name="connsiteX28" fmla="*/ 22225 w 520814"/>
              <a:gd name="connsiteY28" fmla="*/ 723900 h 895350"/>
              <a:gd name="connsiteX29" fmla="*/ 28575 w 520814"/>
              <a:gd name="connsiteY29" fmla="*/ 733425 h 895350"/>
              <a:gd name="connsiteX30" fmla="*/ 31750 w 520814"/>
              <a:gd name="connsiteY30" fmla="*/ 742950 h 895350"/>
              <a:gd name="connsiteX31" fmla="*/ 44450 w 520814"/>
              <a:gd name="connsiteY31" fmla="*/ 762000 h 895350"/>
              <a:gd name="connsiteX32" fmla="*/ 60325 w 520814"/>
              <a:gd name="connsiteY32" fmla="*/ 790575 h 895350"/>
              <a:gd name="connsiteX33" fmla="*/ 92075 w 520814"/>
              <a:gd name="connsiteY33" fmla="*/ 838200 h 895350"/>
              <a:gd name="connsiteX34" fmla="*/ 111125 w 520814"/>
              <a:gd name="connsiteY34" fmla="*/ 857250 h 895350"/>
              <a:gd name="connsiteX35" fmla="*/ 142875 w 520814"/>
              <a:gd name="connsiteY35" fmla="*/ 876300 h 895350"/>
              <a:gd name="connsiteX36" fmla="*/ 161925 w 520814"/>
              <a:gd name="connsiteY36" fmla="*/ 882650 h 895350"/>
              <a:gd name="connsiteX37" fmla="*/ 171450 w 520814"/>
              <a:gd name="connsiteY37" fmla="*/ 889000 h 895350"/>
              <a:gd name="connsiteX38" fmla="*/ 206375 w 520814"/>
              <a:gd name="connsiteY38" fmla="*/ 895350 h 895350"/>
              <a:gd name="connsiteX39" fmla="*/ 301625 w 520814"/>
              <a:gd name="connsiteY39" fmla="*/ 892175 h 895350"/>
              <a:gd name="connsiteX40" fmla="*/ 320675 w 520814"/>
              <a:gd name="connsiteY40" fmla="*/ 882650 h 895350"/>
              <a:gd name="connsiteX41" fmla="*/ 330200 w 520814"/>
              <a:gd name="connsiteY41" fmla="*/ 879475 h 895350"/>
              <a:gd name="connsiteX42" fmla="*/ 336550 w 520814"/>
              <a:gd name="connsiteY42" fmla="*/ 869950 h 895350"/>
              <a:gd name="connsiteX43" fmla="*/ 346075 w 520814"/>
              <a:gd name="connsiteY43" fmla="*/ 866775 h 895350"/>
              <a:gd name="connsiteX44" fmla="*/ 355600 w 520814"/>
              <a:gd name="connsiteY44" fmla="*/ 860425 h 895350"/>
              <a:gd name="connsiteX45" fmla="*/ 377825 w 520814"/>
              <a:gd name="connsiteY45" fmla="*/ 831850 h 895350"/>
              <a:gd name="connsiteX46" fmla="*/ 393700 w 520814"/>
              <a:gd name="connsiteY46" fmla="*/ 803275 h 895350"/>
              <a:gd name="connsiteX47" fmla="*/ 400050 w 520814"/>
              <a:gd name="connsiteY47" fmla="*/ 793750 h 895350"/>
              <a:gd name="connsiteX48" fmla="*/ 415925 w 520814"/>
              <a:gd name="connsiteY48" fmla="*/ 765175 h 895350"/>
              <a:gd name="connsiteX49" fmla="*/ 422275 w 520814"/>
              <a:gd name="connsiteY49" fmla="*/ 755650 h 895350"/>
              <a:gd name="connsiteX50" fmla="*/ 441325 w 520814"/>
              <a:gd name="connsiteY50" fmla="*/ 717550 h 895350"/>
              <a:gd name="connsiteX51" fmla="*/ 447675 w 520814"/>
              <a:gd name="connsiteY51" fmla="*/ 698500 h 895350"/>
              <a:gd name="connsiteX52" fmla="*/ 460375 w 520814"/>
              <a:gd name="connsiteY52" fmla="*/ 660400 h 895350"/>
              <a:gd name="connsiteX53" fmla="*/ 466725 w 520814"/>
              <a:gd name="connsiteY53" fmla="*/ 650875 h 895350"/>
              <a:gd name="connsiteX54" fmla="*/ 476250 w 520814"/>
              <a:gd name="connsiteY54" fmla="*/ 619125 h 895350"/>
              <a:gd name="connsiteX55" fmla="*/ 482600 w 520814"/>
              <a:gd name="connsiteY55" fmla="*/ 600075 h 895350"/>
              <a:gd name="connsiteX56" fmla="*/ 488950 w 520814"/>
              <a:gd name="connsiteY56" fmla="*/ 581025 h 895350"/>
              <a:gd name="connsiteX57" fmla="*/ 492125 w 520814"/>
              <a:gd name="connsiteY57" fmla="*/ 571500 h 895350"/>
              <a:gd name="connsiteX58" fmla="*/ 495300 w 520814"/>
              <a:gd name="connsiteY58" fmla="*/ 558800 h 895350"/>
              <a:gd name="connsiteX59" fmla="*/ 504825 w 520814"/>
              <a:gd name="connsiteY59" fmla="*/ 530225 h 895350"/>
              <a:gd name="connsiteX60" fmla="*/ 511175 w 520814"/>
              <a:gd name="connsiteY60" fmla="*/ 501650 h 895350"/>
              <a:gd name="connsiteX61" fmla="*/ 517525 w 520814"/>
              <a:gd name="connsiteY61" fmla="*/ 384175 h 895350"/>
              <a:gd name="connsiteX62" fmla="*/ 511175 w 520814"/>
              <a:gd name="connsiteY62" fmla="*/ 241300 h 895350"/>
              <a:gd name="connsiteX63" fmla="*/ 501650 w 520814"/>
              <a:gd name="connsiteY63" fmla="*/ 180975 h 895350"/>
              <a:gd name="connsiteX64" fmla="*/ 495300 w 520814"/>
              <a:gd name="connsiteY64" fmla="*/ 161925 h 895350"/>
              <a:gd name="connsiteX65" fmla="*/ 488950 w 520814"/>
              <a:gd name="connsiteY65" fmla="*/ 142875 h 895350"/>
              <a:gd name="connsiteX66" fmla="*/ 485775 w 520814"/>
              <a:gd name="connsiteY66" fmla="*/ 133350 h 895350"/>
              <a:gd name="connsiteX67" fmla="*/ 482600 w 520814"/>
              <a:gd name="connsiteY67" fmla="*/ 123825 h 895350"/>
              <a:gd name="connsiteX68" fmla="*/ 476250 w 520814"/>
              <a:gd name="connsiteY68" fmla="*/ 114300 h 895350"/>
              <a:gd name="connsiteX69" fmla="*/ 463550 w 520814"/>
              <a:gd name="connsiteY69" fmla="*/ 85725 h 895350"/>
              <a:gd name="connsiteX70" fmla="*/ 454025 w 520814"/>
              <a:gd name="connsiteY70" fmla="*/ 76200 h 895350"/>
              <a:gd name="connsiteX71" fmla="*/ 441325 w 520814"/>
              <a:gd name="connsiteY71" fmla="*/ 60325 h 895350"/>
              <a:gd name="connsiteX72" fmla="*/ 412750 w 520814"/>
              <a:gd name="connsiteY72" fmla="*/ 38100 h 895350"/>
              <a:gd name="connsiteX73" fmla="*/ 393700 w 520814"/>
              <a:gd name="connsiteY73" fmla="*/ 25400 h 895350"/>
              <a:gd name="connsiteX74" fmla="*/ 365125 w 520814"/>
              <a:gd name="connsiteY74" fmla="*/ 15875 h 895350"/>
              <a:gd name="connsiteX75" fmla="*/ 355600 w 520814"/>
              <a:gd name="connsiteY75" fmla="*/ 12700 h 895350"/>
              <a:gd name="connsiteX76" fmla="*/ 311150 w 520814"/>
              <a:gd name="connsiteY76" fmla="*/ 3175 h 895350"/>
              <a:gd name="connsiteX77" fmla="*/ 307975 w 520814"/>
              <a:gd name="connsiteY77" fmla="*/ 0 h 8953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</a:cxnLst>
            <a:rect l="l" t="t" r="r" b="b"/>
            <a:pathLst>
              <a:path w="520814" h="895350">
                <a:moveTo>
                  <a:pt x="307975" y="0"/>
                </a:moveTo>
                <a:cubicBezTo>
                  <a:pt x="299508" y="0"/>
                  <a:pt x="276189" y="1667"/>
                  <a:pt x="260350" y="3175"/>
                </a:cubicBezTo>
                <a:cubicBezTo>
                  <a:pt x="238863" y="5221"/>
                  <a:pt x="246958" y="5187"/>
                  <a:pt x="231775" y="9525"/>
                </a:cubicBezTo>
                <a:cubicBezTo>
                  <a:pt x="218513" y="13314"/>
                  <a:pt x="214994" y="13380"/>
                  <a:pt x="200025" y="15875"/>
                </a:cubicBezTo>
                <a:cubicBezTo>
                  <a:pt x="193675" y="17992"/>
                  <a:pt x="186544" y="18512"/>
                  <a:pt x="180975" y="22225"/>
                </a:cubicBezTo>
                <a:lnTo>
                  <a:pt x="142875" y="47625"/>
                </a:lnTo>
                <a:cubicBezTo>
                  <a:pt x="139139" y="50116"/>
                  <a:pt x="136525" y="53975"/>
                  <a:pt x="133350" y="57150"/>
                </a:cubicBezTo>
                <a:cubicBezTo>
                  <a:pt x="126200" y="78600"/>
                  <a:pt x="136116" y="55350"/>
                  <a:pt x="120650" y="73025"/>
                </a:cubicBezTo>
                <a:cubicBezTo>
                  <a:pt x="94721" y="102658"/>
                  <a:pt x="119856" y="84137"/>
                  <a:pt x="98425" y="98425"/>
                </a:cubicBezTo>
                <a:cubicBezTo>
                  <a:pt x="96308" y="101600"/>
                  <a:pt x="93782" y="104537"/>
                  <a:pt x="92075" y="107950"/>
                </a:cubicBezTo>
                <a:cubicBezTo>
                  <a:pt x="90578" y="110943"/>
                  <a:pt x="91267" y="115108"/>
                  <a:pt x="88900" y="117475"/>
                </a:cubicBezTo>
                <a:cubicBezTo>
                  <a:pt x="86533" y="119842"/>
                  <a:pt x="82550" y="119592"/>
                  <a:pt x="79375" y="120650"/>
                </a:cubicBezTo>
                <a:cubicBezTo>
                  <a:pt x="77258" y="127000"/>
                  <a:pt x="76738" y="134131"/>
                  <a:pt x="73025" y="139700"/>
                </a:cubicBezTo>
                <a:cubicBezTo>
                  <a:pt x="70908" y="142875"/>
                  <a:pt x="68382" y="145812"/>
                  <a:pt x="66675" y="149225"/>
                </a:cubicBezTo>
                <a:cubicBezTo>
                  <a:pt x="65178" y="152218"/>
                  <a:pt x="65356" y="155965"/>
                  <a:pt x="63500" y="158750"/>
                </a:cubicBezTo>
                <a:cubicBezTo>
                  <a:pt x="61009" y="162486"/>
                  <a:pt x="57150" y="165100"/>
                  <a:pt x="53975" y="168275"/>
                </a:cubicBezTo>
                <a:cubicBezTo>
                  <a:pt x="48387" y="185040"/>
                  <a:pt x="52656" y="175015"/>
                  <a:pt x="38100" y="196850"/>
                </a:cubicBezTo>
                <a:cubicBezTo>
                  <a:pt x="36244" y="199635"/>
                  <a:pt x="36422" y="203382"/>
                  <a:pt x="34925" y="206375"/>
                </a:cubicBezTo>
                <a:cubicBezTo>
                  <a:pt x="33218" y="209788"/>
                  <a:pt x="30125" y="212413"/>
                  <a:pt x="28575" y="215900"/>
                </a:cubicBezTo>
                <a:cubicBezTo>
                  <a:pt x="25857" y="222017"/>
                  <a:pt x="24342" y="228600"/>
                  <a:pt x="22225" y="234950"/>
                </a:cubicBezTo>
                <a:cubicBezTo>
                  <a:pt x="17343" y="249595"/>
                  <a:pt x="19706" y="241193"/>
                  <a:pt x="15875" y="260350"/>
                </a:cubicBezTo>
                <a:cubicBezTo>
                  <a:pt x="7546" y="393607"/>
                  <a:pt x="18364" y="208586"/>
                  <a:pt x="9525" y="482600"/>
                </a:cubicBezTo>
                <a:cubicBezTo>
                  <a:pt x="9250" y="491128"/>
                  <a:pt x="7922" y="499614"/>
                  <a:pt x="6350" y="508000"/>
                </a:cubicBezTo>
                <a:cubicBezTo>
                  <a:pt x="4742" y="516578"/>
                  <a:pt x="0" y="533400"/>
                  <a:pt x="0" y="533400"/>
                </a:cubicBezTo>
                <a:cubicBezTo>
                  <a:pt x="1058" y="577850"/>
                  <a:pt x="401" y="622374"/>
                  <a:pt x="3175" y="666750"/>
                </a:cubicBezTo>
                <a:cubicBezTo>
                  <a:pt x="3593" y="673430"/>
                  <a:pt x="7408" y="679450"/>
                  <a:pt x="9525" y="685800"/>
                </a:cubicBezTo>
                <a:lnTo>
                  <a:pt x="12700" y="695325"/>
                </a:lnTo>
                <a:lnTo>
                  <a:pt x="19050" y="714375"/>
                </a:lnTo>
                <a:cubicBezTo>
                  <a:pt x="20108" y="717550"/>
                  <a:pt x="20369" y="721115"/>
                  <a:pt x="22225" y="723900"/>
                </a:cubicBezTo>
                <a:cubicBezTo>
                  <a:pt x="24342" y="727075"/>
                  <a:pt x="26868" y="730012"/>
                  <a:pt x="28575" y="733425"/>
                </a:cubicBezTo>
                <a:cubicBezTo>
                  <a:pt x="30072" y="736418"/>
                  <a:pt x="30125" y="740024"/>
                  <a:pt x="31750" y="742950"/>
                </a:cubicBezTo>
                <a:cubicBezTo>
                  <a:pt x="35456" y="749621"/>
                  <a:pt x="42037" y="754760"/>
                  <a:pt x="44450" y="762000"/>
                </a:cubicBezTo>
                <a:cubicBezTo>
                  <a:pt x="50038" y="778765"/>
                  <a:pt x="45769" y="768740"/>
                  <a:pt x="60325" y="790575"/>
                </a:cubicBezTo>
                <a:lnTo>
                  <a:pt x="92075" y="838200"/>
                </a:lnTo>
                <a:cubicBezTo>
                  <a:pt x="97056" y="845672"/>
                  <a:pt x="104775" y="850900"/>
                  <a:pt x="111125" y="857250"/>
                </a:cubicBezTo>
                <a:cubicBezTo>
                  <a:pt x="116094" y="862219"/>
                  <a:pt x="134524" y="872959"/>
                  <a:pt x="142875" y="876300"/>
                </a:cubicBezTo>
                <a:cubicBezTo>
                  <a:pt x="149090" y="878786"/>
                  <a:pt x="161925" y="882650"/>
                  <a:pt x="161925" y="882650"/>
                </a:cubicBezTo>
                <a:cubicBezTo>
                  <a:pt x="165100" y="884767"/>
                  <a:pt x="168037" y="887293"/>
                  <a:pt x="171450" y="889000"/>
                </a:cubicBezTo>
                <a:cubicBezTo>
                  <a:pt x="181239" y="893894"/>
                  <a:pt x="197619" y="894256"/>
                  <a:pt x="206375" y="895350"/>
                </a:cubicBezTo>
                <a:cubicBezTo>
                  <a:pt x="238125" y="894292"/>
                  <a:pt x="269916" y="894097"/>
                  <a:pt x="301625" y="892175"/>
                </a:cubicBezTo>
                <a:cubicBezTo>
                  <a:pt x="310706" y="891625"/>
                  <a:pt x="312999" y="886488"/>
                  <a:pt x="320675" y="882650"/>
                </a:cubicBezTo>
                <a:cubicBezTo>
                  <a:pt x="323668" y="881153"/>
                  <a:pt x="327025" y="880533"/>
                  <a:pt x="330200" y="879475"/>
                </a:cubicBezTo>
                <a:cubicBezTo>
                  <a:pt x="332317" y="876300"/>
                  <a:pt x="333570" y="872334"/>
                  <a:pt x="336550" y="869950"/>
                </a:cubicBezTo>
                <a:cubicBezTo>
                  <a:pt x="339163" y="867859"/>
                  <a:pt x="343082" y="868272"/>
                  <a:pt x="346075" y="866775"/>
                </a:cubicBezTo>
                <a:cubicBezTo>
                  <a:pt x="349488" y="865068"/>
                  <a:pt x="352425" y="862542"/>
                  <a:pt x="355600" y="860425"/>
                </a:cubicBezTo>
                <a:cubicBezTo>
                  <a:pt x="370791" y="837639"/>
                  <a:pt x="362904" y="846771"/>
                  <a:pt x="377825" y="831850"/>
                </a:cubicBezTo>
                <a:cubicBezTo>
                  <a:pt x="383413" y="815085"/>
                  <a:pt x="379144" y="825110"/>
                  <a:pt x="393700" y="803275"/>
                </a:cubicBezTo>
                <a:cubicBezTo>
                  <a:pt x="395817" y="800100"/>
                  <a:pt x="398843" y="797370"/>
                  <a:pt x="400050" y="793750"/>
                </a:cubicBezTo>
                <a:cubicBezTo>
                  <a:pt x="405638" y="776985"/>
                  <a:pt x="401369" y="787010"/>
                  <a:pt x="415925" y="765175"/>
                </a:cubicBezTo>
                <a:cubicBezTo>
                  <a:pt x="418042" y="762000"/>
                  <a:pt x="421068" y="759270"/>
                  <a:pt x="422275" y="755650"/>
                </a:cubicBezTo>
                <a:cubicBezTo>
                  <a:pt x="431038" y="729360"/>
                  <a:pt x="424912" y="742169"/>
                  <a:pt x="441325" y="717550"/>
                </a:cubicBezTo>
                <a:cubicBezTo>
                  <a:pt x="445038" y="711981"/>
                  <a:pt x="445558" y="704850"/>
                  <a:pt x="447675" y="698500"/>
                </a:cubicBezTo>
                <a:lnTo>
                  <a:pt x="460375" y="660400"/>
                </a:lnTo>
                <a:cubicBezTo>
                  <a:pt x="461582" y="656780"/>
                  <a:pt x="465175" y="654362"/>
                  <a:pt x="466725" y="650875"/>
                </a:cubicBezTo>
                <a:cubicBezTo>
                  <a:pt x="473633" y="635332"/>
                  <a:pt x="471987" y="633333"/>
                  <a:pt x="476250" y="619125"/>
                </a:cubicBezTo>
                <a:cubicBezTo>
                  <a:pt x="478173" y="612714"/>
                  <a:pt x="480483" y="606425"/>
                  <a:pt x="482600" y="600075"/>
                </a:cubicBezTo>
                <a:lnTo>
                  <a:pt x="488950" y="581025"/>
                </a:lnTo>
                <a:cubicBezTo>
                  <a:pt x="490008" y="577850"/>
                  <a:pt x="491313" y="574747"/>
                  <a:pt x="492125" y="571500"/>
                </a:cubicBezTo>
                <a:cubicBezTo>
                  <a:pt x="493183" y="567267"/>
                  <a:pt x="494046" y="562980"/>
                  <a:pt x="495300" y="558800"/>
                </a:cubicBezTo>
                <a:cubicBezTo>
                  <a:pt x="498185" y="549183"/>
                  <a:pt x="501650" y="539750"/>
                  <a:pt x="504825" y="530225"/>
                </a:cubicBezTo>
                <a:cubicBezTo>
                  <a:pt x="507067" y="523499"/>
                  <a:pt x="509917" y="507941"/>
                  <a:pt x="511175" y="501650"/>
                </a:cubicBezTo>
                <a:cubicBezTo>
                  <a:pt x="513757" y="465504"/>
                  <a:pt x="517525" y="418557"/>
                  <a:pt x="517525" y="384175"/>
                </a:cubicBezTo>
                <a:cubicBezTo>
                  <a:pt x="517525" y="257243"/>
                  <a:pt x="528165" y="292271"/>
                  <a:pt x="511175" y="241300"/>
                </a:cubicBezTo>
                <a:cubicBezTo>
                  <a:pt x="510841" y="238959"/>
                  <a:pt x="505316" y="194418"/>
                  <a:pt x="501650" y="180975"/>
                </a:cubicBezTo>
                <a:cubicBezTo>
                  <a:pt x="499889" y="174517"/>
                  <a:pt x="497417" y="168275"/>
                  <a:pt x="495300" y="161925"/>
                </a:cubicBezTo>
                <a:lnTo>
                  <a:pt x="488950" y="142875"/>
                </a:lnTo>
                <a:lnTo>
                  <a:pt x="485775" y="133350"/>
                </a:lnTo>
                <a:cubicBezTo>
                  <a:pt x="484717" y="130175"/>
                  <a:pt x="484456" y="126610"/>
                  <a:pt x="482600" y="123825"/>
                </a:cubicBezTo>
                <a:cubicBezTo>
                  <a:pt x="480483" y="120650"/>
                  <a:pt x="477800" y="117787"/>
                  <a:pt x="476250" y="114300"/>
                </a:cubicBezTo>
                <a:cubicBezTo>
                  <a:pt x="468339" y="96500"/>
                  <a:pt x="473815" y="98043"/>
                  <a:pt x="463550" y="85725"/>
                </a:cubicBezTo>
                <a:cubicBezTo>
                  <a:pt x="460675" y="82276"/>
                  <a:pt x="457200" y="79375"/>
                  <a:pt x="454025" y="76200"/>
                </a:cubicBezTo>
                <a:cubicBezTo>
                  <a:pt x="448507" y="59646"/>
                  <a:pt x="454930" y="72419"/>
                  <a:pt x="441325" y="60325"/>
                </a:cubicBezTo>
                <a:cubicBezTo>
                  <a:pt x="415625" y="37481"/>
                  <a:pt x="432391" y="44647"/>
                  <a:pt x="412750" y="38100"/>
                </a:cubicBezTo>
                <a:cubicBezTo>
                  <a:pt x="406400" y="33867"/>
                  <a:pt x="400940" y="27813"/>
                  <a:pt x="393700" y="25400"/>
                </a:cubicBezTo>
                <a:lnTo>
                  <a:pt x="365125" y="15875"/>
                </a:lnTo>
                <a:cubicBezTo>
                  <a:pt x="361950" y="14817"/>
                  <a:pt x="358847" y="13512"/>
                  <a:pt x="355600" y="12700"/>
                </a:cubicBezTo>
                <a:cubicBezTo>
                  <a:pt x="332429" y="6907"/>
                  <a:pt x="347179" y="10381"/>
                  <a:pt x="311150" y="3175"/>
                </a:cubicBezTo>
                <a:cubicBezTo>
                  <a:pt x="303886" y="1722"/>
                  <a:pt x="316442" y="0"/>
                  <a:pt x="307975" y="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71" name="フリーフォーム 170"/>
          <p:cNvSpPr/>
          <p:nvPr/>
        </p:nvSpPr>
        <p:spPr>
          <a:xfrm>
            <a:off x="5484996" y="3867398"/>
            <a:ext cx="520814" cy="895350"/>
          </a:xfrm>
          <a:custGeom>
            <a:avLst/>
            <a:gdLst>
              <a:gd name="connsiteX0" fmla="*/ 307975 w 520814"/>
              <a:gd name="connsiteY0" fmla="*/ 0 h 895350"/>
              <a:gd name="connsiteX1" fmla="*/ 260350 w 520814"/>
              <a:gd name="connsiteY1" fmla="*/ 3175 h 895350"/>
              <a:gd name="connsiteX2" fmla="*/ 231775 w 520814"/>
              <a:gd name="connsiteY2" fmla="*/ 9525 h 895350"/>
              <a:gd name="connsiteX3" fmla="*/ 200025 w 520814"/>
              <a:gd name="connsiteY3" fmla="*/ 15875 h 895350"/>
              <a:gd name="connsiteX4" fmla="*/ 180975 w 520814"/>
              <a:gd name="connsiteY4" fmla="*/ 22225 h 895350"/>
              <a:gd name="connsiteX5" fmla="*/ 142875 w 520814"/>
              <a:gd name="connsiteY5" fmla="*/ 47625 h 895350"/>
              <a:gd name="connsiteX6" fmla="*/ 133350 w 520814"/>
              <a:gd name="connsiteY6" fmla="*/ 57150 h 895350"/>
              <a:gd name="connsiteX7" fmla="*/ 120650 w 520814"/>
              <a:gd name="connsiteY7" fmla="*/ 73025 h 895350"/>
              <a:gd name="connsiteX8" fmla="*/ 98425 w 520814"/>
              <a:gd name="connsiteY8" fmla="*/ 98425 h 895350"/>
              <a:gd name="connsiteX9" fmla="*/ 92075 w 520814"/>
              <a:gd name="connsiteY9" fmla="*/ 107950 h 895350"/>
              <a:gd name="connsiteX10" fmla="*/ 88900 w 520814"/>
              <a:gd name="connsiteY10" fmla="*/ 117475 h 895350"/>
              <a:gd name="connsiteX11" fmla="*/ 79375 w 520814"/>
              <a:gd name="connsiteY11" fmla="*/ 120650 h 895350"/>
              <a:gd name="connsiteX12" fmla="*/ 73025 w 520814"/>
              <a:gd name="connsiteY12" fmla="*/ 139700 h 895350"/>
              <a:gd name="connsiteX13" fmla="*/ 66675 w 520814"/>
              <a:gd name="connsiteY13" fmla="*/ 149225 h 895350"/>
              <a:gd name="connsiteX14" fmla="*/ 63500 w 520814"/>
              <a:gd name="connsiteY14" fmla="*/ 158750 h 895350"/>
              <a:gd name="connsiteX15" fmla="*/ 53975 w 520814"/>
              <a:gd name="connsiteY15" fmla="*/ 168275 h 895350"/>
              <a:gd name="connsiteX16" fmla="*/ 38100 w 520814"/>
              <a:gd name="connsiteY16" fmla="*/ 196850 h 895350"/>
              <a:gd name="connsiteX17" fmla="*/ 34925 w 520814"/>
              <a:gd name="connsiteY17" fmla="*/ 206375 h 895350"/>
              <a:gd name="connsiteX18" fmla="*/ 28575 w 520814"/>
              <a:gd name="connsiteY18" fmla="*/ 215900 h 895350"/>
              <a:gd name="connsiteX19" fmla="*/ 22225 w 520814"/>
              <a:gd name="connsiteY19" fmla="*/ 234950 h 895350"/>
              <a:gd name="connsiteX20" fmla="*/ 15875 w 520814"/>
              <a:gd name="connsiteY20" fmla="*/ 260350 h 895350"/>
              <a:gd name="connsiteX21" fmla="*/ 9525 w 520814"/>
              <a:gd name="connsiteY21" fmla="*/ 482600 h 895350"/>
              <a:gd name="connsiteX22" fmla="*/ 6350 w 520814"/>
              <a:gd name="connsiteY22" fmla="*/ 508000 h 895350"/>
              <a:gd name="connsiteX23" fmla="*/ 0 w 520814"/>
              <a:gd name="connsiteY23" fmla="*/ 533400 h 895350"/>
              <a:gd name="connsiteX24" fmla="*/ 3175 w 520814"/>
              <a:gd name="connsiteY24" fmla="*/ 666750 h 895350"/>
              <a:gd name="connsiteX25" fmla="*/ 9525 w 520814"/>
              <a:gd name="connsiteY25" fmla="*/ 685800 h 895350"/>
              <a:gd name="connsiteX26" fmla="*/ 12700 w 520814"/>
              <a:gd name="connsiteY26" fmla="*/ 695325 h 895350"/>
              <a:gd name="connsiteX27" fmla="*/ 19050 w 520814"/>
              <a:gd name="connsiteY27" fmla="*/ 714375 h 895350"/>
              <a:gd name="connsiteX28" fmla="*/ 22225 w 520814"/>
              <a:gd name="connsiteY28" fmla="*/ 723900 h 895350"/>
              <a:gd name="connsiteX29" fmla="*/ 28575 w 520814"/>
              <a:gd name="connsiteY29" fmla="*/ 733425 h 895350"/>
              <a:gd name="connsiteX30" fmla="*/ 31750 w 520814"/>
              <a:gd name="connsiteY30" fmla="*/ 742950 h 895350"/>
              <a:gd name="connsiteX31" fmla="*/ 44450 w 520814"/>
              <a:gd name="connsiteY31" fmla="*/ 762000 h 895350"/>
              <a:gd name="connsiteX32" fmla="*/ 60325 w 520814"/>
              <a:gd name="connsiteY32" fmla="*/ 790575 h 895350"/>
              <a:gd name="connsiteX33" fmla="*/ 92075 w 520814"/>
              <a:gd name="connsiteY33" fmla="*/ 838200 h 895350"/>
              <a:gd name="connsiteX34" fmla="*/ 111125 w 520814"/>
              <a:gd name="connsiteY34" fmla="*/ 857250 h 895350"/>
              <a:gd name="connsiteX35" fmla="*/ 142875 w 520814"/>
              <a:gd name="connsiteY35" fmla="*/ 876300 h 895350"/>
              <a:gd name="connsiteX36" fmla="*/ 161925 w 520814"/>
              <a:gd name="connsiteY36" fmla="*/ 882650 h 895350"/>
              <a:gd name="connsiteX37" fmla="*/ 171450 w 520814"/>
              <a:gd name="connsiteY37" fmla="*/ 889000 h 895350"/>
              <a:gd name="connsiteX38" fmla="*/ 206375 w 520814"/>
              <a:gd name="connsiteY38" fmla="*/ 895350 h 895350"/>
              <a:gd name="connsiteX39" fmla="*/ 301625 w 520814"/>
              <a:gd name="connsiteY39" fmla="*/ 892175 h 895350"/>
              <a:gd name="connsiteX40" fmla="*/ 320675 w 520814"/>
              <a:gd name="connsiteY40" fmla="*/ 882650 h 895350"/>
              <a:gd name="connsiteX41" fmla="*/ 330200 w 520814"/>
              <a:gd name="connsiteY41" fmla="*/ 879475 h 895350"/>
              <a:gd name="connsiteX42" fmla="*/ 336550 w 520814"/>
              <a:gd name="connsiteY42" fmla="*/ 869950 h 895350"/>
              <a:gd name="connsiteX43" fmla="*/ 346075 w 520814"/>
              <a:gd name="connsiteY43" fmla="*/ 866775 h 895350"/>
              <a:gd name="connsiteX44" fmla="*/ 355600 w 520814"/>
              <a:gd name="connsiteY44" fmla="*/ 860425 h 895350"/>
              <a:gd name="connsiteX45" fmla="*/ 377825 w 520814"/>
              <a:gd name="connsiteY45" fmla="*/ 831850 h 895350"/>
              <a:gd name="connsiteX46" fmla="*/ 393700 w 520814"/>
              <a:gd name="connsiteY46" fmla="*/ 803275 h 895350"/>
              <a:gd name="connsiteX47" fmla="*/ 400050 w 520814"/>
              <a:gd name="connsiteY47" fmla="*/ 793750 h 895350"/>
              <a:gd name="connsiteX48" fmla="*/ 415925 w 520814"/>
              <a:gd name="connsiteY48" fmla="*/ 765175 h 895350"/>
              <a:gd name="connsiteX49" fmla="*/ 422275 w 520814"/>
              <a:gd name="connsiteY49" fmla="*/ 755650 h 895350"/>
              <a:gd name="connsiteX50" fmla="*/ 441325 w 520814"/>
              <a:gd name="connsiteY50" fmla="*/ 717550 h 895350"/>
              <a:gd name="connsiteX51" fmla="*/ 447675 w 520814"/>
              <a:gd name="connsiteY51" fmla="*/ 698500 h 895350"/>
              <a:gd name="connsiteX52" fmla="*/ 460375 w 520814"/>
              <a:gd name="connsiteY52" fmla="*/ 660400 h 895350"/>
              <a:gd name="connsiteX53" fmla="*/ 466725 w 520814"/>
              <a:gd name="connsiteY53" fmla="*/ 650875 h 895350"/>
              <a:gd name="connsiteX54" fmla="*/ 476250 w 520814"/>
              <a:gd name="connsiteY54" fmla="*/ 619125 h 895350"/>
              <a:gd name="connsiteX55" fmla="*/ 482600 w 520814"/>
              <a:gd name="connsiteY55" fmla="*/ 600075 h 895350"/>
              <a:gd name="connsiteX56" fmla="*/ 488950 w 520814"/>
              <a:gd name="connsiteY56" fmla="*/ 581025 h 895350"/>
              <a:gd name="connsiteX57" fmla="*/ 492125 w 520814"/>
              <a:gd name="connsiteY57" fmla="*/ 571500 h 895350"/>
              <a:gd name="connsiteX58" fmla="*/ 495300 w 520814"/>
              <a:gd name="connsiteY58" fmla="*/ 558800 h 895350"/>
              <a:gd name="connsiteX59" fmla="*/ 504825 w 520814"/>
              <a:gd name="connsiteY59" fmla="*/ 530225 h 895350"/>
              <a:gd name="connsiteX60" fmla="*/ 511175 w 520814"/>
              <a:gd name="connsiteY60" fmla="*/ 501650 h 895350"/>
              <a:gd name="connsiteX61" fmla="*/ 517525 w 520814"/>
              <a:gd name="connsiteY61" fmla="*/ 384175 h 895350"/>
              <a:gd name="connsiteX62" fmla="*/ 511175 w 520814"/>
              <a:gd name="connsiteY62" fmla="*/ 241300 h 895350"/>
              <a:gd name="connsiteX63" fmla="*/ 501650 w 520814"/>
              <a:gd name="connsiteY63" fmla="*/ 180975 h 895350"/>
              <a:gd name="connsiteX64" fmla="*/ 495300 w 520814"/>
              <a:gd name="connsiteY64" fmla="*/ 161925 h 895350"/>
              <a:gd name="connsiteX65" fmla="*/ 488950 w 520814"/>
              <a:gd name="connsiteY65" fmla="*/ 142875 h 895350"/>
              <a:gd name="connsiteX66" fmla="*/ 485775 w 520814"/>
              <a:gd name="connsiteY66" fmla="*/ 133350 h 895350"/>
              <a:gd name="connsiteX67" fmla="*/ 482600 w 520814"/>
              <a:gd name="connsiteY67" fmla="*/ 123825 h 895350"/>
              <a:gd name="connsiteX68" fmla="*/ 476250 w 520814"/>
              <a:gd name="connsiteY68" fmla="*/ 114300 h 895350"/>
              <a:gd name="connsiteX69" fmla="*/ 463550 w 520814"/>
              <a:gd name="connsiteY69" fmla="*/ 85725 h 895350"/>
              <a:gd name="connsiteX70" fmla="*/ 454025 w 520814"/>
              <a:gd name="connsiteY70" fmla="*/ 76200 h 895350"/>
              <a:gd name="connsiteX71" fmla="*/ 441325 w 520814"/>
              <a:gd name="connsiteY71" fmla="*/ 60325 h 895350"/>
              <a:gd name="connsiteX72" fmla="*/ 412750 w 520814"/>
              <a:gd name="connsiteY72" fmla="*/ 38100 h 895350"/>
              <a:gd name="connsiteX73" fmla="*/ 393700 w 520814"/>
              <a:gd name="connsiteY73" fmla="*/ 25400 h 895350"/>
              <a:gd name="connsiteX74" fmla="*/ 365125 w 520814"/>
              <a:gd name="connsiteY74" fmla="*/ 15875 h 895350"/>
              <a:gd name="connsiteX75" fmla="*/ 355600 w 520814"/>
              <a:gd name="connsiteY75" fmla="*/ 12700 h 895350"/>
              <a:gd name="connsiteX76" fmla="*/ 311150 w 520814"/>
              <a:gd name="connsiteY76" fmla="*/ 3175 h 895350"/>
              <a:gd name="connsiteX77" fmla="*/ 307975 w 520814"/>
              <a:gd name="connsiteY77" fmla="*/ 0 h 8953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</a:cxnLst>
            <a:rect l="l" t="t" r="r" b="b"/>
            <a:pathLst>
              <a:path w="520814" h="895350">
                <a:moveTo>
                  <a:pt x="307975" y="0"/>
                </a:moveTo>
                <a:cubicBezTo>
                  <a:pt x="299508" y="0"/>
                  <a:pt x="276189" y="1667"/>
                  <a:pt x="260350" y="3175"/>
                </a:cubicBezTo>
                <a:cubicBezTo>
                  <a:pt x="238863" y="5221"/>
                  <a:pt x="246958" y="5187"/>
                  <a:pt x="231775" y="9525"/>
                </a:cubicBezTo>
                <a:cubicBezTo>
                  <a:pt x="218513" y="13314"/>
                  <a:pt x="214994" y="13380"/>
                  <a:pt x="200025" y="15875"/>
                </a:cubicBezTo>
                <a:cubicBezTo>
                  <a:pt x="193675" y="17992"/>
                  <a:pt x="186544" y="18512"/>
                  <a:pt x="180975" y="22225"/>
                </a:cubicBezTo>
                <a:lnTo>
                  <a:pt x="142875" y="47625"/>
                </a:lnTo>
                <a:cubicBezTo>
                  <a:pt x="139139" y="50116"/>
                  <a:pt x="136525" y="53975"/>
                  <a:pt x="133350" y="57150"/>
                </a:cubicBezTo>
                <a:cubicBezTo>
                  <a:pt x="126200" y="78600"/>
                  <a:pt x="136116" y="55350"/>
                  <a:pt x="120650" y="73025"/>
                </a:cubicBezTo>
                <a:cubicBezTo>
                  <a:pt x="94721" y="102658"/>
                  <a:pt x="119856" y="84137"/>
                  <a:pt x="98425" y="98425"/>
                </a:cubicBezTo>
                <a:cubicBezTo>
                  <a:pt x="96308" y="101600"/>
                  <a:pt x="93782" y="104537"/>
                  <a:pt x="92075" y="107950"/>
                </a:cubicBezTo>
                <a:cubicBezTo>
                  <a:pt x="90578" y="110943"/>
                  <a:pt x="91267" y="115108"/>
                  <a:pt x="88900" y="117475"/>
                </a:cubicBezTo>
                <a:cubicBezTo>
                  <a:pt x="86533" y="119842"/>
                  <a:pt x="82550" y="119592"/>
                  <a:pt x="79375" y="120650"/>
                </a:cubicBezTo>
                <a:cubicBezTo>
                  <a:pt x="77258" y="127000"/>
                  <a:pt x="76738" y="134131"/>
                  <a:pt x="73025" y="139700"/>
                </a:cubicBezTo>
                <a:cubicBezTo>
                  <a:pt x="70908" y="142875"/>
                  <a:pt x="68382" y="145812"/>
                  <a:pt x="66675" y="149225"/>
                </a:cubicBezTo>
                <a:cubicBezTo>
                  <a:pt x="65178" y="152218"/>
                  <a:pt x="65356" y="155965"/>
                  <a:pt x="63500" y="158750"/>
                </a:cubicBezTo>
                <a:cubicBezTo>
                  <a:pt x="61009" y="162486"/>
                  <a:pt x="57150" y="165100"/>
                  <a:pt x="53975" y="168275"/>
                </a:cubicBezTo>
                <a:cubicBezTo>
                  <a:pt x="48387" y="185040"/>
                  <a:pt x="52656" y="175015"/>
                  <a:pt x="38100" y="196850"/>
                </a:cubicBezTo>
                <a:cubicBezTo>
                  <a:pt x="36244" y="199635"/>
                  <a:pt x="36422" y="203382"/>
                  <a:pt x="34925" y="206375"/>
                </a:cubicBezTo>
                <a:cubicBezTo>
                  <a:pt x="33218" y="209788"/>
                  <a:pt x="30125" y="212413"/>
                  <a:pt x="28575" y="215900"/>
                </a:cubicBezTo>
                <a:cubicBezTo>
                  <a:pt x="25857" y="222017"/>
                  <a:pt x="24342" y="228600"/>
                  <a:pt x="22225" y="234950"/>
                </a:cubicBezTo>
                <a:cubicBezTo>
                  <a:pt x="17343" y="249595"/>
                  <a:pt x="19706" y="241193"/>
                  <a:pt x="15875" y="260350"/>
                </a:cubicBezTo>
                <a:cubicBezTo>
                  <a:pt x="7546" y="393607"/>
                  <a:pt x="18364" y="208586"/>
                  <a:pt x="9525" y="482600"/>
                </a:cubicBezTo>
                <a:cubicBezTo>
                  <a:pt x="9250" y="491128"/>
                  <a:pt x="7922" y="499614"/>
                  <a:pt x="6350" y="508000"/>
                </a:cubicBezTo>
                <a:cubicBezTo>
                  <a:pt x="4742" y="516578"/>
                  <a:pt x="0" y="533400"/>
                  <a:pt x="0" y="533400"/>
                </a:cubicBezTo>
                <a:cubicBezTo>
                  <a:pt x="1058" y="577850"/>
                  <a:pt x="401" y="622374"/>
                  <a:pt x="3175" y="666750"/>
                </a:cubicBezTo>
                <a:cubicBezTo>
                  <a:pt x="3593" y="673430"/>
                  <a:pt x="7408" y="679450"/>
                  <a:pt x="9525" y="685800"/>
                </a:cubicBezTo>
                <a:lnTo>
                  <a:pt x="12700" y="695325"/>
                </a:lnTo>
                <a:lnTo>
                  <a:pt x="19050" y="714375"/>
                </a:lnTo>
                <a:cubicBezTo>
                  <a:pt x="20108" y="717550"/>
                  <a:pt x="20369" y="721115"/>
                  <a:pt x="22225" y="723900"/>
                </a:cubicBezTo>
                <a:cubicBezTo>
                  <a:pt x="24342" y="727075"/>
                  <a:pt x="26868" y="730012"/>
                  <a:pt x="28575" y="733425"/>
                </a:cubicBezTo>
                <a:cubicBezTo>
                  <a:pt x="30072" y="736418"/>
                  <a:pt x="30125" y="740024"/>
                  <a:pt x="31750" y="742950"/>
                </a:cubicBezTo>
                <a:cubicBezTo>
                  <a:pt x="35456" y="749621"/>
                  <a:pt x="42037" y="754760"/>
                  <a:pt x="44450" y="762000"/>
                </a:cubicBezTo>
                <a:cubicBezTo>
                  <a:pt x="50038" y="778765"/>
                  <a:pt x="45769" y="768740"/>
                  <a:pt x="60325" y="790575"/>
                </a:cubicBezTo>
                <a:lnTo>
                  <a:pt x="92075" y="838200"/>
                </a:lnTo>
                <a:cubicBezTo>
                  <a:pt x="97056" y="845672"/>
                  <a:pt x="104775" y="850900"/>
                  <a:pt x="111125" y="857250"/>
                </a:cubicBezTo>
                <a:cubicBezTo>
                  <a:pt x="116094" y="862219"/>
                  <a:pt x="134524" y="872959"/>
                  <a:pt x="142875" y="876300"/>
                </a:cubicBezTo>
                <a:cubicBezTo>
                  <a:pt x="149090" y="878786"/>
                  <a:pt x="161925" y="882650"/>
                  <a:pt x="161925" y="882650"/>
                </a:cubicBezTo>
                <a:cubicBezTo>
                  <a:pt x="165100" y="884767"/>
                  <a:pt x="168037" y="887293"/>
                  <a:pt x="171450" y="889000"/>
                </a:cubicBezTo>
                <a:cubicBezTo>
                  <a:pt x="181239" y="893894"/>
                  <a:pt x="197619" y="894256"/>
                  <a:pt x="206375" y="895350"/>
                </a:cubicBezTo>
                <a:cubicBezTo>
                  <a:pt x="238125" y="894292"/>
                  <a:pt x="269916" y="894097"/>
                  <a:pt x="301625" y="892175"/>
                </a:cubicBezTo>
                <a:cubicBezTo>
                  <a:pt x="310706" y="891625"/>
                  <a:pt x="312999" y="886488"/>
                  <a:pt x="320675" y="882650"/>
                </a:cubicBezTo>
                <a:cubicBezTo>
                  <a:pt x="323668" y="881153"/>
                  <a:pt x="327025" y="880533"/>
                  <a:pt x="330200" y="879475"/>
                </a:cubicBezTo>
                <a:cubicBezTo>
                  <a:pt x="332317" y="876300"/>
                  <a:pt x="333570" y="872334"/>
                  <a:pt x="336550" y="869950"/>
                </a:cubicBezTo>
                <a:cubicBezTo>
                  <a:pt x="339163" y="867859"/>
                  <a:pt x="343082" y="868272"/>
                  <a:pt x="346075" y="866775"/>
                </a:cubicBezTo>
                <a:cubicBezTo>
                  <a:pt x="349488" y="865068"/>
                  <a:pt x="352425" y="862542"/>
                  <a:pt x="355600" y="860425"/>
                </a:cubicBezTo>
                <a:cubicBezTo>
                  <a:pt x="370791" y="837639"/>
                  <a:pt x="362904" y="846771"/>
                  <a:pt x="377825" y="831850"/>
                </a:cubicBezTo>
                <a:cubicBezTo>
                  <a:pt x="383413" y="815085"/>
                  <a:pt x="379144" y="825110"/>
                  <a:pt x="393700" y="803275"/>
                </a:cubicBezTo>
                <a:cubicBezTo>
                  <a:pt x="395817" y="800100"/>
                  <a:pt x="398843" y="797370"/>
                  <a:pt x="400050" y="793750"/>
                </a:cubicBezTo>
                <a:cubicBezTo>
                  <a:pt x="405638" y="776985"/>
                  <a:pt x="401369" y="787010"/>
                  <a:pt x="415925" y="765175"/>
                </a:cubicBezTo>
                <a:cubicBezTo>
                  <a:pt x="418042" y="762000"/>
                  <a:pt x="421068" y="759270"/>
                  <a:pt x="422275" y="755650"/>
                </a:cubicBezTo>
                <a:cubicBezTo>
                  <a:pt x="431038" y="729360"/>
                  <a:pt x="424912" y="742169"/>
                  <a:pt x="441325" y="717550"/>
                </a:cubicBezTo>
                <a:cubicBezTo>
                  <a:pt x="445038" y="711981"/>
                  <a:pt x="445558" y="704850"/>
                  <a:pt x="447675" y="698500"/>
                </a:cubicBezTo>
                <a:lnTo>
                  <a:pt x="460375" y="660400"/>
                </a:lnTo>
                <a:cubicBezTo>
                  <a:pt x="461582" y="656780"/>
                  <a:pt x="465175" y="654362"/>
                  <a:pt x="466725" y="650875"/>
                </a:cubicBezTo>
                <a:cubicBezTo>
                  <a:pt x="473633" y="635332"/>
                  <a:pt x="471987" y="633333"/>
                  <a:pt x="476250" y="619125"/>
                </a:cubicBezTo>
                <a:cubicBezTo>
                  <a:pt x="478173" y="612714"/>
                  <a:pt x="480483" y="606425"/>
                  <a:pt x="482600" y="600075"/>
                </a:cubicBezTo>
                <a:lnTo>
                  <a:pt x="488950" y="581025"/>
                </a:lnTo>
                <a:cubicBezTo>
                  <a:pt x="490008" y="577850"/>
                  <a:pt x="491313" y="574747"/>
                  <a:pt x="492125" y="571500"/>
                </a:cubicBezTo>
                <a:cubicBezTo>
                  <a:pt x="493183" y="567267"/>
                  <a:pt x="494046" y="562980"/>
                  <a:pt x="495300" y="558800"/>
                </a:cubicBezTo>
                <a:cubicBezTo>
                  <a:pt x="498185" y="549183"/>
                  <a:pt x="501650" y="539750"/>
                  <a:pt x="504825" y="530225"/>
                </a:cubicBezTo>
                <a:cubicBezTo>
                  <a:pt x="507067" y="523499"/>
                  <a:pt x="509917" y="507941"/>
                  <a:pt x="511175" y="501650"/>
                </a:cubicBezTo>
                <a:cubicBezTo>
                  <a:pt x="513757" y="465504"/>
                  <a:pt x="517525" y="418557"/>
                  <a:pt x="517525" y="384175"/>
                </a:cubicBezTo>
                <a:cubicBezTo>
                  <a:pt x="517525" y="257243"/>
                  <a:pt x="528165" y="292271"/>
                  <a:pt x="511175" y="241300"/>
                </a:cubicBezTo>
                <a:cubicBezTo>
                  <a:pt x="510841" y="238959"/>
                  <a:pt x="505316" y="194418"/>
                  <a:pt x="501650" y="180975"/>
                </a:cubicBezTo>
                <a:cubicBezTo>
                  <a:pt x="499889" y="174517"/>
                  <a:pt x="497417" y="168275"/>
                  <a:pt x="495300" y="161925"/>
                </a:cubicBezTo>
                <a:lnTo>
                  <a:pt x="488950" y="142875"/>
                </a:lnTo>
                <a:lnTo>
                  <a:pt x="485775" y="133350"/>
                </a:lnTo>
                <a:cubicBezTo>
                  <a:pt x="484717" y="130175"/>
                  <a:pt x="484456" y="126610"/>
                  <a:pt x="482600" y="123825"/>
                </a:cubicBezTo>
                <a:cubicBezTo>
                  <a:pt x="480483" y="120650"/>
                  <a:pt x="477800" y="117787"/>
                  <a:pt x="476250" y="114300"/>
                </a:cubicBezTo>
                <a:cubicBezTo>
                  <a:pt x="468339" y="96500"/>
                  <a:pt x="473815" y="98043"/>
                  <a:pt x="463550" y="85725"/>
                </a:cubicBezTo>
                <a:cubicBezTo>
                  <a:pt x="460675" y="82276"/>
                  <a:pt x="457200" y="79375"/>
                  <a:pt x="454025" y="76200"/>
                </a:cubicBezTo>
                <a:cubicBezTo>
                  <a:pt x="448507" y="59646"/>
                  <a:pt x="454930" y="72419"/>
                  <a:pt x="441325" y="60325"/>
                </a:cubicBezTo>
                <a:cubicBezTo>
                  <a:pt x="415625" y="37481"/>
                  <a:pt x="432391" y="44647"/>
                  <a:pt x="412750" y="38100"/>
                </a:cubicBezTo>
                <a:cubicBezTo>
                  <a:pt x="406400" y="33867"/>
                  <a:pt x="400940" y="27813"/>
                  <a:pt x="393700" y="25400"/>
                </a:cubicBezTo>
                <a:lnTo>
                  <a:pt x="365125" y="15875"/>
                </a:lnTo>
                <a:cubicBezTo>
                  <a:pt x="361950" y="14817"/>
                  <a:pt x="358847" y="13512"/>
                  <a:pt x="355600" y="12700"/>
                </a:cubicBezTo>
                <a:cubicBezTo>
                  <a:pt x="332429" y="6907"/>
                  <a:pt x="347179" y="10381"/>
                  <a:pt x="311150" y="3175"/>
                </a:cubicBezTo>
                <a:cubicBezTo>
                  <a:pt x="303886" y="1722"/>
                  <a:pt x="316442" y="0"/>
                  <a:pt x="307975" y="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7" name="フリーフォーム 36"/>
          <p:cNvSpPr/>
          <p:nvPr/>
        </p:nvSpPr>
        <p:spPr>
          <a:xfrm>
            <a:off x="8074025" y="5203825"/>
            <a:ext cx="914400" cy="708025"/>
          </a:xfrm>
          <a:custGeom>
            <a:avLst/>
            <a:gdLst>
              <a:gd name="connsiteX0" fmla="*/ 425450 w 914400"/>
              <a:gd name="connsiteY0" fmla="*/ 114300 h 708025"/>
              <a:gd name="connsiteX1" fmla="*/ 409575 w 914400"/>
              <a:gd name="connsiteY1" fmla="*/ 104775 h 708025"/>
              <a:gd name="connsiteX2" fmla="*/ 393700 w 914400"/>
              <a:gd name="connsiteY2" fmla="*/ 92075 h 708025"/>
              <a:gd name="connsiteX3" fmla="*/ 384175 w 914400"/>
              <a:gd name="connsiteY3" fmla="*/ 73025 h 708025"/>
              <a:gd name="connsiteX4" fmla="*/ 374650 w 914400"/>
              <a:gd name="connsiteY4" fmla="*/ 69850 h 708025"/>
              <a:gd name="connsiteX5" fmla="*/ 365125 w 914400"/>
              <a:gd name="connsiteY5" fmla="*/ 63500 h 708025"/>
              <a:gd name="connsiteX6" fmla="*/ 355600 w 914400"/>
              <a:gd name="connsiteY6" fmla="*/ 53975 h 708025"/>
              <a:gd name="connsiteX7" fmla="*/ 346075 w 914400"/>
              <a:gd name="connsiteY7" fmla="*/ 50800 h 708025"/>
              <a:gd name="connsiteX8" fmla="*/ 327025 w 914400"/>
              <a:gd name="connsiteY8" fmla="*/ 38100 h 708025"/>
              <a:gd name="connsiteX9" fmla="*/ 307975 w 914400"/>
              <a:gd name="connsiteY9" fmla="*/ 25400 h 708025"/>
              <a:gd name="connsiteX10" fmla="*/ 288925 w 914400"/>
              <a:gd name="connsiteY10" fmla="*/ 12700 h 708025"/>
              <a:gd name="connsiteX11" fmla="*/ 269875 w 914400"/>
              <a:gd name="connsiteY11" fmla="*/ 6350 h 708025"/>
              <a:gd name="connsiteX12" fmla="*/ 250825 w 914400"/>
              <a:gd name="connsiteY12" fmla="*/ 3175 h 708025"/>
              <a:gd name="connsiteX13" fmla="*/ 234950 w 914400"/>
              <a:gd name="connsiteY13" fmla="*/ 0 h 708025"/>
              <a:gd name="connsiteX14" fmla="*/ 177800 w 914400"/>
              <a:gd name="connsiteY14" fmla="*/ 6350 h 708025"/>
              <a:gd name="connsiteX15" fmla="*/ 168275 w 914400"/>
              <a:gd name="connsiteY15" fmla="*/ 9525 h 708025"/>
              <a:gd name="connsiteX16" fmla="*/ 149225 w 914400"/>
              <a:gd name="connsiteY16" fmla="*/ 19050 h 708025"/>
              <a:gd name="connsiteX17" fmla="*/ 130175 w 914400"/>
              <a:gd name="connsiteY17" fmla="*/ 28575 h 708025"/>
              <a:gd name="connsiteX18" fmla="*/ 82550 w 914400"/>
              <a:gd name="connsiteY18" fmla="*/ 60325 h 708025"/>
              <a:gd name="connsiteX19" fmla="*/ 63500 w 914400"/>
              <a:gd name="connsiteY19" fmla="*/ 73025 h 708025"/>
              <a:gd name="connsiteX20" fmla="*/ 53975 w 914400"/>
              <a:gd name="connsiteY20" fmla="*/ 79375 h 708025"/>
              <a:gd name="connsiteX21" fmla="*/ 47625 w 914400"/>
              <a:gd name="connsiteY21" fmla="*/ 88900 h 708025"/>
              <a:gd name="connsiteX22" fmla="*/ 38100 w 914400"/>
              <a:gd name="connsiteY22" fmla="*/ 92075 h 708025"/>
              <a:gd name="connsiteX23" fmla="*/ 25400 w 914400"/>
              <a:gd name="connsiteY23" fmla="*/ 111125 h 708025"/>
              <a:gd name="connsiteX24" fmla="*/ 19050 w 914400"/>
              <a:gd name="connsiteY24" fmla="*/ 120650 h 708025"/>
              <a:gd name="connsiteX25" fmla="*/ 12700 w 914400"/>
              <a:gd name="connsiteY25" fmla="*/ 130175 h 708025"/>
              <a:gd name="connsiteX26" fmla="*/ 6350 w 914400"/>
              <a:gd name="connsiteY26" fmla="*/ 149225 h 708025"/>
              <a:gd name="connsiteX27" fmla="*/ 3175 w 914400"/>
              <a:gd name="connsiteY27" fmla="*/ 158750 h 708025"/>
              <a:gd name="connsiteX28" fmla="*/ 0 w 914400"/>
              <a:gd name="connsiteY28" fmla="*/ 174625 h 708025"/>
              <a:gd name="connsiteX29" fmla="*/ 3175 w 914400"/>
              <a:gd name="connsiteY29" fmla="*/ 244475 h 708025"/>
              <a:gd name="connsiteX30" fmla="*/ 6350 w 914400"/>
              <a:gd name="connsiteY30" fmla="*/ 263525 h 708025"/>
              <a:gd name="connsiteX31" fmla="*/ 9525 w 914400"/>
              <a:gd name="connsiteY31" fmla="*/ 285750 h 708025"/>
              <a:gd name="connsiteX32" fmla="*/ 25400 w 914400"/>
              <a:gd name="connsiteY32" fmla="*/ 314325 h 708025"/>
              <a:gd name="connsiteX33" fmla="*/ 28575 w 914400"/>
              <a:gd name="connsiteY33" fmla="*/ 323850 h 708025"/>
              <a:gd name="connsiteX34" fmla="*/ 41275 w 914400"/>
              <a:gd name="connsiteY34" fmla="*/ 342900 h 708025"/>
              <a:gd name="connsiteX35" fmla="*/ 50800 w 914400"/>
              <a:gd name="connsiteY35" fmla="*/ 361950 h 708025"/>
              <a:gd name="connsiteX36" fmla="*/ 53975 w 914400"/>
              <a:gd name="connsiteY36" fmla="*/ 371475 h 708025"/>
              <a:gd name="connsiteX37" fmla="*/ 60325 w 914400"/>
              <a:gd name="connsiteY37" fmla="*/ 381000 h 708025"/>
              <a:gd name="connsiteX38" fmla="*/ 63500 w 914400"/>
              <a:gd name="connsiteY38" fmla="*/ 390525 h 708025"/>
              <a:gd name="connsiteX39" fmla="*/ 69850 w 914400"/>
              <a:gd name="connsiteY39" fmla="*/ 400050 h 708025"/>
              <a:gd name="connsiteX40" fmla="*/ 76200 w 914400"/>
              <a:gd name="connsiteY40" fmla="*/ 419100 h 708025"/>
              <a:gd name="connsiteX41" fmla="*/ 79375 w 914400"/>
              <a:gd name="connsiteY41" fmla="*/ 428625 h 708025"/>
              <a:gd name="connsiteX42" fmla="*/ 82550 w 914400"/>
              <a:gd name="connsiteY42" fmla="*/ 438150 h 708025"/>
              <a:gd name="connsiteX43" fmla="*/ 92075 w 914400"/>
              <a:gd name="connsiteY43" fmla="*/ 444500 h 708025"/>
              <a:gd name="connsiteX44" fmla="*/ 98425 w 914400"/>
              <a:gd name="connsiteY44" fmla="*/ 463550 h 708025"/>
              <a:gd name="connsiteX45" fmla="*/ 117475 w 914400"/>
              <a:gd name="connsiteY45" fmla="*/ 479425 h 708025"/>
              <a:gd name="connsiteX46" fmla="*/ 133350 w 914400"/>
              <a:gd name="connsiteY46" fmla="*/ 492125 h 708025"/>
              <a:gd name="connsiteX47" fmla="*/ 152400 w 914400"/>
              <a:gd name="connsiteY47" fmla="*/ 508000 h 708025"/>
              <a:gd name="connsiteX48" fmla="*/ 171450 w 914400"/>
              <a:gd name="connsiteY48" fmla="*/ 514350 h 708025"/>
              <a:gd name="connsiteX49" fmla="*/ 180975 w 914400"/>
              <a:gd name="connsiteY49" fmla="*/ 517525 h 708025"/>
              <a:gd name="connsiteX50" fmla="*/ 190500 w 914400"/>
              <a:gd name="connsiteY50" fmla="*/ 523875 h 708025"/>
              <a:gd name="connsiteX51" fmla="*/ 225425 w 914400"/>
              <a:gd name="connsiteY51" fmla="*/ 533400 h 708025"/>
              <a:gd name="connsiteX52" fmla="*/ 234950 w 914400"/>
              <a:gd name="connsiteY52" fmla="*/ 536575 h 708025"/>
              <a:gd name="connsiteX53" fmla="*/ 260350 w 914400"/>
              <a:gd name="connsiteY53" fmla="*/ 574675 h 708025"/>
              <a:gd name="connsiteX54" fmla="*/ 266700 w 914400"/>
              <a:gd name="connsiteY54" fmla="*/ 584200 h 708025"/>
              <a:gd name="connsiteX55" fmla="*/ 273050 w 914400"/>
              <a:gd name="connsiteY55" fmla="*/ 603250 h 708025"/>
              <a:gd name="connsiteX56" fmla="*/ 276225 w 914400"/>
              <a:gd name="connsiteY56" fmla="*/ 612775 h 708025"/>
              <a:gd name="connsiteX57" fmla="*/ 288925 w 914400"/>
              <a:gd name="connsiteY57" fmla="*/ 631825 h 708025"/>
              <a:gd name="connsiteX58" fmla="*/ 301625 w 914400"/>
              <a:gd name="connsiteY58" fmla="*/ 647700 h 708025"/>
              <a:gd name="connsiteX59" fmla="*/ 317500 w 914400"/>
              <a:gd name="connsiteY59" fmla="*/ 663575 h 708025"/>
              <a:gd name="connsiteX60" fmla="*/ 327025 w 914400"/>
              <a:gd name="connsiteY60" fmla="*/ 673100 h 708025"/>
              <a:gd name="connsiteX61" fmla="*/ 355600 w 914400"/>
              <a:gd name="connsiteY61" fmla="*/ 688975 h 708025"/>
              <a:gd name="connsiteX62" fmla="*/ 374650 w 914400"/>
              <a:gd name="connsiteY62" fmla="*/ 698500 h 708025"/>
              <a:gd name="connsiteX63" fmla="*/ 393700 w 914400"/>
              <a:gd name="connsiteY63" fmla="*/ 708025 h 708025"/>
              <a:gd name="connsiteX64" fmla="*/ 508000 w 914400"/>
              <a:gd name="connsiteY64" fmla="*/ 704850 h 708025"/>
              <a:gd name="connsiteX65" fmla="*/ 517525 w 914400"/>
              <a:gd name="connsiteY65" fmla="*/ 701675 h 708025"/>
              <a:gd name="connsiteX66" fmla="*/ 530225 w 914400"/>
              <a:gd name="connsiteY66" fmla="*/ 698500 h 708025"/>
              <a:gd name="connsiteX67" fmla="*/ 577850 w 914400"/>
              <a:gd name="connsiteY67" fmla="*/ 692150 h 708025"/>
              <a:gd name="connsiteX68" fmla="*/ 603250 w 914400"/>
              <a:gd name="connsiteY68" fmla="*/ 685800 h 708025"/>
              <a:gd name="connsiteX69" fmla="*/ 612775 w 914400"/>
              <a:gd name="connsiteY69" fmla="*/ 682625 h 708025"/>
              <a:gd name="connsiteX70" fmla="*/ 644525 w 914400"/>
              <a:gd name="connsiteY70" fmla="*/ 676275 h 708025"/>
              <a:gd name="connsiteX71" fmla="*/ 657225 w 914400"/>
              <a:gd name="connsiteY71" fmla="*/ 673100 h 708025"/>
              <a:gd name="connsiteX72" fmla="*/ 676275 w 914400"/>
              <a:gd name="connsiteY72" fmla="*/ 666750 h 708025"/>
              <a:gd name="connsiteX73" fmla="*/ 701675 w 914400"/>
              <a:gd name="connsiteY73" fmla="*/ 660400 h 708025"/>
              <a:gd name="connsiteX74" fmla="*/ 720725 w 914400"/>
              <a:gd name="connsiteY74" fmla="*/ 647700 h 708025"/>
              <a:gd name="connsiteX75" fmla="*/ 730250 w 914400"/>
              <a:gd name="connsiteY75" fmla="*/ 644525 h 708025"/>
              <a:gd name="connsiteX76" fmla="*/ 755650 w 914400"/>
              <a:gd name="connsiteY76" fmla="*/ 638175 h 708025"/>
              <a:gd name="connsiteX77" fmla="*/ 765175 w 914400"/>
              <a:gd name="connsiteY77" fmla="*/ 631825 h 708025"/>
              <a:gd name="connsiteX78" fmla="*/ 774700 w 914400"/>
              <a:gd name="connsiteY78" fmla="*/ 628650 h 708025"/>
              <a:gd name="connsiteX79" fmla="*/ 793750 w 914400"/>
              <a:gd name="connsiteY79" fmla="*/ 615950 h 708025"/>
              <a:gd name="connsiteX80" fmla="*/ 812800 w 914400"/>
              <a:gd name="connsiteY80" fmla="*/ 603250 h 708025"/>
              <a:gd name="connsiteX81" fmla="*/ 822325 w 914400"/>
              <a:gd name="connsiteY81" fmla="*/ 600075 h 708025"/>
              <a:gd name="connsiteX82" fmla="*/ 841375 w 914400"/>
              <a:gd name="connsiteY82" fmla="*/ 587375 h 708025"/>
              <a:gd name="connsiteX83" fmla="*/ 850900 w 914400"/>
              <a:gd name="connsiteY83" fmla="*/ 581025 h 708025"/>
              <a:gd name="connsiteX84" fmla="*/ 860425 w 914400"/>
              <a:gd name="connsiteY84" fmla="*/ 577850 h 708025"/>
              <a:gd name="connsiteX85" fmla="*/ 866775 w 914400"/>
              <a:gd name="connsiteY85" fmla="*/ 568325 h 708025"/>
              <a:gd name="connsiteX86" fmla="*/ 882650 w 914400"/>
              <a:gd name="connsiteY86" fmla="*/ 552450 h 708025"/>
              <a:gd name="connsiteX87" fmla="*/ 901700 w 914400"/>
              <a:gd name="connsiteY87" fmla="*/ 514350 h 708025"/>
              <a:gd name="connsiteX88" fmla="*/ 908050 w 914400"/>
              <a:gd name="connsiteY88" fmla="*/ 504825 h 708025"/>
              <a:gd name="connsiteX89" fmla="*/ 914400 w 914400"/>
              <a:gd name="connsiteY89" fmla="*/ 485775 h 708025"/>
              <a:gd name="connsiteX90" fmla="*/ 908050 w 914400"/>
              <a:gd name="connsiteY90" fmla="*/ 466725 h 708025"/>
              <a:gd name="connsiteX91" fmla="*/ 904875 w 914400"/>
              <a:gd name="connsiteY91" fmla="*/ 457200 h 708025"/>
              <a:gd name="connsiteX92" fmla="*/ 892175 w 914400"/>
              <a:gd name="connsiteY92" fmla="*/ 438150 h 708025"/>
              <a:gd name="connsiteX93" fmla="*/ 879475 w 914400"/>
              <a:gd name="connsiteY93" fmla="*/ 409575 h 708025"/>
              <a:gd name="connsiteX94" fmla="*/ 876300 w 914400"/>
              <a:gd name="connsiteY94" fmla="*/ 400050 h 708025"/>
              <a:gd name="connsiteX95" fmla="*/ 869950 w 914400"/>
              <a:gd name="connsiteY95" fmla="*/ 390525 h 708025"/>
              <a:gd name="connsiteX96" fmla="*/ 866775 w 914400"/>
              <a:gd name="connsiteY96" fmla="*/ 381000 h 708025"/>
              <a:gd name="connsiteX97" fmla="*/ 860425 w 914400"/>
              <a:gd name="connsiteY97" fmla="*/ 371475 h 708025"/>
              <a:gd name="connsiteX98" fmla="*/ 857250 w 914400"/>
              <a:gd name="connsiteY98" fmla="*/ 361950 h 708025"/>
              <a:gd name="connsiteX99" fmla="*/ 850900 w 914400"/>
              <a:gd name="connsiteY99" fmla="*/ 352425 h 708025"/>
              <a:gd name="connsiteX100" fmla="*/ 841375 w 914400"/>
              <a:gd name="connsiteY100" fmla="*/ 323850 h 708025"/>
              <a:gd name="connsiteX101" fmla="*/ 828675 w 914400"/>
              <a:gd name="connsiteY101" fmla="*/ 304800 h 708025"/>
              <a:gd name="connsiteX102" fmla="*/ 822325 w 914400"/>
              <a:gd name="connsiteY102" fmla="*/ 295275 h 708025"/>
              <a:gd name="connsiteX103" fmla="*/ 812800 w 914400"/>
              <a:gd name="connsiteY103" fmla="*/ 285750 h 708025"/>
              <a:gd name="connsiteX104" fmla="*/ 800100 w 914400"/>
              <a:gd name="connsiteY104" fmla="*/ 266700 h 708025"/>
              <a:gd name="connsiteX105" fmla="*/ 793750 w 914400"/>
              <a:gd name="connsiteY105" fmla="*/ 257175 h 708025"/>
              <a:gd name="connsiteX106" fmla="*/ 784225 w 914400"/>
              <a:gd name="connsiteY106" fmla="*/ 250825 h 708025"/>
              <a:gd name="connsiteX107" fmla="*/ 762000 w 914400"/>
              <a:gd name="connsiteY107" fmla="*/ 225425 h 708025"/>
              <a:gd name="connsiteX108" fmla="*/ 739775 w 914400"/>
              <a:gd name="connsiteY108" fmla="*/ 203200 h 708025"/>
              <a:gd name="connsiteX109" fmla="*/ 733425 w 914400"/>
              <a:gd name="connsiteY109" fmla="*/ 193675 h 708025"/>
              <a:gd name="connsiteX110" fmla="*/ 723900 w 914400"/>
              <a:gd name="connsiteY110" fmla="*/ 187325 h 708025"/>
              <a:gd name="connsiteX111" fmla="*/ 692150 w 914400"/>
              <a:gd name="connsiteY111" fmla="*/ 177800 h 708025"/>
              <a:gd name="connsiteX112" fmla="*/ 657225 w 914400"/>
              <a:gd name="connsiteY112" fmla="*/ 168275 h 708025"/>
              <a:gd name="connsiteX113" fmla="*/ 584200 w 914400"/>
              <a:gd name="connsiteY113" fmla="*/ 165100 h 708025"/>
              <a:gd name="connsiteX114" fmla="*/ 571500 w 914400"/>
              <a:gd name="connsiteY114" fmla="*/ 161925 h 708025"/>
              <a:gd name="connsiteX115" fmla="*/ 552450 w 914400"/>
              <a:gd name="connsiteY115" fmla="*/ 158750 h 708025"/>
              <a:gd name="connsiteX116" fmla="*/ 533400 w 914400"/>
              <a:gd name="connsiteY116" fmla="*/ 152400 h 708025"/>
              <a:gd name="connsiteX117" fmla="*/ 514350 w 914400"/>
              <a:gd name="connsiteY117" fmla="*/ 146050 h 708025"/>
              <a:gd name="connsiteX118" fmla="*/ 479425 w 914400"/>
              <a:gd name="connsiteY118" fmla="*/ 142875 h 708025"/>
              <a:gd name="connsiteX119" fmla="*/ 447675 w 914400"/>
              <a:gd name="connsiteY119" fmla="*/ 136525 h 708025"/>
              <a:gd name="connsiteX120" fmla="*/ 428625 w 914400"/>
              <a:gd name="connsiteY120" fmla="*/ 123825 h 708025"/>
              <a:gd name="connsiteX121" fmla="*/ 419100 w 914400"/>
              <a:gd name="connsiteY121" fmla="*/ 104775 h 708025"/>
              <a:gd name="connsiteX122" fmla="*/ 390525 w 914400"/>
              <a:gd name="connsiteY122" fmla="*/ 85725 h 708025"/>
              <a:gd name="connsiteX123" fmla="*/ 384175 w 914400"/>
              <a:gd name="connsiteY123" fmla="*/ 79375 h 7080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</a:cxnLst>
            <a:rect l="l" t="t" r="r" b="b"/>
            <a:pathLst>
              <a:path w="914400" h="708025">
                <a:moveTo>
                  <a:pt x="425450" y="114300"/>
                </a:moveTo>
                <a:cubicBezTo>
                  <a:pt x="420158" y="111125"/>
                  <a:pt x="414260" y="108791"/>
                  <a:pt x="409575" y="104775"/>
                </a:cubicBezTo>
                <a:cubicBezTo>
                  <a:pt x="391297" y="89108"/>
                  <a:pt x="415678" y="99401"/>
                  <a:pt x="393700" y="92075"/>
                </a:cubicBezTo>
                <a:cubicBezTo>
                  <a:pt x="391608" y="85800"/>
                  <a:pt x="389770" y="77501"/>
                  <a:pt x="384175" y="73025"/>
                </a:cubicBezTo>
                <a:cubicBezTo>
                  <a:pt x="381562" y="70934"/>
                  <a:pt x="377825" y="70908"/>
                  <a:pt x="374650" y="69850"/>
                </a:cubicBezTo>
                <a:cubicBezTo>
                  <a:pt x="371475" y="67733"/>
                  <a:pt x="368056" y="65943"/>
                  <a:pt x="365125" y="63500"/>
                </a:cubicBezTo>
                <a:cubicBezTo>
                  <a:pt x="361676" y="60625"/>
                  <a:pt x="359336" y="56466"/>
                  <a:pt x="355600" y="53975"/>
                </a:cubicBezTo>
                <a:cubicBezTo>
                  <a:pt x="352815" y="52119"/>
                  <a:pt x="349250" y="51858"/>
                  <a:pt x="346075" y="50800"/>
                </a:cubicBezTo>
                <a:cubicBezTo>
                  <a:pt x="339725" y="46567"/>
                  <a:pt x="332421" y="43496"/>
                  <a:pt x="327025" y="38100"/>
                </a:cubicBezTo>
                <a:cubicBezTo>
                  <a:pt x="315133" y="26208"/>
                  <a:pt x="321760" y="29995"/>
                  <a:pt x="307975" y="25400"/>
                </a:cubicBezTo>
                <a:lnTo>
                  <a:pt x="288925" y="12700"/>
                </a:lnTo>
                <a:cubicBezTo>
                  <a:pt x="283356" y="8987"/>
                  <a:pt x="276225" y="8467"/>
                  <a:pt x="269875" y="6350"/>
                </a:cubicBezTo>
                <a:cubicBezTo>
                  <a:pt x="263768" y="4314"/>
                  <a:pt x="257159" y="4327"/>
                  <a:pt x="250825" y="3175"/>
                </a:cubicBezTo>
                <a:cubicBezTo>
                  <a:pt x="245516" y="2210"/>
                  <a:pt x="240242" y="1058"/>
                  <a:pt x="234950" y="0"/>
                </a:cubicBezTo>
                <a:cubicBezTo>
                  <a:pt x="220226" y="1339"/>
                  <a:pt x="193894" y="3131"/>
                  <a:pt x="177800" y="6350"/>
                </a:cubicBezTo>
                <a:cubicBezTo>
                  <a:pt x="174518" y="7006"/>
                  <a:pt x="171450" y="8467"/>
                  <a:pt x="168275" y="9525"/>
                </a:cubicBezTo>
                <a:cubicBezTo>
                  <a:pt x="140978" y="27723"/>
                  <a:pt x="175515" y="5905"/>
                  <a:pt x="149225" y="19050"/>
                </a:cubicBezTo>
                <a:cubicBezTo>
                  <a:pt x="124606" y="31360"/>
                  <a:pt x="154116" y="20595"/>
                  <a:pt x="130175" y="28575"/>
                </a:cubicBezTo>
                <a:lnTo>
                  <a:pt x="82550" y="60325"/>
                </a:lnTo>
                <a:lnTo>
                  <a:pt x="63500" y="73025"/>
                </a:lnTo>
                <a:lnTo>
                  <a:pt x="53975" y="79375"/>
                </a:lnTo>
                <a:cubicBezTo>
                  <a:pt x="51858" y="82550"/>
                  <a:pt x="50605" y="86516"/>
                  <a:pt x="47625" y="88900"/>
                </a:cubicBezTo>
                <a:cubicBezTo>
                  <a:pt x="45012" y="90991"/>
                  <a:pt x="40467" y="89708"/>
                  <a:pt x="38100" y="92075"/>
                </a:cubicBezTo>
                <a:cubicBezTo>
                  <a:pt x="32704" y="97471"/>
                  <a:pt x="29633" y="104775"/>
                  <a:pt x="25400" y="111125"/>
                </a:cubicBezTo>
                <a:lnTo>
                  <a:pt x="19050" y="120650"/>
                </a:lnTo>
                <a:cubicBezTo>
                  <a:pt x="16933" y="123825"/>
                  <a:pt x="13907" y="126555"/>
                  <a:pt x="12700" y="130175"/>
                </a:cubicBezTo>
                <a:lnTo>
                  <a:pt x="6350" y="149225"/>
                </a:lnTo>
                <a:cubicBezTo>
                  <a:pt x="5292" y="152400"/>
                  <a:pt x="3831" y="155468"/>
                  <a:pt x="3175" y="158750"/>
                </a:cubicBezTo>
                <a:lnTo>
                  <a:pt x="0" y="174625"/>
                </a:lnTo>
                <a:cubicBezTo>
                  <a:pt x="1058" y="197908"/>
                  <a:pt x="1514" y="221227"/>
                  <a:pt x="3175" y="244475"/>
                </a:cubicBezTo>
                <a:cubicBezTo>
                  <a:pt x="3634" y="250896"/>
                  <a:pt x="5371" y="257162"/>
                  <a:pt x="6350" y="263525"/>
                </a:cubicBezTo>
                <a:cubicBezTo>
                  <a:pt x="7488" y="270922"/>
                  <a:pt x="8057" y="278412"/>
                  <a:pt x="9525" y="285750"/>
                </a:cubicBezTo>
                <a:cubicBezTo>
                  <a:pt x="11920" y="297725"/>
                  <a:pt x="18126" y="303413"/>
                  <a:pt x="25400" y="314325"/>
                </a:cubicBezTo>
                <a:cubicBezTo>
                  <a:pt x="27256" y="317110"/>
                  <a:pt x="26950" y="320924"/>
                  <a:pt x="28575" y="323850"/>
                </a:cubicBezTo>
                <a:cubicBezTo>
                  <a:pt x="32281" y="330521"/>
                  <a:pt x="38862" y="335660"/>
                  <a:pt x="41275" y="342900"/>
                </a:cubicBezTo>
                <a:cubicBezTo>
                  <a:pt x="49255" y="366841"/>
                  <a:pt x="38490" y="337331"/>
                  <a:pt x="50800" y="361950"/>
                </a:cubicBezTo>
                <a:cubicBezTo>
                  <a:pt x="52297" y="364943"/>
                  <a:pt x="52478" y="368482"/>
                  <a:pt x="53975" y="371475"/>
                </a:cubicBezTo>
                <a:cubicBezTo>
                  <a:pt x="55682" y="374888"/>
                  <a:pt x="58618" y="377587"/>
                  <a:pt x="60325" y="381000"/>
                </a:cubicBezTo>
                <a:cubicBezTo>
                  <a:pt x="61822" y="383993"/>
                  <a:pt x="62003" y="387532"/>
                  <a:pt x="63500" y="390525"/>
                </a:cubicBezTo>
                <a:cubicBezTo>
                  <a:pt x="65207" y="393938"/>
                  <a:pt x="68300" y="396563"/>
                  <a:pt x="69850" y="400050"/>
                </a:cubicBezTo>
                <a:cubicBezTo>
                  <a:pt x="72568" y="406167"/>
                  <a:pt x="74083" y="412750"/>
                  <a:pt x="76200" y="419100"/>
                </a:cubicBezTo>
                <a:lnTo>
                  <a:pt x="79375" y="428625"/>
                </a:lnTo>
                <a:cubicBezTo>
                  <a:pt x="80433" y="431800"/>
                  <a:pt x="79765" y="436294"/>
                  <a:pt x="82550" y="438150"/>
                </a:cubicBezTo>
                <a:lnTo>
                  <a:pt x="92075" y="444500"/>
                </a:lnTo>
                <a:cubicBezTo>
                  <a:pt x="94192" y="450850"/>
                  <a:pt x="92856" y="459837"/>
                  <a:pt x="98425" y="463550"/>
                </a:cubicBezTo>
                <a:cubicBezTo>
                  <a:pt x="107791" y="469794"/>
                  <a:pt x="109835" y="470258"/>
                  <a:pt x="117475" y="479425"/>
                </a:cubicBezTo>
                <a:cubicBezTo>
                  <a:pt x="128522" y="492682"/>
                  <a:pt x="117713" y="486913"/>
                  <a:pt x="133350" y="492125"/>
                </a:cubicBezTo>
                <a:cubicBezTo>
                  <a:pt x="139332" y="498107"/>
                  <a:pt x="144443" y="504464"/>
                  <a:pt x="152400" y="508000"/>
                </a:cubicBezTo>
                <a:cubicBezTo>
                  <a:pt x="158517" y="510718"/>
                  <a:pt x="165100" y="512233"/>
                  <a:pt x="171450" y="514350"/>
                </a:cubicBezTo>
                <a:lnTo>
                  <a:pt x="180975" y="517525"/>
                </a:lnTo>
                <a:cubicBezTo>
                  <a:pt x="184150" y="519642"/>
                  <a:pt x="187013" y="522325"/>
                  <a:pt x="190500" y="523875"/>
                </a:cubicBezTo>
                <a:cubicBezTo>
                  <a:pt x="208015" y="531659"/>
                  <a:pt x="208352" y="529132"/>
                  <a:pt x="225425" y="533400"/>
                </a:cubicBezTo>
                <a:cubicBezTo>
                  <a:pt x="228672" y="534212"/>
                  <a:pt x="231775" y="535517"/>
                  <a:pt x="234950" y="536575"/>
                </a:cubicBezTo>
                <a:lnTo>
                  <a:pt x="260350" y="574675"/>
                </a:lnTo>
                <a:cubicBezTo>
                  <a:pt x="262467" y="577850"/>
                  <a:pt x="265493" y="580580"/>
                  <a:pt x="266700" y="584200"/>
                </a:cubicBezTo>
                <a:lnTo>
                  <a:pt x="273050" y="603250"/>
                </a:lnTo>
                <a:cubicBezTo>
                  <a:pt x="274108" y="606425"/>
                  <a:pt x="274369" y="609990"/>
                  <a:pt x="276225" y="612775"/>
                </a:cubicBezTo>
                <a:cubicBezTo>
                  <a:pt x="280458" y="619125"/>
                  <a:pt x="286512" y="624585"/>
                  <a:pt x="288925" y="631825"/>
                </a:cubicBezTo>
                <a:cubicBezTo>
                  <a:pt x="293307" y="644970"/>
                  <a:pt x="289315" y="639494"/>
                  <a:pt x="301625" y="647700"/>
                </a:cubicBezTo>
                <a:cubicBezTo>
                  <a:pt x="313267" y="665162"/>
                  <a:pt x="301625" y="650346"/>
                  <a:pt x="317500" y="663575"/>
                </a:cubicBezTo>
                <a:cubicBezTo>
                  <a:pt x="320949" y="666450"/>
                  <a:pt x="323481" y="670343"/>
                  <a:pt x="327025" y="673100"/>
                </a:cubicBezTo>
                <a:cubicBezTo>
                  <a:pt x="343401" y="685837"/>
                  <a:pt x="341229" y="684185"/>
                  <a:pt x="355600" y="688975"/>
                </a:cubicBezTo>
                <a:cubicBezTo>
                  <a:pt x="382897" y="707173"/>
                  <a:pt x="348360" y="685355"/>
                  <a:pt x="374650" y="698500"/>
                </a:cubicBezTo>
                <a:cubicBezTo>
                  <a:pt x="399269" y="710810"/>
                  <a:pt x="369759" y="700045"/>
                  <a:pt x="393700" y="708025"/>
                </a:cubicBezTo>
                <a:cubicBezTo>
                  <a:pt x="431800" y="706967"/>
                  <a:pt x="469935" y="706802"/>
                  <a:pt x="508000" y="704850"/>
                </a:cubicBezTo>
                <a:cubicBezTo>
                  <a:pt x="511342" y="704679"/>
                  <a:pt x="514307" y="702594"/>
                  <a:pt x="517525" y="701675"/>
                </a:cubicBezTo>
                <a:cubicBezTo>
                  <a:pt x="521721" y="700476"/>
                  <a:pt x="525932" y="699281"/>
                  <a:pt x="530225" y="698500"/>
                </a:cubicBezTo>
                <a:cubicBezTo>
                  <a:pt x="539865" y="696747"/>
                  <a:pt x="569005" y="693256"/>
                  <a:pt x="577850" y="692150"/>
                </a:cubicBezTo>
                <a:cubicBezTo>
                  <a:pt x="599623" y="684892"/>
                  <a:pt x="572599" y="693463"/>
                  <a:pt x="603250" y="685800"/>
                </a:cubicBezTo>
                <a:cubicBezTo>
                  <a:pt x="606497" y="684988"/>
                  <a:pt x="609514" y="683378"/>
                  <a:pt x="612775" y="682625"/>
                </a:cubicBezTo>
                <a:cubicBezTo>
                  <a:pt x="623292" y="680198"/>
                  <a:pt x="633942" y="678392"/>
                  <a:pt x="644525" y="676275"/>
                </a:cubicBezTo>
                <a:cubicBezTo>
                  <a:pt x="648804" y="675419"/>
                  <a:pt x="653045" y="674354"/>
                  <a:pt x="657225" y="673100"/>
                </a:cubicBezTo>
                <a:cubicBezTo>
                  <a:pt x="663636" y="671177"/>
                  <a:pt x="669711" y="668063"/>
                  <a:pt x="676275" y="666750"/>
                </a:cubicBezTo>
                <a:cubicBezTo>
                  <a:pt x="695432" y="662919"/>
                  <a:pt x="687030" y="665282"/>
                  <a:pt x="701675" y="660400"/>
                </a:cubicBezTo>
                <a:lnTo>
                  <a:pt x="720725" y="647700"/>
                </a:lnTo>
                <a:cubicBezTo>
                  <a:pt x="723510" y="645844"/>
                  <a:pt x="727003" y="645337"/>
                  <a:pt x="730250" y="644525"/>
                </a:cubicBezTo>
                <a:lnTo>
                  <a:pt x="755650" y="638175"/>
                </a:lnTo>
                <a:cubicBezTo>
                  <a:pt x="758825" y="636058"/>
                  <a:pt x="761762" y="633532"/>
                  <a:pt x="765175" y="631825"/>
                </a:cubicBezTo>
                <a:cubicBezTo>
                  <a:pt x="768168" y="630328"/>
                  <a:pt x="771774" y="630275"/>
                  <a:pt x="774700" y="628650"/>
                </a:cubicBezTo>
                <a:cubicBezTo>
                  <a:pt x="781371" y="624944"/>
                  <a:pt x="787400" y="620183"/>
                  <a:pt x="793750" y="615950"/>
                </a:cubicBezTo>
                <a:lnTo>
                  <a:pt x="812800" y="603250"/>
                </a:lnTo>
                <a:cubicBezTo>
                  <a:pt x="815585" y="601394"/>
                  <a:pt x="819150" y="601133"/>
                  <a:pt x="822325" y="600075"/>
                </a:cubicBezTo>
                <a:lnTo>
                  <a:pt x="841375" y="587375"/>
                </a:lnTo>
                <a:cubicBezTo>
                  <a:pt x="844550" y="585258"/>
                  <a:pt x="847280" y="582232"/>
                  <a:pt x="850900" y="581025"/>
                </a:cubicBezTo>
                <a:lnTo>
                  <a:pt x="860425" y="577850"/>
                </a:lnTo>
                <a:cubicBezTo>
                  <a:pt x="862542" y="574675"/>
                  <a:pt x="864077" y="571023"/>
                  <a:pt x="866775" y="568325"/>
                </a:cubicBezTo>
                <a:cubicBezTo>
                  <a:pt x="877782" y="557318"/>
                  <a:pt x="875877" y="567690"/>
                  <a:pt x="882650" y="552450"/>
                </a:cubicBezTo>
                <a:cubicBezTo>
                  <a:pt x="900177" y="513015"/>
                  <a:pt x="875295" y="553957"/>
                  <a:pt x="901700" y="514350"/>
                </a:cubicBezTo>
                <a:lnTo>
                  <a:pt x="908050" y="504825"/>
                </a:lnTo>
                <a:cubicBezTo>
                  <a:pt x="911763" y="499256"/>
                  <a:pt x="914400" y="485775"/>
                  <a:pt x="914400" y="485775"/>
                </a:cubicBezTo>
                <a:lnTo>
                  <a:pt x="908050" y="466725"/>
                </a:lnTo>
                <a:cubicBezTo>
                  <a:pt x="906992" y="463550"/>
                  <a:pt x="906731" y="459985"/>
                  <a:pt x="904875" y="457200"/>
                </a:cubicBezTo>
                <a:cubicBezTo>
                  <a:pt x="900642" y="450850"/>
                  <a:pt x="894588" y="445390"/>
                  <a:pt x="892175" y="438150"/>
                </a:cubicBezTo>
                <a:cubicBezTo>
                  <a:pt x="875793" y="389003"/>
                  <a:pt x="894569" y="439764"/>
                  <a:pt x="879475" y="409575"/>
                </a:cubicBezTo>
                <a:cubicBezTo>
                  <a:pt x="877978" y="406582"/>
                  <a:pt x="877797" y="403043"/>
                  <a:pt x="876300" y="400050"/>
                </a:cubicBezTo>
                <a:cubicBezTo>
                  <a:pt x="874593" y="396637"/>
                  <a:pt x="871657" y="393938"/>
                  <a:pt x="869950" y="390525"/>
                </a:cubicBezTo>
                <a:cubicBezTo>
                  <a:pt x="868453" y="387532"/>
                  <a:pt x="868272" y="383993"/>
                  <a:pt x="866775" y="381000"/>
                </a:cubicBezTo>
                <a:cubicBezTo>
                  <a:pt x="865068" y="377587"/>
                  <a:pt x="862132" y="374888"/>
                  <a:pt x="860425" y="371475"/>
                </a:cubicBezTo>
                <a:cubicBezTo>
                  <a:pt x="858928" y="368482"/>
                  <a:pt x="858747" y="364943"/>
                  <a:pt x="857250" y="361950"/>
                </a:cubicBezTo>
                <a:cubicBezTo>
                  <a:pt x="855543" y="358537"/>
                  <a:pt x="852450" y="355912"/>
                  <a:pt x="850900" y="352425"/>
                </a:cubicBezTo>
                <a:lnTo>
                  <a:pt x="841375" y="323850"/>
                </a:lnTo>
                <a:cubicBezTo>
                  <a:pt x="838962" y="316610"/>
                  <a:pt x="832908" y="311150"/>
                  <a:pt x="828675" y="304800"/>
                </a:cubicBezTo>
                <a:cubicBezTo>
                  <a:pt x="826558" y="301625"/>
                  <a:pt x="825023" y="297973"/>
                  <a:pt x="822325" y="295275"/>
                </a:cubicBezTo>
                <a:cubicBezTo>
                  <a:pt x="819150" y="292100"/>
                  <a:pt x="815557" y="289294"/>
                  <a:pt x="812800" y="285750"/>
                </a:cubicBezTo>
                <a:cubicBezTo>
                  <a:pt x="808115" y="279726"/>
                  <a:pt x="804333" y="273050"/>
                  <a:pt x="800100" y="266700"/>
                </a:cubicBezTo>
                <a:cubicBezTo>
                  <a:pt x="797983" y="263525"/>
                  <a:pt x="796925" y="259292"/>
                  <a:pt x="793750" y="257175"/>
                </a:cubicBezTo>
                <a:lnTo>
                  <a:pt x="784225" y="250825"/>
                </a:lnTo>
                <a:cubicBezTo>
                  <a:pt x="769408" y="228600"/>
                  <a:pt x="777875" y="236008"/>
                  <a:pt x="762000" y="225425"/>
                </a:cubicBezTo>
                <a:cubicBezTo>
                  <a:pt x="747444" y="203590"/>
                  <a:pt x="756540" y="208788"/>
                  <a:pt x="739775" y="203200"/>
                </a:cubicBezTo>
                <a:cubicBezTo>
                  <a:pt x="737658" y="200025"/>
                  <a:pt x="736123" y="196373"/>
                  <a:pt x="733425" y="193675"/>
                </a:cubicBezTo>
                <a:cubicBezTo>
                  <a:pt x="730727" y="190977"/>
                  <a:pt x="727387" y="188875"/>
                  <a:pt x="723900" y="187325"/>
                </a:cubicBezTo>
                <a:cubicBezTo>
                  <a:pt x="708357" y="180417"/>
                  <a:pt x="706358" y="182063"/>
                  <a:pt x="692150" y="177800"/>
                </a:cubicBezTo>
                <a:cubicBezTo>
                  <a:pt x="680111" y="174188"/>
                  <a:pt x="669884" y="169179"/>
                  <a:pt x="657225" y="168275"/>
                </a:cubicBezTo>
                <a:cubicBezTo>
                  <a:pt x="632922" y="166539"/>
                  <a:pt x="608542" y="166158"/>
                  <a:pt x="584200" y="165100"/>
                </a:cubicBezTo>
                <a:cubicBezTo>
                  <a:pt x="579967" y="164042"/>
                  <a:pt x="575779" y="162781"/>
                  <a:pt x="571500" y="161925"/>
                </a:cubicBezTo>
                <a:cubicBezTo>
                  <a:pt x="565187" y="160662"/>
                  <a:pt x="558695" y="160311"/>
                  <a:pt x="552450" y="158750"/>
                </a:cubicBezTo>
                <a:cubicBezTo>
                  <a:pt x="545956" y="157127"/>
                  <a:pt x="539750" y="154517"/>
                  <a:pt x="533400" y="152400"/>
                </a:cubicBezTo>
                <a:lnTo>
                  <a:pt x="514350" y="146050"/>
                </a:lnTo>
                <a:cubicBezTo>
                  <a:pt x="503260" y="142353"/>
                  <a:pt x="491035" y="144241"/>
                  <a:pt x="479425" y="142875"/>
                </a:cubicBezTo>
                <a:cubicBezTo>
                  <a:pt x="464720" y="141145"/>
                  <a:pt x="460757" y="139796"/>
                  <a:pt x="447675" y="136525"/>
                </a:cubicBezTo>
                <a:cubicBezTo>
                  <a:pt x="441325" y="132292"/>
                  <a:pt x="431038" y="131065"/>
                  <a:pt x="428625" y="123825"/>
                </a:cubicBezTo>
                <a:cubicBezTo>
                  <a:pt x="426360" y="117031"/>
                  <a:pt x="424893" y="109844"/>
                  <a:pt x="419100" y="104775"/>
                </a:cubicBezTo>
                <a:lnTo>
                  <a:pt x="390525" y="85725"/>
                </a:lnTo>
                <a:cubicBezTo>
                  <a:pt x="388034" y="84065"/>
                  <a:pt x="386292" y="81492"/>
                  <a:pt x="384175" y="79375"/>
                </a:cubicBezTo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noFill/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73" name="フリーフォーム 172"/>
          <p:cNvSpPr/>
          <p:nvPr/>
        </p:nvSpPr>
        <p:spPr>
          <a:xfrm>
            <a:off x="6681936" y="5203800"/>
            <a:ext cx="914400" cy="708025"/>
          </a:xfrm>
          <a:custGeom>
            <a:avLst/>
            <a:gdLst>
              <a:gd name="connsiteX0" fmla="*/ 425450 w 914400"/>
              <a:gd name="connsiteY0" fmla="*/ 114300 h 708025"/>
              <a:gd name="connsiteX1" fmla="*/ 409575 w 914400"/>
              <a:gd name="connsiteY1" fmla="*/ 104775 h 708025"/>
              <a:gd name="connsiteX2" fmla="*/ 393700 w 914400"/>
              <a:gd name="connsiteY2" fmla="*/ 92075 h 708025"/>
              <a:gd name="connsiteX3" fmla="*/ 384175 w 914400"/>
              <a:gd name="connsiteY3" fmla="*/ 73025 h 708025"/>
              <a:gd name="connsiteX4" fmla="*/ 374650 w 914400"/>
              <a:gd name="connsiteY4" fmla="*/ 69850 h 708025"/>
              <a:gd name="connsiteX5" fmla="*/ 365125 w 914400"/>
              <a:gd name="connsiteY5" fmla="*/ 63500 h 708025"/>
              <a:gd name="connsiteX6" fmla="*/ 355600 w 914400"/>
              <a:gd name="connsiteY6" fmla="*/ 53975 h 708025"/>
              <a:gd name="connsiteX7" fmla="*/ 346075 w 914400"/>
              <a:gd name="connsiteY7" fmla="*/ 50800 h 708025"/>
              <a:gd name="connsiteX8" fmla="*/ 327025 w 914400"/>
              <a:gd name="connsiteY8" fmla="*/ 38100 h 708025"/>
              <a:gd name="connsiteX9" fmla="*/ 307975 w 914400"/>
              <a:gd name="connsiteY9" fmla="*/ 25400 h 708025"/>
              <a:gd name="connsiteX10" fmla="*/ 288925 w 914400"/>
              <a:gd name="connsiteY10" fmla="*/ 12700 h 708025"/>
              <a:gd name="connsiteX11" fmla="*/ 269875 w 914400"/>
              <a:gd name="connsiteY11" fmla="*/ 6350 h 708025"/>
              <a:gd name="connsiteX12" fmla="*/ 250825 w 914400"/>
              <a:gd name="connsiteY12" fmla="*/ 3175 h 708025"/>
              <a:gd name="connsiteX13" fmla="*/ 234950 w 914400"/>
              <a:gd name="connsiteY13" fmla="*/ 0 h 708025"/>
              <a:gd name="connsiteX14" fmla="*/ 177800 w 914400"/>
              <a:gd name="connsiteY14" fmla="*/ 6350 h 708025"/>
              <a:gd name="connsiteX15" fmla="*/ 168275 w 914400"/>
              <a:gd name="connsiteY15" fmla="*/ 9525 h 708025"/>
              <a:gd name="connsiteX16" fmla="*/ 149225 w 914400"/>
              <a:gd name="connsiteY16" fmla="*/ 19050 h 708025"/>
              <a:gd name="connsiteX17" fmla="*/ 130175 w 914400"/>
              <a:gd name="connsiteY17" fmla="*/ 28575 h 708025"/>
              <a:gd name="connsiteX18" fmla="*/ 82550 w 914400"/>
              <a:gd name="connsiteY18" fmla="*/ 60325 h 708025"/>
              <a:gd name="connsiteX19" fmla="*/ 63500 w 914400"/>
              <a:gd name="connsiteY19" fmla="*/ 73025 h 708025"/>
              <a:gd name="connsiteX20" fmla="*/ 53975 w 914400"/>
              <a:gd name="connsiteY20" fmla="*/ 79375 h 708025"/>
              <a:gd name="connsiteX21" fmla="*/ 47625 w 914400"/>
              <a:gd name="connsiteY21" fmla="*/ 88900 h 708025"/>
              <a:gd name="connsiteX22" fmla="*/ 38100 w 914400"/>
              <a:gd name="connsiteY22" fmla="*/ 92075 h 708025"/>
              <a:gd name="connsiteX23" fmla="*/ 25400 w 914400"/>
              <a:gd name="connsiteY23" fmla="*/ 111125 h 708025"/>
              <a:gd name="connsiteX24" fmla="*/ 19050 w 914400"/>
              <a:gd name="connsiteY24" fmla="*/ 120650 h 708025"/>
              <a:gd name="connsiteX25" fmla="*/ 12700 w 914400"/>
              <a:gd name="connsiteY25" fmla="*/ 130175 h 708025"/>
              <a:gd name="connsiteX26" fmla="*/ 6350 w 914400"/>
              <a:gd name="connsiteY26" fmla="*/ 149225 h 708025"/>
              <a:gd name="connsiteX27" fmla="*/ 3175 w 914400"/>
              <a:gd name="connsiteY27" fmla="*/ 158750 h 708025"/>
              <a:gd name="connsiteX28" fmla="*/ 0 w 914400"/>
              <a:gd name="connsiteY28" fmla="*/ 174625 h 708025"/>
              <a:gd name="connsiteX29" fmla="*/ 3175 w 914400"/>
              <a:gd name="connsiteY29" fmla="*/ 244475 h 708025"/>
              <a:gd name="connsiteX30" fmla="*/ 6350 w 914400"/>
              <a:gd name="connsiteY30" fmla="*/ 263525 h 708025"/>
              <a:gd name="connsiteX31" fmla="*/ 9525 w 914400"/>
              <a:gd name="connsiteY31" fmla="*/ 285750 h 708025"/>
              <a:gd name="connsiteX32" fmla="*/ 25400 w 914400"/>
              <a:gd name="connsiteY32" fmla="*/ 314325 h 708025"/>
              <a:gd name="connsiteX33" fmla="*/ 28575 w 914400"/>
              <a:gd name="connsiteY33" fmla="*/ 323850 h 708025"/>
              <a:gd name="connsiteX34" fmla="*/ 41275 w 914400"/>
              <a:gd name="connsiteY34" fmla="*/ 342900 h 708025"/>
              <a:gd name="connsiteX35" fmla="*/ 50800 w 914400"/>
              <a:gd name="connsiteY35" fmla="*/ 361950 h 708025"/>
              <a:gd name="connsiteX36" fmla="*/ 53975 w 914400"/>
              <a:gd name="connsiteY36" fmla="*/ 371475 h 708025"/>
              <a:gd name="connsiteX37" fmla="*/ 60325 w 914400"/>
              <a:gd name="connsiteY37" fmla="*/ 381000 h 708025"/>
              <a:gd name="connsiteX38" fmla="*/ 63500 w 914400"/>
              <a:gd name="connsiteY38" fmla="*/ 390525 h 708025"/>
              <a:gd name="connsiteX39" fmla="*/ 69850 w 914400"/>
              <a:gd name="connsiteY39" fmla="*/ 400050 h 708025"/>
              <a:gd name="connsiteX40" fmla="*/ 76200 w 914400"/>
              <a:gd name="connsiteY40" fmla="*/ 419100 h 708025"/>
              <a:gd name="connsiteX41" fmla="*/ 79375 w 914400"/>
              <a:gd name="connsiteY41" fmla="*/ 428625 h 708025"/>
              <a:gd name="connsiteX42" fmla="*/ 82550 w 914400"/>
              <a:gd name="connsiteY42" fmla="*/ 438150 h 708025"/>
              <a:gd name="connsiteX43" fmla="*/ 92075 w 914400"/>
              <a:gd name="connsiteY43" fmla="*/ 444500 h 708025"/>
              <a:gd name="connsiteX44" fmla="*/ 98425 w 914400"/>
              <a:gd name="connsiteY44" fmla="*/ 463550 h 708025"/>
              <a:gd name="connsiteX45" fmla="*/ 117475 w 914400"/>
              <a:gd name="connsiteY45" fmla="*/ 479425 h 708025"/>
              <a:gd name="connsiteX46" fmla="*/ 133350 w 914400"/>
              <a:gd name="connsiteY46" fmla="*/ 492125 h 708025"/>
              <a:gd name="connsiteX47" fmla="*/ 152400 w 914400"/>
              <a:gd name="connsiteY47" fmla="*/ 508000 h 708025"/>
              <a:gd name="connsiteX48" fmla="*/ 171450 w 914400"/>
              <a:gd name="connsiteY48" fmla="*/ 514350 h 708025"/>
              <a:gd name="connsiteX49" fmla="*/ 180975 w 914400"/>
              <a:gd name="connsiteY49" fmla="*/ 517525 h 708025"/>
              <a:gd name="connsiteX50" fmla="*/ 190500 w 914400"/>
              <a:gd name="connsiteY50" fmla="*/ 523875 h 708025"/>
              <a:gd name="connsiteX51" fmla="*/ 225425 w 914400"/>
              <a:gd name="connsiteY51" fmla="*/ 533400 h 708025"/>
              <a:gd name="connsiteX52" fmla="*/ 234950 w 914400"/>
              <a:gd name="connsiteY52" fmla="*/ 536575 h 708025"/>
              <a:gd name="connsiteX53" fmla="*/ 260350 w 914400"/>
              <a:gd name="connsiteY53" fmla="*/ 574675 h 708025"/>
              <a:gd name="connsiteX54" fmla="*/ 266700 w 914400"/>
              <a:gd name="connsiteY54" fmla="*/ 584200 h 708025"/>
              <a:gd name="connsiteX55" fmla="*/ 273050 w 914400"/>
              <a:gd name="connsiteY55" fmla="*/ 603250 h 708025"/>
              <a:gd name="connsiteX56" fmla="*/ 276225 w 914400"/>
              <a:gd name="connsiteY56" fmla="*/ 612775 h 708025"/>
              <a:gd name="connsiteX57" fmla="*/ 288925 w 914400"/>
              <a:gd name="connsiteY57" fmla="*/ 631825 h 708025"/>
              <a:gd name="connsiteX58" fmla="*/ 301625 w 914400"/>
              <a:gd name="connsiteY58" fmla="*/ 647700 h 708025"/>
              <a:gd name="connsiteX59" fmla="*/ 317500 w 914400"/>
              <a:gd name="connsiteY59" fmla="*/ 663575 h 708025"/>
              <a:gd name="connsiteX60" fmla="*/ 327025 w 914400"/>
              <a:gd name="connsiteY60" fmla="*/ 673100 h 708025"/>
              <a:gd name="connsiteX61" fmla="*/ 355600 w 914400"/>
              <a:gd name="connsiteY61" fmla="*/ 688975 h 708025"/>
              <a:gd name="connsiteX62" fmla="*/ 374650 w 914400"/>
              <a:gd name="connsiteY62" fmla="*/ 698500 h 708025"/>
              <a:gd name="connsiteX63" fmla="*/ 393700 w 914400"/>
              <a:gd name="connsiteY63" fmla="*/ 708025 h 708025"/>
              <a:gd name="connsiteX64" fmla="*/ 508000 w 914400"/>
              <a:gd name="connsiteY64" fmla="*/ 704850 h 708025"/>
              <a:gd name="connsiteX65" fmla="*/ 517525 w 914400"/>
              <a:gd name="connsiteY65" fmla="*/ 701675 h 708025"/>
              <a:gd name="connsiteX66" fmla="*/ 530225 w 914400"/>
              <a:gd name="connsiteY66" fmla="*/ 698500 h 708025"/>
              <a:gd name="connsiteX67" fmla="*/ 577850 w 914400"/>
              <a:gd name="connsiteY67" fmla="*/ 692150 h 708025"/>
              <a:gd name="connsiteX68" fmla="*/ 603250 w 914400"/>
              <a:gd name="connsiteY68" fmla="*/ 685800 h 708025"/>
              <a:gd name="connsiteX69" fmla="*/ 612775 w 914400"/>
              <a:gd name="connsiteY69" fmla="*/ 682625 h 708025"/>
              <a:gd name="connsiteX70" fmla="*/ 644525 w 914400"/>
              <a:gd name="connsiteY70" fmla="*/ 676275 h 708025"/>
              <a:gd name="connsiteX71" fmla="*/ 657225 w 914400"/>
              <a:gd name="connsiteY71" fmla="*/ 673100 h 708025"/>
              <a:gd name="connsiteX72" fmla="*/ 676275 w 914400"/>
              <a:gd name="connsiteY72" fmla="*/ 666750 h 708025"/>
              <a:gd name="connsiteX73" fmla="*/ 701675 w 914400"/>
              <a:gd name="connsiteY73" fmla="*/ 660400 h 708025"/>
              <a:gd name="connsiteX74" fmla="*/ 720725 w 914400"/>
              <a:gd name="connsiteY74" fmla="*/ 647700 h 708025"/>
              <a:gd name="connsiteX75" fmla="*/ 730250 w 914400"/>
              <a:gd name="connsiteY75" fmla="*/ 644525 h 708025"/>
              <a:gd name="connsiteX76" fmla="*/ 755650 w 914400"/>
              <a:gd name="connsiteY76" fmla="*/ 638175 h 708025"/>
              <a:gd name="connsiteX77" fmla="*/ 765175 w 914400"/>
              <a:gd name="connsiteY77" fmla="*/ 631825 h 708025"/>
              <a:gd name="connsiteX78" fmla="*/ 774700 w 914400"/>
              <a:gd name="connsiteY78" fmla="*/ 628650 h 708025"/>
              <a:gd name="connsiteX79" fmla="*/ 793750 w 914400"/>
              <a:gd name="connsiteY79" fmla="*/ 615950 h 708025"/>
              <a:gd name="connsiteX80" fmla="*/ 812800 w 914400"/>
              <a:gd name="connsiteY80" fmla="*/ 603250 h 708025"/>
              <a:gd name="connsiteX81" fmla="*/ 822325 w 914400"/>
              <a:gd name="connsiteY81" fmla="*/ 600075 h 708025"/>
              <a:gd name="connsiteX82" fmla="*/ 841375 w 914400"/>
              <a:gd name="connsiteY82" fmla="*/ 587375 h 708025"/>
              <a:gd name="connsiteX83" fmla="*/ 850900 w 914400"/>
              <a:gd name="connsiteY83" fmla="*/ 581025 h 708025"/>
              <a:gd name="connsiteX84" fmla="*/ 860425 w 914400"/>
              <a:gd name="connsiteY84" fmla="*/ 577850 h 708025"/>
              <a:gd name="connsiteX85" fmla="*/ 866775 w 914400"/>
              <a:gd name="connsiteY85" fmla="*/ 568325 h 708025"/>
              <a:gd name="connsiteX86" fmla="*/ 882650 w 914400"/>
              <a:gd name="connsiteY86" fmla="*/ 552450 h 708025"/>
              <a:gd name="connsiteX87" fmla="*/ 901700 w 914400"/>
              <a:gd name="connsiteY87" fmla="*/ 514350 h 708025"/>
              <a:gd name="connsiteX88" fmla="*/ 908050 w 914400"/>
              <a:gd name="connsiteY88" fmla="*/ 504825 h 708025"/>
              <a:gd name="connsiteX89" fmla="*/ 914400 w 914400"/>
              <a:gd name="connsiteY89" fmla="*/ 485775 h 708025"/>
              <a:gd name="connsiteX90" fmla="*/ 908050 w 914400"/>
              <a:gd name="connsiteY90" fmla="*/ 466725 h 708025"/>
              <a:gd name="connsiteX91" fmla="*/ 904875 w 914400"/>
              <a:gd name="connsiteY91" fmla="*/ 457200 h 708025"/>
              <a:gd name="connsiteX92" fmla="*/ 892175 w 914400"/>
              <a:gd name="connsiteY92" fmla="*/ 438150 h 708025"/>
              <a:gd name="connsiteX93" fmla="*/ 879475 w 914400"/>
              <a:gd name="connsiteY93" fmla="*/ 409575 h 708025"/>
              <a:gd name="connsiteX94" fmla="*/ 876300 w 914400"/>
              <a:gd name="connsiteY94" fmla="*/ 400050 h 708025"/>
              <a:gd name="connsiteX95" fmla="*/ 869950 w 914400"/>
              <a:gd name="connsiteY95" fmla="*/ 390525 h 708025"/>
              <a:gd name="connsiteX96" fmla="*/ 866775 w 914400"/>
              <a:gd name="connsiteY96" fmla="*/ 381000 h 708025"/>
              <a:gd name="connsiteX97" fmla="*/ 860425 w 914400"/>
              <a:gd name="connsiteY97" fmla="*/ 371475 h 708025"/>
              <a:gd name="connsiteX98" fmla="*/ 857250 w 914400"/>
              <a:gd name="connsiteY98" fmla="*/ 361950 h 708025"/>
              <a:gd name="connsiteX99" fmla="*/ 850900 w 914400"/>
              <a:gd name="connsiteY99" fmla="*/ 352425 h 708025"/>
              <a:gd name="connsiteX100" fmla="*/ 841375 w 914400"/>
              <a:gd name="connsiteY100" fmla="*/ 323850 h 708025"/>
              <a:gd name="connsiteX101" fmla="*/ 828675 w 914400"/>
              <a:gd name="connsiteY101" fmla="*/ 304800 h 708025"/>
              <a:gd name="connsiteX102" fmla="*/ 822325 w 914400"/>
              <a:gd name="connsiteY102" fmla="*/ 295275 h 708025"/>
              <a:gd name="connsiteX103" fmla="*/ 812800 w 914400"/>
              <a:gd name="connsiteY103" fmla="*/ 285750 h 708025"/>
              <a:gd name="connsiteX104" fmla="*/ 800100 w 914400"/>
              <a:gd name="connsiteY104" fmla="*/ 266700 h 708025"/>
              <a:gd name="connsiteX105" fmla="*/ 793750 w 914400"/>
              <a:gd name="connsiteY105" fmla="*/ 257175 h 708025"/>
              <a:gd name="connsiteX106" fmla="*/ 784225 w 914400"/>
              <a:gd name="connsiteY106" fmla="*/ 250825 h 708025"/>
              <a:gd name="connsiteX107" fmla="*/ 762000 w 914400"/>
              <a:gd name="connsiteY107" fmla="*/ 225425 h 708025"/>
              <a:gd name="connsiteX108" fmla="*/ 739775 w 914400"/>
              <a:gd name="connsiteY108" fmla="*/ 203200 h 708025"/>
              <a:gd name="connsiteX109" fmla="*/ 733425 w 914400"/>
              <a:gd name="connsiteY109" fmla="*/ 193675 h 708025"/>
              <a:gd name="connsiteX110" fmla="*/ 723900 w 914400"/>
              <a:gd name="connsiteY110" fmla="*/ 187325 h 708025"/>
              <a:gd name="connsiteX111" fmla="*/ 692150 w 914400"/>
              <a:gd name="connsiteY111" fmla="*/ 177800 h 708025"/>
              <a:gd name="connsiteX112" fmla="*/ 657225 w 914400"/>
              <a:gd name="connsiteY112" fmla="*/ 168275 h 708025"/>
              <a:gd name="connsiteX113" fmla="*/ 584200 w 914400"/>
              <a:gd name="connsiteY113" fmla="*/ 165100 h 708025"/>
              <a:gd name="connsiteX114" fmla="*/ 571500 w 914400"/>
              <a:gd name="connsiteY114" fmla="*/ 161925 h 708025"/>
              <a:gd name="connsiteX115" fmla="*/ 552450 w 914400"/>
              <a:gd name="connsiteY115" fmla="*/ 158750 h 708025"/>
              <a:gd name="connsiteX116" fmla="*/ 533400 w 914400"/>
              <a:gd name="connsiteY116" fmla="*/ 152400 h 708025"/>
              <a:gd name="connsiteX117" fmla="*/ 514350 w 914400"/>
              <a:gd name="connsiteY117" fmla="*/ 146050 h 708025"/>
              <a:gd name="connsiteX118" fmla="*/ 479425 w 914400"/>
              <a:gd name="connsiteY118" fmla="*/ 142875 h 708025"/>
              <a:gd name="connsiteX119" fmla="*/ 447675 w 914400"/>
              <a:gd name="connsiteY119" fmla="*/ 136525 h 708025"/>
              <a:gd name="connsiteX120" fmla="*/ 428625 w 914400"/>
              <a:gd name="connsiteY120" fmla="*/ 123825 h 708025"/>
              <a:gd name="connsiteX121" fmla="*/ 419100 w 914400"/>
              <a:gd name="connsiteY121" fmla="*/ 104775 h 708025"/>
              <a:gd name="connsiteX122" fmla="*/ 390525 w 914400"/>
              <a:gd name="connsiteY122" fmla="*/ 85725 h 708025"/>
              <a:gd name="connsiteX123" fmla="*/ 384175 w 914400"/>
              <a:gd name="connsiteY123" fmla="*/ 79375 h 7080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</a:cxnLst>
            <a:rect l="l" t="t" r="r" b="b"/>
            <a:pathLst>
              <a:path w="914400" h="708025">
                <a:moveTo>
                  <a:pt x="425450" y="114300"/>
                </a:moveTo>
                <a:cubicBezTo>
                  <a:pt x="420158" y="111125"/>
                  <a:pt x="414260" y="108791"/>
                  <a:pt x="409575" y="104775"/>
                </a:cubicBezTo>
                <a:cubicBezTo>
                  <a:pt x="391297" y="89108"/>
                  <a:pt x="415678" y="99401"/>
                  <a:pt x="393700" y="92075"/>
                </a:cubicBezTo>
                <a:cubicBezTo>
                  <a:pt x="391608" y="85800"/>
                  <a:pt x="389770" y="77501"/>
                  <a:pt x="384175" y="73025"/>
                </a:cubicBezTo>
                <a:cubicBezTo>
                  <a:pt x="381562" y="70934"/>
                  <a:pt x="377825" y="70908"/>
                  <a:pt x="374650" y="69850"/>
                </a:cubicBezTo>
                <a:cubicBezTo>
                  <a:pt x="371475" y="67733"/>
                  <a:pt x="368056" y="65943"/>
                  <a:pt x="365125" y="63500"/>
                </a:cubicBezTo>
                <a:cubicBezTo>
                  <a:pt x="361676" y="60625"/>
                  <a:pt x="359336" y="56466"/>
                  <a:pt x="355600" y="53975"/>
                </a:cubicBezTo>
                <a:cubicBezTo>
                  <a:pt x="352815" y="52119"/>
                  <a:pt x="349250" y="51858"/>
                  <a:pt x="346075" y="50800"/>
                </a:cubicBezTo>
                <a:cubicBezTo>
                  <a:pt x="339725" y="46567"/>
                  <a:pt x="332421" y="43496"/>
                  <a:pt x="327025" y="38100"/>
                </a:cubicBezTo>
                <a:cubicBezTo>
                  <a:pt x="315133" y="26208"/>
                  <a:pt x="321760" y="29995"/>
                  <a:pt x="307975" y="25400"/>
                </a:cubicBezTo>
                <a:lnTo>
                  <a:pt x="288925" y="12700"/>
                </a:lnTo>
                <a:cubicBezTo>
                  <a:pt x="283356" y="8987"/>
                  <a:pt x="276225" y="8467"/>
                  <a:pt x="269875" y="6350"/>
                </a:cubicBezTo>
                <a:cubicBezTo>
                  <a:pt x="263768" y="4314"/>
                  <a:pt x="257159" y="4327"/>
                  <a:pt x="250825" y="3175"/>
                </a:cubicBezTo>
                <a:cubicBezTo>
                  <a:pt x="245516" y="2210"/>
                  <a:pt x="240242" y="1058"/>
                  <a:pt x="234950" y="0"/>
                </a:cubicBezTo>
                <a:cubicBezTo>
                  <a:pt x="220226" y="1339"/>
                  <a:pt x="193894" y="3131"/>
                  <a:pt x="177800" y="6350"/>
                </a:cubicBezTo>
                <a:cubicBezTo>
                  <a:pt x="174518" y="7006"/>
                  <a:pt x="171450" y="8467"/>
                  <a:pt x="168275" y="9525"/>
                </a:cubicBezTo>
                <a:cubicBezTo>
                  <a:pt x="140978" y="27723"/>
                  <a:pt x="175515" y="5905"/>
                  <a:pt x="149225" y="19050"/>
                </a:cubicBezTo>
                <a:cubicBezTo>
                  <a:pt x="124606" y="31360"/>
                  <a:pt x="154116" y="20595"/>
                  <a:pt x="130175" y="28575"/>
                </a:cubicBezTo>
                <a:lnTo>
                  <a:pt x="82550" y="60325"/>
                </a:lnTo>
                <a:lnTo>
                  <a:pt x="63500" y="73025"/>
                </a:lnTo>
                <a:lnTo>
                  <a:pt x="53975" y="79375"/>
                </a:lnTo>
                <a:cubicBezTo>
                  <a:pt x="51858" y="82550"/>
                  <a:pt x="50605" y="86516"/>
                  <a:pt x="47625" y="88900"/>
                </a:cubicBezTo>
                <a:cubicBezTo>
                  <a:pt x="45012" y="90991"/>
                  <a:pt x="40467" y="89708"/>
                  <a:pt x="38100" y="92075"/>
                </a:cubicBezTo>
                <a:cubicBezTo>
                  <a:pt x="32704" y="97471"/>
                  <a:pt x="29633" y="104775"/>
                  <a:pt x="25400" y="111125"/>
                </a:cubicBezTo>
                <a:lnTo>
                  <a:pt x="19050" y="120650"/>
                </a:lnTo>
                <a:cubicBezTo>
                  <a:pt x="16933" y="123825"/>
                  <a:pt x="13907" y="126555"/>
                  <a:pt x="12700" y="130175"/>
                </a:cubicBezTo>
                <a:lnTo>
                  <a:pt x="6350" y="149225"/>
                </a:lnTo>
                <a:cubicBezTo>
                  <a:pt x="5292" y="152400"/>
                  <a:pt x="3831" y="155468"/>
                  <a:pt x="3175" y="158750"/>
                </a:cubicBezTo>
                <a:lnTo>
                  <a:pt x="0" y="174625"/>
                </a:lnTo>
                <a:cubicBezTo>
                  <a:pt x="1058" y="197908"/>
                  <a:pt x="1514" y="221227"/>
                  <a:pt x="3175" y="244475"/>
                </a:cubicBezTo>
                <a:cubicBezTo>
                  <a:pt x="3634" y="250896"/>
                  <a:pt x="5371" y="257162"/>
                  <a:pt x="6350" y="263525"/>
                </a:cubicBezTo>
                <a:cubicBezTo>
                  <a:pt x="7488" y="270922"/>
                  <a:pt x="8057" y="278412"/>
                  <a:pt x="9525" y="285750"/>
                </a:cubicBezTo>
                <a:cubicBezTo>
                  <a:pt x="11920" y="297725"/>
                  <a:pt x="18126" y="303413"/>
                  <a:pt x="25400" y="314325"/>
                </a:cubicBezTo>
                <a:cubicBezTo>
                  <a:pt x="27256" y="317110"/>
                  <a:pt x="26950" y="320924"/>
                  <a:pt x="28575" y="323850"/>
                </a:cubicBezTo>
                <a:cubicBezTo>
                  <a:pt x="32281" y="330521"/>
                  <a:pt x="38862" y="335660"/>
                  <a:pt x="41275" y="342900"/>
                </a:cubicBezTo>
                <a:cubicBezTo>
                  <a:pt x="49255" y="366841"/>
                  <a:pt x="38490" y="337331"/>
                  <a:pt x="50800" y="361950"/>
                </a:cubicBezTo>
                <a:cubicBezTo>
                  <a:pt x="52297" y="364943"/>
                  <a:pt x="52478" y="368482"/>
                  <a:pt x="53975" y="371475"/>
                </a:cubicBezTo>
                <a:cubicBezTo>
                  <a:pt x="55682" y="374888"/>
                  <a:pt x="58618" y="377587"/>
                  <a:pt x="60325" y="381000"/>
                </a:cubicBezTo>
                <a:cubicBezTo>
                  <a:pt x="61822" y="383993"/>
                  <a:pt x="62003" y="387532"/>
                  <a:pt x="63500" y="390525"/>
                </a:cubicBezTo>
                <a:cubicBezTo>
                  <a:pt x="65207" y="393938"/>
                  <a:pt x="68300" y="396563"/>
                  <a:pt x="69850" y="400050"/>
                </a:cubicBezTo>
                <a:cubicBezTo>
                  <a:pt x="72568" y="406167"/>
                  <a:pt x="74083" y="412750"/>
                  <a:pt x="76200" y="419100"/>
                </a:cubicBezTo>
                <a:lnTo>
                  <a:pt x="79375" y="428625"/>
                </a:lnTo>
                <a:cubicBezTo>
                  <a:pt x="80433" y="431800"/>
                  <a:pt x="79765" y="436294"/>
                  <a:pt x="82550" y="438150"/>
                </a:cubicBezTo>
                <a:lnTo>
                  <a:pt x="92075" y="444500"/>
                </a:lnTo>
                <a:cubicBezTo>
                  <a:pt x="94192" y="450850"/>
                  <a:pt x="92856" y="459837"/>
                  <a:pt x="98425" y="463550"/>
                </a:cubicBezTo>
                <a:cubicBezTo>
                  <a:pt x="107791" y="469794"/>
                  <a:pt x="109835" y="470258"/>
                  <a:pt x="117475" y="479425"/>
                </a:cubicBezTo>
                <a:cubicBezTo>
                  <a:pt x="128522" y="492682"/>
                  <a:pt x="117713" y="486913"/>
                  <a:pt x="133350" y="492125"/>
                </a:cubicBezTo>
                <a:cubicBezTo>
                  <a:pt x="139332" y="498107"/>
                  <a:pt x="144443" y="504464"/>
                  <a:pt x="152400" y="508000"/>
                </a:cubicBezTo>
                <a:cubicBezTo>
                  <a:pt x="158517" y="510718"/>
                  <a:pt x="165100" y="512233"/>
                  <a:pt x="171450" y="514350"/>
                </a:cubicBezTo>
                <a:lnTo>
                  <a:pt x="180975" y="517525"/>
                </a:lnTo>
                <a:cubicBezTo>
                  <a:pt x="184150" y="519642"/>
                  <a:pt x="187013" y="522325"/>
                  <a:pt x="190500" y="523875"/>
                </a:cubicBezTo>
                <a:cubicBezTo>
                  <a:pt x="208015" y="531659"/>
                  <a:pt x="208352" y="529132"/>
                  <a:pt x="225425" y="533400"/>
                </a:cubicBezTo>
                <a:cubicBezTo>
                  <a:pt x="228672" y="534212"/>
                  <a:pt x="231775" y="535517"/>
                  <a:pt x="234950" y="536575"/>
                </a:cubicBezTo>
                <a:lnTo>
                  <a:pt x="260350" y="574675"/>
                </a:lnTo>
                <a:cubicBezTo>
                  <a:pt x="262467" y="577850"/>
                  <a:pt x="265493" y="580580"/>
                  <a:pt x="266700" y="584200"/>
                </a:cubicBezTo>
                <a:lnTo>
                  <a:pt x="273050" y="603250"/>
                </a:lnTo>
                <a:cubicBezTo>
                  <a:pt x="274108" y="606425"/>
                  <a:pt x="274369" y="609990"/>
                  <a:pt x="276225" y="612775"/>
                </a:cubicBezTo>
                <a:cubicBezTo>
                  <a:pt x="280458" y="619125"/>
                  <a:pt x="286512" y="624585"/>
                  <a:pt x="288925" y="631825"/>
                </a:cubicBezTo>
                <a:cubicBezTo>
                  <a:pt x="293307" y="644970"/>
                  <a:pt x="289315" y="639494"/>
                  <a:pt x="301625" y="647700"/>
                </a:cubicBezTo>
                <a:cubicBezTo>
                  <a:pt x="313267" y="665162"/>
                  <a:pt x="301625" y="650346"/>
                  <a:pt x="317500" y="663575"/>
                </a:cubicBezTo>
                <a:cubicBezTo>
                  <a:pt x="320949" y="666450"/>
                  <a:pt x="323481" y="670343"/>
                  <a:pt x="327025" y="673100"/>
                </a:cubicBezTo>
                <a:cubicBezTo>
                  <a:pt x="343401" y="685837"/>
                  <a:pt x="341229" y="684185"/>
                  <a:pt x="355600" y="688975"/>
                </a:cubicBezTo>
                <a:cubicBezTo>
                  <a:pt x="382897" y="707173"/>
                  <a:pt x="348360" y="685355"/>
                  <a:pt x="374650" y="698500"/>
                </a:cubicBezTo>
                <a:cubicBezTo>
                  <a:pt x="399269" y="710810"/>
                  <a:pt x="369759" y="700045"/>
                  <a:pt x="393700" y="708025"/>
                </a:cubicBezTo>
                <a:cubicBezTo>
                  <a:pt x="431800" y="706967"/>
                  <a:pt x="469935" y="706802"/>
                  <a:pt x="508000" y="704850"/>
                </a:cubicBezTo>
                <a:cubicBezTo>
                  <a:pt x="511342" y="704679"/>
                  <a:pt x="514307" y="702594"/>
                  <a:pt x="517525" y="701675"/>
                </a:cubicBezTo>
                <a:cubicBezTo>
                  <a:pt x="521721" y="700476"/>
                  <a:pt x="525932" y="699281"/>
                  <a:pt x="530225" y="698500"/>
                </a:cubicBezTo>
                <a:cubicBezTo>
                  <a:pt x="539865" y="696747"/>
                  <a:pt x="569005" y="693256"/>
                  <a:pt x="577850" y="692150"/>
                </a:cubicBezTo>
                <a:cubicBezTo>
                  <a:pt x="599623" y="684892"/>
                  <a:pt x="572599" y="693463"/>
                  <a:pt x="603250" y="685800"/>
                </a:cubicBezTo>
                <a:cubicBezTo>
                  <a:pt x="606497" y="684988"/>
                  <a:pt x="609514" y="683378"/>
                  <a:pt x="612775" y="682625"/>
                </a:cubicBezTo>
                <a:cubicBezTo>
                  <a:pt x="623292" y="680198"/>
                  <a:pt x="633942" y="678392"/>
                  <a:pt x="644525" y="676275"/>
                </a:cubicBezTo>
                <a:cubicBezTo>
                  <a:pt x="648804" y="675419"/>
                  <a:pt x="653045" y="674354"/>
                  <a:pt x="657225" y="673100"/>
                </a:cubicBezTo>
                <a:cubicBezTo>
                  <a:pt x="663636" y="671177"/>
                  <a:pt x="669711" y="668063"/>
                  <a:pt x="676275" y="666750"/>
                </a:cubicBezTo>
                <a:cubicBezTo>
                  <a:pt x="695432" y="662919"/>
                  <a:pt x="687030" y="665282"/>
                  <a:pt x="701675" y="660400"/>
                </a:cubicBezTo>
                <a:lnTo>
                  <a:pt x="720725" y="647700"/>
                </a:lnTo>
                <a:cubicBezTo>
                  <a:pt x="723510" y="645844"/>
                  <a:pt x="727003" y="645337"/>
                  <a:pt x="730250" y="644525"/>
                </a:cubicBezTo>
                <a:lnTo>
                  <a:pt x="755650" y="638175"/>
                </a:lnTo>
                <a:cubicBezTo>
                  <a:pt x="758825" y="636058"/>
                  <a:pt x="761762" y="633532"/>
                  <a:pt x="765175" y="631825"/>
                </a:cubicBezTo>
                <a:cubicBezTo>
                  <a:pt x="768168" y="630328"/>
                  <a:pt x="771774" y="630275"/>
                  <a:pt x="774700" y="628650"/>
                </a:cubicBezTo>
                <a:cubicBezTo>
                  <a:pt x="781371" y="624944"/>
                  <a:pt x="787400" y="620183"/>
                  <a:pt x="793750" y="615950"/>
                </a:cubicBezTo>
                <a:lnTo>
                  <a:pt x="812800" y="603250"/>
                </a:lnTo>
                <a:cubicBezTo>
                  <a:pt x="815585" y="601394"/>
                  <a:pt x="819150" y="601133"/>
                  <a:pt x="822325" y="600075"/>
                </a:cubicBezTo>
                <a:lnTo>
                  <a:pt x="841375" y="587375"/>
                </a:lnTo>
                <a:cubicBezTo>
                  <a:pt x="844550" y="585258"/>
                  <a:pt x="847280" y="582232"/>
                  <a:pt x="850900" y="581025"/>
                </a:cubicBezTo>
                <a:lnTo>
                  <a:pt x="860425" y="577850"/>
                </a:lnTo>
                <a:cubicBezTo>
                  <a:pt x="862542" y="574675"/>
                  <a:pt x="864077" y="571023"/>
                  <a:pt x="866775" y="568325"/>
                </a:cubicBezTo>
                <a:cubicBezTo>
                  <a:pt x="877782" y="557318"/>
                  <a:pt x="875877" y="567690"/>
                  <a:pt x="882650" y="552450"/>
                </a:cubicBezTo>
                <a:cubicBezTo>
                  <a:pt x="900177" y="513015"/>
                  <a:pt x="875295" y="553957"/>
                  <a:pt x="901700" y="514350"/>
                </a:cubicBezTo>
                <a:lnTo>
                  <a:pt x="908050" y="504825"/>
                </a:lnTo>
                <a:cubicBezTo>
                  <a:pt x="911763" y="499256"/>
                  <a:pt x="914400" y="485775"/>
                  <a:pt x="914400" y="485775"/>
                </a:cubicBezTo>
                <a:lnTo>
                  <a:pt x="908050" y="466725"/>
                </a:lnTo>
                <a:cubicBezTo>
                  <a:pt x="906992" y="463550"/>
                  <a:pt x="906731" y="459985"/>
                  <a:pt x="904875" y="457200"/>
                </a:cubicBezTo>
                <a:cubicBezTo>
                  <a:pt x="900642" y="450850"/>
                  <a:pt x="894588" y="445390"/>
                  <a:pt x="892175" y="438150"/>
                </a:cubicBezTo>
                <a:cubicBezTo>
                  <a:pt x="875793" y="389003"/>
                  <a:pt x="894569" y="439764"/>
                  <a:pt x="879475" y="409575"/>
                </a:cubicBezTo>
                <a:cubicBezTo>
                  <a:pt x="877978" y="406582"/>
                  <a:pt x="877797" y="403043"/>
                  <a:pt x="876300" y="400050"/>
                </a:cubicBezTo>
                <a:cubicBezTo>
                  <a:pt x="874593" y="396637"/>
                  <a:pt x="871657" y="393938"/>
                  <a:pt x="869950" y="390525"/>
                </a:cubicBezTo>
                <a:cubicBezTo>
                  <a:pt x="868453" y="387532"/>
                  <a:pt x="868272" y="383993"/>
                  <a:pt x="866775" y="381000"/>
                </a:cubicBezTo>
                <a:cubicBezTo>
                  <a:pt x="865068" y="377587"/>
                  <a:pt x="862132" y="374888"/>
                  <a:pt x="860425" y="371475"/>
                </a:cubicBezTo>
                <a:cubicBezTo>
                  <a:pt x="858928" y="368482"/>
                  <a:pt x="858747" y="364943"/>
                  <a:pt x="857250" y="361950"/>
                </a:cubicBezTo>
                <a:cubicBezTo>
                  <a:pt x="855543" y="358537"/>
                  <a:pt x="852450" y="355912"/>
                  <a:pt x="850900" y="352425"/>
                </a:cubicBezTo>
                <a:lnTo>
                  <a:pt x="841375" y="323850"/>
                </a:lnTo>
                <a:cubicBezTo>
                  <a:pt x="838962" y="316610"/>
                  <a:pt x="832908" y="311150"/>
                  <a:pt x="828675" y="304800"/>
                </a:cubicBezTo>
                <a:cubicBezTo>
                  <a:pt x="826558" y="301625"/>
                  <a:pt x="825023" y="297973"/>
                  <a:pt x="822325" y="295275"/>
                </a:cubicBezTo>
                <a:cubicBezTo>
                  <a:pt x="819150" y="292100"/>
                  <a:pt x="815557" y="289294"/>
                  <a:pt x="812800" y="285750"/>
                </a:cubicBezTo>
                <a:cubicBezTo>
                  <a:pt x="808115" y="279726"/>
                  <a:pt x="804333" y="273050"/>
                  <a:pt x="800100" y="266700"/>
                </a:cubicBezTo>
                <a:cubicBezTo>
                  <a:pt x="797983" y="263525"/>
                  <a:pt x="796925" y="259292"/>
                  <a:pt x="793750" y="257175"/>
                </a:cubicBezTo>
                <a:lnTo>
                  <a:pt x="784225" y="250825"/>
                </a:lnTo>
                <a:cubicBezTo>
                  <a:pt x="769408" y="228600"/>
                  <a:pt x="777875" y="236008"/>
                  <a:pt x="762000" y="225425"/>
                </a:cubicBezTo>
                <a:cubicBezTo>
                  <a:pt x="747444" y="203590"/>
                  <a:pt x="756540" y="208788"/>
                  <a:pt x="739775" y="203200"/>
                </a:cubicBezTo>
                <a:cubicBezTo>
                  <a:pt x="737658" y="200025"/>
                  <a:pt x="736123" y="196373"/>
                  <a:pt x="733425" y="193675"/>
                </a:cubicBezTo>
                <a:cubicBezTo>
                  <a:pt x="730727" y="190977"/>
                  <a:pt x="727387" y="188875"/>
                  <a:pt x="723900" y="187325"/>
                </a:cubicBezTo>
                <a:cubicBezTo>
                  <a:pt x="708357" y="180417"/>
                  <a:pt x="706358" y="182063"/>
                  <a:pt x="692150" y="177800"/>
                </a:cubicBezTo>
                <a:cubicBezTo>
                  <a:pt x="680111" y="174188"/>
                  <a:pt x="669884" y="169179"/>
                  <a:pt x="657225" y="168275"/>
                </a:cubicBezTo>
                <a:cubicBezTo>
                  <a:pt x="632922" y="166539"/>
                  <a:pt x="608542" y="166158"/>
                  <a:pt x="584200" y="165100"/>
                </a:cubicBezTo>
                <a:cubicBezTo>
                  <a:pt x="579967" y="164042"/>
                  <a:pt x="575779" y="162781"/>
                  <a:pt x="571500" y="161925"/>
                </a:cubicBezTo>
                <a:cubicBezTo>
                  <a:pt x="565187" y="160662"/>
                  <a:pt x="558695" y="160311"/>
                  <a:pt x="552450" y="158750"/>
                </a:cubicBezTo>
                <a:cubicBezTo>
                  <a:pt x="545956" y="157127"/>
                  <a:pt x="539750" y="154517"/>
                  <a:pt x="533400" y="152400"/>
                </a:cubicBezTo>
                <a:lnTo>
                  <a:pt x="514350" y="146050"/>
                </a:lnTo>
                <a:cubicBezTo>
                  <a:pt x="503260" y="142353"/>
                  <a:pt x="491035" y="144241"/>
                  <a:pt x="479425" y="142875"/>
                </a:cubicBezTo>
                <a:cubicBezTo>
                  <a:pt x="464720" y="141145"/>
                  <a:pt x="460757" y="139796"/>
                  <a:pt x="447675" y="136525"/>
                </a:cubicBezTo>
                <a:cubicBezTo>
                  <a:pt x="441325" y="132292"/>
                  <a:pt x="431038" y="131065"/>
                  <a:pt x="428625" y="123825"/>
                </a:cubicBezTo>
                <a:cubicBezTo>
                  <a:pt x="426360" y="117031"/>
                  <a:pt x="424893" y="109844"/>
                  <a:pt x="419100" y="104775"/>
                </a:cubicBezTo>
                <a:lnTo>
                  <a:pt x="390525" y="85725"/>
                </a:lnTo>
                <a:cubicBezTo>
                  <a:pt x="388034" y="84065"/>
                  <a:pt x="386292" y="81492"/>
                  <a:pt x="384175" y="79375"/>
                </a:cubicBezTo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noFill/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74" name="フリーフォーム 173"/>
          <p:cNvSpPr/>
          <p:nvPr/>
        </p:nvSpPr>
        <p:spPr>
          <a:xfrm>
            <a:off x="5313784" y="5204172"/>
            <a:ext cx="914400" cy="708025"/>
          </a:xfrm>
          <a:custGeom>
            <a:avLst/>
            <a:gdLst>
              <a:gd name="connsiteX0" fmla="*/ 425450 w 914400"/>
              <a:gd name="connsiteY0" fmla="*/ 114300 h 708025"/>
              <a:gd name="connsiteX1" fmla="*/ 409575 w 914400"/>
              <a:gd name="connsiteY1" fmla="*/ 104775 h 708025"/>
              <a:gd name="connsiteX2" fmla="*/ 393700 w 914400"/>
              <a:gd name="connsiteY2" fmla="*/ 92075 h 708025"/>
              <a:gd name="connsiteX3" fmla="*/ 384175 w 914400"/>
              <a:gd name="connsiteY3" fmla="*/ 73025 h 708025"/>
              <a:gd name="connsiteX4" fmla="*/ 374650 w 914400"/>
              <a:gd name="connsiteY4" fmla="*/ 69850 h 708025"/>
              <a:gd name="connsiteX5" fmla="*/ 365125 w 914400"/>
              <a:gd name="connsiteY5" fmla="*/ 63500 h 708025"/>
              <a:gd name="connsiteX6" fmla="*/ 355600 w 914400"/>
              <a:gd name="connsiteY6" fmla="*/ 53975 h 708025"/>
              <a:gd name="connsiteX7" fmla="*/ 346075 w 914400"/>
              <a:gd name="connsiteY7" fmla="*/ 50800 h 708025"/>
              <a:gd name="connsiteX8" fmla="*/ 327025 w 914400"/>
              <a:gd name="connsiteY8" fmla="*/ 38100 h 708025"/>
              <a:gd name="connsiteX9" fmla="*/ 307975 w 914400"/>
              <a:gd name="connsiteY9" fmla="*/ 25400 h 708025"/>
              <a:gd name="connsiteX10" fmla="*/ 288925 w 914400"/>
              <a:gd name="connsiteY10" fmla="*/ 12700 h 708025"/>
              <a:gd name="connsiteX11" fmla="*/ 269875 w 914400"/>
              <a:gd name="connsiteY11" fmla="*/ 6350 h 708025"/>
              <a:gd name="connsiteX12" fmla="*/ 250825 w 914400"/>
              <a:gd name="connsiteY12" fmla="*/ 3175 h 708025"/>
              <a:gd name="connsiteX13" fmla="*/ 234950 w 914400"/>
              <a:gd name="connsiteY13" fmla="*/ 0 h 708025"/>
              <a:gd name="connsiteX14" fmla="*/ 177800 w 914400"/>
              <a:gd name="connsiteY14" fmla="*/ 6350 h 708025"/>
              <a:gd name="connsiteX15" fmla="*/ 168275 w 914400"/>
              <a:gd name="connsiteY15" fmla="*/ 9525 h 708025"/>
              <a:gd name="connsiteX16" fmla="*/ 149225 w 914400"/>
              <a:gd name="connsiteY16" fmla="*/ 19050 h 708025"/>
              <a:gd name="connsiteX17" fmla="*/ 130175 w 914400"/>
              <a:gd name="connsiteY17" fmla="*/ 28575 h 708025"/>
              <a:gd name="connsiteX18" fmla="*/ 82550 w 914400"/>
              <a:gd name="connsiteY18" fmla="*/ 60325 h 708025"/>
              <a:gd name="connsiteX19" fmla="*/ 63500 w 914400"/>
              <a:gd name="connsiteY19" fmla="*/ 73025 h 708025"/>
              <a:gd name="connsiteX20" fmla="*/ 53975 w 914400"/>
              <a:gd name="connsiteY20" fmla="*/ 79375 h 708025"/>
              <a:gd name="connsiteX21" fmla="*/ 47625 w 914400"/>
              <a:gd name="connsiteY21" fmla="*/ 88900 h 708025"/>
              <a:gd name="connsiteX22" fmla="*/ 38100 w 914400"/>
              <a:gd name="connsiteY22" fmla="*/ 92075 h 708025"/>
              <a:gd name="connsiteX23" fmla="*/ 25400 w 914400"/>
              <a:gd name="connsiteY23" fmla="*/ 111125 h 708025"/>
              <a:gd name="connsiteX24" fmla="*/ 19050 w 914400"/>
              <a:gd name="connsiteY24" fmla="*/ 120650 h 708025"/>
              <a:gd name="connsiteX25" fmla="*/ 12700 w 914400"/>
              <a:gd name="connsiteY25" fmla="*/ 130175 h 708025"/>
              <a:gd name="connsiteX26" fmla="*/ 6350 w 914400"/>
              <a:gd name="connsiteY26" fmla="*/ 149225 h 708025"/>
              <a:gd name="connsiteX27" fmla="*/ 3175 w 914400"/>
              <a:gd name="connsiteY27" fmla="*/ 158750 h 708025"/>
              <a:gd name="connsiteX28" fmla="*/ 0 w 914400"/>
              <a:gd name="connsiteY28" fmla="*/ 174625 h 708025"/>
              <a:gd name="connsiteX29" fmla="*/ 3175 w 914400"/>
              <a:gd name="connsiteY29" fmla="*/ 244475 h 708025"/>
              <a:gd name="connsiteX30" fmla="*/ 6350 w 914400"/>
              <a:gd name="connsiteY30" fmla="*/ 263525 h 708025"/>
              <a:gd name="connsiteX31" fmla="*/ 9525 w 914400"/>
              <a:gd name="connsiteY31" fmla="*/ 285750 h 708025"/>
              <a:gd name="connsiteX32" fmla="*/ 25400 w 914400"/>
              <a:gd name="connsiteY32" fmla="*/ 314325 h 708025"/>
              <a:gd name="connsiteX33" fmla="*/ 28575 w 914400"/>
              <a:gd name="connsiteY33" fmla="*/ 323850 h 708025"/>
              <a:gd name="connsiteX34" fmla="*/ 41275 w 914400"/>
              <a:gd name="connsiteY34" fmla="*/ 342900 h 708025"/>
              <a:gd name="connsiteX35" fmla="*/ 50800 w 914400"/>
              <a:gd name="connsiteY35" fmla="*/ 361950 h 708025"/>
              <a:gd name="connsiteX36" fmla="*/ 53975 w 914400"/>
              <a:gd name="connsiteY36" fmla="*/ 371475 h 708025"/>
              <a:gd name="connsiteX37" fmla="*/ 60325 w 914400"/>
              <a:gd name="connsiteY37" fmla="*/ 381000 h 708025"/>
              <a:gd name="connsiteX38" fmla="*/ 63500 w 914400"/>
              <a:gd name="connsiteY38" fmla="*/ 390525 h 708025"/>
              <a:gd name="connsiteX39" fmla="*/ 69850 w 914400"/>
              <a:gd name="connsiteY39" fmla="*/ 400050 h 708025"/>
              <a:gd name="connsiteX40" fmla="*/ 76200 w 914400"/>
              <a:gd name="connsiteY40" fmla="*/ 419100 h 708025"/>
              <a:gd name="connsiteX41" fmla="*/ 79375 w 914400"/>
              <a:gd name="connsiteY41" fmla="*/ 428625 h 708025"/>
              <a:gd name="connsiteX42" fmla="*/ 82550 w 914400"/>
              <a:gd name="connsiteY42" fmla="*/ 438150 h 708025"/>
              <a:gd name="connsiteX43" fmla="*/ 92075 w 914400"/>
              <a:gd name="connsiteY43" fmla="*/ 444500 h 708025"/>
              <a:gd name="connsiteX44" fmla="*/ 98425 w 914400"/>
              <a:gd name="connsiteY44" fmla="*/ 463550 h 708025"/>
              <a:gd name="connsiteX45" fmla="*/ 117475 w 914400"/>
              <a:gd name="connsiteY45" fmla="*/ 479425 h 708025"/>
              <a:gd name="connsiteX46" fmla="*/ 133350 w 914400"/>
              <a:gd name="connsiteY46" fmla="*/ 492125 h 708025"/>
              <a:gd name="connsiteX47" fmla="*/ 152400 w 914400"/>
              <a:gd name="connsiteY47" fmla="*/ 508000 h 708025"/>
              <a:gd name="connsiteX48" fmla="*/ 171450 w 914400"/>
              <a:gd name="connsiteY48" fmla="*/ 514350 h 708025"/>
              <a:gd name="connsiteX49" fmla="*/ 180975 w 914400"/>
              <a:gd name="connsiteY49" fmla="*/ 517525 h 708025"/>
              <a:gd name="connsiteX50" fmla="*/ 190500 w 914400"/>
              <a:gd name="connsiteY50" fmla="*/ 523875 h 708025"/>
              <a:gd name="connsiteX51" fmla="*/ 225425 w 914400"/>
              <a:gd name="connsiteY51" fmla="*/ 533400 h 708025"/>
              <a:gd name="connsiteX52" fmla="*/ 234950 w 914400"/>
              <a:gd name="connsiteY52" fmla="*/ 536575 h 708025"/>
              <a:gd name="connsiteX53" fmla="*/ 260350 w 914400"/>
              <a:gd name="connsiteY53" fmla="*/ 574675 h 708025"/>
              <a:gd name="connsiteX54" fmla="*/ 266700 w 914400"/>
              <a:gd name="connsiteY54" fmla="*/ 584200 h 708025"/>
              <a:gd name="connsiteX55" fmla="*/ 273050 w 914400"/>
              <a:gd name="connsiteY55" fmla="*/ 603250 h 708025"/>
              <a:gd name="connsiteX56" fmla="*/ 276225 w 914400"/>
              <a:gd name="connsiteY56" fmla="*/ 612775 h 708025"/>
              <a:gd name="connsiteX57" fmla="*/ 288925 w 914400"/>
              <a:gd name="connsiteY57" fmla="*/ 631825 h 708025"/>
              <a:gd name="connsiteX58" fmla="*/ 301625 w 914400"/>
              <a:gd name="connsiteY58" fmla="*/ 647700 h 708025"/>
              <a:gd name="connsiteX59" fmla="*/ 317500 w 914400"/>
              <a:gd name="connsiteY59" fmla="*/ 663575 h 708025"/>
              <a:gd name="connsiteX60" fmla="*/ 327025 w 914400"/>
              <a:gd name="connsiteY60" fmla="*/ 673100 h 708025"/>
              <a:gd name="connsiteX61" fmla="*/ 355600 w 914400"/>
              <a:gd name="connsiteY61" fmla="*/ 688975 h 708025"/>
              <a:gd name="connsiteX62" fmla="*/ 374650 w 914400"/>
              <a:gd name="connsiteY62" fmla="*/ 698500 h 708025"/>
              <a:gd name="connsiteX63" fmla="*/ 393700 w 914400"/>
              <a:gd name="connsiteY63" fmla="*/ 708025 h 708025"/>
              <a:gd name="connsiteX64" fmla="*/ 508000 w 914400"/>
              <a:gd name="connsiteY64" fmla="*/ 704850 h 708025"/>
              <a:gd name="connsiteX65" fmla="*/ 517525 w 914400"/>
              <a:gd name="connsiteY65" fmla="*/ 701675 h 708025"/>
              <a:gd name="connsiteX66" fmla="*/ 530225 w 914400"/>
              <a:gd name="connsiteY66" fmla="*/ 698500 h 708025"/>
              <a:gd name="connsiteX67" fmla="*/ 577850 w 914400"/>
              <a:gd name="connsiteY67" fmla="*/ 692150 h 708025"/>
              <a:gd name="connsiteX68" fmla="*/ 603250 w 914400"/>
              <a:gd name="connsiteY68" fmla="*/ 685800 h 708025"/>
              <a:gd name="connsiteX69" fmla="*/ 612775 w 914400"/>
              <a:gd name="connsiteY69" fmla="*/ 682625 h 708025"/>
              <a:gd name="connsiteX70" fmla="*/ 644525 w 914400"/>
              <a:gd name="connsiteY70" fmla="*/ 676275 h 708025"/>
              <a:gd name="connsiteX71" fmla="*/ 657225 w 914400"/>
              <a:gd name="connsiteY71" fmla="*/ 673100 h 708025"/>
              <a:gd name="connsiteX72" fmla="*/ 676275 w 914400"/>
              <a:gd name="connsiteY72" fmla="*/ 666750 h 708025"/>
              <a:gd name="connsiteX73" fmla="*/ 701675 w 914400"/>
              <a:gd name="connsiteY73" fmla="*/ 660400 h 708025"/>
              <a:gd name="connsiteX74" fmla="*/ 720725 w 914400"/>
              <a:gd name="connsiteY74" fmla="*/ 647700 h 708025"/>
              <a:gd name="connsiteX75" fmla="*/ 730250 w 914400"/>
              <a:gd name="connsiteY75" fmla="*/ 644525 h 708025"/>
              <a:gd name="connsiteX76" fmla="*/ 755650 w 914400"/>
              <a:gd name="connsiteY76" fmla="*/ 638175 h 708025"/>
              <a:gd name="connsiteX77" fmla="*/ 765175 w 914400"/>
              <a:gd name="connsiteY77" fmla="*/ 631825 h 708025"/>
              <a:gd name="connsiteX78" fmla="*/ 774700 w 914400"/>
              <a:gd name="connsiteY78" fmla="*/ 628650 h 708025"/>
              <a:gd name="connsiteX79" fmla="*/ 793750 w 914400"/>
              <a:gd name="connsiteY79" fmla="*/ 615950 h 708025"/>
              <a:gd name="connsiteX80" fmla="*/ 812800 w 914400"/>
              <a:gd name="connsiteY80" fmla="*/ 603250 h 708025"/>
              <a:gd name="connsiteX81" fmla="*/ 822325 w 914400"/>
              <a:gd name="connsiteY81" fmla="*/ 600075 h 708025"/>
              <a:gd name="connsiteX82" fmla="*/ 841375 w 914400"/>
              <a:gd name="connsiteY82" fmla="*/ 587375 h 708025"/>
              <a:gd name="connsiteX83" fmla="*/ 850900 w 914400"/>
              <a:gd name="connsiteY83" fmla="*/ 581025 h 708025"/>
              <a:gd name="connsiteX84" fmla="*/ 860425 w 914400"/>
              <a:gd name="connsiteY84" fmla="*/ 577850 h 708025"/>
              <a:gd name="connsiteX85" fmla="*/ 866775 w 914400"/>
              <a:gd name="connsiteY85" fmla="*/ 568325 h 708025"/>
              <a:gd name="connsiteX86" fmla="*/ 882650 w 914400"/>
              <a:gd name="connsiteY86" fmla="*/ 552450 h 708025"/>
              <a:gd name="connsiteX87" fmla="*/ 901700 w 914400"/>
              <a:gd name="connsiteY87" fmla="*/ 514350 h 708025"/>
              <a:gd name="connsiteX88" fmla="*/ 908050 w 914400"/>
              <a:gd name="connsiteY88" fmla="*/ 504825 h 708025"/>
              <a:gd name="connsiteX89" fmla="*/ 914400 w 914400"/>
              <a:gd name="connsiteY89" fmla="*/ 485775 h 708025"/>
              <a:gd name="connsiteX90" fmla="*/ 908050 w 914400"/>
              <a:gd name="connsiteY90" fmla="*/ 466725 h 708025"/>
              <a:gd name="connsiteX91" fmla="*/ 904875 w 914400"/>
              <a:gd name="connsiteY91" fmla="*/ 457200 h 708025"/>
              <a:gd name="connsiteX92" fmla="*/ 892175 w 914400"/>
              <a:gd name="connsiteY92" fmla="*/ 438150 h 708025"/>
              <a:gd name="connsiteX93" fmla="*/ 879475 w 914400"/>
              <a:gd name="connsiteY93" fmla="*/ 409575 h 708025"/>
              <a:gd name="connsiteX94" fmla="*/ 876300 w 914400"/>
              <a:gd name="connsiteY94" fmla="*/ 400050 h 708025"/>
              <a:gd name="connsiteX95" fmla="*/ 869950 w 914400"/>
              <a:gd name="connsiteY95" fmla="*/ 390525 h 708025"/>
              <a:gd name="connsiteX96" fmla="*/ 866775 w 914400"/>
              <a:gd name="connsiteY96" fmla="*/ 381000 h 708025"/>
              <a:gd name="connsiteX97" fmla="*/ 860425 w 914400"/>
              <a:gd name="connsiteY97" fmla="*/ 371475 h 708025"/>
              <a:gd name="connsiteX98" fmla="*/ 857250 w 914400"/>
              <a:gd name="connsiteY98" fmla="*/ 361950 h 708025"/>
              <a:gd name="connsiteX99" fmla="*/ 850900 w 914400"/>
              <a:gd name="connsiteY99" fmla="*/ 352425 h 708025"/>
              <a:gd name="connsiteX100" fmla="*/ 841375 w 914400"/>
              <a:gd name="connsiteY100" fmla="*/ 323850 h 708025"/>
              <a:gd name="connsiteX101" fmla="*/ 828675 w 914400"/>
              <a:gd name="connsiteY101" fmla="*/ 304800 h 708025"/>
              <a:gd name="connsiteX102" fmla="*/ 822325 w 914400"/>
              <a:gd name="connsiteY102" fmla="*/ 295275 h 708025"/>
              <a:gd name="connsiteX103" fmla="*/ 812800 w 914400"/>
              <a:gd name="connsiteY103" fmla="*/ 285750 h 708025"/>
              <a:gd name="connsiteX104" fmla="*/ 800100 w 914400"/>
              <a:gd name="connsiteY104" fmla="*/ 266700 h 708025"/>
              <a:gd name="connsiteX105" fmla="*/ 793750 w 914400"/>
              <a:gd name="connsiteY105" fmla="*/ 257175 h 708025"/>
              <a:gd name="connsiteX106" fmla="*/ 784225 w 914400"/>
              <a:gd name="connsiteY106" fmla="*/ 250825 h 708025"/>
              <a:gd name="connsiteX107" fmla="*/ 762000 w 914400"/>
              <a:gd name="connsiteY107" fmla="*/ 225425 h 708025"/>
              <a:gd name="connsiteX108" fmla="*/ 739775 w 914400"/>
              <a:gd name="connsiteY108" fmla="*/ 203200 h 708025"/>
              <a:gd name="connsiteX109" fmla="*/ 733425 w 914400"/>
              <a:gd name="connsiteY109" fmla="*/ 193675 h 708025"/>
              <a:gd name="connsiteX110" fmla="*/ 723900 w 914400"/>
              <a:gd name="connsiteY110" fmla="*/ 187325 h 708025"/>
              <a:gd name="connsiteX111" fmla="*/ 692150 w 914400"/>
              <a:gd name="connsiteY111" fmla="*/ 177800 h 708025"/>
              <a:gd name="connsiteX112" fmla="*/ 657225 w 914400"/>
              <a:gd name="connsiteY112" fmla="*/ 168275 h 708025"/>
              <a:gd name="connsiteX113" fmla="*/ 584200 w 914400"/>
              <a:gd name="connsiteY113" fmla="*/ 165100 h 708025"/>
              <a:gd name="connsiteX114" fmla="*/ 571500 w 914400"/>
              <a:gd name="connsiteY114" fmla="*/ 161925 h 708025"/>
              <a:gd name="connsiteX115" fmla="*/ 552450 w 914400"/>
              <a:gd name="connsiteY115" fmla="*/ 158750 h 708025"/>
              <a:gd name="connsiteX116" fmla="*/ 533400 w 914400"/>
              <a:gd name="connsiteY116" fmla="*/ 152400 h 708025"/>
              <a:gd name="connsiteX117" fmla="*/ 514350 w 914400"/>
              <a:gd name="connsiteY117" fmla="*/ 146050 h 708025"/>
              <a:gd name="connsiteX118" fmla="*/ 479425 w 914400"/>
              <a:gd name="connsiteY118" fmla="*/ 142875 h 708025"/>
              <a:gd name="connsiteX119" fmla="*/ 447675 w 914400"/>
              <a:gd name="connsiteY119" fmla="*/ 136525 h 708025"/>
              <a:gd name="connsiteX120" fmla="*/ 428625 w 914400"/>
              <a:gd name="connsiteY120" fmla="*/ 123825 h 708025"/>
              <a:gd name="connsiteX121" fmla="*/ 419100 w 914400"/>
              <a:gd name="connsiteY121" fmla="*/ 104775 h 708025"/>
              <a:gd name="connsiteX122" fmla="*/ 390525 w 914400"/>
              <a:gd name="connsiteY122" fmla="*/ 85725 h 708025"/>
              <a:gd name="connsiteX123" fmla="*/ 384175 w 914400"/>
              <a:gd name="connsiteY123" fmla="*/ 79375 h 7080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</a:cxnLst>
            <a:rect l="l" t="t" r="r" b="b"/>
            <a:pathLst>
              <a:path w="914400" h="708025">
                <a:moveTo>
                  <a:pt x="425450" y="114300"/>
                </a:moveTo>
                <a:cubicBezTo>
                  <a:pt x="420158" y="111125"/>
                  <a:pt x="414260" y="108791"/>
                  <a:pt x="409575" y="104775"/>
                </a:cubicBezTo>
                <a:cubicBezTo>
                  <a:pt x="391297" y="89108"/>
                  <a:pt x="415678" y="99401"/>
                  <a:pt x="393700" y="92075"/>
                </a:cubicBezTo>
                <a:cubicBezTo>
                  <a:pt x="391608" y="85800"/>
                  <a:pt x="389770" y="77501"/>
                  <a:pt x="384175" y="73025"/>
                </a:cubicBezTo>
                <a:cubicBezTo>
                  <a:pt x="381562" y="70934"/>
                  <a:pt x="377825" y="70908"/>
                  <a:pt x="374650" y="69850"/>
                </a:cubicBezTo>
                <a:cubicBezTo>
                  <a:pt x="371475" y="67733"/>
                  <a:pt x="368056" y="65943"/>
                  <a:pt x="365125" y="63500"/>
                </a:cubicBezTo>
                <a:cubicBezTo>
                  <a:pt x="361676" y="60625"/>
                  <a:pt x="359336" y="56466"/>
                  <a:pt x="355600" y="53975"/>
                </a:cubicBezTo>
                <a:cubicBezTo>
                  <a:pt x="352815" y="52119"/>
                  <a:pt x="349250" y="51858"/>
                  <a:pt x="346075" y="50800"/>
                </a:cubicBezTo>
                <a:cubicBezTo>
                  <a:pt x="339725" y="46567"/>
                  <a:pt x="332421" y="43496"/>
                  <a:pt x="327025" y="38100"/>
                </a:cubicBezTo>
                <a:cubicBezTo>
                  <a:pt x="315133" y="26208"/>
                  <a:pt x="321760" y="29995"/>
                  <a:pt x="307975" y="25400"/>
                </a:cubicBezTo>
                <a:lnTo>
                  <a:pt x="288925" y="12700"/>
                </a:lnTo>
                <a:cubicBezTo>
                  <a:pt x="283356" y="8987"/>
                  <a:pt x="276225" y="8467"/>
                  <a:pt x="269875" y="6350"/>
                </a:cubicBezTo>
                <a:cubicBezTo>
                  <a:pt x="263768" y="4314"/>
                  <a:pt x="257159" y="4327"/>
                  <a:pt x="250825" y="3175"/>
                </a:cubicBezTo>
                <a:cubicBezTo>
                  <a:pt x="245516" y="2210"/>
                  <a:pt x="240242" y="1058"/>
                  <a:pt x="234950" y="0"/>
                </a:cubicBezTo>
                <a:cubicBezTo>
                  <a:pt x="220226" y="1339"/>
                  <a:pt x="193894" y="3131"/>
                  <a:pt x="177800" y="6350"/>
                </a:cubicBezTo>
                <a:cubicBezTo>
                  <a:pt x="174518" y="7006"/>
                  <a:pt x="171450" y="8467"/>
                  <a:pt x="168275" y="9525"/>
                </a:cubicBezTo>
                <a:cubicBezTo>
                  <a:pt x="140978" y="27723"/>
                  <a:pt x="175515" y="5905"/>
                  <a:pt x="149225" y="19050"/>
                </a:cubicBezTo>
                <a:cubicBezTo>
                  <a:pt x="124606" y="31360"/>
                  <a:pt x="154116" y="20595"/>
                  <a:pt x="130175" y="28575"/>
                </a:cubicBezTo>
                <a:lnTo>
                  <a:pt x="82550" y="60325"/>
                </a:lnTo>
                <a:lnTo>
                  <a:pt x="63500" y="73025"/>
                </a:lnTo>
                <a:lnTo>
                  <a:pt x="53975" y="79375"/>
                </a:lnTo>
                <a:cubicBezTo>
                  <a:pt x="51858" y="82550"/>
                  <a:pt x="50605" y="86516"/>
                  <a:pt x="47625" y="88900"/>
                </a:cubicBezTo>
                <a:cubicBezTo>
                  <a:pt x="45012" y="90991"/>
                  <a:pt x="40467" y="89708"/>
                  <a:pt x="38100" y="92075"/>
                </a:cubicBezTo>
                <a:cubicBezTo>
                  <a:pt x="32704" y="97471"/>
                  <a:pt x="29633" y="104775"/>
                  <a:pt x="25400" y="111125"/>
                </a:cubicBezTo>
                <a:lnTo>
                  <a:pt x="19050" y="120650"/>
                </a:lnTo>
                <a:cubicBezTo>
                  <a:pt x="16933" y="123825"/>
                  <a:pt x="13907" y="126555"/>
                  <a:pt x="12700" y="130175"/>
                </a:cubicBezTo>
                <a:lnTo>
                  <a:pt x="6350" y="149225"/>
                </a:lnTo>
                <a:cubicBezTo>
                  <a:pt x="5292" y="152400"/>
                  <a:pt x="3831" y="155468"/>
                  <a:pt x="3175" y="158750"/>
                </a:cubicBezTo>
                <a:lnTo>
                  <a:pt x="0" y="174625"/>
                </a:lnTo>
                <a:cubicBezTo>
                  <a:pt x="1058" y="197908"/>
                  <a:pt x="1514" y="221227"/>
                  <a:pt x="3175" y="244475"/>
                </a:cubicBezTo>
                <a:cubicBezTo>
                  <a:pt x="3634" y="250896"/>
                  <a:pt x="5371" y="257162"/>
                  <a:pt x="6350" y="263525"/>
                </a:cubicBezTo>
                <a:cubicBezTo>
                  <a:pt x="7488" y="270922"/>
                  <a:pt x="8057" y="278412"/>
                  <a:pt x="9525" y="285750"/>
                </a:cubicBezTo>
                <a:cubicBezTo>
                  <a:pt x="11920" y="297725"/>
                  <a:pt x="18126" y="303413"/>
                  <a:pt x="25400" y="314325"/>
                </a:cubicBezTo>
                <a:cubicBezTo>
                  <a:pt x="27256" y="317110"/>
                  <a:pt x="26950" y="320924"/>
                  <a:pt x="28575" y="323850"/>
                </a:cubicBezTo>
                <a:cubicBezTo>
                  <a:pt x="32281" y="330521"/>
                  <a:pt x="38862" y="335660"/>
                  <a:pt x="41275" y="342900"/>
                </a:cubicBezTo>
                <a:cubicBezTo>
                  <a:pt x="49255" y="366841"/>
                  <a:pt x="38490" y="337331"/>
                  <a:pt x="50800" y="361950"/>
                </a:cubicBezTo>
                <a:cubicBezTo>
                  <a:pt x="52297" y="364943"/>
                  <a:pt x="52478" y="368482"/>
                  <a:pt x="53975" y="371475"/>
                </a:cubicBezTo>
                <a:cubicBezTo>
                  <a:pt x="55682" y="374888"/>
                  <a:pt x="58618" y="377587"/>
                  <a:pt x="60325" y="381000"/>
                </a:cubicBezTo>
                <a:cubicBezTo>
                  <a:pt x="61822" y="383993"/>
                  <a:pt x="62003" y="387532"/>
                  <a:pt x="63500" y="390525"/>
                </a:cubicBezTo>
                <a:cubicBezTo>
                  <a:pt x="65207" y="393938"/>
                  <a:pt x="68300" y="396563"/>
                  <a:pt x="69850" y="400050"/>
                </a:cubicBezTo>
                <a:cubicBezTo>
                  <a:pt x="72568" y="406167"/>
                  <a:pt x="74083" y="412750"/>
                  <a:pt x="76200" y="419100"/>
                </a:cubicBezTo>
                <a:lnTo>
                  <a:pt x="79375" y="428625"/>
                </a:lnTo>
                <a:cubicBezTo>
                  <a:pt x="80433" y="431800"/>
                  <a:pt x="79765" y="436294"/>
                  <a:pt x="82550" y="438150"/>
                </a:cubicBezTo>
                <a:lnTo>
                  <a:pt x="92075" y="444500"/>
                </a:lnTo>
                <a:cubicBezTo>
                  <a:pt x="94192" y="450850"/>
                  <a:pt x="92856" y="459837"/>
                  <a:pt x="98425" y="463550"/>
                </a:cubicBezTo>
                <a:cubicBezTo>
                  <a:pt x="107791" y="469794"/>
                  <a:pt x="109835" y="470258"/>
                  <a:pt x="117475" y="479425"/>
                </a:cubicBezTo>
                <a:cubicBezTo>
                  <a:pt x="128522" y="492682"/>
                  <a:pt x="117713" y="486913"/>
                  <a:pt x="133350" y="492125"/>
                </a:cubicBezTo>
                <a:cubicBezTo>
                  <a:pt x="139332" y="498107"/>
                  <a:pt x="144443" y="504464"/>
                  <a:pt x="152400" y="508000"/>
                </a:cubicBezTo>
                <a:cubicBezTo>
                  <a:pt x="158517" y="510718"/>
                  <a:pt x="165100" y="512233"/>
                  <a:pt x="171450" y="514350"/>
                </a:cubicBezTo>
                <a:lnTo>
                  <a:pt x="180975" y="517525"/>
                </a:lnTo>
                <a:cubicBezTo>
                  <a:pt x="184150" y="519642"/>
                  <a:pt x="187013" y="522325"/>
                  <a:pt x="190500" y="523875"/>
                </a:cubicBezTo>
                <a:cubicBezTo>
                  <a:pt x="208015" y="531659"/>
                  <a:pt x="208352" y="529132"/>
                  <a:pt x="225425" y="533400"/>
                </a:cubicBezTo>
                <a:cubicBezTo>
                  <a:pt x="228672" y="534212"/>
                  <a:pt x="231775" y="535517"/>
                  <a:pt x="234950" y="536575"/>
                </a:cubicBezTo>
                <a:lnTo>
                  <a:pt x="260350" y="574675"/>
                </a:lnTo>
                <a:cubicBezTo>
                  <a:pt x="262467" y="577850"/>
                  <a:pt x="265493" y="580580"/>
                  <a:pt x="266700" y="584200"/>
                </a:cubicBezTo>
                <a:lnTo>
                  <a:pt x="273050" y="603250"/>
                </a:lnTo>
                <a:cubicBezTo>
                  <a:pt x="274108" y="606425"/>
                  <a:pt x="274369" y="609990"/>
                  <a:pt x="276225" y="612775"/>
                </a:cubicBezTo>
                <a:cubicBezTo>
                  <a:pt x="280458" y="619125"/>
                  <a:pt x="286512" y="624585"/>
                  <a:pt x="288925" y="631825"/>
                </a:cubicBezTo>
                <a:cubicBezTo>
                  <a:pt x="293307" y="644970"/>
                  <a:pt x="289315" y="639494"/>
                  <a:pt x="301625" y="647700"/>
                </a:cubicBezTo>
                <a:cubicBezTo>
                  <a:pt x="313267" y="665162"/>
                  <a:pt x="301625" y="650346"/>
                  <a:pt x="317500" y="663575"/>
                </a:cubicBezTo>
                <a:cubicBezTo>
                  <a:pt x="320949" y="666450"/>
                  <a:pt x="323481" y="670343"/>
                  <a:pt x="327025" y="673100"/>
                </a:cubicBezTo>
                <a:cubicBezTo>
                  <a:pt x="343401" y="685837"/>
                  <a:pt x="341229" y="684185"/>
                  <a:pt x="355600" y="688975"/>
                </a:cubicBezTo>
                <a:cubicBezTo>
                  <a:pt x="382897" y="707173"/>
                  <a:pt x="348360" y="685355"/>
                  <a:pt x="374650" y="698500"/>
                </a:cubicBezTo>
                <a:cubicBezTo>
                  <a:pt x="399269" y="710810"/>
                  <a:pt x="369759" y="700045"/>
                  <a:pt x="393700" y="708025"/>
                </a:cubicBezTo>
                <a:cubicBezTo>
                  <a:pt x="431800" y="706967"/>
                  <a:pt x="469935" y="706802"/>
                  <a:pt x="508000" y="704850"/>
                </a:cubicBezTo>
                <a:cubicBezTo>
                  <a:pt x="511342" y="704679"/>
                  <a:pt x="514307" y="702594"/>
                  <a:pt x="517525" y="701675"/>
                </a:cubicBezTo>
                <a:cubicBezTo>
                  <a:pt x="521721" y="700476"/>
                  <a:pt x="525932" y="699281"/>
                  <a:pt x="530225" y="698500"/>
                </a:cubicBezTo>
                <a:cubicBezTo>
                  <a:pt x="539865" y="696747"/>
                  <a:pt x="569005" y="693256"/>
                  <a:pt x="577850" y="692150"/>
                </a:cubicBezTo>
                <a:cubicBezTo>
                  <a:pt x="599623" y="684892"/>
                  <a:pt x="572599" y="693463"/>
                  <a:pt x="603250" y="685800"/>
                </a:cubicBezTo>
                <a:cubicBezTo>
                  <a:pt x="606497" y="684988"/>
                  <a:pt x="609514" y="683378"/>
                  <a:pt x="612775" y="682625"/>
                </a:cubicBezTo>
                <a:cubicBezTo>
                  <a:pt x="623292" y="680198"/>
                  <a:pt x="633942" y="678392"/>
                  <a:pt x="644525" y="676275"/>
                </a:cubicBezTo>
                <a:cubicBezTo>
                  <a:pt x="648804" y="675419"/>
                  <a:pt x="653045" y="674354"/>
                  <a:pt x="657225" y="673100"/>
                </a:cubicBezTo>
                <a:cubicBezTo>
                  <a:pt x="663636" y="671177"/>
                  <a:pt x="669711" y="668063"/>
                  <a:pt x="676275" y="666750"/>
                </a:cubicBezTo>
                <a:cubicBezTo>
                  <a:pt x="695432" y="662919"/>
                  <a:pt x="687030" y="665282"/>
                  <a:pt x="701675" y="660400"/>
                </a:cubicBezTo>
                <a:lnTo>
                  <a:pt x="720725" y="647700"/>
                </a:lnTo>
                <a:cubicBezTo>
                  <a:pt x="723510" y="645844"/>
                  <a:pt x="727003" y="645337"/>
                  <a:pt x="730250" y="644525"/>
                </a:cubicBezTo>
                <a:lnTo>
                  <a:pt x="755650" y="638175"/>
                </a:lnTo>
                <a:cubicBezTo>
                  <a:pt x="758825" y="636058"/>
                  <a:pt x="761762" y="633532"/>
                  <a:pt x="765175" y="631825"/>
                </a:cubicBezTo>
                <a:cubicBezTo>
                  <a:pt x="768168" y="630328"/>
                  <a:pt x="771774" y="630275"/>
                  <a:pt x="774700" y="628650"/>
                </a:cubicBezTo>
                <a:cubicBezTo>
                  <a:pt x="781371" y="624944"/>
                  <a:pt x="787400" y="620183"/>
                  <a:pt x="793750" y="615950"/>
                </a:cubicBezTo>
                <a:lnTo>
                  <a:pt x="812800" y="603250"/>
                </a:lnTo>
                <a:cubicBezTo>
                  <a:pt x="815585" y="601394"/>
                  <a:pt x="819150" y="601133"/>
                  <a:pt x="822325" y="600075"/>
                </a:cubicBezTo>
                <a:lnTo>
                  <a:pt x="841375" y="587375"/>
                </a:lnTo>
                <a:cubicBezTo>
                  <a:pt x="844550" y="585258"/>
                  <a:pt x="847280" y="582232"/>
                  <a:pt x="850900" y="581025"/>
                </a:cubicBezTo>
                <a:lnTo>
                  <a:pt x="860425" y="577850"/>
                </a:lnTo>
                <a:cubicBezTo>
                  <a:pt x="862542" y="574675"/>
                  <a:pt x="864077" y="571023"/>
                  <a:pt x="866775" y="568325"/>
                </a:cubicBezTo>
                <a:cubicBezTo>
                  <a:pt x="877782" y="557318"/>
                  <a:pt x="875877" y="567690"/>
                  <a:pt x="882650" y="552450"/>
                </a:cubicBezTo>
                <a:cubicBezTo>
                  <a:pt x="900177" y="513015"/>
                  <a:pt x="875295" y="553957"/>
                  <a:pt x="901700" y="514350"/>
                </a:cubicBezTo>
                <a:lnTo>
                  <a:pt x="908050" y="504825"/>
                </a:lnTo>
                <a:cubicBezTo>
                  <a:pt x="911763" y="499256"/>
                  <a:pt x="914400" y="485775"/>
                  <a:pt x="914400" y="485775"/>
                </a:cubicBezTo>
                <a:lnTo>
                  <a:pt x="908050" y="466725"/>
                </a:lnTo>
                <a:cubicBezTo>
                  <a:pt x="906992" y="463550"/>
                  <a:pt x="906731" y="459985"/>
                  <a:pt x="904875" y="457200"/>
                </a:cubicBezTo>
                <a:cubicBezTo>
                  <a:pt x="900642" y="450850"/>
                  <a:pt x="894588" y="445390"/>
                  <a:pt x="892175" y="438150"/>
                </a:cubicBezTo>
                <a:cubicBezTo>
                  <a:pt x="875793" y="389003"/>
                  <a:pt x="894569" y="439764"/>
                  <a:pt x="879475" y="409575"/>
                </a:cubicBezTo>
                <a:cubicBezTo>
                  <a:pt x="877978" y="406582"/>
                  <a:pt x="877797" y="403043"/>
                  <a:pt x="876300" y="400050"/>
                </a:cubicBezTo>
                <a:cubicBezTo>
                  <a:pt x="874593" y="396637"/>
                  <a:pt x="871657" y="393938"/>
                  <a:pt x="869950" y="390525"/>
                </a:cubicBezTo>
                <a:cubicBezTo>
                  <a:pt x="868453" y="387532"/>
                  <a:pt x="868272" y="383993"/>
                  <a:pt x="866775" y="381000"/>
                </a:cubicBezTo>
                <a:cubicBezTo>
                  <a:pt x="865068" y="377587"/>
                  <a:pt x="862132" y="374888"/>
                  <a:pt x="860425" y="371475"/>
                </a:cubicBezTo>
                <a:cubicBezTo>
                  <a:pt x="858928" y="368482"/>
                  <a:pt x="858747" y="364943"/>
                  <a:pt x="857250" y="361950"/>
                </a:cubicBezTo>
                <a:cubicBezTo>
                  <a:pt x="855543" y="358537"/>
                  <a:pt x="852450" y="355912"/>
                  <a:pt x="850900" y="352425"/>
                </a:cubicBezTo>
                <a:lnTo>
                  <a:pt x="841375" y="323850"/>
                </a:lnTo>
                <a:cubicBezTo>
                  <a:pt x="838962" y="316610"/>
                  <a:pt x="832908" y="311150"/>
                  <a:pt x="828675" y="304800"/>
                </a:cubicBezTo>
                <a:cubicBezTo>
                  <a:pt x="826558" y="301625"/>
                  <a:pt x="825023" y="297973"/>
                  <a:pt x="822325" y="295275"/>
                </a:cubicBezTo>
                <a:cubicBezTo>
                  <a:pt x="819150" y="292100"/>
                  <a:pt x="815557" y="289294"/>
                  <a:pt x="812800" y="285750"/>
                </a:cubicBezTo>
                <a:cubicBezTo>
                  <a:pt x="808115" y="279726"/>
                  <a:pt x="804333" y="273050"/>
                  <a:pt x="800100" y="266700"/>
                </a:cubicBezTo>
                <a:cubicBezTo>
                  <a:pt x="797983" y="263525"/>
                  <a:pt x="796925" y="259292"/>
                  <a:pt x="793750" y="257175"/>
                </a:cubicBezTo>
                <a:lnTo>
                  <a:pt x="784225" y="250825"/>
                </a:lnTo>
                <a:cubicBezTo>
                  <a:pt x="769408" y="228600"/>
                  <a:pt x="777875" y="236008"/>
                  <a:pt x="762000" y="225425"/>
                </a:cubicBezTo>
                <a:cubicBezTo>
                  <a:pt x="747444" y="203590"/>
                  <a:pt x="756540" y="208788"/>
                  <a:pt x="739775" y="203200"/>
                </a:cubicBezTo>
                <a:cubicBezTo>
                  <a:pt x="737658" y="200025"/>
                  <a:pt x="736123" y="196373"/>
                  <a:pt x="733425" y="193675"/>
                </a:cubicBezTo>
                <a:cubicBezTo>
                  <a:pt x="730727" y="190977"/>
                  <a:pt x="727387" y="188875"/>
                  <a:pt x="723900" y="187325"/>
                </a:cubicBezTo>
                <a:cubicBezTo>
                  <a:pt x="708357" y="180417"/>
                  <a:pt x="706358" y="182063"/>
                  <a:pt x="692150" y="177800"/>
                </a:cubicBezTo>
                <a:cubicBezTo>
                  <a:pt x="680111" y="174188"/>
                  <a:pt x="669884" y="169179"/>
                  <a:pt x="657225" y="168275"/>
                </a:cubicBezTo>
                <a:cubicBezTo>
                  <a:pt x="632922" y="166539"/>
                  <a:pt x="608542" y="166158"/>
                  <a:pt x="584200" y="165100"/>
                </a:cubicBezTo>
                <a:cubicBezTo>
                  <a:pt x="579967" y="164042"/>
                  <a:pt x="575779" y="162781"/>
                  <a:pt x="571500" y="161925"/>
                </a:cubicBezTo>
                <a:cubicBezTo>
                  <a:pt x="565187" y="160662"/>
                  <a:pt x="558695" y="160311"/>
                  <a:pt x="552450" y="158750"/>
                </a:cubicBezTo>
                <a:cubicBezTo>
                  <a:pt x="545956" y="157127"/>
                  <a:pt x="539750" y="154517"/>
                  <a:pt x="533400" y="152400"/>
                </a:cubicBezTo>
                <a:lnTo>
                  <a:pt x="514350" y="146050"/>
                </a:lnTo>
                <a:cubicBezTo>
                  <a:pt x="503260" y="142353"/>
                  <a:pt x="491035" y="144241"/>
                  <a:pt x="479425" y="142875"/>
                </a:cubicBezTo>
                <a:cubicBezTo>
                  <a:pt x="464720" y="141145"/>
                  <a:pt x="460757" y="139796"/>
                  <a:pt x="447675" y="136525"/>
                </a:cubicBezTo>
                <a:cubicBezTo>
                  <a:pt x="441325" y="132292"/>
                  <a:pt x="431038" y="131065"/>
                  <a:pt x="428625" y="123825"/>
                </a:cubicBezTo>
                <a:cubicBezTo>
                  <a:pt x="426360" y="117031"/>
                  <a:pt x="424893" y="109844"/>
                  <a:pt x="419100" y="104775"/>
                </a:cubicBezTo>
                <a:lnTo>
                  <a:pt x="390525" y="85725"/>
                </a:lnTo>
                <a:cubicBezTo>
                  <a:pt x="388034" y="84065"/>
                  <a:pt x="386292" y="81492"/>
                  <a:pt x="384175" y="79375"/>
                </a:cubicBezTo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noFill/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178" name="直線コネクタ 177"/>
          <p:cNvCxnSpPr/>
          <p:nvPr/>
        </p:nvCxnSpPr>
        <p:spPr>
          <a:xfrm>
            <a:off x="8565423" y="2030486"/>
            <a:ext cx="45536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/>
          <p:cNvSpPr txBox="1"/>
          <p:nvPr/>
        </p:nvSpPr>
        <p:spPr>
          <a:xfrm rot="16200000">
            <a:off x="4344038" y="3956132"/>
            <a:ext cx="115881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R514S</a:t>
            </a:r>
            <a:r>
              <a:rPr kumimoji="1" lang="en-US" altLang="ja-JP" sz="14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FUS/TLS</a:t>
            </a:r>
            <a:endParaRPr kumimoji="1" lang="ja-JP" altLang="en-US" sz="1400" b="1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 rot="16200000">
            <a:off x="4334802" y="5192632"/>
            <a:ext cx="115881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525L</a:t>
            </a:r>
            <a:r>
              <a:rPr kumimoji="1" lang="en-US" altLang="ja-JP" sz="14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FUS/TLS</a:t>
            </a:r>
            <a:endParaRPr kumimoji="1" lang="ja-JP" altLang="en-US" sz="1400" b="1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 rot="16200000">
            <a:off x="-1033662" y="4813280"/>
            <a:ext cx="273249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Overlap frequency</a:t>
            </a:r>
            <a:r>
              <a:rPr kumimoji="1" lang="en-US" altLang="ja-JP" sz="11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of aggregates </a:t>
            </a:r>
          </a:p>
          <a:p>
            <a:r>
              <a:rPr kumimoji="1" lang="en-US" altLang="ja-JP" sz="11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on NEAT1_2</a:t>
            </a:r>
            <a:r>
              <a:rPr lang="ja-JP" altLang="en-US" sz="11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  <a:r>
              <a:rPr lang="en-US" altLang="ja-JP" sz="1100" b="1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</a:t>
            </a:r>
            <a:r>
              <a:rPr kumimoji="1" lang="en-US" altLang="ja-JP" sz="11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oci in the nucleus    (%)</a:t>
            </a:r>
            <a:endParaRPr kumimoji="1" lang="ja-JP" altLang="en-US" sz="11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4716016" y="332656"/>
            <a:ext cx="2777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B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0236899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7431" y="0"/>
            <a:ext cx="28098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S1.</a:t>
            </a:r>
            <a:endParaRPr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pic>
        <p:nvPicPr>
          <p:cNvPr id="115" name="Picture 1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5717" y="5095934"/>
            <a:ext cx="1322166" cy="12803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6" name="テキスト ボックス 115"/>
          <p:cNvSpPr txBox="1"/>
          <p:nvPr/>
        </p:nvSpPr>
        <p:spPr>
          <a:xfrm>
            <a:off x="93729" y="528290"/>
            <a:ext cx="2777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17" name="正方形/長方形 116"/>
          <p:cNvSpPr/>
          <p:nvPr/>
        </p:nvSpPr>
        <p:spPr>
          <a:xfrm>
            <a:off x="1688681" y="1217012"/>
            <a:ext cx="514370" cy="72008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bg2">
                  <a:lumMod val="75000"/>
                </a:schemeClr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18" name="正方形/長方形 117"/>
          <p:cNvSpPr/>
          <p:nvPr/>
        </p:nvSpPr>
        <p:spPr>
          <a:xfrm>
            <a:off x="1678367" y="1592098"/>
            <a:ext cx="3538706" cy="72008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bg2">
                  <a:lumMod val="75000"/>
                </a:schemeClr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119" name="直線矢印コネクタ 118"/>
          <p:cNvCxnSpPr/>
          <p:nvPr/>
        </p:nvCxnSpPr>
        <p:spPr>
          <a:xfrm>
            <a:off x="2147296" y="897622"/>
            <a:ext cx="0" cy="2944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テキスト ボックス 119"/>
          <p:cNvSpPr txBox="1"/>
          <p:nvPr/>
        </p:nvSpPr>
        <p:spPr>
          <a:xfrm>
            <a:off x="2035133" y="583986"/>
            <a:ext cx="14401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AUAAA</a:t>
            </a:r>
            <a:endParaRPr kumimoji="1" lang="ja-JP" altLang="en-US" sz="16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21" name="テキスト ボックス 120"/>
          <p:cNvSpPr txBox="1"/>
          <p:nvPr/>
        </p:nvSpPr>
        <p:spPr>
          <a:xfrm>
            <a:off x="219119" y="1093558"/>
            <a:ext cx="1558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1 </a:t>
            </a:r>
            <a:r>
              <a:rPr lang="en-US" altLang="ja-JP" sz="1200" b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cRNA</a:t>
            </a:r>
            <a:endParaRPr kumimoji="1" lang="ja-JP" altLang="en-US" sz="12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122" name="直線コネクタ 121"/>
          <p:cNvCxnSpPr/>
          <p:nvPr/>
        </p:nvCxnSpPr>
        <p:spPr>
          <a:xfrm flipV="1">
            <a:off x="5215936" y="1352865"/>
            <a:ext cx="0" cy="303129"/>
          </a:xfrm>
          <a:prstGeom prst="line">
            <a:avLst/>
          </a:prstGeom>
          <a:ln w="349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直線コネクタ 122"/>
          <p:cNvCxnSpPr/>
          <p:nvPr/>
        </p:nvCxnSpPr>
        <p:spPr>
          <a:xfrm>
            <a:off x="4909914" y="1352865"/>
            <a:ext cx="306022" cy="0"/>
          </a:xfrm>
          <a:prstGeom prst="line">
            <a:avLst/>
          </a:prstGeom>
          <a:ln w="349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直線コネクタ 123"/>
          <p:cNvCxnSpPr/>
          <p:nvPr/>
        </p:nvCxnSpPr>
        <p:spPr>
          <a:xfrm>
            <a:off x="4909914" y="1310689"/>
            <a:ext cx="306022" cy="0"/>
          </a:xfrm>
          <a:prstGeom prst="line">
            <a:avLst/>
          </a:prstGeom>
          <a:ln w="349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直線コネクタ 124"/>
          <p:cNvCxnSpPr/>
          <p:nvPr/>
        </p:nvCxnSpPr>
        <p:spPr>
          <a:xfrm flipH="1">
            <a:off x="5276099" y="1349116"/>
            <a:ext cx="1838" cy="306878"/>
          </a:xfrm>
          <a:prstGeom prst="line">
            <a:avLst/>
          </a:prstGeom>
          <a:ln w="349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直線コネクタ 125"/>
          <p:cNvCxnSpPr/>
          <p:nvPr/>
        </p:nvCxnSpPr>
        <p:spPr>
          <a:xfrm>
            <a:off x="5264743" y="1351656"/>
            <a:ext cx="306022" cy="0"/>
          </a:xfrm>
          <a:prstGeom prst="line">
            <a:avLst/>
          </a:prstGeom>
          <a:ln w="349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直線コネクタ 126"/>
          <p:cNvCxnSpPr/>
          <p:nvPr/>
        </p:nvCxnSpPr>
        <p:spPr>
          <a:xfrm>
            <a:off x="5264743" y="1310689"/>
            <a:ext cx="306022" cy="0"/>
          </a:xfrm>
          <a:prstGeom prst="line">
            <a:avLst/>
          </a:prstGeom>
          <a:ln w="349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直線コネクタ 127"/>
          <p:cNvCxnSpPr/>
          <p:nvPr/>
        </p:nvCxnSpPr>
        <p:spPr>
          <a:xfrm>
            <a:off x="5215936" y="1042119"/>
            <a:ext cx="0" cy="269667"/>
          </a:xfrm>
          <a:prstGeom prst="line">
            <a:avLst/>
          </a:prstGeom>
          <a:ln w="349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直線コネクタ 128"/>
          <p:cNvCxnSpPr/>
          <p:nvPr/>
        </p:nvCxnSpPr>
        <p:spPr>
          <a:xfrm>
            <a:off x="5259653" y="1042119"/>
            <a:ext cx="5090" cy="267718"/>
          </a:xfrm>
          <a:prstGeom prst="line">
            <a:avLst/>
          </a:prstGeom>
          <a:ln w="349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フリーフォーム 132"/>
          <p:cNvSpPr/>
          <p:nvPr/>
        </p:nvSpPr>
        <p:spPr>
          <a:xfrm rot="5400000">
            <a:off x="5185627" y="959352"/>
            <a:ext cx="106879" cy="60682"/>
          </a:xfrm>
          <a:custGeom>
            <a:avLst/>
            <a:gdLst>
              <a:gd name="connsiteX0" fmla="*/ 320634 w 332509"/>
              <a:gd name="connsiteY0" fmla="*/ 273133 h 296883"/>
              <a:gd name="connsiteX1" fmla="*/ 213756 w 332509"/>
              <a:gd name="connsiteY1" fmla="*/ 285008 h 296883"/>
              <a:gd name="connsiteX2" fmla="*/ 178130 w 332509"/>
              <a:gd name="connsiteY2" fmla="*/ 296883 h 296883"/>
              <a:gd name="connsiteX3" fmla="*/ 83127 w 332509"/>
              <a:gd name="connsiteY3" fmla="*/ 285008 h 296883"/>
              <a:gd name="connsiteX4" fmla="*/ 59377 w 332509"/>
              <a:gd name="connsiteY4" fmla="*/ 249382 h 296883"/>
              <a:gd name="connsiteX5" fmla="*/ 0 w 332509"/>
              <a:gd name="connsiteY5" fmla="*/ 201881 h 296883"/>
              <a:gd name="connsiteX6" fmla="*/ 11875 w 332509"/>
              <a:gd name="connsiteY6" fmla="*/ 83128 h 296883"/>
              <a:gd name="connsiteX7" fmla="*/ 47501 w 332509"/>
              <a:gd name="connsiteY7" fmla="*/ 59377 h 296883"/>
              <a:gd name="connsiteX8" fmla="*/ 71252 w 332509"/>
              <a:gd name="connsiteY8" fmla="*/ 23751 h 296883"/>
              <a:gd name="connsiteX9" fmla="*/ 142504 w 332509"/>
              <a:gd name="connsiteY9" fmla="*/ 0 h 296883"/>
              <a:gd name="connsiteX10" fmla="*/ 285008 w 332509"/>
              <a:gd name="connsiteY10" fmla="*/ 23751 h 296883"/>
              <a:gd name="connsiteX11" fmla="*/ 332509 w 332509"/>
              <a:gd name="connsiteY11" fmla="*/ 59377 h 2968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32509" h="296883">
                <a:moveTo>
                  <a:pt x="320634" y="273133"/>
                </a:moveTo>
                <a:cubicBezTo>
                  <a:pt x="285008" y="277091"/>
                  <a:pt x="249114" y="279115"/>
                  <a:pt x="213756" y="285008"/>
                </a:cubicBezTo>
                <a:cubicBezTo>
                  <a:pt x="201409" y="287066"/>
                  <a:pt x="190648" y="296883"/>
                  <a:pt x="178130" y="296883"/>
                </a:cubicBezTo>
                <a:cubicBezTo>
                  <a:pt x="146216" y="296883"/>
                  <a:pt x="114795" y="288966"/>
                  <a:pt x="83127" y="285008"/>
                </a:cubicBezTo>
                <a:cubicBezTo>
                  <a:pt x="75210" y="273133"/>
                  <a:pt x="70522" y="258298"/>
                  <a:pt x="59377" y="249382"/>
                </a:cubicBezTo>
                <a:cubicBezTo>
                  <a:pt x="-22568" y="183825"/>
                  <a:pt x="68069" y="303983"/>
                  <a:pt x="0" y="201881"/>
                </a:cubicBezTo>
                <a:cubicBezTo>
                  <a:pt x="3958" y="162297"/>
                  <a:pt x="-705" y="120868"/>
                  <a:pt x="11875" y="83128"/>
                </a:cubicBezTo>
                <a:cubicBezTo>
                  <a:pt x="16388" y="69588"/>
                  <a:pt x="37409" y="69469"/>
                  <a:pt x="47501" y="59377"/>
                </a:cubicBezTo>
                <a:cubicBezTo>
                  <a:pt x="57593" y="49285"/>
                  <a:pt x="59149" y="31315"/>
                  <a:pt x="71252" y="23751"/>
                </a:cubicBezTo>
                <a:cubicBezTo>
                  <a:pt x="92482" y="10482"/>
                  <a:pt x="142504" y="0"/>
                  <a:pt x="142504" y="0"/>
                </a:cubicBezTo>
                <a:cubicBezTo>
                  <a:pt x="176361" y="3762"/>
                  <a:pt x="245220" y="3857"/>
                  <a:pt x="285008" y="23751"/>
                </a:cubicBezTo>
                <a:cubicBezTo>
                  <a:pt x="311863" y="37179"/>
                  <a:pt x="315809" y="42677"/>
                  <a:pt x="332509" y="59377"/>
                </a:cubicBezTo>
              </a:path>
            </a:pathLst>
          </a:custGeom>
          <a:noFill/>
          <a:ln w="349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>
                  <a:lumMod val="85000"/>
                  <a:lumOff val="15000"/>
                </a:schemeClr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43" name="フリーフォーム 142"/>
          <p:cNvSpPr/>
          <p:nvPr/>
        </p:nvSpPr>
        <p:spPr>
          <a:xfrm>
            <a:off x="4785025" y="1294709"/>
            <a:ext cx="147759" cy="86789"/>
          </a:xfrm>
          <a:custGeom>
            <a:avLst/>
            <a:gdLst>
              <a:gd name="connsiteX0" fmla="*/ 1540954 w 1564705"/>
              <a:gd name="connsiteY0" fmla="*/ 760021 h 1021278"/>
              <a:gd name="connsiteX1" fmla="*/ 1410325 w 1564705"/>
              <a:gd name="connsiteY1" fmla="*/ 819398 h 1021278"/>
              <a:gd name="connsiteX2" fmla="*/ 1339073 w 1564705"/>
              <a:gd name="connsiteY2" fmla="*/ 866899 h 1021278"/>
              <a:gd name="connsiteX3" fmla="*/ 1267822 w 1564705"/>
              <a:gd name="connsiteY3" fmla="*/ 890650 h 1021278"/>
              <a:gd name="connsiteX4" fmla="*/ 1172819 w 1564705"/>
              <a:gd name="connsiteY4" fmla="*/ 950026 h 1021278"/>
              <a:gd name="connsiteX5" fmla="*/ 1113442 w 1564705"/>
              <a:gd name="connsiteY5" fmla="*/ 961902 h 1021278"/>
              <a:gd name="connsiteX6" fmla="*/ 1077816 w 1564705"/>
              <a:gd name="connsiteY6" fmla="*/ 973777 h 1021278"/>
              <a:gd name="connsiteX7" fmla="*/ 1030315 w 1564705"/>
              <a:gd name="connsiteY7" fmla="*/ 985652 h 1021278"/>
              <a:gd name="connsiteX8" fmla="*/ 899686 w 1564705"/>
              <a:gd name="connsiteY8" fmla="*/ 1009403 h 1021278"/>
              <a:gd name="connsiteX9" fmla="*/ 852185 w 1564705"/>
              <a:gd name="connsiteY9" fmla="*/ 1021278 h 1021278"/>
              <a:gd name="connsiteX10" fmla="*/ 377172 w 1564705"/>
              <a:gd name="connsiteY10" fmla="*/ 985652 h 1021278"/>
              <a:gd name="connsiteX11" fmla="*/ 329671 w 1564705"/>
              <a:gd name="connsiteY11" fmla="*/ 961902 h 1021278"/>
              <a:gd name="connsiteX12" fmla="*/ 294045 w 1564705"/>
              <a:gd name="connsiteY12" fmla="*/ 926276 h 1021278"/>
              <a:gd name="connsiteX13" fmla="*/ 210918 w 1564705"/>
              <a:gd name="connsiteY13" fmla="*/ 855024 h 1021278"/>
              <a:gd name="connsiteX14" fmla="*/ 163416 w 1564705"/>
              <a:gd name="connsiteY14" fmla="*/ 783772 h 1021278"/>
              <a:gd name="connsiteX15" fmla="*/ 127790 w 1564705"/>
              <a:gd name="connsiteY15" fmla="*/ 760021 h 1021278"/>
              <a:gd name="connsiteX16" fmla="*/ 92164 w 1564705"/>
              <a:gd name="connsiteY16" fmla="*/ 724395 h 1021278"/>
              <a:gd name="connsiteX17" fmla="*/ 68414 w 1564705"/>
              <a:gd name="connsiteY17" fmla="*/ 676894 h 1021278"/>
              <a:gd name="connsiteX18" fmla="*/ 20912 w 1564705"/>
              <a:gd name="connsiteY18" fmla="*/ 593767 h 1021278"/>
              <a:gd name="connsiteX19" fmla="*/ 20912 w 1564705"/>
              <a:gd name="connsiteY19" fmla="*/ 296883 h 1021278"/>
              <a:gd name="connsiteX20" fmla="*/ 44663 w 1564705"/>
              <a:gd name="connsiteY20" fmla="*/ 261257 h 1021278"/>
              <a:gd name="connsiteX21" fmla="*/ 115915 w 1564705"/>
              <a:gd name="connsiteY21" fmla="*/ 225631 h 1021278"/>
              <a:gd name="connsiteX22" fmla="*/ 163416 w 1564705"/>
              <a:gd name="connsiteY22" fmla="*/ 178130 h 1021278"/>
              <a:gd name="connsiteX23" fmla="*/ 246544 w 1564705"/>
              <a:gd name="connsiteY23" fmla="*/ 154380 h 1021278"/>
              <a:gd name="connsiteX24" fmla="*/ 341546 w 1564705"/>
              <a:gd name="connsiteY24" fmla="*/ 83128 h 1021278"/>
              <a:gd name="connsiteX25" fmla="*/ 377172 w 1564705"/>
              <a:gd name="connsiteY25" fmla="*/ 71252 h 1021278"/>
              <a:gd name="connsiteX26" fmla="*/ 436549 w 1564705"/>
              <a:gd name="connsiteY26" fmla="*/ 47502 h 1021278"/>
              <a:gd name="connsiteX27" fmla="*/ 567177 w 1564705"/>
              <a:gd name="connsiteY27" fmla="*/ 0 h 1021278"/>
              <a:gd name="connsiteX28" fmla="*/ 1137193 w 1564705"/>
              <a:gd name="connsiteY28" fmla="*/ 11876 h 1021278"/>
              <a:gd name="connsiteX29" fmla="*/ 1208445 w 1564705"/>
              <a:gd name="connsiteY29" fmla="*/ 35626 h 1021278"/>
              <a:gd name="connsiteX30" fmla="*/ 1303447 w 1564705"/>
              <a:gd name="connsiteY30" fmla="*/ 59377 h 1021278"/>
              <a:gd name="connsiteX31" fmla="*/ 1339073 w 1564705"/>
              <a:gd name="connsiteY31" fmla="*/ 71252 h 1021278"/>
              <a:gd name="connsiteX32" fmla="*/ 1374699 w 1564705"/>
              <a:gd name="connsiteY32" fmla="*/ 95003 h 1021278"/>
              <a:gd name="connsiteX33" fmla="*/ 1410325 w 1564705"/>
              <a:gd name="connsiteY33" fmla="*/ 106878 h 1021278"/>
              <a:gd name="connsiteX34" fmla="*/ 1493453 w 1564705"/>
              <a:gd name="connsiteY34" fmla="*/ 154380 h 1021278"/>
              <a:gd name="connsiteX35" fmla="*/ 1564705 w 1564705"/>
              <a:gd name="connsiteY35" fmla="*/ 201881 h 102127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564705" h="1021278">
                <a:moveTo>
                  <a:pt x="1540954" y="760021"/>
                </a:moveTo>
                <a:cubicBezTo>
                  <a:pt x="1460109" y="808528"/>
                  <a:pt x="1503474" y="788348"/>
                  <a:pt x="1410325" y="819398"/>
                </a:cubicBezTo>
                <a:cubicBezTo>
                  <a:pt x="1383245" y="828425"/>
                  <a:pt x="1366153" y="857872"/>
                  <a:pt x="1339073" y="866899"/>
                </a:cubicBezTo>
                <a:cubicBezTo>
                  <a:pt x="1315323" y="874816"/>
                  <a:pt x="1289052" y="877382"/>
                  <a:pt x="1267822" y="890650"/>
                </a:cubicBezTo>
                <a:cubicBezTo>
                  <a:pt x="1236154" y="910442"/>
                  <a:pt x="1209438" y="942702"/>
                  <a:pt x="1172819" y="950026"/>
                </a:cubicBezTo>
                <a:cubicBezTo>
                  <a:pt x="1153027" y="953985"/>
                  <a:pt x="1133024" y="957007"/>
                  <a:pt x="1113442" y="961902"/>
                </a:cubicBezTo>
                <a:cubicBezTo>
                  <a:pt x="1101298" y="964938"/>
                  <a:pt x="1089852" y="970338"/>
                  <a:pt x="1077816" y="973777"/>
                </a:cubicBezTo>
                <a:cubicBezTo>
                  <a:pt x="1062123" y="978261"/>
                  <a:pt x="1046247" y="982111"/>
                  <a:pt x="1030315" y="985652"/>
                </a:cubicBezTo>
                <a:cubicBezTo>
                  <a:pt x="915673" y="1011128"/>
                  <a:pt x="1028609" y="983619"/>
                  <a:pt x="899686" y="1009403"/>
                </a:cubicBezTo>
                <a:cubicBezTo>
                  <a:pt x="883682" y="1012604"/>
                  <a:pt x="868019" y="1017320"/>
                  <a:pt x="852185" y="1021278"/>
                </a:cubicBezTo>
                <a:cubicBezTo>
                  <a:pt x="439549" y="1008383"/>
                  <a:pt x="595123" y="1040140"/>
                  <a:pt x="377172" y="985652"/>
                </a:cubicBezTo>
                <a:cubicBezTo>
                  <a:pt x="359998" y="981358"/>
                  <a:pt x="345505" y="969819"/>
                  <a:pt x="329671" y="961902"/>
                </a:cubicBezTo>
                <a:cubicBezTo>
                  <a:pt x="317796" y="950027"/>
                  <a:pt x="306947" y="937027"/>
                  <a:pt x="294045" y="926276"/>
                </a:cubicBezTo>
                <a:cubicBezTo>
                  <a:pt x="240110" y="881330"/>
                  <a:pt x="268005" y="926383"/>
                  <a:pt x="210918" y="855024"/>
                </a:cubicBezTo>
                <a:cubicBezTo>
                  <a:pt x="193086" y="832734"/>
                  <a:pt x="179250" y="807523"/>
                  <a:pt x="163416" y="783772"/>
                </a:cubicBezTo>
                <a:cubicBezTo>
                  <a:pt x="155499" y="771897"/>
                  <a:pt x="138754" y="769158"/>
                  <a:pt x="127790" y="760021"/>
                </a:cubicBezTo>
                <a:cubicBezTo>
                  <a:pt x="114888" y="749270"/>
                  <a:pt x="104039" y="736270"/>
                  <a:pt x="92164" y="724395"/>
                </a:cubicBezTo>
                <a:cubicBezTo>
                  <a:pt x="84247" y="708561"/>
                  <a:pt x="77197" y="692264"/>
                  <a:pt x="68414" y="676894"/>
                </a:cubicBezTo>
                <a:cubicBezTo>
                  <a:pt x="1263" y="559379"/>
                  <a:pt x="92697" y="737335"/>
                  <a:pt x="20912" y="593767"/>
                </a:cubicBezTo>
                <a:cubicBezTo>
                  <a:pt x="-8458" y="476281"/>
                  <a:pt x="-5445" y="507741"/>
                  <a:pt x="20912" y="296883"/>
                </a:cubicBezTo>
                <a:cubicBezTo>
                  <a:pt x="22682" y="282721"/>
                  <a:pt x="34571" y="271349"/>
                  <a:pt x="44663" y="261257"/>
                </a:cubicBezTo>
                <a:cubicBezTo>
                  <a:pt x="67682" y="238238"/>
                  <a:pt x="86941" y="235289"/>
                  <a:pt x="115915" y="225631"/>
                </a:cubicBezTo>
                <a:cubicBezTo>
                  <a:pt x="131749" y="209797"/>
                  <a:pt x="145195" y="191145"/>
                  <a:pt x="163416" y="178130"/>
                </a:cubicBezTo>
                <a:cubicBezTo>
                  <a:pt x="172590" y="171577"/>
                  <a:pt x="241577" y="155622"/>
                  <a:pt x="246544" y="154380"/>
                </a:cubicBezTo>
                <a:cubicBezTo>
                  <a:pt x="261118" y="142721"/>
                  <a:pt x="316333" y="95734"/>
                  <a:pt x="341546" y="83128"/>
                </a:cubicBezTo>
                <a:cubicBezTo>
                  <a:pt x="352742" y="77530"/>
                  <a:pt x="365451" y="75647"/>
                  <a:pt x="377172" y="71252"/>
                </a:cubicBezTo>
                <a:cubicBezTo>
                  <a:pt x="397132" y="63767"/>
                  <a:pt x="416515" y="54787"/>
                  <a:pt x="436549" y="47502"/>
                </a:cubicBezTo>
                <a:cubicBezTo>
                  <a:pt x="604204" y="-13463"/>
                  <a:pt x="419692" y="58996"/>
                  <a:pt x="567177" y="0"/>
                </a:cubicBezTo>
                <a:cubicBezTo>
                  <a:pt x="757182" y="3959"/>
                  <a:pt x="947439" y="1334"/>
                  <a:pt x="1137193" y="11876"/>
                </a:cubicBezTo>
                <a:cubicBezTo>
                  <a:pt x="1162190" y="13265"/>
                  <a:pt x="1184694" y="27709"/>
                  <a:pt x="1208445" y="35626"/>
                </a:cubicBezTo>
                <a:cubicBezTo>
                  <a:pt x="1239412" y="45948"/>
                  <a:pt x="1272480" y="49055"/>
                  <a:pt x="1303447" y="59377"/>
                </a:cubicBezTo>
                <a:lnTo>
                  <a:pt x="1339073" y="71252"/>
                </a:lnTo>
                <a:cubicBezTo>
                  <a:pt x="1350948" y="79169"/>
                  <a:pt x="1361933" y="88620"/>
                  <a:pt x="1374699" y="95003"/>
                </a:cubicBezTo>
                <a:cubicBezTo>
                  <a:pt x="1385895" y="100601"/>
                  <a:pt x="1399910" y="99934"/>
                  <a:pt x="1410325" y="106878"/>
                </a:cubicBezTo>
                <a:cubicBezTo>
                  <a:pt x="1495227" y="163479"/>
                  <a:pt x="1392985" y="129262"/>
                  <a:pt x="1493453" y="154380"/>
                </a:cubicBezTo>
                <a:lnTo>
                  <a:pt x="1564705" y="201881"/>
                </a:lnTo>
              </a:path>
            </a:pathLst>
          </a:custGeom>
          <a:noFill/>
          <a:ln w="349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>
                  <a:lumMod val="85000"/>
                  <a:lumOff val="15000"/>
                </a:schemeClr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44" name="フリーフォーム 143"/>
          <p:cNvSpPr/>
          <p:nvPr/>
        </p:nvSpPr>
        <p:spPr>
          <a:xfrm flipH="1">
            <a:off x="5553107" y="1294709"/>
            <a:ext cx="171021" cy="86789"/>
          </a:xfrm>
          <a:custGeom>
            <a:avLst/>
            <a:gdLst>
              <a:gd name="connsiteX0" fmla="*/ 1540954 w 1564705"/>
              <a:gd name="connsiteY0" fmla="*/ 760021 h 1021278"/>
              <a:gd name="connsiteX1" fmla="*/ 1410325 w 1564705"/>
              <a:gd name="connsiteY1" fmla="*/ 819398 h 1021278"/>
              <a:gd name="connsiteX2" fmla="*/ 1339073 w 1564705"/>
              <a:gd name="connsiteY2" fmla="*/ 866899 h 1021278"/>
              <a:gd name="connsiteX3" fmla="*/ 1267822 w 1564705"/>
              <a:gd name="connsiteY3" fmla="*/ 890650 h 1021278"/>
              <a:gd name="connsiteX4" fmla="*/ 1172819 w 1564705"/>
              <a:gd name="connsiteY4" fmla="*/ 950026 h 1021278"/>
              <a:gd name="connsiteX5" fmla="*/ 1113442 w 1564705"/>
              <a:gd name="connsiteY5" fmla="*/ 961902 h 1021278"/>
              <a:gd name="connsiteX6" fmla="*/ 1077816 w 1564705"/>
              <a:gd name="connsiteY6" fmla="*/ 973777 h 1021278"/>
              <a:gd name="connsiteX7" fmla="*/ 1030315 w 1564705"/>
              <a:gd name="connsiteY7" fmla="*/ 985652 h 1021278"/>
              <a:gd name="connsiteX8" fmla="*/ 899686 w 1564705"/>
              <a:gd name="connsiteY8" fmla="*/ 1009403 h 1021278"/>
              <a:gd name="connsiteX9" fmla="*/ 852185 w 1564705"/>
              <a:gd name="connsiteY9" fmla="*/ 1021278 h 1021278"/>
              <a:gd name="connsiteX10" fmla="*/ 377172 w 1564705"/>
              <a:gd name="connsiteY10" fmla="*/ 985652 h 1021278"/>
              <a:gd name="connsiteX11" fmla="*/ 329671 w 1564705"/>
              <a:gd name="connsiteY11" fmla="*/ 961902 h 1021278"/>
              <a:gd name="connsiteX12" fmla="*/ 294045 w 1564705"/>
              <a:gd name="connsiteY12" fmla="*/ 926276 h 1021278"/>
              <a:gd name="connsiteX13" fmla="*/ 210918 w 1564705"/>
              <a:gd name="connsiteY13" fmla="*/ 855024 h 1021278"/>
              <a:gd name="connsiteX14" fmla="*/ 163416 w 1564705"/>
              <a:gd name="connsiteY14" fmla="*/ 783772 h 1021278"/>
              <a:gd name="connsiteX15" fmla="*/ 127790 w 1564705"/>
              <a:gd name="connsiteY15" fmla="*/ 760021 h 1021278"/>
              <a:gd name="connsiteX16" fmla="*/ 92164 w 1564705"/>
              <a:gd name="connsiteY16" fmla="*/ 724395 h 1021278"/>
              <a:gd name="connsiteX17" fmla="*/ 68414 w 1564705"/>
              <a:gd name="connsiteY17" fmla="*/ 676894 h 1021278"/>
              <a:gd name="connsiteX18" fmla="*/ 20912 w 1564705"/>
              <a:gd name="connsiteY18" fmla="*/ 593767 h 1021278"/>
              <a:gd name="connsiteX19" fmla="*/ 20912 w 1564705"/>
              <a:gd name="connsiteY19" fmla="*/ 296883 h 1021278"/>
              <a:gd name="connsiteX20" fmla="*/ 44663 w 1564705"/>
              <a:gd name="connsiteY20" fmla="*/ 261257 h 1021278"/>
              <a:gd name="connsiteX21" fmla="*/ 115915 w 1564705"/>
              <a:gd name="connsiteY21" fmla="*/ 225631 h 1021278"/>
              <a:gd name="connsiteX22" fmla="*/ 163416 w 1564705"/>
              <a:gd name="connsiteY22" fmla="*/ 178130 h 1021278"/>
              <a:gd name="connsiteX23" fmla="*/ 246544 w 1564705"/>
              <a:gd name="connsiteY23" fmla="*/ 154380 h 1021278"/>
              <a:gd name="connsiteX24" fmla="*/ 341546 w 1564705"/>
              <a:gd name="connsiteY24" fmla="*/ 83128 h 1021278"/>
              <a:gd name="connsiteX25" fmla="*/ 377172 w 1564705"/>
              <a:gd name="connsiteY25" fmla="*/ 71252 h 1021278"/>
              <a:gd name="connsiteX26" fmla="*/ 436549 w 1564705"/>
              <a:gd name="connsiteY26" fmla="*/ 47502 h 1021278"/>
              <a:gd name="connsiteX27" fmla="*/ 567177 w 1564705"/>
              <a:gd name="connsiteY27" fmla="*/ 0 h 1021278"/>
              <a:gd name="connsiteX28" fmla="*/ 1137193 w 1564705"/>
              <a:gd name="connsiteY28" fmla="*/ 11876 h 1021278"/>
              <a:gd name="connsiteX29" fmla="*/ 1208445 w 1564705"/>
              <a:gd name="connsiteY29" fmla="*/ 35626 h 1021278"/>
              <a:gd name="connsiteX30" fmla="*/ 1303447 w 1564705"/>
              <a:gd name="connsiteY30" fmla="*/ 59377 h 1021278"/>
              <a:gd name="connsiteX31" fmla="*/ 1339073 w 1564705"/>
              <a:gd name="connsiteY31" fmla="*/ 71252 h 1021278"/>
              <a:gd name="connsiteX32" fmla="*/ 1374699 w 1564705"/>
              <a:gd name="connsiteY32" fmla="*/ 95003 h 1021278"/>
              <a:gd name="connsiteX33" fmla="*/ 1410325 w 1564705"/>
              <a:gd name="connsiteY33" fmla="*/ 106878 h 1021278"/>
              <a:gd name="connsiteX34" fmla="*/ 1493453 w 1564705"/>
              <a:gd name="connsiteY34" fmla="*/ 154380 h 1021278"/>
              <a:gd name="connsiteX35" fmla="*/ 1564705 w 1564705"/>
              <a:gd name="connsiteY35" fmla="*/ 201881 h 102127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564705" h="1021278">
                <a:moveTo>
                  <a:pt x="1540954" y="760021"/>
                </a:moveTo>
                <a:cubicBezTo>
                  <a:pt x="1460109" y="808528"/>
                  <a:pt x="1503474" y="788348"/>
                  <a:pt x="1410325" y="819398"/>
                </a:cubicBezTo>
                <a:cubicBezTo>
                  <a:pt x="1383245" y="828425"/>
                  <a:pt x="1366153" y="857872"/>
                  <a:pt x="1339073" y="866899"/>
                </a:cubicBezTo>
                <a:cubicBezTo>
                  <a:pt x="1315323" y="874816"/>
                  <a:pt x="1289052" y="877382"/>
                  <a:pt x="1267822" y="890650"/>
                </a:cubicBezTo>
                <a:cubicBezTo>
                  <a:pt x="1236154" y="910442"/>
                  <a:pt x="1209438" y="942702"/>
                  <a:pt x="1172819" y="950026"/>
                </a:cubicBezTo>
                <a:cubicBezTo>
                  <a:pt x="1153027" y="953985"/>
                  <a:pt x="1133024" y="957007"/>
                  <a:pt x="1113442" y="961902"/>
                </a:cubicBezTo>
                <a:cubicBezTo>
                  <a:pt x="1101298" y="964938"/>
                  <a:pt x="1089852" y="970338"/>
                  <a:pt x="1077816" y="973777"/>
                </a:cubicBezTo>
                <a:cubicBezTo>
                  <a:pt x="1062123" y="978261"/>
                  <a:pt x="1046247" y="982111"/>
                  <a:pt x="1030315" y="985652"/>
                </a:cubicBezTo>
                <a:cubicBezTo>
                  <a:pt x="915673" y="1011128"/>
                  <a:pt x="1028609" y="983619"/>
                  <a:pt x="899686" y="1009403"/>
                </a:cubicBezTo>
                <a:cubicBezTo>
                  <a:pt x="883682" y="1012604"/>
                  <a:pt x="868019" y="1017320"/>
                  <a:pt x="852185" y="1021278"/>
                </a:cubicBezTo>
                <a:cubicBezTo>
                  <a:pt x="439549" y="1008383"/>
                  <a:pt x="595123" y="1040140"/>
                  <a:pt x="377172" y="985652"/>
                </a:cubicBezTo>
                <a:cubicBezTo>
                  <a:pt x="359998" y="981358"/>
                  <a:pt x="345505" y="969819"/>
                  <a:pt x="329671" y="961902"/>
                </a:cubicBezTo>
                <a:cubicBezTo>
                  <a:pt x="317796" y="950027"/>
                  <a:pt x="306947" y="937027"/>
                  <a:pt x="294045" y="926276"/>
                </a:cubicBezTo>
                <a:cubicBezTo>
                  <a:pt x="240110" y="881330"/>
                  <a:pt x="268005" y="926383"/>
                  <a:pt x="210918" y="855024"/>
                </a:cubicBezTo>
                <a:cubicBezTo>
                  <a:pt x="193086" y="832734"/>
                  <a:pt x="179250" y="807523"/>
                  <a:pt x="163416" y="783772"/>
                </a:cubicBezTo>
                <a:cubicBezTo>
                  <a:pt x="155499" y="771897"/>
                  <a:pt x="138754" y="769158"/>
                  <a:pt x="127790" y="760021"/>
                </a:cubicBezTo>
                <a:cubicBezTo>
                  <a:pt x="114888" y="749270"/>
                  <a:pt x="104039" y="736270"/>
                  <a:pt x="92164" y="724395"/>
                </a:cubicBezTo>
                <a:cubicBezTo>
                  <a:pt x="84247" y="708561"/>
                  <a:pt x="77197" y="692264"/>
                  <a:pt x="68414" y="676894"/>
                </a:cubicBezTo>
                <a:cubicBezTo>
                  <a:pt x="1263" y="559379"/>
                  <a:pt x="92697" y="737335"/>
                  <a:pt x="20912" y="593767"/>
                </a:cubicBezTo>
                <a:cubicBezTo>
                  <a:pt x="-8458" y="476281"/>
                  <a:pt x="-5445" y="507741"/>
                  <a:pt x="20912" y="296883"/>
                </a:cubicBezTo>
                <a:cubicBezTo>
                  <a:pt x="22682" y="282721"/>
                  <a:pt x="34571" y="271349"/>
                  <a:pt x="44663" y="261257"/>
                </a:cubicBezTo>
                <a:cubicBezTo>
                  <a:pt x="67682" y="238238"/>
                  <a:pt x="86941" y="235289"/>
                  <a:pt x="115915" y="225631"/>
                </a:cubicBezTo>
                <a:cubicBezTo>
                  <a:pt x="131749" y="209797"/>
                  <a:pt x="145195" y="191145"/>
                  <a:pt x="163416" y="178130"/>
                </a:cubicBezTo>
                <a:cubicBezTo>
                  <a:pt x="172590" y="171577"/>
                  <a:pt x="241577" y="155622"/>
                  <a:pt x="246544" y="154380"/>
                </a:cubicBezTo>
                <a:cubicBezTo>
                  <a:pt x="261118" y="142721"/>
                  <a:pt x="316333" y="95734"/>
                  <a:pt x="341546" y="83128"/>
                </a:cubicBezTo>
                <a:cubicBezTo>
                  <a:pt x="352742" y="77530"/>
                  <a:pt x="365451" y="75647"/>
                  <a:pt x="377172" y="71252"/>
                </a:cubicBezTo>
                <a:cubicBezTo>
                  <a:pt x="397132" y="63767"/>
                  <a:pt x="416515" y="54787"/>
                  <a:pt x="436549" y="47502"/>
                </a:cubicBezTo>
                <a:cubicBezTo>
                  <a:pt x="604204" y="-13463"/>
                  <a:pt x="419692" y="58996"/>
                  <a:pt x="567177" y="0"/>
                </a:cubicBezTo>
                <a:cubicBezTo>
                  <a:pt x="757182" y="3959"/>
                  <a:pt x="947439" y="1334"/>
                  <a:pt x="1137193" y="11876"/>
                </a:cubicBezTo>
                <a:cubicBezTo>
                  <a:pt x="1162190" y="13265"/>
                  <a:pt x="1184694" y="27709"/>
                  <a:pt x="1208445" y="35626"/>
                </a:cubicBezTo>
                <a:cubicBezTo>
                  <a:pt x="1239412" y="45948"/>
                  <a:pt x="1272480" y="49055"/>
                  <a:pt x="1303447" y="59377"/>
                </a:cubicBezTo>
                <a:lnTo>
                  <a:pt x="1339073" y="71252"/>
                </a:lnTo>
                <a:cubicBezTo>
                  <a:pt x="1350948" y="79169"/>
                  <a:pt x="1361933" y="88620"/>
                  <a:pt x="1374699" y="95003"/>
                </a:cubicBezTo>
                <a:cubicBezTo>
                  <a:pt x="1385895" y="100601"/>
                  <a:pt x="1399910" y="99934"/>
                  <a:pt x="1410325" y="106878"/>
                </a:cubicBezTo>
                <a:cubicBezTo>
                  <a:pt x="1495227" y="163479"/>
                  <a:pt x="1392985" y="129262"/>
                  <a:pt x="1493453" y="154380"/>
                </a:cubicBezTo>
                <a:lnTo>
                  <a:pt x="1564705" y="201881"/>
                </a:lnTo>
              </a:path>
            </a:pathLst>
          </a:custGeom>
          <a:noFill/>
          <a:ln w="349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>
                  <a:lumMod val="85000"/>
                  <a:lumOff val="15000"/>
                </a:schemeClr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45" name="テキスト ボックス 144"/>
          <p:cNvSpPr txBox="1"/>
          <p:nvPr/>
        </p:nvSpPr>
        <p:spPr>
          <a:xfrm>
            <a:off x="232587" y="1471886"/>
            <a:ext cx="13969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2 </a:t>
            </a:r>
            <a:r>
              <a:rPr lang="en-US" altLang="ja-JP" sz="1200" b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lncRNA</a:t>
            </a:r>
            <a:endParaRPr kumimoji="1" lang="ja-JP" altLang="en-US" sz="12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50" name="テキスト ボックス 149"/>
          <p:cNvSpPr txBox="1"/>
          <p:nvPr/>
        </p:nvSpPr>
        <p:spPr>
          <a:xfrm rot="16200000">
            <a:off x="-240877" y="2700971"/>
            <a:ext cx="14225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WT TDP-43</a:t>
            </a:r>
            <a:endParaRPr kumimoji="1" lang="ja-JP" altLang="en-US" sz="1400" b="1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51" name="テキスト ボックス 150"/>
          <p:cNvSpPr txBox="1"/>
          <p:nvPr/>
        </p:nvSpPr>
        <p:spPr>
          <a:xfrm rot="16200000">
            <a:off x="-218327" y="4179355"/>
            <a:ext cx="1377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WT FUS</a:t>
            </a:r>
            <a:r>
              <a:rPr lang="en-US" altLang="ja-JP" sz="14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/TLS</a:t>
            </a:r>
            <a:endParaRPr kumimoji="1" lang="ja-JP" altLang="en-US" sz="1400" b="1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52" name="テキスト ボックス 151"/>
          <p:cNvSpPr txBox="1"/>
          <p:nvPr/>
        </p:nvSpPr>
        <p:spPr>
          <a:xfrm rot="16200000">
            <a:off x="119748" y="5535117"/>
            <a:ext cx="6584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ock</a:t>
            </a:r>
            <a:endParaRPr kumimoji="1" lang="ja-JP" altLang="en-US" sz="1400" b="1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53" name="フリーフォーム 152"/>
          <p:cNvSpPr/>
          <p:nvPr/>
        </p:nvSpPr>
        <p:spPr>
          <a:xfrm>
            <a:off x="3757538" y="2916252"/>
            <a:ext cx="552450" cy="468630"/>
          </a:xfrm>
          <a:custGeom>
            <a:avLst/>
            <a:gdLst>
              <a:gd name="connsiteX0" fmla="*/ 514350 w 552450"/>
              <a:gd name="connsiteY0" fmla="*/ 415290 h 468630"/>
              <a:gd name="connsiteX1" fmla="*/ 495300 w 552450"/>
              <a:gd name="connsiteY1" fmla="*/ 419100 h 468630"/>
              <a:gd name="connsiteX2" fmla="*/ 472440 w 552450"/>
              <a:gd name="connsiteY2" fmla="*/ 426720 h 468630"/>
              <a:gd name="connsiteX3" fmla="*/ 464820 w 552450"/>
              <a:gd name="connsiteY3" fmla="*/ 438150 h 468630"/>
              <a:gd name="connsiteX4" fmla="*/ 453390 w 552450"/>
              <a:gd name="connsiteY4" fmla="*/ 441960 h 468630"/>
              <a:gd name="connsiteX5" fmla="*/ 438150 w 552450"/>
              <a:gd name="connsiteY5" fmla="*/ 449580 h 468630"/>
              <a:gd name="connsiteX6" fmla="*/ 403860 w 552450"/>
              <a:gd name="connsiteY6" fmla="*/ 461010 h 468630"/>
              <a:gd name="connsiteX7" fmla="*/ 392430 w 552450"/>
              <a:gd name="connsiteY7" fmla="*/ 464820 h 468630"/>
              <a:gd name="connsiteX8" fmla="*/ 365760 w 552450"/>
              <a:gd name="connsiteY8" fmla="*/ 468630 h 468630"/>
              <a:gd name="connsiteX9" fmla="*/ 266700 w 552450"/>
              <a:gd name="connsiteY9" fmla="*/ 464820 h 468630"/>
              <a:gd name="connsiteX10" fmla="*/ 232410 w 552450"/>
              <a:gd name="connsiteY10" fmla="*/ 453390 h 468630"/>
              <a:gd name="connsiteX11" fmla="*/ 220980 w 552450"/>
              <a:gd name="connsiteY11" fmla="*/ 449580 h 468630"/>
              <a:gd name="connsiteX12" fmla="*/ 194310 w 552450"/>
              <a:gd name="connsiteY12" fmla="*/ 434340 h 468630"/>
              <a:gd name="connsiteX13" fmla="*/ 182880 w 552450"/>
              <a:gd name="connsiteY13" fmla="*/ 426720 h 468630"/>
              <a:gd name="connsiteX14" fmla="*/ 171450 w 552450"/>
              <a:gd name="connsiteY14" fmla="*/ 411480 h 468630"/>
              <a:gd name="connsiteX15" fmla="*/ 144780 w 552450"/>
              <a:gd name="connsiteY15" fmla="*/ 400050 h 468630"/>
              <a:gd name="connsiteX16" fmla="*/ 121920 w 552450"/>
              <a:gd name="connsiteY16" fmla="*/ 384810 h 468630"/>
              <a:gd name="connsiteX17" fmla="*/ 110490 w 552450"/>
              <a:gd name="connsiteY17" fmla="*/ 373380 h 468630"/>
              <a:gd name="connsiteX18" fmla="*/ 95250 w 552450"/>
              <a:gd name="connsiteY18" fmla="*/ 350520 h 468630"/>
              <a:gd name="connsiteX19" fmla="*/ 80010 w 552450"/>
              <a:gd name="connsiteY19" fmla="*/ 346710 h 468630"/>
              <a:gd name="connsiteX20" fmla="*/ 57150 w 552450"/>
              <a:gd name="connsiteY20" fmla="*/ 327660 h 468630"/>
              <a:gd name="connsiteX21" fmla="*/ 30480 w 552450"/>
              <a:gd name="connsiteY21" fmla="*/ 293370 h 468630"/>
              <a:gd name="connsiteX22" fmla="*/ 19050 w 552450"/>
              <a:gd name="connsiteY22" fmla="*/ 266700 h 468630"/>
              <a:gd name="connsiteX23" fmla="*/ 11430 w 552450"/>
              <a:gd name="connsiteY23" fmla="*/ 255270 h 468630"/>
              <a:gd name="connsiteX24" fmla="*/ 3810 w 552450"/>
              <a:gd name="connsiteY24" fmla="*/ 232410 h 468630"/>
              <a:gd name="connsiteX25" fmla="*/ 0 w 552450"/>
              <a:gd name="connsiteY25" fmla="*/ 220980 h 468630"/>
              <a:gd name="connsiteX26" fmla="*/ 3810 w 552450"/>
              <a:gd name="connsiteY26" fmla="*/ 198120 h 468630"/>
              <a:gd name="connsiteX27" fmla="*/ 7620 w 552450"/>
              <a:gd name="connsiteY27" fmla="*/ 160020 h 468630"/>
              <a:gd name="connsiteX28" fmla="*/ 26670 w 552450"/>
              <a:gd name="connsiteY28" fmla="*/ 140970 h 468630"/>
              <a:gd name="connsiteX29" fmla="*/ 30480 w 552450"/>
              <a:gd name="connsiteY29" fmla="*/ 129540 h 468630"/>
              <a:gd name="connsiteX30" fmla="*/ 49530 w 552450"/>
              <a:gd name="connsiteY30" fmla="*/ 106680 h 468630"/>
              <a:gd name="connsiteX31" fmla="*/ 53340 w 552450"/>
              <a:gd name="connsiteY31" fmla="*/ 95250 h 468630"/>
              <a:gd name="connsiteX32" fmla="*/ 76200 w 552450"/>
              <a:gd name="connsiteY32" fmla="*/ 80010 h 468630"/>
              <a:gd name="connsiteX33" fmla="*/ 95250 w 552450"/>
              <a:gd name="connsiteY33" fmla="*/ 64770 h 468630"/>
              <a:gd name="connsiteX34" fmla="*/ 106680 w 552450"/>
              <a:gd name="connsiteY34" fmla="*/ 57150 h 468630"/>
              <a:gd name="connsiteX35" fmla="*/ 121920 w 552450"/>
              <a:gd name="connsiteY35" fmla="*/ 49530 h 468630"/>
              <a:gd name="connsiteX36" fmla="*/ 133350 w 552450"/>
              <a:gd name="connsiteY36" fmla="*/ 41910 h 468630"/>
              <a:gd name="connsiteX37" fmla="*/ 148590 w 552450"/>
              <a:gd name="connsiteY37" fmla="*/ 38100 h 468630"/>
              <a:gd name="connsiteX38" fmla="*/ 152400 w 552450"/>
              <a:gd name="connsiteY38" fmla="*/ 26670 h 468630"/>
              <a:gd name="connsiteX39" fmla="*/ 163830 w 552450"/>
              <a:gd name="connsiteY39" fmla="*/ 19050 h 468630"/>
              <a:gd name="connsiteX40" fmla="*/ 190500 w 552450"/>
              <a:gd name="connsiteY40" fmla="*/ 0 h 468630"/>
              <a:gd name="connsiteX41" fmla="*/ 297180 w 552450"/>
              <a:gd name="connsiteY41" fmla="*/ 3810 h 468630"/>
              <a:gd name="connsiteX42" fmla="*/ 320040 w 552450"/>
              <a:gd name="connsiteY42" fmla="*/ 22860 h 468630"/>
              <a:gd name="connsiteX43" fmla="*/ 342900 w 552450"/>
              <a:gd name="connsiteY43" fmla="*/ 30480 h 468630"/>
              <a:gd name="connsiteX44" fmla="*/ 369570 w 552450"/>
              <a:gd name="connsiteY44" fmla="*/ 45720 h 468630"/>
              <a:gd name="connsiteX45" fmla="*/ 384810 w 552450"/>
              <a:gd name="connsiteY45" fmla="*/ 49530 h 468630"/>
              <a:gd name="connsiteX46" fmla="*/ 396240 w 552450"/>
              <a:gd name="connsiteY46" fmla="*/ 53340 h 468630"/>
              <a:gd name="connsiteX47" fmla="*/ 415290 w 552450"/>
              <a:gd name="connsiteY47" fmla="*/ 72390 h 468630"/>
              <a:gd name="connsiteX48" fmla="*/ 434340 w 552450"/>
              <a:gd name="connsiteY48" fmla="*/ 95250 h 468630"/>
              <a:gd name="connsiteX49" fmla="*/ 457200 w 552450"/>
              <a:gd name="connsiteY49" fmla="*/ 110490 h 468630"/>
              <a:gd name="connsiteX50" fmla="*/ 468630 w 552450"/>
              <a:gd name="connsiteY50" fmla="*/ 118110 h 468630"/>
              <a:gd name="connsiteX51" fmla="*/ 480060 w 552450"/>
              <a:gd name="connsiteY51" fmla="*/ 121920 h 468630"/>
              <a:gd name="connsiteX52" fmla="*/ 491490 w 552450"/>
              <a:gd name="connsiteY52" fmla="*/ 129540 h 468630"/>
              <a:gd name="connsiteX53" fmla="*/ 510540 w 552450"/>
              <a:gd name="connsiteY53" fmla="*/ 148590 h 468630"/>
              <a:gd name="connsiteX54" fmla="*/ 518160 w 552450"/>
              <a:gd name="connsiteY54" fmla="*/ 171450 h 468630"/>
              <a:gd name="connsiteX55" fmla="*/ 525780 w 552450"/>
              <a:gd name="connsiteY55" fmla="*/ 182880 h 468630"/>
              <a:gd name="connsiteX56" fmla="*/ 529590 w 552450"/>
              <a:gd name="connsiteY56" fmla="*/ 194310 h 468630"/>
              <a:gd name="connsiteX57" fmla="*/ 533400 w 552450"/>
              <a:gd name="connsiteY57" fmla="*/ 232410 h 468630"/>
              <a:gd name="connsiteX58" fmla="*/ 541020 w 552450"/>
              <a:gd name="connsiteY58" fmla="*/ 243840 h 468630"/>
              <a:gd name="connsiteX59" fmla="*/ 544830 w 552450"/>
              <a:gd name="connsiteY59" fmla="*/ 262890 h 468630"/>
              <a:gd name="connsiteX60" fmla="*/ 552450 w 552450"/>
              <a:gd name="connsiteY60" fmla="*/ 308610 h 468630"/>
              <a:gd name="connsiteX61" fmla="*/ 544830 w 552450"/>
              <a:gd name="connsiteY61" fmla="*/ 350520 h 468630"/>
              <a:gd name="connsiteX62" fmla="*/ 537210 w 552450"/>
              <a:gd name="connsiteY62" fmla="*/ 361950 h 468630"/>
              <a:gd name="connsiteX63" fmla="*/ 533400 w 552450"/>
              <a:gd name="connsiteY63" fmla="*/ 373380 h 468630"/>
              <a:gd name="connsiteX64" fmla="*/ 525780 w 552450"/>
              <a:gd name="connsiteY64" fmla="*/ 384810 h 468630"/>
              <a:gd name="connsiteX65" fmla="*/ 518160 w 552450"/>
              <a:gd name="connsiteY65" fmla="*/ 407670 h 468630"/>
              <a:gd name="connsiteX66" fmla="*/ 514350 w 552450"/>
              <a:gd name="connsiteY66" fmla="*/ 415290 h 46863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</a:cxnLst>
            <a:rect l="l" t="t" r="r" b="b"/>
            <a:pathLst>
              <a:path w="552450" h="468630">
                <a:moveTo>
                  <a:pt x="514350" y="415290"/>
                </a:moveTo>
                <a:cubicBezTo>
                  <a:pt x="510540" y="417195"/>
                  <a:pt x="501548" y="417396"/>
                  <a:pt x="495300" y="419100"/>
                </a:cubicBezTo>
                <a:cubicBezTo>
                  <a:pt x="487551" y="421213"/>
                  <a:pt x="472440" y="426720"/>
                  <a:pt x="472440" y="426720"/>
                </a:cubicBezTo>
                <a:cubicBezTo>
                  <a:pt x="469900" y="430530"/>
                  <a:pt x="468396" y="435289"/>
                  <a:pt x="464820" y="438150"/>
                </a:cubicBezTo>
                <a:cubicBezTo>
                  <a:pt x="461684" y="440659"/>
                  <a:pt x="457081" y="440378"/>
                  <a:pt x="453390" y="441960"/>
                </a:cubicBezTo>
                <a:cubicBezTo>
                  <a:pt x="448170" y="444197"/>
                  <a:pt x="443423" y="447471"/>
                  <a:pt x="438150" y="449580"/>
                </a:cubicBezTo>
                <a:lnTo>
                  <a:pt x="403860" y="461010"/>
                </a:lnTo>
                <a:cubicBezTo>
                  <a:pt x="400050" y="462280"/>
                  <a:pt x="396406" y="464252"/>
                  <a:pt x="392430" y="464820"/>
                </a:cubicBezTo>
                <a:lnTo>
                  <a:pt x="365760" y="468630"/>
                </a:lnTo>
                <a:cubicBezTo>
                  <a:pt x="332740" y="467360"/>
                  <a:pt x="299600" y="467904"/>
                  <a:pt x="266700" y="464820"/>
                </a:cubicBezTo>
                <a:lnTo>
                  <a:pt x="232410" y="453390"/>
                </a:lnTo>
                <a:lnTo>
                  <a:pt x="220980" y="449580"/>
                </a:lnTo>
                <a:cubicBezTo>
                  <a:pt x="193133" y="431015"/>
                  <a:pt x="228147" y="453676"/>
                  <a:pt x="194310" y="434340"/>
                </a:cubicBezTo>
                <a:cubicBezTo>
                  <a:pt x="190334" y="432068"/>
                  <a:pt x="186690" y="429260"/>
                  <a:pt x="182880" y="426720"/>
                </a:cubicBezTo>
                <a:cubicBezTo>
                  <a:pt x="179070" y="421640"/>
                  <a:pt x="176271" y="415613"/>
                  <a:pt x="171450" y="411480"/>
                </a:cubicBezTo>
                <a:cubicBezTo>
                  <a:pt x="165458" y="406344"/>
                  <a:pt x="152519" y="402630"/>
                  <a:pt x="144780" y="400050"/>
                </a:cubicBezTo>
                <a:cubicBezTo>
                  <a:pt x="108317" y="363587"/>
                  <a:pt x="155003" y="406866"/>
                  <a:pt x="121920" y="384810"/>
                </a:cubicBezTo>
                <a:cubicBezTo>
                  <a:pt x="117437" y="381821"/>
                  <a:pt x="113798" y="377633"/>
                  <a:pt x="110490" y="373380"/>
                </a:cubicBezTo>
                <a:cubicBezTo>
                  <a:pt x="104867" y="366151"/>
                  <a:pt x="104135" y="352741"/>
                  <a:pt x="95250" y="350520"/>
                </a:cubicBezTo>
                <a:lnTo>
                  <a:pt x="80010" y="346710"/>
                </a:lnTo>
                <a:cubicBezTo>
                  <a:pt x="69850" y="339937"/>
                  <a:pt x="65048" y="337815"/>
                  <a:pt x="57150" y="327660"/>
                </a:cubicBezTo>
                <a:cubicBezTo>
                  <a:pt x="25250" y="286645"/>
                  <a:pt x="56429" y="319319"/>
                  <a:pt x="30480" y="293370"/>
                </a:cubicBezTo>
                <a:cubicBezTo>
                  <a:pt x="26206" y="280547"/>
                  <a:pt x="26583" y="279882"/>
                  <a:pt x="19050" y="266700"/>
                </a:cubicBezTo>
                <a:cubicBezTo>
                  <a:pt x="16778" y="262724"/>
                  <a:pt x="13290" y="259454"/>
                  <a:pt x="11430" y="255270"/>
                </a:cubicBezTo>
                <a:cubicBezTo>
                  <a:pt x="8168" y="247930"/>
                  <a:pt x="6350" y="240030"/>
                  <a:pt x="3810" y="232410"/>
                </a:cubicBezTo>
                <a:lnTo>
                  <a:pt x="0" y="220980"/>
                </a:lnTo>
                <a:cubicBezTo>
                  <a:pt x="1270" y="213360"/>
                  <a:pt x="2852" y="205785"/>
                  <a:pt x="3810" y="198120"/>
                </a:cubicBezTo>
                <a:cubicBezTo>
                  <a:pt x="5393" y="185455"/>
                  <a:pt x="4750" y="172456"/>
                  <a:pt x="7620" y="160020"/>
                </a:cubicBezTo>
                <a:cubicBezTo>
                  <a:pt x="9929" y="150014"/>
                  <a:pt x="19281" y="145896"/>
                  <a:pt x="26670" y="140970"/>
                </a:cubicBezTo>
                <a:cubicBezTo>
                  <a:pt x="27940" y="137160"/>
                  <a:pt x="28684" y="133132"/>
                  <a:pt x="30480" y="129540"/>
                </a:cubicBezTo>
                <a:cubicBezTo>
                  <a:pt x="35784" y="118931"/>
                  <a:pt x="41104" y="115106"/>
                  <a:pt x="49530" y="106680"/>
                </a:cubicBezTo>
                <a:cubicBezTo>
                  <a:pt x="50800" y="102870"/>
                  <a:pt x="51112" y="98592"/>
                  <a:pt x="53340" y="95250"/>
                </a:cubicBezTo>
                <a:cubicBezTo>
                  <a:pt x="61494" y="83019"/>
                  <a:pt x="64217" y="84004"/>
                  <a:pt x="76200" y="80010"/>
                </a:cubicBezTo>
                <a:cubicBezTo>
                  <a:pt x="89045" y="60742"/>
                  <a:pt x="76847" y="73972"/>
                  <a:pt x="95250" y="64770"/>
                </a:cubicBezTo>
                <a:cubicBezTo>
                  <a:pt x="99346" y="62722"/>
                  <a:pt x="102704" y="59422"/>
                  <a:pt x="106680" y="57150"/>
                </a:cubicBezTo>
                <a:cubicBezTo>
                  <a:pt x="111611" y="54332"/>
                  <a:pt x="116989" y="52348"/>
                  <a:pt x="121920" y="49530"/>
                </a:cubicBezTo>
                <a:cubicBezTo>
                  <a:pt x="125896" y="47258"/>
                  <a:pt x="129141" y="43714"/>
                  <a:pt x="133350" y="41910"/>
                </a:cubicBezTo>
                <a:cubicBezTo>
                  <a:pt x="138163" y="39847"/>
                  <a:pt x="143510" y="39370"/>
                  <a:pt x="148590" y="38100"/>
                </a:cubicBezTo>
                <a:cubicBezTo>
                  <a:pt x="149860" y="34290"/>
                  <a:pt x="149891" y="29806"/>
                  <a:pt x="152400" y="26670"/>
                </a:cubicBezTo>
                <a:cubicBezTo>
                  <a:pt x="155261" y="23094"/>
                  <a:pt x="160312" y="21981"/>
                  <a:pt x="163830" y="19050"/>
                </a:cubicBezTo>
                <a:cubicBezTo>
                  <a:pt x="186999" y="-258"/>
                  <a:pt x="162300" y="14100"/>
                  <a:pt x="190500" y="0"/>
                </a:cubicBezTo>
                <a:cubicBezTo>
                  <a:pt x="226060" y="1270"/>
                  <a:pt x="261763" y="383"/>
                  <a:pt x="297180" y="3810"/>
                </a:cubicBezTo>
                <a:cubicBezTo>
                  <a:pt x="305402" y="4606"/>
                  <a:pt x="314423" y="19739"/>
                  <a:pt x="320040" y="22860"/>
                </a:cubicBezTo>
                <a:cubicBezTo>
                  <a:pt x="327061" y="26761"/>
                  <a:pt x="342900" y="30480"/>
                  <a:pt x="342900" y="30480"/>
                </a:cubicBezTo>
                <a:cubicBezTo>
                  <a:pt x="352375" y="36797"/>
                  <a:pt x="358521" y="41577"/>
                  <a:pt x="369570" y="45720"/>
                </a:cubicBezTo>
                <a:cubicBezTo>
                  <a:pt x="374473" y="47559"/>
                  <a:pt x="379775" y="48091"/>
                  <a:pt x="384810" y="49530"/>
                </a:cubicBezTo>
                <a:cubicBezTo>
                  <a:pt x="388672" y="50633"/>
                  <a:pt x="392430" y="52070"/>
                  <a:pt x="396240" y="53340"/>
                </a:cubicBezTo>
                <a:cubicBezTo>
                  <a:pt x="416560" y="83820"/>
                  <a:pt x="389890" y="46990"/>
                  <a:pt x="415290" y="72390"/>
                </a:cubicBezTo>
                <a:cubicBezTo>
                  <a:pt x="437303" y="94403"/>
                  <a:pt x="406252" y="73404"/>
                  <a:pt x="434340" y="95250"/>
                </a:cubicBezTo>
                <a:cubicBezTo>
                  <a:pt x="441569" y="100873"/>
                  <a:pt x="449580" y="105410"/>
                  <a:pt x="457200" y="110490"/>
                </a:cubicBezTo>
                <a:cubicBezTo>
                  <a:pt x="461010" y="113030"/>
                  <a:pt x="464286" y="116662"/>
                  <a:pt x="468630" y="118110"/>
                </a:cubicBezTo>
                <a:lnTo>
                  <a:pt x="480060" y="121920"/>
                </a:lnTo>
                <a:cubicBezTo>
                  <a:pt x="483870" y="124460"/>
                  <a:pt x="488252" y="126302"/>
                  <a:pt x="491490" y="129540"/>
                </a:cubicBezTo>
                <a:cubicBezTo>
                  <a:pt x="516890" y="154940"/>
                  <a:pt x="480060" y="128270"/>
                  <a:pt x="510540" y="148590"/>
                </a:cubicBezTo>
                <a:lnTo>
                  <a:pt x="518160" y="171450"/>
                </a:lnTo>
                <a:cubicBezTo>
                  <a:pt x="519608" y="175794"/>
                  <a:pt x="523732" y="178784"/>
                  <a:pt x="525780" y="182880"/>
                </a:cubicBezTo>
                <a:cubicBezTo>
                  <a:pt x="527576" y="186472"/>
                  <a:pt x="528320" y="190500"/>
                  <a:pt x="529590" y="194310"/>
                </a:cubicBezTo>
                <a:cubicBezTo>
                  <a:pt x="530860" y="207010"/>
                  <a:pt x="530530" y="219974"/>
                  <a:pt x="533400" y="232410"/>
                </a:cubicBezTo>
                <a:cubicBezTo>
                  <a:pt x="534430" y="236872"/>
                  <a:pt x="539412" y="239553"/>
                  <a:pt x="541020" y="243840"/>
                </a:cubicBezTo>
                <a:cubicBezTo>
                  <a:pt x="543294" y="249903"/>
                  <a:pt x="543705" y="256513"/>
                  <a:pt x="544830" y="262890"/>
                </a:cubicBezTo>
                <a:cubicBezTo>
                  <a:pt x="547515" y="278105"/>
                  <a:pt x="552450" y="308610"/>
                  <a:pt x="552450" y="308610"/>
                </a:cubicBezTo>
                <a:cubicBezTo>
                  <a:pt x="551137" y="319117"/>
                  <a:pt x="550703" y="338774"/>
                  <a:pt x="544830" y="350520"/>
                </a:cubicBezTo>
                <a:cubicBezTo>
                  <a:pt x="542782" y="354616"/>
                  <a:pt x="539258" y="357854"/>
                  <a:pt x="537210" y="361950"/>
                </a:cubicBezTo>
                <a:cubicBezTo>
                  <a:pt x="535414" y="365542"/>
                  <a:pt x="535196" y="369788"/>
                  <a:pt x="533400" y="373380"/>
                </a:cubicBezTo>
                <a:cubicBezTo>
                  <a:pt x="531352" y="377476"/>
                  <a:pt x="527640" y="380626"/>
                  <a:pt x="525780" y="384810"/>
                </a:cubicBezTo>
                <a:cubicBezTo>
                  <a:pt x="522518" y="392150"/>
                  <a:pt x="525780" y="405130"/>
                  <a:pt x="518160" y="407670"/>
                </a:cubicBezTo>
                <a:cubicBezTo>
                  <a:pt x="505525" y="411882"/>
                  <a:pt x="518160" y="413385"/>
                  <a:pt x="514350" y="41529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56" name="フリーフォーム 155"/>
          <p:cNvSpPr/>
          <p:nvPr/>
        </p:nvSpPr>
        <p:spPr>
          <a:xfrm>
            <a:off x="988482" y="2823294"/>
            <a:ext cx="552450" cy="468630"/>
          </a:xfrm>
          <a:custGeom>
            <a:avLst/>
            <a:gdLst>
              <a:gd name="connsiteX0" fmla="*/ 514350 w 552450"/>
              <a:gd name="connsiteY0" fmla="*/ 415290 h 468630"/>
              <a:gd name="connsiteX1" fmla="*/ 495300 w 552450"/>
              <a:gd name="connsiteY1" fmla="*/ 419100 h 468630"/>
              <a:gd name="connsiteX2" fmla="*/ 472440 w 552450"/>
              <a:gd name="connsiteY2" fmla="*/ 426720 h 468630"/>
              <a:gd name="connsiteX3" fmla="*/ 464820 w 552450"/>
              <a:gd name="connsiteY3" fmla="*/ 438150 h 468630"/>
              <a:gd name="connsiteX4" fmla="*/ 453390 w 552450"/>
              <a:gd name="connsiteY4" fmla="*/ 441960 h 468630"/>
              <a:gd name="connsiteX5" fmla="*/ 438150 w 552450"/>
              <a:gd name="connsiteY5" fmla="*/ 449580 h 468630"/>
              <a:gd name="connsiteX6" fmla="*/ 403860 w 552450"/>
              <a:gd name="connsiteY6" fmla="*/ 461010 h 468630"/>
              <a:gd name="connsiteX7" fmla="*/ 392430 w 552450"/>
              <a:gd name="connsiteY7" fmla="*/ 464820 h 468630"/>
              <a:gd name="connsiteX8" fmla="*/ 365760 w 552450"/>
              <a:gd name="connsiteY8" fmla="*/ 468630 h 468630"/>
              <a:gd name="connsiteX9" fmla="*/ 266700 w 552450"/>
              <a:gd name="connsiteY9" fmla="*/ 464820 h 468630"/>
              <a:gd name="connsiteX10" fmla="*/ 232410 w 552450"/>
              <a:gd name="connsiteY10" fmla="*/ 453390 h 468630"/>
              <a:gd name="connsiteX11" fmla="*/ 220980 w 552450"/>
              <a:gd name="connsiteY11" fmla="*/ 449580 h 468630"/>
              <a:gd name="connsiteX12" fmla="*/ 194310 w 552450"/>
              <a:gd name="connsiteY12" fmla="*/ 434340 h 468630"/>
              <a:gd name="connsiteX13" fmla="*/ 182880 w 552450"/>
              <a:gd name="connsiteY13" fmla="*/ 426720 h 468630"/>
              <a:gd name="connsiteX14" fmla="*/ 171450 w 552450"/>
              <a:gd name="connsiteY14" fmla="*/ 411480 h 468630"/>
              <a:gd name="connsiteX15" fmla="*/ 144780 w 552450"/>
              <a:gd name="connsiteY15" fmla="*/ 400050 h 468630"/>
              <a:gd name="connsiteX16" fmla="*/ 121920 w 552450"/>
              <a:gd name="connsiteY16" fmla="*/ 384810 h 468630"/>
              <a:gd name="connsiteX17" fmla="*/ 110490 w 552450"/>
              <a:gd name="connsiteY17" fmla="*/ 373380 h 468630"/>
              <a:gd name="connsiteX18" fmla="*/ 95250 w 552450"/>
              <a:gd name="connsiteY18" fmla="*/ 350520 h 468630"/>
              <a:gd name="connsiteX19" fmla="*/ 80010 w 552450"/>
              <a:gd name="connsiteY19" fmla="*/ 346710 h 468630"/>
              <a:gd name="connsiteX20" fmla="*/ 57150 w 552450"/>
              <a:gd name="connsiteY20" fmla="*/ 327660 h 468630"/>
              <a:gd name="connsiteX21" fmla="*/ 30480 w 552450"/>
              <a:gd name="connsiteY21" fmla="*/ 293370 h 468630"/>
              <a:gd name="connsiteX22" fmla="*/ 19050 w 552450"/>
              <a:gd name="connsiteY22" fmla="*/ 266700 h 468630"/>
              <a:gd name="connsiteX23" fmla="*/ 11430 w 552450"/>
              <a:gd name="connsiteY23" fmla="*/ 255270 h 468630"/>
              <a:gd name="connsiteX24" fmla="*/ 3810 w 552450"/>
              <a:gd name="connsiteY24" fmla="*/ 232410 h 468630"/>
              <a:gd name="connsiteX25" fmla="*/ 0 w 552450"/>
              <a:gd name="connsiteY25" fmla="*/ 220980 h 468630"/>
              <a:gd name="connsiteX26" fmla="*/ 3810 w 552450"/>
              <a:gd name="connsiteY26" fmla="*/ 198120 h 468630"/>
              <a:gd name="connsiteX27" fmla="*/ 7620 w 552450"/>
              <a:gd name="connsiteY27" fmla="*/ 160020 h 468630"/>
              <a:gd name="connsiteX28" fmla="*/ 26670 w 552450"/>
              <a:gd name="connsiteY28" fmla="*/ 140970 h 468630"/>
              <a:gd name="connsiteX29" fmla="*/ 30480 w 552450"/>
              <a:gd name="connsiteY29" fmla="*/ 129540 h 468630"/>
              <a:gd name="connsiteX30" fmla="*/ 49530 w 552450"/>
              <a:gd name="connsiteY30" fmla="*/ 106680 h 468630"/>
              <a:gd name="connsiteX31" fmla="*/ 53340 w 552450"/>
              <a:gd name="connsiteY31" fmla="*/ 95250 h 468630"/>
              <a:gd name="connsiteX32" fmla="*/ 76200 w 552450"/>
              <a:gd name="connsiteY32" fmla="*/ 80010 h 468630"/>
              <a:gd name="connsiteX33" fmla="*/ 95250 w 552450"/>
              <a:gd name="connsiteY33" fmla="*/ 64770 h 468630"/>
              <a:gd name="connsiteX34" fmla="*/ 106680 w 552450"/>
              <a:gd name="connsiteY34" fmla="*/ 57150 h 468630"/>
              <a:gd name="connsiteX35" fmla="*/ 121920 w 552450"/>
              <a:gd name="connsiteY35" fmla="*/ 49530 h 468630"/>
              <a:gd name="connsiteX36" fmla="*/ 133350 w 552450"/>
              <a:gd name="connsiteY36" fmla="*/ 41910 h 468630"/>
              <a:gd name="connsiteX37" fmla="*/ 148590 w 552450"/>
              <a:gd name="connsiteY37" fmla="*/ 38100 h 468630"/>
              <a:gd name="connsiteX38" fmla="*/ 152400 w 552450"/>
              <a:gd name="connsiteY38" fmla="*/ 26670 h 468630"/>
              <a:gd name="connsiteX39" fmla="*/ 163830 w 552450"/>
              <a:gd name="connsiteY39" fmla="*/ 19050 h 468630"/>
              <a:gd name="connsiteX40" fmla="*/ 190500 w 552450"/>
              <a:gd name="connsiteY40" fmla="*/ 0 h 468630"/>
              <a:gd name="connsiteX41" fmla="*/ 297180 w 552450"/>
              <a:gd name="connsiteY41" fmla="*/ 3810 h 468630"/>
              <a:gd name="connsiteX42" fmla="*/ 320040 w 552450"/>
              <a:gd name="connsiteY42" fmla="*/ 22860 h 468630"/>
              <a:gd name="connsiteX43" fmla="*/ 342900 w 552450"/>
              <a:gd name="connsiteY43" fmla="*/ 30480 h 468630"/>
              <a:gd name="connsiteX44" fmla="*/ 369570 w 552450"/>
              <a:gd name="connsiteY44" fmla="*/ 45720 h 468630"/>
              <a:gd name="connsiteX45" fmla="*/ 384810 w 552450"/>
              <a:gd name="connsiteY45" fmla="*/ 49530 h 468630"/>
              <a:gd name="connsiteX46" fmla="*/ 396240 w 552450"/>
              <a:gd name="connsiteY46" fmla="*/ 53340 h 468630"/>
              <a:gd name="connsiteX47" fmla="*/ 415290 w 552450"/>
              <a:gd name="connsiteY47" fmla="*/ 72390 h 468630"/>
              <a:gd name="connsiteX48" fmla="*/ 434340 w 552450"/>
              <a:gd name="connsiteY48" fmla="*/ 95250 h 468630"/>
              <a:gd name="connsiteX49" fmla="*/ 457200 w 552450"/>
              <a:gd name="connsiteY49" fmla="*/ 110490 h 468630"/>
              <a:gd name="connsiteX50" fmla="*/ 468630 w 552450"/>
              <a:gd name="connsiteY50" fmla="*/ 118110 h 468630"/>
              <a:gd name="connsiteX51" fmla="*/ 480060 w 552450"/>
              <a:gd name="connsiteY51" fmla="*/ 121920 h 468630"/>
              <a:gd name="connsiteX52" fmla="*/ 491490 w 552450"/>
              <a:gd name="connsiteY52" fmla="*/ 129540 h 468630"/>
              <a:gd name="connsiteX53" fmla="*/ 510540 w 552450"/>
              <a:gd name="connsiteY53" fmla="*/ 148590 h 468630"/>
              <a:gd name="connsiteX54" fmla="*/ 518160 w 552450"/>
              <a:gd name="connsiteY54" fmla="*/ 171450 h 468630"/>
              <a:gd name="connsiteX55" fmla="*/ 525780 w 552450"/>
              <a:gd name="connsiteY55" fmla="*/ 182880 h 468630"/>
              <a:gd name="connsiteX56" fmla="*/ 529590 w 552450"/>
              <a:gd name="connsiteY56" fmla="*/ 194310 h 468630"/>
              <a:gd name="connsiteX57" fmla="*/ 533400 w 552450"/>
              <a:gd name="connsiteY57" fmla="*/ 232410 h 468630"/>
              <a:gd name="connsiteX58" fmla="*/ 541020 w 552450"/>
              <a:gd name="connsiteY58" fmla="*/ 243840 h 468630"/>
              <a:gd name="connsiteX59" fmla="*/ 544830 w 552450"/>
              <a:gd name="connsiteY59" fmla="*/ 262890 h 468630"/>
              <a:gd name="connsiteX60" fmla="*/ 552450 w 552450"/>
              <a:gd name="connsiteY60" fmla="*/ 308610 h 468630"/>
              <a:gd name="connsiteX61" fmla="*/ 544830 w 552450"/>
              <a:gd name="connsiteY61" fmla="*/ 350520 h 468630"/>
              <a:gd name="connsiteX62" fmla="*/ 537210 w 552450"/>
              <a:gd name="connsiteY62" fmla="*/ 361950 h 468630"/>
              <a:gd name="connsiteX63" fmla="*/ 533400 w 552450"/>
              <a:gd name="connsiteY63" fmla="*/ 373380 h 468630"/>
              <a:gd name="connsiteX64" fmla="*/ 525780 w 552450"/>
              <a:gd name="connsiteY64" fmla="*/ 384810 h 468630"/>
              <a:gd name="connsiteX65" fmla="*/ 518160 w 552450"/>
              <a:gd name="connsiteY65" fmla="*/ 407670 h 468630"/>
              <a:gd name="connsiteX66" fmla="*/ 514350 w 552450"/>
              <a:gd name="connsiteY66" fmla="*/ 415290 h 46863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</a:cxnLst>
            <a:rect l="l" t="t" r="r" b="b"/>
            <a:pathLst>
              <a:path w="552450" h="468630">
                <a:moveTo>
                  <a:pt x="514350" y="415290"/>
                </a:moveTo>
                <a:cubicBezTo>
                  <a:pt x="510540" y="417195"/>
                  <a:pt x="501548" y="417396"/>
                  <a:pt x="495300" y="419100"/>
                </a:cubicBezTo>
                <a:cubicBezTo>
                  <a:pt x="487551" y="421213"/>
                  <a:pt x="472440" y="426720"/>
                  <a:pt x="472440" y="426720"/>
                </a:cubicBezTo>
                <a:cubicBezTo>
                  <a:pt x="469900" y="430530"/>
                  <a:pt x="468396" y="435289"/>
                  <a:pt x="464820" y="438150"/>
                </a:cubicBezTo>
                <a:cubicBezTo>
                  <a:pt x="461684" y="440659"/>
                  <a:pt x="457081" y="440378"/>
                  <a:pt x="453390" y="441960"/>
                </a:cubicBezTo>
                <a:cubicBezTo>
                  <a:pt x="448170" y="444197"/>
                  <a:pt x="443423" y="447471"/>
                  <a:pt x="438150" y="449580"/>
                </a:cubicBezTo>
                <a:lnTo>
                  <a:pt x="403860" y="461010"/>
                </a:lnTo>
                <a:cubicBezTo>
                  <a:pt x="400050" y="462280"/>
                  <a:pt x="396406" y="464252"/>
                  <a:pt x="392430" y="464820"/>
                </a:cubicBezTo>
                <a:lnTo>
                  <a:pt x="365760" y="468630"/>
                </a:lnTo>
                <a:cubicBezTo>
                  <a:pt x="332740" y="467360"/>
                  <a:pt x="299600" y="467904"/>
                  <a:pt x="266700" y="464820"/>
                </a:cubicBezTo>
                <a:lnTo>
                  <a:pt x="232410" y="453390"/>
                </a:lnTo>
                <a:lnTo>
                  <a:pt x="220980" y="449580"/>
                </a:lnTo>
                <a:cubicBezTo>
                  <a:pt x="193133" y="431015"/>
                  <a:pt x="228147" y="453676"/>
                  <a:pt x="194310" y="434340"/>
                </a:cubicBezTo>
                <a:cubicBezTo>
                  <a:pt x="190334" y="432068"/>
                  <a:pt x="186690" y="429260"/>
                  <a:pt x="182880" y="426720"/>
                </a:cubicBezTo>
                <a:cubicBezTo>
                  <a:pt x="179070" y="421640"/>
                  <a:pt x="176271" y="415613"/>
                  <a:pt x="171450" y="411480"/>
                </a:cubicBezTo>
                <a:cubicBezTo>
                  <a:pt x="165458" y="406344"/>
                  <a:pt x="152519" y="402630"/>
                  <a:pt x="144780" y="400050"/>
                </a:cubicBezTo>
                <a:cubicBezTo>
                  <a:pt x="108317" y="363587"/>
                  <a:pt x="155003" y="406866"/>
                  <a:pt x="121920" y="384810"/>
                </a:cubicBezTo>
                <a:cubicBezTo>
                  <a:pt x="117437" y="381821"/>
                  <a:pt x="113798" y="377633"/>
                  <a:pt x="110490" y="373380"/>
                </a:cubicBezTo>
                <a:cubicBezTo>
                  <a:pt x="104867" y="366151"/>
                  <a:pt x="104135" y="352741"/>
                  <a:pt x="95250" y="350520"/>
                </a:cubicBezTo>
                <a:lnTo>
                  <a:pt x="80010" y="346710"/>
                </a:lnTo>
                <a:cubicBezTo>
                  <a:pt x="69850" y="339937"/>
                  <a:pt x="65048" y="337815"/>
                  <a:pt x="57150" y="327660"/>
                </a:cubicBezTo>
                <a:cubicBezTo>
                  <a:pt x="25250" y="286645"/>
                  <a:pt x="56429" y="319319"/>
                  <a:pt x="30480" y="293370"/>
                </a:cubicBezTo>
                <a:cubicBezTo>
                  <a:pt x="26206" y="280547"/>
                  <a:pt x="26583" y="279882"/>
                  <a:pt x="19050" y="266700"/>
                </a:cubicBezTo>
                <a:cubicBezTo>
                  <a:pt x="16778" y="262724"/>
                  <a:pt x="13290" y="259454"/>
                  <a:pt x="11430" y="255270"/>
                </a:cubicBezTo>
                <a:cubicBezTo>
                  <a:pt x="8168" y="247930"/>
                  <a:pt x="6350" y="240030"/>
                  <a:pt x="3810" y="232410"/>
                </a:cubicBezTo>
                <a:lnTo>
                  <a:pt x="0" y="220980"/>
                </a:lnTo>
                <a:cubicBezTo>
                  <a:pt x="1270" y="213360"/>
                  <a:pt x="2852" y="205785"/>
                  <a:pt x="3810" y="198120"/>
                </a:cubicBezTo>
                <a:cubicBezTo>
                  <a:pt x="5393" y="185455"/>
                  <a:pt x="4750" y="172456"/>
                  <a:pt x="7620" y="160020"/>
                </a:cubicBezTo>
                <a:cubicBezTo>
                  <a:pt x="9929" y="150014"/>
                  <a:pt x="19281" y="145896"/>
                  <a:pt x="26670" y="140970"/>
                </a:cubicBezTo>
                <a:cubicBezTo>
                  <a:pt x="27940" y="137160"/>
                  <a:pt x="28684" y="133132"/>
                  <a:pt x="30480" y="129540"/>
                </a:cubicBezTo>
                <a:cubicBezTo>
                  <a:pt x="35784" y="118931"/>
                  <a:pt x="41104" y="115106"/>
                  <a:pt x="49530" y="106680"/>
                </a:cubicBezTo>
                <a:cubicBezTo>
                  <a:pt x="50800" y="102870"/>
                  <a:pt x="51112" y="98592"/>
                  <a:pt x="53340" y="95250"/>
                </a:cubicBezTo>
                <a:cubicBezTo>
                  <a:pt x="61494" y="83019"/>
                  <a:pt x="64217" y="84004"/>
                  <a:pt x="76200" y="80010"/>
                </a:cubicBezTo>
                <a:cubicBezTo>
                  <a:pt x="89045" y="60742"/>
                  <a:pt x="76847" y="73972"/>
                  <a:pt x="95250" y="64770"/>
                </a:cubicBezTo>
                <a:cubicBezTo>
                  <a:pt x="99346" y="62722"/>
                  <a:pt x="102704" y="59422"/>
                  <a:pt x="106680" y="57150"/>
                </a:cubicBezTo>
                <a:cubicBezTo>
                  <a:pt x="111611" y="54332"/>
                  <a:pt x="116989" y="52348"/>
                  <a:pt x="121920" y="49530"/>
                </a:cubicBezTo>
                <a:cubicBezTo>
                  <a:pt x="125896" y="47258"/>
                  <a:pt x="129141" y="43714"/>
                  <a:pt x="133350" y="41910"/>
                </a:cubicBezTo>
                <a:cubicBezTo>
                  <a:pt x="138163" y="39847"/>
                  <a:pt x="143510" y="39370"/>
                  <a:pt x="148590" y="38100"/>
                </a:cubicBezTo>
                <a:cubicBezTo>
                  <a:pt x="149860" y="34290"/>
                  <a:pt x="149891" y="29806"/>
                  <a:pt x="152400" y="26670"/>
                </a:cubicBezTo>
                <a:cubicBezTo>
                  <a:pt x="155261" y="23094"/>
                  <a:pt x="160312" y="21981"/>
                  <a:pt x="163830" y="19050"/>
                </a:cubicBezTo>
                <a:cubicBezTo>
                  <a:pt x="186999" y="-258"/>
                  <a:pt x="162300" y="14100"/>
                  <a:pt x="190500" y="0"/>
                </a:cubicBezTo>
                <a:cubicBezTo>
                  <a:pt x="226060" y="1270"/>
                  <a:pt x="261763" y="383"/>
                  <a:pt x="297180" y="3810"/>
                </a:cubicBezTo>
                <a:cubicBezTo>
                  <a:pt x="305402" y="4606"/>
                  <a:pt x="314423" y="19739"/>
                  <a:pt x="320040" y="22860"/>
                </a:cubicBezTo>
                <a:cubicBezTo>
                  <a:pt x="327061" y="26761"/>
                  <a:pt x="342900" y="30480"/>
                  <a:pt x="342900" y="30480"/>
                </a:cubicBezTo>
                <a:cubicBezTo>
                  <a:pt x="352375" y="36797"/>
                  <a:pt x="358521" y="41577"/>
                  <a:pt x="369570" y="45720"/>
                </a:cubicBezTo>
                <a:cubicBezTo>
                  <a:pt x="374473" y="47559"/>
                  <a:pt x="379775" y="48091"/>
                  <a:pt x="384810" y="49530"/>
                </a:cubicBezTo>
                <a:cubicBezTo>
                  <a:pt x="388672" y="50633"/>
                  <a:pt x="392430" y="52070"/>
                  <a:pt x="396240" y="53340"/>
                </a:cubicBezTo>
                <a:cubicBezTo>
                  <a:pt x="416560" y="83820"/>
                  <a:pt x="389890" y="46990"/>
                  <a:pt x="415290" y="72390"/>
                </a:cubicBezTo>
                <a:cubicBezTo>
                  <a:pt x="437303" y="94403"/>
                  <a:pt x="406252" y="73404"/>
                  <a:pt x="434340" y="95250"/>
                </a:cubicBezTo>
                <a:cubicBezTo>
                  <a:pt x="441569" y="100873"/>
                  <a:pt x="449580" y="105410"/>
                  <a:pt x="457200" y="110490"/>
                </a:cubicBezTo>
                <a:cubicBezTo>
                  <a:pt x="461010" y="113030"/>
                  <a:pt x="464286" y="116662"/>
                  <a:pt x="468630" y="118110"/>
                </a:cubicBezTo>
                <a:lnTo>
                  <a:pt x="480060" y="121920"/>
                </a:lnTo>
                <a:cubicBezTo>
                  <a:pt x="483870" y="124460"/>
                  <a:pt x="488252" y="126302"/>
                  <a:pt x="491490" y="129540"/>
                </a:cubicBezTo>
                <a:cubicBezTo>
                  <a:pt x="516890" y="154940"/>
                  <a:pt x="480060" y="128270"/>
                  <a:pt x="510540" y="148590"/>
                </a:cubicBezTo>
                <a:lnTo>
                  <a:pt x="518160" y="171450"/>
                </a:lnTo>
                <a:cubicBezTo>
                  <a:pt x="519608" y="175794"/>
                  <a:pt x="523732" y="178784"/>
                  <a:pt x="525780" y="182880"/>
                </a:cubicBezTo>
                <a:cubicBezTo>
                  <a:pt x="527576" y="186472"/>
                  <a:pt x="528320" y="190500"/>
                  <a:pt x="529590" y="194310"/>
                </a:cubicBezTo>
                <a:cubicBezTo>
                  <a:pt x="530860" y="207010"/>
                  <a:pt x="530530" y="219974"/>
                  <a:pt x="533400" y="232410"/>
                </a:cubicBezTo>
                <a:cubicBezTo>
                  <a:pt x="534430" y="236872"/>
                  <a:pt x="539412" y="239553"/>
                  <a:pt x="541020" y="243840"/>
                </a:cubicBezTo>
                <a:cubicBezTo>
                  <a:pt x="543294" y="249903"/>
                  <a:pt x="543705" y="256513"/>
                  <a:pt x="544830" y="262890"/>
                </a:cubicBezTo>
                <a:cubicBezTo>
                  <a:pt x="547515" y="278105"/>
                  <a:pt x="552450" y="308610"/>
                  <a:pt x="552450" y="308610"/>
                </a:cubicBezTo>
                <a:cubicBezTo>
                  <a:pt x="551137" y="319117"/>
                  <a:pt x="550703" y="338774"/>
                  <a:pt x="544830" y="350520"/>
                </a:cubicBezTo>
                <a:cubicBezTo>
                  <a:pt x="542782" y="354616"/>
                  <a:pt x="539258" y="357854"/>
                  <a:pt x="537210" y="361950"/>
                </a:cubicBezTo>
                <a:cubicBezTo>
                  <a:pt x="535414" y="365542"/>
                  <a:pt x="535196" y="369788"/>
                  <a:pt x="533400" y="373380"/>
                </a:cubicBezTo>
                <a:cubicBezTo>
                  <a:pt x="531352" y="377476"/>
                  <a:pt x="527640" y="380626"/>
                  <a:pt x="525780" y="384810"/>
                </a:cubicBezTo>
                <a:cubicBezTo>
                  <a:pt x="522518" y="392150"/>
                  <a:pt x="525780" y="405130"/>
                  <a:pt x="518160" y="407670"/>
                </a:cubicBezTo>
                <a:cubicBezTo>
                  <a:pt x="505525" y="411882"/>
                  <a:pt x="518160" y="413385"/>
                  <a:pt x="514350" y="41529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57" name="フリーフォーム 156"/>
          <p:cNvSpPr/>
          <p:nvPr/>
        </p:nvSpPr>
        <p:spPr>
          <a:xfrm>
            <a:off x="2387114" y="4277558"/>
            <a:ext cx="491506" cy="419100"/>
          </a:xfrm>
          <a:custGeom>
            <a:avLst/>
            <a:gdLst>
              <a:gd name="connsiteX0" fmla="*/ 491490 w 491506"/>
              <a:gd name="connsiteY0" fmla="*/ 167640 h 419100"/>
              <a:gd name="connsiteX1" fmla="*/ 472440 w 491506"/>
              <a:gd name="connsiteY1" fmla="*/ 186690 h 419100"/>
              <a:gd name="connsiteX2" fmla="*/ 468630 w 491506"/>
              <a:gd name="connsiteY2" fmla="*/ 201930 h 419100"/>
              <a:gd name="connsiteX3" fmla="*/ 461010 w 491506"/>
              <a:gd name="connsiteY3" fmla="*/ 213360 h 419100"/>
              <a:gd name="connsiteX4" fmla="*/ 449580 w 491506"/>
              <a:gd name="connsiteY4" fmla="*/ 240030 h 419100"/>
              <a:gd name="connsiteX5" fmla="*/ 434340 w 491506"/>
              <a:gd name="connsiteY5" fmla="*/ 262890 h 419100"/>
              <a:gd name="connsiteX6" fmla="*/ 411480 w 491506"/>
              <a:gd name="connsiteY6" fmla="*/ 297180 h 419100"/>
              <a:gd name="connsiteX7" fmla="*/ 400050 w 491506"/>
              <a:gd name="connsiteY7" fmla="*/ 308610 h 419100"/>
              <a:gd name="connsiteX8" fmla="*/ 373380 w 491506"/>
              <a:gd name="connsiteY8" fmla="*/ 335280 h 419100"/>
              <a:gd name="connsiteX9" fmla="*/ 316230 w 491506"/>
              <a:gd name="connsiteY9" fmla="*/ 373380 h 419100"/>
              <a:gd name="connsiteX10" fmla="*/ 304800 w 491506"/>
              <a:gd name="connsiteY10" fmla="*/ 384810 h 419100"/>
              <a:gd name="connsiteX11" fmla="*/ 274320 w 491506"/>
              <a:gd name="connsiteY11" fmla="*/ 396240 h 419100"/>
              <a:gd name="connsiteX12" fmla="*/ 262890 w 491506"/>
              <a:gd name="connsiteY12" fmla="*/ 400050 h 419100"/>
              <a:gd name="connsiteX13" fmla="*/ 247650 w 491506"/>
              <a:gd name="connsiteY13" fmla="*/ 403860 h 419100"/>
              <a:gd name="connsiteX14" fmla="*/ 220980 w 491506"/>
              <a:gd name="connsiteY14" fmla="*/ 411480 h 419100"/>
              <a:gd name="connsiteX15" fmla="*/ 175260 w 491506"/>
              <a:gd name="connsiteY15" fmla="*/ 419100 h 419100"/>
              <a:gd name="connsiteX16" fmla="*/ 114300 w 491506"/>
              <a:gd name="connsiteY16" fmla="*/ 415290 h 419100"/>
              <a:gd name="connsiteX17" fmla="*/ 95250 w 491506"/>
              <a:gd name="connsiteY17" fmla="*/ 411480 h 419100"/>
              <a:gd name="connsiteX18" fmla="*/ 68580 w 491506"/>
              <a:gd name="connsiteY18" fmla="*/ 407670 h 419100"/>
              <a:gd name="connsiteX19" fmla="*/ 45720 w 491506"/>
              <a:gd name="connsiteY19" fmla="*/ 396240 h 419100"/>
              <a:gd name="connsiteX20" fmla="*/ 26670 w 491506"/>
              <a:gd name="connsiteY20" fmla="*/ 377190 h 419100"/>
              <a:gd name="connsiteX21" fmla="*/ 11430 w 491506"/>
              <a:gd name="connsiteY21" fmla="*/ 361950 h 419100"/>
              <a:gd name="connsiteX22" fmla="*/ 3810 w 491506"/>
              <a:gd name="connsiteY22" fmla="*/ 350520 h 419100"/>
              <a:gd name="connsiteX23" fmla="*/ 0 w 491506"/>
              <a:gd name="connsiteY23" fmla="*/ 335280 h 419100"/>
              <a:gd name="connsiteX24" fmla="*/ 3810 w 491506"/>
              <a:gd name="connsiteY24" fmla="*/ 278130 h 419100"/>
              <a:gd name="connsiteX25" fmla="*/ 15240 w 491506"/>
              <a:gd name="connsiteY25" fmla="*/ 243840 h 419100"/>
              <a:gd name="connsiteX26" fmla="*/ 22860 w 491506"/>
              <a:gd name="connsiteY26" fmla="*/ 232410 h 419100"/>
              <a:gd name="connsiteX27" fmla="*/ 30480 w 491506"/>
              <a:gd name="connsiteY27" fmla="*/ 201930 h 419100"/>
              <a:gd name="connsiteX28" fmla="*/ 45720 w 491506"/>
              <a:gd name="connsiteY28" fmla="*/ 179070 h 419100"/>
              <a:gd name="connsiteX29" fmla="*/ 57150 w 491506"/>
              <a:gd name="connsiteY29" fmla="*/ 171450 h 419100"/>
              <a:gd name="connsiteX30" fmla="*/ 60960 w 491506"/>
              <a:gd name="connsiteY30" fmla="*/ 160020 h 419100"/>
              <a:gd name="connsiteX31" fmla="*/ 64770 w 491506"/>
              <a:gd name="connsiteY31" fmla="*/ 121920 h 419100"/>
              <a:gd name="connsiteX32" fmla="*/ 68580 w 491506"/>
              <a:gd name="connsiteY32" fmla="*/ 110490 h 419100"/>
              <a:gd name="connsiteX33" fmla="*/ 80010 w 491506"/>
              <a:gd name="connsiteY33" fmla="*/ 99060 h 419100"/>
              <a:gd name="connsiteX34" fmla="*/ 91440 w 491506"/>
              <a:gd name="connsiteY34" fmla="*/ 95250 h 419100"/>
              <a:gd name="connsiteX35" fmla="*/ 114300 w 491506"/>
              <a:gd name="connsiteY35" fmla="*/ 76200 h 419100"/>
              <a:gd name="connsiteX36" fmla="*/ 118110 w 491506"/>
              <a:gd name="connsiteY36" fmla="*/ 64770 h 419100"/>
              <a:gd name="connsiteX37" fmla="*/ 125730 w 491506"/>
              <a:gd name="connsiteY37" fmla="*/ 53340 h 419100"/>
              <a:gd name="connsiteX38" fmla="*/ 140970 w 491506"/>
              <a:gd name="connsiteY38" fmla="*/ 30480 h 419100"/>
              <a:gd name="connsiteX39" fmla="*/ 175260 w 491506"/>
              <a:gd name="connsiteY39" fmla="*/ 15240 h 419100"/>
              <a:gd name="connsiteX40" fmla="*/ 186690 w 491506"/>
              <a:gd name="connsiteY40" fmla="*/ 11430 h 419100"/>
              <a:gd name="connsiteX41" fmla="*/ 198120 w 491506"/>
              <a:gd name="connsiteY41" fmla="*/ 7620 h 419100"/>
              <a:gd name="connsiteX42" fmla="*/ 213360 w 491506"/>
              <a:gd name="connsiteY42" fmla="*/ 3810 h 419100"/>
              <a:gd name="connsiteX43" fmla="*/ 270510 w 491506"/>
              <a:gd name="connsiteY43" fmla="*/ 0 h 419100"/>
              <a:gd name="connsiteX44" fmla="*/ 396240 w 491506"/>
              <a:gd name="connsiteY44" fmla="*/ 3810 h 419100"/>
              <a:gd name="connsiteX45" fmla="*/ 419100 w 491506"/>
              <a:gd name="connsiteY45" fmla="*/ 11430 h 419100"/>
              <a:gd name="connsiteX46" fmla="*/ 449580 w 491506"/>
              <a:gd name="connsiteY46" fmla="*/ 15240 h 419100"/>
              <a:gd name="connsiteX47" fmla="*/ 461010 w 491506"/>
              <a:gd name="connsiteY47" fmla="*/ 22860 h 419100"/>
              <a:gd name="connsiteX48" fmla="*/ 468630 w 491506"/>
              <a:gd name="connsiteY48" fmla="*/ 45720 h 419100"/>
              <a:gd name="connsiteX49" fmla="*/ 472440 w 491506"/>
              <a:gd name="connsiteY49" fmla="*/ 57150 h 419100"/>
              <a:gd name="connsiteX50" fmla="*/ 476250 w 491506"/>
              <a:gd name="connsiteY50" fmla="*/ 68580 h 419100"/>
              <a:gd name="connsiteX51" fmla="*/ 483870 w 491506"/>
              <a:gd name="connsiteY51" fmla="*/ 99060 h 419100"/>
              <a:gd name="connsiteX52" fmla="*/ 491490 w 491506"/>
              <a:gd name="connsiteY52" fmla="*/ 121920 h 419100"/>
              <a:gd name="connsiteX53" fmla="*/ 483870 w 491506"/>
              <a:gd name="connsiteY53" fmla="*/ 175260 h 419100"/>
              <a:gd name="connsiteX54" fmla="*/ 476250 w 491506"/>
              <a:gd name="connsiteY54" fmla="*/ 186690 h 419100"/>
              <a:gd name="connsiteX55" fmla="*/ 491490 w 491506"/>
              <a:gd name="connsiteY55" fmla="*/ 167640 h 4191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</a:cxnLst>
            <a:rect l="l" t="t" r="r" b="b"/>
            <a:pathLst>
              <a:path w="491506" h="419100">
                <a:moveTo>
                  <a:pt x="491490" y="167640"/>
                </a:moveTo>
                <a:cubicBezTo>
                  <a:pt x="490855" y="167640"/>
                  <a:pt x="477421" y="179218"/>
                  <a:pt x="472440" y="186690"/>
                </a:cubicBezTo>
                <a:cubicBezTo>
                  <a:pt x="469535" y="191047"/>
                  <a:pt x="470693" y="197117"/>
                  <a:pt x="468630" y="201930"/>
                </a:cubicBezTo>
                <a:cubicBezTo>
                  <a:pt x="466826" y="206139"/>
                  <a:pt x="463058" y="209264"/>
                  <a:pt x="461010" y="213360"/>
                </a:cubicBezTo>
                <a:cubicBezTo>
                  <a:pt x="445244" y="244892"/>
                  <a:pt x="473364" y="200389"/>
                  <a:pt x="449580" y="240030"/>
                </a:cubicBezTo>
                <a:cubicBezTo>
                  <a:pt x="444868" y="247883"/>
                  <a:pt x="439420" y="255270"/>
                  <a:pt x="434340" y="262890"/>
                </a:cubicBezTo>
                <a:lnTo>
                  <a:pt x="411480" y="297180"/>
                </a:lnTo>
                <a:cubicBezTo>
                  <a:pt x="408491" y="301663"/>
                  <a:pt x="403358" y="304357"/>
                  <a:pt x="400050" y="308610"/>
                </a:cubicBezTo>
                <a:cubicBezTo>
                  <a:pt x="378652" y="336122"/>
                  <a:pt x="395222" y="327999"/>
                  <a:pt x="373380" y="335280"/>
                </a:cubicBezTo>
                <a:lnTo>
                  <a:pt x="316230" y="373380"/>
                </a:lnTo>
                <a:cubicBezTo>
                  <a:pt x="311747" y="376369"/>
                  <a:pt x="309185" y="381678"/>
                  <a:pt x="304800" y="384810"/>
                </a:cubicBezTo>
                <a:cubicBezTo>
                  <a:pt x="292963" y="393265"/>
                  <a:pt x="287615" y="392441"/>
                  <a:pt x="274320" y="396240"/>
                </a:cubicBezTo>
                <a:cubicBezTo>
                  <a:pt x="270458" y="397343"/>
                  <a:pt x="266752" y="398947"/>
                  <a:pt x="262890" y="400050"/>
                </a:cubicBezTo>
                <a:cubicBezTo>
                  <a:pt x="257855" y="401489"/>
                  <a:pt x="252685" y="402421"/>
                  <a:pt x="247650" y="403860"/>
                </a:cubicBezTo>
                <a:cubicBezTo>
                  <a:pt x="225375" y="410224"/>
                  <a:pt x="247779" y="405525"/>
                  <a:pt x="220980" y="411480"/>
                </a:cubicBezTo>
                <a:cubicBezTo>
                  <a:pt x="200924" y="415937"/>
                  <a:pt x="197525" y="415919"/>
                  <a:pt x="175260" y="419100"/>
                </a:cubicBezTo>
                <a:cubicBezTo>
                  <a:pt x="154940" y="417830"/>
                  <a:pt x="134568" y="417220"/>
                  <a:pt x="114300" y="415290"/>
                </a:cubicBezTo>
                <a:cubicBezTo>
                  <a:pt x="107853" y="414676"/>
                  <a:pt x="101638" y="412545"/>
                  <a:pt x="95250" y="411480"/>
                </a:cubicBezTo>
                <a:cubicBezTo>
                  <a:pt x="86392" y="410004"/>
                  <a:pt x="77470" y="408940"/>
                  <a:pt x="68580" y="407670"/>
                </a:cubicBezTo>
                <a:cubicBezTo>
                  <a:pt x="59284" y="404571"/>
                  <a:pt x="53106" y="403626"/>
                  <a:pt x="45720" y="396240"/>
                </a:cubicBezTo>
                <a:cubicBezTo>
                  <a:pt x="20320" y="370840"/>
                  <a:pt x="57150" y="397510"/>
                  <a:pt x="26670" y="377190"/>
                </a:cubicBezTo>
                <a:cubicBezTo>
                  <a:pt x="18357" y="352252"/>
                  <a:pt x="29903" y="376728"/>
                  <a:pt x="11430" y="361950"/>
                </a:cubicBezTo>
                <a:cubicBezTo>
                  <a:pt x="7854" y="359089"/>
                  <a:pt x="6350" y="354330"/>
                  <a:pt x="3810" y="350520"/>
                </a:cubicBezTo>
                <a:cubicBezTo>
                  <a:pt x="2540" y="345440"/>
                  <a:pt x="0" y="340516"/>
                  <a:pt x="0" y="335280"/>
                </a:cubicBezTo>
                <a:cubicBezTo>
                  <a:pt x="0" y="316188"/>
                  <a:pt x="1110" y="297030"/>
                  <a:pt x="3810" y="278130"/>
                </a:cubicBezTo>
                <a:lnTo>
                  <a:pt x="15240" y="243840"/>
                </a:lnTo>
                <a:cubicBezTo>
                  <a:pt x="16688" y="239496"/>
                  <a:pt x="20320" y="236220"/>
                  <a:pt x="22860" y="232410"/>
                </a:cubicBezTo>
                <a:cubicBezTo>
                  <a:pt x="23916" y="227132"/>
                  <a:pt x="26819" y="208520"/>
                  <a:pt x="30480" y="201930"/>
                </a:cubicBezTo>
                <a:cubicBezTo>
                  <a:pt x="34928" y="193924"/>
                  <a:pt x="38100" y="184150"/>
                  <a:pt x="45720" y="179070"/>
                </a:cubicBezTo>
                <a:lnTo>
                  <a:pt x="57150" y="171450"/>
                </a:lnTo>
                <a:cubicBezTo>
                  <a:pt x="58420" y="167640"/>
                  <a:pt x="60349" y="163989"/>
                  <a:pt x="60960" y="160020"/>
                </a:cubicBezTo>
                <a:cubicBezTo>
                  <a:pt x="62901" y="147405"/>
                  <a:pt x="62829" y="134535"/>
                  <a:pt x="64770" y="121920"/>
                </a:cubicBezTo>
                <a:cubicBezTo>
                  <a:pt x="65381" y="117951"/>
                  <a:pt x="66352" y="113832"/>
                  <a:pt x="68580" y="110490"/>
                </a:cubicBezTo>
                <a:cubicBezTo>
                  <a:pt x="71569" y="106007"/>
                  <a:pt x="75527" y="102049"/>
                  <a:pt x="80010" y="99060"/>
                </a:cubicBezTo>
                <a:cubicBezTo>
                  <a:pt x="83352" y="96832"/>
                  <a:pt x="87630" y="96520"/>
                  <a:pt x="91440" y="95250"/>
                </a:cubicBezTo>
                <a:cubicBezTo>
                  <a:pt x="99874" y="89627"/>
                  <a:pt x="108433" y="85001"/>
                  <a:pt x="114300" y="76200"/>
                </a:cubicBezTo>
                <a:cubicBezTo>
                  <a:pt x="116528" y="72858"/>
                  <a:pt x="116314" y="68362"/>
                  <a:pt x="118110" y="64770"/>
                </a:cubicBezTo>
                <a:cubicBezTo>
                  <a:pt x="120158" y="60674"/>
                  <a:pt x="123682" y="57436"/>
                  <a:pt x="125730" y="53340"/>
                </a:cubicBezTo>
                <a:cubicBezTo>
                  <a:pt x="134451" y="35899"/>
                  <a:pt x="122398" y="45957"/>
                  <a:pt x="140970" y="30480"/>
                </a:cubicBezTo>
                <a:cubicBezTo>
                  <a:pt x="153045" y="20417"/>
                  <a:pt x="158647" y="20778"/>
                  <a:pt x="175260" y="15240"/>
                </a:cubicBezTo>
                <a:lnTo>
                  <a:pt x="186690" y="11430"/>
                </a:lnTo>
                <a:cubicBezTo>
                  <a:pt x="190500" y="10160"/>
                  <a:pt x="194224" y="8594"/>
                  <a:pt x="198120" y="7620"/>
                </a:cubicBezTo>
                <a:cubicBezTo>
                  <a:pt x="203200" y="6350"/>
                  <a:pt x="208152" y="4358"/>
                  <a:pt x="213360" y="3810"/>
                </a:cubicBezTo>
                <a:cubicBezTo>
                  <a:pt x="232347" y="1811"/>
                  <a:pt x="251460" y="1270"/>
                  <a:pt x="270510" y="0"/>
                </a:cubicBezTo>
                <a:cubicBezTo>
                  <a:pt x="312420" y="1270"/>
                  <a:pt x="354434" y="594"/>
                  <a:pt x="396240" y="3810"/>
                </a:cubicBezTo>
                <a:cubicBezTo>
                  <a:pt x="404249" y="4426"/>
                  <a:pt x="411480" y="8890"/>
                  <a:pt x="419100" y="11430"/>
                </a:cubicBezTo>
                <a:cubicBezTo>
                  <a:pt x="428814" y="14668"/>
                  <a:pt x="439420" y="13970"/>
                  <a:pt x="449580" y="15240"/>
                </a:cubicBezTo>
                <a:cubicBezTo>
                  <a:pt x="453390" y="17780"/>
                  <a:pt x="458583" y="18977"/>
                  <a:pt x="461010" y="22860"/>
                </a:cubicBezTo>
                <a:cubicBezTo>
                  <a:pt x="465267" y="29671"/>
                  <a:pt x="466090" y="38100"/>
                  <a:pt x="468630" y="45720"/>
                </a:cubicBezTo>
                <a:lnTo>
                  <a:pt x="472440" y="57150"/>
                </a:lnTo>
                <a:cubicBezTo>
                  <a:pt x="473710" y="60960"/>
                  <a:pt x="475276" y="64684"/>
                  <a:pt x="476250" y="68580"/>
                </a:cubicBezTo>
                <a:lnTo>
                  <a:pt x="483870" y="99060"/>
                </a:lnTo>
                <a:cubicBezTo>
                  <a:pt x="485818" y="106852"/>
                  <a:pt x="491490" y="121920"/>
                  <a:pt x="491490" y="121920"/>
                </a:cubicBezTo>
                <a:cubicBezTo>
                  <a:pt x="490517" y="132627"/>
                  <a:pt x="491200" y="160601"/>
                  <a:pt x="483870" y="175260"/>
                </a:cubicBezTo>
                <a:cubicBezTo>
                  <a:pt x="481822" y="179356"/>
                  <a:pt x="479111" y="183114"/>
                  <a:pt x="476250" y="186690"/>
                </a:cubicBezTo>
                <a:cubicBezTo>
                  <a:pt x="474006" y="189495"/>
                  <a:pt x="492125" y="167640"/>
                  <a:pt x="491490" y="16764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58" name="フリーフォーム 157"/>
          <p:cNvSpPr/>
          <p:nvPr/>
        </p:nvSpPr>
        <p:spPr>
          <a:xfrm>
            <a:off x="996102" y="4250888"/>
            <a:ext cx="491506" cy="419100"/>
          </a:xfrm>
          <a:custGeom>
            <a:avLst/>
            <a:gdLst>
              <a:gd name="connsiteX0" fmla="*/ 491490 w 491506"/>
              <a:gd name="connsiteY0" fmla="*/ 167640 h 419100"/>
              <a:gd name="connsiteX1" fmla="*/ 472440 w 491506"/>
              <a:gd name="connsiteY1" fmla="*/ 186690 h 419100"/>
              <a:gd name="connsiteX2" fmla="*/ 468630 w 491506"/>
              <a:gd name="connsiteY2" fmla="*/ 201930 h 419100"/>
              <a:gd name="connsiteX3" fmla="*/ 461010 w 491506"/>
              <a:gd name="connsiteY3" fmla="*/ 213360 h 419100"/>
              <a:gd name="connsiteX4" fmla="*/ 449580 w 491506"/>
              <a:gd name="connsiteY4" fmla="*/ 240030 h 419100"/>
              <a:gd name="connsiteX5" fmla="*/ 434340 w 491506"/>
              <a:gd name="connsiteY5" fmla="*/ 262890 h 419100"/>
              <a:gd name="connsiteX6" fmla="*/ 411480 w 491506"/>
              <a:gd name="connsiteY6" fmla="*/ 297180 h 419100"/>
              <a:gd name="connsiteX7" fmla="*/ 400050 w 491506"/>
              <a:gd name="connsiteY7" fmla="*/ 308610 h 419100"/>
              <a:gd name="connsiteX8" fmla="*/ 373380 w 491506"/>
              <a:gd name="connsiteY8" fmla="*/ 335280 h 419100"/>
              <a:gd name="connsiteX9" fmla="*/ 316230 w 491506"/>
              <a:gd name="connsiteY9" fmla="*/ 373380 h 419100"/>
              <a:gd name="connsiteX10" fmla="*/ 304800 w 491506"/>
              <a:gd name="connsiteY10" fmla="*/ 384810 h 419100"/>
              <a:gd name="connsiteX11" fmla="*/ 274320 w 491506"/>
              <a:gd name="connsiteY11" fmla="*/ 396240 h 419100"/>
              <a:gd name="connsiteX12" fmla="*/ 262890 w 491506"/>
              <a:gd name="connsiteY12" fmla="*/ 400050 h 419100"/>
              <a:gd name="connsiteX13" fmla="*/ 247650 w 491506"/>
              <a:gd name="connsiteY13" fmla="*/ 403860 h 419100"/>
              <a:gd name="connsiteX14" fmla="*/ 220980 w 491506"/>
              <a:gd name="connsiteY14" fmla="*/ 411480 h 419100"/>
              <a:gd name="connsiteX15" fmla="*/ 175260 w 491506"/>
              <a:gd name="connsiteY15" fmla="*/ 419100 h 419100"/>
              <a:gd name="connsiteX16" fmla="*/ 114300 w 491506"/>
              <a:gd name="connsiteY16" fmla="*/ 415290 h 419100"/>
              <a:gd name="connsiteX17" fmla="*/ 95250 w 491506"/>
              <a:gd name="connsiteY17" fmla="*/ 411480 h 419100"/>
              <a:gd name="connsiteX18" fmla="*/ 68580 w 491506"/>
              <a:gd name="connsiteY18" fmla="*/ 407670 h 419100"/>
              <a:gd name="connsiteX19" fmla="*/ 45720 w 491506"/>
              <a:gd name="connsiteY19" fmla="*/ 396240 h 419100"/>
              <a:gd name="connsiteX20" fmla="*/ 26670 w 491506"/>
              <a:gd name="connsiteY20" fmla="*/ 377190 h 419100"/>
              <a:gd name="connsiteX21" fmla="*/ 11430 w 491506"/>
              <a:gd name="connsiteY21" fmla="*/ 361950 h 419100"/>
              <a:gd name="connsiteX22" fmla="*/ 3810 w 491506"/>
              <a:gd name="connsiteY22" fmla="*/ 350520 h 419100"/>
              <a:gd name="connsiteX23" fmla="*/ 0 w 491506"/>
              <a:gd name="connsiteY23" fmla="*/ 335280 h 419100"/>
              <a:gd name="connsiteX24" fmla="*/ 3810 w 491506"/>
              <a:gd name="connsiteY24" fmla="*/ 278130 h 419100"/>
              <a:gd name="connsiteX25" fmla="*/ 15240 w 491506"/>
              <a:gd name="connsiteY25" fmla="*/ 243840 h 419100"/>
              <a:gd name="connsiteX26" fmla="*/ 22860 w 491506"/>
              <a:gd name="connsiteY26" fmla="*/ 232410 h 419100"/>
              <a:gd name="connsiteX27" fmla="*/ 30480 w 491506"/>
              <a:gd name="connsiteY27" fmla="*/ 201930 h 419100"/>
              <a:gd name="connsiteX28" fmla="*/ 45720 w 491506"/>
              <a:gd name="connsiteY28" fmla="*/ 179070 h 419100"/>
              <a:gd name="connsiteX29" fmla="*/ 57150 w 491506"/>
              <a:gd name="connsiteY29" fmla="*/ 171450 h 419100"/>
              <a:gd name="connsiteX30" fmla="*/ 60960 w 491506"/>
              <a:gd name="connsiteY30" fmla="*/ 160020 h 419100"/>
              <a:gd name="connsiteX31" fmla="*/ 64770 w 491506"/>
              <a:gd name="connsiteY31" fmla="*/ 121920 h 419100"/>
              <a:gd name="connsiteX32" fmla="*/ 68580 w 491506"/>
              <a:gd name="connsiteY32" fmla="*/ 110490 h 419100"/>
              <a:gd name="connsiteX33" fmla="*/ 80010 w 491506"/>
              <a:gd name="connsiteY33" fmla="*/ 99060 h 419100"/>
              <a:gd name="connsiteX34" fmla="*/ 91440 w 491506"/>
              <a:gd name="connsiteY34" fmla="*/ 95250 h 419100"/>
              <a:gd name="connsiteX35" fmla="*/ 114300 w 491506"/>
              <a:gd name="connsiteY35" fmla="*/ 76200 h 419100"/>
              <a:gd name="connsiteX36" fmla="*/ 118110 w 491506"/>
              <a:gd name="connsiteY36" fmla="*/ 64770 h 419100"/>
              <a:gd name="connsiteX37" fmla="*/ 125730 w 491506"/>
              <a:gd name="connsiteY37" fmla="*/ 53340 h 419100"/>
              <a:gd name="connsiteX38" fmla="*/ 140970 w 491506"/>
              <a:gd name="connsiteY38" fmla="*/ 30480 h 419100"/>
              <a:gd name="connsiteX39" fmla="*/ 175260 w 491506"/>
              <a:gd name="connsiteY39" fmla="*/ 15240 h 419100"/>
              <a:gd name="connsiteX40" fmla="*/ 186690 w 491506"/>
              <a:gd name="connsiteY40" fmla="*/ 11430 h 419100"/>
              <a:gd name="connsiteX41" fmla="*/ 198120 w 491506"/>
              <a:gd name="connsiteY41" fmla="*/ 7620 h 419100"/>
              <a:gd name="connsiteX42" fmla="*/ 213360 w 491506"/>
              <a:gd name="connsiteY42" fmla="*/ 3810 h 419100"/>
              <a:gd name="connsiteX43" fmla="*/ 270510 w 491506"/>
              <a:gd name="connsiteY43" fmla="*/ 0 h 419100"/>
              <a:gd name="connsiteX44" fmla="*/ 396240 w 491506"/>
              <a:gd name="connsiteY44" fmla="*/ 3810 h 419100"/>
              <a:gd name="connsiteX45" fmla="*/ 419100 w 491506"/>
              <a:gd name="connsiteY45" fmla="*/ 11430 h 419100"/>
              <a:gd name="connsiteX46" fmla="*/ 449580 w 491506"/>
              <a:gd name="connsiteY46" fmla="*/ 15240 h 419100"/>
              <a:gd name="connsiteX47" fmla="*/ 461010 w 491506"/>
              <a:gd name="connsiteY47" fmla="*/ 22860 h 419100"/>
              <a:gd name="connsiteX48" fmla="*/ 468630 w 491506"/>
              <a:gd name="connsiteY48" fmla="*/ 45720 h 419100"/>
              <a:gd name="connsiteX49" fmla="*/ 472440 w 491506"/>
              <a:gd name="connsiteY49" fmla="*/ 57150 h 419100"/>
              <a:gd name="connsiteX50" fmla="*/ 476250 w 491506"/>
              <a:gd name="connsiteY50" fmla="*/ 68580 h 419100"/>
              <a:gd name="connsiteX51" fmla="*/ 483870 w 491506"/>
              <a:gd name="connsiteY51" fmla="*/ 99060 h 419100"/>
              <a:gd name="connsiteX52" fmla="*/ 491490 w 491506"/>
              <a:gd name="connsiteY52" fmla="*/ 121920 h 419100"/>
              <a:gd name="connsiteX53" fmla="*/ 483870 w 491506"/>
              <a:gd name="connsiteY53" fmla="*/ 175260 h 419100"/>
              <a:gd name="connsiteX54" fmla="*/ 476250 w 491506"/>
              <a:gd name="connsiteY54" fmla="*/ 186690 h 419100"/>
              <a:gd name="connsiteX55" fmla="*/ 491490 w 491506"/>
              <a:gd name="connsiteY55" fmla="*/ 167640 h 4191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</a:cxnLst>
            <a:rect l="l" t="t" r="r" b="b"/>
            <a:pathLst>
              <a:path w="491506" h="419100">
                <a:moveTo>
                  <a:pt x="491490" y="167640"/>
                </a:moveTo>
                <a:cubicBezTo>
                  <a:pt x="490855" y="167640"/>
                  <a:pt x="477421" y="179218"/>
                  <a:pt x="472440" y="186690"/>
                </a:cubicBezTo>
                <a:cubicBezTo>
                  <a:pt x="469535" y="191047"/>
                  <a:pt x="470693" y="197117"/>
                  <a:pt x="468630" y="201930"/>
                </a:cubicBezTo>
                <a:cubicBezTo>
                  <a:pt x="466826" y="206139"/>
                  <a:pt x="463058" y="209264"/>
                  <a:pt x="461010" y="213360"/>
                </a:cubicBezTo>
                <a:cubicBezTo>
                  <a:pt x="445244" y="244892"/>
                  <a:pt x="473364" y="200389"/>
                  <a:pt x="449580" y="240030"/>
                </a:cubicBezTo>
                <a:cubicBezTo>
                  <a:pt x="444868" y="247883"/>
                  <a:pt x="439420" y="255270"/>
                  <a:pt x="434340" y="262890"/>
                </a:cubicBezTo>
                <a:lnTo>
                  <a:pt x="411480" y="297180"/>
                </a:lnTo>
                <a:cubicBezTo>
                  <a:pt x="408491" y="301663"/>
                  <a:pt x="403358" y="304357"/>
                  <a:pt x="400050" y="308610"/>
                </a:cubicBezTo>
                <a:cubicBezTo>
                  <a:pt x="378652" y="336122"/>
                  <a:pt x="395222" y="327999"/>
                  <a:pt x="373380" y="335280"/>
                </a:cubicBezTo>
                <a:lnTo>
                  <a:pt x="316230" y="373380"/>
                </a:lnTo>
                <a:cubicBezTo>
                  <a:pt x="311747" y="376369"/>
                  <a:pt x="309185" y="381678"/>
                  <a:pt x="304800" y="384810"/>
                </a:cubicBezTo>
                <a:cubicBezTo>
                  <a:pt x="292963" y="393265"/>
                  <a:pt x="287615" y="392441"/>
                  <a:pt x="274320" y="396240"/>
                </a:cubicBezTo>
                <a:cubicBezTo>
                  <a:pt x="270458" y="397343"/>
                  <a:pt x="266752" y="398947"/>
                  <a:pt x="262890" y="400050"/>
                </a:cubicBezTo>
                <a:cubicBezTo>
                  <a:pt x="257855" y="401489"/>
                  <a:pt x="252685" y="402421"/>
                  <a:pt x="247650" y="403860"/>
                </a:cubicBezTo>
                <a:cubicBezTo>
                  <a:pt x="225375" y="410224"/>
                  <a:pt x="247779" y="405525"/>
                  <a:pt x="220980" y="411480"/>
                </a:cubicBezTo>
                <a:cubicBezTo>
                  <a:pt x="200924" y="415937"/>
                  <a:pt x="197525" y="415919"/>
                  <a:pt x="175260" y="419100"/>
                </a:cubicBezTo>
                <a:cubicBezTo>
                  <a:pt x="154940" y="417830"/>
                  <a:pt x="134568" y="417220"/>
                  <a:pt x="114300" y="415290"/>
                </a:cubicBezTo>
                <a:cubicBezTo>
                  <a:pt x="107853" y="414676"/>
                  <a:pt x="101638" y="412545"/>
                  <a:pt x="95250" y="411480"/>
                </a:cubicBezTo>
                <a:cubicBezTo>
                  <a:pt x="86392" y="410004"/>
                  <a:pt x="77470" y="408940"/>
                  <a:pt x="68580" y="407670"/>
                </a:cubicBezTo>
                <a:cubicBezTo>
                  <a:pt x="59284" y="404571"/>
                  <a:pt x="53106" y="403626"/>
                  <a:pt x="45720" y="396240"/>
                </a:cubicBezTo>
                <a:cubicBezTo>
                  <a:pt x="20320" y="370840"/>
                  <a:pt x="57150" y="397510"/>
                  <a:pt x="26670" y="377190"/>
                </a:cubicBezTo>
                <a:cubicBezTo>
                  <a:pt x="18357" y="352252"/>
                  <a:pt x="29903" y="376728"/>
                  <a:pt x="11430" y="361950"/>
                </a:cubicBezTo>
                <a:cubicBezTo>
                  <a:pt x="7854" y="359089"/>
                  <a:pt x="6350" y="354330"/>
                  <a:pt x="3810" y="350520"/>
                </a:cubicBezTo>
                <a:cubicBezTo>
                  <a:pt x="2540" y="345440"/>
                  <a:pt x="0" y="340516"/>
                  <a:pt x="0" y="335280"/>
                </a:cubicBezTo>
                <a:cubicBezTo>
                  <a:pt x="0" y="316188"/>
                  <a:pt x="1110" y="297030"/>
                  <a:pt x="3810" y="278130"/>
                </a:cubicBezTo>
                <a:lnTo>
                  <a:pt x="15240" y="243840"/>
                </a:lnTo>
                <a:cubicBezTo>
                  <a:pt x="16688" y="239496"/>
                  <a:pt x="20320" y="236220"/>
                  <a:pt x="22860" y="232410"/>
                </a:cubicBezTo>
                <a:cubicBezTo>
                  <a:pt x="23916" y="227132"/>
                  <a:pt x="26819" y="208520"/>
                  <a:pt x="30480" y="201930"/>
                </a:cubicBezTo>
                <a:cubicBezTo>
                  <a:pt x="34928" y="193924"/>
                  <a:pt x="38100" y="184150"/>
                  <a:pt x="45720" y="179070"/>
                </a:cubicBezTo>
                <a:lnTo>
                  <a:pt x="57150" y="171450"/>
                </a:lnTo>
                <a:cubicBezTo>
                  <a:pt x="58420" y="167640"/>
                  <a:pt x="60349" y="163989"/>
                  <a:pt x="60960" y="160020"/>
                </a:cubicBezTo>
                <a:cubicBezTo>
                  <a:pt x="62901" y="147405"/>
                  <a:pt x="62829" y="134535"/>
                  <a:pt x="64770" y="121920"/>
                </a:cubicBezTo>
                <a:cubicBezTo>
                  <a:pt x="65381" y="117951"/>
                  <a:pt x="66352" y="113832"/>
                  <a:pt x="68580" y="110490"/>
                </a:cubicBezTo>
                <a:cubicBezTo>
                  <a:pt x="71569" y="106007"/>
                  <a:pt x="75527" y="102049"/>
                  <a:pt x="80010" y="99060"/>
                </a:cubicBezTo>
                <a:cubicBezTo>
                  <a:pt x="83352" y="96832"/>
                  <a:pt x="87630" y="96520"/>
                  <a:pt x="91440" y="95250"/>
                </a:cubicBezTo>
                <a:cubicBezTo>
                  <a:pt x="99874" y="89627"/>
                  <a:pt x="108433" y="85001"/>
                  <a:pt x="114300" y="76200"/>
                </a:cubicBezTo>
                <a:cubicBezTo>
                  <a:pt x="116528" y="72858"/>
                  <a:pt x="116314" y="68362"/>
                  <a:pt x="118110" y="64770"/>
                </a:cubicBezTo>
                <a:cubicBezTo>
                  <a:pt x="120158" y="60674"/>
                  <a:pt x="123682" y="57436"/>
                  <a:pt x="125730" y="53340"/>
                </a:cubicBezTo>
                <a:cubicBezTo>
                  <a:pt x="134451" y="35899"/>
                  <a:pt x="122398" y="45957"/>
                  <a:pt x="140970" y="30480"/>
                </a:cubicBezTo>
                <a:cubicBezTo>
                  <a:pt x="153045" y="20417"/>
                  <a:pt x="158647" y="20778"/>
                  <a:pt x="175260" y="15240"/>
                </a:cubicBezTo>
                <a:lnTo>
                  <a:pt x="186690" y="11430"/>
                </a:lnTo>
                <a:cubicBezTo>
                  <a:pt x="190500" y="10160"/>
                  <a:pt x="194224" y="8594"/>
                  <a:pt x="198120" y="7620"/>
                </a:cubicBezTo>
                <a:cubicBezTo>
                  <a:pt x="203200" y="6350"/>
                  <a:pt x="208152" y="4358"/>
                  <a:pt x="213360" y="3810"/>
                </a:cubicBezTo>
                <a:cubicBezTo>
                  <a:pt x="232347" y="1811"/>
                  <a:pt x="251460" y="1270"/>
                  <a:pt x="270510" y="0"/>
                </a:cubicBezTo>
                <a:cubicBezTo>
                  <a:pt x="312420" y="1270"/>
                  <a:pt x="354434" y="594"/>
                  <a:pt x="396240" y="3810"/>
                </a:cubicBezTo>
                <a:cubicBezTo>
                  <a:pt x="404249" y="4426"/>
                  <a:pt x="411480" y="8890"/>
                  <a:pt x="419100" y="11430"/>
                </a:cubicBezTo>
                <a:cubicBezTo>
                  <a:pt x="428814" y="14668"/>
                  <a:pt x="439420" y="13970"/>
                  <a:pt x="449580" y="15240"/>
                </a:cubicBezTo>
                <a:cubicBezTo>
                  <a:pt x="453390" y="17780"/>
                  <a:pt x="458583" y="18977"/>
                  <a:pt x="461010" y="22860"/>
                </a:cubicBezTo>
                <a:cubicBezTo>
                  <a:pt x="465267" y="29671"/>
                  <a:pt x="466090" y="38100"/>
                  <a:pt x="468630" y="45720"/>
                </a:cubicBezTo>
                <a:lnTo>
                  <a:pt x="472440" y="57150"/>
                </a:lnTo>
                <a:cubicBezTo>
                  <a:pt x="473710" y="60960"/>
                  <a:pt x="475276" y="64684"/>
                  <a:pt x="476250" y="68580"/>
                </a:cubicBezTo>
                <a:lnTo>
                  <a:pt x="483870" y="99060"/>
                </a:lnTo>
                <a:cubicBezTo>
                  <a:pt x="485818" y="106852"/>
                  <a:pt x="491490" y="121920"/>
                  <a:pt x="491490" y="121920"/>
                </a:cubicBezTo>
                <a:cubicBezTo>
                  <a:pt x="490517" y="132627"/>
                  <a:pt x="491200" y="160601"/>
                  <a:pt x="483870" y="175260"/>
                </a:cubicBezTo>
                <a:cubicBezTo>
                  <a:pt x="481822" y="179356"/>
                  <a:pt x="479111" y="183114"/>
                  <a:pt x="476250" y="186690"/>
                </a:cubicBezTo>
                <a:cubicBezTo>
                  <a:pt x="474006" y="189495"/>
                  <a:pt x="492125" y="167640"/>
                  <a:pt x="491490" y="16764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63" name="フリーフォーム 162"/>
          <p:cNvSpPr/>
          <p:nvPr/>
        </p:nvSpPr>
        <p:spPr>
          <a:xfrm>
            <a:off x="3738488" y="5467607"/>
            <a:ext cx="566989" cy="416635"/>
          </a:xfrm>
          <a:custGeom>
            <a:avLst/>
            <a:gdLst>
              <a:gd name="connsiteX0" fmla="*/ 209550 w 566989"/>
              <a:gd name="connsiteY0" fmla="*/ 50875 h 416635"/>
              <a:gd name="connsiteX1" fmla="*/ 163830 w 566989"/>
              <a:gd name="connsiteY1" fmla="*/ 62305 h 416635"/>
              <a:gd name="connsiteX2" fmla="*/ 144780 w 566989"/>
              <a:gd name="connsiteY2" fmla="*/ 66115 h 416635"/>
              <a:gd name="connsiteX3" fmla="*/ 118110 w 566989"/>
              <a:gd name="connsiteY3" fmla="*/ 77545 h 416635"/>
              <a:gd name="connsiteX4" fmla="*/ 95250 w 566989"/>
              <a:gd name="connsiteY4" fmla="*/ 96595 h 416635"/>
              <a:gd name="connsiteX5" fmla="*/ 49530 w 566989"/>
              <a:gd name="connsiteY5" fmla="*/ 123265 h 416635"/>
              <a:gd name="connsiteX6" fmla="*/ 45720 w 566989"/>
              <a:gd name="connsiteY6" fmla="*/ 138505 h 416635"/>
              <a:gd name="connsiteX7" fmla="*/ 22860 w 566989"/>
              <a:gd name="connsiteY7" fmla="*/ 153745 h 416635"/>
              <a:gd name="connsiteX8" fmla="*/ 7620 w 566989"/>
              <a:gd name="connsiteY8" fmla="*/ 176605 h 416635"/>
              <a:gd name="connsiteX9" fmla="*/ 0 w 566989"/>
              <a:gd name="connsiteY9" fmla="*/ 199465 h 416635"/>
              <a:gd name="connsiteX10" fmla="*/ 3810 w 566989"/>
              <a:gd name="connsiteY10" fmla="*/ 248995 h 416635"/>
              <a:gd name="connsiteX11" fmla="*/ 15240 w 566989"/>
              <a:gd name="connsiteY11" fmla="*/ 256615 h 416635"/>
              <a:gd name="connsiteX12" fmla="*/ 19050 w 566989"/>
              <a:gd name="connsiteY12" fmla="*/ 268045 h 416635"/>
              <a:gd name="connsiteX13" fmla="*/ 22860 w 566989"/>
              <a:gd name="connsiteY13" fmla="*/ 298525 h 416635"/>
              <a:gd name="connsiteX14" fmla="*/ 30480 w 566989"/>
              <a:gd name="connsiteY14" fmla="*/ 309955 h 416635"/>
              <a:gd name="connsiteX15" fmla="*/ 34290 w 566989"/>
              <a:gd name="connsiteY15" fmla="*/ 321385 h 416635"/>
              <a:gd name="connsiteX16" fmla="*/ 80010 w 566989"/>
              <a:gd name="connsiteY16" fmla="*/ 359485 h 416635"/>
              <a:gd name="connsiteX17" fmla="*/ 91440 w 566989"/>
              <a:gd name="connsiteY17" fmla="*/ 363295 h 416635"/>
              <a:gd name="connsiteX18" fmla="*/ 102870 w 566989"/>
              <a:gd name="connsiteY18" fmla="*/ 374725 h 416635"/>
              <a:gd name="connsiteX19" fmla="*/ 114300 w 566989"/>
              <a:gd name="connsiteY19" fmla="*/ 378535 h 416635"/>
              <a:gd name="connsiteX20" fmla="*/ 125730 w 566989"/>
              <a:gd name="connsiteY20" fmla="*/ 386155 h 416635"/>
              <a:gd name="connsiteX21" fmla="*/ 148590 w 566989"/>
              <a:gd name="connsiteY21" fmla="*/ 393775 h 416635"/>
              <a:gd name="connsiteX22" fmla="*/ 160020 w 566989"/>
              <a:gd name="connsiteY22" fmla="*/ 397585 h 416635"/>
              <a:gd name="connsiteX23" fmla="*/ 179070 w 566989"/>
              <a:gd name="connsiteY23" fmla="*/ 401395 h 416635"/>
              <a:gd name="connsiteX24" fmla="*/ 190500 w 566989"/>
              <a:gd name="connsiteY24" fmla="*/ 405205 h 416635"/>
              <a:gd name="connsiteX25" fmla="*/ 201930 w 566989"/>
              <a:gd name="connsiteY25" fmla="*/ 412825 h 416635"/>
              <a:gd name="connsiteX26" fmla="*/ 213360 w 566989"/>
              <a:gd name="connsiteY26" fmla="*/ 416635 h 416635"/>
              <a:gd name="connsiteX27" fmla="*/ 346710 w 566989"/>
              <a:gd name="connsiteY27" fmla="*/ 412825 h 416635"/>
              <a:gd name="connsiteX28" fmla="*/ 361950 w 566989"/>
              <a:gd name="connsiteY28" fmla="*/ 409015 h 416635"/>
              <a:gd name="connsiteX29" fmla="*/ 384810 w 566989"/>
              <a:gd name="connsiteY29" fmla="*/ 401395 h 416635"/>
              <a:gd name="connsiteX30" fmla="*/ 396240 w 566989"/>
              <a:gd name="connsiteY30" fmla="*/ 393775 h 416635"/>
              <a:gd name="connsiteX31" fmla="*/ 411480 w 566989"/>
              <a:gd name="connsiteY31" fmla="*/ 389965 h 416635"/>
              <a:gd name="connsiteX32" fmla="*/ 415290 w 566989"/>
              <a:gd name="connsiteY32" fmla="*/ 378535 h 416635"/>
              <a:gd name="connsiteX33" fmla="*/ 430530 w 566989"/>
              <a:gd name="connsiteY33" fmla="*/ 370915 h 416635"/>
              <a:gd name="connsiteX34" fmla="*/ 445770 w 566989"/>
              <a:gd name="connsiteY34" fmla="*/ 367105 h 416635"/>
              <a:gd name="connsiteX35" fmla="*/ 468630 w 566989"/>
              <a:gd name="connsiteY35" fmla="*/ 359485 h 416635"/>
              <a:gd name="connsiteX36" fmla="*/ 480060 w 566989"/>
              <a:gd name="connsiteY36" fmla="*/ 348055 h 416635"/>
              <a:gd name="connsiteX37" fmla="*/ 491490 w 566989"/>
              <a:gd name="connsiteY37" fmla="*/ 344245 h 416635"/>
              <a:gd name="connsiteX38" fmla="*/ 506730 w 566989"/>
              <a:gd name="connsiteY38" fmla="*/ 332815 h 416635"/>
              <a:gd name="connsiteX39" fmla="*/ 525780 w 566989"/>
              <a:gd name="connsiteY39" fmla="*/ 309955 h 416635"/>
              <a:gd name="connsiteX40" fmla="*/ 537210 w 566989"/>
              <a:gd name="connsiteY40" fmla="*/ 298525 h 416635"/>
              <a:gd name="connsiteX41" fmla="*/ 541020 w 566989"/>
              <a:gd name="connsiteY41" fmla="*/ 271855 h 416635"/>
              <a:gd name="connsiteX42" fmla="*/ 544830 w 566989"/>
              <a:gd name="connsiteY42" fmla="*/ 260425 h 416635"/>
              <a:gd name="connsiteX43" fmla="*/ 556260 w 566989"/>
              <a:gd name="connsiteY43" fmla="*/ 256615 h 416635"/>
              <a:gd name="connsiteX44" fmla="*/ 560070 w 566989"/>
              <a:gd name="connsiteY44" fmla="*/ 195655 h 416635"/>
              <a:gd name="connsiteX45" fmla="*/ 552450 w 566989"/>
              <a:gd name="connsiteY45" fmla="*/ 172795 h 416635"/>
              <a:gd name="connsiteX46" fmla="*/ 544830 w 566989"/>
              <a:gd name="connsiteY46" fmla="*/ 149935 h 416635"/>
              <a:gd name="connsiteX47" fmla="*/ 533400 w 566989"/>
              <a:gd name="connsiteY47" fmla="*/ 115645 h 416635"/>
              <a:gd name="connsiteX48" fmla="*/ 529590 w 566989"/>
              <a:gd name="connsiteY48" fmla="*/ 104215 h 416635"/>
              <a:gd name="connsiteX49" fmla="*/ 514350 w 566989"/>
              <a:gd name="connsiteY49" fmla="*/ 81355 h 416635"/>
              <a:gd name="connsiteX50" fmla="*/ 491490 w 566989"/>
              <a:gd name="connsiteY50" fmla="*/ 69925 h 416635"/>
              <a:gd name="connsiteX51" fmla="*/ 480060 w 566989"/>
              <a:gd name="connsiteY51" fmla="*/ 62305 h 416635"/>
              <a:gd name="connsiteX52" fmla="*/ 468630 w 566989"/>
              <a:gd name="connsiteY52" fmla="*/ 58495 h 416635"/>
              <a:gd name="connsiteX53" fmla="*/ 445770 w 566989"/>
              <a:gd name="connsiteY53" fmla="*/ 43255 h 416635"/>
              <a:gd name="connsiteX54" fmla="*/ 438150 w 566989"/>
              <a:gd name="connsiteY54" fmla="*/ 31825 h 416635"/>
              <a:gd name="connsiteX55" fmla="*/ 434340 w 566989"/>
              <a:gd name="connsiteY55" fmla="*/ 20395 h 416635"/>
              <a:gd name="connsiteX56" fmla="*/ 411480 w 566989"/>
              <a:gd name="connsiteY56" fmla="*/ 8965 h 416635"/>
              <a:gd name="connsiteX57" fmla="*/ 400050 w 566989"/>
              <a:gd name="connsiteY57" fmla="*/ 1345 h 416635"/>
              <a:gd name="connsiteX58" fmla="*/ 320040 w 566989"/>
              <a:gd name="connsiteY58" fmla="*/ 8965 h 416635"/>
              <a:gd name="connsiteX59" fmla="*/ 297180 w 566989"/>
              <a:gd name="connsiteY59" fmla="*/ 24205 h 416635"/>
              <a:gd name="connsiteX60" fmla="*/ 278130 w 566989"/>
              <a:gd name="connsiteY60" fmla="*/ 35635 h 416635"/>
              <a:gd name="connsiteX61" fmla="*/ 266700 w 566989"/>
              <a:gd name="connsiteY61" fmla="*/ 43255 h 416635"/>
              <a:gd name="connsiteX62" fmla="*/ 209550 w 566989"/>
              <a:gd name="connsiteY62" fmla="*/ 50875 h 41663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</a:cxnLst>
            <a:rect l="l" t="t" r="r" b="b"/>
            <a:pathLst>
              <a:path w="566989" h="416635">
                <a:moveTo>
                  <a:pt x="209550" y="50875"/>
                </a:moveTo>
                <a:cubicBezTo>
                  <a:pt x="192405" y="54050"/>
                  <a:pt x="208647" y="48860"/>
                  <a:pt x="163830" y="62305"/>
                </a:cubicBezTo>
                <a:cubicBezTo>
                  <a:pt x="157627" y="64166"/>
                  <a:pt x="151062" y="64544"/>
                  <a:pt x="144780" y="66115"/>
                </a:cubicBezTo>
                <a:cubicBezTo>
                  <a:pt x="135281" y="68490"/>
                  <a:pt x="126591" y="72699"/>
                  <a:pt x="118110" y="77545"/>
                </a:cubicBezTo>
                <a:cubicBezTo>
                  <a:pt x="90107" y="93547"/>
                  <a:pt x="124144" y="75581"/>
                  <a:pt x="95250" y="96595"/>
                </a:cubicBezTo>
                <a:cubicBezTo>
                  <a:pt x="75837" y="110714"/>
                  <a:pt x="67957" y="114052"/>
                  <a:pt x="49530" y="123265"/>
                </a:cubicBezTo>
                <a:cubicBezTo>
                  <a:pt x="48260" y="128345"/>
                  <a:pt x="49168" y="134564"/>
                  <a:pt x="45720" y="138505"/>
                </a:cubicBezTo>
                <a:cubicBezTo>
                  <a:pt x="39689" y="145397"/>
                  <a:pt x="22860" y="153745"/>
                  <a:pt x="22860" y="153745"/>
                </a:cubicBezTo>
                <a:lnTo>
                  <a:pt x="7620" y="176605"/>
                </a:lnTo>
                <a:cubicBezTo>
                  <a:pt x="3165" y="183288"/>
                  <a:pt x="0" y="199465"/>
                  <a:pt x="0" y="199465"/>
                </a:cubicBezTo>
                <a:cubicBezTo>
                  <a:pt x="1270" y="215975"/>
                  <a:pt x="-457" y="232995"/>
                  <a:pt x="3810" y="248995"/>
                </a:cubicBezTo>
                <a:cubicBezTo>
                  <a:pt x="4990" y="253419"/>
                  <a:pt x="12379" y="253039"/>
                  <a:pt x="15240" y="256615"/>
                </a:cubicBezTo>
                <a:cubicBezTo>
                  <a:pt x="17749" y="259751"/>
                  <a:pt x="17780" y="264235"/>
                  <a:pt x="19050" y="268045"/>
                </a:cubicBezTo>
                <a:cubicBezTo>
                  <a:pt x="20320" y="278205"/>
                  <a:pt x="20166" y="288647"/>
                  <a:pt x="22860" y="298525"/>
                </a:cubicBezTo>
                <a:cubicBezTo>
                  <a:pt x="24065" y="302943"/>
                  <a:pt x="28432" y="305859"/>
                  <a:pt x="30480" y="309955"/>
                </a:cubicBezTo>
                <a:cubicBezTo>
                  <a:pt x="32276" y="313547"/>
                  <a:pt x="31824" y="318215"/>
                  <a:pt x="34290" y="321385"/>
                </a:cubicBezTo>
                <a:cubicBezTo>
                  <a:pt x="50086" y="341694"/>
                  <a:pt x="59690" y="345938"/>
                  <a:pt x="80010" y="359485"/>
                </a:cubicBezTo>
                <a:cubicBezTo>
                  <a:pt x="83352" y="361713"/>
                  <a:pt x="87630" y="362025"/>
                  <a:pt x="91440" y="363295"/>
                </a:cubicBezTo>
                <a:cubicBezTo>
                  <a:pt x="95250" y="367105"/>
                  <a:pt x="98387" y="371736"/>
                  <a:pt x="102870" y="374725"/>
                </a:cubicBezTo>
                <a:cubicBezTo>
                  <a:pt x="106212" y="376953"/>
                  <a:pt x="110708" y="376739"/>
                  <a:pt x="114300" y="378535"/>
                </a:cubicBezTo>
                <a:cubicBezTo>
                  <a:pt x="118396" y="380583"/>
                  <a:pt x="121546" y="384295"/>
                  <a:pt x="125730" y="386155"/>
                </a:cubicBezTo>
                <a:cubicBezTo>
                  <a:pt x="133070" y="389417"/>
                  <a:pt x="140970" y="391235"/>
                  <a:pt x="148590" y="393775"/>
                </a:cubicBezTo>
                <a:lnTo>
                  <a:pt x="160020" y="397585"/>
                </a:lnTo>
                <a:cubicBezTo>
                  <a:pt x="166163" y="399633"/>
                  <a:pt x="172788" y="399824"/>
                  <a:pt x="179070" y="401395"/>
                </a:cubicBezTo>
                <a:cubicBezTo>
                  <a:pt x="182966" y="402369"/>
                  <a:pt x="186690" y="403935"/>
                  <a:pt x="190500" y="405205"/>
                </a:cubicBezTo>
                <a:cubicBezTo>
                  <a:pt x="194310" y="407745"/>
                  <a:pt x="197834" y="410777"/>
                  <a:pt x="201930" y="412825"/>
                </a:cubicBezTo>
                <a:cubicBezTo>
                  <a:pt x="205522" y="414621"/>
                  <a:pt x="209344" y="416635"/>
                  <a:pt x="213360" y="416635"/>
                </a:cubicBezTo>
                <a:cubicBezTo>
                  <a:pt x="257828" y="416635"/>
                  <a:pt x="302260" y="414095"/>
                  <a:pt x="346710" y="412825"/>
                </a:cubicBezTo>
                <a:cubicBezTo>
                  <a:pt x="351790" y="411555"/>
                  <a:pt x="356934" y="410520"/>
                  <a:pt x="361950" y="409015"/>
                </a:cubicBezTo>
                <a:cubicBezTo>
                  <a:pt x="369643" y="406707"/>
                  <a:pt x="384810" y="401395"/>
                  <a:pt x="384810" y="401395"/>
                </a:cubicBezTo>
                <a:cubicBezTo>
                  <a:pt x="388620" y="398855"/>
                  <a:pt x="392031" y="395579"/>
                  <a:pt x="396240" y="393775"/>
                </a:cubicBezTo>
                <a:cubicBezTo>
                  <a:pt x="401053" y="391712"/>
                  <a:pt x="407391" y="393236"/>
                  <a:pt x="411480" y="389965"/>
                </a:cubicBezTo>
                <a:cubicBezTo>
                  <a:pt x="414616" y="387456"/>
                  <a:pt x="412450" y="381375"/>
                  <a:pt x="415290" y="378535"/>
                </a:cubicBezTo>
                <a:cubicBezTo>
                  <a:pt x="419306" y="374519"/>
                  <a:pt x="425212" y="372909"/>
                  <a:pt x="430530" y="370915"/>
                </a:cubicBezTo>
                <a:cubicBezTo>
                  <a:pt x="435433" y="369076"/>
                  <a:pt x="440754" y="368610"/>
                  <a:pt x="445770" y="367105"/>
                </a:cubicBezTo>
                <a:cubicBezTo>
                  <a:pt x="453463" y="364797"/>
                  <a:pt x="468630" y="359485"/>
                  <a:pt x="468630" y="359485"/>
                </a:cubicBezTo>
                <a:cubicBezTo>
                  <a:pt x="472440" y="355675"/>
                  <a:pt x="475577" y="351044"/>
                  <a:pt x="480060" y="348055"/>
                </a:cubicBezTo>
                <a:cubicBezTo>
                  <a:pt x="483402" y="345827"/>
                  <a:pt x="488003" y="346238"/>
                  <a:pt x="491490" y="344245"/>
                </a:cubicBezTo>
                <a:cubicBezTo>
                  <a:pt x="497003" y="341095"/>
                  <a:pt x="501909" y="336948"/>
                  <a:pt x="506730" y="332815"/>
                </a:cubicBezTo>
                <a:cubicBezTo>
                  <a:pt x="526209" y="316119"/>
                  <a:pt x="511082" y="327592"/>
                  <a:pt x="525780" y="309955"/>
                </a:cubicBezTo>
                <a:cubicBezTo>
                  <a:pt x="529229" y="305816"/>
                  <a:pt x="533400" y="302335"/>
                  <a:pt x="537210" y="298525"/>
                </a:cubicBezTo>
                <a:cubicBezTo>
                  <a:pt x="538480" y="289635"/>
                  <a:pt x="539259" y="280661"/>
                  <a:pt x="541020" y="271855"/>
                </a:cubicBezTo>
                <a:cubicBezTo>
                  <a:pt x="541808" y="267917"/>
                  <a:pt x="541990" y="263265"/>
                  <a:pt x="544830" y="260425"/>
                </a:cubicBezTo>
                <a:cubicBezTo>
                  <a:pt x="547670" y="257585"/>
                  <a:pt x="552450" y="257885"/>
                  <a:pt x="556260" y="256615"/>
                </a:cubicBezTo>
                <a:cubicBezTo>
                  <a:pt x="572086" y="232876"/>
                  <a:pt x="567773" y="244438"/>
                  <a:pt x="560070" y="195655"/>
                </a:cubicBezTo>
                <a:cubicBezTo>
                  <a:pt x="558817" y="187721"/>
                  <a:pt x="554990" y="180415"/>
                  <a:pt x="552450" y="172795"/>
                </a:cubicBezTo>
                <a:lnTo>
                  <a:pt x="544830" y="149935"/>
                </a:lnTo>
                <a:lnTo>
                  <a:pt x="533400" y="115645"/>
                </a:lnTo>
                <a:cubicBezTo>
                  <a:pt x="532130" y="111835"/>
                  <a:pt x="531818" y="107557"/>
                  <a:pt x="529590" y="104215"/>
                </a:cubicBezTo>
                <a:lnTo>
                  <a:pt x="514350" y="81355"/>
                </a:lnTo>
                <a:cubicBezTo>
                  <a:pt x="510130" y="75024"/>
                  <a:pt x="498010" y="72098"/>
                  <a:pt x="491490" y="69925"/>
                </a:cubicBezTo>
                <a:cubicBezTo>
                  <a:pt x="487680" y="67385"/>
                  <a:pt x="484156" y="64353"/>
                  <a:pt x="480060" y="62305"/>
                </a:cubicBezTo>
                <a:cubicBezTo>
                  <a:pt x="476468" y="60509"/>
                  <a:pt x="472141" y="60445"/>
                  <a:pt x="468630" y="58495"/>
                </a:cubicBezTo>
                <a:cubicBezTo>
                  <a:pt x="460624" y="54047"/>
                  <a:pt x="445770" y="43255"/>
                  <a:pt x="445770" y="43255"/>
                </a:cubicBezTo>
                <a:cubicBezTo>
                  <a:pt x="443230" y="39445"/>
                  <a:pt x="440198" y="35921"/>
                  <a:pt x="438150" y="31825"/>
                </a:cubicBezTo>
                <a:cubicBezTo>
                  <a:pt x="436354" y="28233"/>
                  <a:pt x="436849" y="23531"/>
                  <a:pt x="434340" y="20395"/>
                </a:cubicBezTo>
                <a:cubicBezTo>
                  <a:pt x="428969" y="13681"/>
                  <a:pt x="419010" y="11475"/>
                  <a:pt x="411480" y="8965"/>
                </a:cubicBezTo>
                <a:cubicBezTo>
                  <a:pt x="407670" y="6425"/>
                  <a:pt x="404624" y="1563"/>
                  <a:pt x="400050" y="1345"/>
                </a:cubicBezTo>
                <a:cubicBezTo>
                  <a:pt x="347120" y="-1175"/>
                  <a:pt x="349742" y="-936"/>
                  <a:pt x="320040" y="8965"/>
                </a:cubicBezTo>
                <a:cubicBezTo>
                  <a:pt x="312420" y="14045"/>
                  <a:pt x="304906" y="19288"/>
                  <a:pt x="297180" y="24205"/>
                </a:cubicBezTo>
                <a:cubicBezTo>
                  <a:pt x="290932" y="28181"/>
                  <a:pt x="284292" y="31527"/>
                  <a:pt x="278130" y="35635"/>
                </a:cubicBezTo>
                <a:cubicBezTo>
                  <a:pt x="274320" y="38175"/>
                  <a:pt x="271249" y="42730"/>
                  <a:pt x="266700" y="43255"/>
                </a:cubicBezTo>
                <a:cubicBezTo>
                  <a:pt x="237655" y="46606"/>
                  <a:pt x="226695" y="47700"/>
                  <a:pt x="209550" y="50875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66" name="正方形/長方形 165"/>
          <p:cNvSpPr/>
          <p:nvPr/>
        </p:nvSpPr>
        <p:spPr>
          <a:xfrm>
            <a:off x="2035133" y="1777934"/>
            <a:ext cx="428991" cy="51098"/>
          </a:xfrm>
          <a:prstGeom prst="rect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69" name="正方形/長方形 168"/>
          <p:cNvSpPr/>
          <p:nvPr/>
        </p:nvSpPr>
        <p:spPr>
          <a:xfrm>
            <a:off x="4133008" y="1777934"/>
            <a:ext cx="189705" cy="51098"/>
          </a:xfrm>
          <a:prstGeom prst="rect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72" name="テキスト ボックス 171"/>
          <p:cNvSpPr txBox="1"/>
          <p:nvPr/>
        </p:nvSpPr>
        <p:spPr>
          <a:xfrm>
            <a:off x="1602856" y="1831984"/>
            <a:ext cx="14974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 smtClean="0">
                <a:solidFill>
                  <a:srgbClr val="00B0F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1/1_2 probe</a:t>
            </a:r>
            <a:endParaRPr kumimoji="1" lang="ja-JP" altLang="en-US" sz="1100" b="1" dirty="0">
              <a:solidFill>
                <a:srgbClr val="00B0F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75" name="テキスト ボックス 174"/>
          <p:cNvSpPr txBox="1"/>
          <p:nvPr/>
        </p:nvSpPr>
        <p:spPr>
          <a:xfrm>
            <a:off x="3715634" y="1834544"/>
            <a:ext cx="14974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 smtClean="0">
                <a:solidFill>
                  <a:srgbClr val="00B0F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2 probe</a:t>
            </a:r>
            <a:endParaRPr kumimoji="1" lang="ja-JP" altLang="en-US" sz="1100" b="1" dirty="0">
              <a:solidFill>
                <a:srgbClr val="00B0F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pic>
        <p:nvPicPr>
          <p:cNvPr id="17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0895" y="2349748"/>
            <a:ext cx="1371868" cy="13260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7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6642" y="2343505"/>
            <a:ext cx="1371868" cy="13260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2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6048" y="2343505"/>
            <a:ext cx="1371868" cy="13260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84" name="直線コネクタ 183"/>
          <p:cNvCxnSpPr/>
          <p:nvPr/>
        </p:nvCxnSpPr>
        <p:spPr>
          <a:xfrm flipV="1">
            <a:off x="4303137" y="3565018"/>
            <a:ext cx="360953" cy="1095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6" name="フリーフォーム 185"/>
          <p:cNvSpPr/>
          <p:nvPr/>
        </p:nvSpPr>
        <p:spPr>
          <a:xfrm>
            <a:off x="3695323" y="2681559"/>
            <a:ext cx="612732" cy="504274"/>
          </a:xfrm>
          <a:custGeom>
            <a:avLst/>
            <a:gdLst>
              <a:gd name="connsiteX0" fmla="*/ 514350 w 552450"/>
              <a:gd name="connsiteY0" fmla="*/ 415290 h 468630"/>
              <a:gd name="connsiteX1" fmla="*/ 495300 w 552450"/>
              <a:gd name="connsiteY1" fmla="*/ 419100 h 468630"/>
              <a:gd name="connsiteX2" fmla="*/ 472440 w 552450"/>
              <a:gd name="connsiteY2" fmla="*/ 426720 h 468630"/>
              <a:gd name="connsiteX3" fmla="*/ 464820 w 552450"/>
              <a:gd name="connsiteY3" fmla="*/ 438150 h 468630"/>
              <a:gd name="connsiteX4" fmla="*/ 453390 w 552450"/>
              <a:gd name="connsiteY4" fmla="*/ 441960 h 468630"/>
              <a:gd name="connsiteX5" fmla="*/ 438150 w 552450"/>
              <a:gd name="connsiteY5" fmla="*/ 449580 h 468630"/>
              <a:gd name="connsiteX6" fmla="*/ 403860 w 552450"/>
              <a:gd name="connsiteY6" fmla="*/ 461010 h 468630"/>
              <a:gd name="connsiteX7" fmla="*/ 392430 w 552450"/>
              <a:gd name="connsiteY7" fmla="*/ 464820 h 468630"/>
              <a:gd name="connsiteX8" fmla="*/ 365760 w 552450"/>
              <a:gd name="connsiteY8" fmla="*/ 468630 h 468630"/>
              <a:gd name="connsiteX9" fmla="*/ 266700 w 552450"/>
              <a:gd name="connsiteY9" fmla="*/ 464820 h 468630"/>
              <a:gd name="connsiteX10" fmla="*/ 232410 w 552450"/>
              <a:gd name="connsiteY10" fmla="*/ 453390 h 468630"/>
              <a:gd name="connsiteX11" fmla="*/ 220980 w 552450"/>
              <a:gd name="connsiteY11" fmla="*/ 449580 h 468630"/>
              <a:gd name="connsiteX12" fmla="*/ 194310 w 552450"/>
              <a:gd name="connsiteY12" fmla="*/ 434340 h 468630"/>
              <a:gd name="connsiteX13" fmla="*/ 182880 w 552450"/>
              <a:gd name="connsiteY13" fmla="*/ 426720 h 468630"/>
              <a:gd name="connsiteX14" fmla="*/ 171450 w 552450"/>
              <a:gd name="connsiteY14" fmla="*/ 411480 h 468630"/>
              <a:gd name="connsiteX15" fmla="*/ 144780 w 552450"/>
              <a:gd name="connsiteY15" fmla="*/ 400050 h 468630"/>
              <a:gd name="connsiteX16" fmla="*/ 121920 w 552450"/>
              <a:gd name="connsiteY16" fmla="*/ 384810 h 468630"/>
              <a:gd name="connsiteX17" fmla="*/ 110490 w 552450"/>
              <a:gd name="connsiteY17" fmla="*/ 373380 h 468630"/>
              <a:gd name="connsiteX18" fmla="*/ 95250 w 552450"/>
              <a:gd name="connsiteY18" fmla="*/ 350520 h 468630"/>
              <a:gd name="connsiteX19" fmla="*/ 80010 w 552450"/>
              <a:gd name="connsiteY19" fmla="*/ 346710 h 468630"/>
              <a:gd name="connsiteX20" fmla="*/ 57150 w 552450"/>
              <a:gd name="connsiteY20" fmla="*/ 327660 h 468630"/>
              <a:gd name="connsiteX21" fmla="*/ 30480 w 552450"/>
              <a:gd name="connsiteY21" fmla="*/ 293370 h 468630"/>
              <a:gd name="connsiteX22" fmla="*/ 19050 w 552450"/>
              <a:gd name="connsiteY22" fmla="*/ 266700 h 468630"/>
              <a:gd name="connsiteX23" fmla="*/ 11430 w 552450"/>
              <a:gd name="connsiteY23" fmla="*/ 255270 h 468630"/>
              <a:gd name="connsiteX24" fmla="*/ 3810 w 552450"/>
              <a:gd name="connsiteY24" fmla="*/ 232410 h 468630"/>
              <a:gd name="connsiteX25" fmla="*/ 0 w 552450"/>
              <a:gd name="connsiteY25" fmla="*/ 220980 h 468630"/>
              <a:gd name="connsiteX26" fmla="*/ 3810 w 552450"/>
              <a:gd name="connsiteY26" fmla="*/ 198120 h 468630"/>
              <a:gd name="connsiteX27" fmla="*/ 7620 w 552450"/>
              <a:gd name="connsiteY27" fmla="*/ 160020 h 468630"/>
              <a:gd name="connsiteX28" fmla="*/ 26670 w 552450"/>
              <a:gd name="connsiteY28" fmla="*/ 140970 h 468630"/>
              <a:gd name="connsiteX29" fmla="*/ 30480 w 552450"/>
              <a:gd name="connsiteY29" fmla="*/ 129540 h 468630"/>
              <a:gd name="connsiteX30" fmla="*/ 49530 w 552450"/>
              <a:gd name="connsiteY30" fmla="*/ 106680 h 468630"/>
              <a:gd name="connsiteX31" fmla="*/ 53340 w 552450"/>
              <a:gd name="connsiteY31" fmla="*/ 95250 h 468630"/>
              <a:gd name="connsiteX32" fmla="*/ 76200 w 552450"/>
              <a:gd name="connsiteY32" fmla="*/ 80010 h 468630"/>
              <a:gd name="connsiteX33" fmla="*/ 95250 w 552450"/>
              <a:gd name="connsiteY33" fmla="*/ 64770 h 468630"/>
              <a:gd name="connsiteX34" fmla="*/ 106680 w 552450"/>
              <a:gd name="connsiteY34" fmla="*/ 57150 h 468630"/>
              <a:gd name="connsiteX35" fmla="*/ 121920 w 552450"/>
              <a:gd name="connsiteY35" fmla="*/ 49530 h 468630"/>
              <a:gd name="connsiteX36" fmla="*/ 133350 w 552450"/>
              <a:gd name="connsiteY36" fmla="*/ 41910 h 468630"/>
              <a:gd name="connsiteX37" fmla="*/ 148590 w 552450"/>
              <a:gd name="connsiteY37" fmla="*/ 38100 h 468630"/>
              <a:gd name="connsiteX38" fmla="*/ 152400 w 552450"/>
              <a:gd name="connsiteY38" fmla="*/ 26670 h 468630"/>
              <a:gd name="connsiteX39" fmla="*/ 163830 w 552450"/>
              <a:gd name="connsiteY39" fmla="*/ 19050 h 468630"/>
              <a:gd name="connsiteX40" fmla="*/ 190500 w 552450"/>
              <a:gd name="connsiteY40" fmla="*/ 0 h 468630"/>
              <a:gd name="connsiteX41" fmla="*/ 297180 w 552450"/>
              <a:gd name="connsiteY41" fmla="*/ 3810 h 468630"/>
              <a:gd name="connsiteX42" fmla="*/ 320040 w 552450"/>
              <a:gd name="connsiteY42" fmla="*/ 22860 h 468630"/>
              <a:gd name="connsiteX43" fmla="*/ 342900 w 552450"/>
              <a:gd name="connsiteY43" fmla="*/ 30480 h 468630"/>
              <a:gd name="connsiteX44" fmla="*/ 369570 w 552450"/>
              <a:gd name="connsiteY44" fmla="*/ 45720 h 468630"/>
              <a:gd name="connsiteX45" fmla="*/ 384810 w 552450"/>
              <a:gd name="connsiteY45" fmla="*/ 49530 h 468630"/>
              <a:gd name="connsiteX46" fmla="*/ 396240 w 552450"/>
              <a:gd name="connsiteY46" fmla="*/ 53340 h 468630"/>
              <a:gd name="connsiteX47" fmla="*/ 415290 w 552450"/>
              <a:gd name="connsiteY47" fmla="*/ 72390 h 468630"/>
              <a:gd name="connsiteX48" fmla="*/ 434340 w 552450"/>
              <a:gd name="connsiteY48" fmla="*/ 95250 h 468630"/>
              <a:gd name="connsiteX49" fmla="*/ 457200 w 552450"/>
              <a:gd name="connsiteY49" fmla="*/ 110490 h 468630"/>
              <a:gd name="connsiteX50" fmla="*/ 468630 w 552450"/>
              <a:gd name="connsiteY50" fmla="*/ 118110 h 468630"/>
              <a:gd name="connsiteX51" fmla="*/ 480060 w 552450"/>
              <a:gd name="connsiteY51" fmla="*/ 121920 h 468630"/>
              <a:gd name="connsiteX52" fmla="*/ 491490 w 552450"/>
              <a:gd name="connsiteY52" fmla="*/ 129540 h 468630"/>
              <a:gd name="connsiteX53" fmla="*/ 510540 w 552450"/>
              <a:gd name="connsiteY53" fmla="*/ 148590 h 468630"/>
              <a:gd name="connsiteX54" fmla="*/ 518160 w 552450"/>
              <a:gd name="connsiteY54" fmla="*/ 171450 h 468630"/>
              <a:gd name="connsiteX55" fmla="*/ 525780 w 552450"/>
              <a:gd name="connsiteY55" fmla="*/ 182880 h 468630"/>
              <a:gd name="connsiteX56" fmla="*/ 529590 w 552450"/>
              <a:gd name="connsiteY56" fmla="*/ 194310 h 468630"/>
              <a:gd name="connsiteX57" fmla="*/ 533400 w 552450"/>
              <a:gd name="connsiteY57" fmla="*/ 232410 h 468630"/>
              <a:gd name="connsiteX58" fmla="*/ 541020 w 552450"/>
              <a:gd name="connsiteY58" fmla="*/ 243840 h 468630"/>
              <a:gd name="connsiteX59" fmla="*/ 544830 w 552450"/>
              <a:gd name="connsiteY59" fmla="*/ 262890 h 468630"/>
              <a:gd name="connsiteX60" fmla="*/ 552450 w 552450"/>
              <a:gd name="connsiteY60" fmla="*/ 308610 h 468630"/>
              <a:gd name="connsiteX61" fmla="*/ 544830 w 552450"/>
              <a:gd name="connsiteY61" fmla="*/ 350520 h 468630"/>
              <a:gd name="connsiteX62" fmla="*/ 537210 w 552450"/>
              <a:gd name="connsiteY62" fmla="*/ 361950 h 468630"/>
              <a:gd name="connsiteX63" fmla="*/ 533400 w 552450"/>
              <a:gd name="connsiteY63" fmla="*/ 373380 h 468630"/>
              <a:gd name="connsiteX64" fmla="*/ 525780 w 552450"/>
              <a:gd name="connsiteY64" fmla="*/ 384810 h 468630"/>
              <a:gd name="connsiteX65" fmla="*/ 518160 w 552450"/>
              <a:gd name="connsiteY65" fmla="*/ 407670 h 468630"/>
              <a:gd name="connsiteX66" fmla="*/ 514350 w 552450"/>
              <a:gd name="connsiteY66" fmla="*/ 415290 h 46863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</a:cxnLst>
            <a:rect l="l" t="t" r="r" b="b"/>
            <a:pathLst>
              <a:path w="552450" h="468630">
                <a:moveTo>
                  <a:pt x="514350" y="415290"/>
                </a:moveTo>
                <a:cubicBezTo>
                  <a:pt x="510540" y="417195"/>
                  <a:pt x="501548" y="417396"/>
                  <a:pt x="495300" y="419100"/>
                </a:cubicBezTo>
                <a:cubicBezTo>
                  <a:pt x="487551" y="421213"/>
                  <a:pt x="472440" y="426720"/>
                  <a:pt x="472440" y="426720"/>
                </a:cubicBezTo>
                <a:cubicBezTo>
                  <a:pt x="469900" y="430530"/>
                  <a:pt x="468396" y="435289"/>
                  <a:pt x="464820" y="438150"/>
                </a:cubicBezTo>
                <a:cubicBezTo>
                  <a:pt x="461684" y="440659"/>
                  <a:pt x="457081" y="440378"/>
                  <a:pt x="453390" y="441960"/>
                </a:cubicBezTo>
                <a:cubicBezTo>
                  <a:pt x="448170" y="444197"/>
                  <a:pt x="443423" y="447471"/>
                  <a:pt x="438150" y="449580"/>
                </a:cubicBezTo>
                <a:lnTo>
                  <a:pt x="403860" y="461010"/>
                </a:lnTo>
                <a:cubicBezTo>
                  <a:pt x="400050" y="462280"/>
                  <a:pt x="396406" y="464252"/>
                  <a:pt x="392430" y="464820"/>
                </a:cubicBezTo>
                <a:lnTo>
                  <a:pt x="365760" y="468630"/>
                </a:lnTo>
                <a:cubicBezTo>
                  <a:pt x="332740" y="467360"/>
                  <a:pt x="299600" y="467904"/>
                  <a:pt x="266700" y="464820"/>
                </a:cubicBezTo>
                <a:lnTo>
                  <a:pt x="232410" y="453390"/>
                </a:lnTo>
                <a:lnTo>
                  <a:pt x="220980" y="449580"/>
                </a:lnTo>
                <a:cubicBezTo>
                  <a:pt x="193133" y="431015"/>
                  <a:pt x="228147" y="453676"/>
                  <a:pt x="194310" y="434340"/>
                </a:cubicBezTo>
                <a:cubicBezTo>
                  <a:pt x="190334" y="432068"/>
                  <a:pt x="186690" y="429260"/>
                  <a:pt x="182880" y="426720"/>
                </a:cubicBezTo>
                <a:cubicBezTo>
                  <a:pt x="179070" y="421640"/>
                  <a:pt x="176271" y="415613"/>
                  <a:pt x="171450" y="411480"/>
                </a:cubicBezTo>
                <a:cubicBezTo>
                  <a:pt x="165458" y="406344"/>
                  <a:pt x="152519" y="402630"/>
                  <a:pt x="144780" y="400050"/>
                </a:cubicBezTo>
                <a:cubicBezTo>
                  <a:pt x="108317" y="363587"/>
                  <a:pt x="155003" y="406866"/>
                  <a:pt x="121920" y="384810"/>
                </a:cubicBezTo>
                <a:cubicBezTo>
                  <a:pt x="117437" y="381821"/>
                  <a:pt x="113798" y="377633"/>
                  <a:pt x="110490" y="373380"/>
                </a:cubicBezTo>
                <a:cubicBezTo>
                  <a:pt x="104867" y="366151"/>
                  <a:pt x="104135" y="352741"/>
                  <a:pt x="95250" y="350520"/>
                </a:cubicBezTo>
                <a:lnTo>
                  <a:pt x="80010" y="346710"/>
                </a:lnTo>
                <a:cubicBezTo>
                  <a:pt x="69850" y="339937"/>
                  <a:pt x="65048" y="337815"/>
                  <a:pt x="57150" y="327660"/>
                </a:cubicBezTo>
                <a:cubicBezTo>
                  <a:pt x="25250" y="286645"/>
                  <a:pt x="56429" y="319319"/>
                  <a:pt x="30480" y="293370"/>
                </a:cubicBezTo>
                <a:cubicBezTo>
                  <a:pt x="26206" y="280547"/>
                  <a:pt x="26583" y="279882"/>
                  <a:pt x="19050" y="266700"/>
                </a:cubicBezTo>
                <a:cubicBezTo>
                  <a:pt x="16778" y="262724"/>
                  <a:pt x="13290" y="259454"/>
                  <a:pt x="11430" y="255270"/>
                </a:cubicBezTo>
                <a:cubicBezTo>
                  <a:pt x="8168" y="247930"/>
                  <a:pt x="6350" y="240030"/>
                  <a:pt x="3810" y="232410"/>
                </a:cubicBezTo>
                <a:lnTo>
                  <a:pt x="0" y="220980"/>
                </a:lnTo>
                <a:cubicBezTo>
                  <a:pt x="1270" y="213360"/>
                  <a:pt x="2852" y="205785"/>
                  <a:pt x="3810" y="198120"/>
                </a:cubicBezTo>
                <a:cubicBezTo>
                  <a:pt x="5393" y="185455"/>
                  <a:pt x="4750" y="172456"/>
                  <a:pt x="7620" y="160020"/>
                </a:cubicBezTo>
                <a:cubicBezTo>
                  <a:pt x="9929" y="150014"/>
                  <a:pt x="19281" y="145896"/>
                  <a:pt x="26670" y="140970"/>
                </a:cubicBezTo>
                <a:cubicBezTo>
                  <a:pt x="27940" y="137160"/>
                  <a:pt x="28684" y="133132"/>
                  <a:pt x="30480" y="129540"/>
                </a:cubicBezTo>
                <a:cubicBezTo>
                  <a:pt x="35784" y="118931"/>
                  <a:pt x="41104" y="115106"/>
                  <a:pt x="49530" y="106680"/>
                </a:cubicBezTo>
                <a:cubicBezTo>
                  <a:pt x="50800" y="102870"/>
                  <a:pt x="51112" y="98592"/>
                  <a:pt x="53340" y="95250"/>
                </a:cubicBezTo>
                <a:cubicBezTo>
                  <a:pt x="61494" y="83019"/>
                  <a:pt x="64217" y="84004"/>
                  <a:pt x="76200" y="80010"/>
                </a:cubicBezTo>
                <a:cubicBezTo>
                  <a:pt x="89045" y="60742"/>
                  <a:pt x="76847" y="73972"/>
                  <a:pt x="95250" y="64770"/>
                </a:cubicBezTo>
                <a:cubicBezTo>
                  <a:pt x="99346" y="62722"/>
                  <a:pt x="102704" y="59422"/>
                  <a:pt x="106680" y="57150"/>
                </a:cubicBezTo>
                <a:cubicBezTo>
                  <a:pt x="111611" y="54332"/>
                  <a:pt x="116989" y="52348"/>
                  <a:pt x="121920" y="49530"/>
                </a:cubicBezTo>
                <a:cubicBezTo>
                  <a:pt x="125896" y="47258"/>
                  <a:pt x="129141" y="43714"/>
                  <a:pt x="133350" y="41910"/>
                </a:cubicBezTo>
                <a:cubicBezTo>
                  <a:pt x="138163" y="39847"/>
                  <a:pt x="143510" y="39370"/>
                  <a:pt x="148590" y="38100"/>
                </a:cubicBezTo>
                <a:cubicBezTo>
                  <a:pt x="149860" y="34290"/>
                  <a:pt x="149891" y="29806"/>
                  <a:pt x="152400" y="26670"/>
                </a:cubicBezTo>
                <a:cubicBezTo>
                  <a:pt x="155261" y="23094"/>
                  <a:pt x="160312" y="21981"/>
                  <a:pt x="163830" y="19050"/>
                </a:cubicBezTo>
                <a:cubicBezTo>
                  <a:pt x="186999" y="-258"/>
                  <a:pt x="162300" y="14100"/>
                  <a:pt x="190500" y="0"/>
                </a:cubicBezTo>
                <a:cubicBezTo>
                  <a:pt x="226060" y="1270"/>
                  <a:pt x="261763" y="383"/>
                  <a:pt x="297180" y="3810"/>
                </a:cubicBezTo>
                <a:cubicBezTo>
                  <a:pt x="305402" y="4606"/>
                  <a:pt x="314423" y="19739"/>
                  <a:pt x="320040" y="22860"/>
                </a:cubicBezTo>
                <a:cubicBezTo>
                  <a:pt x="327061" y="26761"/>
                  <a:pt x="342900" y="30480"/>
                  <a:pt x="342900" y="30480"/>
                </a:cubicBezTo>
                <a:cubicBezTo>
                  <a:pt x="352375" y="36797"/>
                  <a:pt x="358521" y="41577"/>
                  <a:pt x="369570" y="45720"/>
                </a:cubicBezTo>
                <a:cubicBezTo>
                  <a:pt x="374473" y="47559"/>
                  <a:pt x="379775" y="48091"/>
                  <a:pt x="384810" y="49530"/>
                </a:cubicBezTo>
                <a:cubicBezTo>
                  <a:pt x="388672" y="50633"/>
                  <a:pt x="392430" y="52070"/>
                  <a:pt x="396240" y="53340"/>
                </a:cubicBezTo>
                <a:cubicBezTo>
                  <a:pt x="416560" y="83820"/>
                  <a:pt x="389890" y="46990"/>
                  <a:pt x="415290" y="72390"/>
                </a:cubicBezTo>
                <a:cubicBezTo>
                  <a:pt x="437303" y="94403"/>
                  <a:pt x="406252" y="73404"/>
                  <a:pt x="434340" y="95250"/>
                </a:cubicBezTo>
                <a:cubicBezTo>
                  <a:pt x="441569" y="100873"/>
                  <a:pt x="449580" y="105410"/>
                  <a:pt x="457200" y="110490"/>
                </a:cubicBezTo>
                <a:cubicBezTo>
                  <a:pt x="461010" y="113030"/>
                  <a:pt x="464286" y="116662"/>
                  <a:pt x="468630" y="118110"/>
                </a:cubicBezTo>
                <a:lnTo>
                  <a:pt x="480060" y="121920"/>
                </a:lnTo>
                <a:cubicBezTo>
                  <a:pt x="483870" y="124460"/>
                  <a:pt x="488252" y="126302"/>
                  <a:pt x="491490" y="129540"/>
                </a:cubicBezTo>
                <a:cubicBezTo>
                  <a:pt x="516890" y="154940"/>
                  <a:pt x="480060" y="128270"/>
                  <a:pt x="510540" y="148590"/>
                </a:cubicBezTo>
                <a:lnTo>
                  <a:pt x="518160" y="171450"/>
                </a:lnTo>
                <a:cubicBezTo>
                  <a:pt x="519608" y="175794"/>
                  <a:pt x="523732" y="178784"/>
                  <a:pt x="525780" y="182880"/>
                </a:cubicBezTo>
                <a:cubicBezTo>
                  <a:pt x="527576" y="186472"/>
                  <a:pt x="528320" y="190500"/>
                  <a:pt x="529590" y="194310"/>
                </a:cubicBezTo>
                <a:cubicBezTo>
                  <a:pt x="530860" y="207010"/>
                  <a:pt x="530530" y="219974"/>
                  <a:pt x="533400" y="232410"/>
                </a:cubicBezTo>
                <a:cubicBezTo>
                  <a:pt x="534430" y="236872"/>
                  <a:pt x="539412" y="239553"/>
                  <a:pt x="541020" y="243840"/>
                </a:cubicBezTo>
                <a:cubicBezTo>
                  <a:pt x="543294" y="249903"/>
                  <a:pt x="543705" y="256513"/>
                  <a:pt x="544830" y="262890"/>
                </a:cubicBezTo>
                <a:cubicBezTo>
                  <a:pt x="547515" y="278105"/>
                  <a:pt x="552450" y="308610"/>
                  <a:pt x="552450" y="308610"/>
                </a:cubicBezTo>
                <a:cubicBezTo>
                  <a:pt x="551137" y="319117"/>
                  <a:pt x="550703" y="338774"/>
                  <a:pt x="544830" y="350520"/>
                </a:cubicBezTo>
                <a:cubicBezTo>
                  <a:pt x="542782" y="354616"/>
                  <a:pt x="539258" y="357854"/>
                  <a:pt x="537210" y="361950"/>
                </a:cubicBezTo>
                <a:cubicBezTo>
                  <a:pt x="535414" y="365542"/>
                  <a:pt x="535196" y="369788"/>
                  <a:pt x="533400" y="373380"/>
                </a:cubicBezTo>
                <a:cubicBezTo>
                  <a:pt x="531352" y="377476"/>
                  <a:pt x="527640" y="380626"/>
                  <a:pt x="525780" y="384810"/>
                </a:cubicBezTo>
                <a:cubicBezTo>
                  <a:pt x="522518" y="392150"/>
                  <a:pt x="525780" y="405130"/>
                  <a:pt x="518160" y="407670"/>
                </a:cubicBezTo>
                <a:cubicBezTo>
                  <a:pt x="505525" y="411882"/>
                  <a:pt x="518160" y="413385"/>
                  <a:pt x="514350" y="41529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87" name="フリーフォーム 186"/>
          <p:cNvSpPr/>
          <p:nvPr/>
        </p:nvSpPr>
        <p:spPr>
          <a:xfrm>
            <a:off x="2343461" y="2686768"/>
            <a:ext cx="612732" cy="504274"/>
          </a:xfrm>
          <a:custGeom>
            <a:avLst/>
            <a:gdLst>
              <a:gd name="connsiteX0" fmla="*/ 514350 w 552450"/>
              <a:gd name="connsiteY0" fmla="*/ 415290 h 468630"/>
              <a:gd name="connsiteX1" fmla="*/ 495300 w 552450"/>
              <a:gd name="connsiteY1" fmla="*/ 419100 h 468630"/>
              <a:gd name="connsiteX2" fmla="*/ 472440 w 552450"/>
              <a:gd name="connsiteY2" fmla="*/ 426720 h 468630"/>
              <a:gd name="connsiteX3" fmla="*/ 464820 w 552450"/>
              <a:gd name="connsiteY3" fmla="*/ 438150 h 468630"/>
              <a:gd name="connsiteX4" fmla="*/ 453390 w 552450"/>
              <a:gd name="connsiteY4" fmla="*/ 441960 h 468630"/>
              <a:gd name="connsiteX5" fmla="*/ 438150 w 552450"/>
              <a:gd name="connsiteY5" fmla="*/ 449580 h 468630"/>
              <a:gd name="connsiteX6" fmla="*/ 403860 w 552450"/>
              <a:gd name="connsiteY6" fmla="*/ 461010 h 468630"/>
              <a:gd name="connsiteX7" fmla="*/ 392430 w 552450"/>
              <a:gd name="connsiteY7" fmla="*/ 464820 h 468630"/>
              <a:gd name="connsiteX8" fmla="*/ 365760 w 552450"/>
              <a:gd name="connsiteY8" fmla="*/ 468630 h 468630"/>
              <a:gd name="connsiteX9" fmla="*/ 266700 w 552450"/>
              <a:gd name="connsiteY9" fmla="*/ 464820 h 468630"/>
              <a:gd name="connsiteX10" fmla="*/ 232410 w 552450"/>
              <a:gd name="connsiteY10" fmla="*/ 453390 h 468630"/>
              <a:gd name="connsiteX11" fmla="*/ 220980 w 552450"/>
              <a:gd name="connsiteY11" fmla="*/ 449580 h 468630"/>
              <a:gd name="connsiteX12" fmla="*/ 194310 w 552450"/>
              <a:gd name="connsiteY12" fmla="*/ 434340 h 468630"/>
              <a:gd name="connsiteX13" fmla="*/ 182880 w 552450"/>
              <a:gd name="connsiteY13" fmla="*/ 426720 h 468630"/>
              <a:gd name="connsiteX14" fmla="*/ 171450 w 552450"/>
              <a:gd name="connsiteY14" fmla="*/ 411480 h 468630"/>
              <a:gd name="connsiteX15" fmla="*/ 144780 w 552450"/>
              <a:gd name="connsiteY15" fmla="*/ 400050 h 468630"/>
              <a:gd name="connsiteX16" fmla="*/ 121920 w 552450"/>
              <a:gd name="connsiteY16" fmla="*/ 384810 h 468630"/>
              <a:gd name="connsiteX17" fmla="*/ 110490 w 552450"/>
              <a:gd name="connsiteY17" fmla="*/ 373380 h 468630"/>
              <a:gd name="connsiteX18" fmla="*/ 95250 w 552450"/>
              <a:gd name="connsiteY18" fmla="*/ 350520 h 468630"/>
              <a:gd name="connsiteX19" fmla="*/ 80010 w 552450"/>
              <a:gd name="connsiteY19" fmla="*/ 346710 h 468630"/>
              <a:gd name="connsiteX20" fmla="*/ 57150 w 552450"/>
              <a:gd name="connsiteY20" fmla="*/ 327660 h 468630"/>
              <a:gd name="connsiteX21" fmla="*/ 30480 w 552450"/>
              <a:gd name="connsiteY21" fmla="*/ 293370 h 468630"/>
              <a:gd name="connsiteX22" fmla="*/ 19050 w 552450"/>
              <a:gd name="connsiteY22" fmla="*/ 266700 h 468630"/>
              <a:gd name="connsiteX23" fmla="*/ 11430 w 552450"/>
              <a:gd name="connsiteY23" fmla="*/ 255270 h 468630"/>
              <a:gd name="connsiteX24" fmla="*/ 3810 w 552450"/>
              <a:gd name="connsiteY24" fmla="*/ 232410 h 468630"/>
              <a:gd name="connsiteX25" fmla="*/ 0 w 552450"/>
              <a:gd name="connsiteY25" fmla="*/ 220980 h 468630"/>
              <a:gd name="connsiteX26" fmla="*/ 3810 w 552450"/>
              <a:gd name="connsiteY26" fmla="*/ 198120 h 468630"/>
              <a:gd name="connsiteX27" fmla="*/ 7620 w 552450"/>
              <a:gd name="connsiteY27" fmla="*/ 160020 h 468630"/>
              <a:gd name="connsiteX28" fmla="*/ 26670 w 552450"/>
              <a:gd name="connsiteY28" fmla="*/ 140970 h 468630"/>
              <a:gd name="connsiteX29" fmla="*/ 30480 w 552450"/>
              <a:gd name="connsiteY29" fmla="*/ 129540 h 468630"/>
              <a:gd name="connsiteX30" fmla="*/ 49530 w 552450"/>
              <a:gd name="connsiteY30" fmla="*/ 106680 h 468630"/>
              <a:gd name="connsiteX31" fmla="*/ 53340 w 552450"/>
              <a:gd name="connsiteY31" fmla="*/ 95250 h 468630"/>
              <a:gd name="connsiteX32" fmla="*/ 76200 w 552450"/>
              <a:gd name="connsiteY32" fmla="*/ 80010 h 468630"/>
              <a:gd name="connsiteX33" fmla="*/ 95250 w 552450"/>
              <a:gd name="connsiteY33" fmla="*/ 64770 h 468630"/>
              <a:gd name="connsiteX34" fmla="*/ 106680 w 552450"/>
              <a:gd name="connsiteY34" fmla="*/ 57150 h 468630"/>
              <a:gd name="connsiteX35" fmla="*/ 121920 w 552450"/>
              <a:gd name="connsiteY35" fmla="*/ 49530 h 468630"/>
              <a:gd name="connsiteX36" fmla="*/ 133350 w 552450"/>
              <a:gd name="connsiteY36" fmla="*/ 41910 h 468630"/>
              <a:gd name="connsiteX37" fmla="*/ 148590 w 552450"/>
              <a:gd name="connsiteY37" fmla="*/ 38100 h 468630"/>
              <a:gd name="connsiteX38" fmla="*/ 152400 w 552450"/>
              <a:gd name="connsiteY38" fmla="*/ 26670 h 468630"/>
              <a:gd name="connsiteX39" fmla="*/ 163830 w 552450"/>
              <a:gd name="connsiteY39" fmla="*/ 19050 h 468630"/>
              <a:gd name="connsiteX40" fmla="*/ 190500 w 552450"/>
              <a:gd name="connsiteY40" fmla="*/ 0 h 468630"/>
              <a:gd name="connsiteX41" fmla="*/ 297180 w 552450"/>
              <a:gd name="connsiteY41" fmla="*/ 3810 h 468630"/>
              <a:gd name="connsiteX42" fmla="*/ 320040 w 552450"/>
              <a:gd name="connsiteY42" fmla="*/ 22860 h 468630"/>
              <a:gd name="connsiteX43" fmla="*/ 342900 w 552450"/>
              <a:gd name="connsiteY43" fmla="*/ 30480 h 468630"/>
              <a:gd name="connsiteX44" fmla="*/ 369570 w 552450"/>
              <a:gd name="connsiteY44" fmla="*/ 45720 h 468630"/>
              <a:gd name="connsiteX45" fmla="*/ 384810 w 552450"/>
              <a:gd name="connsiteY45" fmla="*/ 49530 h 468630"/>
              <a:gd name="connsiteX46" fmla="*/ 396240 w 552450"/>
              <a:gd name="connsiteY46" fmla="*/ 53340 h 468630"/>
              <a:gd name="connsiteX47" fmla="*/ 415290 w 552450"/>
              <a:gd name="connsiteY47" fmla="*/ 72390 h 468630"/>
              <a:gd name="connsiteX48" fmla="*/ 434340 w 552450"/>
              <a:gd name="connsiteY48" fmla="*/ 95250 h 468630"/>
              <a:gd name="connsiteX49" fmla="*/ 457200 w 552450"/>
              <a:gd name="connsiteY49" fmla="*/ 110490 h 468630"/>
              <a:gd name="connsiteX50" fmla="*/ 468630 w 552450"/>
              <a:gd name="connsiteY50" fmla="*/ 118110 h 468630"/>
              <a:gd name="connsiteX51" fmla="*/ 480060 w 552450"/>
              <a:gd name="connsiteY51" fmla="*/ 121920 h 468630"/>
              <a:gd name="connsiteX52" fmla="*/ 491490 w 552450"/>
              <a:gd name="connsiteY52" fmla="*/ 129540 h 468630"/>
              <a:gd name="connsiteX53" fmla="*/ 510540 w 552450"/>
              <a:gd name="connsiteY53" fmla="*/ 148590 h 468630"/>
              <a:gd name="connsiteX54" fmla="*/ 518160 w 552450"/>
              <a:gd name="connsiteY54" fmla="*/ 171450 h 468630"/>
              <a:gd name="connsiteX55" fmla="*/ 525780 w 552450"/>
              <a:gd name="connsiteY55" fmla="*/ 182880 h 468630"/>
              <a:gd name="connsiteX56" fmla="*/ 529590 w 552450"/>
              <a:gd name="connsiteY56" fmla="*/ 194310 h 468630"/>
              <a:gd name="connsiteX57" fmla="*/ 533400 w 552450"/>
              <a:gd name="connsiteY57" fmla="*/ 232410 h 468630"/>
              <a:gd name="connsiteX58" fmla="*/ 541020 w 552450"/>
              <a:gd name="connsiteY58" fmla="*/ 243840 h 468630"/>
              <a:gd name="connsiteX59" fmla="*/ 544830 w 552450"/>
              <a:gd name="connsiteY59" fmla="*/ 262890 h 468630"/>
              <a:gd name="connsiteX60" fmla="*/ 552450 w 552450"/>
              <a:gd name="connsiteY60" fmla="*/ 308610 h 468630"/>
              <a:gd name="connsiteX61" fmla="*/ 544830 w 552450"/>
              <a:gd name="connsiteY61" fmla="*/ 350520 h 468630"/>
              <a:gd name="connsiteX62" fmla="*/ 537210 w 552450"/>
              <a:gd name="connsiteY62" fmla="*/ 361950 h 468630"/>
              <a:gd name="connsiteX63" fmla="*/ 533400 w 552450"/>
              <a:gd name="connsiteY63" fmla="*/ 373380 h 468630"/>
              <a:gd name="connsiteX64" fmla="*/ 525780 w 552450"/>
              <a:gd name="connsiteY64" fmla="*/ 384810 h 468630"/>
              <a:gd name="connsiteX65" fmla="*/ 518160 w 552450"/>
              <a:gd name="connsiteY65" fmla="*/ 407670 h 468630"/>
              <a:gd name="connsiteX66" fmla="*/ 514350 w 552450"/>
              <a:gd name="connsiteY66" fmla="*/ 415290 h 46863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</a:cxnLst>
            <a:rect l="l" t="t" r="r" b="b"/>
            <a:pathLst>
              <a:path w="552450" h="468630">
                <a:moveTo>
                  <a:pt x="514350" y="415290"/>
                </a:moveTo>
                <a:cubicBezTo>
                  <a:pt x="510540" y="417195"/>
                  <a:pt x="501548" y="417396"/>
                  <a:pt x="495300" y="419100"/>
                </a:cubicBezTo>
                <a:cubicBezTo>
                  <a:pt x="487551" y="421213"/>
                  <a:pt x="472440" y="426720"/>
                  <a:pt x="472440" y="426720"/>
                </a:cubicBezTo>
                <a:cubicBezTo>
                  <a:pt x="469900" y="430530"/>
                  <a:pt x="468396" y="435289"/>
                  <a:pt x="464820" y="438150"/>
                </a:cubicBezTo>
                <a:cubicBezTo>
                  <a:pt x="461684" y="440659"/>
                  <a:pt x="457081" y="440378"/>
                  <a:pt x="453390" y="441960"/>
                </a:cubicBezTo>
                <a:cubicBezTo>
                  <a:pt x="448170" y="444197"/>
                  <a:pt x="443423" y="447471"/>
                  <a:pt x="438150" y="449580"/>
                </a:cubicBezTo>
                <a:lnTo>
                  <a:pt x="403860" y="461010"/>
                </a:lnTo>
                <a:cubicBezTo>
                  <a:pt x="400050" y="462280"/>
                  <a:pt x="396406" y="464252"/>
                  <a:pt x="392430" y="464820"/>
                </a:cubicBezTo>
                <a:lnTo>
                  <a:pt x="365760" y="468630"/>
                </a:lnTo>
                <a:cubicBezTo>
                  <a:pt x="332740" y="467360"/>
                  <a:pt x="299600" y="467904"/>
                  <a:pt x="266700" y="464820"/>
                </a:cubicBezTo>
                <a:lnTo>
                  <a:pt x="232410" y="453390"/>
                </a:lnTo>
                <a:lnTo>
                  <a:pt x="220980" y="449580"/>
                </a:lnTo>
                <a:cubicBezTo>
                  <a:pt x="193133" y="431015"/>
                  <a:pt x="228147" y="453676"/>
                  <a:pt x="194310" y="434340"/>
                </a:cubicBezTo>
                <a:cubicBezTo>
                  <a:pt x="190334" y="432068"/>
                  <a:pt x="186690" y="429260"/>
                  <a:pt x="182880" y="426720"/>
                </a:cubicBezTo>
                <a:cubicBezTo>
                  <a:pt x="179070" y="421640"/>
                  <a:pt x="176271" y="415613"/>
                  <a:pt x="171450" y="411480"/>
                </a:cubicBezTo>
                <a:cubicBezTo>
                  <a:pt x="165458" y="406344"/>
                  <a:pt x="152519" y="402630"/>
                  <a:pt x="144780" y="400050"/>
                </a:cubicBezTo>
                <a:cubicBezTo>
                  <a:pt x="108317" y="363587"/>
                  <a:pt x="155003" y="406866"/>
                  <a:pt x="121920" y="384810"/>
                </a:cubicBezTo>
                <a:cubicBezTo>
                  <a:pt x="117437" y="381821"/>
                  <a:pt x="113798" y="377633"/>
                  <a:pt x="110490" y="373380"/>
                </a:cubicBezTo>
                <a:cubicBezTo>
                  <a:pt x="104867" y="366151"/>
                  <a:pt x="104135" y="352741"/>
                  <a:pt x="95250" y="350520"/>
                </a:cubicBezTo>
                <a:lnTo>
                  <a:pt x="80010" y="346710"/>
                </a:lnTo>
                <a:cubicBezTo>
                  <a:pt x="69850" y="339937"/>
                  <a:pt x="65048" y="337815"/>
                  <a:pt x="57150" y="327660"/>
                </a:cubicBezTo>
                <a:cubicBezTo>
                  <a:pt x="25250" y="286645"/>
                  <a:pt x="56429" y="319319"/>
                  <a:pt x="30480" y="293370"/>
                </a:cubicBezTo>
                <a:cubicBezTo>
                  <a:pt x="26206" y="280547"/>
                  <a:pt x="26583" y="279882"/>
                  <a:pt x="19050" y="266700"/>
                </a:cubicBezTo>
                <a:cubicBezTo>
                  <a:pt x="16778" y="262724"/>
                  <a:pt x="13290" y="259454"/>
                  <a:pt x="11430" y="255270"/>
                </a:cubicBezTo>
                <a:cubicBezTo>
                  <a:pt x="8168" y="247930"/>
                  <a:pt x="6350" y="240030"/>
                  <a:pt x="3810" y="232410"/>
                </a:cubicBezTo>
                <a:lnTo>
                  <a:pt x="0" y="220980"/>
                </a:lnTo>
                <a:cubicBezTo>
                  <a:pt x="1270" y="213360"/>
                  <a:pt x="2852" y="205785"/>
                  <a:pt x="3810" y="198120"/>
                </a:cubicBezTo>
                <a:cubicBezTo>
                  <a:pt x="5393" y="185455"/>
                  <a:pt x="4750" y="172456"/>
                  <a:pt x="7620" y="160020"/>
                </a:cubicBezTo>
                <a:cubicBezTo>
                  <a:pt x="9929" y="150014"/>
                  <a:pt x="19281" y="145896"/>
                  <a:pt x="26670" y="140970"/>
                </a:cubicBezTo>
                <a:cubicBezTo>
                  <a:pt x="27940" y="137160"/>
                  <a:pt x="28684" y="133132"/>
                  <a:pt x="30480" y="129540"/>
                </a:cubicBezTo>
                <a:cubicBezTo>
                  <a:pt x="35784" y="118931"/>
                  <a:pt x="41104" y="115106"/>
                  <a:pt x="49530" y="106680"/>
                </a:cubicBezTo>
                <a:cubicBezTo>
                  <a:pt x="50800" y="102870"/>
                  <a:pt x="51112" y="98592"/>
                  <a:pt x="53340" y="95250"/>
                </a:cubicBezTo>
                <a:cubicBezTo>
                  <a:pt x="61494" y="83019"/>
                  <a:pt x="64217" y="84004"/>
                  <a:pt x="76200" y="80010"/>
                </a:cubicBezTo>
                <a:cubicBezTo>
                  <a:pt x="89045" y="60742"/>
                  <a:pt x="76847" y="73972"/>
                  <a:pt x="95250" y="64770"/>
                </a:cubicBezTo>
                <a:cubicBezTo>
                  <a:pt x="99346" y="62722"/>
                  <a:pt x="102704" y="59422"/>
                  <a:pt x="106680" y="57150"/>
                </a:cubicBezTo>
                <a:cubicBezTo>
                  <a:pt x="111611" y="54332"/>
                  <a:pt x="116989" y="52348"/>
                  <a:pt x="121920" y="49530"/>
                </a:cubicBezTo>
                <a:cubicBezTo>
                  <a:pt x="125896" y="47258"/>
                  <a:pt x="129141" y="43714"/>
                  <a:pt x="133350" y="41910"/>
                </a:cubicBezTo>
                <a:cubicBezTo>
                  <a:pt x="138163" y="39847"/>
                  <a:pt x="143510" y="39370"/>
                  <a:pt x="148590" y="38100"/>
                </a:cubicBezTo>
                <a:cubicBezTo>
                  <a:pt x="149860" y="34290"/>
                  <a:pt x="149891" y="29806"/>
                  <a:pt x="152400" y="26670"/>
                </a:cubicBezTo>
                <a:cubicBezTo>
                  <a:pt x="155261" y="23094"/>
                  <a:pt x="160312" y="21981"/>
                  <a:pt x="163830" y="19050"/>
                </a:cubicBezTo>
                <a:cubicBezTo>
                  <a:pt x="186999" y="-258"/>
                  <a:pt x="162300" y="14100"/>
                  <a:pt x="190500" y="0"/>
                </a:cubicBezTo>
                <a:cubicBezTo>
                  <a:pt x="226060" y="1270"/>
                  <a:pt x="261763" y="383"/>
                  <a:pt x="297180" y="3810"/>
                </a:cubicBezTo>
                <a:cubicBezTo>
                  <a:pt x="305402" y="4606"/>
                  <a:pt x="314423" y="19739"/>
                  <a:pt x="320040" y="22860"/>
                </a:cubicBezTo>
                <a:cubicBezTo>
                  <a:pt x="327061" y="26761"/>
                  <a:pt x="342900" y="30480"/>
                  <a:pt x="342900" y="30480"/>
                </a:cubicBezTo>
                <a:cubicBezTo>
                  <a:pt x="352375" y="36797"/>
                  <a:pt x="358521" y="41577"/>
                  <a:pt x="369570" y="45720"/>
                </a:cubicBezTo>
                <a:cubicBezTo>
                  <a:pt x="374473" y="47559"/>
                  <a:pt x="379775" y="48091"/>
                  <a:pt x="384810" y="49530"/>
                </a:cubicBezTo>
                <a:cubicBezTo>
                  <a:pt x="388672" y="50633"/>
                  <a:pt x="392430" y="52070"/>
                  <a:pt x="396240" y="53340"/>
                </a:cubicBezTo>
                <a:cubicBezTo>
                  <a:pt x="416560" y="83820"/>
                  <a:pt x="389890" y="46990"/>
                  <a:pt x="415290" y="72390"/>
                </a:cubicBezTo>
                <a:cubicBezTo>
                  <a:pt x="437303" y="94403"/>
                  <a:pt x="406252" y="73404"/>
                  <a:pt x="434340" y="95250"/>
                </a:cubicBezTo>
                <a:cubicBezTo>
                  <a:pt x="441569" y="100873"/>
                  <a:pt x="449580" y="105410"/>
                  <a:pt x="457200" y="110490"/>
                </a:cubicBezTo>
                <a:cubicBezTo>
                  <a:pt x="461010" y="113030"/>
                  <a:pt x="464286" y="116662"/>
                  <a:pt x="468630" y="118110"/>
                </a:cubicBezTo>
                <a:lnTo>
                  <a:pt x="480060" y="121920"/>
                </a:lnTo>
                <a:cubicBezTo>
                  <a:pt x="483870" y="124460"/>
                  <a:pt x="488252" y="126302"/>
                  <a:pt x="491490" y="129540"/>
                </a:cubicBezTo>
                <a:cubicBezTo>
                  <a:pt x="516890" y="154940"/>
                  <a:pt x="480060" y="128270"/>
                  <a:pt x="510540" y="148590"/>
                </a:cubicBezTo>
                <a:lnTo>
                  <a:pt x="518160" y="171450"/>
                </a:lnTo>
                <a:cubicBezTo>
                  <a:pt x="519608" y="175794"/>
                  <a:pt x="523732" y="178784"/>
                  <a:pt x="525780" y="182880"/>
                </a:cubicBezTo>
                <a:cubicBezTo>
                  <a:pt x="527576" y="186472"/>
                  <a:pt x="528320" y="190500"/>
                  <a:pt x="529590" y="194310"/>
                </a:cubicBezTo>
                <a:cubicBezTo>
                  <a:pt x="530860" y="207010"/>
                  <a:pt x="530530" y="219974"/>
                  <a:pt x="533400" y="232410"/>
                </a:cubicBezTo>
                <a:cubicBezTo>
                  <a:pt x="534430" y="236872"/>
                  <a:pt x="539412" y="239553"/>
                  <a:pt x="541020" y="243840"/>
                </a:cubicBezTo>
                <a:cubicBezTo>
                  <a:pt x="543294" y="249903"/>
                  <a:pt x="543705" y="256513"/>
                  <a:pt x="544830" y="262890"/>
                </a:cubicBezTo>
                <a:cubicBezTo>
                  <a:pt x="547515" y="278105"/>
                  <a:pt x="552450" y="308610"/>
                  <a:pt x="552450" y="308610"/>
                </a:cubicBezTo>
                <a:cubicBezTo>
                  <a:pt x="551137" y="319117"/>
                  <a:pt x="550703" y="338774"/>
                  <a:pt x="544830" y="350520"/>
                </a:cubicBezTo>
                <a:cubicBezTo>
                  <a:pt x="542782" y="354616"/>
                  <a:pt x="539258" y="357854"/>
                  <a:pt x="537210" y="361950"/>
                </a:cubicBezTo>
                <a:cubicBezTo>
                  <a:pt x="535414" y="365542"/>
                  <a:pt x="535196" y="369788"/>
                  <a:pt x="533400" y="373380"/>
                </a:cubicBezTo>
                <a:cubicBezTo>
                  <a:pt x="531352" y="377476"/>
                  <a:pt x="527640" y="380626"/>
                  <a:pt x="525780" y="384810"/>
                </a:cubicBezTo>
                <a:cubicBezTo>
                  <a:pt x="522518" y="392150"/>
                  <a:pt x="525780" y="405130"/>
                  <a:pt x="518160" y="407670"/>
                </a:cubicBezTo>
                <a:cubicBezTo>
                  <a:pt x="505525" y="411882"/>
                  <a:pt x="518160" y="413385"/>
                  <a:pt x="514350" y="41529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88" name="フリーフォーム 187"/>
          <p:cNvSpPr/>
          <p:nvPr/>
        </p:nvSpPr>
        <p:spPr>
          <a:xfrm>
            <a:off x="978484" y="2693575"/>
            <a:ext cx="612732" cy="504274"/>
          </a:xfrm>
          <a:custGeom>
            <a:avLst/>
            <a:gdLst>
              <a:gd name="connsiteX0" fmla="*/ 514350 w 552450"/>
              <a:gd name="connsiteY0" fmla="*/ 415290 h 468630"/>
              <a:gd name="connsiteX1" fmla="*/ 495300 w 552450"/>
              <a:gd name="connsiteY1" fmla="*/ 419100 h 468630"/>
              <a:gd name="connsiteX2" fmla="*/ 472440 w 552450"/>
              <a:gd name="connsiteY2" fmla="*/ 426720 h 468630"/>
              <a:gd name="connsiteX3" fmla="*/ 464820 w 552450"/>
              <a:gd name="connsiteY3" fmla="*/ 438150 h 468630"/>
              <a:gd name="connsiteX4" fmla="*/ 453390 w 552450"/>
              <a:gd name="connsiteY4" fmla="*/ 441960 h 468630"/>
              <a:gd name="connsiteX5" fmla="*/ 438150 w 552450"/>
              <a:gd name="connsiteY5" fmla="*/ 449580 h 468630"/>
              <a:gd name="connsiteX6" fmla="*/ 403860 w 552450"/>
              <a:gd name="connsiteY6" fmla="*/ 461010 h 468630"/>
              <a:gd name="connsiteX7" fmla="*/ 392430 w 552450"/>
              <a:gd name="connsiteY7" fmla="*/ 464820 h 468630"/>
              <a:gd name="connsiteX8" fmla="*/ 365760 w 552450"/>
              <a:gd name="connsiteY8" fmla="*/ 468630 h 468630"/>
              <a:gd name="connsiteX9" fmla="*/ 266700 w 552450"/>
              <a:gd name="connsiteY9" fmla="*/ 464820 h 468630"/>
              <a:gd name="connsiteX10" fmla="*/ 232410 w 552450"/>
              <a:gd name="connsiteY10" fmla="*/ 453390 h 468630"/>
              <a:gd name="connsiteX11" fmla="*/ 220980 w 552450"/>
              <a:gd name="connsiteY11" fmla="*/ 449580 h 468630"/>
              <a:gd name="connsiteX12" fmla="*/ 194310 w 552450"/>
              <a:gd name="connsiteY12" fmla="*/ 434340 h 468630"/>
              <a:gd name="connsiteX13" fmla="*/ 182880 w 552450"/>
              <a:gd name="connsiteY13" fmla="*/ 426720 h 468630"/>
              <a:gd name="connsiteX14" fmla="*/ 171450 w 552450"/>
              <a:gd name="connsiteY14" fmla="*/ 411480 h 468630"/>
              <a:gd name="connsiteX15" fmla="*/ 144780 w 552450"/>
              <a:gd name="connsiteY15" fmla="*/ 400050 h 468630"/>
              <a:gd name="connsiteX16" fmla="*/ 121920 w 552450"/>
              <a:gd name="connsiteY16" fmla="*/ 384810 h 468630"/>
              <a:gd name="connsiteX17" fmla="*/ 110490 w 552450"/>
              <a:gd name="connsiteY17" fmla="*/ 373380 h 468630"/>
              <a:gd name="connsiteX18" fmla="*/ 95250 w 552450"/>
              <a:gd name="connsiteY18" fmla="*/ 350520 h 468630"/>
              <a:gd name="connsiteX19" fmla="*/ 80010 w 552450"/>
              <a:gd name="connsiteY19" fmla="*/ 346710 h 468630"/>
              <a:gd name="connsiteX20" fmla="*/ 57150 w 552450"/>
              <a:gd name="connsiteY20" fmla="*/ 327660 h 468630"/>
              <a:gd name="connsiteX21" fmla="*/ 30480 w 552450"/>
              <a:gd name="connsiteY21" fmla="*/ 293370 h 468630"/>
              <a:gd name="connsiteX22" fmla="*/ 19050 w 552450"/>
              <a:gd name="connsiteY22" fmla="*/ 266700 h 468630"/>
              <a:gd name="connsiteX23" fmla="*/ 11430 w 552450"/>
              <a:gd name="connsiteY23" fmla="*/ 255270 h 468630"/>
              <a:gd name="connsiteX24" fmla="*/ 3810 w 552450"/>
              <a:gd name="connsiteY24" fmla="*/ 232410 h 468630"/>
              <a:gd name="connsiteX25" fmla="*/ 0 w 552450"/>
              <a:gd name="connsiteY25" fmla="*/ 220980 h 468630"/>
              <a:gd name="connsiteX26" fmla="*/ 3810 w 552450"/>
              <a:gd name="connsiteY26" fmla="*/ 198120 h 468630"/>
              <a:gd name="connsiteX27" fmla="*/ 7620 w 552450"/>
              <a:gd name="connsiteY27" fmla="*/ 160020 h 468630"/>
              <a:gd name="connsiteX28" fmla="*/ 26670 w 552450"/>
              <a:gd name="connsiteY28" fmla="*/ 140970 h 468630"/>
              <a:gd name="connsiteX29" fmla="*/ 30480 w 552450"/>
              <a:gd name="connsiteY29" fmla="*/ 129540 h 468630"/>
              <a:gd name="connsiteX30" fmla="*/ 49530 w 552450"/>
              <a:gd name="connsiteY30" fmla="*/ 106680 h 468630"/>
              <a:gd name="connsiteX31" fmla="*/ 53340 w 552450"/>
              <a:gd name="connsiteY31" fmla="*/ 95250 h 468630"/>
              <a:gd name="connsiteX32" fmla="*/ 76200 w 552450"/>
              <a:gd name="connsiteY32" fmla="*/ 80010 h 468630"/>
              <a:gd name="connsiteX33" fmla="*/ 95250 w 552450"/>
              <a:gd name="connsiteY33" fmla="*/ 64770 h 468630"/>
              <a:gd name="connsiteX34" fmla="*/ 106680 w 552450"/>
              <a:gd name="connsiteY34" fmla="*/ 57150 h 468630"/>
              <a:gd name="connsiteX35" fmla="*/ 121920 w 552450"/>
              <a:gd name="connsiteY35" fmla="*/ 49530 h 468630"/>
              <a:gd name="connsiteX36" fmla="*/ 133350 w 552450"/>
              <a:gd name="connsiteY36" fmla="*/ 41910 h 468630"/>
              <a:gd name="connsiteX37" fmla="*/ 148590 w 552450"/>
              <a:gd name="connsiteY37" fmla="*/ 38100 h 468630"/>
              <a:gd name="connsiteX38" fmla="*/ 152400 w 552450"/>
              <a:gd name="connsiteY38" fmla="*/ 26670 h 468630"/>
              <a:gd name="connsiteX39" fmla="*/ 163830 w 552450"/>
              <a:gd name="connsiteY39" fmla="*/ 19050 h 468630"/>
              <a:gd name="connsiteX40" fmla="*/ 190500 w 552450"/>
              <a:gd name="connsiteY40" fmla="*/ 0 h 468630"/>
              <a:gd name="connsiteX41" fmla="*/ 297180 w 552450"/>
              <a:gd name="connsiteY41" fmla="*/ 3810 h 468630"/>
              <a:gd name="connsiteX42" fmla="*/ 320040 w 552450"/>
              <a:gd name="connsiteY42" fmla="*/ 22860 h 468630"/>
              <a:gd name="connsiteX43" fmla="*/ 342900 w 552450"/>
              <a:gd name="connsiteY43" fmla="*/ 30480 h 468630"/>
              <a:gd name="connsiteX44" fmla="*/ 369570 w 552450"/>
              <a:gd name="connsiteY44" fmla="*/ 45720 h 468630"/>
              <a:gd name="connsiteX45" fmla="*/ 384810 w 552450"/>
              <a:gd name="connsiteY45" fmla="*/ 49530 h 468630"/>
              <a:gd name="connsiteX46" fmla="*/ 396240 w 552450"/>
              <a:gd name="connsiteY46" fmla="*/ 53340 h 468630"/>
              <a:gd name="connsiteX47" fmla="*/ 415290 w 552450"/>
              <a:gd name="connsiteY47" fmla="*/ 72390 h 468630"/>
              <a:gd name="connsiteX48" fmla="*/ 434340 w 552450"/>
              <a:gd name="connsiteY48" fmla="*/ 95250 h 468630"/>
              <a:gd name="connsiteX49" fmla="*/ 457200 w 552450"/>
              <a:gd name="connsiteY49" fmla="*/ 110490 h 468630"/>
              <a:gd name="connsiteX50" fmla="*/ 468630 w 552450"/>
              <a:gd name="connsiteY50" fmla="*/ 118110 h 468630"/>
              <a:gd name="connsiteX51" fmla="*/ 480060 w 552450"/>
              <a:gd name="connsiteY51" fmla="*/ 121920 h 468630"/>
              <a:gd name="connsiteX52" fmla="*/ 491490 w 552450"/>
              <a:gd name="connsiteY52" fmla="*/ 129540 h 468630"/>
              <a:gd name="connsiteX53" fmla="*/ 510540 w 552450"/>
              <a:gd name="connsiteY53" fmla="*/ 148590 h 468630"/>
              <a:gd name="connsiteX54" fmla="*/ 518160 w 552450"/>
              <a:gd name="connsiteY54" fmla="*/ 171450 h 468630"/>
              <a:gd name="connsiteX55" fmla="*/ 525780 w 552450"/>
              <a:gd name="connsiteY55" fmla="*/ 182880 h 468630"/>
              <a:gd name="connsiteX56" fmla="*/ 529590 w 552450"/>
              <a:gd name="connsiteY56" fmla="*/ 194310 h 468630"/>
              <a:gd name="connsiteX57" fmla="*/ 533400 w 552450"/>
              <a:gd name="connsiteY57" fmla="*/ 232410 h 468630"/>
              <a:gd name="connsiteX58" fmla="*/ 541020 w 552450"/>
              <a:gd name="connsiteY58" fmla="*/ 243840 h 468630"/>
              <a:gd name="connsiteX59" fmla="*/ 544830 w 552450"/>
              <a:gd name="connsiteY59" fmla="*/ 262890 h 468630"/>
              <a:gd name="connsiteX60" fmla="*/ 552450 w 552450"/>
              <a:gd name="connsiteY60" fmla="*/ 308610 h 468630"/>
              <a:gd name="connsiteX61" fmla="*/ 544830 w 552450"/>
              <a:gd name="connsiteY61" fmla="*/ 350520 h 468630"/>
              <a:gd name="connsiteX62" fmla="*/ 537210 w 552450"/>
              <a:gd name="connsiteY62" fmla="*/ 361950 h 468630"/>
              <a:gd name="connsiteX63" fmla="*/ 533400 w 552450"/>
              <a:gd name="connsiteY63" fmla="*/ 373380 h 468630"/>
              <a:gd name="connsiteX64" fmla="*/ 525780 w 552450"/>
              <a:gd name="connsiteY64" fmla="*/ 384810 h 468630"/>
              <a:gd name="connsiteX65" fmla="*/ 518160 w 552450"/>
              <a:gd name="connsiteY65" fmla="*/ 407670 h 468630"/>
              <a:gd name="connsiteX66" fmla="*/ 514350 w 552450"/>
              <a:gd name="connsiteY66" fmla="*/ 415290 h 46863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</a:cxnLst>
            <a:rect l="l" t="t" r="r" b="b"/>
            <a:pathLst>
              <a:path w="552450" h="468630">
                <a:moveTo>
                  <a:pt x="514350" y="415290"/>
                </a:moveTo>
                <a:cubicBezTo>
                  <a:pt x="510540" y="417195"/>
                  <a:pt x="501548" y="417396"/>
                  <a:pt x="495300" y="419100"/>
                </a:cubicBezTo>
                <a:cubicBezTo>
                  <a:pt x="487551" y="421213"/>
                  <a:pt x="472440" y="426720"/>
                  <a:pt x="472440" y="426720"/>
                </a:cubicBezTo>
                <a:cubicBezTo>
                  <a:pt x="469900" y="430530"/>
                  <a:pt x="468396" y="435289"/>
                  <a:pt x="464820" y="438150"/>
                </a:cubicBezTo>
                <a:cubicBezTo>
                  <a:pt x="461684" y="440659"/>
                  <a:pt x="457081" y="440378"/>
                  <a:pt x="453390" y="441960"/>
                </a:cubicBezTo>
                <a:cubicBezTo>
                  <a:pt x="448170" y="444197"/>
                  <a:pt x="443423" y="447471"/>
                  <a:pt x="438150" y="449580"/>
                </a:cubicBezTo>
                <a:lnTo>
                  <a:pt x="403860" y="461010"/>
                </a:lnTo>
                <a:cubicBezTo>
                  <a:pt x="400050" y="462280"/>
                  <a:pt x="396406" y="464252"/>
                  <a:pt x="392430" y="464820"/>
                </a:cubicBezTo>
                <a:lnTo>
                  <a:pt x="365760" y="468630"/>
                </a:lnTo>
                <a:cubicBezTo>
                  <a:pt x="332740" y="467360"/>
                  <a:pt x="299600" y="467904"/>
                  <a:pt x="266700" y="464820"/>
                </a:cubicBezTo>
                <a:lnTo>
                  <a:pt x="232410" y="453390"/>
                </a:lnTo>
                <a:lnTo>
                  <a:pt x="220980" y="449580"/>
                </a:lnTo>
                <a:cubicBezTo>
                  <a:pt x="193133" y="431015"/>
                  <a:pt x="228147" y="453676"/>
                  <a:pt x="194310" y="434340"/>
                </a:cubicBezTo>
                <a:cubicBezTo>
                  <a:pt x="190334" y="432068"/>
                  <a:pt x="186690" y="429260"/>
                  <a:pt x="182880" y="426720"/>
                </a:cubicBezTo>
                <a:cubicBezTo>
                  <a:pt x="179070" y="421640"/>
                  <a:pt x="176271" y="415613"/>
                  <a:pt x="171450" y="411480"/>
                </a:cubicBezTo>
                <a:cubicBezTo>
                  <a:pt x="165458" y="406344"/>
                  <a:pt x="152519" y="402630"/>
                  <a:pt x="144780" y="400050"/>
                </a:cubicBezTo>
                <a:cubicBezTo>
                  <a:pt x="108317" y="363587"/>
                  <a:pt x="155003" y="406866"/>
                  <a:pt x="121920" y="384810"/>
                </a:cubicBezTo>
                <a:cubicBezTo>
                  <a:pt x="117437" y="381821"/>
                  <a:pt x="113798" y="377633"/>
                  <a:pt x="110490" y="373380"/>
                </a:cubicBezTo>
                <a:cubicBezTo>
                  <a:pt x="104867" y="366151"/>
                  <a:pt x="104135" y="352741"/>
                  <a:pt x="95250" y="350520"/>
                </a:cubicBezTo>
                <a:lnTo>
                  <a:pt x="80010" y="346710"/>
                </a:lnTo>
                <a:cubicBezTo>
                  <a:pt x="69850" y="339937"/>
                  <a:pt x="65048" y="337815"/>
                  <a:pt x="57150" y="327660"/>
                </a:cubicBezTo>
                <a:cubicBezTo>
                  <a:pt x="25250" y="286645"/>
                  <a:pt x="56429" y="319319"/>
                  <a:pt x="30480" y="293370"/>
                </a:cubicBezTo>
                <a:cubicBezTo>
                  <a:pt x="26206" y="280547"/>
                  <a:pt x="26583" y="279882"/>
                  <a:pt x="19050" y="266700"/>
                </a:cubicBezTo>
                <a:cubicBezTo>
                  <a:pt x="16778" y="262724"/>
                  <a:pt x="13290" y="259454"/>
                  <a:pt x="11430" y="255270"/>
                </a:cubicBezTo>
                <a:cubicBezTo>
                  <a:pt x="8168" y="247930"/>
                  <a:pt x="6350" y="240030"/>
                  <a:pt x="3810" y="232410"/>
                </a:cubicBezTo>
                <a:lnTo>
                  <a:pt x="0" y="220980"/>
                </a:lnTo>
                <a:cubicBezTo>
                  <a:pt x="1270" y="213360"/>
                  <a:pt x="2852" y="205785"/>
                  <a:pt x="3810" y="198120"/>
                </a:cubicBezTo>
                <a:cubicBezTo>
                  <a:pt x="5393" y="185455"/>
                  <a:pt x="4750" y="172456"/>
                  <a:pt x="7620" y="160020"/>
                </a:cubicBezTo>
                <a:cubicBezTo>
                  <a:pt x="9929" y="150014"/>
                  <a:pt x="19281" y="145896"/>
                  <a:pt x="26670" y="140970"/>
                </a:cubicBezTo>
                <a:cubicBezTo>
                  <a:pt x="27940" y="137160"/>
                  <a:pt x="28684" y="133132"/>
                  <a:pt x="30480" y="129540"/>
                </a:cubicBezTo>
                <a:cubicBezTo>
                  <a:pt x="35784" y="118931"/>
                  <a:pt x="41104" y="115106"/>
                  <a:pt x="49530" y="106680"/>
                </a:cubicBezTo>
                <a:cubicBezTo>
                  <a:pt x="50800" y="102870"/>
                  <a:pt x="51112" y="98592"/>
                  <a:pt x="53340" y="95250"/>
                </a:cubicBezTo>
                <a:cubicBezTo>
                  <a:pt x="61494" y="83019"/>
                  <a:pt x="64217" y="84004"/>
                  <a:pt x="76200" y="80010"/>
                </a:cubicBezTo>
                <a:cubicBezTo>
                  <a:pt x="89045" y="60742"/>
                  <a:pt x="76847" y="73972"/>
                  <a:pt x="95250" y="64770"/>
                </a:cubicBezTo>
                <a:cubicBezTo>
                  <a:pt x="99346" y="62722"/>
                  <a:pt x="102704" y="59422"/>
                  <a:pt x="106680" y="57150"/>
                </a:cubicBezTo>
                <a:cubicBezTo>
                  <a:pt x="111611" y="54332"/>
                  <a:pt x="116989" y="52348"/>
                  <a:pt x="121920" y="49530"/>
                </a:cubicBezTo>
                <a:cubicBezTo>
                  <a:pt x="125896" y="47258"/>
                  <a:pt x="129141" y="43714"/>
                  <a:pt x="133350" y="41910"/>
                </a:cubicBezTo>
                <a:cubicBezTo>
                  <a:pt x="138163" y="39847"/>
                  <a:pt x="143510" y="39370"/>
                  <a:pt x="148590" y="38100"/>
                </a:cubicBezTo>
                <a:cubicBezTo>
                  <a:pt x="149860" y="34290"/>
                  <a:pt x="149891" y="29806"/>
                  <a:pt x="152400" y="26670"/>
                </a:cubicBezTo>
                <a:cubicBezTo>
                  <a:pt x="155261" y="23094"/>
                  <a:pt x="160312" y="21981"/>
                  <a:pt x="163830" y="19050"/>
                </a:cubicBezTo>
                <a:cubicBezTo>
                  <a:pt x="186999" y="-258"/>
                  <a:pt x="162300" y="14100"/>
                  <a:pt x="190500" y="0"/>
                </a:cubicBezTo>
                <a:cubicBezTo>
                  <a:pt x="226060" y="1270"/>
                  <a:pt x="261763" y="383"/>
                  <a:pt x="297180" y="3810"/>
                </a:cubicBezTo>
                <a:cubicBezTo>
                  <a:pt x="305402" y="4606"/>
                  <a:pt x="314423" y="19739"/>
                  <a:pt x="320040" y="22860"/>
                </a:cubicBezTo>
                <a:cubicBezTo>
                  <a:pt x="327061" y="26761"/>
                  <a:pt x="342900" y="30480"/>
                  <a:pt x="342900" y="30480"/>
                </a:cubicBezTo>
                <a:cubicBezTo>
                  <a:pt x="352375" y="36797"/>
                  <a:pt x="358521" y="41577"/>
                  <a:pt x="369570" y="45720"/>
                </a:cubicBezTo>
                <a:cubicBezTo>
                  <a:pt x="374473" y="47559"/>
                  <a:pt x="379775" y="48091"/>
                  <a:pt x="384810" y="49530"/>
                </a:cubicBezTo>
                <a:cubicBezTo>
                  <a:pt x="388672" y="50633"/>
                  <a:pt x="392430" y="52070"/>
                  <a:pt x="396240" y="53340"/>
                </a:cubicBezTo>
                <a:cubicBezTo>
                  <a:pt x="416560" y="83820"/>
                  <a:pt x="389890" y="46990"/>
                  <a:pt x="415290" y="72390"/>
                </a:cubicBezTo>
                <a:cubicBezTo>
                  <a:pt x="437303" y="94403"/>
                  <a:pt x="406252" y="73404"/>
                  <a:pt x="434340" y="95250"/>
                </a:cubicBezTo>
                <a:cubicBezTo>
                  <a:pt x="441569" y="100873"/>
                  <a:pt x="449580" y="105410"/>
                  <a:pt x="457200" y="110490"/>
                </a:cubicBezTo>
                <a:cubicBezTo>
                  <a:pt x="461010" y="113030"/>
                  <a:pt x="464286" y="116662"/>
                  <a:pt x="468630" y="118110"/>
                </a:cubicBezTo>
                <a:lnTo>
                  <a:pt x="480060" y="121920"/>
                </a:lnTo>
                <a:cubicBezTo>
                  <a:pt x="483870" y="124460"/>
                  <a:pt x="488252" y="126302"/>
                  <a:pt x="491490" y="129540"/>
                </a:cubicBezTo>
                <a:cubicBezTo>
                  <a:pt x="516890" y="154940"/>
                  <a:pt x="480060" y="128270"/>
                  <a:pt x="510540" y="148590"/>
                </a:cubicBezTo>
                <a:lnTo>
                  <a:pt x="518160" y="171450"/>
                </a:lnTo>
                <a:cubicBezTo>
                  <a:pt x="519608" y="175794"/>
                  <a:pt x="523732" y="178784"/>
                  <a:pt x="525780" y="182880"/>
                </a:cubicBezTo>
                <a:cubicBezTo>
                  <a:pt x="527576" y="186472"/>
                  <a:pt x="528320" y="190500"/>
                  <a:pt x="529590" y="194310"/>
                </a:cubicBezTo>
                <a:cubicBezTo>
                  <a:pt x="530860" y="207010"/>
                  <a:pt x="530530" y="219974"/>
                  <a:pt x="533400" y="232410"/>
                </a:cubicBezTo>
                <a:cubicBezTo>
                  <a:pt x="534430" y="236872"/>
                  <a:pt x="539412" y="239553"/>
                  <a:pt x="541020" y="243840"/>
                </a:cubicBezTo>
                <a:cubicBezTo>
                  <a:pt x="543294" y="249903"/>
                  <a:pt x="543705" y="256513"/>
                  <a:pt x="544830" y="262890"/>
                </a:cubicBezTo>
                <a:cubicBezTo>
                  <a:pt x="547515" y="278105"/>
                  <a:pt x="552450" y="308610"/>
                  <a:pt x="552450" y="308610"/>
                </a:cubicBezTo>
                <a:cubicBezTo>
                  <a:pt x="551137" y="319117"/>
                  <a:pt x="550703" y="338774"/>
                  <a:pt x="544830" y="350520"/>
                </a:cubicBezTo>
                <a:cubicBezTo>
                  <a:pt x="542782" y="354616"/>
                  <a:pt x="539258" y="357854"/>
                  <a:pt x="537210" y="361950"/>
                </a:cubicBezTo>
                <a:cubicBezTo>
                  <a:pt x="535414" y="365542"/>
                  <a:pt x="535196" y="369788"/>
                  <a:pt x="533400" y="373380"/>
                </a:cubicBezTo>
                <a:cubicBezTo>
                  <a:pt x="531352" y="377476"/>
                  <a:pt x="527640" y="380626"/>
                  <a:pt x="525780" y="384810"/>
                </a:cubicBezTo>
                <a:cubicBezTo>
                  <a:pt x="522518" y="392150"/>
                  <a:pt x="525780" y="405130"/>
                  <a:pt x="518160" y="407670"/>
                </a:cubicBezTo>
                <a:cubicBezTo>
                  <a:pt x="505525" y="411882"/>
                  <a:pt x="518160" y="413385"/>
                  <a:pt x="514350" y="41529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89" name="テキスト ボックス 188"/>
          <p:cNvSpPr txBox="1"/>
          <p:nvPr/>
        </p:nvSpPr>
        <p:spPr>
          <a:xfrm>
            <a:off x="2296755" y="2324628"/>
            <a:ext cx="1032365" cy="253916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</a:t>
            </a:r>
            <a:r>
              <a:rPr lang="en-US" altLang="ja-JP" sz="105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1_1/</a:t>
            </a:r>
            <a:r>
              <a:rPr kumimoji="1" lang="en-US" altLang="ja-JP" sz="105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1_2</a:t>
            </a:r>
            <a:endParaRPr kumimoji="1" lang="ja-JP" altLang="en-US" sz="1050" b="1" dirty="0">
              <a:solidFill>
                <a:srgbClr val="92D05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90" name="テキスト ボックス 189"/>
          <p:cNvSpPr txBox="1"/>
          <p:nvPr/>
        </p:nvSpPr>
        <p:spPr>
          <a:xfrm>
            <a:off x="2325939" y="5095439"/>
            <a:ext cx="1032334" cy="253916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</a:t>
            </a:r>
            <a:r>
              <a:rPr lang="en-US" altLang="ja-JP" sz="105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1_1/</a:t>
            </a:r>
            <a:r>
              <a:rPr kumimoji="1" lang="en-US" altLang="ja-JP" sz="105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1_2</a:t>
            </a:r>
            <a:endParaRPr kumimoji="1" lang="ja-JP" altLang="en-US" sz="1050" b="1" dirty="0">
              <a:solidFill>
                <a:srgbClr val="92D05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91" name="テキスト ボックス 190"/>
          <p:cNvSpPr txBox="1"/>
          <p:nvPr/>
        </p:nvSpPr>
        <p:spPr>
          <a:xfrm>
            <a:off x="4133333" y="2288486"/>
            <a:ext cx="59463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 smtClean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ge</a:t>
            </a:r>
            <a:endParaRPr kumimoji="1" lang="ja-JP" altLang="en-US" sz="1050" b="1" dirty="0">
              <a:solidFill>
                <a:schemeClr val="bg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pic>
        <p:nvPicPr>
          <p:cNvPr id="192" name="Picture 6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0766" y="3739273"/>
            <a:ext cx="1386880" cy="12921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3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8249" y="3729758"/>
            <a:ext cx="1386880" cy="12921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4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6261" y="3730642"/>
            <a:ext cx="1386880" cy="12921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95" name="正方形/長方形 194"/>
          <p:cNvSpPr/>
          <p:nvPr/>
        </p:nvSpPr>
        <p:spPr>
          <a:xfrm flipH="1">
            <a:off x="594250" y="3681518"/>
            <a:ext cx="4093309" cy="8602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96" name="正方形/長方形 195"/>
          <p:cNvSpPr/>
          <p:nvPr/>
        </p:nvSpPr>
        <p:spPr>
          <a:xfrm flipH="1">
            <a:off x="583104" y="5009906"/>
            <a:ext cx="4093309" cy="8602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97" name="テキスト ボックス 196"/>
          <p:cNvSpPr txBox="1"/>
          <p:nvPr/>
        </p:nvSpPr>
        <p:spPr>
          <a:xfrm>
            <a:off x="2277388" y="3754692"/>
            <a:ext cx="1060603" cy="253916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</a:t>
            </a:r>
            <a:r>
              <a:rPr lang="en-US" altLang="ja-JP" sz="105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1_1/</a:t>
            </a:r>
            <a:r>
              <a:rPr kumimoji="1" lang="en-US" altLang="ja-JP" sz="105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1_2</a:t>
            </a:r>
            <a:endParaRPr kumimoji="1" lang="ja-JP" altLang="en-US" sz="1050" b="1" dirty="0">
              <a:solidFill>
                <a:srgbClr val="92D05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200" name="直線コネクタ 199"/>
          <p:cNvCxnSpPr/>
          <p:nvPr/>
        </p:nvCxnSpPr>
        <p:spPr>
          <a:xfrm flipV="1">
            <a:off x="4241795" y="4921505"/>
            <a:ext cx="385440" cy="1096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1" name="フリーフォーム 200"/>
          <p:cNvSpPr/>
          <p:nvPr/>
        </p:nvSpPr>
        <p:spPr>
          <a:xfrm>
            <a:off x="3626093" y="3999889"/>
            <a:ext cx="758825" cy="705921"/>
          </a:xfrm>
          <a:custGeom>
            <a:avLst/>
            <a:gdLst>
              <a:gd name="connsiteX0" fmla="*/ 612775 w 758825"/>
              <a:gd name="connsiteY0" fmla="*/ 679450 h 705921"/>
              <a:gd name="connsiteX1" fmla="*/ 587375 w 758825"/>
              <a:gd name="connsiteY1" fmla="*/ 692150 h 705921"/>
              <a:gd name="connsiteX2" fmla="*/ 549275 w 758825"/>
              <a:gd name="connsiteY2" fmla="*/ 698500 h 705921"/>
              <a:gd name="connsiteX3" fmla="*/ 539750 w 758825"/>
              <a:gd name="connsiteY3" fmla="*/ 701675 h 705921"/>
              <a:gd name="connsiteX4" fmla="*/ 320675 w 758825"/>
              <a:gd name="connsiteY4" fmla="*/ 701675 h 705921"/>
              <a:gd name="connsiteX5" fmla="*/ 301625 w 758825"/>
              <a:gd name="connsiteY5" fmla="*/ 698500 h 705921"/>
              <a:gd name="connsiteX6" fmla="*/ 276225 w 758825"/>
              <a:gd name="connsiteY6" fmla="*/ 692150 h 705921"/>
              <a:gd name="connsiteX7" fmla="*/ 254000 w 758825"/>
              <a:gd name="connsiteY7" fmla="*/ 688975 h 705921"/>
              <a:gd name="connsiteX8" fmla="*/ 234950 w 758825"/>
              <a:gd name="connsiteY8" fmla="*/ 682625 h 705921"/>
              <a:gd name="connsiteX9" fmla="*/ 215900 w 758825"/>
              <a:gd name="connsiteY9" fmla="*/ 673100 h 705921"/>
              <a:gd name="connsiteX10" fmla="*/ 206375 w 758825"/>
              <a:gd name="connsiteY10" fmla="*/ 666750 h 705921"/>
              <a:gd name="connsiteX11" fmla="*/ 187325 w 758825"/>
              <a:gd name="connsiteY11" fmla="*/ 657225 h 705921"/>
              <a:gd name="connsiteX12" fmla="*/ 180975 w 758825"/>
              <a:gd name="connsiteY12" fmla="*/ 647700 h 705921"/>
              <a:gd name="connsiteX13" fmla="*/ 161925 w 758825"/>
              <a:gd name="connsiteY13" fmla="*/ 641350 h 705921"/>
              <a:gd name="connsiteX14" fmla="*/ 155575 w 758825"/>
              <a:gd name="connsiteY14" fmla="*/ 631825 h 705921"/>
              <a:gd name="connsiteX15" fmla="*/ 146050 w 758825"/>
              <a:gd name="connsiteY15" fmla="*/ 628650 h 705921"/>
              <a:gd name="connsiteX16" fmla="*/ 136525 w 758825"/>
              <a:gd name="connsiteY16" fmla="*/ 622300 h 705921"/>
              <a:gd name="connsiteX17" fmla="*/ 117475 w 758825"/>
              <a:gd name="connsiteY17" fmla="*/ 603250 h 705921"/>
              <a:gd name="connsiteX18" fmla="*/ 95250 w 758825"/>
              <a:gd name="connsiteY18" fmla="*/ 577850 h 705921"/>
              <a:gd name="connsiteX19" fmla="*/ 79375 w 758825"/>
              <a:gd name="connsiteY19" fmla="*/ 549275 h 705921"/>
              <a:gd name="connsiteX20" fmla="*/ 73025 w 758825"/>
              <a:gd name="connsiteY20" fmla="*/ 539750 h 705921"/>
              <a:gd name="connsiteX21" fmla="*/ 69850 w 758825"/>
              <a:gd name="connsiteY21" fmla="*/ 530225 h 705921"/>
              <a:gd name="connsiteX22" fmla="*/ 50800 w 758825"/>
              <a:gd name="connsiteY22" fmla="*/ 501650 h 705921"/>
              <a:gd name="connsiteX23" fmla="*/ 47625 w 758825"/>
              <a:gd name="connsiteY23" fmla="*/ 492125 h 705921"/>
              <a:gd name="connsiteX24" fmla="*/ 41275 w 758825"/>
              <a:gd name="connsiteY24" fmla="*/ 482600 h 705921"/>
              <a:gd name="connsiteX25" fmla="*/ 38100 w 758825"/>
              <a:gd name="connsiteY25" fmla="*/ 473075 h 705921"/>
              <a:gd name="connsiteX26" fmla="*/ 31750 w 758825"/>
              <a:gd name="connsiteY26" fmla="*/ 463550 h 705921"/>
              <a:gd name="connsiteX27" fmla="*/ 22225 w 758825"/>
              <a:gd name="connsiteY27" fmla="*/ 431800 h 705921"/>
              <a:gd name="connsiteX28" fmla="*/ 15875 w 758825"/>
              <a:gd name="connsiteY28" fmla="*/ 412750 h 705921"/>
              <a:gd name="connsiteX29" fmla="*/ 9525 w 758825"/>
              <a:gd name="connsiteY29" fmla="*/ 393700 h 705921"/>
              <a:gd name="connsiteX30" fmla="*/ 6350 w 758825"/>
              <a:gd name="connsiteY30" fmla="*/ 384175 h 705921"/>
              <a:gd name="connsiteX31" fmla="*/ 3175 w 758825"/>
              <a:gd name="connsiteY31" fmla="*/ 371475 h 705921"/>
              <a:gd name="connsiteX32" fmla="*/ 0 w 758825"/>
              <a:gd name="connsiteY32" fmla="*/ 330200 h 705921"/>
              <a:gd name="connsiteX33" fmla="*/ 3175 w 758825"/>
              <a:gd name="connsiteY33" fmla="*/ 174625 h 705921"/>
              <a:gd name="connsiteX34" fmla="*/ 9525 w 758825"/>
              <a:gd name="connsiteY34" fmla="*/ 146050 h 705921"/>
              <a:gd name="connsiteX35" fmla="*/ 22225 w 758825"/>
              <a:gd name="connsiteY35" fmla="*/ 127000 h 705921"/>
              <a:gd name="connsiteX36" fmla="*/ 25400 w 758825"/>
              <a:gd name="connsiteY36" fmla="*/ 117475 h 705921"/>
              <a:gd name="connsiteX37" fmla="*/ 38100 w 758825"/>
              <a:gd name="connsiteY37" fmla="*/ 98425 h 705921"/>
              <a:gd name="connsiteX38" fmla="*/ 50800 w 758825"/>
              <a:gd name="connsiteY38" fmla="*/ 79375 h 705921"/>
              <a:gd name="connsiteX39" fmla="*/ 60325 w 758825"/>
              <a:gd name="connsiteY39" fmla="*/ 73025 h 705921"/>
              <a:gd name="connsiteX40" fmla="*/ 66675 w 758825"/>
              <a:gd name="connsiteY40" fmla="*/ 63500 h 705921"/>
              <a:gd name="connsiteX41" fmla="*/ 76200 w 758825"/>
              <a:gd name="connsiteY41" fmla="*/ 60325 h 705921"/>
              <a:gd name="connsiteX42" fmla="*/ 85725 w 758825"/>
              <a:gd name="connsiteY42" fmla="*/ 53975 h 705921"/>
              <a:gd name="connsiteX43" fmla="*/ 104775 w 758825"/>
              <a:gd name="connsiteY43" fmla="*/ 41275 h 705921"/>
              <a:gd name="connsiteX44" fmla="*/ 123825 w 758825"/>
              <a:gd name="connsiteY44" fmla="*/ 31750 h 705921"/>
              <a:gd name="connsiteX45" fmla="*/ 133350 w 758825"/>
              <a:gd name="connsiteY45" fmla="*/ 25400 h 705921"/>
              <a:gd name="connsiteX46" fmla="*/ 152400 w 758825"/>
              <a:gd name="connsiteY46" fmla="*/ 19050 h 705921"/>
              <a:gd name="connsiteX47" fmla="*/ 187325 w 758825"/>
              <a:gd name="connsiteY47" fmla="*/ 9525 h 705921"/>
              <a:gd name="connsiteX48" fmla="*/ 219075 w 758825"/>
              <a:gd name="connsiteY48" fmla="*/ 3175 h 705921"/>
              <a:gd name="connsiteX49" fmla="*/ 234950 w 758825"/>
              <a:gd name="connsiteY49" fmla="*/ 0 h 705921"/>
              <a:gd name="connsiteX50" fmla="*/ 400050 w 758825"/>
              <a:gd name="connsiteY50" fmla="*/ 3175 h 705921"/>
              <a:gd name="connsiteX51" fmla="*/ 431800 w 758825"/>
              <a:gd name="connsiteY51" fmla="*/ 12700 h 705921"/>
              <a:gd name="connsiteX52" fmla="*/ 441325 w 758825"/>
              <a:gd name="connsiteY52" fmla="*/ 15875 h 705921"/>
              <a:gd name="connsiteX53" fmla="*/ 450850 w 758825"/>
              <a:gd name="connsiteY53" fmla="*/ 22225 h 705921"/>
              <a:gd name="connsiteX54" fmla="*/ 460375 w 758825"/>
              <a:gd name="connsiteY54" fmla="*/ 25400 h 705921"/>
              <a:gd name="connsiteX55" fmla="*/ 488950 w 758825"/>
              <a:gd name="connsiteY55" fmla="*/ 44450 h 705921"/>
              <a:gd name="connsiteX56" fmla="*/ 498475 w 758825"/>
              <a:gd name="connsiteY56" fmla="*/ 47625 h 705921"/>
              <a:gd name="connsiteX57" fmla="*/ 527050 w 758825"/>
              <a:gd name="connsiteY57" fmla="*/ 63500 h 705921"/>
              <a:gd name="connsiteX58" fmla="*/ 542925 w 758825"/>
              <a:gd name="connsiteY58" fmla="*/ 79375 h 705921"/>
              <a:gd name="connsiteX59" fmla="*/ 558800 w 758825"/>
              <a:gd name="connsiteY59" fmla="*/ 95250 h 705921"/>
              <a:gd name="connsiteX60" fmla="*/ 571500 w 758825"/>
              <a:gd name="connsiteY60" fmla="*/ 111125 h 705921"/>
              <a:gd name="connsiteX61" fmla="*/ 574675 w 758825"/>
              <a:gd name="connsiteY61" fmla="*/ 120650 h 705921"/>
              <a:gd name="connsiteX62" fmla="*/ 593725 w 758825"/>
              <a:gd name="connsiteY62" fmla="*/ 139700 h 705921"/>
              <a:gd name="connsiteX63" fmla="*/ 606425 w 758825"/>
              <a:gd name="connsiteY63" fmla="*/ 158750 h 705921"/>
              <a:gd name="connsiteX64" fmla="*/ 609600 w 758825"/>
              <a:gd name="connsiteY64" fmla="*/ 168275 h 705921"/>
              <a:gd name="connsiteX65" fmla="*/ 615950 w 758825"/>
              <a:gd name="connsiteY65" fmla="*/ 177800 h 705921"/>
              <a:gd name="connsiteX66" fmla="*/ 619125 w 758825"/>
              <a:gd name="connsiteY66" fmla="*/ 187325 h 705921"/>
              <a:gd name="connsiteX67" fmla="*/ 625475 w 758825"/>
              <a:gd name="connsiteY67" fmla="*/ 196850 h 705921"/>
              <a:gd name="connsiteX68" fmla="*/ 628650 w 758825"/>
              <a:gd name="connsiteY68" fmla="*/ 206375 h 705921"/>
              <a:gd name="connsiteX69" fmla="*/ 635000 w 758825"/>
              <a:gd name="connsiteY69" fmla="*/ 215900 h 705921"/>
              <a:gd name="connsiteX70" fmla="*/ 650875 w 758825"/>
              <a:gd name="connsiteY70" fmla="*/ 241300 h 705921"/>
              <a:gd name="connsiteX71" fmla="*/ 654050 w 758825"/>
              <a:gd name="connsiteY71" fmla="*/ 250825 h 705921"/>
              <a:gd name="connsiteX72" fmla="*/ 660400 w 758825"/>
              <a:gd name="connsiteY72" fmla="*/ 260350 h 705921"/>
              <a:gd name="connsiteX73" fmla="*/ 663575 w 758825"/>
              <a:gd name="connsiteY73" fmla="*/ 273050 h 705921"/>
              <a:gd name="connsiteX74" fmla="*/ 676275 w 758825"/>
              <a:gd name="connsiteY74" fmla="*/ 292100 h 705921"/>
              <a:gd name="connsiteX75" fmla="*/ 688975 w 758825"/>
              <a:gd name="connsiteY75" fmla="*/ 311150 h 705921"/>
              <a:gd name="connsiteX76" fmla="*/ 695325 w 758825"/>
              <a:gd name="connsiteY76" fmla="*/ 320675 h 705921"/>
              <a:gd name="connsiteX77" fmla="*/ 704850 w 758825"/>
              <a:gd name="connsiteY77" fmla="*/ 327025 h 705921"/>
              <a:gd name="connsiteX78" fmla="*/ 714375 w 758825"/>
              <a:gd name="connsiteY78" fmla="*/ 346075 h 705921"/>
              <a:gd name="connsiteX79" fmla="*/ 723900 w 758825"/>
              <a:gd name="connsiteY79" fmla="*/ 352425 h 705921"/>
              <a:gd name="connsiteX80" fmla="*/ 727075 w 758825"/>
              <a:gd name="connsiteY80" fmla="*/ 361950 h 705921"/>
              <a:gd name="connsiteX81" fmla="*/ 742950 w 758825"/>
              <a:gd name="connsiteY81" fmla="*/ 377825 h 705921"/>
              <a:gd name="connsiteX82" fmla="*/ 749300 w 758825"/>
              <a:gd name="connsiteY82" fmla="*/ 396875 h 705921"/>
              <a:gd name="connsiteX83" fmla="*/ 755650 w 758825"/>
              <a:gd name="connsiteY83" fmla="*/ 419100 h 705921"/>
              <a:gd name="connsiteX84" fmla="*/ 758825 w 758825"/>
              <a:gd name="connsiteY84" fmla="*/ 438150 h 705921"/>
              <a:gd name="connsiteX85" fmla="*/ 755650 w 758825"/>
              <a:gd name="connsiteY85" fmla="*/ 523875 h 705921"/>
              <a:gd name="connsiteX86" fmla="*/ 749300 w 758825"/>
              <a:gd name="connsiteY86" fmla="*/ 542925 h 705921"/>
              <a:gd name="connsiteX87" fmla="*/ 746125 w 758825"/>
              <a:gd name="connsiteY87" fmla="*/ 552450 h 705921"/>
              <a:gd name="connsiteX88" fmla="*/ 739775 w 758825"/>
              <a:gd name="connsiteY88" fmla="*/ 561975 h 705921"/>
              <a:gd name="connsiteX89" fmla="*/ 723900 w 758825"/>
              <a:gd name="connsiteY89" fmla="*/ 590550 h 705921"/>
              <a:gd name="connsiteX90" fmla="*/ 720725 w 758825"/>
              <a:gd name="connsiteY90" fmla="*/ 600075 h 705921"/>
              <a:gd name="connsiteX91" fmla="*/ 711200 w 758825"/>
              <a:gd name="connsiteY91" fmla="*/ 606425 h 705921"/>
              <a:gd name="connsiteX92" fmla="*/ 695325 w 758825"/>
              <a:gd name="connsiteY92" fmla="*/ 619125 h 705921"/>
              <a:gd name="connsiteX93" fmla="*/ 688975 w 758825"/>
              <a:gd name="connsiteY93" fmla="*/ 628650 h 705921"/>
              <a:gd name="connsiteX94" fmla="*/ 669925 w 758825"/>
              <a:gd name="connsiteY94" fmla="*/ 635000 h 705921"/>
              <a:gd name="connsiteX95" fmla="*/ 654050 w 758825"/>
              <a:gd name="connsiteY95" fmla="*/ 654050 h 705921"/>
              <a:gd name="connsiteX96" fmla="*/ 644525 w 758825"/>
              <a:gd name="connsiteY96" fmla="*/ 657225 h 705921"/>
              <a:gd name="connsiteX97" fmla="*/ 628650 w 758825"/>
              <a:gd name="connsiteY97" fmla="*/ 673100 h 705921"/>
              <a:gd name="connsiteX98" fmla="*/ 606425 w 758825"/>
              <a:gd name="connsiteY98" fmla="*/ 698500 h 705921"/>
              <a:gd name="connsiteX99" fmla="*/ 590550 w 758825"/>
              <a:gd name="connsiteY99" fmla="*/ 701675 h 705921"/>
              <a:gd name="connsiteX100" fmla="*/ 565150 w 758825"/>
              <a:gd name="connsiteY100" fmla="*/ 701675 h 70592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</a:cxnLst>
            <a:rect l="l" t="t" r="r" b="b"/>
            <a:pathLst>
              <a:path w="758825" h="705921">
                <a:moveTo>
                  <a:pt x="612775" y="679450"/>
                </a:moveTo>
                <a:cubicBezTo>
                  <a:pt x="603483" y="685025"/>
                  <a:pt x="597628" y="690099"/>
                  <a:pt x="587375" y="692150"/>
                </a:cubicBezTo>
                <a:cubicBezTo>
                  <a:pt x="574750" y="694675"/>
                  <a:pt x="549275" y="698500"/>
                  <a:pt x="549275" y="698500"/>
                </a:cubicBezTo>
                <a:cubicBezTo>
                  <a:pt x="546100" y="699558"/>
                  <a:pt x="543063" y="701202"/>
                  <a:pt x="539750" y="701675"/>
                </a:cubicBezTo>
                <a:cubicBezTo>
                  <a:pt x="474856" y="710946"/>
                  <a:pt x="352808" y="702229"/>
                  <a:pt x="320675" y="701675"/>
                </a:cubicBezTo>
                <a:cubicBezTo>
                  <a:pt x="314325" y="700617"/>
                  <a:pt x="307920" y="699849"/>
                  <a:pt x="301625" y="698500"/>
                </a:cubicBezTo>
                <a:cubicBezTo>
                  <a:pt x="293091" y="696671"/>
                  <a:pt x="284865" y="693384"/>
                  <a:pt x="276225" y="692150"/>
                </a:cubicBezTo>
                <a:lnTo>
                  <a:pt x="254000" y="688975"/>
                </a:lnTo>
                <a:cubicBezTo>
                  <a:pt x="247650" y="686858"/>
                  <a:pt x="240519" y="686338"/>
                  <a:pt x="234950" y="682625"/>
                </a:cubicBezTo>
                <a:cubicBezTo>
                  <a:pt x="222640" y="674419"/>
                  <a:pt x="229045" y="677482"/>
                  <a:pt x="215900" y="673100"/>
                </a:cubicBezTo>
                <a:cubicBezTo>
                  <a:pt x="212725" y="670983"/>
                  <a:pt x="209788" y="668457"/>
                  <a:pt x="206375" y="666750"/>
                </a:cubicBezTo>
                <a:cubicBezTo>
                  <a:pt x="180085" y="653605"/>
                  <a:pt x="214622" y="675423"/>
                  <a:pt x="187325" y="657225"/>
                </a:cubicBezTo>
                <a:cubicBezTo>
                  <a:pt x="185208" y="654050"/>
                  <a:pt x="184211" y="649722"/>
                  <a:pt x="180975" y="647700"/>
                </a:cubicBezTo>
                <a:cubicBezTo>
                  <a:pt x="175299" y="644152"/>
                  <a:pt x="161925" y="641350"/>
                  <a:pt x="161925" y="641350"/>
                </a:cubicBezTo>
                <a:cubicBezTo>
                  <a:pt x="159808" y="638175"/>
                  <a:pt x="158555" y="634209"/>
                  <a:pt x="155575" y="631825"/>
                </a:cubicBezTo>
                <a:cubicBezTo>
                  <a:pt x="152962" y="629734"/>
                  <a:pt x="149043" y="630147"/>
                  <a:pt x="146050" y="628650"/>
                </a:cubicBezTo>
                <a:cubicBezTo>
                  <a:pt x="142637" y="626943"/>
                  <a:pt x="139377" y="624835"/>
                  <a:pt x="136525" y="622300"/>
                </a:cubicBezTo>
                <a:cubicBezTo>
                  <a:pt x="129813" y="616334"/>
                  <a:pt x="122456" y="610722"/>
                  <a:pt x="117475" y="603250"/>
                </a:cubicBezTo>
                <a:cubicBezTo>
                  <a:pt x="102658" y="581025"/>
                  <a:pt x="111125" y="588433"/>
                  <a:pt x="95250" y="577850"/>
                </a:cubicBezTo>
                <a:cubicBezTo>
                  <a:pt x="89662" y="561085"/>
                  <a:pt x="93931" y="571110"/>
                  <a:pt x="79375" y="549275"/>
                </a:cubicBezTo>
                <a:cubicBezTo>
                  <a:pt x="77258" y="546100"/>
                  <a:pt x="74232" y="543370"/>
                  <a:pt x="73025" y="539750"/>
                </a:cubicBezTo>
                <a:cubicBezTo>
                  <a:pt x="71967" y="536575"/>
                  <a:pt x="71475" y="533151"/>
                  <a:pt x="69850" y="530225"/>
                </a:cubicBezTo>
                <a:lnTo>
                  <a:pt x="50800" y="501650"/>
                </a:lnTo>
                <a:cubicBezTo>
                  <a:pt x="48944" y="498865"/>
                  <a:pt x="49122" y="495118"/>
                  <a:pt x="47625" y="492125"/>
                </a:cubicBezTo>
                <a:cubicBezTo>
                  <a:pt x="45918" y="488712"/>
                  <a:pt x="42982" y="486013"/>
                  <a:pt x="41275" y="482600"/>
                </a:cubicBezTo>
                <a:cubicBezTo>
                  <a:pt x="39778" y="479607"/>
                  <a:pt x="39597" y="476068"/>
                  <a:pt x="38100" y="473075"/>
                </a:cubicBezTo>
                <a:cubicBezTo>
                  <a:pt x="36393" y="469662"/>
                  <a:pt x="33300" y="467037"/>
                  <a:pt x="31750" y="463550"/>
                </a:cubicBezTo>
                <a:cubicBezTo>
                  <a:pt x="24842" y="448007"/>
                  <a:pt x="26488" y="446008"/>
                  <a:pt x="22225" y="431800"/>
                </a:cubicBezTo>
                <a:cubicBezTo>
                  <a:pt x="20302" y="425389"/>
                  <a:pt x="17992" y="419100"/>
                  <a:pt x="15875" y="412750"/>
                </a:cubicBezTo>
                <a:lnTo>
                  <a:pt x="9525" y="393700"/>
                </a:lnTo>
                <a:cubicBezTo>
                  <a:pt x="8467" y="390525"/>
                  <a:pt x="7162" y="387422"/>
                  <a:pt x="6350" y="384175"/>
                </a:cubicBezTo>
                <a:lnTo>
                  <a:pt x="3175" y="371475"/>
                </a:lnTo>
                <a:cubicBezTo>
                  <a:pt x="2117" y="357717"/>
                  <a:pt x="0" y="343999"/>
                  <a:pt x="0" y="330200"/>
                </a:cubicBezTo>
                <a:cubicBezTo>
                  <a:pt x="0" y="278331"/>
                  <a:pt x="1290" y="226460"/>
                  <a:pt x="3175" y="174625"/>
                </a:cubicBezTo>
                <a:cubicBezTo>
                  <a:pt x="3316" y="170753"/>
                  <a:pt x="6178" y="152075"/>
                  <a:pt x="9525" y="146050"/>
                </a:cubicBezTo>
                <a:cubicBezTo>
                  <a:pt x="13231" y="139379"/>
                  <a:pt x="17992" y="133350"/>
                  <a:pt x="22225" y="127000"/>
                </a:cubicBezTo>
                <a:cubicBezTo>
                  <a:pt x="24081" y="124215"/>
                  <a:pt x="23775" y="120401"/>
                  <a:pt x="25400" y="117475"/>
                </a:cubicBezTo>
                <a:cubicBezTo>
                  <a:pt x="29106" y="110804"/>
                  <a:pt x="33867" y="104775"/>
                  <a:pt x="38100" y="98425"/>
                </a:cubicBezTo>
                <a:lnTo>
                  <a:pt x="50800" y="79375"/>
                </a:lnTo>
                <a:cubicBezTo>
                  <a:pt x="52917" y="76200"/>
                  <a:pt x="57150" y="75142"/>
                  <a:pt x="60325" y="73025"/>
                </a:cubicBezTo>
                <a:cubicBezTo>
                  <a:pt x="62442" y="69850"/>
                  <a:pt x="63695" y="65884"/>
                  <a:pt x="66675" y="63500"/>
                </a:cubicBezTo>
                <a:cubicBezTo>
                  <a:pt x="69288" y="61409"/>
                  <a:pt x="73207" y="61822"/>
                  <a:pt x="76200" y="60325"/>
                </a:cubicBezTo>
                <a:cubicBezTo>
                  <a:pt x="79613" y="58618"/>
                  <a:pt x="82794" y="56418"/>
                  <a:pt x="85725" y="53975"/>
                </a:cubicBezTo>
                <a:cubicBezTo>
                  <a:pt x="101580" y="40762"/>
                  <a:pt x="88036" y="46855"/>
                  <a:pt x="104775" y="41275"/>
                </a:cubicBezTo>
                <a:cubicBezTo>
                  <a:pt x="132072" y="23077"/>
                  <a:pt x="97535" y="44895"/>
                  <a:pt x="123825" y="31750"/>
                </a:cubicBezTo>
                <a:cubicBezTo>
                  <a:pt x="127238" y="30043"/>
                  <a:pt x="129863" y="26950"/>
                  <a:pt x="133350" y="25400"/>
                </a:cubicBezTo>
                <a:cubicBezTo>
                  <a:pt x="139467" y="22682"/>
                  <a:pt x="146050" y="21167"/>
                  <a:pt x="152400" y="19050"/>
                </a:cubicBezTo>
                <a:cubicBezTo>
                  <a:pt x="170204" y="13115"/>
                  <a:pt x="158678" y="16687"/>
                  <a:pt x="187325" y="9525"/>
                </a:cubicBezTo>
                <a:cubicBezTo>
                  <a:pt x="197796" y="6907"/>
                  <a:pt x="208492" y="5292"/>
                  <a:pt x="219075" y="3175"/>
                </a:cubicBezTo>
                <a:lnTo>
                  <a:pt x="234950" y="0"/>
                </a:lnTo>
                <a:lnTo>
                  <a:pt x="400050" y="3175"/>
                </a:lnTo>
                <a:cubicBezTo>
                  <a:pt x="405424" y="3367"/>
                  <a:pt x="429808" y="12036"/>
                  <a:pt x="431800" y="12700"/>
                </a:cubicBezTo>
                <a:lnTo>
                  <a:pt x="441325" y="15875"/>
                </a:lnTo>
                <a:cubicBezTo>
                  <a:pt x="444500" y="17992"/>
                  <a:pt x="447437" y="20518"/>
                  <a:pt x="450850" y="22225"/>
                </a:cubicBezTo>
                <a:cubicBezTo>
                  <a:pt x="453843" y="23722"/>
                  <a:pt x="457449" y="23775"/>
                  <a:pt x="460375" y="25400"/>
                </a:cubicBezTo>
                <a:lnTo>
                  <a:pt x="488950" y="44450"/>
                </a:lnTo>
                <a:cubicBezTo>
                  <a:pt x="491735" y="46306"/>
                  <a:pt x="495300" y="46567"/>
                  <a:pt x="498475" y="47625"/>
                </a:cubicBezTo>
                <a:cubicBezTo>
                  <a:pt x="520310" y="62181"/>
                  <a:pt x="510285" y="57912"/>
                  <a:pt x="527050" y="63500"/>
                </a:cubicBezTo>
                <a:cubicBezTo>
                  <a:pt x="543983" y="88900"/>
                  <a:pt x="521758" y="58208"/>
                  <a:pt x="542925" y="79375"/>
                </a:cubicBezTo>
                <a:cubicBezTo>
                  <a:pt x="564092" y="100542"/>
                  <a:pt x="533400" y="78317"/>
                  <a:pt x="558800" y="95250"/>
                </a:cubicBezTo>
                <a:cubicBezTo>
                  <a:pt x="566780" y="119191"/>
                  <a:pt x="555087" y="90609"/>
                  <a:pt x="571500" y="111125"/>
                </a:cubicBezTo>
                <a:cubicBezTo>
                  <a:pt x="573591" y="113738"/>
                  <a:pt x="572620" y="118008"/>
                  <a:pt x="574675" y="120650"/>
                </a:cubicBezTo>
                <a:cubicBezTo>
                  <a:pt x="580188" y="127739"/>
                  <a:pt x="593725" y="139700"/>
                  <a:pt x="593725" y="139700"/>
                </a:cubicBezTo>
                <a:cubicBezTo>
                  <a:pt x="601274" y="162348"/>
                  <a:pt x="590570" y="134967"/>
                  <a:pt x="606425" y="158750"/>
                </a:cubicBezTo>
                <a:cubicBezTo>
                  <a:pt x="608281" y="161535"/>
                  <a:pt x="608103" y="165282"/>
                  <a:pt x="609600" y="168275"/>
                </a:cubicBezTo>
                <a:cubicBezTo>
                  <a:pt x="611307" y="171688"/>
                  <a:pt x="614243" y="174387"/>
                  <a:pt x="615950" y="177800"/>
                </a:cubicBezTo>
                <a:cubicBezTo>
                  <a:pt x="617447" y="180793"/>
                  <a:pt x="617628" y="184332"/>
                  <a:pt x="619125" y="187325"/>
                </a:cubicBezTo>
                <a:cubicBezTo>
                  <a:pt x="620832" y="190738"/>
                  <a:pt x="623768" y="193437"/>
                  <a:pt x="625475" y="196850"/>
                </a:cubicBezTo>
                <a:cubicBezTo>
                  <a:pt x="626972" y="199843"/>
                  <a:pt x="627153" y="203382"/>
                  <a:pt x="628650" y="206375"/>
                </a:cubicBezTo>
                <a:cubicBezTo>
                  <a:pt x="630357" y="209788"/>
                  <a:pt x="633450" y="212413"/>
                  <a:pt x="635000" y="215900"/>
                </a:cubicBezTo>
                <a:cubicBezTo>
                  <a:pt x="646136" y="240956"/>
                  <a:pt x="633740" y="229877"/>
                  <a:pt x="650875" y="241300"/>
                </a:cubicBezTo>
                <a:cubicBezTo>
                  <a:pt x="651933" y="244475"/>
                  <a:pt x="652553" y="247832"/>
                  <a:pt x="654050" y="250825"/>
                </a:cubicBezTo>
                <a:cubicBezTo>
                  <a:pt x="655757" y="254238"/>
                  <a:pt x="658897" y="256843"/>
                  <a:pt x="660400" y="260350"/>
                </a:cubicBezTo>
                <a:cubicBezTo>
                  <a:pt x="662119" y="264361"/>
                  <a:pt x="661624" y="269147"/>
                  <a:pt x="663575" y="273050"/>
                </a:cubicBezTo>
                <a:cubicBezTo>
                  <a:pt x="666988" y="279876"/>
                  <a:pt x="672042" y="285750"/>
                  <a:pt x="676275" y="292100"/>
                </a:cubicBezTo>
                <a:lnTo>
                  <a:pt x="688975" y="311150"/>
                </a:lnTo>
                <a:cubicBezTo>
                  <a:pt x="691092" y="314325"/>
                  <a:pt x="692150" y="318558"/>
                  <a:pt x="695325" y="320675"/>
                </a:cubicBezTo>
                <a:lnTo>
                  <a:pt x="704850" y="327025"/>
                </a:lnTo>
                <a:cubicBezTo>
                  <a:pt x="707432" y="334772"/>
                  <a:pt x="708220" y="339920"/>
                  <a:pt x="714375" y="346075"/>
                </a:cubicBezTo>
                <a:cubicBezTo>
                  <a:pt x="717073" y="348773"/>
                  <a:pt x="720725" y="350308"/>
                  <a:pt x="723900" y="352425"/>
                </a:cubicBezTo>
                <a:cubicBezTo>
                  <a:pt x="724958" y="355600"/>
                  <a:pt x="724984" y="359337"/>
                  <a:pt x="727075" y="361950"/>
                </a:cubicBezTo>
                <a:cubicBezTo>
                  <a:pt x="740833" y="379148"/>
                  <a:pt x="733425" y="356394"/>
                  <a:pt x="742950" y="377825"/>
                </a:cubicBezTo>
                <a:cubicBezTo>
                  <a:pt x="745668" y="383942"/>
                  <a:pt x="747183" y="390525"/>
                  <a:pt x="749300" y="396875"/>
                </a:cubicBezTo>
                <a:cubicBezTo>
                  <a:pt x="752326" y="405953"/>
                  <a:pt x="753657" y="409133"/>
                  <a:pt x="755650" y="419100"/>
                </a:cubicBezTo>
                <a:cubicBezTo>
                  <a:pt x="756913" y="425413"/>
                  <a:pt x="757767" y="431800"/>
                  <a:pt x="758825" y="438150"/>
                </a:cubicBezTo>
                <a:cubicBezTo>
                  <a:pt x="757767" y="466725"/>
                  <a:pt x="758239" y="495398"/>
                  <a:pt x="755650" y="523875"/>
                </a:cubicBezTo>
                <a:cubicBezTo>
                  <a:pt x="755044" y="530541"/>
                  <a:pt x="751417" y="536575"/>
                  <a:pt x="749300" y="542925"/>
                </a:cubicBezTo>
                <a:cubicBezTo>
                  <a:pt x="748242" y="546100"/>
                  <a:pt x="747981" y="549665"/>
                  <a:pt x="746125" y="552450"/>
                </a:cubicBezTo>
                <a:cubicBezTo>
                  <a:pt x="744008" y="555625"/>
                  <a:pt x="741482" y="558562"/>
                  <a:pt x="739775" y="561975"/>
                </a:cubicBezTo>
                <a:cubicBezTo>
                  <a:pt x="723010" y="595505"/>
                  <a:pt x="763943" y="530485"/>
                  <a:pt x="723900" y="590550"/>
                </a:cubicBezTo>
                <a:cubicBezTo>
                  <a:pt x="722044" y="593335"/>
                  <a:pt x="722816" y="597462"/>
                  <a:pt x="720725" y="600075"/>
                </a:cubicBezTo>
                <a:cubicBezTo>
                  <a:pt x="718341" y="603055"/>
                  <a:pt x="714375" y="604308"/>
                  <a:pt x="711200" y="606425"/>
                </a:cubicBezTo>
                <a:cubicBezTo>
                  <a:pt x="693002" y="633722"/>
                  <a:pt x="717233" y="601598"/>
                  <a:pt x="695325" y="619125"/>
                </a:cubicBezTo>
                <a:cubicBezTo>
                  <a:pt x="692345" y="621509"/>
                  <a:pt x="692211" y="626628"/>
                  <a:pt x="688975" y="628650"/>
                </a:cubicBezTo>
                <a:cubicBezTo>
                  <a:pt x="683299" y="632198"/>
                  <a:pt x="669925" y="635000"/>
                  <a:pt x="669925" y="635000"/>
                </a:cubicBezTo>
                <a:cubicBezTo>
                  <a:pt x="665239" y="642028"/>
                  <a:pt x="661384" y="649161"/>
                  <a:pt x="654050" y="654050"/>
                </a:cubicBezTo>
                <a:cubicBezTo>
                  <a:pt x="651265" y="655906"/>
                  <a:pt x="647700" y="656167"/>
                  <a:pt x="644525" y="657225"/>
                </a:cubicBezTo>
                <a:cubicBezTo>
                  <a:pt x="619125" y="695325"/>
                  <a:pt x="658283" y="639233"/>
                  <a:pt x="628650" y="673100"/>
                </a:cubicBezTo>
                <a:cubicBezTo>
                  <a:pt x="619002" y="684126"/>
                  <a:pt x="619716" y="693516"/>
                  <a:pt x="606425" y="698500"/>
                </a:cubicBezTo>
                <a:cubicBezTo>
                  <a:pt x="601372" y="700395"/>
                  <a:pt x="595931" y="701261"/>
                  <a:pt x="590550" y="701675"/>
                </a:cubicBezTo>
                <a:cubicBezTo>
                  <a:pt x="582108" y="702324"/>
                  <a:pt x="573617" y="701675"/>
                  <a:pt x="565150" y="701675"/>
                </a:cubicBezTo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02" name="フリーフォーム 201"/>
          <p:cNvSpPr/>
          <p:nvPr/>
        </p:nvSpPr>
        <p:spPr>
          <a:xfrm>
            <a:off x="2277388" y="3996069"/>
            <a:ext cx="758825" cy="705921"/>
          </a:xfrm>
          <a:custGeom>
            <a:avLst/>
            <a:gdLst>
              <a:gd name="connsiteX0" fmla="*/ 612775 w 758825"/>
              <a:gd name="connsiteY0" fmla="*/ 679450 h 705921"/>
              <a:gd name="connsiteX1" fmla="*/ 587375 w 758825"/>
              <a:gd name="connsiteY1" fmla="*/ 692150 h 705921"/>
              <a:gd name="connsiteX2" fmla="*/ 549275 w 758825"/>
              <a:gd name="connsiteY2" fmla="*/ 698500 h 705921"/>
              <a:gd name="connsiteX3" fmla="*/ 539750 w 758825"/>
              <a:gd name="connsiteY3" fmla="*/ 701675 h 705921"/>
              <a:gd name="connsiteX4" fmla="*/ 320675 w 758825"/>
              <a:gd name="connsiteY4" fmla="*/ 701675 h 705921"/>
              <a:gd name="connsiteX5" fmla="*/ 301625 w 758825"/>
              <a:gd name="connsiteY5" fmla="*/ 698500 h 705921"/>
              <a:gd name="connsiteX6" fmla="*/ 276225 w 758825"/>
              <a:gd name="connsiteY6" fmla="*/ 692150 h 705921"/>
              <a:gd name="connsiteX7" fmla="*/ 254000 w 758825"/>
              <a:gd name="connsiteY7" fmla="*/ 688975 h 705921"/>
              <a:gd name="connsiteX8" fmla="*/ 234950 w 758825"/>
              <a:gd name="connsiteY8" fmla="*/ 682625 h 705921"/>
              <a:gd name="connsiteX9" fmla="*/ 215900 w 758825"/>
              <a:gd name="connsiteY9" fmla="*/ 673100 h 705921"/>
              <a:gd name="connsiteX10" fmla="*/ 206375 w 758825"/>
              <a:gd name="connsiteY10" fmla="*/ 666750 h 705921"/>
              <a:gd name="connsiteX11" fmla="*/ 187325 w 758825"/>
              <a:gd name="connsiteY11" fmla="*/ 657225 h 705921"/>
              <a:gd name="connsiteX12" fmla="*/ 180975 w 758825"/>
              <a:gd name="connsiteY12" fmla="*/ 647700 h 705921"/>
              <a:gd name="connsiteX13" fmla="*/ 161925 w 758825"/>
              <a:gd name="connsiteY13" fmla="*/ 641350 h 705921"/>
              <a:gd name="connsiteX14" fmla="*/ 155575 w 758825"/>
              <a:gd name="connsiteY14" fmla="*/ 631825 h 705921"/>
              <a:gd name="connsiteX15" fmla="*/ 146050 w 758825"/>
              <a:gd name="connsiteY15" fmla="*/ 628650 h 705921"/>
              <a:gd name="connsiteX16" fmla="*/ 136525 w 758825"/>
              <a:gd name="connsiteY16" fmla="*/ 622300 h 705921"/>
              <a:gd name="connsiteX17" fmla="*/ 117475 w 758825"/>
              <a:gd name="connsiteY17" fmla="*/ 603250 h 705921"/>
              <a:gd name="connsiteX18" fmla="*/ 95250 w 758825"/>
              <a:gd name="connsiteY18" fmla="*/ 577850 h 705921"/>
              <a:gd name="connsiteX19" fmla="*/ 79375 w 758825"/>
              <a:gd name="connsiteY19" fmla="*/ 549275 h 705921"/>
              <a:gd name="connsiteX20" fmla="*/ 73025 w 758825"/>
              <a:gd name="connsiteY20" fmla="*/ 539750 h 705921"/>
              <a:gd name="connsiteX21" fmla="*/ 69850 w 758825"/>
              <a:gd name="connsiteY21" fmla="*/ 530225 h 705921"/>
              <a:gd name="connsiteX22" fmla="*/ 50800 w 758825"/>
              <a:gd name="connsiteY22" fmla="*/ 501650 h 705921"/>
              <a:gd name="connsiteX23" fmla="*/ 47625 w 758825"/>
              <a:gd name="connsiteY23" fmla="*/ 492125 h 705921"/>
              <a:gd name="connsiteX24" fmla="*/ 41275 w 758825"/>
              <a:gd name="connsiteY24" fmla="*/ 482600 h 705921"/>
              <a:gd name="connsiteX25" fmla="*/ 38100 w 758825"/>
              <a:gd name="connsiteY25" fmla="*/ 473075 h 705921"/>
              <a:gd name="connsiteX26" fmla="*/ 31750 w 758825"/>
              <a:gd name="connsiteY26" fmla="*/ 463550 h 705921"/>
              <a:gd name="connsiteX27" fmla="*/ 22225 w 758825"/>
              <a:gd name="connsiteY27" fmla="*/ 431800 h 705921"/>
              <a:gd name="connsiteX28" fmla="*/ 15875 w 758825"/>
              <a:gd name="connsiteY28" fmla="*/ 412750 h 705921"/>
              <a:gd name="connsiteX29" fmla="*/ 9525 w 758825"/>
              <a:gd name="connsiteY29" fmla="*/ 393700 h 705921"/>
              <a:gd name="connsiteX30" fmla="*/ 6350 w 758825"/>
              <a:gd name="connsiteY30" fmla="*/ 384175 h 705921"/>
              <a:gd name="connsiteX31" fmla="*/ 3175 w 758825"/>
              <a:gd name="connsiteY31" fmla="*/ 371475 h 705921"/>
              <a:gd name="connsiteX32" fmla="*/ 0 w 758825"/>
              <a:gd name="connsiteY32" fmla="*/ 330200 h 705921"/>
              <a:gd name="connsiteX33" fmla="*/ 3175 w 758825"/>
              <a:gd name="connsiteY33" fmla="*/ 174625 h 705921"/>
              <a:gd name="connsiteX34" fmla="*/ 9525 w 758825"/>
              <a:gd name="connsiteY34" fmla="*/ 146050 h 705921"/>
              <a:gd name="connsiteX35" fmla="*/ 22225 w 758825"/>
              <a:gd name="connsiteY35" fmla="*/ 127000 h 705921"/>
              <a:gd name="connsiteX36" fmla="*/ 25400 w 758825"/>
              <a:gd name="connsiteY36" fmla="*/ 117475 h 705921"/>
              <a:gd name="connsiteX37" fmla="*/ 38100 w 758825"/>
              <a:gd name="connsiteY37" fmla="*/ 98425 h 705921"/>
              <a:gd name="connsiteX38" fmla="*/ 50800 w 758825"/>
              <a:gd name="connsiteY38" fmla="*/ 79375 h 705921"/>
              <a:gd name="connsiteX39" fmla="*/ 60325 w 758825"/>
              <a:gd name="connsiteY39" fmla="*/ 73025 h 705921"/>
              <a:gd name="connsiteX40" fmla="*/ 66675 w 758825"/>
              <a:gd name="connsiteY40" fmla="*/ 63500 h 705921"/>
              <a:gd name="connsiteX41" fmla="*/ 76200 w 758825"/>
              <a:gd name="connsiteY41" fmla="*/ 60325 h 705921"/>
              <a:gd name="connsiteX42" fmla="*/ 85725 w 758825"/>
              <a:gd name="connsiteY42" fmla="*/ 53975 h 705921"/>
              <a:gd name="connsiteX43" fmla="*/ 104775 w 758825"/>
              <a:gd name="connsiteY43" fmla="*/ 41275 h 705921"/>
              <a:gd name="connsiteX44" fmla="*/ 123825 w 758825"/>
              <a:gd name="connsiteY44" fmla="*/ 31750 h 705921"/>
              <a:gd name="connsiteX45" fmla="*/ 133350 w 758825"/>
              <a:gd name="connsiteY45" fmla="*/ 25400 h 705921"/>
              <a:gd name="connsiteX46" fmla="*/ 152400 w 758825"/>
              <a:gd name="connsiteY46" fmla="*/ 19050 h 705921"/>
              <a:gd name="connsiteX47" fmla="*/ 187325 w 758825"/>
              <a:gd name="connsiteY47" fmla="*/ 9525 h 705921"/>
              <a:gd name="connsiteX48" fmla="*/ 219075 w 758825"/>
              <a:gd name="connsiteY48" fmla="*/ 3175 h 705921"/>
              <a:gd name="connsiteX49" fmla="*/ 234950 w 758825"/>
              <a:gd name="connsiteY49" fmla="*/ 0 h 705921"/>
              <a:gd name="connsiteX50" fmla="*/ 400050 w 758825"/>
              <a:gd name="connsiteY50" fmla="*/ 3175 h 705921"/>
              <a:gd name="connsiteX51" fmla="*/ 431800 w 758825"/>
              <a:gd name="connsiteY51" fmla="*/ 12700 h 705921"/>
              <a:gd name="connsiteX52" fmla="*/ 441325 w 758825"/>
              <a:gd name="connsiteY52" fmla="*/ 15875 h 705921"/>
              <a:gd name="connsiteX53" fmla="*/ 450850 w 758825"/>
              <a:gd name="connsiteY53" fmla="*/ 22225 h 705921"/>
              <a:gd name="connsiteX54" fmla="*/ 460375 w 758825"/>
              <a:gd name="connsiteY54" fmla="*/ 25400 h 705921"/>
              <a:gd name="connsiteX55" fmla="*/ 488950 w 758825"/>
              <a:gd name="connsiteY55" fmla="*/ 44450 h 705921"/>
              <a:gd name="connsiteX56" fmla="*/ 498475 w 758825"/>
              <a:gd name="connsiteY56" fmla="*/ 47625 h 705921"/>
              <a:gd name="connsiteX57" fmla="*/ 527050 w 758825"/>
              <a:gd name="connsiteY57" fmla="*/ 63500 h 705921"/>
              <a:gd name="connsiteX58" fmla="*/ 542925 w 758825"/>
              <a:gd name="connsiteY58" fmla="*/ 79375 h 705921"/>
              <a:gd name="connsiteX59" fmla="*/ 558800 w 758825"/>
              <a:gd name="connsiteY59" fmla="*/ 95250 h 705921"/>
              <a:gd name="connsiteX60" fmla="*/ 571500 w 758825"/>
              <a:gd name="connsiteY60" fmla="*/ 111125 h 705921"/>
              <a:gd name="connsiteX61" fmla="*/ 574675 w 758825"/>
              <a:gd name="connsiteY61" fmla="*/ 120650 h 705921"/>
              <a:gd name="connsiteX62" fmla="*/ 593725 w 758825"/>
              <a:gd name="connsiteY62" fmla="*/ 139700 h 705921"/>
              <a:gd name="connsiteX63" fmla="*/ 606425 w 758825"/>
              <a:gd name="connsiteY63" fmla="*/ 158750 h 705921"/>
              <a:gd name="connsiteX64" fmla="*/ 609600 w 758825"/>
              <a:gd name="connsiteY64" fmla="*/ 168275 h 705921"/>
              <a:gd name="connsiteX65" fmla="*/ 615950 w 758825"/>
              <a:gd name="connsiteY65" fmla="*/ 177800 h 705921"/>
              <a:gd name="connsiteX66" fmla="*/ 619125 w 758825"/>
              <a:gd name="connsiteY66" fmla="*/ 187325 h 705921"/>
              <a:gd name="connsiteX67" fmla="*/ 625475 w 758825"/>
              <a:gd name="connsiteY67" fmla="*/ 196850 h 705921"/>
              <a:gd name="connsiteX68" fmla="*/ 628650 w 758825"/>
              <a:gd name="connsiteY68" fmla="*/ 206375 h 705921"/>
              <a:gd name="connsiteX69" fmla="*/ 635000 w 758825"/>
              <a:gd name="connsiteY69" fmla="*/ 215900 h 705921"/>
              <a:gd name="connsiteX70" fmla="*/ 650875 w 758825"/>
              <a:gd name="connsiteY70" fmla="*/ 241300 h 705921"/>
              <a:gd name="connsiteX71" fmla="*/ 654050 w 758825"/>
              <a:gd name="connsiteY71" fmla="*/ 250825 h 705921"/>
              <a:gd name="connsiteX72" fmla="*/ 660400 w 758825"/>
              <a:gd name="connsiteY72" fmla="*/ 260350 h 705921"/>
              <a:gd name="connsiteX73" fmla="*/ 663575 w 758825"/>
              <a:gd name="connsiteY73" fmla="*/ 273050 h 705921"/>
              <a:gd name="connsiteX74" fmla="*/ 676275 w 758825"/>
              <a:gd name="connsiteY74" fmla="*/ 292100 h 705921"/>
              <a:gd name="connsiteX75" fmla="*/ 688975 w 758825"/>
              <a:gd name="connsiteY75" fmla="*/ 311150 h 705921"/>
              <a:gd name="connsiteX76" fmla="*/ 695325 w 758825"/>
              <a:gd name="connsiteY76" fmla="*/ 320675 h 705921"/>
              <a:gd name="connsiteX77" fmla="*/ 704850 w 758825"/>
              <a:gd name="connsiteY77" fmla="*/ 327025 h 705921"/>
              <a:gd name="connsiteX78" fmla="*/ 714375 w 758825"/>
              <a:gd name="connsiteY78" fmla="*/ 346075 h 705921"/>
              <a:gd name="connsiteX79" fmla="*/ 723900 w 758825"/>
              <a:gd name="connsiteY79" fmla="*/ 352425 h 705921"/>
              <a:gd name="connsiteX80" fmla="*/ 727075 w 758825"/>
              <a:gd name="connsiteY80" fmla="*/ 361950 h 705921"/>
              <a:gd name="connsiteX81" fmla="*/ 742950 w 758825"/>
              <a:gd name="connsiteY81" fmla="*/ 377825 h 705921"/>
              <a:gd name="connsiteX82" fmla="*/ 749300 w 758825"/>
              <a:gd name="connsiteY82" fmla="*/ 396875 h 705921"/>
              <a:gd name="connsiteX83" fmla="*/ 755650 w 758825"/>
              <a:gd name="connsiteY83" fmla="*/ 419100 h 705921"/>
              <a:gd name="connsiteX84" fmla="*/ 758825 w 758825"/>
              <a:gd name="connsiteY84" fmla="*/ 438150 h 705921"/>
              <a:gd name="connsiteX85" fmla="*/ 755650 w 758825"/>
              <a:gd name="connsiteY85" fmla="*/ 523875 h 705921"/>
              <a:gd name="connsiteX86" fmla="*/ 749300 w 758825"/>
              <a:gd name="connsiteY86" fmla="*/ 542925 h 705921"/>
              <a:gd name="connsiteX87" fmla="*/ 746125 w 758825"/>
              <a:gd name="connsiteY87" fmla="*/ 552450 h 705921"/>
              <a:gd name="connsiteX88" fmla="*/ 739775 w 758825"/>
              <a:gd name="connsiteY88" fmla="*/ 561975 h 705921"/>
              <a:gd name="connsiteX89" fmla="*/ 723900 w 758825"/>
              <a:gd name="connsiteY89" fmla="*/ 590550 h 705921"/>
              <a:gd name="connsiteX90" fmla="*/ 720725 w 758825"/>
              <a:gd name="connsiteY90" fmla="*/ 600075 h 705921"/>
              <a:gd name="connsiteX91" fmla="*/ 711200 w 758825"/>
              <a:gd name="connsiteY91" fmla="*/ 606425 h 705921"/>
              <a:gd name="connsiteX92" fmla="*/ 695325 w 758825"/>
              <a:gd name="connsiteY92" fmla="*/ 619125 h 705921"/>
              <a:gd name="connsiteX93" fmla="*/ 688975 w 758825"/>
              <a:gd name="connsiteY93" fmla="*/ 628650 h 705921"/>
              <a:gd name="connsiteX94" fmla="*/ 669925 w 758825"/>
              <a:gd name="connsiteY94" fmla="*/ 635000 h 705921"/>
              <a:gd name="connsiteX95" fmla="*/ 654050 w 758825"/>
              <a:gd name="connsiteY95" fmla="*/ 654050 h 705921"/>
              <a:gd name="connsiteX96" fmla="*/ 644525 w 758825"/>
              <a:gd name="connsiteY96" fmla="*/ 657225 h 705921"/>
              <a:gd name="connsiteX97" fmla="*/ 628650 w 758825"/>
              <a:gd name="connsiteY97" fmla="*/ 673100 h 705921"/>
              <a:gd name="connsiteX98" fmla="*/ 606425 w 758825"/>
              <a:gd name="connsiteY98" fmla="*/ 698500 h 705921"/>
              <a:gd name="connsiteX99" fmla="*/ 590550 w 758825"/>
              <a:gd name="connsiteY99" fmla="*/ 701675 h 705921"/>
              <a:gd name="connsiteX100" fmla="*/ 565150 w 758825"/>
              <a:gd name="connsiteY100" fmla="*/ 701675 h 70592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</a:cxnLst>
            <a:rect l="l" t="t" r="r" b="b"/>
            <a:pathLst>
              <a:path w="758825" h="705921">
                <a:moveTo>
                  <a:pt x="612775" y="679450"/>
                </a:moveTo>
                <a:cubicBezTo>
                  <a:pt x="603483" y="685025"/>
                  <a:pt x="597628" y="690099"/>
                  <a:pt x="587375" y="692150"/>
                </a:cubicBezTo>
                <a:cubicBezTo>
                  <a:pt x="574750" y="694675"/>
                  <a:pt x="549275" y="698500"/>
                  <a:pt x="549275" y="698500"/>
                </a:cubicBezTo>
                <a:cubicBezTo>
                  <a:pt x="546100" y="699558"/>
                  <a:pt x="543063" y="701202"/>
                  <a:pt x="539750" y="701675"/>
                </a:cubicBezTo>
                <a:cubicBezTo>
                  <a:pt x="474856" y="710946"/>
                  <a:pt x="352808" y="702229"/>
                  <a:pt x="320675" y="701675"/>
                </a:cubicBezTo>
                <a:cubicBezTo>
                  <a:pt x="314325" y="700617"/>
                  <a:pt x="307920" y="699849"/>
                  <a:pt x="301625" y="698500"/>
                </a:cubicBezTo>
                <a:cubicBezTo>
                  <a:pt x="293091" y="696671"/>
                  <a:pt x="284865" y="693384"/>
                  <a:pt x="276225" y="692150"/>
                </a:cubicBezTo>
                <a:lnTo>
                  <a:pt x="254000" y="688975"/>
                </a:lnTo>
                <a:cubicBezTo>
                  <a:pt x="247650" y="686858"/>
                  <a:pt x="240519" y="686338"/>
                  <a:pt x="234950" y="682625"/>
                </a:cubicBezTo>
                <a:cubicBezTo>
                  <a:pt x="222640" y="674419"/>
                  <a:pt x="229045" y="677482"/>
                  <a:pt x="215900" y="673100"/>
                </a:cubicBezTo>
                <a:cubicBezTo>
                  <a:pt x="212725" y="670983"/>
                  <a:pt x="209788" y="668457"/>
                  <a:pt x="206375" y="666750"/>
                </a:cubicBezTo>
                <a:cubicBezTo>
                  <a:pt x="180085" y="653605"/>
                  <a:pt x="214622" y="675423"/>
                  <a:pt x="187325" y="657225"/>
                </a:cubicBezTo>
                <a:cubicBezTo>
                  <a:pt x="185208" y="654050"/>
                  <a:pt x="184211" y="649722"/>
                  <a:pt x="180975" y="647700"/>
                </a:cubicBezTo>
                <a:cubicBezTo>
                  <a:pt x="175299" y="644152"/>
                  <a:pt x="161925" y="641350"/>
                  <a:pt x="161925" y="641350"/>
                </a:cubicBezTo>
                <a:cubicBezTo>
                  <a:pt x="159808" y="638175"/>
                  <a:pt x="158555" y="634209"/>
                  <a:pt x="155575" y="631825"/>
                </a:cubicBezTo>
                <a:cubicBezTo>
                  <a:pt x="152962" y="629734"/>
                  <a:pt x="149043" y="630147"/>
                  <a:pt x="146050" y="628650"/>
                </a:cubicBezTo>
                <a:cubicBezTo>
                  <a:pt x="142637" y="626943"/>
                  <a:pt x="139377" y="624835"/>
                  <a:pt x="136525" y="622300"/>
                </a:cubicBezTo>
                <a:cubicBezTo>
                  <a:pt x="129813" y="616334"/>
                  <a:pt x="122456" y="610722"/>
                  <a:pt x="117475" y="603250"/>
                </a:cubicBezTo>
                <a:cubicBezTo>
                  <a:pt x="102658" y="581025"/>
                  <a:pt x="111125" y="588433"/>
                  <a:pt x="95250" y="577850"/>
                </a:cubicBezTo>
                <a:cubicBezTo>
                  <a:pt x="89662" y="561085"/>
                  <a:pt x="93931" y="571110"/>
                  <a:pt x="79375" y="549275"/>
                </a:cubicBezTo>
                <a:cubicBezTo>
                  <a:pt x="77258" y="546100"/>
                  <a:pt x="74232" y="543370"/>
                  <a:pt x="73025" y="539750"/>
                </a:cubicBezTo>
                <a:cubicBezTo>
                  <a:pt x="71967" y="536575"/>
                  <a:pt x="71475" y="533151"/>
                  <a:pt x="69850" y="530225"/>
                </a:cubicBezTo>
                <a:lnTo>
                  <a:pt x="50800" y="501650"/>
                </a:lnTo>
                <a:cubicBezTo>
                  <a:pt x="48944" y="498865"/>
                  <a:pt x="49122" y="495118"/>
                  <a:pt x="47625" y="492125"/>
                </a:cubicBezTo>
                <a:cubicBezTo>
                  <a:pt x="45918" y="488712"/>
                  <a:pt x="42982" y="486013"/>
                  <a:pt x="41275" y="482600"/>
                </a:cubicBezTo>
                <a:cubicBezTo>
                  <a:pt x="39778" y="479607"/>
                  <a:pt x="39597" y="476068"/>
                  <a:pt x="38100" y="473075"/>
                </a:cubicBezTo>
                <a:cubicBezTo>
                  <a:pt x="36393" y="469662"/>
                  <a:pt x="33300" y="467037"/>
                  <a:pt x="31750" y="463550"/>
                </a:cubicBezTo>
                <a:cubicBezTo>
                  <a:pt x="24842" y="448007"/>
                  <a:pt x="26488" y="446008"/>
                  <a:pt x="22225" y="431800"/>
                </a:cubicBezTo>
                <a:cubicBezTo>
                  <a:pt x="20302" y="425389"/>
                  <a:pt x="17992" y="419100"/>
                  <a:pt x="15875" y="412750"/>
                </a:cubicBezTo>
                <a:lnTo>
                  <a:pt x="9525" y="393700"/>
                </a:lnTo>
                <a:cubicBezTo>
                  <a:pt x="8467" y="390525"/>
                  <a:pt x="7162" y="387422"/>
                  <a:pt x="6350" y="384175"/>
                </a:cubicBezTo>
                <a:lnTo>
                  <a:pt x="3175" y="371475"/>
                </a:lnTo>
                <a:cubicBezTo>
                  <a:pt x="2117" y="357717"/>
                  <a:pt x="0" y="343999"/>
                  <a:pt x="0" y="330200"/>
                </a:cubicBezTo>
                <a:cubicBezTo>
                  <a:pt x="0" y="278331"/>
                  <a:pt x="1290" y="226460"/>
                  <a:pt x="3175" y="174625"/>
                </a:cubicBezTo>
                <a:cubicBezTo>
                  <a:pt x="3316" y="170753"/>
                  <a:pt x="6178" y="152075"/>
                  <a:pt x="9525" y="146050"/>
                </a:cubicBezTo>
                <a:cubicBezTo>
                  <a:pt x="13231" y="139379"/>
                  <a:pt x="17992" y="133350"/>
                  <a:pt x="22225" y="127000"/>
                </a:cubicBezTo>
                <a:cubicBezTo>
                  <a:pt x="24081" y="124215"/>
                  <a:pt x="23775" y="120401"/>
                  <a:pt x="25400" y="117475"/>
                </a:cubicBezTo>
                <a:cubicBezTo>
                  <a:pt x="29106" y="110804"/>
                  <a:pt x="33867" y="104775"/>
                  <a:pt x="38100" y="98425"/>
                </a:cubicBezTo>
                <a:lnTo>
                  <a:pt x="50800" y="79375"/>
                </a:lnTo>
                <a:cubicBezTo>
                  <a:pt x="52917" y="76200"/>
                  <a:pt x="57150" y="75142"/>
                  <a:pt x="60325" y="73025"/>
                </a:cubicBezTo>
                <a:cubicBezTo>
                  <a:pt x="62442" y="69850"/>
                  <a:pt x="63695" y="65884"/>
                  <a:pt x="66675" y="63500"/>
                </a:cubicBezTo>
                <a:cubicBezTo>
                  <a:pt x="69288" y="61409"/>
                  <a:pt x="73207" y="61822"/>
                  <a:pt x="76200" y="60325"/>
                </a:cubicBezTo>
                <a:cubicBezTo>
                  <a:pt x="79613" y="58618"/>
                  <a:pt x="82794" y="56418"/>
                  <a:pt x="85725" y="53975"/>
                </a:cubicBezTo>
                <a:cubicBezTo>
                  <a:pt x="101580" y="40762"/>
                  <a:pt x="88036" y="46855"/>
                  <a:pt x="104775" y="41275"/>
                </a:cubicBezTo>
                <a:cubicBezTo>
                  <a:pt x="132072" y="23077"/>
                  <a:pt x="97535" y="44895"/>
                  <a:pt x="123825" y="31750"/>
                </a:cubicBezTo>
                <a:cubicBezTo>
                  <a:pt x="127238" y="30043"/>
                  <a:pt x="129863" y="26950"/>
                  <a:pt x="133350" y="25400"/>
                </a:cubicBezTo>
                <a:cubicBezTo>
                  <a:pt x="139467" y="22682"/>
                  <a:pt x="146050" y="21167"/>
                  <a:pt x="152400" y="19050"/>
                </a:cubicBezTo>
                <a:cubicBezTo>
                  <a:pt x="170204" y="13115"/>
                  <a:pt x="158678" y="16687"/>
                  <a:pt x="187325" y="9525"/>
                </a:cubicBezTo>
                <a:cubicBezTo>
                  <a:pt x="197796" y="6907"/>
                  <a:pt x="208492" y="5292"/>
                  <a:pt x="219075" y="3175"/>
                </a:cubicBezTo>
                <a:lnTo>
                  <a:pt x="234950" y="0"/>
                </a:lnTo>
                <a:lnTo>
                  <a:pt x="400050" y="3175"/>
                </a:lnTo>
                <a:cubicBezTo>
                  <a:pt x="405424" y="3367"/>
                  <a:pt x="429808" y="12036"/>
                  <a:pt x="431800" y="12700"/>
                </a:cubicBezTo>
                <a:lnTo>
                  <a:pt x="441325" y="15875"/>
                </a:lnTo>
                <a:cubicBezTo>
                  <a:pt x="444500" y="17992"/>
                  <a:pt x="447437" y="20518"/>
                  <a:pt x="450850" y="22225"/>
                </a:cubicBezTo>
                <a:cubicBezTo>
                  <a:pt x="453843" y="23722"/>
                  <a:pt x="457449" y="23775"/>
                  <a:pt x="460375" y="25400"/>
                </a:cubicBezTo>
                <a:lnTo>
                  <a:pt x="488950" y="44450"/>
                </a:lnTo>
                <a:cubicBezTo>
                  <a:pt x="491735" y="46306"/>
                  <a:pt x="495300" y="46567"/>
                  <a:pt x="498475" y="47625"/>
                </a:cubicBezTo>
                <a:cubicBezTo>
                  <a:pt x="520310" y="62181"/>
                  <a:pt x="510285" y="57912"/>
                  <a:pt x="527050" y="63500"/>
                </a:cubicBezTo>
                <a:cubicBezTo>
                  <a:pt x="543983" y="88900"/>
                  <a:pt x="521758" y="58208"/>
                  <a:pt x="542925" y="79375"/>
                </a:cubicBezTo>
                <a:cubicBezTo>
                  <a:pt x="564092" y="100542"/>
                  <a:pt x="533400" y="78317"/>
                  <a:pt x="558800" y="95250"/>
                </a:cubicBezTo>
                <a:cubicBezTo>
                  <a:pt x="566780" y="119191"/>
                  <a:pt x="555087" y="90609"/>
                  <a:pt x="571500" y="111125"/>
                </a:cubicBezTo>
                <a:cubicBezTo>
                  <a:pt x="573591" y="113738"/>
                  <a:pt x="572620" y="118008"/>
                  <a:pt x="574675" y="120650"/>
                </a:cubicBezTo>
                <a:cubicBezTo>
                  <a:pt x="580188" y="127739"/>
                  <a:pt x="593725" y="139700"/>
                  <a:pt x="593725" y="139700"/>
                </a:cubicBezTo>
                <a:cubicBezTo>
                  <a:pt x="601274" y="162348"/>
                  <a:pt x="590570" y="134967"/>
                  <a:pt x="606425" y="158750"/>
                </a:cubicBezTo>
                <a:cubicBezTo>
                  <a:pt x="608281" y="161535"/>
                  <a:pt x="608103" y="165282"/>
                  <a:pt x="609600" y="168275"/>
                </a:cubicBezTo>
                <a:cubicBezTo>
                  <a:pt x="611307" y="171688"/>
                  <a:pt x="614243" y="174387"/>
                  <a:pt x="615950" y="177800"/>
                </a:cubicBezTo>
                <a:cubicBezTo>
                  <a:pt x="617447" y="180793"/>
                  <a:pt x="617628" y="184332"/>
                  <a:pt x="619125" y="187325"/>
                </a:cubicBezTo>
                <a:cubicBezTo>
                  <a:pt x="620832" y="190738"/>
                  <a:pt x="623768" y="193437"/>
                  <a:pt x="625475" y="196850"/>
                </a:cubicBezTo>
                <a:cubicBezTo>
                  <a:pt x="626972" y="199843"/>
                  <a:pt x="627153" y="203382"/>
                  <a:pt x="628650" y="206375"/>
                </a:cubicBezTo>
                <a:cubicBezTo>
                  <a:pt x="630357" y="209788"/>
                  <a:pt x="633450" y="212413"/>
                  <a:pt x="635000" y="215900"/>
                </a:cubicBezTo>
                <a:cubicBezTo>
                  <a:pt x="646136" y="240956"/>
                  <a:pt x="633740" y="229877"/>
                  <a:pt x="650875" y="241300"/>
                </a:cubicBezTo>
                <a:cubicBezTo>
                  <a:pt x="651933" y="244475"/>
                  <a:pt x="652553" y="247832"/>
                  <a:pt x="654050" y="250825"/>
                </a:cubicBezTo>
                <a:cubicBezTo>
                  <a:pt x="655757" y="254238"/>
                  <a:pt x="658897" y="256843"/>
                  <a:pt x="660400" y="260350"/>
                </a:cubicBezTo>
                <a:cubicBezTo>
                  <a:pt x="662119" y="264361"/>
                  <a:pt x="661624" y="269147"/>
                  <a:pt x="663575" y="273050"/>
                </a:cubicBezTo>
                <a:cubicBezTo>
                  <a:pt x="666988" y="279876"/>
                  <a:pt x="672042" y="285750"/>
                  <a:pt x="676275" y="292100"/>
                </a:cubicBezTo>
                <a:lnTo>
                  <a:pt x="688975" y="311150"/>
                </a:lnTo>
                <a:cubicBezTo>
                  <a:pt x="691092" y="314325"/>
                  <a:pt x="692150" y="318558"/>
                  <a:pt x="695325" y="320675"/>
                </a:cubicBezTo>
                <a:lnTo>
                  <a:pt x="704850" y="327025"/>
                </a:lnTo>
                <a:cubicBezTo>
                  <a:pt x="707432" y="334772"/>
                  <a:pt x="708220" y="339920"/>
                  <a:pt x="714375" y="346075"/>
                </a:cubicBezTo>
                <a:cubicBezTo>
                  <a:pt x="717073" y="348773"/>
                  <a:pt x="720725" y="350308"/>
                  <a:pt x="723900" y="352425"/>
                </a:cubicBezTo>
                <a:cubicBezTo>
                  <a:pt x="724958" y="355600"/>
                  <a:pt x="724984" y="359337"/>
                  <a:pt x="727075" y="361950"/>
                </a:cubicBezTo>
                <a:cubicBezTo>
                  <a:pt x="740833" y="379148"/>
                  <a:pt x="733425" y="356394"/>
                  <a:pt x="742950" y="377825"/>
                </a:cubicBezTo>
                <a:cubicBezTo>
                  <a:pt x="745668" y="383942"/>
                  <a:pt x="747183" y="390525"/>
                  <a:pt x="749300" y="396875"/>
                </a:cubicBezTo>
                <a:cubicBezTo>
                  <a:pt x="752326" y="405953"/>
                  <a:pt x="753657" y="409133"/>
                  <a:pt x="755650" y="419100"/>
                </a:cubicBezTo>
                <a:cubicBezTo>
                  <a:pt x="756913" y="425413"/>
                  <a:pt x="757767" y="431800"/>
                  <a:pt x="758825" y="438150"/>
                </a:cubicBezTo>
                <a:cubicBezTo>
                  <a:pt x="757767" y="466725"/>
                  <a:pt x="758239" y="495398"/>
                  <a:pt x="755650" y="523875"/>
                </a:cubicBezTo>
                <a:cubicBezTo>
                  <a:pt x="755044" y="530541"/>
                  <a:pt x="751417" y="536575"/>
                  <a:pt x="749300" y="542925"/>
                </a:cubicBezTo>
                <a:cubicBezTo>
                  <a:pt x="748242" y="546100"/>
                  <a:pt x="747981" y="549665"/>
                  <a:pt x="746125" y="552450"/>
                </a:cubicBezTo>
                <a:cubicBezTo>
                  <a:pt x="744008" y="555625"/>
                  <a:pt x="741482" y="558562"/>
                  <a:pt x="739775" y="561975"/>
                </a:cubicBezTo>
                <a:cubicBezTo>
                  <a:pt x="723010" y="595505"/>
                  <a:pt x="763943" y="530485"/>
                  <a:pt x="723900" y="590550"/>
                </a:cubicBezTo>
                <a:cubicBezTo>
                  <a:pt x="722044" y="593335"/>
                  <a:pt x="722816" y="597462"/>
                  <a:pt x="720725" y="600075"/>
                </a:cubicBezTo>
                <a:cubicBezTo>
                  <a:pt x="718341" y="603055"/>
                  <a:pt x="714375" y="604308"/>
                  <a:pt x="711200" y="606425"/>
                </a:cubicBezTo>
                <a:cubicBezTo>
                  <a:pt x="693002" y="633722"/>
                  <a:pt x="717233" y="601598"/>
                  <a:pt x="695325" y="619125"/>
                </a:cubicBezTo>
                <a:cubicBezTo>
                  <a:pt x="692345" y="621509"/>
                  <a:pt x="692211" y="626628"/>
                  <a:pt x="688975" y="628650"/>
                </a:cubicBezTo>
                <a:cubicBezTo>
                  <a:pt x="683299" y="632198"/>
                  <a:pt x="669925" y="635000"/>
                  <a:pt x="669925" y="635000"/>
                </a:cubicBezTo>
                <a:cubicBezTo>
                  <a:pt x="665239" y="642028"/>
                  <a:pt x="661384" y="649161"/>
                  <a:pt x="654050" y="654050"/>
                </a:cubicBezTo>
                <a:cubicBezTo>
                  <a:pt x="651265" y="655906"/>
                  <a:pt x="647700" y="656167"/>
                  <a:pt x="644525" y="657225"/>
                </a:cubicBezTo>
                <a:cubicBezTo>
                  <a:pt x="619125" y="695325"/>
                  <a:pt x="658283" y="639233"/>
                  <a:pt x="628650" y="673100"/>
                </a:cubicBezTo>
                <a:cubicBezTo>
                  <a:pt x="619002" y="684126"/>
                  <a:pt x="619716" y="693516"/>
                  <a:pt x="606425" y="698500"/>
                </a:cubicBezTo>
                <a:cubicBezTo>
                  <a:pt x="601372" y="700395"/>
                  <a:pt x="595931" y="701261"/>
                  <a:pt x="590550" y="701675"/>
                </a:cubicBezTo>
                <a:cubicBezTo>
                  <a:pt x="582108" y="702324"/>
                  <a:pt x="573617" y="701675"/>
                  <a:pt x="565150" y="701675"/>
                </a:cubicBezTo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03" name="フリーフォーム 202"/>
          <p:cNvSpPr/>
          <p:nvPr/>
        </p:nvSpPr>
        <p:spPr>
          <a:xfrm>
            <a:off x="891699" y="3996069"/>
            <a:ext cx="758825" cy="705921"/>
          </a:xfrm>
          <a:custGeom>
            <a:avLst/>
            <a:gdLst>
              <a:gd name="connsiteX0" fmla="*/ 612775 w 758825"/>
              <a:gd name="connsiteY0" fmla="*/ 679450 h 705921"/>
              <a:gd name="connsiteX1" fmla="*/ 587375 w 758825"/>
              <a:gd name="connsiteY1" fmla="*/ 692150 h 705921"/>
              <a:gd name="connsiteX2" fmla="*/ 549275 w 758825"/>
              <a:gd name="connsiteY2" fmla="*/ 698500 h 705921"/>
              <a:gd name="connsiteX3" fmla="*/ 539750 w 758825"/>
              <a:gd name="connsiteY3" fmla="*/ 701675 h 705921"/>
              <a:gd name="connsiteX4" fmla="*/ 320675 w 758825"/>
              <a:gd name="connsiteY4" fmla="*/ 701675 h 705921"/>
              <a:gd name="connsiteX5" fmla="*/ 301625 w 758825"/>
              <a:gd name="connsiteY5" fmla="*/ 698500 h 705921"/>
              <a:gd name="connsiteX6" fmla="*/ 276225 w 758825"/>
              <a:gd name="connsiteY6" fmla="*/ 692150 h 705921"/>
              <a:gd name="connsiteX7" fmla="*/ 254000 w 758825"/>
              <a:gd name="connsiteY7" fmla="*/ 688975 h 705921"/>
              <a:gd name="connsiteX8" fmla="*/ 234950 w 758825"/>
              <a:gd name="connsiteY8" fmla="*/ 682625 h 705921"/>
              <a:gd name="connsiteX9" fmla="*/ 215900 w 758825"/>
              <a:gd name="connsiteY9" fmla="*/ 673100 h 705921"/>
              <a:gd name="connsiteX10" fmla="*/ 206375 w 758825"/>
              <a:gd name="connsiteY10" fmla="*/ 666750 h 705921"/>
              <a:gd name="connsiteX11" fmla="*/ 187325 w 758825"/>
              <a:gd name="connsiteY11" fmla="*/ 657225 h 705921"/>
              <a:gd name="connsiteX12" fmla="*/ 180975 w 758825"/>
              <a:gd name="connsiteY12" fmla="*/ 647700 h 705921"/>
              <a:gd name="connsiteX13" fmla="*/ 161925 w 758825"/>
              <a:gd name="connsiteY13" fmla="*/ 641350 h 705921"/>
              <a:gd name="connsiteX14" fmla="*/ 155575 w 758825"/>
              <a:gd name="connsiteY14" fmla="*/ 631825 h 705921"/>
              <a:gd name="connsiteX15" fmla="*/ 146050 w 758825"/>
              <a:gd name="connsiteY15" fmla="*/ 628650 h 705921"/>
              <a:gd name="connsiteX16" fmla="*/ 136525 w 758825"/>
              <a:gd name="connsiteY16" fmla="*/ 622300 h 705921"/>
              <a:gd name="connsiteX17" fmla="*/ 117475 w 758825"/>
              <a:gd name="connsiteY17" fmla="*/ 603250 h 705921"/>
              <a:gd name="connsiteX18" fmla="*/ 95250 w 758825"/>
              <a:gd name="connsiteY18" fmla="*/ 577850 h 705921"/>
              <a:gd name="connsiteX19" fmla="*/ 79375 w 758825"/>
              <a:gd name="connsiteY19" fmla="*/ 549275 h 705921"/>
              <a:gd name="connsiteX20" fmla="*/ 73025 w 758825"/>
              <a:gd name="connsiteY20" fmla="*/ 539750 h 705921"/>
              <a:gd name="connsiteX21" fmla="*/ 69850 w 758825"/>
              <a:gd name="connsiteY21" fmla="*/ 530225 h 705921"/>
              <a:gd name="connsiteX22" fmla="*/ 50800 w 758825"/>
              <a:gd name="connsiteY22" fmla="*/ 501650 h 705921"/>
              <a:gd name="connsiteX23" fmla="*/ 47625 w 758825"/>
              <a:gd name="connsiteY23" fmla="*/ 492125 h 705921"/>
              <a:gd name="connsiteX24" fmla="*/ 41275 w 758825"/>
              <a:gd name="connsiteY24" fmla="*/ 482600 h 705921"/>
              <a:gd name="connsiteX25" fmla="*/ 38100 w 758825"/>
              <a:gd name="connsiteY25" fmla="*/ 473075 h 705921"/>
              <a:gd name="connsiteX26" fmla="*/ 31750 w 758825"/>
              <a:gd name="connsiteY26" fmla="*/ 463550 h 705921"/>
              <a:gd name="connsiteX27" fmla="*/ 22225 w 758825"/>
              <a:gd name="connsiteY27" fmla="*/ 431800 h 705921"/>
              <a:gd name="connsiteX28" fmla="*/ 15875 w 758825"/>
              <a:gd name="connsiteY28" fmla="*/ 412750 h 705921"/>
              <a:gd name="connsiteX29" fmla="*/ 9525 w 758825"/>
              <a:gd name="connsiteY29" fmla="*/ 393700 h 705921"/>
              <a:gd name="connsiteX30" fmla="*/ 6350 w 758825"/>
              <a:gd name="connsiteY30" fmla="*/ 384175 h 705921"/>
              <a:gd name="connsiteX31" fmla="*/ 3175 w 758825"/>
              <a:gd name="connsiteY31" fmla="*/ 371475 h 705921"/>
              <a:gd name="connsiteX32" fmla="*/ 0 w 758825"/>
              <a:gd name="connsiteY32" fmla="*/ 330200 h 705921"/>
              <a:gd name="connsiteX33" fmla="*/ 3175 w 758825"/>
              <a:gd name="connsiteY33" fmla="*/ 174625 h 705921"/>
              <a:gd name="connsiteX34" fmla="*/ 9525 w 758825"/>
              <a:gd name="connsiteY34" fmla="*/ 146050 h 705921"/>
              <a:gd name="connsiteX35" fmla="*/ 22225 w 758825"/>
              <a:gd name="connsiteY35" fmla="*/ 127000 h 705921"/>
              <a:gd name="connsiteX36" fmla="*/ 25400 w 758825"/>
              <a:gd name="connsiteY36" fmla="*/ 117475 h 705921"/>
              <a:gd name="connsiteX37" fmla="*/ 38100 w 758825"/>
              <a:gd name="connsiteY37" fmla="*/ 98425 h 705921"/>
              <a:gd name="connsiteX38" fmla="*/ 50800 w 758825"/>
              <a:gd name="connsiteY38" fmla="*/ 79375 h 705921"/>
              <a:gd name="connsiteX39" fmla="*/ 60325 w 758825"/>
              <a:gd name="connsiteY39" fmla="*/ 73025 h 705921"/>
              <a:gd name="connsiteX40" fmla="*/ 66675 w 758825"/>
              <a:gd name="connsiteY40" fmla="*/ 63500 h 705921"/>
              <a:gd name="connsiteX41" fmla="*/ 76200 w 758825"/>
              <a:gd name="connsiteY41" fmla="*/ 60325 h 705921"/>
              <a:gd name="connsiteX42" fmla="*/ 85725 w 758825"/>
              <a:gd name="connsiteY42" fmla="*/ 53975 h 705921"/>
              <a:gd name="connsiteX43" fmla="*/ 104775 w 758825"/>
              <a:gd name="connsiteY43" fmla="*/ 41275 h 705921"/>
              <a:gd name="connsiteX44" fmla="*/ 123825 w 758825"/>
              <a:gd name="connsiteY44" fmla="*/ 31750 h 705921"/>
              <a:gd name="connsiteX45" fmla="*/ 133350 w 758825"/>
              <a:gd name="connsiteY45" fmla="*/ 25400 h 705921"/>
              <a:gd name="connsiteX46" fmla="*/ 152400 w 758825"/>
              <a:gd name="connsiteY46" fmla="*/ 19050 h 705921"/>
              <a:gd name="connsiteX47" fmla="*/ 187325 w 758825"/>
              <a:gd name="connsiteY47" fmla="*/ 9525 h 705921"/>
              <a:gd name="connsiteX48" fmla="*/ 219075 w 758825"/>
              <a:gd name="connsiteY48" fmla="*/ 3175 h 705921"/>
              <a:gd name="connsiteX49" fmla="*/ 234950 w 758825"/>
              <a:gd name="connsiteY49" fmla="*/ 0 h 705921"/>
              <a:gd name="connsiteX50" fmla="*/ 400050 w 758825"/>
              <a:gd name="connsiteY50" fmla="*/ 3175 h 705921"/>
              <a:gd name="connsiteX51" fmla="*/ 431800 w 758825"/>
              <a:gd name="connsiteY51" fmla="*/ 12700 h 705921"/>
              <a:gd name="connsiteX52" fmla="*/ 441325 w 758825"/>
              <a:gd name="connsiteY52" fmla="*/ 15875 h 705921"/>
              <a:gd name="connsiteX53" fmla="*/ 450850 w 758825"/>
              <a:gd name="connsiteY53" fmla="*/ 22225 h 705921"/>
              <a:gd name="connsiteX54" fmla="*/ 460375 w 758825"/>
              <a:gd name="connsiteY54" fmla="*/ 25400 h 705921"/>
              <a:gd name="connsiteX55" fmla="*/ 488950 w 758825"/>
              <a:gd name="connsiteY55" fmla="*/ 44450 h 705921"/>
              <a:gd name="connsiteX56" fmla="*/ 498475 w 758825"/>
              <a:gd name="connsiteY56" fmla="*/ 47625 h 705921"/>
              <a:gd name="connsiteX57" fmla="*/ 527050 w 758825"/>
              <a:gd name="connsiteY57" fmla="*/ 63500 h 705921"/>
              <a:gd name="connsiteX58" fmla="*/ 542925 w 758825"/>
              <a:gd name="connsiteY58" fmla="*/ 79375 h 705921"/>
              <a:gd name="connsiteX59" fmla="*/ 558800 w 758825"/>
              <a:gd name="connsiteY59" fmla="*/ 95250 h 705921"/>
              <a:gd name="connsiteX60" fmla="*/ 571500 w 758825"/>
              <a:gd name="connsiteY60" fmla="*/ 111125 h 705921"/>
              <a:gd name="connsiteX61" fmla="*/ 574675 w 758825"/>
              <a:gd name="connsiteY61" fmla="*/ 120650 h 705921"/>
              <a:gd name="connsiteX62" fmla="*/ 593725 w 758825"/>
              <a:gd name="connsiteY62" fmla="*/ 139700 h 705921"/>
              <a:gd name="connsiteX63" fmla="*/ 606425 w 758825"/>
              <a:gd name="connsiteY63" fmla="*/ 158750 h 705921"/>
              <a:gd name="connsiteX64" fmla="*/ 609600 w 758825"/>
              <a:gd name="connsiteY64" fmla="*/ 168275 h 705921"/>
              <a:gd name="connsiteX65" fmla="*/ 615950 w 758825"/>
              <a:gd name="connsiteY65" fmla="*/ 177800 h 705921"/>
              <a:gd name="connsiteX66" fmla="*/ 619125 w 758825"/>
              <a:gd name="connsiteY66" fmla="*/ 187325 h 705921"/>
              <a:gd name="connsiteX67" fmla="*/ 625475 w 758825"/>
              <a:gd name="connsiteY67" fmla="*/ 196850 h 705921"/>
              <a:gd name="connsiteX68" fmla="*/ 628650 w 758825"/>
              <a:gd name="connsiteY68" fmla="*/ 206375 h 705921"/>
              <a:gd name="connsiteX69" fmla="*/ 635000 w 758825"/>
              <a:gd name="connsiteY69" fmla="*/ 215900 h 705921"/>
              <a:gd name="connsiteX70" fmla="*/ 650875 w 758825"/>
              <a:gd name="connsiteY70" fmla="*/ 241300 h 705921"/>
              <a:gd name="connsiteX71" fmla="*/ 654050 w 758825"/>
              <a:gd name="connsiteY71" fmla="*/ 250825 h 705921"/>
              <a:gd name="connsiteX72" fmla="*/ 660400 w 758825"/>
              <a:gd name="connsiteY72" fmla="*/ 260350 h 705921"/>
              <a:gd name="connsiteX73" fmla="*/ 663575 w 758825"/>
              <a:gd name="connsiteY73" fmla="*/ 273050 h 705921"/>
              <a:gd name="connsiteX74" fmla="*/ 676275 w 758825"/>
              <a:gd name="connsiteY74" fmla="*/ 292100 h 705921"/>
              <a:gd name="connsiteX75" fmla="*/ 688975 w 758825"/>
              <a:gd name="connsiteY75" fmla="*/ 311150 h 705921"/>
              <a:gd name="connsiteX76" fmla="*/ 695325 w 758825"/>
              <a:gd name="connsiteY76" fmla="*/ 320675 h 705921"/>
              <a:gd name="connsiteX77" fmla="*/ 704850 w 758825"/>
              <a:gd name="connsiteY77" fmla="*/ 327025 h 705921"/>
              <a:gd name="connsiteX78" fmla="*/ 714375 w 758825"/>
              <a:gd name="connsiteY78" fmla="*/ 346075 h 705921"/>
              <a:gd name="connsiteX79" fmla="*/ 723900 w 758825"/>
              <a:gd name="connsiteY79" fmla="*/ 352425 h 705921"/>
              <a:gd name="connsiteX80" fmla="*/ 727075 w 758825"/>
              <a:gd name="connsiteY80" fmla="*/ 361950 h 705921"/>
              <a:gd name="connsiteX81" fmla="*/ 742950 w 758825"/>
              <a:gd name="connsiteY81" fmla="*/ 377825 h 705921"/>
              <a:gd name="connsiteX82" fmla="*/ 749300 w 758825"/>
              <a:gd name="connsiteY82" fmla="*/ 396875 h 705921"/>
              <a:gd name="connsiteX83" fmla="*/ 755650 w 758825"/>
              <a:gd name="connsiteY83" fmla="*/ 419100 h 705921"/>
              <a:gd name="connsiteX84" fmla="*/ 758825 w 758825"/>
              <a:gd name="connsiteY84" fmla="*/ 438150 h 705921"/>
              <a:gd name="connsiteX85" fmla="*/ 755650 w 758825"/>
              <a:gd name="connsiteY85" fmla="*/ 523875 h 705921"/>
              <a:gd name="connsiteX86" fmla="*/ 749300 w 758825"/>
              <a:gd name="connsiteY86" fmla="*/ 542925 h 705921"/>
              <a:gd name="connsiteX87" fmla="*/ 746125 w 758825"/>
              <a:gd name="connsiteY87" fmla="*/ 552450 h 705921"/>
              <a:gd name="connsiteX88" fmla="*/ 739775 w 758825"/>
              <a:gd name="connsiteY88" fmla="*/ 561975 h 705921"/>
              <a:gd name="connsiteX89" fmla="*/ 723900 w 758825"/>
              <a:gd name="connsiteY89" fmla="*/ 590550 h 705921"/>
              <a:gd name="connsiteX90" fmla="*/ 720725 w 758825"/>
              <a:gd name="connsiteY90" fmla="*/ 600075 h 705921"/>
              <a:gd name="connsiteX91" fmla="*/ 711200 w 758825"/>
              <a:gd name="connsiteY91" fmla="*/ 606425 h 705921"/>
              <a:gd name="connsiteX92" fmla="*/ 695325 w 758825"/>
              <a:gd name="connsiteY92" fmla="*/ 619125 h 705921"/>
              <a:gd name="connsiteX93" fmla="*/ 688975 w 758825"/>
              <a:gd name="connsiteY93" fmla="*/ 628650 h 705921"/>
              <a:gd name="connsiteX94" fmla="*/ 669925 w 758825"/>
              <a:gd name="connsiteY94" fmla="*/ 635000 h 705921"/>
              <a:gd name="connsiteX95" fmla="*/ 654050 w 758825"/>
              <a:gd name="connsiteY95" fmla="*/ 654050 h 705921"/>
              <a:gd name="connsiteX96" fmla="*/ 644525 w 758825"/>
              <a:gd name="connsiteY96" fmla="*/ 657225 h 705921"/>
              <a:gd name="connsiteX97" fmla="*/ 628650 w 758825"/>
              <a:gd name="connsiteY97" fmla="*/ 673100 h 705921"/>
              <a:gd name="connsiteX98" fmla="*/ 606425 w 758825"/>
              <a:gd name="connsiteY98" fmla="*/ 698500 h 705921"/>
              <a:gd name="connsiteX99" fmla="*/ 590550 w 758825"/>
              <a:gd name="connsiteY99" fmla="*/ 701675 h 705921"/>
              <a:gd name="connsiteX100" fmla="*/ 565150 w 758825"/>
              <a:gd name="connsiteY100" fmla="*/ 701675 h 70592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</a:cxnLst>
            <a:rect l="l" t="t" r="r" b="b"/>
            <a:pathLst>
              <a:path w="758825" h="705921">
                <a:moveTo>
                  <a:pt x="612775" y="679450"/>
                </a:moveTo>
                <a:cubicBezTo>
                  <a:pt x="603483" y="685025"/>
                  <a:pt x="597628" y="690099"/>
                  <a:pt x="587375" y="692150"/>
                </a:cubicBezTo>
                <a:cubicBezTo>
                  <a:pt x="574750" y="694675"/>
                  <a:pt x="549275" y="698500"/>
                  <a:pt x="549275" y="698500"/>
                </a:cubicBezTo>
                <a:cubicBezTo>
                  <a:pt x="546100" y="699558"/>
                  <a:pt x="543063" y="701202"/>
                  <a:pt x="539750" y="701675"/>
                </a:cubicBezTo>
                <a:cubicBezTo>
                  <a:pt x="474856" y="710946"/>
                  <a:pt x="352808" y="702229"/>
                  <a:pt x="320675" y="701675"/>
                </a:cubicBezTo>
                <a:cubicBezTo>
                  <a:pt x="314325" y="700617"/>
                  <a:pt x="307920" y="699849"/>
                  <a:pt x="301625" y="698500"/>
                </a:cubicBezTo>
                <a:cubicBezTo>
                  <a:pt x="293091" y="696671"/>
                  <a:pt x="284865" y="693384"/>
                  <a:pt x="276225" y="692150"/>
                </a:cubicBezTo>
                <a:lnTo>
                  <a:pt x="254000" y="688975"/>
                </a:lnTo>
                <a:cubicBezTo>
                  <a:pt x="247650" y="686858"/>
                  <a:pt x="240519" y="686338"/>
                  <a:pt x="234950" y="682625"/>
                </a:cubicBezTo>
                <a:cubicBezTo>
                  <a:pt x="222640" y="674419"/>
                  <a:pt x="229045" y="677482"/>
                  <a:pt x="215900" y="673100"/>
                </a:cubicBezTo>
                <a:cubicBezTo>
                  <a:pt x="212725" y="670983"/>
                  <a:pt x="209788" y="668457"/>
                  <a:pt x="206375" y="666750"/>
                </a:cubicBezTo>
                <a:cubicBezTo>
                  <a:pt x="180085" y="653605"/>
                  <a:pt x="214622" y="675423"/>
                  <a:pt x="187325" y="657225"/>
                </a:cubicBezTo>
                <a:cubicBezTo>
                  <a:pt x="185208" y="654050"/>
                  <a:pt x="184211" y="649722"/>
                  <a:pt x="180975" y="647700"/>
                </a:cubicBezTo>
                <a:cubicBezTo>
                  <a:pt x="175299" y="644152"/>
                  <a:pt x="161925" y="641350"/>
                  <a:pt x="161925" y="641350"/>
                </a:cubicBezTo>
                <a:cubicBezTo>
                  <a:pt x="159808" y="638175"/>
                  <a:pt x="158555" y="634209"/>
                  <a:pt x="155575" y="631825"/>
                </a:cubicBezTo>
                <a:cubicBezTo>
                  <a:pt x="152962" y="629734"/>
                  <a:pt x="149043" y="630147"/>
                  <a:pt x="146050" y="628650"/>
                </a:cubicBezTo>
                <a:cubicBezTo>
                  <a:pt x="142637" y="626943"/>
                  <a:pt x="139377" y="624835"/>
                  <a:pt x="136525" y="622300"/>
                </a:cubicBezTo>
                <a:cubicBezTo>
                  <a:pt x="129813" y="616334"/>
                  <a:pt x="122456" y="610722"/>
                  <a:pt x="117475" y="603250"/>
                </a:cubicBezTo>
                <a:cubicBezTo>
                  <a:pt x="102658" y="581025"/>
                  <a:pt x="111125" y="588433"/>
                  <a:pt x="95250" y="577850"/>
                </a:cubicBezTo>
                <a:cubicBezTo>
                  <a:pt x="89662" y="561085"/>
                  <a:pt x="93931" y="571110"/>
                  <a:pt x="79375" y="549275"/>
                </a:cubicBezTo>
                <a:cubicBezTo>
                  <a:pt x="77258" y="546100"/>
                  <a:pt x="74232" y="543370"/>
                  <a:pt x="73025" y="539750"/>
                </a:cubicBezTo>
                <a:cubicBezTo>
                  <a:pt x="71967" y="536575"/>
                  <a:pt x="71475" y="533151"/>
                  <a:pt x="69850" y="530225"/>
                </a:cubicBezTo>
                <a:lnTo>
                  <a:pt x="50800" y="501650"/>
                </a:lnTo>
                <a:cubicBezTo>
                  <a:pt x="48944" y="498865"/>
                  <a:pt x="49122" y="495118"/>
                  <a:pt x="47625" y="492125"/>
                </a:cubicBezTo>
                <a:cubicBezTo>
                  <a:pt x="45918" y="488712"/>
                  <a:pt x="42982" y="486013"/>
                  <a:pt x="41275" y="482600"/>
                </a:cubicBezTo>
                <a:cubicBezTo>
                  <a:pt x="39778" y="479607"/>
                  <a:pt x="39597" y="476068"/>
                  <a:pt x="38100" y="473075"/>
                </a:cubicBezTo>
                <a:cubicBezTo>
                  <a:pt x="36393" y="469662"/>
                  <a:pt x="33300" y="467037"/>
                  <a:pt x="31750" y="463550"/>
                </a:cubicBezTo>
                <a:cubicBezTo>
                  <a:pt x="24842" y="448007"/>
                  <a:pt x="26488" y="446008"/>
                  <a:pt x="22225" y="431800"/>
                </a:cubicBezTo>
                <a:cubicBezTo>
                  <a:pt x="20302" y="425389"/>
                  <a:pt x="17992" y="419100"/>
                  <a:pt x="15875" y="412750"/>
                </a:cubicBezTo>
                <a:lnTo>
                  <a:pt x="9525" y="393700"/>
                </a:lnTo>
                <a:cubicBezTo>
                  <a:pt x="8467" y="390525"/>
                  <a:pt x="7162" y="387422"/>
                  <a:pt x="6350" y="384175"/>
                </a:cubicBezTo>
                <a:lnTo>
                  <a:pt x="3175" y="371475"/>
                </a:lnTo>
                <a:cubicBezTo>
                  <a:pt x="2117" y="357717"/>
                  <a:pt x="0" y="343999"/>
                  <a:pt x="0" y="330200"/>
                </a:cubicBezTo>
                <a:cubicBezTo>
                  <a:pt x="0" y="278331"/>
                  <a:pt x="1290" y="226460"/>
                  <a:pt x="3175" y="174625"/>
                </a:cubicBezTo>
                <a:cubicBezTo>
                  <a:pt x="3316" y="170753"/>
                  <a:pt x="6178" y="152075"/>
                  <a:pt x="9525" y="146050"/>
                </a:cubicBezTo>
                <a:cubicBezTo>
                  <a:pt x="13231" y="139379"/>
                  <a:pt x="17992" y="133350"/>
                  <a:pt x="22225" y="127000"/>
                </a:cubicBezTo>
                <a:cubicBezTo>
                  <a:pt x="24081" y="124215"/>
                  <a:pt x="23775" y="120401"/>
                  <a:pt x="25400" y="117475"/>
                </a:cubicBezTo>
                <a:cubicBezTo>
                  <a:pt x="29106" y="110804"/>
                  <a:pt x="33867" y="104775"/>
                  <a:pt x="38100" y="98425"/>
                </a:cubicBezTo>
                <a:lnTo>
                  <a:pt x="50800" y="79375"/>
                </a:lnTo>
                <a:cubicBezTo>
                  <a:pt x="52917" y="76200"/>
                  <a:pt x="57150" y="75142"/>
                  <a:pt x="60325" y="73025"/>
                </a:cubicBezTo>
                <a:cubicBezTo>
                  <a:pt x="62442" y="69850"/>
                  <a:pt x="63695" y="65884"/>
                  <a:pt x="66675" y="63500"/>
                </a:cubicBezTo>
                <a:cubicBezTo>
                  <a:pt x="69288" y="61409"/>
                  <a:pt x="73207" y="61822"/>
                  <a:pt x="76200" y="60325"/>
                </a:cubicBezTo>
                <a:cubicBezTo>
                  <a:pt x="79613" y="58618"/>
                  <a:pt x="82794" y="56418"/>
                  <a:pt x="85725" y="53975"/>
                </a:cubicBezTo>
                <a:cubicBezTo>
                  <a:pt x="101580" y="40762"/>
                  <a:pt x="88036" y="46855"/>
                  <a:pt x="104775" y="41275"/>
                </a:cubicBezTo>
                <a:cubicBezTo>
                  <a:pt x="132072" y="23077"/>
                  <a:pt x="97535" y="44895"/>
                  <a:pt x="123825" y="31750"/>
                </a:cubicBezTo>
                <a:cubicBezTo>
                  <a:pt x="127238" y="30043"/>
                  <a:pt x="129863" y="26950"/>
                  <a:pt x="133350" y="25400"/>
                </a:cubicBezTo>
                <a:cubicBezTo>
                  <a:pt x="139467" y="22682"/>
                  <a:pt x="146050" y="21167"/>
                  <a:pt x="152400" y="19050"/>
                </a:cubicBezTo>
                <a:cubicBezTo>
                  <a:pt x="170204" y="13115"/>
                  <a:pt x="158678" y="16687"/>
                  <a:pt x="187325" y="9525"/>
                </a:cubicBezTo>
                <a:cubicBezTo>
                  <a:pt x="197796" y="6907"/>
                  <a:pt x="208492" y="5292"/>
                  <a:pt x="219075" y="3175"/>
                </a:cubicBezTo>
                <a:lnTo>
                  <a:pt x="234950" y="0"/>
                </a:lnTo>
                <a:lnTo>
                  <a:pt x="400050" y="3175"/>
                </a:lnTo>
                <a:cubicBezTo>
                  <a:pt x="405424" y="3367"/>
                  <a:pt x="429808" y="12036"/>
                  <a:pt x="431800" y="12700"/>
                </a:cubicBezTo>
                <a:lnTo>
                  <a:pt x="441325" y="15875"/>
                </a:lnTo>
                <a:cubicBezTo>
                  <a:pt x="444500" y="17992"/>
                  <a:pt x="447437" y="20518"/>
                  <a:pt x="450850" y="22225"/>
                </a:cubicBezTo>
                <a:cubicBezTo>
                  <a:pt x="453843" y="23722"/>
                  <a:pt x="457449" y="23775"/>
                  <a:pt x="460375" y="25400"/>
                </a:cubicBezTo>
                <a:lnTo>
                  <a:pt x="488950" y="44450"/>
                </a:lnTo>
                <a:cubicBezTo>
                  <a:pt x="491735" y="46306"/>
                  <a:pt x="495300" y="46567"/>
                  <a:pt x="498475" y="47625"/>
                </a:cubicBezTo>
                <a:cubicBezTo>
                  <a:pt x="520310" y="62181"/>
                  <a:pt x="510285" y="57912"/>
                  <a:pt x="527050" y="63500"/>
                </a:cubicBezTo>
                <a:cubicBezTo>
                  <a:pt x="543983" y="88900"/>
                  <a:pt x="521758" y="58208"/>
                  <a:pt x="542925" y="79375"/>
                </a:cubicBezTo>
                <a:cubicBezTo>
                  <a:pt x="564092" y="100542"/>
                  <a:pt x="533400" y="78317"/>
                  <a:pt x="558800" y="95250"/>
                </a:cubicBezTo>
                <a:cubicBezTo>
                  <a:pt x="566780" y="119191"/>
                  <a:pt x="555087" y="90609"/>
                  <a:pt x="571500" y="111125"/>
                </a:cubicBezTo>
                <a:cubicBezTo>
                  <a:pt x="573591" y="113738"/>
                  <a:pt x="572620" y="118008"/>
                  <a:pt x="574675" y="120650"/>
                </a:cubicBezTo>
                <a:cubicBezTo>
                  <a:pt x="580188" y="127739"/>
                  <a:pt x="593725" y="139700"/>
                  <a:pt x="593725" y="139700"/>
                </a:cubicBezTo>
                <a:cubicBezTo>
                  <a:pt x="601274" y="162348"/>
                  <a:pt x="590570" y="134967"/>
                  <a:pt x="606425" y="158750"/>
                </a:cubicBezTo>
                <a:cubicBezTo>
                  <a:pt x="608281" y="161535"/>
                  <a:pt x="608103" y="165282"/>
                  <a:pt x="609600" y="168275"/>
                </a:cubicBezTo>
                <a:cubicBezTo>
                  <a:pt x="611307" y="171688"/>
                  <a:pt x="614243" y="174387"/>
                  <a:pt x="615950" y="177800"/>
                </a:cubicBezTo>
                <a:cubicBezTo>
                  <a:pt x="617447" y="180793"/>
                  <a:pt x="617628" y="184332"/>
                  <a:pt x="619125" y="187325"/>
                </a:cubicBezTo>
                <a:cubicBezTo>
                  <a:pt x="620832" y="190738"/>
                  <a:pt x="623768" y="193437"/>
                  <a:pt x="625475" y="196850"/>
                </a:cubicBezTo>
                <a:cubicBezTo>
                  <a:pt x="626972" y="199843"/>
                  <a:pt x="627153" y="203382"/>
                  <a:pt x="628650" y="206375"/>
                </a:cubicBezTo>
                <a:cubicBezTo>
                  <a:pt x="630357" y="209788"/>
                  <a:pt x="633450" y="212413"/>
                  <a:pt x="635000" y="215900"/>
                </a:cubicBezTo>
                <a:cubicBezTo>
                  <a:pt x="646136" y="240956"/>
                  <a:pt x="633740" y="229877"/>
                  <a:pt x="650875" y="241300"/>
                </a:cubicBezTo>
                <a:cubicBezTo>
                  <a:pt x="651933" y="244475"/>
                  <a:pt x="652553" y="247832"/>
                  <a:pt x="654050" y="250825"/>
                </a:cubicBezTo>
                <a:cubicBezTo>
                  <a:pt x="655757" y="254238"/>
                  <a:pt x="658897" y="256843"/>
                  <a:pt x="660400" y="260350"/>
                </a:cubicBezTo>
                <a:cubicBezTo>
                  <a:pt x="662119" y="264361"/>
                  <a:pt x="661624" y="269147"/>
                  <a:pt x="663575" y="273050"/>
                </a:cubicBezTo>
                <a:cubicBezTo>
                  <a:pt x="666988" y="279876"/>
                  <a:pt x="672042" y="285750"/>
                  <a:pt x="676275" y="292100"/>
                </a:cubicBezTo>
                <a:lnTo>
                  <a:pt x="688975" y="311150"/>
                </a:lnTo>
                <a:cubicBezTo>
                  <a:pt x="691092" y="314325"/>
                  <a:pt x="692150" y="318558"/>
                  <a:pt x="695325" y="320675"/>
                </a:cubicBezTo>
                <a:lnTo>
                  <a:pt x="704850" y="327025"/>
                </a:lnTo>
                <a:cubicBezTo>
                  <a:pt x="707432" y="334772"/>
                  <a:pt x="708220" y="339920"/>
                  <a:pt x="714375" y="346075"/>
                </a:cubicBezTo>
                <a:cubicBezTo>
                  <a:pt x="717073" y="348773"/>
                  <a:pt x="720725" y="350308"/>
                  <a:pt x="723900" y="352425"/>
                </a:cubicBezTo>
                <a:cubicBezTo>
                  <a:pt x="724958" y="355600"/>
                  <a:pt x="724984" y="359337"/>
                  <a:pt x="727075" y="361950"/>
                </a:cubicBezTo>
                <a:cubicBezTo>
                  <a:pt x="740833" y="379148"/>
                  <a:pt x="733425" y="356394"/>
                  <a:pt x="742950" y="377825"/>
                </a:cubicBezTo>
                <a:cubicBezTo>
                  <a:pt x="745668" y="383942"/>
                  <a:pt x="747183" y="390525"/>
                  <a:pt x="749300" y="396875"/>
                </a:cubicBezTo>
                <a:cubicBezTo>
                  <a:pt x="752326" y="405953"/>
                  <a:pt x="753657" y="409133"/>
                  <a:pt x="755650" y="419100"/>
                </a:cubicBezTo>
                <a:cubicBezTo>
                  <a:pt x="756913" y="425413"/>
                  <a:pt x="757767" y="431800"/>
                  <a:pt x="758825" y="438150"/>
                </a:cubicBezTo>
                <a:cubicBezTo>
                  <a:pt x="757767" y="466725"/>
                  <a:pt x="758239" y="495398"/>
                  <a:pt x="755650" y="523875"/>
                </a:cubicBezTo>
                <a:cubicBezTo>
                  <a:pt x="755044" y="530541"/>
                  <a:pt x="751417" y="536575"/>
                  <a:pt x="749300" y="542925"/>
                </a:cubicBezTo>
                <a:cubicBezTo>
                  <a:pt x="748242" y="546100"/>
                  <a:pt x="747981" y="549665"/>
                  <a:pt x="746125" y="552450"/>
                </a:cubicBezTo>
                <a:cubicBezTo>
                  <a:pt x="744008" y="555625"/>
                  <a:pt x="741482" y="558562"/>
                  <a:pt x="739775" y="561975"/>
                </a:cubicBezTo>
                <a:cubicBezTo>
                  <a:pt x="723010" y="595505"/>
                  <a:pt x="763943" y="530485"/>
                  <a:pt x="723900" y="590550"/>
                </a:cubicBezTo>
                <a:cubicBezTo>
                  <a:pt x="722044" y="593335"/>
                  <a:pt x="722816" y="597462"/>
                  <a:pt x="720725" y="600075"/>
                </a:cubicBezTo>
                <a:cubicBezTo>
                  <a:pt x="718341" y="603055"/>
                  <a:pt x="714375" y="604308"/>
                  <a:pt x="711200" y="606425"/>
                </a:cubicBezTo>
                <a:cubicBezTo>
                  <a:pt x="693002" y="633722"/>
                  <a:pt x="717233" y="601598"/>
                  <a:pt x="695325" y="619125"/>
                </a:cubicBezTo>
                <a:cubicBezTo>
                  <a:pt x="692345" y="621509"/>
                  <a:pt x="692211" y="626628"/>
                  <a:pt x="688975" y="628650"/>
                </a:cubicBezTo>
                <a:cubicBezTo>
                  <a:pt x="683299" y="632198"/>
                  <a:pt x="669925" y="635000"/>
                  <a:pt x="669925" y="635000"/>
                </a:cubicBezTo>
                <a:cubicBezTo>
                  <a:pt x="665239" y="642028"/>
                  <a:pt x="661384" y="649161"/>
                  <a:pt x="654050" y="654050"/>
                </a:cubicBezTo>
                <a:cubicBezTo>
                  <a:pt x="651265" y="655906"/>
                  <a:pt x="647700" y="656167"/>
                  <a:pt x="644525" y="657225"/>
                </a:cubicBezTo>
                <a:cubicBezTo>
                  <a:pt x="619125" y="695325"/>
                  <a:pt x="658283" y="639233"/>
                  <a:pt x="628650" y="673100"/>
                </a:cubicBezTo>
                <a:cubicBezTo>
                  <a:pt x="619002" y="684126"/>
                  <a:pt x="619716" y="693516"/>
                  <a:pt x="606425" y="698500"/>
                </a:cubicBezTo>
                <a:cubicBezTo>
                  <a:pt x="601372" y="700395"/>
                  <a:pt x="595931" y="701261"/>
                  <a:pt x="590550" y="701675"/>
                </a:cubicBezTo>
                <a:cubicBezTo>
                  <a:pt x="582108" y="702324"/>
                  <a:pt x="573617" y="701675"/>
                  <a:pt x="565150" y="701675"/>
                </a:cubicBezTo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pic>
        <p:nvPicPr>
          <p:cNvPr id="204" name="Picture 14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5750" y="5095934"/>
            <a:ext cx="1322166" cy="12803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" name="Picture 16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6059" y="5095439"/>
            <a:ext cx="1322166" cy="12803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208" name="直線コネクタ 207"/>
          <p:cNvCxnSpPr/>
          <p:nvPr/>
        </p:nvCxnSpPr>
        <p:spPr>
          <a:xfrm>
            <a:off x="4265240" y="6267229"/>
            <a:ext cx="36004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9" name="フリーフォーム 208"/>
          <p:cNvSpPr/>
          <p:nvPr/>
        </p:nvSpPr>
        <p:spPr>
          <a:xfrm>
            <a:off x="3641968" y="5399970"/>
            <a:ext cx="752475" cy="539844"/>
          </a:xfrm>
          <a:custGeom>
            <a:avLst/>
            <a:gdLst>
              <a:gd name="connsiteX0" fmla="*/ 444500 w 752475"/>
              <a:gd name="connsiteY0" fmla="*/ 3269 h 539844"/>
              <a:gd name="connsiteX1" fmla="*/ 406400 w 752475"/>
              <a:gd name="connsiteY1" fmla="*/ 9619 h 539844"/>
              <a:gd name="connsiteX2" fmla="*/ 374650 w 752475"/>
              <a:gd name="connsiteY2" fmla="*/ 12794 h 539844"/>
              <a:gd name="connsiteX3" fmla="*/ 365125 w 752475"/>
              <a:gd name="connsiteY3" fmla="*/ 19144 h 539844"/>
              <a:gd name="connsiteX4" fmla="*/ 358775 w 752475"/>
              <a:gd name="connsiteY4" fmla="*/ 28669 h 539844"/>
              <a:gd name="connsiteX5" fmla="*/ 349250 w 752475"/>
              <a:gd name="connsiteY5" fmla="*/ 31844 h 539844"/>
              <a:gd name="connsiteX6" fmla="*/ 320675 w 752475"/>
              <a:gd name="connsiteY6" fmla="*/ 47719 h 539844"/>
              <a:gd name="connsiteX7" fmla="*/ 257175 w 752475"/>
              <a:gd name="connsiteY7" fmla="*/ 50894 h 539844"/>
              <a:gd name="connsiteX8" fmla="*/ 231775 w 752475"/>
              <a:gd name="connsiteY8" fmla="*/ 54069 h 539844"/>
              <a:gd name="connsiteX9" fmla="*/ 180975 w 752475"/>
              <a:gd name="connsiteY9" fmla="*/ 60419 h 539844"/>
              <a:gd name="connsiteX10" fmla="*/ 161925 w 752475"/>
              <a:gd name="connsiteY10" fmla="*/ 66769 h 539844"/>
              <a:gd name="connsiteX11" fmla="*/ 152400 w 752475"/>
              <a:gd name="connsiteY11" fmla="*/ 69944 h 539844"/>
              <a:gd name="connsiteX12" fmla="*/ 142875 w 752475"/>
              <a:gd name="connsiteY12" fmla="*/ 76294 h 539844"/>
              <a:gd name="connsiteX13" fmla="*/ 133350 w 752475"/>
              <a:gd name="connsiteY13" fmla="*/ 79469 h 539844"/>
              <a:gd name="connsiteX14" fmla="*/ 104775 w 752475"/>
              <a:gd name="connsiteY14" fmla="*/ 98519 h 539844"/>
              <a:gd name="connsiteX15" fmla="*/ 95250 w 752475"/>
              <a:gd name="connsiteY15" fmla="*/ 101694 h 539844"/>
              <a:gd name="connsiteX16" fmla="*/ 79375 w 752475"/>
              <a:gd name="connsiteY16" fmla="*/ 117569 h 539844"/>
              <a:gd name="connsiteX17" fmla="*/ 63500 w 752475"/>
              <a:gd name="connsiteY17" fmla="*/ 133444 h 539844"/>
              <a:gd name="connsiteX18" fmla="*/ 53975 w 752475"/>
              <a:gd name="connsiteY18" fmla="*/ 152494 h 539844"/>
              <a:gd name="connsiteX19" fmla="*/ 50800 w 752475"/>
              <a:gd name="connsiteY19" fmla="*/ 162019 h 539844"/>
              <a:gd name="connsiteX20" fmla="*/ 38100 w 752475"/>
              <a:gd name="connsiteY20" fmla="*/ 181069 h 539844"/>
              <a:gd name="connsiteX21" fmla="*/ 31750 w 752475"/>
              <a:gd name="connsiteY21" fmla="*/ 190594 h 539844"/>
              <a:gd name="connsiteX22" fmla="*/ 28575 w 752475"/>
              <a:gd name="connsiteY22" fmla="*/ 200119 h 539844"/>
              <a:gd name="connsiteX23" fmla="*/ 15875 w 752475"/>
              <a:gd name="connsiteY23" fmla="*/ 219169 h 539844"/>
              <a:gd name="connsiteX24" fmla="*/ 6350 w 752475"/>
              <a:gd name="connsiteY24" fmla="*/ 238219 h 539844"/>
              <a:gd name="connsiteX25" fmla="*/ 0 w 752475"/>
              <a:gd name="connsiteY25" fmla="*/ 273144 h 539844"/>
              <a:gd name="connsiteX26" fmla="*/ 3175 w 752475"/>
              <a:gd name="connsiteY26" fmla="*/ 333469 h 539844"/>
              <a:gd name="connsiteX27" fmla="*/ 9525 w 752475"/>
              <a:gd name="connsiteY27" fmla="*/ 352519 h 539844"/>
              <a:gd name="connsiteX28" fmla="*/ 22225 w 752475"/>
              <a:gd name="connsiteY28" fmla="*/ 368394 h 539844"/>
              <a:gd name="connsiteX29" fmla="*/ 25400 w 752475"/>
              <a:gd name="connsiteY29" fmla="*/ 377919 h 539844"/>
              <a:gd name="connsiteX30" fmla="*/ 50800 w 752475"/>
              <a:gd name="connsiteY30" fmla="*/ 406494 h 539844"/>
              <a:gd name="connsiteX31" fmla="*/ 60325 w 752475"/>
              <a:gd name="connsiteY31" fmla="*/ 409669 h 539844"/>
              <a:gd name="connsiteX32" fmla="*/ 88900 w 752475"/>
              <a:gd name="connsiteY32" fmla="*/ 431894 h 539844"/>
              <a:gd name="connsiteX33" fmla="*/ 117475 w 752475"/>
              <a:gd name="connsiteY33" fmla="*/ 454119 h 539844"/>
              <a:gd name="connsiteX34" fmla="*/ 136525 w 752475"/>
              <a:gd name="connsiteY34" fmla="*/ 466819 h 539844"/>
              <a:gd name="connsiteX35" fmla="*/ 146050 w 752475"/>
              <a:gd name="connsiteY35" fmla="*/ 473169 h 539844"/>
              <a:gd name="connsiteX36" fmla="*/ 155575 w 752475"/>
              <a:gd name="connsiteY36" fmla="*/ 476344 h 539844"/>
              <a:gd name="connsiteX37" fmla="*/ 174625 w 752475"/>
              <a:gd name="connsiteY37" fmla="*/ 489044 h 539844"/>
              <a:gd name="connsiteX38" fmla="*/ 184150 w 752475"/>
              <a:gd name="connsiteY38" fmla="*/ 495394 h 539844"/>
              <a:gd name="connsiteX39" fmla="*/ 203200 w 752475"/>
              <a:gd name="connsiteY39" fmla="*/ 501744 h 539844"/>
              <a:gd name="connsiteX40" fmla="*/ 212725 w 752475"/>
              <a:gd name="connsiteY40" fmla="*/ 508094 h 539844"/>
              <a:gd name="connsiteX41" fmla="*/ 234950 w 752475"/>
              <a:gd name="connsiteY41" fmla="*/ 517619 h 539844"/>
              <a:gd name="connsiteX42" fmla="*/ 244475 w 752475"/>
              <a:gd name="connsiteY42" fmla="*/ 523969 h 539844"/>
              <a:gd name="connsiteX43" fmla="*/ 260350 w 752475"/>
              <a:gd name="connsiteY43" fmla="*/ 527144 h 539844"/>
              <a:gd name="connsiteX44" fmla="*/ 279400 w 752475"/>
              <a:gd name="connsiteY44" fmla="*/ 533494 h 539844"/>
              <a:gd name="connsiteX45" fmla="*/ 352425 w 752475"/>
              <a:gd name="connsiteY45" fmla="*/ 539844 h 539844"/>
              <a:gd name="connsiteX46" fmla="*/ 447675 w 752475"/>
              <a:gd name="connsiteY46" fmla="*/ 536669 h 539844"/>
              <a:gd name="connsiteX47" fmla="*/ 466725 w 752475"/>
              <a:gd name="connsiteY47" fmla="*/ 533494 h 539844"/>
              <a:gd name="connsiteX48" fmla="*/ 492125 w 752475"/>
              <a:gd name="connsiteY48" fmla="*/ 530319 h 539844"/>
              <a:gd name="connsiteX49" fmla="*/ 517525 w 752475"/>
              <a:gd name="connsiteY49" fmla="*/ 523969 h 539844"/>
              <a:gd name="connsiteX50" fmla="*/ 533400 w 752475"/>
              <a:gd name="connsiteY50" fmla="*/ 520794 h 539844"/>
              <a:gd name="connsiteX51" fmla="*/ 552450 w 752475"/>
              <a:gd name="connsiteY51" fmla="*/ 514444 h 539844"/>
              <a:gd name="connsiteX52" fmla="*/ 561975 w 752475"/>
              <a:gd name="connsiteY52" fmla="*/ 511269 h 539844"/>
              <a:gd name="connsiteX53" fmla="*/ 571500 w 752475"/>
              <a:gd name="connsiteY53" fmla="*/ 504919 h 539844"/>
              <a:gd name="connsiteX54" fmla="*/ 590550 w 752475"/>
              <a:gd name="connsiteY54" fmla="*/ 498569 h 539844"/>
              <a:gd name="connsiteX55" fmla="*/ 600075 w 752475"/>
              <a:gd name="connsiteY55" fmla="*/ 492219 h 539844"/>
              <a:gd name="connsiteX56" fmla="*/ 606425 w 752475"/>
              <a:gd name="connsiteY56" fmla="*/ 482694 h 539844"/>
              <a:gd name="connsiteX57" fmla="*/ 625475 w 752475"/>
              <a:gd name="connsiteY57" fmla="*/ 476344 h 539844"/>
              <a:gd name="connsiteX58" fmla="*/ 635000 w 752475"/>
              <a:gd name="connsiteY58" fmla="*/ 469994 h 539844"/>
              <a:gd name="connsiteX59" fmla="*/ 644525 w 752475"/>
              <a:gd name="connsiteY59" fmla="*/ 460469 h 539844"/>
              <a:gd name="connsiteX60" fmla="*/ 654050 w 752475"/>
              <a:gd name="connsiteY60" fmla="*/ 457294 h 539844"/>
              <a:gd name="connsiteX61" fmla="*/ 660400 w 752475"/>
              <a:gd name="connsiteY61" fmla="*/ 447769 h 539844"/>
              <a:gd name="connsiteX62" fmla="*/ 669925 w 752475"/>
              <a:gd name="connsiteY62" fmla="*/ 441419 h 539844"/>
              <a:gd name="connsiteX63" fmla="*/ 682625 w 752475"/>
              <a:gd name="connsiteY63" fmla="*/ 422369 h 539844"/>
              <a:gd name="connsiteX64" fmla="*/ 695325 w 752475"/>
              <a:gd name="connsiteY64" fmla="*/ 403319 h 539844"/>
              <a:gd name="connsiteX65" fmla="*/ 698500 w 752475"/>
              <a:gd name="connsiteY65" fmla="*/ 393794 h 539844"/>
              <a:gd name="connsiteX66" fmla="*/ 704850 w 752475"/>
              <a:gd name="connsiteY66" fmla="*/ 384269 h 539844"/>
              <a:gd name="connsiteX67" fmla="*/ 714375 w 752475"/>
              <a:gd name="connsiteY67" fmla="*/ 355694 h 539844"/>
              <a:gd name="connsiteX68" fmla="*/ 717550 w 752475"/>
              <a:gd name="connsiteY68" fmla="*/ 346169 h 539844"/>
              <a:gd name="connsiteX69" fmla="*/ 723900 w 752475"/>
              <a:gd name="connsiteY69" fmla="*/ 298544 h 539844"/>
              <a:gd name="connsiteX70" fmla="*/ 730250 w 752475"/>
              <a:gd name="connsiteY70" fmla="*/ 279494 h 539844"/>
              <a:gd name="connsiteX71" fmla="*/ 736600 w 752475"/>
              <a:gd name="connsiteY71" fmla="*/ 260444 h 539844"/>
              <a:gd name="connsiteX72" fmla="*/ 739775 w 752475"/>
              <a:gd name="connsiteY72" fmla="*/ 250919 h 539844"/>
              <a:gd name="connsiteX73" fmla="*/ 749300 w 752475"/>
              <a:gd name="connsiteY73" fmla="*/ 219169 h 539844"/>
              <a:gd name="connsiteX74" fmla="*/ 752475 w 752475"/>
              <a:gd name="connsiteY74" fmla="*/ 209644 h 539844"/>
              <a:gd name="connsiteX75" fmla="*/ 749300 w 752475"/>
              <a:gd name="connsiteY75" fmla="*/ 146144 h 539844"/>
              <a:gd name="connsiteX76" fmla="*/ 742950 w 752475"/>
              <a:gd name="connsiteY76" fmla="*/ 127094 h 539844"/>
              <a:gd name="connsiteX77" fmla="*/ 736600 w 752475"/>
              <a:gd name="connsiteY77" fmla="*/ 108044 h 539844"/>
              <a:gd name="connsiteX78" fmla="*/ 727075 w 752475"/>
              <a:gd name="connsiteY78" fmla="*/ 98519 h 539844"/>
              <a:gd name="connsiteX79" fmla="*/ 717550 w 752475"/>
              <a:gd name="connsiteY79" fmla="*/ 79469 h 539844"/>
              <a:gd name="connsiteX80" fmla="*/ 708025 w 752475"/>
              <a:gd name="connsiteY80" fmla="*/ 69944 h 539844"/>
              <a:gd name="connsiteX81" fmla="*/ 701675 w 752475"/>
              <a:gd name="connsiteY81" fmla="*/ 60419 h 539844"/>
              <a:gd name="connsiteX82" fmla="*/ 682625 w 752475"/>
              <a:gd name="connsiteY82" fmla="*/ 47719 h 539844"/>
              <a:gd name="connsiteX83" fmla="*/ 663575 w 752475"/>
              <a:gd name="connsiteY83" fmla="*/ 35019 h 539844"/>
              <a:gd name="connsiteX84" fmla="*/ 654050 w 752475"/>
              <a:gd name="connsiteY84" fmla="*/ 31844 h 539844"/>
              <a:gd name="connsiteX85" fmla="*/ 635000 w 752475"/>
              <a:gd name="connsiteY85" fmla="*/ 19144 h 539844"/>
              <a:gd name="connsiteX86" fmla="*/ 593725 w 752475"/>
              <a:gd name="connsiteY86" fmla="*/ 9619 h 539844"/>
              <a:gd name="connsiteX87" fmla="*/ 584200 w 752475"/>
              <a:gd name="connsiteY87" fmla="*/ 6444 h 539844"/>
              <a:gd name="connsiteX88" fmla="*/ 498475 w 752475"/>
              <a:gd name="connsiteY88" fmla="*/ 94 h 539844"/>
              <a:gd name="connsiteX89" fmla="*/ 444500 w 752475"/>
              <a:gd name="connsiteY89" fmla="*/ 3269 h 53984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752475" h="539844">
                <a:moveTo>
                  <a:pt x="444500" y="3269"/>
                </a:moveTo>
                <a:cubicBezTo>
                  <a:pt x="429154" y="4857"/>
                  <a:pt x="425528" y="7369"/>
                  <a:pt x="406400" y="9619"/>
                </a:cubicBezTo>
                <a:cubicBezTo>
                  <a:pt x="395837" y="10862"/>
                  <a:pt x="385233" y="11736"/>
                  <a:pt x="374650" y="12794"/>
                </a:cubicBezTo>
                <a:cubicBezTo>
                  <a:pt x="371475" y="14911"/>
                  <a:pt x="367823" y="16446"/>
                  <a:pt x="365125" y="19144"/>
                </a:cubicBezTo>
                <a:cubicBezTo>
                  <a:pt x="362427" y="21842"/>
                  <a:pt x="361755" y="26285"/>
                  <a:pt x="358775" y="28669"/>
                </a:cubicBezTo>
                <a:cubicBezTo>
                  <a:pt x="356162" y="30760"/>
                  <a:pt x="352425" y="30786"/>
                  <a:pt x="349250" y="31844"/>
                </a:cubicBezTo>
                <a:cubicBezTo>
                  <a:pt x="343663" y="35569"/>
                  <a:pt x="330315" y="46881"/>
                  <a:pt x="320675" y="47719"/>
                </a:cubicBezTo>
                <a:cubicBezTo>
                  <a:pt x="299562" y="49555"/>
                  <a:pt x="278342" y="49836"/>
                  <a:pt x="257175" y="50894"/>
                </a:cubicBezTo>
                <a:lnTo>
                  <a:pt x="231775" y="54069"/>
                </a:lnTo>
                <a:cubicBezTo>
                  <a:pt x="213739" y="55968"/>
                  <a:pt x="198035" y="55766"/>
                  <a:pt x="180975" y="60419"/>
                </a:cubicBezTo>
                <a:cubicBezTo>
                  <a:pt x="174517" y="62180"/>
                  <a:pt x="168275" y="64652"/>
                  <a:pt x="161925" y="66769"/>
                </a:cubicBezTo>
                <a:lnTo>
                  <a:pt x="152400" y="69944"/>
                </a:lnTo>
                <a:cubicBezTo>
                  <a:pt x="149225" y="72061"/>
                  <a:pt x="146288" y="74587"/>
                  <a:pt x="142875" y="76294"/>
                </a:cubicBezTo>
                <a:cubicBezTo>
                  <a:pt x="139882" y="77791"/>
                  <a:pt x="136276" y="77844"/>
                  <a:pt x="133350" y="79469"/>
                </a:cubicBezTo>
                <a:lnTo>
                  <a:pt x="104775" y="98519"/>
                </a:lnTo>
                <a:cubicBezTo>
                  <a:pt x="101990" y="100375"/>
                  <a:pt x="98425" y="100636"/>
                  <a:pt x="95250" y="101694"/>
                </a:cubicBezTo>
                <a:cubicBezTo>
                  <a:pt x="78317" y="127094"/>
                  <a:pt x="100542" y="96402"/>
                  <a:pt x="79375" y="117569"/>
                </a:cubicBezTo>
                <a:cubicBezTo>
                  <a:pt x="58208" y="138736"/>
                  <a:pt x="88900" y="116511"/>
                  <a:pt x="63500" y="133444"/>
                </a:cubicBezTo>
                <a:cubicBezTo>
                  <a:pt x="55520" y="157385"/>
                  <a:pt x="66285" y="127875"/>
                  <a:pt x="53975" y="152494"/>
                </a:cubicBezTo>
                <a:cubicBezTo>
                  <a:pt x="52478" y="155487"/>
                  <a:pt x="52425" y="159093"/>
                  <a:pt x="50800" y="162019"/>
                </a:cubicBezTo>
                <a:cubicBezTo>
                  <a:pt x="47094" y="168690"/>
                  <a:pt x="42333" y="174719"/>
                  <a:pt x="38100" y="181069"/>
                </a:cubicBezTo>
                <a:cubicBezTo>
                  <a:pt x="35983" y="184244"/>
                  <a:pt x="32957" y="186974"/>
                  <a:pt x="31750" y="190594"/>
                </a:cubicBezTo>
                <a:cubicBezTo>
                  <a:pt x="30692" y="193769"/>
                  <a:pt x="30200" y="197193"/>
                  <a:pt x="28575" y="200119"/>
                </a:cubicBezTo>
                <a:cubicBezTo>
                  <a:pt x="24869" y="206790"/>
                  <a:pt x="18288" y="211929"/>
                  <a:pt x="15875" y="219169"/>
                </a:cubicBezTo>
                <a:cubicBezTo>
                  <a:pt x="11493" y="232314"/>
                  <a:pt x="14556" y="225909"/>
                  <a:pt x="6350" y="238219"/>
                </a:cubicBezTo>
                <a:cubicBezTo>
                  <a:pt x="3571" y="249334"/>
                  <a:pt x="0" y="261768"/>
                  <a:pt x="0" y="273144"/>
                </a:cubicBezTo>
                <a:cubicBezTo>
                  <a:pt x="0" y="293280"/>
                  <a:pt x="776" y="313476"/>
                  <a:pt x="3175" y="333469"/>
                </a:cubicBezTo>
                <a:cubicBezTo>
                  <a:pt x="3972" y="340115"/>
                  <a:pt x="7408" y="346169"/>
                  <a:pt x="9525" y="352519"/>
                </a:cubicBezTo>
                <a:cubicBezTo>
                  <a:pt x="13907" y="365664"/>
                  <a:pt x="9915" y="360188"/>
                  <a:pt x="22225" y="368394"/>
                </a:cubicBezTo>
                <a:cubicBezTo>
                  <a:pt x="23283" y="371569"/>
                  <a:pt x="23903" y="374926"/>
                  <a:pt x="25400" y="377919"/>
                </a:cubicBezTo>
                <a:cubicBezTo>
                  <a:pt x="29635" y="386390"/>
                  <a:pt x="45751" y="404811"/>
                  <a:pt x="50800" y="406494"/>
                </a:cubicBezTo>
                <a:lnTo>
                  <a:pt x="60325" y="409669"/>
                </a:lnTo>
                <a:cubicBezTo>
                  <a:pt x="81742" y="431086"/>
                  <a:pt x="70856" y="425879"/>
                  <a:pt x="88900" y="431894"/>
                </a:cubicBezTo>
                <a:cubicBezTo>
                  <a:pt x="110317" y="453311"/>
                  <a:pt x="99431" y="448104"/>
                  <a:pt x="117475" y="454119"/>
                </a:cubicBezTo>
                <a:lnTo>
                  <a:pt x="136525" y="466819"/>
                </a:lnTo>
                <a:cubicBezTo>
                  <a:pt x="139700" y="468936"/>
                  <a:pt x="142430" y="471962"/>
                  <a:pt x="146050" y="473169"/>
                </a:cubicBezTo>
                <a:lnTo>
                  <a:pt x="155575" y="476344"/>
                </a:lnTo>
                <a:cubicBezTo>
                  <a:pt x="173631" y="494400"/>
                  <a:pt x="156245" y="479854"/>
                  <a:pt x="174625" y="489044"/>
                </a:cubicBezTo>
                <a:cubicBezTo>
                  <a:pt x="178038" y="490751"/>
                  <a:pt x="180663" y="493844"/>
                  <a:pt x="184150" y="495394"/>
                </a:cubicBezTo>
                <a:cubicBezTo>
                  <a:pt x="190267" y="498112"/>
                  <a:pt x="203200" y="501744"/>
                  <a:pt x="203200" y="501744"/>
                </a:cubicBezTo>
                <a:cubicBezTo>
                  <a:pt x="206375" y="503861"/>
                  <a:pt x="209312" y="506387"/>
                  <a:pt x="212725" y="508094"/>
                </a:cubicBezTo>
                <a:cubicBezTo>
                  <a:pt x="248345" y="525904"/>
                  <a:pt x="188702" y="491192"/>
                  <a:pt x="234950" y="517619"/>
                </a:cubicBezTo>
                <a:cubicBezTo>
                  <a:pt x="238263" y="519512"/>
                  <a:pt x="240902" y="522629"/>
                  <a:pt x="244475" y="523969"/>
                </a:cubicBezTo>
                <a:cubicBezTo>
                  <a:pt x="249528" y="525864"/>
                  <a:pt x="255144" y="525724"/>
                  <a:pt x="260350" y="527144"/>
                </a:cubicBezTo>
                <a:cubicBezTo>
                  <a:pt x="266808" y="528905"/>
                  <a:pt x="272774" y="532547"/>
                  <a:pt x="279400" y="533494"/>
                </a:cubicBezTo>
                <a:cubicBezTo>
                  <a:pt x="318421" y="539068"/>
                  <a:pt x="294156" y="536202"/>
                  <a:pt x="352425" y="539844"/>
                </a:cubicBezTo>
                <a:cubicBezTo>
                  <a:pt x="384175" y="538786"/>
                  <a:pt x="415956" y="538431"/>
                  <a:pt x="447675" y="536669"/>
                </a:cubicBezTo>
                <a:cubicBezTo>
                  <a:pt x="454103" y="536312"/>
                  <a:pt x="460352" y="534404"/>
                  <a:pt x="466725" y="533494"/>
                </a:cubicBezTo>
                <a:cubicBezTo>
                  <a:pt x="475172" y="532287"/>
                  <a:pt x="483692" y="531616"/>
                  <a:pt x="492125" y="530319"/>
                </a:cubicBezTo>
                <a:cubicBezTo>
                  <a:pt x="522552" y="525638"/>
                  <a:pt x="495891" y="529377"/>
                  <a:pt x="517525" y="523969"/>
                </a:cubicBezTo>
                <a:cubicBezTo>
                  <a:pt x="522760" y="522660"/>
                  <a:pt x="528194" y="522214"/>
                  <a:pt x="533400" y="520794"/>
                </a:cubicBezTo>
                <a:cubicBezTo>
                  <a:pt x="539858" y="519033"/>
                  <a:pt x="546100" y="516561"/>
                  <a:pt x="552450" y="514444"/>
                </a:cubicBezTo>
                <a:lnTo>
                  <a:pt x="561975" y="511269"/>
                </a:lnTo>
                <a:cubicBezTo>
                  <a:pt x="565150" y="509152"/>
                  <a:pt x="568013" y="506469"/>
                  <a:pt x="571500" y="504919"/>
                </a:cubicBezTo>
                <a:cubicBezTo>
                  <a:pt x="577617" y="502201"/>
                  <a:pt x="590550" y="498569"/>
                  <a:pt x="590550" y="498569"/>
                </a:cubicBezTo>
                <a:cubicBezTo>
                  <a:pt x="593725" y="496452"/>
                  <a:pt x="597377" y="494917"/>
                  <a:pt x="600075" y="492219"/>
                </a:cubicBezTo>
                <a:cubicBezTo>
                  <a:pt x="602773" y="489521"/>
                  <a:pt x="603189" y="484716"/>
                  <a:pt x="606425" y="482694"/>
                </a:cubicBezTo>
                <a:cubicBezTo>
                  <a:pt x="612101" y="479146"/>
                  <a:pt x="625475" y="476344"/>
                  <a:pt x="625475" y="476344"/>
                </a:cubicBezTo>
                <a:cubicBezTo>
                  <a:pt x="628650" y="474227"/>
                  <a:pt x="632069" y="472437"/>
                  <a:pt x="635000" y="469994"/>
                </a:cubicBezTo>
                <a:cubicBezTo>
                  <a:pt x="638449" y="467119"/>
                  <a:pt x="640789" y="462960"/>
                  <a:pt x="644525" y="460469"/>
                </a:cubicBezTo>
                <a:cubicBezTo>
                  <a:pt x="647310" y="458613"/>
                  <a:pt x="650875" y="458352"/>
                  <a:pt x="654050" y="457294"/>
                </a:cubicBezTo>
                <a:cubicBezTo>
                  <a:pt x="656167" y="454119"/>
                  <a:pt x="657702" y="450467"/>
                  <a:pt x="660400" y="447769"/>
                </a:cubicBezTo>
                <a:cubicBezTo>
                  <a:pt x="663098" y="445071"/>
                  <a:pt x="667412" y="444291"/>
                  <a:pt x="669925" y="441419"/>
                </a:cubicBezTo>
                <a:cubicBezTo>
                  <a:pt x="674951" y="435676"/>
                  <a:pt x="678392" y="428719"/>
                  <a:pt x="682625" y="422369"/>
                </a:cubicBezTo>
                <a:lnTo>
                  <a:pt x="695325" y="403319"/>
                </a:lnTo>
                <a:cubicBezTo>
                  <a:pt x="697181" y="400534"/>
                  <a:pt x="697003" y="396787"/>
                  <a:pt x="698500" y="393794"/>
                </a:cubicBezTo>
                <a:cubicBezTo>
                  <a:pt x="700207" y="390381"/>
                  <a:pt x="703300" y="387756"/>
                  <a:pt x="704850" y="384269"/>
                </a:cubicBezTo>
                <a:lnTo>
                  <a:pt x="714375" y="355694"/>
                </a:lnTo>
                <a:lnTo>
                  <a:pt x="717550" y="346169"/>
                </a:lnTo>
                <a:cubicBezTo>
                  <a:pt x="718607" y="336655"/>
                  <a:pt x="721050" y="309945"/>
                  <a:pt x="723900" y="298544"/>
                </a:cubicBezTo>
                <a:cubicBezTo>
                  <a:pt x="725523" y="292050"/>
                  <a:pt x="728133" y="285844"/>
                  <a:pt x="730250" y="279494"/>
                </a:cubicBezTo>
                <a:lnTo>
                  <a:pt x="736600" y="260444"/>
                </a:lnTo>
                <a:cubicBezTo>
                  <a:pt x="737658" y="257269"/>
                  <a:pt x="738963" y="254166"/>
                  <a:pt x="739775" y="250919"/>
                </a:cubicBezTo>
                <a:cubicBezTo>
                  <a:pt x="744573" y="231725"/>
                  <a:pt x="741570" y="242359"/>
                  <a:pt x="749300" y="219169"/>
                </a:cubicBezTo>
                <a:lnTo>
                  <a:pt x="752475" y="209644"/>
                </a:lnTo>
                <a:cubicBezTo>
                  <a:pt x="751417" y="188477"/>
                  <a:pt x="751729" y="167197"/>
                  <a:pt x="749300" y="146144"/>
                </a:cubicBezTo>
                <a:cubicBezTo>
                  <a:pt x="748533" y="139495"/>
                  <a:pt x="745067" y="133444"/>
                  <a:pt x="742950" y="127094"/>
                </a:cubicBezTo>
                <a:lnTo>
                  <a:pt x="736600" y="108044"/>
                </a:lnTo>
                <a:cubicBezTo>
                  <a:pt x="735180" y="103784"/>
                  <a:pt x="729950" y="101968"/>
                  <a:pt x="727075" y="98519"/>
                </a:cubicBezTo>
                <a:cubicBezTo>
                  <a:pt x="702096" y="68544"/>
                  <a:pt x="736643" y="108108"/>
                  <a:pt x="717550" y="79469"/>
                </a:cubicBezTo>
                <a:cubicBezTo>
                  <a:pt x="715059" y="75733"/>
                  <a:pt x="710900" y="73393"/>
                  <a:pt x="708025" y="69944"/>
                </a:cubicBezTo>
                <a:cubicBezTo>
                  <a:pt x="705582" y="67013"/>
                  <a:pt x="704547" y="62932"/>
                  <a:pt x="701675" y="60419"/>
                </a:cubicBezTo>
                <a:cubicBezTo>
                  <a:pt x="695932" y="55393"/>
                  <a:pt x="688975" y="51952"/>
                  <a:pt x="682625" y="47719"/>
                </a:cubicBezTo>
                <a:lnTo>
                  <a:pt x="663575" y="35019"/>
                </a:lnTo>
                <a:cubicBezTo>
                  <a:pt x="660790" y="33163"/>
                  <a:pt x="657225" y="32902"/>
                  <a:pt x="654050" y="31844"/>
                </a:cubicBezTo>
                <a:lnTo>
                  <a:pt x="635000" y="19144"/>
                </a:lnTo>
                <a:cubicBezTo>
                  <a:pt x="616625" y="6894"/>
                  <a:pt x="629272" y="13174"/>
                  <a:pt x="593725" y="9619"/>
                </a:cubicBezTo>
                <a:cubicBezTo>
                  <a:pt x="590550" y="8561"/>
                  <a:pt x="587447" y="7256"/>
                  <a:pt x="584200" y="6444"/>
                </a:cubicBezTo>
                <a:cubicBezTo>
                  <a:pt x="555792" y="-658"/>
                  <a:pt x="529136" y="733"/>
                  <a:pt x="498475" y="94"/>
                </a:cubicBezTo>
                <a:cubicBezTo>
                  <a:pt x="470964" y="-479"/>
                  <a:pt x="459846" y="1681"/>
                  <a:pt x="444500" y="3269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10" name="フリーフォーム 209"/>
          <p:cNvSpPr/>
          <p:nvPr/>
        </p:nvSpPr>
        <p:spPr>
          <a:xfrm>
            <a:off x="2239288" y="5400441"/>
            <a:ext cx="752475" cy="539844"/>
          </a:xfrm>
          <a:custGeom>
            <a:avLst/>
            <a:gdLst>
              <a:gd name="connsiteX0" fmla="*/ 444500 w 752475"/>
              <a:gd name="connsiteY0" fmla="*/ 3269 h 539844"/>
              <a:gd name="connsiteX1" fmla="*/ 406400 w 752475"/>
              <a:gd name="connsiteY1" fmla="*/ 9619 h 539844"/>
              <a:gd name="connsiteX2" fmla="*/ 374650 w 752475"/>
              <a:gd name="connsiteY2" fmla="*/ 12794 h 539844"/>
              <a:gd name="connsiteX3" fmla="*/ 365125 w 752475"/>
              <a:gd name="connsiteY3" fmla="*/ 19144 h 539844"/>
              <a:gd name="connsiteX4" fmla="*/ 358775 w 752475"/>
              <a:gd name="connsiteY4" fmla="*/ 28669 h 539844"/>
              <a:gd name="connsiteX5" fmla="*/ 349250 w 752475"/>
              <a:gd name="connsiteY5" fmla="*/ 31844 h 539844"/>
              <a:gd name="connsiteX6" fmla="*/ 320675 w 752475"/>
              <a:gd name="connsiteY6" fmla="*/ 47719 h 539844"/>
              <a:gd name="connsiteX7" fmla="*/ 257175 w 752475"/>
              <a:gd name="connsiteY7" fmla="*/ 50894 h 539844"/>
              <a:gd name="connsiteX8" fmla="*/ 231775 w 752475"/>
              <a:gd name="connsiteY8" fmla="*/ 54069 h 539844"/>
              <a:gd name="connsiteX9" fmla="*/ 180975 w 752475"/>
              <a:gd name="connsiteY9" fmla="*/ 60419 h 539844"/>
              <a:gd name="connsiteX10" fmla="*/ 161925 w 752475"/>
              <a:gd name="connsiteY10" fmla="*/ 66769 h 539844"/>
              <a:gd name="connsiteX11" fmla="*/ 152400 w 752475"/>
              <a:gd name="connsiteY11" fmla="*/ 69944 h 539844"/>
              <a:gd name="connsiteX12" fmla="*/ 142875 w 752475"/>
              <a:gd name="connsiteY12" fmla="*/ 76294 h 539844"/>
              <a:gd name="connsiteX13" fmla="*/ 133350 w 752475"/>
              <a:gd name="connsiteY13" fmla="*/ 79469 h 539844"/>
              <a:gd name="connsiteX14" fmla="*/ 104775 w 752475"/>
              <a:gd name="connsiteY14" fmla="*/ 98519 h 539844"/>
              <a:gd name="connsiteX15" fmla="*/ 95250 w 752475"/>
              <a:gd name="connsiteY15" fmla="*/ 101694 h 539844"/>
              <a:gd name="connsiteX16" fmla="*/ 79375 w 752475"/>
              <a:gd name="connsiteY16" fmla="*/ 117569 h 539844"/>
              <a:gd name="connsiteX17" fmla="*/ 63500 w 752475"/>
              <a:gd name="connsiteY17" fmla="*/ 133444 h 539844"/>
              <a:gd name="connsiteX18" fmla="*/ 53975 w 752475"/>
              <a:gd name="connsiteY18" fmla="*/ 152494 h 539844"/>
              <a:gd name="connsiteX19" fmla="*/ 50800 w 752475"/>
              <a:gd name="connsiteY19" fmla="*/ 162019 h 539844"/>
              <a:gd name="connsiteX20" fmla="*/ 38100 w 752475"/>
              <a:gd name="connsiteY20" fmla="*/ 181069 h 539844"/>
              <a:gd name="connsiteX21" fmla="*/ 31750 w 752475"/>
              <a:gd name="connsiteY21" fmla="*/ 190594 h 539844"/>
              <a:gd name="connsiteX22" fmla="*/ 28575 w 752475"/>
              <a:gd name="connsiteY22" fmla="*/ 200119 h 539844"/>
              <a:gd name="connsiteX23" fmla="*/ 15875 w 752475"/>
              <a:gd name="connsiteY23" fmla="*/ 219169 h 539844"/>
              <a:gd name="connsiteX24" fmla="*/ 6350 w 752475"/>
              <a:gd name="connsiteY24" fmla="*/ 238219 h 539844"/>
              <a:gd name="connsiteX25" fmla="*/ 0 w 752475"/>
              <a:gd name="connsiteY25" fmla="*/ 273144 h 539844"/>
              <a:gd name="connsiteX26" fmla="*/ 3175 w 752475"/>
              <a:gd name="connsiteY26" fmla="*/ 333469 h 539844"/>
              <a:gd name="connsiteX27" fmla="*/ 9525 w 752475"/>
              <a:gd name="connsiteY27" fmla="*/ 352519 h 539844"/>
              <a:gd name="connsiteX28" fmla="*/ 22225 w 752475"/>
              <a:gd name="connsiteY28" fmla="*/ 368394 h 539844"/>
              <a:gd name="connsiteX29" fmla="*/ 25400 w 752475"/>
              <a:gd name="connsiteY29" fmla="*/ 377919 h 539844"/>
              <a:gd name="connsiteX30" fmla="*/ 50800 w 752475"/>
              <a:gd name="connsiteY30" fmla="*/ 406494 h 539844"/>
              <a:gd name="connsiteX31" fmla="*/ 60325 w 752475"/>
              <a:gd name="connsiteY31" fmla="*/ 409669 h 539844"/>
              <a:gd name="connsiteX32" fmla="*/ 88900 w 752475"/>
              <a:gd name="connsiteY32" fmla="*/ 431894 h 539844"/>
              <a:gd name="connsiteX33" fmla="*/ 117475 w 752475"/>
              <a:gd name="connsiteY33" fmla="*/ 454119 h 539844"/>
              <a:gd name="connsiteX34" fmla="*/ 136525 w 752475"/>
              <a:gd name="connsiteY34" fmla="*/ 466819 h 539844"/>
              <a:gd name="connsiteX35" fmla="*/ 146050 w 752475"/>
              <a:gd name="connsiteY35" fmla="*/ 473169 h 539844"/>
              <a:gd name="connsiteX36" fmla="*/ 155575 w 752475"/>
              <a:gd name="connsiteY36" fmla="*/ 476344 h 539844"/>
              <a:gd name="connsiteX37" fmla="*/ 174625 w 752475"/>
              <a:gd name="connsiteY37" fmla="*/ 489044 h 539844"/>
              <a:gd name="connsiteX38" fmla="*/ 184150 w 752475"/>
              <a:gd name="connsiteY38" fmla="*/ 495394 h 539844"/>
              <a:gd name="connsiteX39" fmla="*/ 203200 w 752475"/>
              <a:gd name="connsiteY39" fmla="*/ 501744 h 539844"/>
              <a:gd name="connsiteX40" fmla="*/ 212725 w 752475"/>
              <a:gd name="connsiteY40" fmla="*/ 508094 h 539844"/>
              <a:gd name="connsiteX41" fmla="*/ 234950 w 752475"/>
              <a:gd name="connsiteY41" fmla="*/ 517619 h 539844"/>
              <a:gd name="connsiteX42" fmla="*/ 244475 w 752475"/>
              <a:gd name="connsiteY42" fmla="*/ 523969 h 539844"/>
              <a:gd name="connsiteX43" fmla="*/ 260350 w 752475"/>
              <a:gd name="connsiteY43" fmla="*/ 527144 h 539844"/>
              <a:gd name="connsiteX44" fmla="*/ 279400 w 752475"/>
              <a:gd name="connsiteY44" fmla="*/ 533494 h 539844"/>
              <a:gd name="connsiteX45" fmla="*/ 352425 w 752475"/>
              <a:gd name="connsiteY45" fmla="*/ 539844 h 539844"/>
              <a:gd name="connsiteX46" fmla="*/ 447675 w 752475"/>
              <a:gd name="connsiteY46" fmla="*/ 536669 h 539844"/>
              <a:gd name="connsiteX47" fmla="*/ 466725 w 752475"/>
              <a:gd name="connsiteY47" fmla="*/ 533494 h 539844"/>
              <a:gd name="connsiteX48" fmla="*/ 492125 w 752475"/>
              <a:gd name="connsiteY48" fmla="*/ 530319 h 539844"/>
              <a:gd name="connsiteX49" fmla="*/ 517525 w 752475"/>
              <a:gd name="connsiteY49" fmla="*/ 523969 h 539844"/>
              <a:gd name="connsiteX50" fmla="*/ 533400 w 752475"/>
              <a:gd name="connsiteY50" fmla="*/ 520794 h 539844"/>
              <a:gd name="connsiteX51" fmla="*/ 552450 w 752475"/>
              <a:gd name="connsiteY51" fmla="*/ 514444 h 539844"/>
              <a:gd name="connsiteX52" fmla="*/ 561975 w 752475"/>
              <a:gd name="connsiteY52" fmla="*/ 511269 h 539844"/>
              <a:gd name="connsiteX53" fmla="*/ 571500 w 752475"/>
              <a:gd name="connsiteY53" fmla="*/ 504919 h 539844"/>
              <a:gd name="connsiteX54" fmla="*/ 590550 w 752475"/>
              <a:gd name="connsiteY54" fmla="*/ 498569 h 539844"/>
              <a:gd name="connsiteX55" fmla="*/ 600075 w 752475"/>
              <a:gd name="connsiteY55" fmla="*/ 492219 h 539844"/>
              <a:gd name="connsiteX56" fmla="*/ 606425 w 752475"/>
              <a:gd name="connsiteY56" fmla="*/ 482694 h 539844"/>
              <a:gd name="connsiteX57" fmla="*/ 625475 w 752475"/>
              <a:gd name="connsiteY57" fmla="*/ 476344 h 539844"/>
              <a:gd name="connsiteX58" fmla="*/ 635000 w 752475"/>
              <a:gd name="connsiteY58" fmla="*/ 469994 h 539844"/>
              <a:gd name="connsiteX59" fmla="*/ 644525 w 752475"/>
              <a:gd name="connsiteY59" fmla="*/ 460469 h 539844"/>
              <a:gd name="connsiteX60" fmla="*/ 654050 w 752475"/>
              <a:gd name="connsiteY60" fmla="*/ 457294 h 539844"/>
              <a:gd name="connsiteX61" fmla="*/ 660400 w 752475"/>
              <a:gd name="connsiteY61" fmla="*/ 447769 h 539844"/>
              <a:gd name="connsiteX62" fmla="*/ 669925 w 752475"/>
              <a:gd name="connsiteY62" fmla="*/ 441419 h 539844"/>
              <a:gd name="connsiteX63" fmla="*/ 682625 w 752475"/>
              <a:gd name="connsiteY63" fmla="*/ 422369 h 539844"/>
              <a:gd name="connsiteX64" fmla="*/ 695325 w 752475"/>
              <a:gd name="connsiteY64" fmla="*/ 403319 h 539844"/>
              <a:gd name="connsiteX65" fmla="*/ 698500 w 752475"/>
              <a:gd name="connsiteY65" fmla="*/ 393794 h 539844"/>
              <a:gd name="connsiteX66" fmla="*/ 704850 w 752475"/>
              <a:gd name="connsiteY66" fmla="*/ 384269 h 539844"/>
              <a:gd name="connsiteX67" fmla="*/ 714375 w 752475"/>
              <a:gd name="connsiteY67" fmla="*/ 355694 h 539844"/>
              <a:gd name="connsiteX68" fmla="*/ 717550 w 752475"/>
              <a:gd name="connsiteY68" fmla="*/ 346169 h 539844"/>
              <a:gd name="connsiteX69" fmla="*/ 723900 w 752475"/>
              <a:gd name="connsiteY69" fmla="*/ 298544 h 539844"/>
              <a:gd name="connsiteX70" fmla="*/ 730250 w 752475"/>
              <a:gd name="connsiteY70" fmla="*/ 279494 h 539844"/>
              <a:gd name="connsiteX71" fmla="*/ 736600 w 752475"/>
              <a:gd name="connsiteY71" fmla="*/ 260444 h 539844"/>
              <a:gd name="connsiteX72" fmla="*/ 739775 w 752475"/>
              <a:gd name="connsiteY72" fmla="*/ 250919 h 539844"/>
              <a:gd name="connsiteX73" fmla="*/ 749300 w 752475"/>
              <a:gd name="connsiteY73" fmla="*/ 219169 h 539844"/>
              <a:gd name="connsiteX74" fmla="*/ 752475 w 752475"/>
              <a:gd name="connsiteY74" fmla="*/ 209644 h 539844"/>
              <a:gd name="connsiteX75" fmla="*/ 749300 w 752475"/>
              <a:gd name="connsiteY75" fmla="*/ 146144 h 539844"/>
              <a:gd name="connsiteX76" fmla="*/ 742950 w 752475"/>
              <a:gd name="connsiteY76" fmla="*/ 127094 h 539844"/>
              <a:gd name="connsiteX77" fmla="*/ 736600 w 752475"/>
              <a:gd name="connsiteY77" fmla="*/ 108044 h 539844"/>
              <a:gd name="connsiteX78" fmla="*/ 727075 w 752475"/>
              <a:gd name="connsiteY78" fmla="*/ 98519 h 539844"/>
              <a:gd name="connsiteX79" fmla="*/ 717550 w 752475"/>
              <a:gd name="connsiteY79" fmla="*/ 79469 h 539844"/>
              <a:gd name="connsiteX80" fmla="*/ 708025 w 752475"/>
              <a:gd name="connsiteY80" fmla="*/ 69944 h 539844"/>
              <a:gd name="connsiteX81" fmla="*/ 701675 w 752475"/>
              <a:gd name="connsiteY81" fmla="*/ 60419 h 539844"/>
              <a:gd name="connsiteX82" fmla="*/ 682625 w 752475"/>
              <a:gd name="connsiteY82" fmla="*/ 47719 h 539844"/>
              <a:gd name="connsiteX83" fmla="*/ 663575 w 752475"/>
              <a:gd name="connsiteY83" fmla="*/ 35019 h 539844"/>
              <a:gd name="connsiteX84" fmla="*/ 654050 w 752475"/>
              <a:gd name="connsiteY84" fmla="*/ 31844 h 539844"/>
              <a:gd name="connsiteX85" fmla="*/ 635000 w 752475"/>
              <a:gd name="connsiteY85" fmla="*/ 19144 h 539844"/>
              <a:gd name="connsiteX86" fmla="*/ 593725 w 752475"/>
              <a:gd name="connsiteY86" fmla="*/ 9619 h 539844"/>
              <a:gd name="connsiteX87" fmla="*/ 584200 w 752475"/>
              <a:gd name="connsiteY87" fmla="*/ 6444 h 539844"/>
              <a:gd name="connsiteX88" fmla="*/ 498475 w 752475"/>
              <a:gd name="connsiteY88" fmla="*/ 94 h 539844"/>
              <a:gd name="connsiteX89" fmla="*/ 444500 w 752475"/>
              <a:gd name="connsiteY89" fmla="*/ 3269 h 53984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752475" h="539844">
                <a:moveTo>
                  <a:pt x="444500" y="3269"/>
                </a:moveTo>
                <a:cubicBezTo>
                  <a:pt x="429154" y="4857"/>
                  <a:pt x="425528" y="7369"/>
                  <a:pt x="406400" y="9619"/>
                </a:cubicBezTo>
                <a:cubicBezTo>
                  <a:pt x="395837" y="10862"/>
                  <a:pt x="385233" y="11736"/>
                  <a:pt x="374650" y="12794"/>
                </a:cubicBezTo>
                <a:cubicBezTo>
                  <a:pt x="371475" y="14911"/>
                  <a:pt x="367823" y="16446"/>
                  <a:pt x="365125" y="19144"/>
                </a:cubicBezTo>
                <a:cubicBezTo>
                  <a:pt x="362427" y="21842"/>
                  <a:pt x="361755" y="26285"/>
                  <a:pt x="358775" y="28669"/>
                </a:cubicBezTo>
                <a:cubicBezTo>
                  <a:pt x="356162" y="30760"/>
                  <a:pt x="352425" y="30786"/>
                  <a:pt x="349250" y="31844"/>
                </a:cubicBezTo>
                <a:cubicBezTo>
                  <a:pt x="343663" y="35569"/>
                  <a:pt x="330315" y="46881"/>
                  <a:pt x="320675" y="47719"/>
                </a:cubicBezTo>
                <a:cubicBezTo>
                  <a:pt x="299562" y="49555"/>
                  <a:pt x="278342" y="49836"/>
                  <a:pt x="257175" y="50894"/>
                </a:cubicBezTo>
                <a:lnTo>
                  <a:pt x="231775" y="54069"/>
                </a:lnTo>
                <a:cubicBezTo>
                  <a:pt x="213739" y="55968"/>
                  <a:pt x="198035" y="55766"/>
                  <a:pt x="180975" y="60419"/>
                </a:cubicBezTo>
                <a:cubicBezTo>
                  <a:pt x="174517" y="62180"/>
                  <a:pt x="168275" y="64652"/>
                  <a:pt x="161925" y="66769"/>
                </a:cubicBezTo>
                <a:lnTo>
                  <a:pt x="152400" y="69944"/>
                </a:lnTo>
                <a:cubicBezTo>
                  <a:pt x="149225" y="72061"/>
                  <a:pt x="146288" y="74587"/>
                  <a:pt x="142875" y="76294"/>
                </a:cubicBezTo>
                <a:cubicBezTo>
                  <a:pt x="139882" y="77791"/>
                  <a:pt x="136276" y="77844"/>
                  <a:pt x="133350" y="79469"/>
                </a:cubicBezTo>
                <a:lnTo>
                  <a:pt x="104775" y="98519"/>
                </a:lnTo>
                <a:cubicBezTo>
                  <a:pt x="101990" y="100375"/>
                  <a:pt x="98425" y="100636"/>
                  <a:pt x="95250" y="101694"/>
                </a:cubicBezTo>
                <a:cubicBezTo>
                  <a:pt x="78317" y="127094"/>
                  <a:pt x="100542" y="96402"/>
                  <a:pt x="79375" y="117569"/>
                </a:cubicBezTo>
                <a:cubicBezTo>
                  <a:pt x="58208" y="138736"/>
                  <a:pt x="88900" y="116511"/>
                  <a:pt x="63500" y="133444"/>
                </a:cubicBezTo>
                <a:cubicBezTo>
                  <a:pt x="55520" y="157385"/>
                  <a:pt x="66285" y="127875"/>
                  <a:pt x="53975" y="152494"/>
                </a:cubicBezTo>
                <a:cubicBezTo>
                  <a:pt x="52478" y="155487"/>
                  <a:pt x="52425" y="159093"/>
                  <a:pt x="50800" y="162019"/>
                </a:cubicBezTo>
                <a:cubicBezTo>
                  <a:pt x="47094" y="168690"/>
                  <a:pt x="42333" y="174719"/>
                  <a:pt x="38100" y="181069"/>
                </a:cubicBezTo>
                <a:cubicBezTo>
                  <a:pt x="35983" y="184244"/>
                  <a:pt x="32957" y="186974"/>
                  <a:pt x="31750" y="190594"/>
                </a:cubicBezTo>
                <a:cubicBezTo>
                  <a:pt x="30692" y="193769"/>
                  <a:pt x="30200" y="197193"/>
                  <a:pt x="28575" y="200119"/>
                </a:cubicBezTo>
                <a:cubicBezTo>
                  <a:pt x="24869" y="206790"/>
                  <a:pt x="18288" y="211929"/>
                  <a:pt x="15875" y="219169"/>
                </a:cubicBezTo>
                <a:cubicBezTo>
                  <a:pt x="11493" y="232314"/>
                  <a:pt x="14556" y="225909"/>
                  <a:pt x="6350" y="238219"/>
                </a:cubicBezTo>
                <a:cubicBezTo>
                  <a:pt x="3571" y="249334"/>
                  <a:pt x="0" y="261768"/>
                  <a:pt x="0" y="273144"/>
                </a:cubicBezTo>
                <a:cubicBezTo>
                  <a:pt x="0" y="293280"/>
                  <a:pt x="776" y="313476"/>
                  <a:pt x="3175" y="333469"/>
                </a:cubicBezTo>
                <a:cubicBezTo>
                  <a:pt x="3972" y="340115"/>
                  <a:pt x="7408" y="346169"/>
                  <a:pt x="9525" y="352519"/>
                </a:cubicBezTo>
                <a:cubicBezTo>
                  <a:pt x="13907" y="365664"/>
                  <a:pt x="9915" y="360188"/>
                  <a:pt x="22225" y="368394"/>
                </a:cubicBezTo>
                <a:cubicBezTo>
                  <a:pt x="23283" y="371569"/>
                  <a:pt x="23903" y="374926"/>
                  <a:pt x="25400" y="377919"/>
                </a:cubicBezTo>
                <a:cubicBezTo>
                  <a:pt x="29635" y="386390"/>
                  <a:pt x="45751" y="404811"/>
                  <a:pt x="50800" y="406494"/>
                </a:cubicBezTo>
                <a:lnTo>
                  <a:pt x="60325" y="409669"/>
                </a:lnTo>
                <a:cubicBezTo>
                  <a:pt x="81742" y="431086"/>
                  <a:pt x="70856" y="425879"/>
                  <a:pt x="88900" y="431894"/>
                </a:cubicBezTo>
                <a:cubicBezTo>
                  <a:pt x="110317" y="453311"/>
                  <a:pt x="99431" y="448104"/>
                  <a:pt x="117475" y="454119"/>
                </a:cubicBezTo>
                <a:lnTo>
                  <a:pt x="136525" y="466819"/>
                </a:lnTo>
                <a:cubicBezTo>
                  <a:pt x="139700" y="468936"/>
                  <a:pt x="142430" y="471962"/>
                  <a:pt x="146050" y="473169"/>
                </a:cubicBezTo>
                <a:lnTo>
                  <a:pt x="155575" y="476344"/>
                </a:lnTo>
                <a:cubicBezTo>
                  <a:pt x="173631" y="494400"/>
                  <a:pt x="156245" y="479854"/>
                  <a:pt x="174625" y="489044"/>
                </a:cubicBezTo>
                <a:cubicBezTo>
                  <a:pt x="178038" y="490751"/>
                  <a:pt x="180663" y="493844"/>
                  <a:pt x="184150" y="495394"/>
                </a:cubicBezTo>
                <a:cubicBezTo>
                  <a:pt x="190267" y="498112"/>
                  <a:pt x="203200" y="501744"/>
                  <a:pt x="203200" y="501744"/>
                </a:cubicBezTo>
                <a:cubicBezTo>
                  <a:pt x="206375" y="503861"/>
                  <a:pt x="209312" y="506387"/>
                  <a:pt x="212725" y="508094"/>
                </a:cubicBezTo>
                <a:cubicBezTo>
                  <a:pt x="248345" y="525904"/>
                  <a:pt x="188702" y="491192"/>
                  <a:pt x="234950" y="517619"/>
                </a:cubicBezTo>
                <a:cubicBezTo>
                  <a:pt x="238263" y="519512"/>
                  <a:pt x="240902" y="522629"/>
                  <a:pt x="244475" y="523969"/>
                </a:cubicBezTo>
                <a:cubicBezTo>
                  <a:pt x="249528" y="525864"/>
                  <a:pt x="255144" y="525724"/>
                  <a:pt x="260350" y="527144"/>
                </a:cubicBezTo>
                <a:cubicBezTo>
                  <a:pt x="266808" y="528905"/>
                  <a:pt x="272774" y="532547"/>
                  <a:pt x="279400" y="533494"/>
                </a:cubicBezTo>
                <a:cubicBezTo>
                  <a:pt x="318421" y="539068"/>
                  <a:pt x="294156" y="536202"/>
                  <a:pt x="352425" y="539844"/>
                </a:cubicBezTo>
                <a:cubicBezTo>
                  <a:pt x="384175" y="538786"/>
                  <a:pt x="415956" y="538431"/>
                  <a:pt x="447675" y="536669"/>
                </a:cubicBezTo>
                <a:cubicBezTo>
                  <a:pt x="454103" y="536312"/>
                  <a:pt x="460352" y="534404"/>
                  <a:pt x="466725" y="533494"/>
                </a:cubicBezTo>
                <a:cubicBezTo>
                  <a:pt x="475172" y="532287"/>
                  <a:pt x="483692" y="531616"/>
                  <a:pt x="492125" y="530319"/>
                </a:cubicBezTo>
                <a:cubicBezTo>
                  <a:pt x="522552" y="525638"/>
                  <a:pt x="495891" y="529377"/>
                  <a:pt x="517525" y="523969"/>
                </a:cubicBezTo>
                <a:cubicBezTo>
                  <a:pt x="522760" y="522660"/>
                  <a:pt x="528194" y="522214"/>
                  <a:pt x="533400" y="520794"/>
                </a:cubicBezTo>
                <a:cubicBezTo>
                  <a:pt x="539858" y="519033"/>
                  <a:pt x="546100" y="516561"/>
                  <a:pt x="552450" y="514444"/>
                </a:cubicBezTo>
                <a:lnTo>
                  <a:pt x="561975" y="511269"/>
                </a:lnTo>
                <a:cubicBezTo>
                  <a:pt x="565150" y="509152"/>
                  <a:pt x="568013" y="506469"/>
                  <a:pt x="571500" y="504919"/>
                </a:cubicBezTo>
                <a:cubicBezTo>
                  <a:pt x="577617" y="502201"/>
                  <a:pt x="590550" y="498569"/>
                  <a:pt x="590550" y="498569"/>
                </a:cubicBezTo>
                <a:cubicBezTo>
                  <a:pt x="593725" y="496452"/>
                  <a:pt x="597377" y="494917"/>
                  <a:pt x="600075" y="492219"/>
                </a:cubicBezTo>
                <a:cubicBezTo>
                  <a:pt x="602773" y="489521"/>
                  <a:pt x="603189" y="484716"/>
                  <a:pt x="606425" y="482694"/>
                </a:cubicBezTo>
                <a:cubicBezTo>
                  <a:pt x="612101" y="479146"/>
                  <a:pt x="625475" y="476344"/>
                  <a:pt x="625475" y="476344"/>
                </a:cubicBezTo>
                <a:cubicBezTo>
                  <a:pt x="628650" y="474227"/>
                  <a:pt x="632069" y="472437"/>
                  <a:pt x="635000" y="469994"/>
                </a:cubicBezTo>
                <a:cubicBezTo>
                  <a:pt x="638449" y="467119"/>
                  <a:pt x="640789" y="462960"/>
                  <a:pt x="644525" y="460469"/>
                </a:cubicBezTo>
                <a:cubicBezTo>
                  <a:pt x="647310" y="458613"/>
                  <a:pt x="650875" y="458352"/>
                  <a:pt x="654050" y="457294"/>
                </a:cubicBezTo>
                <a:cubicBezTo>
                  <a:pt x="656167" y="454119"/>
                  <a:pt x="657702" y="450467"/>
                  <a:pt x="660400" y="447769"/>
                </a:cubicBezTo>
                <a:cubicBezTo>
                  <a:pt x="663098" y="445071"/>
                  <a:pt x="667412" y="444291"/>
                  <a:pt x="669925" y="441419"/>
                </a:cubicBezTo>
                <a:cubicBezTo>
                  <a:pt x="674951" y="435676"/>
                  <a:pt x="678392" y="428719"/>
                  <a:pt x="682625" y="422369"/>
                </a:cubicBezTo>
                <a:lnTo>
                  <a:pt x="695325" y="403319"/>
                </a:lnTo>
                <a:cubicBezTo>
                  <a:pt x="697181" y="400534"/>
                  <a:pt x="697003" y="396787"/>
                  <a:pt x="698500" y="393794"/>
                </a:cubicBezTo>
                <a:cubicBezTo>
                  <a:pt x="700207" y="390381"/>
                  <a:pt x="703300" y="387756"/>
                  <a:pt x="704850" y="384269"/>
                </a:cubicBezTo>
                <a:lnTo>
                  <a:pt x="714375" y="355694"/>
                </a:lnTo>
                <a:lnTo>
                  <a:pt x="717550" y="346169"/>
                </a:lnTo>
                <a:cubicBezTo>
                  <a:pt x="718607" y="336655"/>
                  <a:pt x="721050" y="309945"/>
                  <a:pt x="723900" y="298544"/>
                </a:cubicBezTo>
                <a:cubicBezTo>
                  <a:pt x="725523" y="292050"/>
                  <a:pt x="728133" y="285844"/>
                  <a:pt x="730250" y="279494"/>
                </a:cubicBezTo>
                <a:lnTo>
                  <a:pt x="736600" y="260444"/>
                </a:lnTo>
                <a:cubicBezTo>
                  <a:pt x="737658" y="257269"/>
                  <a:pt x="738963" y="254166"/>
                  <a:pt x="739775" y="250919"/>
                </a:cubicBezTo>
                <a:cubicBezTo>
                  <a:pt x="744573" y="231725"/>
                  <a:pt x="741570" y="242359"/>
                  <a:pt x="749300" y="219169"/>
                </a:cubicBezTo>
                <a:lnTo>
                  <a:pt x="752475" y="209644"/>
                </a:lnTo>
                <a:cubicBezTo>
                  <a:pt x="751417" y="188477"/>
                  <a:pt x="751729" y="167197"/>
                  <a:pt x="749300" y="146144"/>
                </a:cubicBezTo>
                <a:cubicBezTo>
                  <a:pt x="748533" y="139495"/>
                  <a:pt x="745067" y="133444"/>
                  <a:pt x="742950" y="127094"/>
                </a:cubicBezTo>
                <a:lnTo>
                  <a:pt x="736600" y="108044"/>
                </a:lnTo>
                <a:cubicBezTo>
                  <a:pt x="735180" y="103784"/>
                  <a:pt x="729950" y="101968"/>
                  <a:pt x="727075" y="98519"/>
                </a:cubicBezTo>
                <a:cubicBezTo>
                  <a:pt x="702096" y="68544"/>
                  <a:pt x="736643" y="108108"/>
                  <a:pt x="717550" y="79469"/>
                </a:cubicBezTo>
                <a:cubicBezTo>
                  <a:pt x="715059" y="75733"/>
                  <a:pt x="710900" y="73393"/>
                  <a:pt x="708025" y="69944"/>
                </a:cubicBezTo>
                <a:cubicBezTo>
                  <a:pt x="705582" y="67013"/>
                  <a:pt x="704547" y="62932"/>
                  <a:pt x="701675" y="60419"/>
                </a:cubicBezTo>
                <a:cubicBezTo>
                  <a:pt x="695932" y="55393"/>
                  <a:pt x="688975" y="51952"/>
                  <a:pt x="682625" y="47719"/>
                </a:cubicBezTo>
                <a:lnTo>
                  <a:pt x="663575" y="35019"/>
                </a:lnTo>
                <a:cubicBezTo>
                  <a:pt x="660790" y="33163"/>
                  <a:pt x="657225" y="32902"/>
                  <a:pt x="654050" y="31844"/>
                </a:cubicBezTo>
                <a:lnTo>
                  <a:pt x="635000" y="19144"/>
                </a:lnTo>
                <a:cubicBezTo>
                  <a:pt x="616625" y="6894"/>
                  <a:pt x="629272" y="13174"/>
                  <a:pt x="593725" y="9619"/>
                </a:cubicBezTo>
                <a:cubicBezTo>
                  <a:pt x="590550" y="8561"/>
                  <a:pt x="587447" y="7256"/>
                  <a:pt x="584200" y="6444"/>
                </a:cubicBezTo>
                <a:cubicBezTo>
                  <a:pt x="555792" y="-658"/>
                  <a:pt x="529136" y="733"/>
                  <a:pt x="498475" y="94"/>
                </a:cubicBezTo>
                <a:cubicBezTo>
                  <a:pt x="470964" y="-479"/>
                  <a:pt x="459846" y="1681"/>
                  <a:pt x="444500" y="3269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11" name="フリーフォーム 210"/>
          <p:cNvSpPr/>
          <p:nvPr/>
        </p:nvSpPr>
        <p:spPr>
          <a:xfrm>
            <a:off x="843428" y="5400441"/>
            <a:ext cx="752475" cy="539844"/>
          </a:xfrm>
          <a:custGeom>
            <a:avLst/>
            <a:gdLst>
              <a:gd name="connsiteX0" fmla="*/ 444500 w 752475"/>
              <a:gd name="connsiteY0" fmla="*/ 3269 h 539844"/>
              <a:gd name="connsiteX1" fmla="*/ 406400 w 752475"/>
              <a:gd name="connsiteY1" fmla="*/ 9619 h 539844"/>
              <a:gd name="connsiteX2" fmla="*/ 374650 w 752475"/>
              <a:gd name="connsiteY2" fmla="*/ 12794 h 539844"/>
              <a:gd name="connsiteX3" fmla="*/ 365125 w 752475"/>
              <a:gd name="connsiteY3" fmla="*/ 19144 h 539844"/>
              <a:gd name="connsiteX4" fmla="*/ 358775 w 752475"/>
              <a:gd name="connsiteY4" fmla="*/ 28669 h 539844"/>
              <a:gd name="connsiteX5" fmla="*/ 349250 w 752475"/>
              <a:gd name="connsiteY5" fmla="*/ 31844 h 539844"/>
              <a:gd name="connsiteX6" fmla="*/ 320675 w 752475"/>
              <a:gd name="connsiteY6" fmla="*/ 47719 h 539844"/>
              <a:gd name="connsiteX7" fmla="*/ 257175 w 752475"/>
              <a:gd name="connsiteY7" fmla="*/ 50894 h 539844"/>
              <a:gd name="connsiteX8" fmla="*/ 231775 w 752475"/>
              <a:gd name="connsiteY8" fmla="*/ 54069 h 539844"/>
              <a:gd name="connsiteX9" fmla="*/ 180975 w 752475"/>
              <a:gd name="connsiteY9" fmla="*/ 60419 h 539844"/>
              <a:gd name="connsiteX10" fmla="*/ 161925 w 752475"/>
              <a:gd name="connsiteY10" fmla="*/ 66769 h 539844"/>
              <a:gd name="connsiteX11" fmla="*/ 152400 w 752475"/>
              <a:gd name="connsiteY11" fmla="*/ 69944 h 539844"/>
              <a:gd name="connsiteX12" fmla="*/ 142875 w 752475"/>
              <a:gd name="connsiteY12" fmla="*/ 76294 h 539844"/>
              <a:gd name="connsiteX13" fmla="*/ 133350 w 752475"/>
              <a:gd name="connsiteY13" fmla="*/ 79469 h 539844"/>
              <a:gd name="connsiteX14" fmla="*/ 104775 w 752475"/>
              <a:gd name="connsiteY14" fmla="*/ 98519 h 539844"/>
              <a:gd name="connsiteX15" fmla="*/ 95250 w 752475"/>
              <a:gd name="connsiteY15" fmla="*/ 101694 h 539844"/>
              <a:gd name="connsiteX16" fmla="*/ 79375 w 752475"/>
              <a:gd name="connsiteY16" fmla="*/ 117569 h 539844"/>
              <a:gd name="connsiteX17" fmla="*/ 63500 w 752475"/>
              <a:gd name="connsiteY17" fmla="*/ 133444 h 539844"/>
              <a:gd name="connsiteX18" fmla="*/ 53975 w 752475"/>
              <a:gd name="connsiteY18" fmla="*/ 152494 h 539844"/>
              <a:gd name="connsiteX19" fmla="*/ 50800 w 752475"/>
              <a:gd name="connsiteY19" fmla="*/ 162019 h 539844"/>
              <a:gd name="connsiteX20" fmla="*/ 38100 w 752475"/>
              <a:gd name="connsiteY20" fmla="*/ 181069 h 539844"/>
              <a:gd name="connsiteX21" fmla="*/ 31750 w 752475"/>
              <a:gd name="connsiteY21" fmla="*/ 190594 h 539844"/>
              <a:gd name="connsiteX22" fmla="*/ 28575 w 752475"/>
              <a:gd name="connsiteY22" fmla="*/ 200119 h 539844"/>
              <a:gd name="connsiteX23" fmla="*/ 15875 w 752475"/>
              <a:gd name="connsiteY23" fmla="*/ 219169 h 539844"/>
              <a:gd name="connsiteX24" fmla="*/ 6350 w 752475"/>
              <a:gd name="connsiteY24" fmla="*/ 238219 h 539844"/>
              <a:gd name="connsiteX25" fmla="*/ 0 w 752475"/>
              <a:gd name="connsiteY25" fmla="*/ 273144 h 539844"/>
              <a:gd name="connsiteX26" fmla="*/ 3175 w 752475"/>
              <a:gd name="connsiteY26" fmla="*/ 333469 h 539844"/>
              <a:gd name="connsiteX27" fmla="*/ 9525 w 752475"/>
              <a:gd name="connsiteY27" fmla="*/ 352519 h 539844"/>
              <a:gd name="connsiteX28" fmla="*/ 22225 w 752475"/>
              <a:gd name="connsiteY28" fmla="*/ 368394 h 539844"/>
              <a:gd name="connsiteX29" fmla="*/ 25400 w 752475"/>
              <a:gd name="connsiteY29" fmla="*/ 377919 h 539844"/>
              <a:gd name="connsiteX30" fmla="*/ 50800 w 752475"/>
              <a:gd name="connsiteY30" fmla="*/ 406494 h 539844"/>
              <a:gd name="connsiteX31" fmla="*/ 60325 w 752475"/>
              <a:gd name="connsiteY31" fmla="*/ 409669 h 539844"/>
              <a:gd name="connsiteX32" fmla="*/ 88900 w 752475"/>
              <a:gd name="connsiteY32" fmla="*/ 431894 h 539844"/>
              <a:gd name="connsiteX33" fmla="*/ 117475 w 752475"/>
              <a:gd name="connsiteY33" fmla="*/ 454119 h 539844"/>
              <a:gd name="connsiteX34" fmla="*/ 136525 w 752475"/>
              <a:gd name="connsiteY34" fmla="*/ 466819 h 539844"/>
              <a:gd name="connsiteX35" fmla="*/ 146050 w 752475"/>
              <a:gd name="connsiteY35" fmla="*/ 473169 h 539844"/>
              <a:gd name="connsiteX36" fmla="*/ 155575 w 752475"/>
              <a:gd name="connsiteY36" fmla="*/ 476344 h 539844"/>
              <a:gd name="connsiteX37" fmla="*/ 174625 w 752475"/>
              <a:gd name="connsiteY37" fmla="*/ 489044 h 539844"/>
              <a:gd name="connsiteX38" fmla="*/ 184150 w 752475"/>
              <a:gd name="connsiteY38" fmla="*/ 495394 h 539844"/>
              <a:gd name="connsiteX39" fmla="*/ 203200 w 752475"/>
              <a:gd name="connsiteY39" fmla="*/ 501744 h 539844"/>
              <a:gd name="connsiteX40" fmla="*/ 212725 w 752475"/>
              <a:gd name="connsiteY40" fmla="*/ 508094 h 539844"/>
              <a:gd name="connsiteX41" fmla="*/ 234950 w 752475"/>
              <a:gd name="connsiteY41" fmla="*/ 517619 h 539844"/>
              <a:gd name="connsiteX42" fmla="*/ 244475 w 752475"/>
              <a:gd name="connsiteY42" fmla="*/ 523969 h 539844"/>
              <a:gd name="connsiteX43" fmla="*/ 260350 w 752475"/>
              <a:gd name="connsiteY43" fmla="*/ 527144 h 539844"/>
              <a:gd name="connsiteX44" fmla="*/ 279400 w 752475"/>
              <a:gd name="connsiteY44" fmla="*/ 533494 h 539844"/>
              <a:gd name="connsiteX45" fmla="*/ 352425 w 752475"/>
              <a:gd name="connsiteY45" fmla="*/ 539844 h 539844"/>
              <a:gd name="connsiteX46" fmla="*/ 447675 w 752475"/>
              <a:gd name="connsiteY46" fmla="*/ 536669 h 539844"/>
              <a:gd name="connsiteX47" fmla="*/ 466725 w 752475"/>
              <a:gd name="connsiteY47" fmla="*/ 533494 h 539844"/>
              <a:gd name="connsiteX48" fmla="*/ 492125 w 752475"/>
              <a:gd name="connsiteY48" fmla="*/ 530319 h 539844"/>
              <a:gd name="connsiteX49" fmla="*/ 517525 w 752475"/>
              <a:gd name="connsiteY49" fmla="*/ 523969 h 539844"/>
              <a:gd name="connsiteX50" fmla="*/ 533400 w 752475"/>
              <a:gd name="connsiteY50" fmla="*/ 520794 h 539844"/>
              <a:gd name="connsiteX51" fmla="*/ 552450 w 752475"/>
              <a:gd name="connsiteY51" fmla="*/ 514444 h 539844"/>
              <a:gd name="connsiteX52" fmla="*/ 561975 w 752475"/>
              <a:gd name="connsiteY52" fmla="*/ 511269 h 539844"/>
              <a:gd name="connsiteX53" fmla="*/ 571500 w 752475"/>
              <a:gd name="connsiteY53" fmla="*/ 504919 h 539844"/>
              <a:gd name="connsiteX54" fmla="*/ 590550 w 752475"/>
              <a:gd name="connsiteY54" fmla="*/ 498569 h 539844"/>
              <a:gd name="connsiteX55" fmla="*/ 600075 w 752475"/>
              <a:gd name="connsiteY55" fmla="*/ 492219 h 539844"/>
              <a:gd name="connsiteX56" fmla="*/ 606425 w 752475"/>
              <a:gd name="connsiteY56" fmla="*/ 482694 h 539844"/>
              <a:gd name="connsiteX57" fmla="*/ 625475 w 752475"/>
              <a:gd name="connsiteY57" fmla="*/ 476344 h 539844"/>
              <a:gd name="connsiteX58" fmla="*/ 635000 w 752475"/>
              <a:gd name="connsiteY58" fmla="*/ 469994 h 539844"/>
              <a:gd name="connsiteX59" fmla="*/ 644525 w 752475"/>
              <a:gd name="connsiteY59" fmla="*/ 460469 h 539844"/>
              <a:gd name="connsiteX60" fmla="*/ 654050 w 752475"/>
              <a:gd name="connsiteY60" fmla="*/ 457294 h 539844"/>
              <a:gd name="connsiteX61" fmla="*/ 660400 w 752475"/>
              <a:gd name="connsiteY61" fmla="*/ 447769 h 539844"/>
              <a:gd name="connsiteX62" fmla="*/ 669925 w 752475"/>
              <a:gd name="connsiteY62" fmla="*/ 441419 h 539844"/>
              <a:gd name="connsiteX63" fmla="*/ 682625 w 752475"/>
              <a:gd name="connsiteY63" fmla="*/ 422369 h 539844"/>
              <a:gd name="connsiteX64" fmla="*/ 695325 w 752475"/>
              <a:gd name="connsiteY64" fmla="*/ 403319 h 539844"/>
              <a:gd name="connsiteX65" fmla="*/ 698500 w 752475"/>
              <a:gd name="connsiteY65" fmla="*/ 393794 h 539844"/>
              <a:gd name="connsiteX66" fmla="*/ 704850 w 752475"/>
              <a:gd name="connsiteY66" fmla="*/ 384269 h 539844"/>
              <a:gd name="connsiteX67" fmla="*/ 714375 w 752475"/>
              <a:gd name="connsiteY67" fmla="*/ 355694 h 539844"/>
              <a:gd name="connsiteX68" fmla="*/ 717550 w 752475"/>
              <a:gd name="connsiteY68" fmla="*/ 346169 h 539844"/>
              <a:gd name="connsiteX69" fmla="*/ 723900 w 752475"/>
              <a:gd name="connsiteY69" fmla="*/ 298544 h 539844"/>
              <a:gd name="connsiteX70" fmla="*/ 730250 w 752475"/>
              <a:gd name="connsiteY70" fmla="*/ 279494 h 539844"/>
              <a:gd name="connsiteX71" fmla="*/ 736600 w 752475"/>
              <a:gd name="connsiteY71" fmla="*/ 260444 h 539844"/>
              <a:gd name="connsiteX72" fmla="*/ 739775 w 752475"/>
              <a:gd name="connsiteY72" fmla="*/ 250919 h 539844"/>
              <a:gd name="connsiteX73" fmla="*/ 749300 w 752475"/>
              <a:gd name="connsiteY73" fmla="*/ 219169 h 539844"/>
              <a:gd name="connsiteX74" fmla="*/ 752475 w 752475"/>
              <a:gd name="connsiteY74" fmla="*/ 209644 h 539844"/>
              <a:gd name="connsiteX75" fmla="*/ 749300 w 752475"/>
              <a:gd name="connsiteY75" fmla="*/ 146144 h 539844"/>
              <a:gd name="connsiteX76" fmla="*/ 742950 w 752475"/>
              <a:gd name="connsiteY76" fmla="*/ 127094 h 539844"/>
              <a:gd name="connsiteX77" fmla="*/ 736600 w 752475"/>
              <a:gd name="connsiteY77" fmla="*/ 108044 h 539844"/>
              <a:gd name="connsiteX78" fmla="*/ 727075 w 752475"/>
              <a:gd name="connsiteY78" fmla="*/ 98519 h 539844"/>
              <a:gd name="connsiteX79" fmla="*/ 717550 w 752475"/>
              <a:gd name="connsiteY79" fmla="*/ 79469 h 539844"/>
              <a:gd name="connsiteX80" fmla="*/ 708025 w 752475"/>
              <a:gd name="connsiteY80" fmla="*/ 69944 h 539844"/>
              <a:gd name="connsiteX81" fmla="*/ 701675 w 752475"/>
              <a:gd name="connsiteY81" fmla="*/ 60419 h 539844"/>
              <a:gd name="connsiteX82" fmla="*/ 682625 w 752475"/>
              <a:gd name="connsiteY82" fmla="*/ 47719 h 539844"/>
              <a:gd name="connsiteX83" fmla="*/ 663575 w 752475"/>
              <a:gd name="connsiteY83" fmla="*/ 35019 h 539844"/>
              <a:gd name="connsiteX84" fmla="*/ 654050 w 752475"/>
              <a:gd name="connsiteY84" fmla="*/ 31844 h 539844"/>
              <a:gd name="connsiteX85" fmla="*/ 635000 w 752475"/>
              <a:gd name="connsiteY85" fmla="*/ 19144 h 539844"/>
              <a:gd name="connsiteX86" fmla="*/ 593725 w 752475"/>
              <a:gd name="connsiteY86" fmla="*/ 9619 h 539844"/>
              <a:gd name="connsiteX87" fmla="*/ 584200 w 752475"/>
              <a:gd name="connsiteY87" fmla="*/ 6444 h 539844"/>
              <a:gd name="connsiteX88" fmla="*/ 498475 w 752475"/>
              <a:gd name="connsiteY88" fmla="*/ 94 h 539844"/>
              <a:gd name="connsiteX89" fmla="*/ 444500 w 752475"/>
              <a:gd name="connsiteY89" fmla="*/ 3269 h 53984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752475" h="539844">
                <a:moveTo>
                  <a:pt x="444500" y="3269"/>
                </a:moveTo>
                <a:cubicBezTo>
                  <a:pt x="429154" y="4857"/>
                  <a:pt x="425528" y="7369"/>
                  <a:pt x="406400" y="9619"/>
                </a:cubicBezTo>
                <a:cubicBezTo>
                  <a:pt x="395837" y="10862"/>
                  <a:pt x="385233" y="11736"/>
                  <a:pt x="374650" y="12794"/>
                </a:cubicBezTo>
                <a:cubicBezTo>
                  <a:pt x="371475" y="14911"/>
                  <a:pt x="367823" y="16446"/>
                  <a:pt x="365125" y="19144"/>
                </a:cubicBezTo>
                <a:cubicBezTo>
                  <a:pt x="362427" y="21842"/>
                  <a:pt x="361755" y="26285"/>
                  <a:pt x="358775" y="28669"/>
                </a:cubicBezTo>
                <a:cubicBezTo>
                  <a:pt x="356162" y="30760"/>
                  <a:pt x="352425" y="30786"/>
                  <a:pt x="349250" y="31844"/>
                </a:cubicBezTo>
                <a:cubicBezTo>
                  <a:pt x="343663" y="35569"/>
                  <a:pt x="330315" y="46881"/>
                  <a:pt x="320675" y="47719"/>
                </a:cubicBezTo>
                <a:cubicBezTo>
                  <a:pt x="299562" y="49555"/>
                  <a:pt x="278342" y="49836"/>
                  <a:pt x="257175" y="50894"/>
                </a:cubicBezTo>
                <a:lnTo>
                  <a:pt x="231775" y="54069"/>
                </a:lnTo>
                <a:cubicBezTo>
                  <a:pt x="213739" y="55968"/>
                  <a:pt x="198035" y="55766"/>
                  <a:pt x="180975" y="60419"/>
                </a:cubicBezTo>
                <a:cubicBezTo>
                  <a:pt x="174517" y="62180"/>
                  <a:pt x="168275" y="64652"/>
                  <a:pt x="161925" y="66769"/>
                </a:cubicBezTo>
                <a:lnTo>
                  <a:pt x="152400" y="69944"/>
                </a:lnTo>
                <a:cubicBezTo>
                  <a:pt x="149225" y="72061"/>
                  <a:pt x="146288" y="74587"/>
                  <a:pt x="142875" y="76294"/>
                </a:cubicBezTo>
                <a:cubicBezTo>
                  <a:pt x="139882" y="77791"/>
                  <a:pt x="136276" y="77844"/>
                  <a:pt x="133350" y="79469"/>
                </a:cubicBezTo>
                <a:lnTo>
                  <a:pt x="104775" y="98519"/>
                </a:lnTo>
                <a:cubicBezTo>
                  <a:pt x="101990" y="100375"/>
                  <a:pt x="98425" y="100636"/>
                  <a:pt x="95250" y="101694"/>
                </a:cubicBezTo>
                <a:cubicBezTo>
                  <a:pt x="78317" y="127094"/>
                  <a:pt x="100542" y="96402"/>
                  <a:pt x="79375" y="117569"/>
                </a:cubicBezTo>
                <a:cubicBezTo>
                  <a:pt x="58208" y="138736"/>
                  <a:pt x="88900" y="116511"/>
                  <a:pt x="63500" y="133444"/>
                </a:cubicBezTo>
                <a:cubicBezTo>
                  <a:pt x="55520" y="157385"/>
                  <a:pt x="66285" y="127875"/>
                  <a:pt x="53975" y="152494"/>
                </a:cubicBezTo>
                <a:cubicBezTo>
                  <a:pt x="52478" y="155487"/>
                  <a:pt x="52425" y="159093"/>
                  <a:pt x="50800" y="162019"/>
                </a:cubicBezTo>
                <a:cubicBezTo>
                  <a:pt x="47094" y="168690"/>
                  <a:pt x="42333" y="174719"/>
                  <a:pt x="38100" y="181069"/>
                </a:cubicBezTo>
                <a:cubicBezTo>
                  <a:pt x="35983" y="184244"/>
                  <a:pt x="32957" y="186974"/>
                  <a:pt x="31750" y="190594"/>
                </a:cubicBezTo>
                <a:cubicBezTo>
                  <a:pt x="30692" y="193769"/>
                  <a:pt x="30200" y="197193"/>
                  <a:pt x="28575" y="200119"/>
                </a:cubicBezTo>
                <a:cubicBezTo>
                  <a:pt x="24869" y="206790"/>
                  <a:pt x="18288" y="211929"/>
                  <a:pt x="15875" y="219169"/>
                </a:cubicBezTo>
                <a:cubicBezTo>
                  <a:pt x="11493" y="232314"/>
                  <a:pt x="14556" y="225909"/>
                  <a:pt x="6350" y="238219"/>
                </a:cubicBezTo>
                <a:cubicBezTo>
                  <a:pt x="3571" y="249334"/>
                  <a:pt x="0" y="261768"/>
                  <a:pt x="0" y="273144"/>
                </a:cubicBezTo>
                <a:cubicBezTo>
                  <a:pt x="0" y="293280"/>
                  <a:pt x="776" y="313476"/>
                  <a:pt x="3175" y="333469"/>
                </a:cubicBezTo>
                <a:cubicBezTo>
                  <a:pt x="3972" y="340115"/>
                  <a:pt x="7408" y="346169"/>
                  <a:pt x="9525" y="352519"/>
                </a:cubicBezTo>
                <a:cubicBezTo>
                  <a:pt x="13907" y="365664"/>
                  <a:pt x="9915" y="360188"/>
                  <a:pt x="22225" y="368394"/>
                </a:cubicBezTo>
                <a:cubicBezTo>
                  <a:pt x="23283" y="371569"/>
                  <a:pt x="23903" y="374926"/>
                  <a:pt x="25400" y="377919"/>
                </a:cubicBezTo>
                <a:cubicBezTo>
                  <a:pt x="29635" y="386390"/>
                  <a:pt x="45751" y="404811"/>
                  <a:pt x="50800" y="406494"/>
                </a:cubicBezTo>
                <a:lnTo>
                  <a:pt x="60325" y="409669"/>
                </a:lnTo>
                <a:cubicBezTo>
                  <a:pt x="81742" y="431086"/>
                  <a:pt x="70856" y="425879"/>
                  <a:pt x="88900" y="431894"/>
                </a:cubicBezTo>
                <a:cubicBezTo>
                  <a:pt x="110317" y="453311"/>
                  <a:pt x="99431" y="448104"/>
                  <a:pt x="117475" y="454119"/>
                </a:cubicBezTo>
                <a:lnTo>
                  <a:pt x="136525" y="466819"/>
                </a:lnTo>
                <a:cubicBezTo>
                  <a:pt x="139700" y="468936"/>
                  <a:pt x="142430" y="471962"/>
                  <a:pt x="146050" y="473169"/>
                </a:cubicBezTo>
                <a:lnTo>
                  <a:pt x="155575" y="476344"/>
                </a:lnTo>
                <a:cubicBezTo>
                  <a:pt x="173631" y="494400"/>
                  <a:pt x="156245" y="479854"/>
                  <a:pt x="174625" y="489044"/>
                </a:cubicBezTo>
                <a:cubicBezTo>
                  <a:pt x="178038" y="490751"/>
                  <a:pt x="180663" y="493844"/>
                  <a:pt x="184150" y="495394"/>
                </a:cubicBezTo>
                <a:cubicBezTo>
                  <a:pt x="190267" y="498112"/>
                  <a:pt x="203200" y="501744"/>
                  <a:pt x="203200" y="501744"/>
                </a:cubicBezTo>
                <a:cubicBezTo>
                  <a:pt x="206375" y="503861"/>
                  <a:pt x="209312" y="506387"/>
                  <a:pt x="212725" y="508094"/>
                </a:cubicBezTo>
                <a:cubicBezTo>
                  <a:pt x="248345" y="525904"/>
                  <a:pt x="188702" y="491192"/>
                  <a:pt x="234950" y="517619"/>
                </a:cubicBezTo>
                <a:cubicBezTo>
                  <a:pt x="238263" y="519512"/>
                  <a:pt x="240902" y="522629"/>
                  <a:pt x="244475" y="523969"/>
                </a:cubicBezTo>
                <a:cubicBezTo>
                  <a:pt x="249528" y="525864"/>
                  <a:pt x="255144" y="525724"/>
                  <a:pt x="260350" y="527144"/>
                </a:cubicBezTo>
                <a:cubicBezTo>
                  <a:pt x="266808" y="528905"/>
                  <a:pt x="272774" y="532547"/>
                  <a:pt x="279400" y="533494"/>
                </a:cubicBezTo>
                <a:cubicBezTo>
                  <a:pt x="318421" y="539068"/>
                  <a:pt x="294156" y="536202"/>
                  <a:pt x="352425" y="539844"/>
                </a:cubicBezTo>
                <a:cubicBezTo>
                  <a:pt x="384175" y="538786"/>
                  <a:pt x="415956" y="538431"/>
                  <a:pt x="447675" y="536669"/>
                </a:cubicBezTo>
                <a:cubicBezTo>
                  <a:pt x="454103" y="536312"/>
                  <a:pt x="460352" y="534404"/>
                  <a:pt x="466725" y="533494"/>
                </a:cubicBezTo>
                <a:cubicBezTo>
                  <a:pt x="475172" y="532287"/>
                  <a:pt x="483692" y="531616"/>
                  <a:pt x="492125" y="530319"/>
                </a:cubicBezTo>
                <a:cubicBezTo>
                  <a:pt x="522552" y="525638"/>
                  <a:pt x="495891" y="529377"/>
                  <a:pt x="517525" y="523969"/>
                </a:cubicBezTo>
                <a:cubicBezTo>
                  <a:pt x="522760" y="522660"/>
                  <a:pt x="528194" y="522214"/>
                  <a:pt x="533400" y="520794"/>
                </a:cubicBezTo>
                <a:cubicBezTo>
                  <a:pt x="539858" y="519033"/>
                  <a:pt x="546100" y="516561"/>
                  <a:pt x="552450" y="514444"/>
                </a:cubicBezTo>
                <a:lnTo>
                  <a:pt x="561975" y="511269"/>
                </a:lnTo>
                <a:cubicBezTo>
                  <a:pt x="565150" y="509152"/>
                  <a:pt x="568013" y="506469"/>
                  <a:pt x="571500" y="504919"/>
                </a:cubicBezTo>
                <a:cubicBezTo>
                  <a:pt x="577617" y="502201"/>
                  <a:pt x="590550" y="498569"/>
                  <a:pt x="590550" y="498569"/>
                </a:cubicBezTo>
                <a:cubicBezTo>
                  <a:pt x="593725" y="496452"/>
                  <a:pt x="597377" y="494917"/>
                  <a:pt x="600075" y="492219"/>
                </a:cubicBezTo>
                <a:cubicBezTo>
                  <a:pt x="602773" y="489521"/>
                  <a:pt x="603189" y="484716"/>
                  <a:pt x="606425" y="482694"/>
                </a:cubicBezTo>
                <a:cubicBezTo>
                  <a:pt x="612101" y="479146"/>
                  <a:pt x="625475" y="476344"/>
                  <a:pt x="625475" y="476344"/>
                </a:cubicBezTo>
                <a:cubicBezTo>
                  <a:pt x="628650" y="474227"/>
                  <a:pt x="632069" y="472437"/>
                  <a:pt x="635000" y="469994"/>
                </a:cubicBezTo>
                <a:cubicBezTo>
                  <a:pt x="638449" y="467119"/>
                  <a:pt x="640789" y="462960"/>
                  <a:pt x="644525" y="460469"/>
                </a:cubicBezTo>
                <a:cubicBezTo>
                  <a:pt x="647310" y="458613"/>
                  <a:pt x="650875" y="458352"/>
                  <a:pt x="654050" y="457294"/>
                </a:cubicBezTo>
                <a:cubicBezTo>
                  <a:pt x="656167" y="454119"/>
                  <a:pt x="657702" y="450467"/>
                  <a:pt x="660400" y="447769"/>
                </a:cubicBezTo>
                <a:cubicBezTo>
                  <a:pt x="663098" y="445071"/>
                  <a:pt x="667412" y="444291"/>
                  <a:pt x="669925" y="441419"/>
                </a:cubicBezTo>
                <a:cubicBezTo>
                  <a:pt x="674951" y="435676"/>
                  <a:pt x="678392" y="428719"/>
                  <a:pt x="682625" y="422369"/>
                </a:cubicBezTo>
                <a:lnTo>
                  <a:pt x="695325" y="403319"/>
                </a:lnTo>
                <a:cubicBezTo>
                  <a:pt x="697181" y="400534"/>
                  <a:pt x="697003" y="396787"/>
                  <a:pt x="698500" y="393794"/>
                </a:cubicBezTo>
                <a:cubicBezTo>
                  <a:pt x="700207" y="390381"/>
                  <a:pt x="703300" y="387756"/>
                  <a:pt x="704850" y="384269"/>
                </a:cubicBezTo>
                <a:lnTo>
                  <a:pt x="714375" y="355694"/>
                </a:lnTo>
                <a:lnTo>
                  <a:pt x="717550" y="346169"/>
                </a:lnTo>
                <a:cubicBezTo>
                  <a:pt x="718607" y="336655"/>
                  <a:pt x="721050" y="309945"/>
                  <a:pt x="723900" y="298544"/>
                </a:cubicBezTo>
                <a:cubicBezTo>
                  <a:pt x="725523" y="292050"/>
                  <a:pt x="728133" y="285844"/>
                  <a:pt x="730250" y="279494"/>
                </a:cubicBezTo>
                <a:lnTo>
                  <a:pt x="736600" y="260444"/>
                </a:lnTo>
                <a:cubicBezTo>
                  <a:pt x="737658" y="257269"/>
                  <a:pt x="738963" y="254166"/>
                  <a:pt x="739775" y="250919"/>
                </a:cubicBezTo>
                <a:cubicBezTo>
                  <a:pt x="744573" y="231725"/>
                  <a:pt x="741570" y="242359"/>
                  <a:pt x="749300" y="219169"/>
                </a:cubicBezTo>
                <a:lnTo>
                  <a:pt x="752475" y="209644"/>
                </a:lnTo>
                <a:cubicBezTo>
                  <a:pt x="751417" y="188477"/>
                  <a:pt x="751729" y="167197"/>
                  <a:pt x="749300" y="146144"/>
                </a:cubicBezTo>
                <a:cubicBezTo>
                  <a:pt x="748533" y="139495"/>
                  <a:pt x="745067" y="133444"/>
                  <a:pt x="742950" y="127094"/>
                </a:cubicBezTo>
                <a:lnTo>
                  <a:pt x="736600" y="108044"/>
                </a:lnTo>
                <a:cubicBezTo>
                  <a:pt x="735180" y="103784"/>
                  <a:pt x="729950" y="101968"/>
                  <a:pt x="727075" y="98519"/>
                </a:cubicBezTo>
                <a:cubicBezTo>
                  <a:pt x="702096" y="68544"/>
                  <a:pt x="736643" y="108108"/>
                  <a:pt x="717550" y="79469"/>
                </a:cubicBezTo>
                <a:cubicBezTo>
                  <a:pt x="715059" y="75733"/>
                  <a:pt x="710900" y="73393"/>
                  <a:pt x="708025" y="69944"/>
                </a:cubicBezTo>
                <a:cubicBezTo>
                  <a:pt x="705582" y="67013"/>
                  <a:pt x="704547" y="62932"/>
                  <a:pt x="701675" y="60419"/>
                </a:cubicBezTo>
                <a:cubicBezTo>
                  <a:pt x="695932" y="55393"/>
                  <a:pt x="688975" y="51952"/>
                  <a:pt x="682625" y="47719"/>
                </a:cubicBezTo>
                <a:lnTo>
                  <a:pt x="663575" y="35019"/>
                </a:lnTo>
                <a:cubicBezTo>
                  <a:pt x="660790" y="33163"/>
                  <a:pt x="657225" y="32902"/>
                  <a:pt x="654050" y="31844"/>
                </a:cubicBezTo>
                <a:lnTo>
                  <a:pt x="635000" y="19144"/>
                </a:lnTo>
                <a:cubicBezTo>
                  <a:pt x="616625" y="6894"/>
                  <a:pt x="629272" y="13174"/>
                  <a:pt x="593725" y="9619"/>
                </a:cubicBezTo>
                <a:cubicBezTo>
                  <a:pt x="590550" y="8561"/>
                  <a:pt x="587447" y="7256"/>
                  <a:pt x="584200" y="6444"/>
                </a:cubicBezTo>
                <a:cubicBezTo>
                  <a:pt x="555792" y="-658"/>
                  <a:pt x="529136" y="733"/>
                  <a:pt x="498475" y="94"/>
                </a:cubicBezTo>
                <a:cubicBezTo>
                  <a:pt x="470964" y="-479"/>
                  <a:pt x="459846" y="1681"/>
                  <a:pt x="444500" y="3269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12" name="テキスト ボックス 211"/>
          <p:cNvSpPr txBox="1"/>
          <p:nvPr/>
        </p:nvSpPr>
        <p:spPr>
          <a:xfrm>
            <a:off x="4130158" y="3742153"/>
            <a:ext cx="59463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 smtClean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ge</a:t>
            </a:r>
            <a:endParaRPr kumimoji="1" lang="ja-JP" altLang="en-US" sz="1050" b="1" dirty="0">
              <a:solidFill>
                <a:schemeClr val="bg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13" name="テキスト ボックス 212"/>
          <p:cNvSpPr txBox="1"/>
          <p:nvPr/>
        </p:nvSpPr>
        <p:spPr>
          <a:xfrm>
            <a:off x="4132793" y="5050997"/>
            <a:ext cx="59463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 smtClean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ge</a:t>
            </a:r>
            <a:endParaRPr kumimoji="1" lang="ja-JP" altLang="en-US" sz="1050" b="1" dirty="0">
              <a:solidFill>
                <a:schemeClr val="bg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14" name="正方形/長方形 213"/>
          <p:cNvSpPr/>
          <p:nvPr/>
        </p:nvSpPr>
        <p:spPr>
          <a:xfrm flipH="1">
            <a:off x="1929257" y="2215613"/>
            <a:ext cx="66460" cy="432048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15" name="正方形/長方形 214"/>
          <p:cNvSpPr/>
          <p:nvPr/>
        </p:nvSpPr>
        <p:spPr>
          <a:xfrm flipH="1">
            <a:off x="3327888" y="2209055"/>
            <a:ext cx="66460" cy="432048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2042610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5</TotalTime>
  <Words>87</Words>
  <Application>Microsoft Office PowerPoint</Application>
  <PresentationFormat>画面に合わせる (4:3)</PresentationFormat>
  <Paragraphs>64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Arial Unicode MS</vt:lpstr>
      <vt:lpstr>ＭＳ Ｐゴシック</vt:lpstr>
      <vt:lpstr>Arial</vt:lpstr>
      <vt:lpstr>Calibri</vt:lpstr>
      <vt:lpstr>Helvetica</vt:lpstr>
      <vt:lpstr>Office ​​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nori</dc:creator>
  <cp:lastModifiedBy>Yoshinori</cp:lastModifiedBy>
  <cp:revision>37</cp:revision>
  <cp:lastPrinted>2012-12-12T09:07:08Z</cp:lastPrinted>
  <dcterms:created xsi:type="dcterms:W3CDTF">2012-11-08T08:31:02Z</dcterms:created>
  <dcterms:modified xsi:type="dcterms:W3CDTF">2013-06-18T01:52:13Z</dcterms:modified>
</cp:coreProperties>
</file>